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notesSlides/notesSlide1.xml" ContentType="application/vnd.openxmlformats-officedocument.presentationml.notesSl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notesSlides/notesSlide2.xml" ContentType="application/vnd.openxmlformats-officedocument.presentationml.notesSlid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notesSlides/notesSlide3.xml" ContentType="application/vnd.openxmlformats-officedocument.presentationml.notesSlide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notesSlides/notesSlide4.xml" ContentType="application/vnd.openxmlformats-officedocument.presentationml.notesSlide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notesSlides/notesSlide5.xml" ContentType="application/vnd.openxmlformats-officedocument.presentationml.notesSlide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7"/>
  </p:notesMasterIdLst>
  <p:sldIdLst>
    <p:sldId id="285" r:id="rId2"/>
    <p:sldId id="288" r:id="rId3"/>
    <p:sldId id="286" r:id="rId4"/>
    <p:sldId id="265" r:id="rId5"/>
    <p:sldId id="287" r:id="rId6"/>
    <p:sldId id="274" r:id="rId7"/>
    <p:sldId id="279" r:id="rId8"/>
    <p:sldId id="268" r:id="rId9"/>
    <p:sldId id="278" r:id="rId10"/>
    <p:sldId id="275" r:id="rId11"/>
    <p:sldId id="277" r:id="rId12"/>
    <p:sldId id="281" r:id="rId13"/>
    <p:sldId id="282" r:id="rId14"/>
    <p:sldId id="283" r:id="rId15"/>
    <p:sldId id="284" r:id="rId16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137"/>
    <p:restoredTop sz="99493" autoAdjust="0"/>
  </p:normalViewPr>
  <p:slideViewPr>
    <p:cSldViewPr snapToGrid="0" snapToObjects="1">
      <p:cViewPr>
        <p:scale>
          <a:sx n="100" d="100"/>
          <a:sy n="100" d="100"/>
        </p:scale>
        <p:origin x="-2216" y="-6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viewProps" Target="viewProps.xml"/><Relationship Id="rId21" Type="http://schemas.openxmlformats.org/officeDocument/2006/relationships/theme" Target="theme/theme1.xml"/><Relationship Id="rId22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notesMaster" Target="notesMasters/notesMaster1.xml"/><Relationship Id="rId18" Type="http://schemas.openxmlformats.org/officeDocument/2006/relationships/printerSettings" Target="printerSettings/printerSettings1.bin"/><Relationship Id="rId1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K27M3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Ayasha%20RNA-seq%20vernalization:K27me3&#12392;&#32068;&#32340;&#29305;&#24615;&#12398;&#38306;&#20418;&#24615;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For%20Australia\H3K27me3&#35542;&#25991;\For%20Re-submission\K27me3&#12392;&#32068;&#32340;&#29305;&#24615;&#12398;&#38306;&#20418;&#24615;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For%20figure%20S10%20mutation%20rate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For%20figure%20S10%20mutation%20rate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q-PCR%20of%20BrFLC,SOC1,MAF,VIN3%20and%20FT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q-PCR%20of%20BrFLC,SOC1,MAF,VIN3%20and%20FT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q-PCR%20of%20BrFLC,SOC1,MAF,VIN3%20and%20FT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q-PCR%20of%20BrFLC,SOC1,MAF,VIN3%20and%20FT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q-PCR%20of%20BrFLC,SOC1,MAF,VIN3%20and%20FT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q-PCR%20of%20BrFLC,SOC1,MAF,VIN3%20and%20F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K27M3.xls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q-PCR%20of%20BrFLC,SOC1,MAF,VIN3%20and%20F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&#12502;&#12483;&#12463;3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&#12502;&#12483;&#12463;3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submission%20to%20PBJ:K27M3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For%20Re-submission:For%20revise%20(&#12496;&#12540;&#12472;&#12519;&#12531;%201)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H3K27me3&#35542;&#25991;:K27me3&#20445;&#23384;&#36986;&#20253;&#23376;&#12392;&#30330;&#29694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leo\Desktop\H3K27me3%20for%20revision\New%20submission%20for%20xxx\palalog&#12392;&#30330;&#29694;.xlsx" TargetMode="External"/><Relationship Id="rId2" Type="http://schemas.microsoft.com/office/2011/relationships/chartStyle" Target="style1.xml"/><Relationship Id="rId3" Type="http://schemas.microsoft.com/office/2011/relationships/chartColorStyle" Target="colors1.xm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leo\Desktop\H3K27me3%20for%20revision\New%20submission%20for%20xxx\palalog&#12392;&#30330;&#29694;.xlsx" TargetMode="External"/><Relationship Id="rId2" Type="http://schemas.microsoft.com/office/2011/relationships/chartStyle" Target="style2.xml"/><Relationship Id="rId3" Type="http://schemas.microsoft.com/office/2011/relationships/chartColorStyle" Target="colors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ja-JP" sz="1200" b="1" i="1" baseline="0">
                <a:effectLst/>
              </a:rPr>
              <a:t>FWA</a:t>
            </a:r>
            <a:r>
              <a:rPr lang="en-US" altLang="ja-JP" sz="1200" b="1" i="0" baseline="0">
                <a:effectLst/>
              </a:rPr>
              <a:t> (Bra013898)</a:t>
            </a:r>
            <a:endParaRPr lang="en-US" altLang="ja-JP" sz="1200">
              <a:effectLst/>
            </a:endParaRPr>
          </a:p>
        </c:rich>
      </c:tx>
      <c:layout>
        <c:manualLayout>
          <c:xMode val="edge"/>
          <c:yMode val="edge"/>
          <c:x val="0.379651528238151"/>
          <c:y val="0.0416666666666667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rgbClr val="3366FF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3366FF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09ADDD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09ADDD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まとめ!$J$5:$O$5</c:f>
                <c:numCache>
                  <c:formatCode>General</c:formatCode>
                  <c:ptCount val="6"/>
                  <c:pt idx="0">
                    <c:v>0.289506578128631</c:v>
                  </c:pt>
                  <c:pt idx="1">
                    <c:v>0.321715597646191</c:v>
                  </c:pt>
                  <c:pt idx="2">
                    <c:v>0.274280959878968</c:v>
                  </c:pt>
                  <c:pt idx="3">
                    <c:v>0.100186718021437</c:v>
                  </c:pt>
                  <c:pt idx="4">
                    <c:v>0.3756250911377</c:v>
                  </c:pt>
                  <c:pt idx="5">
                    <c:v>0.311194369889481</c:v>
                  </c:pt>
                </c:numCache>
              </c:numRef>
            </c:plus>
            <c:minus>
              <c:numRef>
                <c:f>まとめ!$J$5:$O$5</c:f>
                <c:numCache>
                  <c:formatCode>General</c:formatCode>
                  <c:ptCount val="6"/>
                  <c:pt idx="0">
                    <c:v>0.289506578128631</c:v>
                  </c:pt>
                  <c:pt idx="1">
                    <c:v>0.321715597646191</c:v>
                  </c:pt>
                  <c:pt idx="2">
                    <c:v>0.274280959878968</c:v>
                  </c:pt>
                  <c:pt idx="3">
                    <c:v>0.100186718021437</c:v>
                  </c:pt>
                  <c:pt idx="4">
                    <c:v>0.3756250911377</c:v>
                  </c:pt>
                  <c:pt idx="5">
                    <c:v>0.311194369889481</c:v>
                  </c:pt>
                </c:numCache>
              </c:numRef>
            </c:minus>
          </c:errBars>
          <c:cat>
            <c:multiLvlStrRef>
              <c:f>まとめ!$J$2:$O$3</c:f>
              <c:multiLvlStrCache>
                <c:ptCount val="6"/>
                <c:lvl>
                  <c:pt idx="0">
                    <c:v>2d-C</c:v>
                  </c:pt>
                  <c:pt idx="1">
                    <c:v>14d-L</c:v>
                  </c:pt>
                  <c:pt idx="2">
                    <c:v>2d-C</c:v>
                  </c:pt>
                  <c:pt idx="3">
                    <c:v>14d-L</c:v>
                  </c:pt>
                  <c:pt idx="4">
                    <c:v>BrV1</c:v>
                  </c:pt>
                  <c:pt idx="5">
                    <c:v>BrV2</c:v>
                  </c:pt>
                </c:lvl>
                <c:lvl>
                  <c:pt idx="0">
                    <c:v>RJKB-T23</c:v>
                  </c:pt>
                  <c:pt idx="2">
                    <c:v>RJKB-T24</c:v>
                  </c:pt>
                </c:lvl>
              </c:multiLvlStrCache>
            </c:multiLvlStrRef>
          </c:cat>
          <c:val>
            <c:numRef>
              <c:f>まとめ!$J$4:$O$4</c:f>
              <c:numCache>
                <c:formatCode>General</c:formatCode>
                <c:ptCount val="6"/>
                <c:pt idx="0">
                  <c:v>11.15045833365107</c:v>
                </c:pt>
                <c:pt idx="1">
                  <c:v>10.34779157399249</c:v>
                </c:pt>
                <c:pt idx="2">
                  <c:v>10.57996321203674</c:v>
                </c:pt>
                <c:pt idx="3">
                  <c:v>10.25987493195918</c:v>
                </c:pt>
                <c:pt idx="4">
                  <c:v>10.41016506488184</c:v>
                </c:pt>
                <c:pt idx="5">
                  <c:v>11.687467898556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5993368"/>
        <c:axId val="2076000424"/>
      </c:barChart>
      <c:catAx>
        <c:axId val="20759933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76000424"/>
        <c:crosses val="autoZero"/>
        <c:auto val="1"/>
        <c:lblAlgn val="ctr"/>
        <c:lblOffset val="100"/>
        <c:noMultiLvlLbl val="0"/>
      </c:catAx>
      <c:valAx>
        <c:axId val="2076000424"/>
        <c:scaling>
          <c:orientation val="minMax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dirty="0" err="1"/>
                  <a:t>Enrichment</a:t>
                </a:r>
                <a:endParaRPr lang="de-DE" dirty="0"/>
              </a:p>
              <a:p>
                <a:pPr>
                  <a:defRPr/>
                </a:pPr>
                <a:r>
                  <a:rPr lang="de-DE" dirty="0"/>
                  <a:t> (vs. Bra013206 &amp; Bra028913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759933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023-405D-8F1E-2C40C910F5F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023-405D-8F1E-2C40C910F5F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023-405D-8F1E-2C40C910F5F4}"/>
              </c:ext>
            </c:extLst>
          </c:dPt>
          <c:dPt>
            <c:idx val="3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023-405D-8F1E-2C40C910F5F4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023-405D-8F1E-2C40C910F5F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023-405D-8F1E-2C40C910F5F4}"/>
              </c:ext>
            </c:extLst>
          </c:dPt>
          <c:dPt>
            <c:idx val="6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023-405D-8F1E-2C40C910F5F4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1023-405D-8F1E-2C40C910F5F4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1023-405D-8F1E-2C40C910F5F4}"/>
              </c:ext>
            </c:extLst>
          </c:dPt>
          <c:dPt>
            <c:idx val="9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1023-405D-8F1E-2C40C910F5F4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1023-405D-8F1E-2C40C910F5F4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1023-405D-8F1E-2C40C910F5F4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1023-405D-8F1E-2C40C910F5F4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B-1023-405D-8F1E-2C40C910F5F4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D-1023-405D-8F1E-2C40C910F5F4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1023-405D-8F1E-2C40C910F5F4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1-1023-405D-8F1E-2C40C910F5F4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1023-405D-8F1E-2C40C910F5F4}"/>
              </c:ext>
            </c:extLst>
          </c:dPt>
          <c:dPt>
            <c:idx val="18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1023-405D-8F1E-2C40C910F5F4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1023-405D-8F1E-2C40C910F5F4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1023-405D-8F1E-2C40C910F5F4}"/>
              </c:ext>
            </c:extLst>
          </c:dPt>
          <c:dPt>
            <c:idx val="21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B-1023-405D-8F1E-2C40C910F5F4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D-1023-405D-8F1E-2C40C910F5F4}"/>
              </c:ext>
            </c:extLst>
          </c:dPt>
          <c:dPt>
            <c:idx val="23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F-1023-405D-8F1E-2C40C910F5F4}"/>
              </c:ext>
            </c:extLst>
          </c:dPt>
          <c:errBars>
            <c:errBarType val="both"/>
            <c:errValType val="cust"/>
            <c:noEndCap val="1"/>
            <c:plus>
              <c:numRef>
                <c:f>パラログ3!$CQ$6:$DN$6</c:f>
                <c:numCache>
                  <c:formatCode>General</c:formatCode>
                  <c:ptCount val="24"/>
                  <c:pt idx="0">
                    <c:v>0.00813904326218106</c:v>
                  </c:pt>
                  <c:pt idx="1">
                    <c:v>0.00868432644403721</c:v>
                  </c:pt>
                  <c:pt idx="2">
                    <c:v>0.00852754136550203</c:v>
                  </c:pt>
                  <c:pt idx="3">
                    <c:v>0.0229082866312831</c:v>
                  </c:pt>
                  <c:pt idx="4">
                    <c:v>0.0213451232813974</c:v>
                  </c:pt>
                  <c:pt idx="5">
                    <c:v>0.0288285523156605</c:v>
                  </c:pt>
                  <c:pt idx="6">
                    <c:v>0.0188871382984489</c:v>
                  </c:pt>
                  <c:pt idx="7">
                    <c:v>0.0230540061895699</c:v>
                  </c:pt>
                  <c:pt idx="8">
                    <c:v>0.0203159292664433</c:v>
                  </c:pt>
                  <c:pt idx="9">
                    <c:v>0.0249868697995501</c:v>
                  </c:pt>
                  <c:pt idx="10">
                    <c:v>0.0172014435975841</c:v>
                  </c:pt>
                  <c:pt idx="11">
                    <c:v>0.0163231725200568</c:v>
                  </c:pt>
                  <c:pt idx="12">
                    <c:v>0.0278541475486538</c:v>
                  </c:pt>
                  <c:pt idx="13">
                    <c:v>0.0269421101095141</c:v>
                  </c:pt>
                  <c:pt idx="14">
                    <c:v>0.0307670222940552</c:v>
                  </c:pt>
                  <c:pt idx="15">
                    <c:v>0.0226747670778544</c:v>
                  </c:pt>
                  <c:pt idx="16">
                    <c:v>0.0204784108315141</c:v>
                  </c:pt>
                  <c:pt idx="17">
                    <c:v>0.0227199286709035</c:v>
                  </c:pt>
                  <c:pt idx="18">
                    <c:v>0.0193537575219385</c:v>
                  </c:pt>
                  <c:pt idx="19">
                    <c:v>0.0190081273462222</c:v>
                  </c:pt>
                  <c:pt idx="20">
                    <c:v>0.016996450558862</c:v>
                  </c:pt>
                  <c:pt idx="21">
                    <c:v>0.00667227956199285</c:v>
                  </c:pt>
                  <c:pt idx="22">
                    <c:v>0.00672369177495514</c:v>
                  </c:pt>
                  <c:pt idx="23">
                    <c:v>0.0068531460647788</c:v>
                  </c:pt>
                </c:numCache>
              </c:numRef>
            </c:plus>
            <c:minus>
              <c:numRef>
                <c:f>パラログ3!$CQ$6:$DN$6</c:f>
                <c:numCache>
                  <c:formatCode>General</c:formatCode>
                  <c:ptCount val="24"/>
                  <c:pt idx="0">
                    <c:v>0.00813904326218106</c:v>
                  </c:pt>
                  <c:pt idx="1">
                    <c:v>0.00868432644403721</c:v>
                  </c:pt>
                  <c:pt idx="2">
                    <c:v>0.00852754136550203</c:v>
                  </c:pt>
                  <c:pt idx="3">
                    <c:v>0.0229082866312831</c:v>
                  </c:pt>
                  <c:pt idx="4">
                    <c:v>0.0213451232813974</c:v>
                  </c:pt>
                  <c:pt idx="5">
                    <c:v>0.0288285523156605</c:v>
                  </c:pt>
                  <c:pt idx="6">
                    <c:v>0.0188871382984489</c:v>
                  </c:pt>
                  <c:pt idx="7">
                    <c:v>0.0230540061895699</c:v>
                  </c:pt>
                  <c:pt idx="8">
                    <c:v>0.0203159292664433</c:v>
                  </c:pt>
                  <c:pt idx="9">
                    <c:v>0.0249868697995501</c:v>
                  </c:pt>
                  <c:pt idx="10">
                    <c:v>0.0172014435975841</c:v>
                  </c:pt>
                  <c:pt idx="11">
                    <c:v>0.0163231725200568</c:v>
                  </c:pt>
                  <c:pt idx="12">
                    <c:v>0.0278541475486538</c:v>
                  </c:pt>
                  <c:pt idx="13">
                    <c:v>0.0269421101095141</c:v>
                  </c:pt>
                  <c:pt idx="14">
                    <c:v>0.0307670222940552</c:v>
                  </c:pt>
                  <c:pt idx="15">
                    <c:v>0.0226747670778544</c:v>
                  </c:pt>
                  <c:pt idx="16">
                    <c:v>0.0204784108315141</c:v>
                  </c:pt>
                  <c:pt idx="17">
                    <c:v>0.0227199286709035</c:v>
                  </c:pt>
                  <c:pt idx="18">
                    <c:v>0.0193537575219385</c:v>
                  </c:pt>
                  <c:pt idx="19">
                    <c:v>0.0190081273462222</c:v>
                  </c:pt>
                  <c:pt idx="20">
                    <c:v>0.016996450558862</c:v>
                  </c:pt>
                  <c:pt idx="21">
                    <c:v>0.00667227956199285</c:v>
                  </c:pt>
                  <c:pt idx="22">
                    <c:v>0.00672369177495514</c:v>
                  </c:pt>
                  <c:pt idx="23">
                    <c:v>0.0068531460647788</c:v>
                  </c:pt>
                </c:numCache>
              </c:numRef>
            </c:minus>
          </c:errBars>
          <c:cat>
            <c:multiLvlStrRef>
              <c:f>パラログ3!$CQ$2:$DN$4</c:f>
              <c:multiLvlStrCache>
                <c:ptCount val="24"/>
                <c:lvl>
                  <c:pt idx="0">
                    <c:v>+</c:v>
                  </c:pt>
                  <c:pt idx="1">
                    <c:v>+</c:v>
                  </c:pt>
                  <c:pt idx="2">
                    <c:v>+</c:v>
                  </c:pt>
                  <c:pt idx="3">
                    <c:v>+</c:v>
                  </c:pt>
                  <c:pt idx="4">
                    <c:v>+</c:v>
                  </c:pt>
                  <c:pt idx="5">
                    <c:v>-</c:v>
                  </c:pt>
                  <c:pt idx="6">
                    <c:v>+</c:v>
                  </c:pt>
                  <c:pt idx="7">
                    <c:v>-</c:v>
                  </c:pt>
                  <c:pt idx="8">
                    <c:v>+</c:v>
                  </c:pt>
                  <c:pt idx="9">
                    <c:v>-</c:v>
                  </c:pt>
                  <c:pt idx="10">
                    <c:v>+</c:v>
                  </c:pt>
                  <c:pt idx="11">
                    <c:v>+</c:v>
                  </c:pt>
                  <c:pt idx="12">
                    <c:v>+</c:v>
                  </c:pt>
                  <c:pt idx="13">
                    <c:v>-</c:v>
                  </c:pt>
                  <c:pt idx="14">
                    <c:v>-</c:v>
                  </c:pt>
                  <c:pt idx="15">
                    <c:v>-</c:v>
                  </c:pt>
                  <c:pt idx="16">
                    <c:v>+</c:v>
                  </c:pt>
                  <c:pt idx="17">
                    <c:v>-</c:v>
                  </c:pt>
                  <c:pt idx="18">
                    <c:v>-</c:v>
                  </c:pt>
                  <c:pt idx="19">
                    <c:v>-</c:v>
                  </c:pt>
                  <c:pt idx="20">
                    <c:v>+</c:v>
                  </c:pt>
                  <c:pt idx="21">
                    <c:v>-</c:v>
                  </c:pt>
                  <c:pt idx="22">
                    <c:v>-</c:v>
                  </c:pt>
                  <c:pt idx="23">
                    <c:v>-</c:v>
                  </c:pt>
                </c:lvl>
                <c:lvl>
                  <c:pt idx="0">
                    <c:v>LF</c:v>
                  </c:pt>
                  <c:pt idx="1">
                    <c:v>MF1</c:v>
                  </c:pt>
                  <c:pt idx="2">
                    <c:v>MF2</c:v>
                  </c:pt>
                  <c:pt idx="3">
                    <c:v>LF</c:v>
                  </c:pt>
                  <c:pt idx="4">
                    <c:v>MF1</c:v>
                  </c:pt>
                  <c:pt idx="5">
                    <c:v>MF2</c:v>
                  </c:pt>
                  <c:pt idx="6">
                    <c:v>LF</c:v>
                  </c:pt>
                  <c:pt idx="7">
                    <c:v>MF1</c:v>
                  </c:pt>
                  <c:pt idx="8">
                    <c:v>MF2</c:v>
                  </c:pt>
                  <c:pt idx="9">
                    <c:v>LF</c:v>
                  </c:pt>
                  <c:pt idx="10">
                    <c:v>MF1</c:v>
                  </c:pt>
                  <c:pt idx="11">
                    <c:v>MF2</c:v>
                  </c:pt>
                  <c:pt idx="12">
                    <c:v>LF</c:v>
                  </c:pt>
                  <c:pt idx="13">
                    <c:v>MF1</c:v>
                  </c:pt>
                  <c:pt idx="14">
                    <c:v>MF2</c:v>
                  </c:pt>
                  <c:pt idx="15">
                    <c:v>LF</c:v>
                  </c:pt>
                  <c:pt idx="16">
                    <c:v>MF1</c:v>
                  </c:pt>
                  <c:pt idx="17">
                    <c:v>MF2</c:v>
                  </c:pt>
                  <c:pt idx="18">
                    <c:v>LF</c:v>
                  </c:pt>
                  <c:pt idx="19">
                    <c:v>MF1</c:v>
                  </c:pt>
                  <c:pt idx="20">
                    <c:v>MF2</c:v>
                  </c:pt>
                  <c:pt idx="21">
                    <c:v>LF</c:v>
                  </c:pt>
                  <c:pt idx="22">
                    <c:v>MF1</c:v>
                  </c:pt>
                  <c:pt idx="23">
                    <c:v>MF2</c:v>
                  </c:pt>
                </c:lvl>
                <c:lvl>
                  <c:pt idx="0">
                    <c:v>3 of 3 genes</c:v>
                  </c:pt>
                  <c:pt idx="3">
                    <c:v>2 of 3 genes</c:v>
                  </c:pt>
                  <c:pt idx="12">
                    <c:v>1 of 3 genes</c:v>
                  </c:pt>
                  <c:pt idx="21">
                    <c:v>0 of 3 genes</c:v>
                  </c:pt>
                </c:lvl>
              </c:multiLvlStrCache>
            </c:multiLvlStrRef>
          </c:cat>
          <c:val>
            <c:numRef>
              <c:f>パラログ3!$CQ$5:$DN$5</c:f>
              <c:numCache>
                <c:formatCode>#,##0.00_);[Red]\(#,##0.00\)</c:formatCode>
                <c:ptCount val="24"/>
                <c:pt idx="0">
                  <c:v>0.827270036872105</c:v>
                </c:pt>
                <c:pt idx="1">
                  <c:v>0.83004163858669</c:v>
                </c:pt>
                <c:pt idx="2">
                  <c:v>0.824064305747207</c:v>
                </c:pt>
                <c:pt idx="3">
                  <c:v>0.83849960137071</c:v>
                </c:pt>
                <c:pt idx="4">
                  <c:v>0.81779071917531</c:v>
                </c:pt>
                <c:pt idx="5">
                  <c:v>0.76794793922948</c:v>
                </c:pt>
                <c:pt idx="6">
                  <c:v>0.854568530220167</c:v>
                </c:pt>
                <c:pt idx="7">
                  <c:v>0.80295032189562</c:v>
                </c:pt>
                <c:pt idx="8">
                  <c:v>0.835424470020988</c:v>
                </c:pt>
                <c:pt idx="9">
                  <c:v>0.777010647993764</c:v>
                </c:pt>
                <c:pt idx="10">
                  <c:v>0.841587010627782</c:v>
                </c:pt>
                <c:pt idx="11">
                  <c:v>0.871838317674571</c:v>
                </c:pt>
                <c:pt idx="12" formatCode="General">
                  <c:v>0.799067958815284</c:v>
                </c:pt>
                <c:pt idx="13" formatCode="General">
                  <c:v>0.62356354100432</c:v>
                </c:pt>
                <c:pt idx="14" formatCode="General">
                  <c:v>0.629035440652773</c:v>
                </c:pt>
                <c:pt idx="15">
                  <c:v>0.664804109784911</c:v>
                </c:pt>
                <c:pt idx="16">
                  <c:v>0.761463414634146</c:v>
                </c:pt>
                <c:pt idx="17">
                  <c:v>0.663152173913043</c:v>
                </c:pt>
                <c:pt idx="18">
                  <c:v>0.634856494575254</c:v>
                </c:pt>
                <c:pt idx="19">
                  <c:v>0.651745334834942</c:v>
                </c:pt>
                <c:pt idx="20">
                  <c:v>0.810013745787647</c:v>
                </c:pt>
                <c:pt idx="21">
                  <c:v>0.574715583684878</c:v>
                </c:pt>
                <c:pt idx="22">
                  <c:v>0.596135427816462</c:v>
                </c:pt>
                <c:pt idx="23">
                  <c:v>0.589210953592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0-1023-405D-8F1E-2C40C910F5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616920"/>
        <c:axId val="2123619768"/>
      </c:barChart>
      <c:catAx>
        <c:axId val="21236169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3619768"/>
        <c:crosses val="autoZero"/>
        <c:auto val="1"/>
        <c:lblAlgn val="ctr"/>
        <c:lblOffset val="100"/>
        <c:noMultiLvlLbl val="0"/>
      </c:catAx>
      <c:valAx>
        <c:axId val="2123619768"/>
        <c:scaling>
          <c:orientation val="minMax"/>
          <c:max val="1.0"/>
          <c:min val="0.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 dirty="0"/>
                  <a:t>Average of T-values</a:t>
                </a:r>
                <a:endParaRPr lang="ja-JP" altLang="en-US" dirty="0"/>
              </a:p>
            </c:rich>
          </c:tx>
          <c:layout/>
          <c:overlay val="0"/>
        </c:title>
        <c:numFmt formatCode="#,##0.00_);[Red]\(#,##0.00\)" sourceLinked="1"/>
        <c:majorTickMark val="out"/>
        <c:minorTickMark val="none"/>
        <c:tickLblPos val="nextTo"/>
        <c:crossAx val="2123616920"/>
        <c:crosses val="autoZero"/>
        <c:crossBetween val="between"/>
        <c:majorUnit val="0.1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93B-4450-837D-6C864E2FF8E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93B-4450-837D-6C864E2FF8E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93B-4450-837D-6C864E2FF8E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93B-4450-837D-6C864E2FF8E7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C93B-4450-837D-6C864E2FF8E7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C93B-4450-837D-6C864E2FF8E7}"/>
              </c:ext>
            </c:extLst>
          </c:dPt>
          <c:dPt>
            <c:idx val="6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C93B-4450-837D-6C864E2FF8E7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C93B-4450-837D-6C864E2FF8E7}"/>
              </c:ext>
            </c:extLst>
          </c:dPt>
          <c:dPt>
            <c:idx val="8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C93B-4450-837D-6C864E2FF8E7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C93B-4450-837D-6C864E2FF8E7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C93B-4450-837D-6C864E2FF8E7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C93B-4450-837D-6C864E2FF8E7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C93B-4450-837D-6C864E2FF8E7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B-C93B-4450-837D-6C864E2FF8E7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D-C93B-4450-837D-6C864E2FF8E7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C93B-4450-837D-6C864E2FF8E7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1-C93B-4450-837D-6C864E2FF8E7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C93B-4450-837D-6C864E2FF8E7}"/>
              </c:ext>
            </c:extLst>
          </c:dPt>
          <c:dPt>
            <c:idx val="18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C93B-4450-837D-6C864E2FF8E7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C93B-4450-837D-6C864E2FF8E7}"/>
              </c:ext>
            </c:extLst>
          </c:dPt>
          <c:dPt>
            <c:idx val="20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C93B-4450-837D-6C864E2FF8E7}"/>
              </c:ext>
            </c:extLst>
          </c:dPt>
          <c:dPt>
            <c:idx val="21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B-C93B-4450-837D-6C864E2FF8E7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D-C93B-4450-837D-6C864E2FF8E7}"/>
              </c:ext>
            </c:extLst>
          </c:dPt>
          <c:dPt>
            <c:idx val="23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F-C93B-4450-837D-6C864E2FF8E7}"/>
              </c:ext>
            </c:extLst>
          </c:dPt>
          <c:errBars>
            <c:errBarType val="both"/>
            <c:errValType val="cust"/>
            <c:noEndCap val="1"/>
            <c:plus>
              <c:numRef>
                <c:f>パラログ2!$CW$5:$DT$5</c:f>
                <c:numCache>
                  <c:formatCode>General</c:formatCode>
                  <c:ptCount val="24"/>
                  <c:pt idx="0">
                    <c:v>0.00716457928456298</c:v>
                  </c:pt>
                  <c:pt idx="1">
                    <c:v>0.00701854321126538</c:v>
                  </c:pt>
                  <c:pt idx="2">
                    <c:v>0.00810965931927419</c:v>
                  </c:pt>
                  <c:pt idx="3">
                    <c:v>0.00814876047220085</c:v>
                  </c:pt>
                  <c:pt idx="4">
                    <c:v>0.0145781979884489</c:v>
                  </c:pt>
                  <c:pt idx="5">
                    <c:v>0.0154684558059988</c:v>
                  </c:pt>
                  <c:pt idx="6">
                    <c:v>0.0138181616794618</c:v>
                  </c:pt>
                  <c:pt idx="7">
                    <c:v>0.0148200081181834</c:v>
                  </c:pt>
                  <c:pt idx="8">
                    <c:v>0.0123724757985201</c:v>
                  </c:pt>
                  <c:pt idx="9">
                    <c:v>0.0119548889872776</c:v>
                  </c:pt>
                  <c:pt idx="10">
                    <c:v>0.0142508895482522</c:v>
                  </c:pt>
                  <c:pt idx="11">
                    <c:v>0.0195412881472843</c:v>
                  </c:pt>
                  <c:pt idx="12">
                    <c:v>0.014423348432175</c:v>
                  </c:pt>
                  <c:pt idx="13">
                    <c:v>0.0117064656587691</c:v>
                  </c:pt>
                  <c:pt idx="14">
                    <c:v>0.0261204071761532</c:v>
                  </c:pt>
                  <c:pt idx="15">
                    <c:v>0.0312383438890904</c:v>
                  </c:pt>
                  <c:pt idx="16">
                    <c:v>0.0254073011661487</c:v>
                  </c:pt>
                  <c:pt idx="17">
                    <c:v>0.0217091955735954</c:v>
                  </c:pt>
                  <c:pt idx="18">
                    <c:v>0.00475449192299448</c:v>
                  </c:pt>
                  <c:pt idx="19">
                    <c:v>0.00491204556285878</c:v>
                  </c:pt>
                  <c:pt idx="20">
                    <c:v>0.00561586364124925</c:v>
                  </c:pt>
                  <c:pt idx="21">
                    <c:v>0.00567342310965814</c:v>
                  </c:pt>
                  <c:pt idx="22">
                    <c:v>0.00882968434691853</c:v>
                  </c:pt>
                  <c:pt idx="23">
                    <c:v>0.00863938167397061</c:v>
                  </c:pt>
                </c:numCache>
              </c:numRef>
            </c:plus>
            <c:minus>
              <c:numRef>
                <c:f>パラログ2!$CW$5:$DT$5</c:f>
                <c:numCache>
                  <c:formatCode>General</c:formatCode>
                  <c:ptCount val="24"/>
                  <c:pt idx="0">
                    <c:v>0.00716457928456298</c:v>
                  </c:pt>
                  <c:pt idx="1">
                    <c:v>0.00701854321126538</c:v>
                  </c:pt>
                  <c:pt idx="2">
                    <c:v>0.00810965931927419</c:v>
                  </c:pt>
                  <c:pt idx="3">
                    <c:v>0.00814876047220085</c:v>
                  </c:pt>
                  <c:pt idx="4">
                    <c:v>0.0145781979884489</c:v>
                  </c:pt>
                  <c:pt idx="5">
                    <c:v>0.0154684558059988</c:v>
                  </c:pt>
                  <c:pt idx="6">
                    <c:v>0.0138181616794618</c:v>
                  </c:pt>
                  <c:pt idx="7">
                    <c:v>0.0148200081181834</c:v>
                  </c:pt>
                  <c:pt idx="8">
                    <c:v>0.0123724757985201</c:v>
                  </c:pt>
                  <c:pt idx="9">
                    <c:v>0.0119548889872776</c:v>
                  </c:pt>
                  <c:pt idx="10">
                    <c:v>0.0142508895482522</c:v>
                  </c:pt>
                  <c:pt idx="11">
                    <c:v>0.0195412881472843</c:v>
                  </c:pt>
                  <c:pt idx="12">
                    <c:v>0.014423348432175</c:v>
                  </c:pt>
                  <c:pt idx="13">
                    <c:v>0.0117064656587691</c:v>
                  </c:pt>
                  <c:pt idx="14">
                    <c:v>0.0261204071761532</c:v>
                  </c:pt>
                  <c:pt idx="15">
                    <c:v>0.0312383438890904</c:v>
                  </c:pt>
                  <c:pt idx="16">
                    <c:v>0.0254073011661487</c:v>
                  </c:pt>
                  <c:pt idx="17">
                    <c:v>0.0217091955735954</c:v>
                  </c:pt>
                  <c:pt idx="18">
                    <c:v>0.00475449192299448</c:v>
                  </c:pt>
                  <c:pt idx="19">
                    <c:v>0.00491204556285878</c:v>
                  </c:pt>
                  <c:pt idx="20">
                    <c:v>0.00561586364124925</c:v>
                  </c:pt>
                  <c:pt idx="21">
                    <c:v>0.00567342310965814</c:v>
                  </c:pt>
                  <c:pt idx="22">
                    <c:v>0.00882968434691853</c:v>
                  </c:pt>
                  <c:pt idx="23">
                    <c:v>0.00863938167397061</c:v>
                  </c:pt>
                </c:numCache>
              </c:numRef>
            </c:minus>
          </c:errBars>
          <c:cat>
            <c:multiLvlStrRef>
              <c:f>パラログ2!$CW$1:$DT$3</c:f>
              <c:multiLvlStrCache>
                <c:ptCount val="24"/>
                <c:lvl>
                  <c:pt idx="0">
                    <c:v>+</c:v>
                  </c:pt>
                  <c:pt idx="1">
                    <c:v>+</c:v>
                  </c:pt>
                  <c:pt idx="2">
                    <c:v>+</c:v>
                  </c:pt>
                  <c:pt idx="3">
                    <c:v>+</c:v>
                  </c:pt>
                  <c:pt idx="4">
                    <c:v>+</c:v>
                  </c:pt>
                  <c:pt idx="5">
                    <c:v>+</c:v>
                  </c:pt>
                  <c:pt idx="6">
                    <c:v>+</c:v>
                  </c:pt>
                  <c:pt idx="7">
                    <c:v>-</c:v>
                  </c:pt>
                  <c:pt idx="8">
                    <c:v>-</c:v>
                  </c:pt>
                  <c:pt idx="9">
                    <c:v>+</c:v>
                  </c:pt>
                  <c:pt idx="10">
                    <c:v>+</c:v>
                  </c:pt>
                  <c:pt idx="11">
                    <c:v>-</c:v>
                  </c:pt>
                  <c:pt idx="12">
                    <c:v>-</c:v>
                  </c:pt>
                  <c:pt idx="13">
                    <c:v>+</c:v>
                  </c:pt>
                  <c:pt idx="14">
                    <c:v>+</c:v>
                  </c:pt>
                  <c:pt idx="15">
                    <c:v>-</c:v>
                  </c:pt>
                  <c:pt idx="16">
                    <c:v>-</c:v>
                  </c:pt>
                  <c:pt idx="17">
                    <c:v>+</c:v>
                  </c:pt>
                  <c:pt idx="18">
                    <c:v>-</c:v>
                  </c:pt>
                  <c:pt idx="19">
                    <c:v>-</c:v>
                  </c:pt>
                  <c:pt idx="20">
                    <c:v>-</c:v>
                  </c:pt>
                  <c:pt idx="21">
                    <c:v>-</c:v>
                  </c:pt>
                  <c:pt idx="22">
                    <c:v>-</c:v>
                  </c:pt>
                  <c:pt idx="23">
                    <c:v>-</c:v>
                  </c:pt>
                </c:lvl>
                <c:lvl>
                  <c:pt idx="0">
                    <c:v>LF</c:v>
                  </c:pt>
                  <c:pt idx="1">
                    <c:v>MF1</c:v>
                  </c:pt>
                  <c:pt idx="2">
                    <c:v>LF</c:v>
                  </c:pt>
                  <c:pt idx="3">
                    <c:v>MF2</c:v>
                  </c:pt>
                  <c:pt idx="4">
                    <c:v>MF1</c:v>
                  </c:pt>
                  <c:pt idx="5">
                    <c:v>MF2</c:v>
                  </c:pt>
                  <c:pt idx="6">
                    <c:v>LF</c:v>
                  </c:pt>
                  <c:pt idx="7">
                    <c:v>MF1</c:v>
                  </c:pt>
                  <c:pt idx="8">
                    <c:v>LF</c:v>
                  </c:pt>
                  <c:pt idx="9">
                    <c:v>MF1</c:v>
                  </c:pt>
                  <c:pt idx="10">
                    <c:v>LF</c:v>
                  </c:pt>
                  <c:pt idx="11">
                    <c:v>MF2</c:v>
                  </c:pt>
                  <c:pt idx="12">
                    <c:v>LF</c:v>
                  </c:pt>
                  <c:pt idx="13">
                    <c:v>MF2</c:v>
                  </c:pt>
                  <c:pt idx="14">
                    <c:v>MF1</c:v>
                  </c:pt>
                  <c:pt idx="15">
                    <c:v>MF2</c:v>
                  </c:pt>
                  <c:pt idx="16">
                    <c:v>MF1</c:v>
                  </c:pt>
                  <c:pt idx="17">
                    <c:v>MF2</c:v>
                  </c:pt>
                  <c:pt idx="18">
                    <c:v>LF</c:v>
                  </c:pt>
                  <c:pt idx="19">
                    <c:v>MF1</c:v>
                  </c:pt>
                  <c:pt idx="20">
                    <c:v>LF</c:v>
                  </c:pt>
                  <c:pt idx="21">
                    <c:v>MF2</c:v>
                  </c:pt>
                  <c:pt idx="22">
                    <c:v>MF1</c:v>
                  </c:pt>
                  <c:pt idx="23">
                    <c:v>MF2</c:v>
                  </c:pt>
                </c:lvl>
                <c:lvl>
                  <c:pt idx="0">
                    <c:v>2 of 2 genes</c:v>
                  </c:pt>
                  <c:pt idx="6">
                    <c:v>1 of 2 genes</c:v>
                  </c:pt>
                  <c:pt idx="18">
                    <c:v>0 of 2 genes</c:v>
                  </c:pt>
                </c:lvl>
              </c:multiLvlStrCache>
            </c:multiLvlStrRef>
          </c:cat>
          <c:val>
            <c:numRef>
              <c:f>パラログ2!$CW$4:$DT$4</c:f>
              <c:numCache>
                <c:formatCode>#,##0.00_);[Red]\(#,##0.00\)</c:formatCode>
                <c:ptCount val="24"/>
                <c:pt idx="0">
                  <c:v>0.834060409159891</c:v>
                </c:pt>
                <c:pt idx="1">
                  <c:v>0.847432432432433</c:v>
                </c:pt>
                <c:pt idx="2">
                  <c:v>0.829967406958489</c:v>
                </c:pt>
                <c:pt idx="3">
                  <c:v>0.846383763837638</c:v>
                </c:pt>
                <c:pt idx="4">
                  <c:v>0.850653371832262</c:v>
                </c:pt>
                <c:pt idx="5">
                  <c:v>0.863917525773196</c:v>
                </c:pt>
                <c:pt idx="6">
                  <c:v>0.794359581822722</c:v>
                </c:pt>
                <c:pt idx="7">
                  <c:v>0.697932960893855</c:v>
                </c:pt>
                <c:pt idx="8">
                  <c:v>0.669908238529873</c:v>
                </c:pt>
                <c:pt idx="9">
                  <c:v>0.795</c:v>
                </c:pt>
                <c:pt idx="10">
                  <c:v>0.835925925925926</c:v>
                </c:pt>
                <c:pt idx="11">
                  <c:v>0.677028985507247</c:v>
                </c:pt>
                <c:pt idx="12">
                  <c:v>0.688248815693693</c:v>
                </c:pt>
                <c:pt idx="13">
                  <c:v>0.810117647058823</c:v>
                </c:pt>
                <c:pt idx="14">
                  <c:v>0.795154387159078</c:v>
                </c:pt>
                <c:pt idx="15">
                  <c:v>0.640862357732859</c:v>
                </c:pt>
                <c:pt idx="16">
                  <c:v>0.676278966321598</c:v>
                </c:pt>
                <c:pt idx="17">
                  <c:v>0.822876712328767</c:v>
                </c:pt>
                <c:pt idx="18">
                  <c:v>0.573086692808585</c:v>
                </c:pt>
                <c:pt idx="19">
                  <c:v>0.593420745920746</c:v>
                </c:pt>
                <c:pt idx="20">
                  <c:v>0.587891373187058</c:v>
                </c:pt>
                <c:pt idx="21">
                  <c:v>0.588926123381568</c:v>
                </c:pt>
                <c:pt idx="22">
                  <c:v>0.593063127685403</c:v>
                </c:pt>
                <c:pt idx="23">
                  <c:v>0.5870162748643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0-C93B-4450-837D-6C864E2FF8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485496"/>
        <c:axId val="2123488472"/>
      </c:barChart>
      <c:catAx>
        <c:axId val="21234854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3488472"/>
        <c:crosses val="autoZero"/>
        <c:auto val="1"/>
        <c:lblAlgn val="ctr"/>
        <c:lblOffset val="100"/>
        <c:noMultiLvlLbl val="0"/>
      </c:catAx>
      <c:valAx>
        <c:axId val="2123488472"/>
        <c:scaling>
          <c:orientation val="minMax"/>
          <c:max val="1.0"/>
          <c:min val="0.5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 baseline="0" dirty="0"/>
                  <a:t>Average T-values</a:t>
                </a:r>
                <a:endParaRPr lang="ja-JP" altLang="en-US" dirty="0"/>
              </a:p>
            </c:rich>
          </c:tx>
          <c:layout/>
          <c:overlay val="0"/>
        </c:title>
        <c:numFmt formatCode="#,##0.00_);[Red]\(#,##0.00\)" sourceLinked="1"/>
        <c:majorTickMark val="out"/>
        <c:minorTickMark val="none"/>
        <c:tickLblPos val="nextTo"/>
        <c:crossAx val="2123485496"/>
        <c:crosses val="autoZero"/>
        <c:crossBetween val="between"/>
        <c:majorUnit val="0.1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8527483068913"/>
          <c:y val="0.0328697850821745"/>
          <c:w val="0.579254342205755"/>
          <c:h val="0.4639949431099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T$3:$AA$3</c:f>
                <c:numCache>
                  <c:formatCode>General</c:formatCode>
                  <c:ptCount val="8"/>
                  <c:pt idx="0">
                    <c:v>2.84011907920663E-5</c:v>
                  </c:pt>
                  <c:pt idx="1">
                    <c:v>3.21167946176649E-5</c:v>
                  </c:pt>
                  <c:pt idx="2">
                    <c:v>4.04759226180318E-5</c:v>
                  </c:pt>
                  <c:pt idx="3">
                    <c:v>4.64707381339764E-5</c:v>
                  </c:pt>
                  <c:pt idx="4">
                    <c:v>5.29702702465593E-5</c:v>
                  </c:pt>
                  <c:pt idx="5">
                    <c:v>9.05090016664841E-5</c:v>
                  </c:pt>
                  <c:pt idx="6">
                    <c:v>8.24668951692868E-5</c:v>
                  </c:pt>
                  <c:pt idx="7">
                    <c:v>1.74978702728388E-5</c:v>
                  </c:pt>
                </c:numCache>
              </c:numRef>
            </c:plus>
            <c:minus>
              <c:numRef>
                <c:f>Sheet1!$T$3:$AA$3</c:f>
                <c:numCache>
                  <c:formatCode>General</c:formatCode>
                  <c:ptCount val="8"/>
                  <c:pt idx="0">
                    <c:v>2.84011907920663E-5</c:v>
                  </c:pt>
                  <c:pt idx="1">
                    <c:v>3.21167946176649E-5</c:v>
                  </c:pt>
                  <c:pt idx="2">
                    <c:v>4.04759226180318E-5</c:v>
                  </c:pt>
                  <c:pt idx="3">
                    <c:v>4.64707381339764E-5</c:v>
                  </c:pt>
                  <c:pt idx="4">
                    <c:v>5.29702702465593E-5</c:v>
                  </c:pt>
                  <c:pt idx="5">
                    <c:v>9.05090016664841E-5</c:v>
                  </c:pt>
                  <c:pt idx="6">
                    <c:v>8.24668951692868E-5</c:v>
                  </c:pt>
                  <c:pt idx="7">
                    <c:v>1.74978702728388E-5</c:v>
                  </c:pt>
                </c:numCache>
              </c:numRef>
            </c:minus>
          </c:errBars>
          <c:cat>
            <c:strRef>
              <c:f>Sheet1!$T$1:$AA$1</c:f>
              <c:strCache>
                <c:ptCount val="8"/>
                <c:pt idx="0">
                  <c:v>K27+ in both lines_x000d_</c:v>
                </c:pt>
                <c:pt idx="1">
                  <c:v>K27*</c:v>
                </c:pt>
                <c:pt idx="2">
                  <c:v>Species-conserved</c:v>
                </c:pt>
                <c:pt idx="3">
                  <c:v>Br-specific </c:v>
                </c:pt>
                <c:pt idx="4">
                  <c:v>Paralogous-conserved</c:v>
                </c:pt>
                <c:pt idx="5">
                  <c:v>Copy-specific_x000d_</c:v>
                </c:pt>
                <c:pt idx="6">
                  <c:v>Pair of copy-specific genes without H3K27me3_x000d_</c:v>
                </c:pt>
                <c:pt idx="7">
                  <c:v>Total</c:v>
                </c:pt>
              </c:strCache>
            </c:strRef>
          </c:cat>
          <c:val>
            <c:numRef>
              <c:f>Sheet1!$T$2:$AA$2</c:f>
              <c:numCache>
                <c:formatCode>General</c:formatCode>
                <c:ptCount val="8"/>
                <c:pt idx="0">
                  <c:v>0.00142033424086915</c:v>
                </c:pt>
                <c:pt idx="1">
                  <c:v>0.00139851915440982</c:v>
                </c:pt>
                <c:pt idx="2">
                  <c:v>0.00134625880466996</c:v>
                </c:pt>
                <c:pt idx="3">
                  <c:v>0.00153004411863468</c:v>
                </c:pt>
                <c:pt idx="4">
                  <c:v>0.00139242943994022</c:v>
                </c:pt>
                <c:pt idx="5">
                  <c:v>0.00158799043951139</c:v>
                </c:pt>
                <c:pt idx="6">
                  <c:v>0.00173727071559064</c:v>
                </c:pt>
                <c:pt idx="7">
                  <c:v>0.00186145666514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500152"/>
        <c:axId val="2122503272"/>
      </c:barChart>
      <c:catAx>
        <c:axId val="21225001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ja-JP"/>
          </a:p>
        </c:txPr>
        <c:crossAx val="2122503272"/>
        <c:crosses val="autoZero"/>
        <c:auto val="1"/>
        <c:lblAlgn val="ctr"/>
        <c:lblOffset val="100"/>
        <c:noMultiLvlLbl val="0"/>
      </c:catAx>
      <c:valAx>
        <c:axId val="212250327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SNPs</a:t>
                </a:r>
                <a:r>
                  <a:rPr lang="en-US" dirty="0" smtClean="0"/>
                  <a:t>/length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152793883011424"/>
              <c:y val="0.165771976561986"/>
            </c:manualLayout>
          </c:layout>
          <c:overlay val="0"/>
        </c:title>
        <c:numFmt formatCode="#,##0.0000_);[Red]\(#,##0.0000\)" sourceLinked="0"/>
        <c:majorTickMark val="out"/>
        <c:minorTickMark val="none"/>
        <c:tickLblPos val="nextTo"/>
        <c:crossAx val="21225001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85299307174307"/>
          <c:y val="0.0277777777777778"/>
          <c:w val="0.58007654790743"/>
          <c:h val="0.4611537620297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T$6:$AA$6</c:f>
                <c:numCache>
                  <c:formatCode>General</c:formatCode>
                  <c:ptCount val="8"/>
                  <c:pt idx="0">
                    <c:v>2.26866873176086E-5</c:v>
                  </c:pt>
                  <c:pt idx="1">
                    <c:v>2.58405183485683E-5</c:v>
                  </c:pt>
                  <c:pt idx="2">
                    <c:v>3.43615477073072E-5</c:v>
                  </c:pt>
                  <c:pt idx="3">
                    <c:v>3.62220575368058E-5</c:v>
                  </c:pt>
                  <c:pt idx="4">
                    <c:v>4.14154144726427E-5</c:v>
                  </c:pt>
                  <c:pt idx="5">
                    <c:v>6.5031470041007E-5</c:v>
                  </c:pt>
                  <c:pt idx="6">
                    <c:v>6.62964533898405E-5</c:v>
                  </c:pt>
                  <c:pt idx="7">
                    <c:v>1.40570071433328E-5</c:v>
                  </c:pt>
                </c:numCache>
              </c:numRef>
            </c:plus>
            <c:minus>
              <c:numRef>
                <c:f>Sheet1!$T$6:$AA$6</c:f>
                <c:numCache>
                  <c:formatCode>General</c:formatCode>
                  <c:ptCount val="8"/>
                  <c:pt idx="0">
                    <c:v>2.26866873176086E-5</c:v>
                  </c:pt>
                  <c:pt idx="1">
                    <c:v>2.58405183485683E-5</c:v>
                  </c:pt>
                  <c:pt idx="2">
                    <c:v>3.43615477073072E-5</c:v>
                  </c:pt>
                  <c:pt idx="3">
                    <c:v>3.62220575368058E-5</c:v>
                  </c:pt>
                  <c:pt idx="4">
                    <c:v>4.14154144726427E-5</c:v>
                  </c:pt>
                  <c:pt idx="5">
                    <c:v>6.5031470041007E-5</c:v>
                  </c:pt>
                  <c:pt idx="6">
                    <c:v>6.62964533898405E-5</c:v>
                  </c:pt>
                  <c:pt idx="7">
                    <c:v>1.40570071433328E-5</c:v>
                  </c:pt>
                </c:numCache>
              </c:numRef>
            </c:minus>
          </c:errBars>
          <c:cat>
            <c:strRef>
              <c:f>Sheet1!$T$1:$AA$1</c:f>
              <c:strCache>
                <c:ptCount val="8"/>
                <c:pt idx="0">
                  <c:v>K27+ in both lines_x000d_</c:v>
                </c:pt>
                <c:pt idx="1">
                  <c:v>K27*</c:v>
                </c:pt>
                <c:pt idx="2">
                  <c:v>Species-conserved</c:v>
                </c:pt>
                <c:pt idx="3">
                  <c:v>Br-specific </c:v>
                </c:pt>
                <c:pt idx="4">
                  <c:v>Paralogous-conserved</c:v>
                </c:pt>
                <c:pt idx="5">
                  <c:v>Copy-specific_x000d_</c:v>
                </c:pt>
                <c:pt idx="6">
                  <c:v>Pair of copy-specific genes without H3K27me3_x000d_</c:v>
                </c:pt>
                <c:pt idx="7">
                  <c:v>Total</c:v>
                </c:pt>
              </c:strCache>
            </c:strRef>
          </c:cat>
          <c:val>
            <c:numRef>
              <c:f>Sheet1!$T$5:$AA$5</c:f>
              <c:numCache>
                <c:formatCode>General</c:formatCode>
                <c:ptCount val="8"/>
                <c:pt idx="0">
                  <c:v>0.00109517195450468</c:v>
                </c:pt>
                <c:pt idx="1">
                  <c:v>0.00108209613086249</c:v>
                </c:pt>
                <c:pt idx="2">
                  <c:v>0.00107970897442285</c:v>
                </c:pt>
                <c:pt idx="3">
                  <c:v>0.00114718656891097</c:v>
                </c:pt>
                <c:pt idx="4">
                  <c:v>0.00102232057367297</c:v>
                </c:pt>
                <c:pt idx="5">
                  <c:v>0.00109188976329109</c:v>
                </c:pt>
                <c:pt idx="6">
                  <c:v>0.00129033015600628</c:v>
                </c:pt>
                <c:pt idx="7">
                  <c:v>0.001405763785082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602808"/>
        <c:axId val="2123583480"/>
      </c:barChart>
      <c:catAx>
        <c:axId val="2123602808"/>
        <c:scaling>
          <c:orientation val="minMax"/>
        </c:scaling>
        <c:delete val="0"/>
        <c:axPos val="b"/>
        <c:majorTickMark val="out"/>
        <c:minorTickMark val="none"/>
        <c:tickLblPos val="nextTo"/>
        <c:crossAx val="2123583480"/>
        <c:crosses val="autoZero"/>
        <c:auto val="1"/>
        <c:lblAlgn val="ctr"/>
        <c:lblOffset val="100"/>
        <c:noMultiLvlLbl val="0"/>
      </c:catAx>
      <c:valAx>
        <c:axId val="2123583480"/>
        <c:scaling>
          <c:orientation val="minMax"/>
          <c:max val="0.002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NPs/length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132071802108567"/>
              <c:y val="0.161193727813531"/>
            </c:manualLayout>
          </c:layout>
          <c:overlay val="0"/>
        </c:title>
        <c:numFmt formatCode="#,##0.0000_);[Red]\(#,##0.0000\)" sourceLinked="0"/>
        <c:majorTickMark val="out"/>
        <c:minorTickMark val="none"/>
        <c:tickLblPos val="nextTo"/>
        <c:crossAx val="2123602808"/>
        <c:crosses val="autoZero"/>
        <c:crossBetween val="between"/>
        <c:majorUnit val="0.0002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FLC</a:t>
            </a:r>
            <a:endParaRPr lang="ja-JP" i="1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I$5:$I$8</c:f>
                <c:numCache>
                  <c:formatCode>General</c:formatCode>
                  <c:ptCount val="4"/>
                  <c:pt idx="0">
                    <c:v>0.167870723603268</c:v>
                  </c:pt>
                  <c:pt idx="1">
                    <c:v>0.0190812316817657</c:v>
                  </c:pt>
                  <c:pt idx="2">
                    <c:v>0.3164764489222</c:v>
                  </c:pt>
                  <c:pt idx="3">
                    <c:v>0.206215114951323</c:v>
                  </c:pt>
                </c:numCache>
              </c:numRef>
            </c:plus>
            <c:minus>
              <c:numRef>
                <c:f>Sheet1!$I$5:$I$8</c:f>
                <c:numCache>
                  <c:formatCode>General</c:formatCode>
                  <c:ptCount val="4"/>
                  <c:pt idx="0">
                    <c:v>0.167870723603268</c:v>
                  </c:pt>
                  <c:pt idx="1">
                    <c:v>0.0190812316817657</c:v>
                  </c:pt>
                  <c:pt idx="2">
                    <c:v>0.3164764489222</c:v>
                  </c:pt>
                  <c:pt idx="3">
                    <c:v>0.206215114951323</c:v>
                  </c:pt>
                </c:numCache>
              </c:numRef>
            </c:minus>
          </c:errBars>
          <c:cat>
            <c:strRef>
              <c:f>Sheet1!$G$5:$G$8</c:f>
              <c:strCache>
                <c:ptCount val="4"/>
                <c:pt idx="0">
                  <c:v>2d-C</c:v>
                </c:pt>
                <c:pt idx="1">
                  <c:v>BrV1</c:v>
                </c:pt>
                <c:pt idx="2">
                  <c:v>14d-L</c:v>
                </c:pt>
                <c:pt idx="3">
                  <c:v>BrV2</c:v>
                </c:pt>
              </c:strCache>
            </c:strRef>
          </c:cat>
          <c:val>
            <c:numRef>
              <c:f>Sheet1!$H$5:$H$8</c:f>
              <c:numCache>
                <c:formatCode>0.00E+00</c:formatCode>
                <c:ptCount val="4"/>
                <c:pt idx="0">
                  <c:v>1.0</c:v>
                </c:pt>
                <c:pt idx="1">
                  <c:v>0.0758356000076067</c:v>
                </c:pt>
                <c:pt idx="2">
                  <c:v>4.6075010637621</c:v>
                </c:pt>
                <c:pt idx="3">
                  <c:v>0.8607205751374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874120"/>
        <c:axId val="2122881912"/>
      </c:barChart>
      <c:catAx>
        <c:axId val="21228741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2881912"/>
        <c:crosses val="autoZero"/>
        <c:auto val="1"/>
        <c:lblAlgn val="ctr"/>
        <c:lblOffset val="100"/>
        <c:noMultiLvlLbl val="0"/>
      </c:catAx>
      <c:valAx>
        <c:axId val="212288191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io (vs. 2d-C)</a:t>
                </a:r>
                <a:endParaRPr lang="ja-JP"/>
              </a:p>
            </c:rich>
          </c:tx>
          <c:layout/>
          <c:overlay val="0"/>
        </c:title>
        <c:numFmt formatCode="#,##0.0_);[Red]\(#,##0.0\)" sourceLinked="0"/>
        <c:majorTickMark val="out"/>
        <c:minorTickMark val="none"/>
        <c:tickLblPos val="nextTo"/>
        <c:crossAx val="21228741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SOC1</a:t>
            </a:r>
            <a:endParaRPr lang="ja-JP" i="1"/>
          </a:p>
        </c:rich>
      </c:tx>
      <c:layout>
        <c:manualLayout>
          <c:xMode val="edge"/>
          <c:yMode val="edge"/>
          <c:x val="0.502963939784227"/>
          <c:y val="0.048480261062661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I$30:$I$33</c:f>
                <c:numCache>
                  <c:formatCode>General</c:formatCode>
                  <c:ptCount val="4"/>
                  <c:pt idx="0">
                    <c:v>0.0888775000333549</c:v>
                  </c:pt>
                  <c:pt idx="1">
                    <c:v>2.67423891865231</c:v>
                  </c:pt>
                  <c:pt idx="2">
                    <c:v>4.91162878958387</c:v>
                  </c:pt>
                  <c:pt idx="3">
                    <c:v>17.23334550859695</c:v>
                  </c:pt>
                </c:numCache>
              </c:numRef>
            </c:plus>
            <c:minus>
              <c:numRef>
                <c:f>Sheet1!$I$30:$I$33</c:f>
                <c:numCache>
                  <c:formatCode>General</c:formatCode>
                  <c:ptCount val="4"/>
                  <c:pt idx="0">
                    <c:v>0.0888775000333549</c:v>
                  </c:pt>
                  <c:pt idx="1">
                    <c:v>2.67423891865231</c:v>
                  </c:pt>
                  <c:pt idx="2">
                    <c:v>4.91162878958387</c:v>
                  </c:pt>
                  <c:pt idx="3">
                    <c:v>17.23334550859695</c:v>
                  </c:pt>
                </c:numCache>
              </c:numRef>
            </c:minus>
          </c:errBars>
          <c:cat>
            <c:strRef>
              <c:f>Sheet1!$G$30:$G$33</c:f>
              <c:strCache>
                <c:ptCount val="4"/>
                <c:pt idx="0">
                  <c:v>2d-C</c:v>
                </c:pt>
                <c:pt idx="1">
                  <c:v>BrV1</c:v>
                </c:pt>
                <c:pt idx="2">
                  <c:v>14d-L</c:v>
                </c:pt>
                <c:pt idx="3">
                  <c:v>BrV2</c:v>
                </c:pt>
              </c:strCache>
            </c:strRef>
          </c:cat>
          <c:val>
            <c:numRef>
              <c:f>Sheet1!$H$30:$H$33</c:f>
              <c:numCache>
                <c:formatCode>0.00E+00</c:formatCode>
                <c:ptCount val="4"/>
                <c:pt idx="0">
                  <c:v>1.0</c:v>
                </c:pt>
                <c:pt idx="1">
                  <c:v>6.676834641094344</c:v>
                </c:pt>
                <c:pt idx="2">
                  <c:v>12.14180398074483</c:v>
                </c:pt>
                <c:pt idx="3">
                  <c:v>52.517342804983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424008"/>
        <c:axId val="2122426920"/>
      </c:barChart>
      <c:catAx>
        <c:axId val="21224240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2426920"/>
        <c:crosses val="autoZero"/>
        <c:auto val="1"/>
        <c:lblAlgn val="ctr"/>
        <c:lblOffset val="100"/>
        <c:noMultiLvlLbl val="0"/>
      </c:catAx>
      <c:valAx>
        <c:axId val="212242692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io (vs. 2d-C)</a:t>
                </a:r>
                <a:endParaRPr lang="ja-JP"/>
              </a:p>
            </c:rich>
          </c:tx>
          <c:layout/>
          <c:overlay val="0"/>
        </c:title>
        <c:numFmt formatCode="#,##0.0_);[Red]\(#,##0.0\)" sourceLinked="0"/>
        <c:majorTickMark val="out"/>
        <c:minorTickMark val="none"/>
        <c:tickLblPos val="nextTo"/>
        <c:crossAx val="21224240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VIN3</a:t>
            </a:r>
            <a:endParaRPr lang="ja-JP" i="1"/>
          </a:p>
        </c:rich>
      </c:tx>
      <c:layout>
        <c:manualLayout>
          <c:xMode val="edge"/>
          <c:yMode val="edge"/>
          <c:x val="0.494950733768328"/>
          <c:y val="0.055406012643041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I$53:$I$56</c:f>
                <c:numCache>
                  <c:formatCode>General</c:formatCode>
                  <c:ptCount val="4"/>
                  <c:pt idx="0">
                    <c:v>0.106101811713432</c:v>
                  </c:pt>
                  <c:pt idx="1">
                    <c:v>0.187779205279444</c:v>
                  </c:pt>
                  <c:pt idx="2">
                    <c:v>0.00150177782580381</c:v>
                  </c:pt>
                  <c:pt idx="3">
                    <c:v>0.0121546740332013</c:v>
                  </c:pt>
                </c:numCache>
              </c:numRef>
            </c:plus>
            <c:minus>
              <c:numRef>
                <c:f>Sheet1!$I$53:$I$56</c:f>
                <c:numCache>
                  <c:formatCode>General</c:formatCode>
                  <c:ptCount val="4"/>
                  <c:pt idx="0">
                    <c:v>0.106101811713432</c:v>
                  </c:pt>
                  <c:pt idx="1">
                    <c:v>0.187779205279444</c:v>
                  </c:pt>
                  <c:pt idx="2">
                    <c:v>0.00150177782580381</c:v>
                  </c:pt>
                  <c:pt idx="3">
                    <c:v>0.0121546740332013</c:v>
                  </c:pt>
                </c:numCache>
              </c:numRef>
            </c:minus>
          </c:errBars>
          <c:cat>
            <c:strRef>
              <c:f>Sheet1!$G$53:$G$56</c:f>
              <c:strCache>
                <c:ptCount val="4"/>
                <c:pt idx="0">
                  <c:v>2d-C</c:v>
                </c:pt>
                <c:pt idx="1">
                  <c:v>BrV1</c:v>
                </c:pt>
                <c:pt idx="2">
                  <c:v>14d-L</c:v>
                </c:pt>
                <c:pt idx="3">
                  <c:v>BrV2</c:v>
                </c:pt>
              </c:strCache>
            </c:strRef>
          </c:cat>
          <c:val>
            <c:numRef>
              <c:f>Sheet1!$H$53:$H$56</c:f>
              <c:numCache>
                <c:formatCode>0.00E+00</c:formatCode>
                <c:ptCount val="4"/>
                <c:pt idx="0">
                  <c:v>1.0</c:v>
                </c:pt>
                <c:pt idx="1">
                  <c:v>2.62449030831154</c:v>
                </c:pt>
                <c:pt idx="2">
                  <c:v>0.0147439274385126</c:v>
                </c:pt>
                <c:pt idx="3">
                  <c:v>0.1000485052600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460216"/>
        <c:axId val="2122463128"/>
      </c:barChart>
      <c:catAx>
        <c:axId val="21224602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2463128"/>
        <c:crosses val="autoZero"/>
        <c:auto val="1"/>
        <c:lblAlgn val="ctr"/>
        <c:lblOffset val="100"/>
        <c:noMultiLvlLbl val="0"/>
      </c:catAx>
      <c:valAx>
        <c:axId val="212246312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io (vs. 2d-C)</a:t>
                </a:r>
                <a:endParaRPr lang="ja-JP"/>
              </a:p>
            </c:rich>
          </c:tx>
          <c:layout/>
          <c:overlay val="0"/>
        </c:title>
        <c:numFmt formatCode="#,##0.0_);[Red]\(#,##0.0\)" sourceLinked="0"/>
        <c:majorTickMark val="out"/>
        <c:minorTickMark val="none"/>
        <c:tickLblPos val="nextTo"/>
        <c:crossAx val="21224602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i="1" dirty="0"/>
              <a:t>MAF</a:t>
            </a:r>
            <a:r>
              <a:rPr lang="en-US" dirty="0"/>
              <a:t> (Bra024350)</a:t>
            </a:r>
          </a:p>
        </c:rich>
      </c:tx>
      <c:layout>
        <c:manualLayout>
          <c:xMode val="edge"/>
          <c:yMode val="edge"/>
          <c:x val="0.358965208016045"/>
          <c:y val="0.055406012643041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I$74:$I$77</c:f>
                <c:numCache>
                  <c:formatCode>General</c:formatCode>
                  <c:ptCount val="4"/>
                  <c:pt idx="0">
                    <c:v>0.20264538138432</c:v>
                  </c:pt>
                  <c:pt idx="1">
                    <c:v>0.11944232659242</c:v>
                  </c:pt>
                  <c:pt idx="2">
                    <c:v>0.618841579499077</c:v>
                  </c:pt>
                  <c:pt idx="3">
                    <c:v>0.00863221091061942</c:v>
                  </c:pt>
                </c:numCache>
              </c:numRef>
            </c:plus>
            <c:minus>
              <c:numRef>
                <c:f>Sheet1!$I$74:$I$77</c:f>
                <c:numCache>
                  <c:formatCode>General</c:formatCode>
                  <c:ptCount val="4"/>
                  <c:pt idx="0">
                    <c:v>0.20264538138432</c:v>
                  </c:pt>
                  <c:pt idx="1">
                    <c:v>0.11944232659242</c:v>
                  </c:pt>
                  <c:pt idx="2">
                    <c:v>0.618841579499077</c:v>
                  </c:pt>
                  <c:pt idx="3">
                    <c:v>0.00863221091061942</c:v>
                  </c:pt>
                </c:numCache>
              </c:numRef>
            </c:minus>
          </c:errBars>
          <c:cat>
            <c:strRef>
              <c:f>Sheet1!$G$74:$G$77</c:f>
              <c:strCache>
                <c:ptCount val="4"/>
                <c:pt idx="0">
                  <c:v>2d-C</c:v>
                </c:pt>
                <c:pt idx="1">
                  <c:v>BrV1</c:v>
                </c:pt>
                <c:pt idx="2">
                  <c:v>14d-L</c:v>
                </c:pt>
                <c:pt idx="3">
                  <c:v>BrV2</c:v>
                </c:pt>
              </c:strCache>
            </c:strRef>
          </c:cat>
          <c:val>
            <c:numRef>
              <c:f>Sheet1!$H$74:$H$77</c:f>
              <c:numCache>
                <c:formatCode>0.00E+00</c:formatCode>
                <c:ptCount val="4"/>
                <c:pt idx="0">
                  <c:v>1.0</c:v>
                </c:pt>
                <c:pt idx="1">
                  <c:v>0.716117626583681</c:v>
                </c:pt>
                <c:pt idx="2">
                  <c:v>2.243058878104793</c:v>
                </c:pt>
                <c:pt idx="3">
                  <c:v>0.1287488993751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348264"/>
        <c:axId val="2122351176"/>
      </c:barChart>
      <c:catAx>
        <c:axId val="21223482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2351176"/>
        <c:crosses val="autoZero"/>
        <c:auto val="1"/>
        <c:lblAlgn val="ctr"/>
        <c:lblOffset val="100"/>
        <c:noMultiLvlLbl val="0"/>
      </c:catAx>
      <c:valAx>
        <c:axId val="212235117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io (vs. 2d-C)</a:t>
                </a:r>
              </a:p>
            </c:rich>
          </c:tx>
          <c:layout/>
          <c:overlay val="0"/>
        </c:title>
        <c:numFmt formatCode="#,##0.0_);[Red]\(#,##0.0\)" sourceLinked="0"/>
        <c:majorTickMark val="out"/>
        <c:minorTickMark val="none"/>
        <c:tickLblPos val="nextTo"/>
        <c:crossAx val="21223482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i="1" dirty="0"/>
              <a:t>MAF</a:t>
            </a:r>
            <a:r>
              <a:rPr lang="en-US" dirty="0"/>
              <a:t> (Bra024351)</a:t>
            </a:r>
            <a:endParaRPr lang="ja-JP" dirty="0"/>
          </a:p>
        </c:rich>
      </c:tx>
      <c:layout>
        <c:manualLayout>
          <c:xMode val="edge"/>
          <c:yMode val="edge"/>
          <c:x val="0.363973461775982"/>
          <c:y val="0.048480261062661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I$95:$I$98</c:f>
                <c:numCache>
                  <c:formatCode>General</c:formatCode>
                  <c:ptCount val="4"/>
                  <c:pt idx="0">
                    <c:v>0.189328930241069</c:v>
                  </c:pt>
                  <c:pt idx="1">
                    <c:v>0.0317550764344648</c:v>
                  </c:pt>
                  <c:pt idx="2">
                    <c:v>0.11748382516585</c:v>
                  </c:pt>
                  <c:pt idx="3">
                    <c:v>0.0112183329724463</c:v>
                  </c:pt>
                </c:numCache>
              </c:numRef>
            </c:plus>
            <c:minus>
              <c:numRef>
                <c:f>Sheet1!$I$95:$I$98</c:f>
                <c:numCache>
                  <c:formatCode>General</c:formatCode>
                  <c:ptCount val="4"/>
                  <c:pt idx="0">
                    <c:v>0.189328930241069</c:v>
                  </c:pt>
                  <c:pt idx="1">
                    <c:v>0.0317550764344648</c:v>
                  </c:pt>
                  <c:pt idx="2">
                    <c:v>0.11748382516585</c:v>
                  </c:pt>
                  <c:pt idx="3">
                    <c:v>0.0112183329724463</c:v>
                  </c:pt>
                </c:numCache>
              </c:numRef>
            </c:minus>
          </c:errBars>
          <c:cat>
            <c:strRef>
              <c:f>Sheet1!$G$95:$G$98</c:f>
              <c:strCache>
                <c:ptCount val="4"/>
                <c:pt idx="0">
                  <c:v>2d-C</c:v>
                </c:pt>
                <c:pt idx="1">
                  <c:v>BrV1</c:v>
                </c:pt>
                <c:pt idx="2">
                  <c:v>14d-L</c:v>
                </c:pt>
                <c:pt idx="3">
                  <c:v>BrV2</c:v>
                </c:pt>
              </c:strCache>
            </c:strRef>
          </c:cat>
          <c:val>
            <c:numRef>
              <c:f>Sheet1!$H$95:$H$98</c:f>
              <c:numCache>
                <c:formatCode>0.00E+00</c:formatCode>
                <c:ptCount val="4"/>
                <c:pt idx="0">
                  <c:v>1.0</c:v>
                </c:pt>
                <c:pt idx="1">
                  <c:v>0.234097992606147</c:v>
                </c:pt>
                <c:pt idx="2">
                  <c:v>0.918352108971107</c:v>
                </c:pt>
                <c:pt idx="3">
                  <c:v>0.133173411598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383208"/>
        <c:axId val="2122386120"/>
      </c:barChart>
      <c:catAx>
        <c:axId val="21223832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2386120"/>
        <c:crosses val="autoZero"/>
        <c:auto val="1"/>
        <c:lblAlgn val="ctr"/>
        <c:lblOffset val="100"/>
        <c:noMultiLvlLbl val="0"/>
      </c:catAx>
      <c:valAx>
        <c:axId val="212238612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io (vs. 2d-C)</a:t>
                </a:r>
                <a:endParaRPr lang="ja-JP"/>
              </a:p>
            </c:rich>
          </c:tx>
          <c:layout/>
          <c:overlay val="0"/>
        </c:title>
        <c:numFmt formatCode="#,##0.0_);[Red]\(#,##0.0\)" sourceLinked="0"/>
        <c:majorTickMark val="out"/>
        <c:minorTickMark val="none"/>
        <c:tickLblPos val="nextTo"/>
        <c:crossAx val="21223832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i="1" dirty="0"/>
              <a:t>MAF</a:t>
            </a:r>
            <a:r>
              <a:rPr lang="en-US" dirty="0"/>
              <a:t> (Bra031888)</a:t>
            </a:r>
            <a:endParaRPr lang="ja-JP" dirty="0"/>
          </a:p>
        </c:rich>
      </c:tx>
      <c:layout>
        <c:manualLayout>
          <c:xMode val="edge"/>
          <c:yMode val="edge"/>
          <c:x val="0.389014730575665"/>
          <c:y val="0.0692575158038016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I$117:$I$120</c:f>
                <c:numCache>
                  <c:formatCode>General</c:formatCode>
                  <c:ptCount val="4"/>
                  <c:pt idx="0">
                    <c:v>0.0576498588371119</c:v>
                  </c:pt>
                  <c:pt idx="1">
                    <c:v>0.099102873655219</c:v>
                  </c:pt>
                  <c:pt idx="2">
                    <c:v>0.0479170250319434</c:v>
                  </c:pt>
                  <c:pt idx="3">
                    <c:v>0.0165617225934931</c:v>
                  </c:pt>
                </c:numCache>
              </c:numRef>
            </c:plus>
            <c:minus>
              <c:numRef>
                <c:f>Sheet1!$I$117:$I$120</c:f>
                <c:numCache>
                  <c:formatCode>General</c:formatCode>
                  <c:ptCount val="4"/>
                  <c:pt idx="0">
                    <c:v>0.0576498588371119</c:v>
                  </c:pt>
                  <c:pt idx="1">
                    <c:v>0.099102873655219</c:v>
                  </c:pt>
                  <c:pt idx="2">
                    <c:v>0.0479170250319434</c:v>
                  </c:pt>
                  <c:pt idx="3">
                    <c:v>0.0165617225934931</c:v>
                  </c:pt>
                </c:numCache>
              </c:numRef>
            </c:minus>
          </c:errBars>
          <c:cat>
            <c:strRef>
              <c:f>Sheet1!$G$117:$G$120</c:f>
              <c:strCache>
                <c:ptCount val="4"/>
                <c:pt idx="0">
                  <c:v>2d-C</c:v>
                </c:pt>
                <c:pt idx="1">
                  <c:v>BrV1</c:v>
                </c:pt>
                <c:pt idx="2">
                  <c:v>14d-L</c:v>
                </c:pt>
                <c:pt idx="3">
                  <c:v>BrV2</c:v>
                </c:pt>
              </c:strCache>
            </c:strRef>
          </c:cat>
          <c:val>
            <c:numRef>
              <c:f>Sheet1!$H$117:$H$120</c:f>
              <c:numCache>
                <c:formatCode>0.00E+00</c:formatCode>
                <c:ptCount val="4"/>
                <c:pt idx="0">
                  <c:v>1.0</c:v>
                </c:pt>
                <c:pt idx="1">
                  <c:v>0.352344581978298</c:v>
                </c:pt>
                <c:pt idx="2">
                  <c:v>0.393464260259422</c:v>
                </c:pt>
                <c:pt idx="3">
                  <c:v>0.09182349747852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340568"/>
        <c:axId val="2125471160"/>
      </c:barChart>
      <c:catAx>
        <c:axId val="21223405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5471160"/>
        <c:crosses val="autoZero"/>
        <c:auto val="1"/>
        <c:lblAlgn val="ctr"/>
        <c:lblOffset val="100"/>
        <c:noMultiLvlLbl val="0"/>
      </c:catAx>
      <c:valAx>
        <c:axId val="212547116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io (vs. 2d-C)</a:t>
                </a:r>
                <a:endParaRPr lang="ja-JP"/>
              </a:p>
            </c:rich>
          </c:tx>
          <c:layout/>
          <c:overlay val="0"/>
        </c:title>
        <c:numFmt formatCode="#,##0.0_);[Red]\(#,##0.0\)" sourceLinked="0"/>
        <c:majorTickMark val="out"/>
        <c:minorTickMark val="none"/>
        <c:tickLblPos val="nextTo"/>
        <c:crossAx val="21223405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i="1"/>
              <a:t>STM</a:t>
            </a:r>
            <a:r>
              <a:rPr lang="en-US" sz="1200"/>
              <a:t> (Bra027050)</a:t>
            </a:r>
            <a:endParaRPr lang="ja-JP" sz="1200"/>
          </a:p>
        </c:rich>
      </c:tx>
      <c:layout>
        <c:manualLayout>
          <c:xMode val="edge"/>
          <c:yMode val="edge"/>
          <c:x val="0.365970933338674"/>
          <c:y val="0.0416666666666667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rgbClr val="3366FF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3366FF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09ADDD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09ADDD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まとめ!$C$5:$H$5</c:f>
                <c:numCache>
                  <c:formatCode>General</c:formatCode>
                  <c:ptCount val="6"/>
                  <c:pt idx="0">
                    <c:v>0.41655622752321</c:v>
                  </c:pt>
                  <c:pt idx="1">
                    <c:v>0.462900140498116</c:v>
                  </c:pt>
                  <c:pt idx="2">
                    <c:v>0.394648863135206</c:v>
                  </c:pt>
                  <c:pt idx="3">
                    <c:v>0.144153551109982</c:v>
                  </c:pt>
                  <c:pt idx="4">
                    <c:v>0.540467757032662</c:v>
                  </c:pt>
                  <c:pt idx="5">
                    <c:v>0.447761683294217</c:v>
                  </c:pt>
                </c:numCache>
              </c:numRef>
            </c:plus>
            <c:minus>
              <c:numRef>
                <c:f>まとめ!$C$5:$H$5</c:f>
                <c:numCache>
                  <c:formatCode>General</c:formatCode>
                  <c:ptCount val="6"/>
                  <c:pt idx="0">
                    <c:v>0.41655622752321</c:v>
                  </c:pt>
                  <c:pt idx="1">
                    <c:v>0.462900140498116</c:v>
                  </c:pt>
                  <c:pt idx="2">
                    <c:v>0.394648863135206</c:v>
                  </c:pt>
                  <c:pt idx="3">
                    <c:v>0.144153551109982</c:v>
                  </c:pt>
                  <c:pt idx="4">
                    <c:v>0.540467757032662</c:v>
                  </c:pt>
                  <c:pt idx="5">
                    <c:v>0.447761683294217</c:v>
                  </c:pt>
                </c:numCache>
              </c:numRef>
            </c:minus>
          </c:errBars>
          <c:cat>
            <c:multiLvlStrRef>
              <c:f>まとめ!$C$2:$H$3</c:f>
              <c:multiLvlStrCache>
                <c:ptCount val="6"/>
                <c:lvl>
                  <c:pt idx="0">
                    <c:v>2d-C</c:v>
                  </c:pt>
                  <c:pt idx="1">
                    <c:v>14d-L</c:v>
                  </c:pt>
                  <c:pt idx="2">
                    <c:v>2d-C</c:v>
                  </c:pt>
                  <c:pt idx="3">
                    <c:v>14d-L</c:v>
                  </c:pt>
                  <c:pt idx="4">
                    <c:v>BrV1</c:v>
                  </c:pt>
                  <c:pt idx="5">
                    <c:v>BrV2</c:v>
                  </c:pt>
                </c:lvl>
                <c:lvl>
                  <c:pt idx="0">
                    <c:v>RJKB-T23</c:v>
                  </c:pt>
                  <c:pt idx="2">
                    <c:v>RJKB-T24</c:v>
                  </c:pt>
                </c:lvl>
              </c:multiLvlStrCache>
            </c:multiLvlStrRef>
          </c:cat>
          <c:val>
            <c:numRef>
              <c:f>まとめ!$C$4:$H$4</c:f>
              <c:numCache>
                <c:formatCode>General</c:formatCode>
                <c:ptCount val="6"/>
                <c:pt idx="0">
                  <c:v>16.04382494050514</c:v>
                </c:pt>
                <c:pt idx="1">
                  <c:v>14.88890873955754</c:v>
                </c:pt>
                <c:pt idx="2">
                  <c:v>15.22296865041257</c:v>
                </c:pt>
                <c:pt idx="3">
                  <c:v>14.762409974042</c:v>
                </c:pt>
                <c:pt idx="4">
                  <c:v>14.97865476961416</c:v>
                </c:pt>
                <c:pt idx="5">
                  <c:v>16.816500573462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5447128"/>
        <c:axId val="2085450104"/>
      </c:barChart>
      <c:catAx>
        <c:axId val="20854471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85450104"/>
        <c:crosses val="autoZero"/>
        <c:auto val="1"/>
        <c:lblAlgn val="ctr"/>
        <c:lblOffset val="100"/>
        <c:noMultiLvlLbl val="0"/>
      </c:catAx>
      <c:valAx>
        <c:axId val="2085450104"/>
        <c:scaling>
          <c:orientation val="minMax"/>
          <c:max val="18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Enrichment</a:t>
                </a:r>
              </a:p>
              <a:p>
                <a:pPr>
                  <a:defRPr/>
                </a:pPr>
                <a:r>
                  <a:rPr lang="en-US"/>
                  <a:t> (vs. Bra013206 &amp; Bra028913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854471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FT</a:t>
            </a:r>
            <a:endParaRPr lang="ja-JP" i="1"/>
          </a:p>
        </c:rich>
      </c:tx>
      <c:layout>
        <c:manualLayout>
          <c:xMode val="edge"/>
          <c:yMode val="edge"/>
          <c:x val="0.564099732866843"/>
          <c:y val="0.0699710253840555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Sheet1!$J$139:$J$142</c:f>
                <c:numCache>
                  <c:formatCode>General</c:formatCode>
                  <c:ptCount val="4"/>
                  <c:pt idx="0">
                    <c:v>0.103536776384031</c:v>
                  </c:pt>
                  <c:pt idx="1">
                    <c:v>1.347626873712869</c:v>
                  </c:pt>
                  <c:pt idx="2">
                    <c:v>0.142867193293875</c:v>
                  </c:pt>
                  <c:pt idx="3">
                    <c:v>0.536176520810888</c:v>
                  </c:pt>
                </c:numCache>
              </c:numRef>
            </c:plus>
            <c:minus>
              <c:numRef>
                <c:f>Sheet1!$J$139:$J$142</c:f>
                <c:numCache>
                  <c:formatCode>General</c:formatCode>
                  <c:ptCount val="4"/>
                  <c:pt idx="0">
                    <c:v>0.103536776384031</c:v>
                  </c:pt>
                  <c:pt idx="1">
                    <c:v>1.347626873712869</c:v>
                  </c:pt>
                  <c:pt idx="2">
                    <c:v>0.142867193293875</c:v>
                  </c:pt>
                  <c:pt idx="3">
                    <c:v>0.536176520810888</c:v>
                  </c:pt>
                </c:numCache>
              </c:numRef>
            </c:minus>
          </c:errBars>
          <c:cat>
            <c:strRef>
              <c:f>Sheet1!$H$139:$H$142</c:f>
              <c:strCache>
                <c:ptCount val="4"/>
                <c:pt idx="0">
                  <c:v>2d-C</c:v>
                </c:pt>
                <c:pt idx="1">
                  <c:v>BrV1</c:v>
                </c:pt>
                <c:pt idx="2">
                  <c:v>14d-L</c:v>
                </c:pt>
                <c:pt idx="3">
                  <c:v>BrV2</c:v>
                </c:pt>
              </c:strCache>
            </c:strRef>
          </c:cat>
          <c:val>
            <c:numRef>
              <c:f>Sheet1!$I$139:$I$142</c:f>
              <c:numCache>
                <c:formatCode>#,##0.00_);[Red]\(#,##0.00\)</c:formatCode>
                <c:ptCount val="4"/>
                <c:pt idx="0">
                  <c:v>1.0</c:v>
                </c:pt>
                <c:pt idx="1">
                  <c:v>3.614750114394277</c:v>
                </c:pt>
                <c:pt idx="2">
                  <c:v>1.313194166116558</c:v>
                </c:pt>
                <c:pt idx="3">
                  <c:v>2.4081220880328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5503160"/>
        <c:axId val="2125505960"/>
      </c:barChart>
      <c:catAx>
        <c:axId val="2125503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5505960"/>
        <c:crosses val="autoZero"/>
        <c:auto val="1"/>
        <c:lblAlgn val="ctr"/>
        <c:lblOffset val="100"/>
        <c:noMultiLvlLbl val="0"/>
      </c:catAx>
      <c:valAx>
        <c:axId val="212550596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io (vs. 2d-C)</a:t>
                </a:r>
                <a:endParaRPr lang="ja-JP"/>
              </a:p>
            </c:rich>
          </c:tx>
          <c:layout/>
          <c:overlay val="0"/>
        </c:title>
        <c:numFmt formatCode="#,##0.0;[Red]\-#,##0.0" sourceLinked="0"/>
        <c:majorTickMark val="out"/>
        <c:minorTickMark val="none"/>
        <c:tickLblPos val="nextTo"/>
        <c:crossAx val="21255031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RJKB-T24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G$1</c:f>
              <c:strCache>
                <c:ptCount val="1"/>
                <c:pt idx="0">
                  <c:v>ip.w.rep2</c:v>
                </c:pt>
              </c:strCache>
            </c:strRef>
          </c:tx>
          <c:spPr>
            <a:ln w="47625">
              <a:noFill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D$2:$D$2579</c:f>
              <c:numCache>
                <c:formatCode>General</c:formatCode>
                <c:ptCount val="2578"/>
                <c:pt idx="0">
                  <c:v>4.13931</c:v>
                </c:pt>
                <c:pt idx="1">
                  <c:v>5.43899</c:v>
                </c:pt>
                <c:pt idx="2">
                  <c:v>6.853089999999995</c:v>
                </c:pt>
                <c:pt idx="3">
                  <c:v>4.362099999999986</c:v>
                </c:pt>
                <c:pt idx="4">
                  <c:v>6.97222</c:v>
                </c:pt>
                <c:pt idx="5">
                  <c:v>5.897349999999998</c:v>
                </c:pt>
                <c:pt idx="6">
                  <c:v>10.1908</c:v>
                </c:pt>
                <c:pt idx="7">
                  <c:v>4.67911</c:v>
                </c:pt>
                <c:pt idx="8">
                  <c:v>4.0498</c:v>
                </c:pt>
                <c:pt idx="9">
                  <c:v>4.118449999999997</c:v>
                </c:pt>
                <c:pt idx="10">
                  <c:v>5.6537</c:v>
                </c:pt>
                <c:pt idx="11">
                  <c:v>7.310099999999998</c:v>
                </c:pt>
                <c:pt idx="12">
                  <c:v>2.7932</c:v>
                </c:pt>
                <c:pt idx="13">
                  <c:v>5.09035</c:v>
                </c:pt>
                <c:pt idx="14">
                  <c:v>4.88305</c:v>
                </c:pt>
                <c:pt idx="15">
                  <c:v>4.95372</c:v>
                </c:pt>
                <c:pt idx="16">
                  <c:v>4.10903</c:v>
                </c:pt>
                <c:pt idx="17">
                  <c:v>2.58253</c:v>
                </c:pt>
                <c:pt idx="18">
                  <c:v>3.91115</c:v>
                </c:pt>
                <c:pt idx="19">
                  <c:v>2.20292</c:v>
                </c:pt>
                <c:pt idx="20">
                  <c:v>4.74372</c:v>
                </c:pt>
                <c:pt idx="21">
                  <c:v>3.46693</c:v>
                </c:pt>
                <c:pt idx="22">
                  <c:v>2.95271</c:v>
                </c:pt>
                <c:pt idx="23">
                  <c:v>9.25793</c:v>
                </c:pt>
                <c:pt idx="24">
                  <c:v>3.30741</c:v>
                </c:pt>
                <c:pt idx="25">
                  <c:v>4.47315</c:v>
                </c:pt>
                <c:pt idx="26">
                  <c:v>3.349819999999998</c:v>
                </c:pt>
                <c:pt idx="27">
                  <c:v>3.11626</c:v>
                </c:pt>
                <c:pt idx="28">
                  <c:v>6.90357</c:v>
                </c:pt>
                <c:pt idx="29">
                  <c:v>4.91266</c:v>
                </c:pt>
                <c:pt idx="30">
                  <c:v>3.94682</c:v>
                </c:pt>
                <c:pt idx="31">
                  <c:v>3.94884</c:v>
                </c:pt>
                <c:pt idx="32">
                  <c:v>2.68416</c:v>
                </c:pt>
                <c:pt idx="33">
                  <c:v>5.307749999999999</c:v>
                </c:pt>
                <c:pt idx="34">
                  <c:v>3.460869999999999</c:v>
                </c:pt>
                <c:pt idx="35">
                  <c:v>4.53642</c:v>
                </c:pt>
                <c:pt idx="36">
                  <c:v>3.803459999999998</c:v>
                </c:pt>
                <c:pt idx="37">
                  <c:v>4.54652</c:v>
                </c:pt>
                <c:pt idx="38">
                  <c:v>5.167749999999987</c:v>
                </c:pt>
                <c:pt idx="39">
                  <c:v>5.57697</c:v>
                </c:pt>
                <c:pt idx="40">
                  <c:v>6.620209999999997</c:v>
                </c:pt>
                <c:pt idx="41">
                  <c:v>6.77569</c:v>
                </c:pt>
                <c:pt idx="42">
                  <c:v>3.95759</c:v>
                </c:pt>
                <c:pt idx="43">
                  <c:v>7.15462</c:v>
                </c:pt>
                <c:pt idx="44">
                  <c:v>4.02961</c:v>
                </c:pt>
                <c:pt idx="45">
                  <c:v>8.10969</c:v>
                </c:pt>
                <c:pt idx="46">
                  <c:v>2.63099</c:v>
                </c:pt>
                <c:pt idx="47">
                  <c:v>3.45616</c:v>
                </c:pt>
                <c:pt idx="48">
                  <c:v>4.2995</c:v>
                </c:pt>
                <c:pt idx="49">
                  <c:v>3.19165</c:v>
                </c:pt>
                <c:pt idx="50">
                  <c:v>5.299</c:v>
                </c:pt>
                <c:pt idx="51">
                  <c:v>3.0005</c:v>
                </c:pt>
                <c:pt idx="52">
                  <c:v>5.856959999999995</c:v>
                </c:pt>
                <c:pt idx="53">
                  <c:v>5.37976</c:v>
                </c:pt>
                <c:pt idx="54">
                  <c:v>3.81759</c:v>
                </c:pt>
                <c:pt idx="55">
                  <c:v>4.04239</c:v>
                </c:pt>
                <c:pt idx="56">
                  <c:v>4.42267</c:v>
                </c:pt>
                <c:pt idx="57">
                  <c:v>2.14504</c:v>
                </c:pt>
                <c:pt idx="58">
                  <c:v>2.352339999999998</c:v>
                </c:pt>
                <c:pt idx="59">
                  <c:v>4.48392</c:v>
                </c:pt>
                <c:pt idx="60">
                  <c:v>3.06982</c:v>
                </c:pt>
                <c:pt idx="61">
                  <c:v>3.36732</c:v>
                </c:pt>
                <c:pt idx="62">
                  <c:v>3.15732</c:v>
                </c:pt>
                <c:pt idx="63">
                  <c:v>4.344599999999994</c:v>
                </c:pt>
                <c:pt idx="64">
                  <c:v>4.90795</c:v>
                </c:pt>
                <c:pt idx="65">
                  <c:v>4.20124</c:v>
                </c:pt>
                <c:pt idx="66">
                  <c:v>6.42974</c:v>
                </c:pt>
                <c:pt idx="67">
                  <c:v>5.59178</c:v>
                </c:pt>
                <c:pt idx="68">
                  <c:v>5.167749999999987</c:v>
                </c:pt>
                <c:pt idx="69">
                  <c:v>2.931169999999998</c:v>
                </c:pt>
                <c:pt idx="70">
                  <c:v>2.06831</c:v>
                </c:pt>
                <c:pt idx="71">
                  <c:v>3.3801</c:v>
                </c:pt>
                <c:pt idx="72">
                  <c:v>5.08362</c:v>
                </c:pt>
                <c:pt idx="73">
                  <c:v>5.04862</c:v>
                </c:pt>
                <c:pt idx="74">
                  <c:v>4.122489999999964</c:v>
                </c:pt>
                <c:pt idx="75">
                  <c:v>3.48779</c:v>
                </c:pt>
                <c:pt idx="76">
                  <c:v>5.9384</c:v>
                </c:pt>
                <c:pt idx="77">
                  <c:v>2.51791</c:v>
                </c:pt>
                <c:pt idx="78">
                  <c:v>3.7099</c:v>
                </c:pt>
                <c:pt idx="79">
                  <c:v>2.2184</c:v>
                </c:pt>
                <c:pt idx="80">
                  <c:v>2.82483</c:v>
                </c:pt>
                <c:pt idx="81">
                  <c:v>2.04273</c:v>
                </c:pt>
                <c:pt idx="82">
                  <c:v>6.826169999999998</c:v>
                </c:pt>
                <c:pt idx="83">
                  <c:v>4.84535</c:v>
                </c:pt>
                <c:pt idx="84">
                  <c:v>5.29563</c:v>
                </c:pt>
                <c:pt idx="85">
                  <c:v>4.81237</c:v>
                </c:pt>
                <c:pt idx="86">
                  <c:v>3.14386</c:v>
                </c:pt>
                <c:pt idx="87">
                  <c:v>1.61467</c:v>
                </c:pt>
                <c:pt idx="88">
                  <c:v>2.0636</c:v>
                </c:pt>
                <c:pt idx="89">
                  <c:v>2.60878</c:v>
                </c:pt>
                <c:pt idx="90">
                  <c:v>3.119629999999999</c:v>
                </c:pt>
                <c:pt idx="91">
                  <c:v>2.932519999999998</c:v>
                </c:pt>
                <c:pt idx="92">
                  <c:v>1.82466</c:v>
                </c:pt>
                <c:pt idx="93">
                  <c:v>2.41628</c:v>
                </c:pt>
                <c:pt idx="94">
                  <c:v>4.33585</c:v>
                </c:pt>
                <c:pt idx="95">
                  <c:v>3.176839999999999</c:v>
                </c:pt>
                <c:pt idx="96">
                  <c:v>3.2004</c:v>
                </c:pt>
                <c:pt idx="97">
                  <c:v>3.44472</c:v>
                </c:pt>
                <c:pt idx="98">
                  <c:v>2.42571</c:v>
                </c:pt>
                <c:pt idx="99">
                  <c:v>3.55039</c:v>
                </c:pt>
                <c:pt idx="100">
                  <c:v>3.15328</c:v>
                </c:pt>
                <c:pt idx="101">
                  <c:v>2.27494</c:v>
                </c:pt>
                <c:pt idx="102">
                  <c:v>2.6283</c:v>
                </c:pt>
                <c:pt idx="103">
                  <c:v>3.434619999999998</c:v>
                </c:pt>
                <c:pt idx="104">
                  <c:v>5.762729999999998</c:v>
                </c:pt>
                <c:pt idx="105">
                  <c:v>2.21302</c:v>
                </c:pt>
                <c:pt idx="106">
                  <c:v>3.35991</c:v>
                </c:pt>
                <c:pt idx="107">
                  <c:v>3.24953</c:v>
                </c:pt>
                <c:pt idx="108">
                  <c:v>2.7131</c:v>
                </c:pt>
                <c:pt idx="109">
                  <c:v>3.16001</c:v>
                </c:pt>
                <c:pt idx="110">
                  <c:v>2.23523</c:v>
                </c:pt>
                <c:pt idx="111">
                  <c:v>3.20713</c:v>
                </c:pt>
                <c:pt idx="112">
                  <c:v>2.16994</c:v>
                </c:pt>
                <c:pt idx="113">
                  <c:v>4.118449999999997</c:v>
                </c:pt>
                <c:pt idx="114">
                  <c:v>2.28571</c:v>
                </c:pt>
                <c:pt idx="115">
                  <c:v>2.53878</c:v>
                </c:pt>
                <c:pt idx="116">
                  <c:v>1.84687</c:v>
                </c:pt>
                <c:pt idx="117">
                  <c:v>2.458689999999998</c:v>
                </c:pt>
                <c:pt idx="118">
                  <c:v>2.559639999999999</c:v>
                </c:pt>
                <c:pt idx="119">
                  <c:v>5.0116</c:v>
                </c:pt>
                <c:pt idx="120">
                  <c:v>2.06898</c:v>
                </c:pt>
                <c:pt idx="121">
                  <c:v>2.65455</c:v>
                </c:pt>
                <c:pt idx="122">
                  <c:v>1.77284</c:v>
                </c:pt>
                <c:pt idx="123">
                  <c:v>2.72118</c:v>
                </c:pt>
                <c:pt idx="124">
                  <c:v>1.69476</c:v>
                </c:pt>
                <c:pt idx="125">
                  <c:v>1.05738</c:v>
                </c:pt>
                <c:pt idx="126">
                  <c:v>1.47669</c:v>
                </c:pt>
                <c:pt idx="127">
                  <c:v>1.51842</c:v>
                </c:pt>
                <c:pt idx="128">
                  <c:v>2.31734</c:v>
                </c:pt>
                <c:pt idx="129">
                  <c:v>1.90005</c:v>
                </c:pt>
                <c:pt idx="130">
                  <c:v>1.52515</c:v>
                </c:pt>
                <c:pt idx="131">
                  <c:v>1.38785</c:v>
                </c:pt>
                <c:pt idx="132">
                  <c:v>1.92697</c:v>
                </c:pt>
                <c:pt idx="133">
                  <c:v>1.13074</c:v>
                </c:pt>
                <c:pt idx="134">
                  <c:v>1.99427</c:v>
                </c:pt>
                <c:pt idx="135">
                  <c:v>3.51539</c:v>
                </c:pt>
                <c:pt idx="136">
                  <c:v>2.85848</c:v>
                </c:pt>
                <c:pt idx="137">
                  <c:v>2.949349999999999</c:v>
                </c:pt>
                <c:pt idx="138">
                  <c:v>1.47467</c:v>
                </c:pt>
                <c:pt idx="139">
                  <c:v>2.60407</c:v>
                </c:pt>
                <c:pt idx="140">
                  <c:v>2.74608</c:v>
                </c:pt>
                <c:pt idx="141">
                  <c:v>1.87985</c:v>
                </c:pt>
                <c:pt idx="142">
                  <c:v>2.40686</c:v>
                </c:pt>
                <c:pt idx="143">
                  <c:v>1.24516</c:v>
                </c:pt>
                <c:pt idx="144">
                  <c:v>1.80784</c:v>
                </c:pt>
                <c:pt idx="145">
                  <c:v>2.14639</c:v>
                </c:pt>
                <c:pt idx="146">
                  <c:v>1.87178</c:v>
                </c:pt>
                <c:pt idx="147">
                  <c:v>2.97492</c:v>
                </c:pt>
                <c:pt idx="148">
                  <c:v>2.20427</c:v>
                </c:pt>
                <c:pt idx="149">
                  <c:v>1.75467</c:v>
                </c:pt>
                <c:pt idx="150">
                  <c:v>4.187099999999996</c:v>
                </c:pt>
                <c:pt idx="151">
                  <c:v>2.515899999999998</c:v>
                </c:pt>
                <c:pt idx="152">
                  <c:v>2.72589</c:v>
                </c:pt>
                <c:pt idx="153">
                  <c:v>1.81457</c:v>
                </c:pt>
                <c:pt idx="154">
                  <c:v>4.17566</c:v>
                </c:pt>
                <c:pt idx="155">
                  <c:v>3.27443</c:v>
                </c:pt>
                <c:pt idx="156">
                  <c:v>3.291259999999998</c:v>
                </c:pt>
                <c:pt idx="157">
                  <c:v>1.4666</c:v>
                </c:pt>
                <c:pt idx="158">
                  <c:v>1.27814</c:v>
                </c:pt>
                <c:pt idx="159">
                  <c:v>1.30439</c:v>
                </c:pt>
                <c:pt idx="160">
                  <c:v>1.62544</c:v>
                </c:pt>
                <c:pt idx="161">
                  <c:v>1.36025</c:v>
                </c:pt>
                <c:pt idx="162">
                  <c:v>2.25206</c:v>
                </c:pt>
                <c:pt idx="163">
                  <c:v>2.31196</c:v>
                </c:pt>
                <c:pt idx="164">
                  <c:v>1.85832</c:v>
                </c:pt>
                <c:pt idx="165">
                  <c:v>2.02052</c:v>
                </c:pt>
                <c:pt idx="166">
                  <c:v>3.26972</c:v>
                </c:pt>
                <c:pt idx="167">
                  <c:v>2.45128</c:v>
                </c:pt>
                <c:pt idx="168">
                  <c:v>1.7439</c:v>
                </c:pt>
                <c:pt idx="169">
                  <c:v>2.00639</c:v>
                </c:pt>
                <c:pt idx="170">
                  <c:v>1.58304</c:v>
                </c:pt>
                <c:pt idx="171">
                  <c:v>3.8849</c:v>
                </c:pt>
                <c:pt idx="172">
                  <c:v>1.92293</c:v>
                </c:pt>
                <c:pt idx="173">
                  <c:v>2.91502</c:v>
                </c:pt>
                <c:pt idx="174">
                  <c:v>3.405679999999998</c:v>
                </c:pt>
                <c:pt idx="175">
                  <c:v>2.69358</c:v>
                </c:pt>
                <c:pt idx="176">
                  <c:v>2.00639</c:v>
                </c:pt>
                <c:pt idx="177">
                  <c:v>4.5344</c:v>
                </c:pt>
                <c:pt idx="178">
                  <c:v>3.05905</c:v>
                </c:pt>
                <c:pt idx="179">
                  <c:v>2.75012</c:v>
                </c:pt>
                <c:pt idx="180">
                  <c:v>4.04172</c:v>
                </c:pt>
                <c:pt idx="181">
                  <c:v>4.76122</c:v>
                </c:pt>
                <c:pt idx="182">
                  <c:v>1.65775</c:v>
                </c:pt>
                <c:pt idx="183">
                  <c:v>4.59565</c:v>
                </c:pt>
                <c:pt idx="184">
                  <c:v>1.49419</c:v>
                </c:pt>
                <c:pt idx="185">
                  <c:v>4.1696</c:v>
                </c:pt>
                <c:pt idx="186">
                  <c:v>5.663789999999984</c:v>
                </c:pt>
                <c:pt idx="187">
                  <c:v>3.14117</c:v>
                </c:pt>
                <c:pt idx="188">
                  <c:v>4.524299999999998</c:v>
                </c:pt>
                <c:pt idx="189">
                  <c:v>2.76425</c:v>
                </c:pt>
                <c:pt idx="190">
                  <c:v>1.58304</c:v>
                </c:pt>
                <c:pt idx="191">
                  <c:v>6.204929999999996</c:v>
                </c:pt>
                <c:pt idx="192">
                  <c:v>3.374719999999999</c:v>
                </c:pt>
                <c:pt idx="193">
                  <c:v>4.27931</c:v>
                </c:pt>
                <c:pt idx="194">
                  <c:v>2.64782</c:v>
                </c:pt>
                <c:pt idx="195">
                  <c:v>5.42688</c:v>
                </c:pt>
                <c:pt idx="196">
                  <c:v>4.09287</c:v>
                </c:pt>
                <c:pt idx="197">
                  <c:v>5.17381</c:v>
                </c:pt>
                <c:pt idx="198">
                  <c:v>6.91838</c:v>
                </c:pt>
                <c:pt idx="199">
                  <c:v>5.70081</c:v>
                </c:pt>
                <c:pt idx="200">
                  <c:v>3.76644</c:v>
                </c:pt>
                <c:pt idx="201">
                  <c:v>6.85646</c:v>
                </c:pt>
                <c:pt idx="202">
                  <c:v>2.52868</c:v>
                </c:pt>
                <c:pt idx="203">
                  <c:v>5.9135</c:v>
                </c:pt>
                <c:pt idx="204">
                  <c:v>3.4925</c:v>
                </c:pt>
                <c:pt idx="205">
                  <c:v>1.36833</c:v>
                </c:pt>
                <c:pt idx="206">
                  <c:v>1.4464</c:v>
                </c:pt>
                <c:pt idx="207">
                  <c:v>4.78141</c:v>
                </c:pt>
                <c:pt idx="208">
                  <c:v>3.54298</c:v>
                </c:pt>
                <c:pt idx="209">
                  <c:v>3.67558</c:v>
                </c:pt>
                <c:pt idx="210">
                  <c:v>5.391879999999999</c:v>
                </c:pt>
                <c:pt idx="211">
                  <c:v>3.1654</c:v>
                </c:pt>
                <c:pt idx="212">
                  <c:v>5.51505</c:v>
                </c:pt>
                <c:pt idx="213">
                  <c:v>3.29395</c:v>
                </c:pt>
                <c:pt idx="214">
                  <c:v>1.30708</c:v>
                </c:pt>
                <c:pt idx="215">
                  <c:v>1.15901</c:v>
                </c:pt>
                <c:pt idx="216">
                  <c:v>0.903919</c:v>
                </c:pt>
                <c:pt idx="217">
                  <c:v>1.09103</c:v>
                </c:pt>
                <c:pt idx="218">
                  <c:v>1.99629</c:v>
                </c:pt>
                <c:pt idx="219">
                  <c:v>3.70788</c:v>
                </c:pt>
                <c:pt idx="220">
                  <c:v>2.61416</c:v>
                </c:pt>
                <c:pt idx="221">
                  <c:v>3.328949999999998</c:v>
                </c:pt>
                <c:pt idx="222">
                  <c:v>2.08985</c:v>
                </c:pt>
                <c:pt idx="223">
                  <c:v>5.81321</c:v>
                </c:pt>
                <c:pt idx="224">
                  <c:v>5.13006</c:v>
                </c:pt>
                <c:pt idx="225">
                  <c:v>3.956239999999998</c:v>
                </c:pt>
                <c:pt idx="226">
                  <c:v>2.56436</c:v>
                </c:pt>
                <c:pt idx="227">
                  <c:v>3.602209999999998</c:v>
                </c:pt>
                <c:pt idx="228">
                  <c:v>2.884059999999998</c:v>
                </c:pt>
                <c:pt idx="229">
                  <c:v>5.04862</c:v>
                </c:pt>
                <c:pt idx="230">
                  <c:v>4.44219</c:v>
                </c:pt>
                <c:pt idx="231">
                  <c:v>2.69089</c:v>
                </c:pt>
                <c:pt idx="232">
                  <c:v>1.89937</c:v>
                </c:pt>
                <c:pt idx="233">
                  <c:v>1.35554</c:v>
                </c:pt>
                <c:pt idx="234">
                  <c:v>5.75533</c:v>
                </c:pt>
                <c:pt idx="235">
                  <c:v>1.94245</c:v>
                </c:pt>
                <c:pt idx="236">
                  <c:v>6.620879999999976</c:v>
                </c:pt>
                <c:pt idx="237">
                  <c:v>3.81557</c:v>
                </c:pt>
                <c:pt idx="238">
                  <c:v>2.15042</c:v>
                </c:pt>
                <c:pt idx="239">
                  <c:v>5.20948</c:v>
                </c:pt>
                <c:pt idx="240">
                  <c:v>6.65925</c:v>
                </c:pt>
                <c:pt idx="241">
                  <c:v>7.49317</c:v>
                </c:pt>
                <c:pt idx="242">
                  <c:v>4.28537</c:v>
                </c:pt>
                <c:pt idx="243">
                  <c:v>5.5413</c:v>
                </c:pt>
                <c:pt idx="244">
                  <c:v>3.602209999999998</c:v>
                </c:pt>
                <c:pt idx="245">
                  <c:v>4.84064</c:v>
                </c:pt>
                <c:pt idx="246">
                  <c:v>4.24835</c:v>
                </c:pt>
                <c:pt idx="247">
                  <c:v>5.26938</c:v>
                </c:pt>
                <c:pt idx="248">
                  <c:v>6.861839999999995</c:v>
                </c:pt>
                <c:pt idx="249">
                  <c:v>4.70065</c:v>
                </c:pt>
                <c:pt idx="250">
                  <c:v>2.699639999999999</c:v>
                </c:pt>
                <c:pt idx="251">
                  <c:v>4.862849999999995</c:v>
                </c:pt>
                <c:pt idx="252">
                  <c:v>2.00302</c:v>
                </c:pt>
                <c:pt idx="253">
                  <c:v>4.78276</c:v>
                </c:pt>
                <c:pt idx="254">
                  <c:v>3.831049999999952</c:v>
                </c:pt>
                <c:pt idx="255">
                  <c:v>3.01867</c:v>
                </c:pt>
                <c:pt idx="256">
                  <c:v>4.39104</c:v>
                </c:pt>
                <c:pt idx="257">
                  <c:v>7.28116</c:v>
                </c:pt>
                <c:pt idx="258">
                  <c:v>5.79369</c:v>
                </c:pt>
                <c:pt idx="259">
                  <c:v>10.3254</c:v>
                </c:pt>
                <c:pt idx="260">
                  <c:v>6.53137</c:v>
                </c:pt>
                <c:pt idx="261">
                  <c:v>4.81237</c:v>
                </c:pt>
                <c:pt idx="262">
                  <c:v>8.179020000000001</c:v>
                </c:pt>
                <c:pt idx="263">
                  <c:v>4.81237</c:v>
                </c:pt>
                <c:pt idx="264">
                  <c:v>3.92192</c:v>
                </c:pt>
                <c:pt idx="265">
                  <c:v>3.85663</c:v>
                </c:pt>
                <c:pt idx="266">
                  <c:v>5.952539999999995</c:v>
                </c:pt>
                <c:pt idx="267">
                  <c:v>4.86524</c:v>
                </c:pt>
                <c:pt idx="268">
                  <c:v>2.31129</c:v>
                </c:pt>
                <c:pt idx="269">
                  <c:v>6.88809</c:v>
                </c:pt>
                <c:pt idx="270">
                  <c:v>9.694750000000001</c:v>
                </c:pt>
                <c:pt idx="271">
                  <c:v>5.43024</c:v>
                </c:pt>
                <c:pt idx="272">
                  <c:v>5.44101</c:v>
                </c:pt>
                <c:pt idx="273">
                  <c:v>12.4765</c:v>
                </c:pt>
                <c:pt idx="274">
                  <c:v>12.2827</c:v>
                </c:pt>
                <c:pt idx="275">
                  <c:v>8.213340000000001</c:v>
                </c:pt>
                <c:pt idx="276">
                  <c:v>6.72521</c:v>
                </c:pt>
                <c:pt idx="277">
                  <c:v>5.196019999999995</c:v>
                </c:pt>
                <c:pt idx="278">
                  <c:v>8.81573</c:v>
                </c:pt>
                <c:pt idx="279">
                  <c:v>7.27039</c:v>
                </c:pt>
                <c:pt idx="280">
                  <c:v>3.63923</c:v>
                </c:pt>
                <c:pt idx="281">
                  <c:v>5.00352</c:v>
                </c:pt>
                <c:pt idx="282">
                  <c:v>4.23018</c:v>
                </c:pt>
                <c:pt idx="283">
                  <c:v>7.08731</c:v>
                </c:pt>
                <c:pt idx="284">
                  <c:v>6.188779999999999</c:v>
                </c:pt>
                <c:pt idx="285">
                  <c:v>4.794869999999999</c:v>
                </c:pt>
                <c:pt idx="286">
                  <c:v>6.4405</c:v>
                </c:pt>
                <c:pt idx="287">
                  <c:v>3.820959999999999</c:v>
                </c:pt>
                <c:pt idx="288">
                  <c:v>6.56166</c:v>
                </c:pt>
                <c:pt idx="289">
                  <c:v>6.50175</c:v>
                </c:pt>
                <c:pt idx="290">
                  <c:v>5.127369999999996</c:v>
                </c:pt>
                <c:pt idx="291">
                  <c:v>6.89886</c:v>
                </c:pt>
                <c:pt idx="292">
                  <c:v>6.104649999999999</c:v>
                </c:pt>
                <c:pt idx="293">
                  <c:v>5.0991</c:v>
                </c:pt>
                <c:pt idx="294">
                  <c:v>5.48072</c:v>
                </c:pt>
                <c:pt idx="295">
                  <c:v>3.38145</c:v>
                </c:pt>
                <c:pt idx="296">
                  <c:v>4.98804</c:v>
                </c:pt>
                <c:pt idx="297">
                  <c:v>5.87379</c:v>
                </c:pt>
                <c:pt idx="298">
                  <c:v>2.95675</c:v>
                </c:pt>
                <c:pt idx="299">
                  <c:v>6.89145</c:v>
                </c:pt>
                <c:pt idx="300">
                  <c:v>9.26735</c:v>
                </c:pt>
                <c:pt idx="301">
                  <c:v>6.2083</c:v>
                </c:pt>
                <c:pt idx="302">
                  <c:v>6.20628</c:v>
                </c:pt>
                <c:pt idx="303">
                  <c:v>7.052319999999995</c:v>
                </c:pt>
                <c:pt idx="304">
                  <c:v>7.4299</c:v>
                </c:pt>
                <c:pt idx="305">
                  <c:v>5.425529999999997</c:v>
                </c:pt>
                <c:pt idx="306">
                  <c:v>7.140489999999994</c:v>
                </c:pt>
                <c:pt idx="307">
                  <c:v>4.33585</c:v>
                </c:pt>
                <c:pt idx="308">
                  <c:v>3.658749999999999</c:v>
                </c:pt>
                <c:pt idx="309">
                  <c:v>4.77603</c:v>
                </c:pt>
                <c:pt idx="310">
                  <c:v>4.01682</c:v>
                </c:pt>
                <c:pt idx="311">
                  <c:v>6.015129999999997</c:v>
                </c:pt>
                <c:pt idx="312">
                  <c:v>6.41022</c:v>
                </c:pt>
                <c:pt idx="313">
                  <c:v>7.00991</c:v>
                </c:pt>
                <c:pt idx="314">
                  <c:v>10.674</c:v>
                </c:pt>
                <c:pt idx="315">
                  <c:v>2.58051</c:v>
                </c:pt>
                <c:pt idx="316">
                  <c:v>6.794529999999995</c:v>
                </c:pt>
                <c:pt idx="317">
                  <c:v>6.89684</c:v>
                </c:pt>
                <c:pt idx="318">
                  <c:v>3.78394</c:v>
                </c:pt>
                <c:pt idx="319">
                  <c:v>5.55005</c:v>
                </c:pt>
                <c:pt idx="320">
                  <c:v>7.40433</c:v>
                </c:pt>
                <c:pt idx="321">
                  <c:v>4.59026</c:v>
                </c:pt>
                <c:pt idx="322">
                  <c:v>4.99343</c:v>
                </c:pt>
                <c:pt idx="323">
                  <c:v>3.1203</c:v>
                </c:pt>
                <c:pt idx="324">
                  <c:v>4.52565</c:v>
                </c:pt>
                <c:pt idx="325">
                  <c:v>10.2695</c:v>
                </c:pt>
                <c:pt idx="326">
                  <c:v>5.48341</c:v>
                </c:pt>
                <c:pt idx="327">
                  <c:v>4.73093</c:v>
                </c:pt>
                <c:pt idx="328">
                  <c:v>4.50075</c:v>
                </c:pt>
                <c:pt idx="329">
                  <c:v>5.158999999999994</c:v>
                </c:pt>
                <c:pt idx="330">
                  <c:v>7.567209999999998</c:v>
                </c:pt>
                <c:pt idx="331">
                  <c:v>4.44623</c:v>
                </c:pt>
                <c:pt idx="332">
                  <c:v>5.97677</c:v>
                </c:pt>
                <c:pt idx="333">
                  <c:v>4.067969999999995</c:v>
                </c:pt>
                <c:pt idx="334">
                  <c:v>6.616169999999998</c:v>
                </c:pt>
                <c:pt idx="335">
                  <c:v>8.715440000000002</c:v>
                </c:pt>
                <c:pt idx="336">
                  <c:v>4.26383</c:v>
                </c:pt>
                <c:pt idx="337">
                  <c:v>4.74911</c:v>
                </c:pt>
                <c:pt idx="338">
                  <c:v>5.655039999999984</c:v>
                </c:pt>
                <c:pt idx="339">
                  <c:v>6.682129999999986</c:v>
                </c:pt>
                <c:pt idx="340">
                  <c:v>3.43866</c:v>
                </c:pt>
                <c:pt idx="341">
                  <c:v>5.20948</c:v>
                </c:pt>
                <c:pt idx="342">
                  <c:v>4.29345</c:v>
                </c:pt>
                <c:pt idx="343">
                  <c:v>3.195009999999999</c:v>
                </c:pt>
                <c:pt idx="344">
                  <c:v>4.45633</c:v>
                </c:pt>
                <c:pt idx="345">
                  <c:v>4.94497</c:v>
                </c:pt>
                <c:pt idx="346">
                  <c:v>7.125009999999985</c:v>
                </c:pt>
                <c:pt idx="347">
                  <c:v>8.624580000000001</c:v>
                </c:pt>
                <c:pt idx="348">
                  <c:v>2.61416</c:v>
                </c:pt>
                <c:pt idx="349">
                  <c:v>3.3902</c:v>
                </c:pt>
                <c:pt idx="350">
                  <c:v>4.8117</c:v>
                </c:pt>
                <c:pt idx="351">
                  <c:v>3.12569</c:v>
                </c:pt>
                <c:pt idx="352">
                  <c:v>2.09456</c:v>
                </c:pt>
                <c:pt idx="353">
                  <c:v>4.45969</c:v>
                </c:pt>
                <c:pt idx="354">
                  <c:v>10.5495</c:v>
                </c:pt>
                <c:pt idx="355">
                  <c:v>3.393559999999999</c:v>
                </c:pt>
                <c:pt idx="356">
                  <c:v>3.576639999999998</c:v>
                </c:pt>
                <c:pt idx="357">
                  <c:v>2.40282</c:v>
                </c:pt>
                <c:pt idx="358">
                  <c:v>2.43513</c:v>
                </c:pt>
                <c:pt idx="359">
                  <c:v>4.55123</c:v>
                </c:pt>
                <c:pt idx="360">
                  <c:v>6.05686</c:v>
                </c:pt>
                <c:pt idx="361">
                  <c:v>2.50715</c:v>
                </c:pt>
                <c:pt idx="362">
                  <c:v>2.983</c:v>
                </c:pt>
                <c:pt idx="363">
                  <c:v>6.394059999999984</c:v>
                </c:pt>
                <c:pt idx="364">
                  <c:v>5.98552</c:v>
                </c:pt>
                <c:pt idx="365">
                  <c:v>3.416449999999952</c:v>
                </c:pt>
                <c:pt idx="366">
                  <c:v>4.84939</c:v>
                </c:pt>
                <c:pt idx="367">
                  <c:v>1.3616</c:v>
                </c:pt>
                <c:pt idx="368">
                  <c:v>2.92713</c:v>
                </c:pt>
                <c:pt idx="369">
                  <c:v>2.66801</c:v>
                </c:pt>
                <c:pt idx="370">
                  <c:v>3.47837</c:v>
                </c:pt>
                <c:pt idx="371">
                  <c:v>3.40905</c:v>
                </c:pt>
                <c:pt idx="372">
                  <c:v>3.89028</c:v>
                </c:pt>
                <c:pt idx="373">
                  <c:v>2.978959999999998</c:v>
                </c:pt>
                <c:pt idx="374">
                  <c:v>5.33669</c:v>
                </c:pt>
                <c:pt idx="375">
                  <c:v>5.71697</c:v>
                </c:pt>
                <c:pt idx="376">
                  <c:v>5.19265</c:v>
                </c:pt>
                <c:pt idx="377">
                  <c:v>4.596989999999995</c:v>
                </c:pt>
                <c:pt idx="378">
                  <c:v>9.592440000000006</c:v>
                </c:pt>
                <c:pt idx="379">
                  <c:v>3.7126</c:v>
                </c:pt>
                <c:pt idx="380">
                  <c:v>6.38262</c:v>
                </c:pt>
                <c:pt idx="381">
                  <c:v>7.6197</c:v>
                </c:pt>
                <c:pt idx="382">
                  <c:v>6.095899999999999</c:v>
                </c:pt>
                <c:pt idx="383">
                  <c:v>7.26904</c:v>
                </c:pt>
                <c:pt idx="384">
                  <c:v>4.40988</c:v>
                </c:pt>
                <c:pt idx="385">
                  <c:v>4.094889999999975</c:v>
                </c:pt>
                <c:pt idx="386">
                  <c:v>2.305899999999998</c:v>
                </c:pt>
                <c:pt idx="387">
                  <c:v>1.83274</c:v>
                </c:pt>
                <c:pt idx="388">
                  <c:v>4.378919999999995</c:v>
                </c:pt>
                <c:pt idx="389">
                  <c:v>4.05114</c:v>
                </c:pt>
                <c:pt idx="390">
                  <c:v>3.02136</c:v>
                </c:pt>
                <c:pt idx="391">
                  <c:v>3.97038</c:v>
                </c:pt>
                <c:pt idx="392">
                  <c:v>6.83626</c:v>
                </c:pt>
                <c:pt idx="393">
                  <c:v>3.877489999999998</c:v>
                </c:pt>
                <c:pt idx="394">
                  <c:v>4.854099999999986</c:v>
                </c:pt>
                <c:pt idx="395">
                  <c:v>7.622399999999986</c:v>
                </c:pt>
                <c:pt idx="396">
                  <c:v>3.92394</c:v>
                </c:pt>
                <c:pt idx="397">
                  <c:v>6.337529999999997</c:v>
                </c:pt>
                <c:pt idx="398">
                  <c:v>3.8573</c:v>
                </c:pt>
                <c:pt idx="399">
                  <c:v>4.74507</c:v>
                </c:pt>
                <c:pt idx="400">
                  <c:v>2.07437</c:v>
                </c:pt>
                <c:pt idx="401">
                  <c:v>3.36799</c:v>
                </c:pt>
                <c:pt idx="402">
                  <c:v>1.14689</c:v>
                </c:pt>
                <c:pt idx="403">
                  <c:v>2.18542</c:v>
                </c:pt>
                <c:pt idx="404">
                  <c:v>2.711079999999999</c:v>
                </c:pt>
                <c:pt idx="405">
                  <c:v>4.117099999999994</c:v>
                </c:pt>
                <c:pt idx="406">
                  <c:v>4.28133</c:v>
                </c:pt>
                <c:pt idx="407">
                  <c:v>2.40686</c:v>
                </c:pt>
                <c:pt idx="408">
                  <c:v>2.68147</c:v>
                </c:pt>
                <c:pt idx="409">
                  <c:v>1.91418</c:v>
                </c:pt>
                <c:pt idx="410">
                  <c:v>3.27309</c:v>
                </c:pt>
                <c:pt idx="411">
                  <c:v>1.83341</c:v>
                </c:pt>
                <c:pt idx="412">
                  <c:v>3.422509999999999</c:v>
                </c:pt>
                <c:pt idx="413">
                  <c:v>2.38465</c:v>
                </c:pt>
                <c:pt idx="414">
                  <c:v>3.77586</c:v>
                </c:pt>
                <c:pt idx="415">
                  <c:v>2.2709</c:v>
                </c:pt>
                <c:pt idx="416">
                  <c:v>4.262479999999996</c:v>
                </c:pt>
                <c:pt idx="417">
                  <c:v>2.54349</c:v>
                </c:pt>
                <c:pt idx="418">
                  <c:v>2.41157</c:v>
                </c:pt>
                <c:pt idx="419">
                  <c:v>6.827509999999966</c:v>
                </c:pt>
                <c:pt idx="420">
                  <c:v>4.512189999999975</c:v>
                </c:pt>
                <c:pt idx="421">
                  <c:v>4.93083</c:v>
                </c:pt>
                <c:pt idx="422">
                  <c:v>3.07521</c:v>
                </c:pt>
                <c:pt idx="423">
                  <c:v>2.7555</c:v>
                </c:pt>
                <c:pt idx="424">
                  <c:v>1.90207</c:v>
                </c:pt>
                <c:pt idx="425">
                  <c:v>1.58034</c:v>
                </c:pt>
                <c:pt idx="426">
                  <c:v>3.470289999999999</c:v>
                </c:pt>
                <c:pt idx="427">
                  <c:v>3.536929999999999</c:v>
                </c:pt>
                <c:pt idx="428">
                  <c:v>2.24802</c:v>
                </c:pt>
                <c:pt idx="429">
                  <c:v>1.76678</c:v>
                </c:pt>
                <c:pt idx="430">
                  <c:v>4.022879999999986</c:v>
                </c:pt>
                <c:pt idx="431">
                  <c:v>2.26619</c:v>
                </c:pt>
                <c:pt idx="432">
                  <c:v>3.15463</c:v>
                </c:pt>
                <c:pt idx="433">
                  <c:v>1.51169</c:v>
                </c:pt>
                <c:pt idx="434">
                  <c:v>2.77435</c:v>
                </c:pt>
                <c:pt idx="435">
                  <c:v>3.10482</c:v>
                </c:pt>
                <c:pt idx="436">
                  <c:v>1.38516</c:v>
                </c:pt>
                <c:pt idx="437">
                  <c:v>2.28167</c:v>
                </c:pt>
                <c:pt idx="438">
                  <c:v>3.18559</c:v>
                </c:pt>
                <c:pt idx="439">
                  <c:v>1.07622</c:v>
                </c:pt>
                <c:pt idx="440">
                  <c:v>1.24381</c:v>
                </c:pt>
                <c:pt idx="441">
                  <c:v>1.20478</c:v>
                </c:pt>
                <c:pt idx="442">
                  <c:v>2.50782</c:v>
                </c:pt>
                <c:pt idx="443">
                  <c:v>1.4215</c:v>
                </c:pt>
                <c:pt idx="444">
                  <c:v>1.53256</c:v>
                </c:pt>
                <c:pt idx="445">
                  <c:v>1.20006</c:v>
                </c:pt>
                <c:pt idx="446">
                  <c:v>1.0917</c:v>
                </c:pt>
                <c:pt idx="447">
                  <c:v>2.47349</c:v>
                </c:pt>
                <c:pt idx="448">
                  <c:v>1.6113</c:v>
                </c:pt>
                <c:pt idx="449">
                  <c:v>5.0991</c:v>
                </c:pt>
                <c:pt idx="450">
                  <c:v>2.550889999999999</c:v>
                </c:pt>
                <c:pt idx="451">
                  <c:v>1.98351</c:v>
                </c:pt>
                <c:pt idx="452">
                  <c:v>2.581859999999998</c:v>
                </c:pt>
                <c:pt idx="453">
                  <c:v>2.79118</c:v>
                </c:pt>
                <c:pt idx="454">
                  <c:v>2.51791</c:v>
                </c:pt>
                <c:pt idx="455">
                  <c:v>1.90341</c:v>
                </c:pt>
                <c:pt idx="456">
                  <c:v>3.28588</c:v>
                </c:pt>
                <c:pt idx="457">
                  <c:v>0.980647</c:v>
                </c:pt>
                <c:pt idx="458">
                  <c:v>2.335519999999998</c:v>
                </c:pt>
                <c:pt idx="459">
                  <c:v>3.31347</c:v>
                </c:pt>
                <c:pt idx="460">
                  <c:v>4.135949999999998</c:v>
                </c:pt>
                <c:pt idx="461">
                  <c:v>1.93706</c:v>
                </c:pt>
                <c:pt idx="462">
                  <c:v>2.871939999999999</c:v>
                </c:pt>
                <c:pt idx="463">
                  <c:v>1.42285</c:v>
                </c:pt>
                <c:pt idx="464">
                  <c:v>2.3483</c:v>
                </c:pt>
                <c:pt idx="465">
                  <c:v>2.32946</c:v>
                </c:pt>
                <c:pt idx="466">
                  <c:v>4.162869999999995</c:v>
                </c:pt>
                <c:pt idx="467">
                  <c:v>3.436639999999997</c:v>
                </c:pt>
                <c:pt idx="468">
                  <c:v>3.356549999999952</c:v>
                </c:pt>
                <c:pt idx="469">
                  <c:v>4.87362</c:v>
                </c:pt>
                <c:pt idx="470">
                  <c:v>3.83576</c:v>
                </c:pt>
                <c:pt idx="471">
                  <c:v>2.95406</c:v>
                </c:pt>
                <c:pt idx="472">
                  <c:v>1.85361</c:v>
                </c:pt>
                <c:pt idx="473">
                  <c:v>5.3138</c:v>
                </c:pt>
                <c:pt idx="474">
                  <c:v>3.2253</c:v>
                </c:pt>
                <c:pt idx="475">
                  <c:v>5.9835</c:v>
                </c:pt>
                <c:pt idx="476">
                  <c:v>3.261649999999999</c:v>
                </c:pt>
                <c:pt idx="477">
                  <c:v>5.92965</c:v>
                </c:pt>
                <c:pt idx="478">
                  <c:v>4.10028</c:v>
                </c:pt>
                <c:pt idx="479">
                  <c:v>3.5302</c:v>
                </c:pt>
                <c:pt idx="480">
                  <c:v>5.90071</c:v>
                </c:pt>
                <c:pt idx="481">
                  <c:v>4.21806</c:v>
                </c:pt>
                <c:pt idx="482">
                  <c:v>3.339049999999952</c:v>
                </c:pt>
                <c:pt idx="483">
                  <c:v>0.930841</c:v>
                </c:pt>
                <c:pt idx="484">
                  <c:v>4.67844</c:v>
                </c:pt>
                <c:pt idx="485">
                  <c:v>3.820279999999999</c:v>
                </c:pt>
                <c:pt idx="486">
                  <c:v>3.05636</c:v>
                </c:pt>
                <c:pt idx="487">
                  <c:v>2.70704</c:v>
                </c:pt>
                <c:pt idx="488">
                  <c:v>2.98838</c:v>
                </c:pt>
                <c:pt idx="489">
                  <c:v>3.679619999999998</c:v>
                </c:pt>
                <c:pt idx="490">
                  <c:v>6.606079999999999</c:v>
                </c:pt>
                <c:pt idx="491">
                  <c:v>4.115079999999995</c:v>
                </c:pt>
                <c:pt idx="492">
                  <c:v>4.79824</c:v>
                </c:pt>
                <c:pt idx="493">
                  <c:v>5.630139999999994</c:v>
                </c:pt>
                <c:pt idx="494">
                  <c:v>3.792689999999998</c:v>
                </c:pt>
                <c:pt idx="495">
                  <c:v>2.80195</c:v>
                </c:pt>
                <c:pt idx="496">
                  <c:v>7.1701</c:v>
                </c:pt>
                <c:pt idx="497">
                  <c:v>3.15126</c:v>
                </c:pt>
                <c:pt idx="498">
                  <c:v>6.105989999999966</c:v>
                </c:pt>
                <c:pt idx="499">
                  <c:v>3.25761</c:v>
                </c:pt>
                <c:pt idx="500">
                  <c:v>2.71849</c:v>
                </c:pt>
                <c:pt idx="501">
                  <c:v>4.648149999999997</c:v>
                </c:pt>
                <c:pt idx="502">
                  <c:v>1.69207</c:v>
                </c:pt>
                <c:pt idx="503">
                  <c:v>4.861509999999996</c:v>
                </c:pt>
                <c:pt idx="504">
                  <c:v>5.387169999999998</c:v>
                </c:pt>
                <c:pt idx="505">
                  <c:v>2.839639999999997</c:v>
                </c:pt>
                <c:pt idx="506">
                  <c:v>1.99427</c:v>
                </c:pt>
                <c:pt idx="507">
                  <c:v>3.802789999999999</c:v>
                </c:pt>
                <c:pt idx="508">
                  <c:v>4.615839999999975</c:v>
                </c:pt>
                <c:pt idx="509">
                  <c:v>4.85007</c:v>
                </c:pt>
                <c:pt idx="510">
                  <c:v>5.98619</c:v>
                </c:pt>
                <c:pt idx="511">
                  <c:v>6.447909999999998</c:v>
                </c:pt>
                <c:pt idx="512">
                  <c:v>3.94413</c:v>
                </c:pt>
                <c:pt idx="513">
                  <c:v>4.387</c:v>
                </c:pt>
                <c:pt idx="514">
                  <c:v>4.78814</c:v>
                </c:pt>
                <c:pt idx="515">
                  <c:v>2.4459</c:v>
                </c:pt>
                <c:pt idx="516">
                  <c:v>5.77889</c:v>
                </c:pt>
                <c:pt idx="517">
                  <c:v>8.619200000000001</c:v>
                </c:pt>
                <c:pt idx="518">
                  <c:v>6.265509999999995</c:v>
                </c:pt>
                <c:pt idx="519">
                  <c:v>9.137450000000001</c:v>
                </c:pt>
                <c:pt idx="520">
                  <c:v>5.40467</c:v>
                </c:pt>
                <c:pt idx="521">
                  <c:v>5.48947</c:v>
                </c:pt>
                <c:pt idx="522">
                  <c:v>3.93269</c:v>
                </c:pt>
                <c:pt idx="523">
                  <c:v>2.48965</c:v>
                </c:pt>
                <c:pt idx="524">
                  <c:v>6.092529999999996</c:v>
                </c:pt>
                <c:pt idx="525">
                  <c:v>4.08884</c:v>
                </c:pt>
                <c:pt idx="526">
                  <c:v>6.364449999999985</c:v>
                </c:pt>
                <c:pt idx="527">
                  <c:v>4.80968</c:v>
                </c:pt>
                <c:pt idx="528">
                  <c:v>4.04037</c:v>
                </c:pt>
                <c:pt idx="529">
                  <c:v>7.194999999999967</c:v>
                </c:pt>
                <c:pt idx="530">
                  <c:v>5.02977</c:v>
                </c:pt>
                <c:pt idx="531">
                  <c:v>5.18996</c:v>
                </c:pt>
                <c:pt idx="532">
                  <c:v>6.152439999999975</c:v>
                </c:pt>
                <c:pt idx="533">
                  <c:v>7.757009999999997</c:v>
                </c:pt>
                <c:pt idx="534">
                  <c:v>6.66127</c:v>
                </c:pt>
                <c:pt idx="535">
                  <c:v>2.61147</c:v>
                </c:pt>
                <c:pt idx="536">
                  <c:v>4.54113</c:v>
                </c:pt>
                <c:pt idx="537">
                  <c:v>4.21825</c:v>
                </c:pt>
                <c:pt idx="538">
                  <c:v>3.21184</c:v>
                </c:pt>
                <c:pt idx="539">
                  <c:v>7.17347</c:v>
                </c:pt>
                <c:pt idx="540">
                  <c:v>7.86066</c:v>
                </c:pt>
                <c:pt idx="541">
                  <c:v>7.013949999999999</c:v>
                </c:pt>
                <c:pt idx="542">
                  <c:v>4.59565</c:v>
                </c:pt>
                <c:pt idx="543">
                  <c:v>8.28603</c:v>
                </c:pt>
                <c:pt idx="544">
                  <c:v>3.510679999999998</c:v>
                </c:pt>
                <c:pt idx="545">
                  <c:v>4.79151</c:v>
                </c:pt>
                <c:pt idx="546">
                  <c:v>4.32037</c:v>
                </c:pt>
                <c:pt idx="547">
                  <c:v>4.78209</c:v>
                </c:pt>
                <c:pt idx="548">
                  <c:v>5.393899999999999</c:v>
                </c:pt>
                <c:pt idx="549">
                  <c:v>6.502429999999999</c:v>
                </c:pt>
                <c:pt idx="550">
                  <c:v>8.28401</c:v>
                </c:pt>
                <c:pt idx="551">
                  <c:v>9.608590000000001</c:v>
                </c:pt>
                <c:pt idx="552">
                  <c:v>4.95304</c:v>
                </c:pt>
                <c:pt idx="553">
                  <c:v>2.42167</c:v>
                </c:pt>
                <c:pt idx="554">
                  <c:v>5.29025</c:v>
                </c:pt>
                <c:pt idx="555">
                  <c:v>6.904919999999985</c:v>
                </c:pt>
                <c:pt idx="556">
                  <c:v>5.48207</c:v>
                </c:pt>
                <c:pt idx="557">
                  <c:v>2.20023</c:v>
                </c:pt>
                <c:pt idx="558">
                  <c:v>4.822469999999996</c:v>
                </c:pt>
                <c:pt idx="559">
                  <c:v>3.97643</c:v>
                </c:pt>
                <c:pt idx="560">
                  <c:v>4.06124</c:v>
                </c:pt>
                <c:pt idx="561">
                  <c:v>4.855449999999998</c:v>
                </c:pt>
                <c:pt idx="562">
                  <c:v>6.22176</c:v>
                </c:pt>
                <c:pt idx="563">
                  <c:v>3.13511</c:v>
                </c:pt>
                <c:pt idx="564">
                  <c:v>5.56149</c:v>
                </c:pt>
                <c:pt idx="565">
                  <c:v>4.03095</c:v>
                </c:pt>
                <c:pt idx="566">
                  <c:v>3.98788</c:v>
                </c:pt>
                <c:pt idx="567">
                  <c:v>3.01867</c:v>
                </c:pt>
                <c:pt idx="568">
                  <c:v>8.244299999999997</c:v>
                </c:pt>
                <c:pt idx="569">
                  <c:v>6.67338</c:v>
                </c:pt>
                <c:pt idx="570">
                  <c:v>6.667999999999965</c:v>
                </c:pt>
                <c:pt idx="571">
                  <c:v>5.22025</c:v>
                </c:pt>
                <c:pt idx="572">
                  <c:v>4.314309999999986</c:v>
                </c:pt>
                <c:pt idx="573">
                  <c:v>3.95893</c:v>
                </c:pt>
                <c:pt idx="574">
                  <c:v>4.31364</c:v>
                </c:pt>
                <c:pt idx="575">
                  <c:v>2.335519999999998</c:v>
                </c:pt>
                <c:pt idx="576">
                  <c:v>4.61921</c:v>
                </c:pt>
                <c:pt idx="577">
                  <c:v>3.90509</c:v>
                </c:pt>
                <c:pt idx="578">
                  <c:v>3.62981</c:v>
                </c:pt>
                <c:pt idx="579">
                  <c:v>3.252219999999999</c:v>
                </c:pt>
                <c:pt idx="580">
                  <c:v>4.7942</c:v>
                </c:pt>
                <c:pt idx="581">
                  <c:v>3.76779</c:v>
                </c:pt>
                <c:pt idx="582">
                  <c:v>6.27089</c:v>
                </c:pt>
                <c:pt idx="583">
                  <c:v>5.252549999999998</c:v>
                </c:pt>
                <c:pt idx="584">
                  <c:v>2.155809999999998</c:v>
                </c:pt>
                <c:pt idx="585">
                  <c:v>5.103139999999994</c:v>
                </c:pt>
                <c:pt idx="586">
                  <c:v>6.36176</c:v>
                </c:pt>
                <c:pt idx="587">
                  <c:v>4.57748</c:v>
                </c:pt>
                <c:pt idx="588">
                  <c:v>4.522289999999995</c:v>
                </c:pt>
                <c:pt idx="589">
                  <c:v>6.75348</c:v>
                </c:pt>
                <c:pt idx="590">
                  <c:v>6.23118</c:v>
                </c:pt>
                <c:pt idx="591">
                  <c:v>5.387169999999998</c:v>
                </c:pt>
                <c:pt idx="592">
                  <c:v>6.612129999999976</c:v>
                </c:pt>
                <c:pt idx="593">
                  <c:v>3.613659999999998</c:v>
                </c:pt>
                <c:pt idx="594">
                  <c:v>2.7582</c:v>
                </c:pt>
                <c:pt idx="595">
                  <c:v>9.387160000000001</c:v>
                </c:pt>
                <c:pt idx="596">
                  <c:v>3.44606</c:v>
                </c:pt>
                <c:pt idx="597">
                  <c:v>5.724369999999999</c:v>
                </c:pt>
                <c:pt idx="598">
                  <c:v>7.845179999999996</c:v>
                </c:pt>
                <c:pt idx="599">
                  <c:v>6.090509999999997</c:v>
                </c:pt>
                <c:pt idx="600">
                  <c:v>4.012779999999998</c:v>
                </c:pt>
                <c:pt idx="601">
                  <c:v>3.67019</c:v>
                </c:pt>
                <c:pt idx="602">
                  <c:v>3.10415</c:v>
                </c:pt>
                <c:pt idx="603">
                  <c:v>9.121299999999996</c:v>
                </c:pt>
                <c:pt idx="604">
                  <c:v>6.75684</c:v>
                </c:pt>
                <c:pt idx="605">
                  <c:v>5.04189</c:v>
                </c:pt>
                <c:pt idx="606">
                  <c:v>4.344599999999994</c:v>
                </c:pt>
                <c:pt idx="607">
                  <c:v>1.90678</c:v>
                </c:pt>
                <c:pt idx="608">
                  <c:v>6.597329999999999</c:v>
                </c:pt>
                <c:pt idx="609">
                  <c:v>3.196359999999999</c:v>
                </c:pt>
                <c:pt idx="610">
                  <c:v>4.816409999999998</c:v>
                </c:pt>
                <c:pt idx="611">
                  <c:v>3.11896</c:v>
                </c:pt>
                <c:pt idx="612">
                  <c:v>4.862179999999975</c:v>
                </c:pt>
                <c:pt idx="613">
                  <c:v>2.76964</c:v>
                </c:pt>
                <c:pt idx="614">
                  <c:v>2.948</c:v>
                </c:pt>
                <c:pt idx="615">
                  <c:v>2.84368</c:v>
                </c:pt>
                <c:pt idx="616">
                  <c:v>3.91855</c:v>
                </c:pt>
                <c:pt idx="617">
                  <c:v>5.72908</c:v>
                </c:pt>
                <c:pt idx="618">
                  <c:v>4.152779999999995</c:v>
                </c:pt>
                <c:pt idx="619">
                  <c:v>4.360749999999999</c:v>
                </c:pt>
                <c:pt idx="620">
                  <c:v>6.120129999999985</c:v>
                </c:pt>
                <c:pt idx="621">
                  <c:v>4.2847</c:v>
                </c:pt>
                <c:pt idx="622">
                  <c:v>6.85646</c:v>
                </c:pt>
                <c:pt idx="623">
                  <c:v>5.877149999999998</c:v>
                </c:pt>
                <c:pt idx="624">
                  <c:v>4.824489999999937</c:v>
                </c:pt>
                <c:pt idx="625">
                  <c:v>4.13326</c:v>
                </c:pt>
                <c:pt idx="626">
                  <c:v>4.93891</c:v>
                </c:pt>
                <c:pt idx="627">
                  <c:v>3.63654</c:v>
                </c:pt>
                <c:pt idx="628">
                  <c:v>6.392039999999985</c:v>
                </c:pt>
                <c:pt idx="629">
                  <c:v>5.43159</c:v>
                </c:pt>
                <c:pt idx="630">
                  <c:v>5.67322</c:v>
                </c:pt>
                <c:pt idx="631">
                  <c:v>4.44421</c:v>
                </c:pt>
                <c:pt idx="632">
                  <c:v>4.83122</c:v>
                </c:pt>
                <c:pt idx="633">
                  <c:v>3.20309</c:v>
                </c:pt>
                <c:pt idx="634">
                  <c:v>2.41292</c:v>
                </c:pt>
                <c:pt idx="635">
                  <c:v>8.681790000000001</c:v>
                </c:pt>
                <c:pt idx="636">
                  <c:v>6.125509999999966</c:v>
                </c:pt>
                <c:pt idx="637">
                  <c:v>2.912999999999998</c:v>
                </c:pt>
                <c:pt idx="638">
                  <c:v>4.08816</c:v>
                </c:pt>
                <c:pt idx="639">
                  <c:v>3.68971</c:v>
                </c:pt>
                <c:pt idx="640">
                  <c:v>10.5933</c:v>
                </c:pt>
                <c:pt idx="641">
                  <c:v>5.360919999999965</c:v>
                </c:pt>
                <c:pt idx="642">
                  <c:v>4.04576</c:v>
                </c:pt>
                <c:pt idx="643">
                  <c:v>8.49468</c:v>
                </c:pt>
                <c:pt idx="644">
                  <c:v>5.842829999999997</c:v>
                </c:pt>
                <c:pt idx="645">
                  <c:v>5.21015</c:v>
                </c:pt>
                <c:pt idx="646">
                  <c:v>7.63115</c:v>
                </c:pt>
                <c:pt idx="647">
                  <c:v>5.23236</c:v>
                </c:pt>
                <c:pt idx="648">
                  <c:v>3.79471</c:v>
                </c:pt>
                <c:pt idx="649">
                  <c:v>5.28688</c:v>
                </c:pt>
                <c:pt idx="650">
                  <c:v>4.33854</c:v>
                </c:pt>
                <c:pt idx="651">
                  <c:v>3.469619999999999</c:v>
                </c:pt>
                <c:pt idx="652">
                  <c:v>4.77334</c:v>
                </c:pt>
                <c:pt idx="653">
                  <c:v>5.804459999999985</c:v>
                </c:pt>
                <c:pt idx="654">
                  <c:v>4.017489999999984</c:v>
                </c:pt>
                <c:pt idx="655">
                  <c:v>4.03095</c:v>
                </c:pt>
                <c:pt idx="656">
                  <c:v>2.44253</c:v>
                </c:pt>
                <c:pt idx="657">
                  <c:v>2.27225</c:v>
                </c:pt>
                <c:pt idx="658">
                  <c:v>3.395579999999998</c:v>
                </c:pt>
                <c:pt idx="659">
                  <c:v>2.873289999999999</c:v>
                </c:pt>
                <c:pt idx="660">
                  <c:v>4.77132</c:v>
                </c:pt>
                <c:pt idx="661">
                  <c:v>3.545679999999999</c:v>
                </c:pt>
                <c:pt idx="662">
                  <c:v>3.47837</c:v>
                </c:pt>
                <c:pt idx="663">
                  <c:v>5.0217</c:v>
                </c:pt>
                <c:pt idx="664">
                  <c:v>3.91317</c:v>
                </c:pt>
                <c:pt idx="665">
                  <c:v>5.03583</c:v>
                </c:pt>
                <c:pt idx="666">
                  <c:v>5.22967</c:v>
                </c:pt>
                <c:pt idx="667">
                  <c:v>6.662609999999986</c:v>
                </c:pt>
                <c:pt idx="668">
                  <c:v>3.691059999999997</c:v>
                </c:pt>
                <c:pt idx="669">
                  <c:v>3.565869999999999</c:v>
                </c:pt>
                <c:pt idx="670">
                  <c:v>8.90929</c:v>
                </c:pt>
                <c:pt idx="671">
                  <c:v>4.267869999999998</c:v>
                </c:pt>
                <c:pt idx="672">
                  <c:v>2.91367</c:v>
                </c:pt>
                <c:pt idx="673">
                  <c:v>4.25845</c:v>
                </c:pt>
                <c:pt idx="674">
                  <c:v>2.912329999999999</c:v>
                </c:pt>
                <c:pt idx="675">
                  <c:v>3.89297</c:v>
                </c:pt>
                <c:pt idx="676">
                  <c:v>2.94329</c:v>
                </c:pt>
                <c:pt idx="677">
                  <c:v>4.31229</c:v>
                </c:pt>
                <c:pt idx="678">
                  <c:v>2.0535</c:v>
                </c:pt>
                <c:pt idx="679">
                  <c:v>4.2396</c:v>
                </c:pt>
                <c:pt idx="680">
                  <c:v>4.55123</c:v>
                </c:pt>
                <c:pt idx="681">
                  <c:v>2.515219999999998</c:v>
                </c:pt>
                <c:pt idx="682">
                  <c:v>5.422169999999999</c:v>
                </c:pt>
                <c:pt idx="683">
                  <c:v>4.24768</c:v>
                </c:pt>
                <c:pt idx="684">
                  <c:v>5.320529999999986</c:v>
                </c:pt>
                <c:pt idx="685">
                  <c:v>3.573269999999999</c:v>
                </c:pt>
                <c:pt idx="686">
                  <c:v>4.25037</c:v>
                </c:pt>
                <c:pt idx="687">
                  <c:v>2.246</c:v>
                </c:pt>
                <c:pt idx="688">
                  <c:v>2.48292</c:v>
                </c:pt>
                <c:pt idx="689">
                  <c:v>4.815739999999995</c:v>
                </c:pt>
                <c:pt idx="690">
                  <c:v>5.178519999999994</c:v>
                </c:pt>
                <c:pt idx="691">
                  <c:v>2.24263</c:v>
                </c:pt>
                <c:pt idx="692">
                  <c:v>4.020179999999995</c:v>
                </c:pt>
                <c:pt idx="693">
                  <c:v>3.62712</c:v>
                </c:pt>
                <c:pt idx="694">
                  <c:v>5.358899999999997</c:v>
                </c:pt>
                <c:pt idx="695">
                  <c:v>3.10348</c:v>
                </c:pt>
                <c:pt idx="696">
                  <c:v>4.9416</c:v>
                </c:pt>
                <c:pt idx="697">
                  <c:v>3.94749</c:v>
                </c:pt>
                <c:pt idx="698">
                  <c:v>5.09977</c:v>
                </c:pt>
                <c:pt idx="699">
                  <c:v>4.647469999999997</c:v>
                </c:pt>
                <c:pt idx="700">
                  <c:v>4.154119999999937</c:v>
                </c:pt>
                <c:pt idx="701">
                  <c:v>4.244979999999996</c:v>
                </c:pt>
                <c:pt idx="702">
                  <c:v>4.23825</c:v>
                </c:pt>
                <c:pt idx="703">
                  <c:v>6.09186</c:v>
                </c:pt>
                <c:pt idx="704">
                  <c:v>3.61837</c:v>
                </c:pt>
                <c:pt idx="705">
                  <c:v>5.53659</c:v>
                </c:pt>
                <c:pt idx="706">
                  <c:v>3.86336</c:v>
                </c:pt>
                <c:pt idx="707">
                  <c:v>5.025059999999995</c:v>
                </c:pt>
                <c:pt idx="708">
                  <c:v>5.59178</c:v>
                </c:pt>
                <c:pt idx="709">
                  <c:v>2.52868</c:v>
                </c:pt>
                <c:pt idx="710">
                  <c:v>4.72824</c:v>
                </c:pt>
                <c:pt idx="711">
                  <c:v>8.728229999999998</c:v>
                </c:pt>
                <c:pt idx="712">
                  <c:v>6.377909999999995</c:v>
                </c:pt>
                <c:pt idx="713">
                  <c:v>6.63906</c:v>
                </c:pt>
                <c:pt idx="714">
                  <c:v>3.03281</c:v>
                </c:pt>
                <c:pt idx="715">
                  <c:v>7.13577</c:v>
                </c:pt>
                <c:pt idx="716">
                  <c:v>3.88557</c:v>
                </c:pt>
                <c:pt idx="717">
                  <c:v>6.25474</c:v>
                </c:pt>
                <c:pt idx="718">
                  <c:v>8.77198</c:v>
                </c:pt>
                <c:pt idx="719">
                  <c:v>6.21839</c:v>
                </c:pt>
                <c:pt idx="720">
                  <c:v>4.60642</c:v>
                </c:pt>
                <c:pt idx="721">
                  <c:v>6.670689999999999</c:v>
                </c:pt>
                <c:pt idx="722">
                  <c:v>4.337189999999985</c:v>
                </c:pt>
                <c:pt idx="723">
                  <c:v>5.95523</c:v>
                </c:pt>
                <c:pt idx="724">
                  <c:v>3.39962</c:v>
                </c:pt>
                <c:pt idx="725">
                  <c:v>5.74927</c:v>
                </c:pt>
                <c:pt idx="726">
                  <c:v>6.048109999999999</c:v>
                </c:pt>
                <c:pt idx="727">
                  <c:v>1.51506</c:v>
                </c:pt>
                <c:pt idx="728">
                  <c:v>1.91957</c:v>
                </c:pt>
                <c:pt idx="729">
                  <c:v>4.71276</c:v>
                </c:pt>
                <c:pt idx="730">
                  <c:v>3.31482</c:v>
                </c:pt>
                <c:pt idx="731">
                  <c:v>5.356879999999998</c:v>
                </c:pt>
                <c:pt idx="732">
                  <c:v>4.29546</c:v>
                </c:pt>
                <c:pt idx="733">
                  <c:v>2.67272</c:v>
                </c:pt>
                <c:pt idx="734">
                  <c:v>5.365629999999999</c:v>
                </c:pt>
                <c:pt idx="735">
                  <c:v>4.144699999999998</c:v>
                </c:pt>
                <c:pt idx="736">
                  <c:v>4.681129999999999</c:v>
                </c:pt>
                <c:pt idx="737">
                  <c:v>3.21319</c:v>
                </c:pt>
                <c:pt idx="738">
                  <c:v>3.110879999999999</c:v>
                </c:pt>
                <c:pt idx="739">
                  <c:v>2.66733</c:v>
                </c:pt>
                <c:pt idx="740">
                  <c:v>3.422509999999999</c:v>
                </c:pt>
                <c:pt idx="741">
                  <c:v>2.58455</c:v>
                </c:pt>
                <c:pt idx="742">
                  <c:v>4.123829999999995</c:v>
                </c:pt>
                <c:pt idx="743">
                  <c:v>2.316669999999952</c:v>
                </c:pt>
                <c:pt idx="744">
                  <c:v>2.305229999999999</c:v>
                </c:pt>
                <c:pt idx="745">
                  <c:v>3.97576</c:v>
                </c:pt>
                <c:pt idx="746">
                  <c:v>4.33383</c:v>
                </c:pt>
                <c:pt idx="747">
                  <c:v>4.94362</c:v>
                </c:pt>
                <c:pt idx="748">
                  <c:v>3.94009</c:v>
                </c:pt>
                <c:pt idx="749">
                  <c:v>6.97895</c:v>
                </c:pt>
                <c:pt idx="750">
                  <c:v>4.91535</c:v>
                </c:pt>
                <c:pt idx="751">
                  <c:v>4.09422</c:v>
                </c:pt>
                <c:pt idx="752">
                  <c:v>8.39574</c:v>
                </c:pt>
                <c:pt idx="753">
                  <c:v>2.90896</c:v>
                </c:pt>
                <c:pt idx="754">
                  <c:v>5.8334</c:v>
                </c:pt>
                <c:pt idx="755">
                  <c:v>3.13376</c:v>
                </c:pt>
                <c:pt idx="756">
                  <c:v>3.17953</c:v>
                </c:pt>
                <c:pt idx="757">
                  <c:v>7.17683</c:v>
                </c:pt>
                <c:pt idx="758">
                  <c:v>2.63099</c:v>
                </c:pt>
                <c:pt idx="759">
                  <c:v>6.188109999999996</c:v>
                </c:pt>
                <c:pt idx="760">
                  <c:v>3.20376</c:v>
                </c:pt>
                <c:pt idx="761">
                  <c:v>5.314479999999985</c:v>
                </c:pt>
                <c:pt idx="762">
                  <c:v>2.91771</c:v>
                </c:pt>
                <c:pt idx="763">
                  <c:v>4.29008</c:v>
                </c:pt>
                <c:pt idx="764">
                  <c:v>5.40332</c:v>
                </c:pt>
                <c:pt idx="765">
                  <c:v>4.629969999999996</c:v>
                </c:pt>
                <c:pt idx="766">
                  <c:v>3.28588</c:v>
                </c:pt>
                <c:pt idx="767">
                  <c:v>2.818099999999998</c:v>
                </c:pt>
                <c:pt idx="768">
                  <c:v>8.529010000000001</c:v>
                </c:pt>
                <c:pt idx="769">
                  <c:v>4.666989999999965</c:v>
                </c:pt>
                <c:pt idx="770">
                  <c:v>5.41611</c:v>
                </c:pt>
                <c:pt idx="771">
                  <c:v>5.75937</c:v>
                </c:pt>
                <c:pt idx="772">
                  <c:v>6.23118</c:v>
                </c:pt>
                <c:pt idx="773">
                  <c:v>6.49031</c:v>
                </c:pt>
                <c:pt idx="774">
                  <c:v>5.95119</c:v>
                </c:pt>
                <c:pt idx="775">
                  <c:v>4.44959</c:v>
                </c:pt>
                <c:pt idx="776">
                  <c:v>3.29059</c:v>
                </c:pt>
                <c:pt idx="777">
                  <c:v>3.04963</c:v>
                </c:pt>
                <c:pt idx="778">
                  <c:v>2.90021</c:v>
                </c:pt>
                <c:pt idx="779">
                  <c:v>3.77182</c:v>
                </c:pt>
                <c:pt idx="780">
                  <c:v>6.02725</c:v>
                </c:pt>
                <c:pt idx="781">
                  <c:v>3.85798</c:v>
                </c:pt>
                <c:pt idx="782">
                  <c:v>3.16338</c:v>
                </c:pt>
                <c:pt idx="783">
                  <c:v>3.79538</c:v>
                </c:pt>
                <c:pt idx="784">
                  <c:v>5.23102</c:v>
                </c:pt>
                <c:pt idx="785">
                  <c:v>5.26063</c:v>
                </c:pt>
                <c:pt idx="786">
                  <c:v>5.385149999999998</c:v>
                </c:pt>
                <c:pt idx="787">
                  <c:v>3.99528</c:v>
                </c:pt>
                <c:pt idx="788">
                  <c:v>5.642929999999985</c:v>
                </c:pt>
                <c:pt idx="789">
                  <c:v>4.91333</c:v>
                </c:pt>
                <c:pt idx="790">
                  <c:v>1.77822</c:v>
                </c:pt>
                <c:pt idx="791">
                  <c:v>6.22647</c:v>
                </c:pt>
                <c:pt idx="792">
                  <c:v>3.85596</c:v>
                </c:pt>
                <c:pt idx="793">
                  <c:v>4.27998</c:v>
                </c:pt>
                <c:pt idx="794">
                  <c:v>4.73363</c:v>
                </c:pt>
                <c:pt idx="795">
                  <c:v>2.62964</c:v>
                </c:pt>
                <c:pt idx="796">
                  <c:v>5.625429999999985</c:v>
                </c:pt>
                <c:pt idx="797">
                  <c:v>6.04878</c:v>
                </c:pt>
                <c:pt idx="798">
                  <c:v>2.22446</c:v>
                </c:pt>
                <c:pt idx="799">
                  <c:v>4.317679999999997</c:v>
                </c:pt>
                <c:pt idx="800">
                  <c:v>5.504949999999996</c:v>
                </c:pt>
                <c:pt idx="801">
                  <c:v>3.19097</c:v>
                </c:pt>
                <c:pt idx="802">
                  <c:v>3.376739999999998</c:v>
                </c:pt>
                <c:pt idx="803">
                  <c:v>8.354690000000006</c:v>
                </c:pt>
                <c:pt idx="804">
                  <c:v>3.78932</c:v>
                </c:pt>
                <c:pt idx="805">
                  <c:v>3.650669999999998</c:v>
                </c:pt>
                <c:pt idx="806">
                  <c:v>5.3764</c:v>
                </c:pt>
                <c:pt idx="807">
                  <c:v>3.74961</c:v>
                </c:pt>
                <c:pt idx="808">
                  <c:v>6.785109999999999</c:v>
                </c:pt>
                <c:pt idx="809">
                  <c:v>4.27191</c:v>
                </c:pt>
                <c:pt idx="810">
                  <c:v>4.43883</c:v>
                </c:pt>
                <c:pt idx="811">
                  <c:v>7.48846</c:v>
                </c:pt>
                <c:pt idx="812">
                  <c:v>4.78343</c:v>
                </c:pt>
                <c:pt idx="813">
                  <c:v>3.24616</c:v>
                </c:pt>
                <c:pt idx="814">
                  <c:v>2.49032</c:v>
                </c:pt>
                <c:pt idx="815">
                  <c:v>3.349819999999998</c:v>
                </c:pt>
                <c:pt idx="816">
                  <c:v>9.719650000000001</c:v>
                </c:pt>
                <c:pt idx="817">
                  <c:v>2.94396</c:v>
                </c:pt>
                <c:pt idx="818">
                  <c:v>1.47871</c:v>
                </c:pt>
                <c:pt idx="819">
                  <c:v>2.334839999999998</c:v>
                </c:pt>
                <c:pt idx="820">
                  <c:v>4.870929999999999</c:v>
                </c:pt>
                <c:pt idx="821">
                  <c:v>1.71226</c:v>
                </c:pt>
                <c:pt idx="822">
                  <c:v>3.26366</c:v>
                </c:pt>
                <c:pt idx="823">
                  <c:v>4.77334</c:v>
                </c:pt>
                <c:pt idx="824">
                  <c:v>2.01379</c:v>
                </c:pt>
                <c:pt idx="825">
                  <c:v>2.417629999999999</c:v>
                </c:pt>
                <c:pt idx="826">
                  <c:v>3.77519</c:v>
                </c:pt>
                <c:pt idx="827">
                  <c:v>2.3934</c:v>
                </c:pt>
                <c:pt idx="828">
                  <c:v>5.134099999999997</c:v>
                </c:pt>
                <c:pt idx="829">
                  <c:v>6.188779999999999</c:v>
                </c:pt>
                <c:pt idx="830">
                  <c:v>3.38347</c:v>
                </c:pt>
                <c:pt idx="831">
                  <c:v>2.36378</c:v>
                </c:pt>
                <c:pt idx="832">
                  <c:v>3.21992</c:v>
                </c:pt>
                <c:pt idx="833">
                  <c:v>5.21015</c:v>
                </c:pt>
                <c:pt idx="834">
                  <c:v>3.44876</c:v>
                </c:pt>
                <c:pt idx="835">
                  <c:v>2.6431</c:v>
                </c:pt>
                <c:pt idx="836">
                  <c:v>3.81692</c:v>
                </c:pt>
                <c:pt idx="837">
                  <c:v>2.40686</c:v>
                </c:pt>
                <c:pt idx="838">
                  <c:v>1.79438</c:v>
                </c:pt>
                <c:pt idx="839">
                  <c:v>2.96483</c:v>
                </c:pt>
                <c:pt idx="840">
                  <c:v>6.407519999999995</c:v>
                </c:pt>
                <c:pt idx="841">
                  <c:v>6.194839999999965</c:v>
                </c:pt>
                <c:pt idx="842">
                  <c:v>3.44943</c:v>
                </c:pt>
                <c:pt idx="843">
                  <c:v>3.70452</c:v>
                </c:pt>
                <c:pt idx="844">
                  <c:v>3.79538</c:v>
                </c:pt>
                <c:pt idx="845">
                  <c:v>1.7587</c:v>
                </c:pt>
                <c:pt idx="846">
                  <c:v>2.324749999999998</c:v>
                </c:pt>
                <c:pt idx="847">
                  <c:v>3.84451</c:v>
                </c:pt>
                <c:pt idx="848">
                  <c:v>2.05687</c:v>
                </c:pt>
                <c:pt idx="849">
                  <c:v>3.15463</c:v>
                </c:pt>
                <c:pt idx="850">
                  <c:v>2.49234</c:v>
                </c:pt>
                <c:pt idx="851">
                  <c:v>1.71361</c:v>
                </c:pt>
                <c:pt idx="852">
                  <c:v>1.37775</c:v>
                </c:pt>
                <c:pt idx="853">
                  <c:v>1.49621</c:v>
                </c:pt>
                <c:pt idx="854">
                  <c:v>1.07824</c:v>
                </c:pt>
                <c:pt idx="855">
                  <c:v>1.76134</c:v>
                </c:pt>
                <c:pt idx="856">
                  <c:v>2.29177</c:v>
                </c:pt>
                <c:pt idx="857">
                  <c:v>3.1055</c:v>
                </c:pt>
                <c:pt idx="858">
                  <c:v>4.20191</c:v>
                </c:pt>
                <c:pt idx="859">
                  <c:v>6.507139999999985</c:v>
                </c:pt>
                <c:pt idx="860">
                  <c:v>3.69913</c:v>
                </c:pt>
                <c:pt idx="861">
                  <c:v>5.654369999999996</c:v>
                </c:pt>
                <c:pt idx="862">
                  <c:v>1.92966</c:v>
                </c:pt>
                <c:pt idx="863">
                  <c:v>3.45751</c:v>
                </c:pt>
                <c:pt idx="864">
                  <c:v>3.40164</c:v>
                </c:pt>
                <c:pt idx="865">
                  <c:v>2.83089</c:v>
                </c:pt>
                <c:pt idx="866">
                  <c:v>2.78175</c:v>
                </c:pt>
                <c:pt idx="867">
                  <c:v>5.319189999999994</c:v>
                </c:pt>
                <c:pt idx="868">
                  <c:v>2.24802</c:v>
                </c:pt>
                <c:pt idx="869">
                  <c:v>1.79707</c:v>
                </c:pt>
                <c:pt idx="870">
                  <c:v>2.53609</c:v>
                </c:pt>
                <c:pt idx="871">
                  <c:v>5.062749999999999</c:v>
                </c:pt>
                <c:pt idx="872">
                  <c:v>3.68836</c:v>
                </c:pt>
                <c:pt idx="873">
                  <c:v>3.66817</c:v>
                </c:pt>
                <c:pt idx="874">
                  <c:v>1.439</c:v>
                </c:pt>
                <c:pt idx="875">
                  <c:v>3.51202</c:v>
                </c:pt>
                <c:pt idx="876">
                  <c:v>5.229</c:v>
                </c:pt>
                <c:pt idx="877">
                  <c:v>3.394909999999998</c:v>
                </c:pt>
                <c:pt idx="878">
                  <c:v>3.53962</c:v>
                </c:pt>
                <c:pt idx="879">
                  <c:v>3.698459999999998</c:v>
                </c:pt>
                <c:pt idx="880">
                  <c:v>5.8334</c:v>
                </c:pt>
                <c:pt idx="881">
                  <c:v>2.10196</c:v>
                </c:pt>
                <c:pt idx="882">
                  <c:v>4.02826</c:v>
                </c:pt>
                <c:pt idx="883">
                  <c:v>4.863529999999995</c:v>
                </c:pt>
                <c:pt idx="884">
                  <c:v>3.906439999999999</c:v>
                </c:pt>
                <c:pt idx="885">
                  <c:v>6.895489999999985</c:v>
                </c:pt>
                <c:pt idx="886">
                  <c:v>4.268539999999994</c:v>
                </c:pt>
                <c:pt idx="887">
                  <c:v>3.12367</c:v>
                </c:pt>
                <c:pt idx="888">
                  <c:v>1.55073</c:v>
                </c:pt>
                <c:pt idx="889">
                  <c:v>1.53054</c:v>
                </c:pt>
                <c:pt idx="890">
                  <c:v>5.5561</c:v>
                </c:pt>
                <c:pt idx="891">
                  <c:v>2.94665</c:v>
                </c:pt>
                <c:pt idx="892">
                  <c:v>2.85781</c:v>
                </c:pt>
                <c:pt idx="893">
                  <c:v>3.97778</c:v>
                </c:pt>
                <c:pt idx="894">
                  <c:v>2.24869</c:v>
                </c:pt>
                <c:pt idx="895">
                  <c:v>2.10802</c:v>
                </c:pt>
                <c:pt idx="896">
                  <c:v>2.74002</c:v>
                </c:pt>
                <c:pt idx="897">
                  <c:v>3.07521</c:v>
                </c:pt>
                <c:pt idx="898">
                  <c:v>2.11139</c:v>
                </c:pt>
                <c:pt idx="899">
                  <c:v>2.27831</c:v>
                </c:pt>
                <c:pt idx="900">
                  <c:v>3.416449999999952</c:v>
                </c:pt>
                <c:pt idx="901">
                  <c:v>2.54888</c:v>
                </c:pt>
                <c:pt idx="902">
                  <c:v>1.99629</c:v>
                </c:pt>
                <c:pt idx="903">
                  <c:v>1.29968</c:v>
                </c:pt>
                <c:pt idx="904">
                  <c:v>2.48763</c:v>
                </c:pt>
                <c:pt idx="905">
                  <c:v>2.32946</c:v>
                </c:pt>
                <c:pt idx="906">
                  <c:v>2.00706</c:v>
                </c:pt>
                <c:pt idx="907">
                  <c:v>1.71899</c:v>
                </c:pt>
                <c:pt idx="908">
                  <c:v>1.25929</c:v>
                </c:pt>
                <c:pt idx="909">
                  <c:v>1.47737</c:v>
                </c:pt>
                <c:pt idx="910">
                  <c:v>1.78159</c:v>
                </c:pt>
                <c:pt idx="911">
                  <c:v>2.45061</c:v>
                </c:pt>
                <c:pt idx="912">
                  <c:v>1.15228</c:v>
                </c:pt>
                <c:pt idx="913">
                  <c:v>1.35083</c:v>
                </c:pt>
                <c:pt idx="914">
                  <c:v>1.4491</c:v>
                </c:pt>
                <c:pt idx="915">
                  <c:v>1.70419</c:v>
                </c:pt>
                <c:pt idx="916">
                  <c:v>1.76611</c:v>
                </c:pt>
                <c:pt idx="917">
                  <c:v>2.63839</c:v>
                </c:pt>
                <c:pt idx="918">
                  <c:v>2.83089</c:v>
                </c:pt>
                <c:pt idx="919">
                  <c:v>1.51573</c:v>
                </c:pt>
                <c:pt idx="920">
                  <c:v>2.68954</c:v>
                </c:pt>
                <c:pt idx="921">
                  <c:v>5.45515</c:v>
                </c:pt>
                <c:pt idx="922">
                  <c:v>1.67659</c:v>
                </c:pt>
                <c:pt idx="923">
                  <c:v>1.63823</c:v>
                </c:pt>
                <c:pt idx="924">
                  <c:v>1.66111</c:v>
                </c:pt>
                <c:pt idx="925">
                  <c:v>2.1585</c:v>
                </c:pt>
                <c:pt idx="926">
                  <c:v>2.316669999999952</c:v>
                </c:pt>
                <c:pt idx="927">
                  <c:v>1.48746</c:v>
                </c:pt>
                <c:pt idx="928">
                  <c:v>2.32609</c:v>
                </c:pt>
                <c:pt idx="929">
                  <c:v>2.00908</c:v>
                </c:pt>
                <c:pt idx="930">
                  <c:v>2.836269999999952</c:v>
                </c:pt>
                <c:pt idx="931">
                  <c:v>1.53188</c:v>
                </c:pt>
                <c:pt idx="932">
                  <c:v>1.71967</c:v>
                </c:pt>
                <c:pt idx="933">
                  <c:v>2.18004</c:v>
                </c:pt>
                <c:pt idx="934">
                  <c:v>2.4008</c:v>
                </c:pt>
                <c:pt idx="935">
                  <c:v>2.11744</c:v>
                </c:pt>
                <c:pt idx="936">
                  <c:v>3.96903</c:v>
                </c:pt>
                <c:pt idx="937">
                  <c:v>1.41141</c:v>
                </c:pt>
                <c:pt idx="938">
                  <c:v>2.22783</c:v>
                </c:pt>
                <c:pt idx="939">
                  <c:v>3.395579999999998</c:v>
                </c:pt>
                <c:pt idx="940">
                  <c:v>2.106</c:v>
                </c:pt>
                <c:pt idx="941">
                  <c:v>1.53054</c:v>
                </c:pt>
                <c:pt idx="942">
                  <c:v>3.68971</c:v>
                </c:pt>
                <c:pt idx="943">
                  <c:v>3.52077</c:v>
                </c:pt>
                <c:pt idx="944">
                  <c:v>5.37842</c:v>
                </c:pt>
                <c:pt idx="945">
                  <c:v>2.36648</c:v>
                </c:pt>
                <c:pt idx="946">
                  <c:v>3.20982</c:v>
                </c:pt>
                <c:pt idx="947">
                  <c:v>3.58135</c:v>
                </c:pt>
                <c:pt idx="948">
                  <c:v>5.04525</c:v>
                </c:pt>
                <c:pt idx="949">
                  <c:v>3.055689999999998</c:v>
                </c:pt>
                <c:pt idx="950">
                  <c:v>2.63503</c:v>
                </c:pt>
                <c:pt idx="951">
                  <c:v>2.6431</c:v>
                </c:pt>
                <c:pt idx="952">
                  <c:v>3.422509999999999</c:v>
                </c:pt>
                <c:pt idx="953">
                  <c:v>3.19097</c:v>
                </c:pt>
                <c:pt idx="954">
                  <c:v>5.0365</c:v>
                </c:pt>
                <c:pt idx="955">
                  <c:v>3.005879999999999</c:v>
                </c:pt>
                <c:pt idx="956">
                  <c:v>2.773</c:v>
                </c:pt>
                <c:pt idx="957">
                  <c:v>2.14639</c:v>
                </c:pt>
                <c:pt idx="958">
                  <c:v>6.50108</c:v>
                </c:pt>
                <c:pt idx="959">
                  <c:v>3.86134</c:v>
                </c:pt>
                <c:pt idx="960">
                  <c:v>4.0047</c:v>
                </c:pt>
                <c:pt idx="961">
                  <c:v>7.312119999999965</c:v>
                </c:pt>
                <c:pt idx="962">
                  <c:v>4.5169</c:v>
                </c:pt>
                <c:pt idx="963">
                  <c:v>3.40164</c:v>
                </c:pt>
                <c:pt idx="964">
                  <c:v>4.51825</c:v>
                </c:pt>
                <c:pt idx="965">
                  <c:v>2.03331</c:v>
                </c:pt>
                <c:pt idx="966">
                  <c:v>4.33316</c:v>
                </c:pt>
                <c:pt idx="967">
                  <c:v>4.720159999999995</c:v>
                </c:pt>
                <c:pt idx="968">
                  <c:v>5.30909</c:v>
                </c:pt>
                <c:pt idx="969">
                  <c:v>4.398439999999995</c:v>
                </c:pt>
                <c:pt idx="970">
                  <c:v>5.290919999999994</c:v>
                </c:pt>
                <c:pt idx="971">
                  <c:v>4.224789999999984</c:v>
                </c:pt>
                <c:pt idx="972">
                  <c:v>4.25306</c:v>
                </c:pt>
                <c:pt idx="973">
                  <c:v>3.41174</c:v>
                </c:pt>
                <c:pt idx="974">
                  <c:v>2.958769999999999</c:v>
                </c:pt>
                <c:pt idx="975">
                  <c:v>2.82348</c:v>
                </c:pt>
                <c:pt idx="976">
                  <c:v>2.28773</c:v>
                </c:pt>
                <c:pt idx="977">
                  <c:v>2.390709999999998</c:v>
                </c:pt>
                <c:pt idx="978">
                  <c:v>4.01682</c:v>
                </c:pt>
                <c:pt idx="979">
                  <c:v>6.652519999999937</c:v>
                </c:pt>
                <c:pt idx="980">
                  <c:v>3.526829999999999</c:v>
                </c:pt>
                <c:pt idx="981">
                  <c:v>2.71916</c:v>
                </c:pt>
                <c:pt idx="982">
                  <c:v>2.62897</c:v>
                </c:pt>
                <c:pt idx="983">
                  <c:v>3.40299</c:v>
                </c:pt>
                <c:pt idx="984">
                  <c:v>4.40315</c:v>
                </c:pt>
                <c:pt idx="985">
                  <c:v>5.390529999999996</c:v>
                </c:pt>
                <c:pt idx="986">
                  <c:v>7.169429999999998</c:v>
                </c:pt>
                <c:pt idx="987">
                  <c:v>4.142009999999996</c:v>
                </c:pt>
                <c:pt idx="988">
                  <c:v>3.05434</c:v>
                </c:pt>
                <c:pt idx="989">
                  <c:v>5.008909999999998</c:v>
                </c:pt>
                <c:pt idx="990">
                  <c:v>7.153949999999996</c:v>
                </c:pt>
                <c:pt idx="991">
                  <c:v>5.4087</c:v>
                </c:pt>
                <c:pt idx="992">
                  <c:v>9.1112</c:v>
                </c:pt>
                <c:pt idx="993">
                  <c:v>7.623739999999985</c:v>
                </c:pt>
                <c:pt idx="994">
                  <c:v>3.97374</c:v>
                </c:pt>
                <c:pt idx="995">
                  <c:v>4.20124</c:v>
                </c:pt>
                <c:pt idx="996">
                  <c:v>7.38683</c:v>
                </c:pt>
                <c:pt idx="997">
                  <c:v>6.717799999999999</c:v>
                </c:pt>
                <c:pt idx="998">
                  <c:v>5.7385</c:v>
                </c:pt>
                <c:pt idx="999">
                  <c:v>3.63856</c:v>
                </c:pt>
                <c:pt idx="1000">
                  <c:v>8.148059999999997</c:v>
                </c:pt>
                <c:pt idx="1001">
                  <c:v>6.3308</c:v>
                </c:pt>
                <c:pt idx="1002">
                  <c:v>4.47383</c:v>
                </c:pt>
                <c:pt idx="1003">
                  <c:v>4.49065</c:v>
                </c:pt>
                <c:pt idx="1004">
                  <c:v>8.930150000000001</c:v>
                </c:pt>
                <c:pt idx="1005">
                  <c:v>3.945469999999998</c:v>
                </c:pt>
                <c:pt idx="1006">
                  <c:v>4.067299999999999</c:v>
                </c:pt>
                <c:pt idx="1007">
                  <c:v>6.96145</c:v>
                </c:pt>
                <c:pt idx="1008">
                  <c:v>4.07268</c:v>
                </c:pt>
                <c:pt idx="1009">
                  <c:v>9.97272</c:v>
                </c:pt>
                <c:pt idx="1010">
                  <c:v>7.060389999999995</c:v>
                </c:pt>
                <c:pt idx="1011">
                  <c:v>5.0466</c:v>
                </c:pt>
                <c:pt idx="1012">
                  <c:v>4.20999</c:v>
                </c:pt>
                <c:pt idx="1013">
                  <c:v>5.50361</c:v>
                </c:pt>
                <c:pt idx="1014">
                  <c:v>4.50882</c:v>
                </c:pt>
                <c:pt idx="1015">
                  <c:v>7.23337</c:v>
                </c:pt>
                <c:pt idx="1016">
                  <c:v>2.63032</c:v>
                </c:pt>
                <c:pt idx="1017">
                  <c:v>4.77334</c:v>
                </c:pt>
                <c:pt idx="1018">
                  <c:v>5.816579999999996</c:v>
                </c:pt>
                <c:pt idx="1019">
                  <c:v>10.6014</c:v>
                </c:pt>
                <c:pt idx="1020">
                  <c:v>4.33181</c:v>
                </c:pt>
                <c:pt idx="1021">
                  <c:v>5.75466</c:v>
                </c:pt>
                <c:pt idx="1022">
                  <c:v>6.25407</c:v>
                </c:pt>
                <c:pt idx="1023">
                  <c:v>4.43748</c:v>
                </c:pt>
                <c:pt idx="1024">
                  <c:v>4.70468</c:v>
                </c:pt>
                <c:pt idx="1025">
                  <c:v>4.83526</c:v>
                </c:pt>
                <c:pt idx="1026">
                  <c:v>4.58286</c:v>
                </c:pt>
                <c:pt idx="1027">
                  <c:v>6.185409999999996</c:v>
                </c:pt>
                <c:pt idx="1028">
                  <c:v>6.42368</c:v>
                </c:pt>
                <c:pt idx="1029">
                  <c:v>7.452109999999998</c:v>
                </c:pt>
                <c:pt idx="1030">
                  <c:v>4.758529999999999</c:v>
                </c:pt>
                <c:pt idx="1031">
                  <c:v>6.123489999999975</c:v>
                </c:pt>
                <c:pt idx="1032">
                  <c:v>6.997119999999994</c:v>
                </c:pt>
                <c:pt idx="1033">
                  <c:v>6.78444</c:v>
                </c:pt>
                <c:pt idx="1034">
                  <c:v>7.034139999999995</c:v>
                </c:pt>
                <c:pt idx="1035">
                  <c:v>6.00907</c:v>
                </c:pt>
                <c:pt idx="1036">
                  <c:v>4.30825</c:v>
                </c:pt>
                <c:pt idx="1037">
                  <c:v>5.79033</c:v>
                </c:pt>
                <c:pt idx="1038">
                  <c:v>8.823810000000003</c:v>
                </c:pt>
                <c:pt idx="1039">
                  <c:v>5.4363</c:v>
                </c:pt>
                <c:pt idx="1040">
                  <c:v>8.44959</c:v>
                </c:pt>
                <c:pt idx="1041">
                  <c:v>8.56333</c:v>
                </c:pt>
                <c:pt idx="1042">
                  <c:v>11.3781</c:v>
                </c:pt>
                <c:pt idx="1043">
                  <c:v>4.526999999999997</c:v>
                </c:pt>
                <c:pt idx="1044">
                  <c:v>4.70334</c:v>
                </c:pt>
                <c:pt idx="1045">
                  <c:v>4.00874</c:v>
                </c:pt>
                <c:pt idx="1046">
                  <c:v>10.1215</c:v>
                </c:pt>
                <c:pt idx="1047">
                  <c:v>9.017650000000001</c:v>
                </c:pt>
                <c:pt idx="1048">
                  <c:v>4.675409999999998</c:v>
                </c:pt>
                <c:pt idx="1049">
                  <c:v>6.22109</c:v>
                </c:pt>
                <c:pt idx="1050">
                  <c:v>4.78612</c:v>
                </c:pt>
                <c:pt idx="1051">
                  <c:v>7.27241</c:v>
                </c:pt>
                <c:pt idx="1052">
                  <c:v>7.28048</c:v>
                </c:pt>
                <c:pt idx="1053">
                  <c:v>5.633509999999997</c:v>
                </c:pt>
                <c:pt idx="1054">
                  <c:v>7.91922</c:v>
                </c:pt>
                <c:pt idx="1055">
                  <c:v>4.25037</c:v>
                </c:pt>
                <c:pt idx="1056">
                  <c:v>4.26316</c:v>
                </c:pt>
                <c:pt idx="1057">
                  <c:v>9.40668</c:v>
                </c:pt>
                <c:pt idx="1058">
                  <c:v>8.53237</c:v>
                </c:pt>
                <c:pt idx="1059">
                  <c:v>8.53641</c:v>
                </c:pt>
                <c:pt idx="1060">
                  <c:v>4.73834</c:v>
                </c:pt>
                <c:pt idx="1061">
                  <c:v>4.74507</c:v>
                </c:pt>
                <c:pt idx="1062">
                  <c:v>7.627109999999964</c:v>
                </c:pt>
                <c:pt idx="1063">
                  <c:v>7.99123</c:v>
                </c:pt>
                <c:pt idx="1064">
                  <c:v>4.5795</c:v>
                </c:pt>
                <c:pt idx="1065">
                  <c:v>4.18037</c:v>
                </c:pt>
                <c:pt idx="1066">
                  <c:v>4.825159999999975</c:v>
                </c:pt>
                <c:pt idx="1067">
                  <c:v>4.41931</c:v>
                </c:pt>
                <c:pt idx="1068">
                  <c:v>6.562999999999985</c:v>
                </c:pt>
                <c:pt idx="1069">
                  <c:v>6.652519999999937</c:v>
                </c:pt>
                <c:pt idx="1070">
                  <c:v>7.14183</c:v>
                </c:pt>
                <c:pt idx="1071">
                  <c:v>6.27762</c:v>
                </c:pt>
                <c:pt idx="1072">
                  <c:v>5.653029999999997</c:v>
                </c:pt>
                <c:pt idx="1073">
                  <c:v>6.58589</c:v>
                </c:pt>
                <c:pt idx="1074">
                  <c:v>7.85124</c:v>
                </c:pt>
                <c:pt idx="1075">
                  <c:v>3.899709999999997</c:v>
                </c:pt>
                <c:pt idx="1076">
                  <c:v>5.73985</c:v>
                </c:pt>
                <c:pt idx="1077">
                  <c:v>3.24213</c:v>
                </c:pt>
                <c:pt idx="1078">
                  <c:v>5.79908</c:v>
                </c:pt>
                <c:pt idx="1079">
                  <c:v>4.78882</c:v>
                </c:pt>
                <c:pt idx="1080">
                  <c:v>6.22647</c:v>
                </c:pt>
                <c:pt idx="1081">
                  <c:v>4.10633</c:v>
                </c:pt>
                <c:pt idx="1082">
                  <c:v>4.358729999999999</c:v>
                </c:pt>
                <c:pt idx="1083">
                  <c:v>7.166739999999995</c:v>
                </c:pt>
                <c:pt idx="1084">
                  <c:v>7.98114</c:v>
                </c:pt>
                <c:pt idx="1085">
                  <c:v>5.24111</c:v>
                </c:pt>
                <c:pt idx="1086">
                  <c:v>8.65756</c:v>
                </c:pt>
                <c:pt idx="1087">
                  <c:v>6.396759999999999</c:v>
                </c:pt>
                <c:pt idx="1088">
                  <c:v>4.760549999999998</c:v>
                </c:pt>
                <c:pt idx="1089">
                  <c:v>3.39155</c:v>
                </c:pt>
                <c:pt idx="1090">
                  <c:v>4.964489999999984</c:v>
                </c:pt>
                <c:pt idx="1091">
                  <c:v>3.36395</c:v>
                </c:pt>
                <c:pt idx="1092">
                  <c:v>5.65168</c:v>
                </c:pt>
                <c:pt idx="1093">
                  <c:v>2.53743</c:v>
                </c:pt>
                <c:pt idx="1094">
                  <c:v>2.34965</c:v>
                </c:pt>
                <c:pt idx="1095">
                  <c:v>5.089</c:v>
                </c:pt>
                <c:pt idx="1096">
                  <c:v>4.967849999999999</c:v>
                </c:pt>
                <c:pt idx="1097">
                  <c:v>5.54197</c:v>
                </c:pt>
                <c:pt idx="1098">
                  <c:v>3.954219999999998</c:v>
                </c:pt>
                <c:pt idx="1099">
                  <c:v>2.70166</c:v>
                </c:pt>
                <c:pt idx="1100">
                  <c:v>8.79958</c:v>
                </c:pt>
                <c:pt idx="1101">
                  <c:v>4.5169</c:v>
                </c:pt>
                <c:pt idx="1102">
                  <c:v>6.71175</c:v>
                </c:pt>
                <c:pt idx="1103">
                  <c:v>2.5758</c:v>
                </c:pt>
                <c:pt idx="1104">
                  <c:v>7.524799999999995</c:v>
                </c:pt>
                <c:pt idx="1105">
                  <c:v>7.816909999999996</c:v>
                </c:pt>
                <c:pt idx="1106">
                  <c:v>2.512529999999999</c:v>
                </c:pt>
                <c:pt idx="1107">
                  <c:v>3.65269</c:v>
                </c:pt>
                <c:pt idx="1108">
                  <c:v>3.22059</c:v>
                </c:pt>
                <c:pt idx="1109">
                  <c:v>4.84872</c:v>
                </c:pt>
                <c:pt idx="1110">
                  <c:v>3.25828</c:v>
                </c:pt>
                <c:pt idx="1111">
                  <c:v>1.78226</c:v>
                </c:pt>
                <c:pt idx="1112">
                  <c:v>5.328609999999998</c:v>
                </c:pt>
                <c:pt idx="1113">
                  <c:v>4.026909999999996</c:v>
                </c:pt>
                <c:pt idx="1114">
                  <c:v>4.07807</c:v>
                </c:pt>
                <c:pt idx="1115">
                  <c:v>4.185079999999997</c:v>
                </c:pt>
                <c:pt idx="1116">
                  <c:v>2.73666</c:v>
                </c:pt>
                <c:pt idx="1117">
                  <c:v>2.63839</c:v>
                </c:pt>
                <c:pt idx="1118">
                  <c:v>2.62022</c:v>
                </c:pt>
                <c:pt idx="1119">
                  <c:v>2.53474</c:v>
                </c:pt>
                <c:pt idx="1120">
                  <c:v>2.521949999999999</c:v>
                </c:pt>
                <c:pt idx="1121">
                  <c:v>3.23674</c:v>
                </c:pt>
                <c:pt idx="1122">
                  <c:v>1.66582</c:v>
                </c:pt>
                <c:pt idx="1123">
                  <c:v>3.82836</c:v>
                </c:pt>
                <c:pt idx="1124">
                  <c:v>3.735479999999999</c:v>
                </c:pt>
                <c:pt idx="1125">
                  <c:v>2.54214</c:v>
                </c:pt>
                <c:pt idx="1126">
                  <c:v>2.15917</c:v>
                </c:pt>
                <c:pt idx="1127">
                  <c:v>1.91889</c:v>
                </c:pt>
                <c:pt idx="1128">
                  <c:v>7.12635</c:v>
                </c:pt>
                <c:pt idx="1129">
                  <c:v>2.19013</c:v>
                </c:pt>
                <c:pt idx="1130">
                  <c:v>5.765429999999998</c:v>
                </c:pt>
                <c:pt idx="1131">
                  <c:v>5.177169999999998</c:v>
                </c:pt>
                <c:pt idx="1132">
                  <c:v>2.51118</c:v>
                </c:pt>
                <c:pt idx="1133">
                  <c:v>1.39323</c:v>
                </c:pt>
                <c:pt idx="1134">
                  <c:v>2.61147</c:v>
                </c:pt>
                <c:pt idx="1135">
                  <c:v>0.944302</c:v>
                </c:pt>
                <c:pt idx="1136">
                  <c:v>1.42823</c:v>
                </c:pt>
                <c:pt idx="1137">
                  <c:v>2.674059999999998</c:v>
                </c:pt>
                <c:pt idx="1138">
                  <c:v>3.112229999999998</c:v>
                </c:pt>
                <c:pt idx="1139">
                  <c:v>1.88255</c:v>
                </c:pt>
                <c:pt idx="1140">
                  <c:v>4.09153</c:v>
                </c:pt>
                <c:pt idx="1141">
                  <c:v>2.02254</c:v>
                </c:pt>
                <c:pt idx="1142">
                  <c:v>1.91149</c:v>
                </c:pt>
                <c:pt idx="1143">
                  <c:v>3.0954</c:v>
                </c:pt>
                <c:pt idx="1144">
                  <c:v>2.059559999999998</c:v>
                </c:pt>
                <c:pt idx="1145">
                  <c:v>1.59784</c:v>
                </c:pt>
                <c:pt idx="1146">
                  <c:v>2.530699999999999</c:v>
                </c:pt>
                <c:pt idx="1147">
                  <c:v>1.29564</c:v>
                </c:pt>
                <c:pt idx="1148">
                  <c:v>2.16389</c:v>
                </c:pt>
                <c:pt idx="1149">
                  <c:v>1.22429</c:v>
                </c:pt>
                <c:pt idx="1150">
                  <c:v>1.55881</c:v>
                </c:pt>
                <c:pt idx="1151">
                  <c:v>3.359239999999998</c:v>
                </c:pt>
                <c:pt idx="1152">
                  <c:v>3.670869999999998</c:v>
                </c:pt>
                <c:pt idx="1153">
                  <c:v>2.209649999999999</c:v>
                </c:pt>
                <c:pt idx="1154">
                  <c:v>1.6288</c:v>
                </c:pt>
                <c:pt idx="1155">
                  <c:v>2.06225</c:v>
                </c:pt>
                <c:pt idx="1156">
                  <c:v>1.96197</c:v>
                </c:pt>
                <c:pt idx="1157">
                  <c:v>2.99713</c:v>
                </c:pt>
                <c:pt idx="1158">
                  <c:v>2.839639999999997</c:v>
                </c:pt>
                <c:pt idx="1159">
                  <c:v>2.398779999999999</c:v>
                </c:pt>
                <c:pt idx="1160">
                  <c:v>1.61669</c:v>
                </c:pt>
                <c:pt idx="1161">
                  <c:v>1.31314</c:v>
                </c:pt>
                <c:pt idx="1162">
                  <c:v>2.474839999999999</c:v>
                </c:pt>
                <c:pt idx="1163">
                  <c:v>1.5514</c:v>
                </c:pt>
                <c:pt idx="1164">
                  <c:v>4.92747</c:v>
                </c:pt>
                <c:pt idx="1165">
                  <c:v>2.72993</c:v>
                </c:pt>
                <c:pt idx="1166">
                  <c:v>3.792689999999998</c:v>
                </c:pt>
                <c:pt idx="1167">
                  <c:v>1.12199</c:v>
                </c:pt>
                <c:pt idx="1168">
                  <c:v>0.944302</c:v>
                </c:pt>
                <c:pt idx="1169">
                  <c:v>1.40669</c:v>
                </c:pt>
                <c:pt idx="1170">
                  <c:v>2.15312</c:v>
                </c:pt>
                <c:pt idx="1171">
                  <c:v>1.77149</c:v>
                </c:pt>
                <c:pt idx="1172">
                  <c:v>1.17583</c:v>
                </c:pt>
                <c:pt idx="1173">
                  <c:v>1.21555</c:v>
                </c:pt>
                <c:pt idx="1174">
                  <c:v>1.77957</c:v>
                </c:pt>
                <c:pt idx="1175">
                  <c:v>2.37725</c:v>
                </c:pt>
                <c:pt idx="1176">
                  <c:v>2.381959999999998</c:v>
                </c:pt>
                <c:pt idx="1177">
                  <c:v>1.0567</c:v>
                </c:pt>
                <c:pt idx="1178">
                  <c:v>2.22648</c:v>
                </c:pt>
                <c:pt idx="1179">
                  <c:v>1.80649</c:v>
                </c:pt>
                <c:pt idx="1180">
                  <c:v>1.03718</c:v>
                </c:pt>
                <c:pt idx="1181">
                  <c:v>3.374049999999996</c:v>
                </c:pt>
                <c:pt idx="1182">
                  <c:v>1.12266</c:v>
                </c:pt>
                <c:pt idx="1183">
                  <c:v>1.6988</c:v>
                </c:pt>
                <c:pt idx="1184">
                  <c:v>1.55611</c:v>
                </c:pt>
                <c:pt idx="1185">
                  <c:v>3.4003</c:v>
                </c:pt>
                <c:pt idx="1186">
                  <c:v>1.01363</c:v>
                </c:pt>
                <c:pt idx="1187">
                  <c:v>1.00892</c:v>
                </c:pt>
                <c:pt idx="1188">
                  <c:v>2.25475</c:v>
                </c:pt>
                <c:pt idx="1189">
                  <c:v>1.17112</c:v>
                </c:pt>
                <c:pt idx="1190">
                  <c:v>1.31112</c:v>
                </c:pt>
                <c:pt idx="1191">
                  <c:v>2.17667</c:v>
                </c:pt>
                <c:pt idx="1192">
                  <c:v>1.28958</c:v>
                </c:pt>
                <c:pt idx="1193">
                  <c:v>1.59582</c:v>
                </c:pt>
                <c:pt idx="1194">
                  <c:v>2.0212</c:v>
                </c:pt>
                <c:pt idx="1195">
                  <c:v>1.43362</c:v>
                </c:pt>
                <c:pt idx="1196">
                  <c:v>3.92326</c:v>
                </c:pt>
                <c:pt idx="1197">
                  <c:v>1.0419</c:v>
                </c:pt>
                <c:pt idx="1198">
                  <c:v>3.44337</c:v>
                </c:pt>
                <c:pt idx="1199">
                  <c:v>1.17045</c:v>
                </c:pt>
                <c:pt idx="1200">
                  <c:v>3.21319</c:v>
                </c:pt>
                <c:pt idx="1201">
                  <c:v>2.21302</c:v>
                </c:pt>
                <c:pt idx="1202">
                  <c:v>1.26199</c:v>
                </c:pt>
                <c:pt idx="1203">
                  <c:v>1.77688</c:v>
                </c:pt>
                <c:pt idx="1204">
                  <c:v>2.134269999999999</c:v>
                </c:pt>
                <c:pt idx="1205">
                  <c:v>1.439</c:v>
                </c:pt>
                <c:pt idx="1206">
                  <c:v>1.55544</c:v>
                </c:pt>
                <c:pt idx="1207">
                  <c:v>1.09507</c:v>
                </c:pt>
                <c:pt idx="1208">
                  <c:v>1.48948</c:v>
                </c:pt>
                <c:pt idx="1209">
                  <c:v>2.23052</c:v>
                </c:pt>
                <c:pt idx="1210">
                  <c:v>1.81322</c:v>
                </c:pt>
                <c:pt idx="1211">
                  <c:v>2.46945</c:v>
                </c:pt>
                <c:pt idx="1212">
                  <c:v>1.45044</c:v>
                </c:pt>
                <c:pt idx="1213">
                  <c:v>1.71563</c:v>
                </c:pt>
                <c:pt idx="1214">
                  <c:v>2.259459999999998</c:v>
                </c:pt>
                <c:pt idx="1215">
                  <c:v>2.68753</c:v>
                </c:pt>
                <c:pt idx="1216">
                  <c:v>1.95928</c:v>
                </c:pt>
                <c:pt idx="1217">
                  <c:v>3.5901</c:v>
                </c:pt>
                <c:pt idx="1218">
                  <c:v>2.42301</c:v>
                </c:pt>
                <c:pt idx="1219">
                  <c:v>4.77939</c:v>
                </c:pt>
                <c:pt idx="1220">
                  <c:v>2.64445</c:v>
                </c:pt>
                <c:pt idx="1221">
                  <c:v>2.341569999999999</c:v>
                </c:pt>
                <c:pt idx="1222">
                  <c:v>3.83711</c:v>
                </c:pt>
                <c:pt idx="1223">
                  <c:v>5.19669</c:v>
                </c:pt>
                <c:pt idx="1224">
                  <c:v>1.87784</c:v>
                </c:pt>
                <c:pt idx="1225">
                  <c:v>2.296479999999998</c:v>
                </c:pt>
                <c:pt idx="1226">
                  <c:v>2.56772</c:v>
                </c:pt>
                <c:pt idx="1227">
                  <c:v>3.58</c:v>
                </c:pt>
                <c:pt idx="1228">
                  <c:v>1.93505</c:v>
                </c:pt>
                <c:pt idx="1229">
                  <c:v>5.13342</c:v>
                </c:pt>
                <c:pt idx="1230">
                  <c:v>1.65034</c:v>
                </c:pt>
                <c:pt idx="1231">
                  <c:v>4.797569999999998</c:v>
                </c:pt>
                <c:pt idx="1232">
                  <c:v>3.72336</c:v>
                </c:pt>
                <c:pt idx="1233">
                  <c:v>2.826179999999999</c:v>
                </c:pt>
                <c:pt idx="1234">
                  <c:v>3.75904</c:v>
                </c:pt>
                <c:pt idx="1235">
                  <c:v>3.792689999999998</c:v>
                </c:pt>
                <c:pt idx="1236">
                  <c:v>4.37623</c:v>
                </c:pt>
                <c:pt idx="1237">
                  <c:v>2.53743</c:v>
                </c:pt>
                <c:pt idx="1238">
                  <c:v>2.56974</c:v>
                </c:pt>
                <c:pt idx="1239">
                  <c:v>4.52161</c:v>
                </c:pt>
                <c:pt idx="1240">
                  <c:v>3.898359999999998</c:v>
                </c:pt>
                <c:pt idx="1241">
                  <c:v>4.1097</c:v>
                </c:pt>
                <c:pt idx="1242">
                  <c:v>5.5238</c:v>
                </c:pt>
                <c:pt idx="1243">
                  <c:v>4.99545</c:v>
                </c:pt>
                <c:pt idx="1244">
                  <c:v>1.55948</c:v>
                </c:pt>
                <c:pt idx="1245">
                  <c:v>3.213859999999999</c:v>
                </c:pt>
                <c:pt idx="1246">
                  <c:v>1.69947</c:v>
                </c:pt>
                <c:pt idx="1247">
                  <c:v>2.96617</c:v>
                </c:pt>
                <c:pt idx="1248">
                  <c:v>3.052999999999999</c:v>
                </c:pt>
                <c:pt idx="1249">
                  <c:v>4.144029999999995</c:v>
                </c:pt>
                <c:pt idx="1250">
                  <c:v>4.35267</c:v>
                </c:pt>
                <c:pt idx="1251">
                  <c:v>4.826509999999986</c:v>
                </c:pt>
                <c:pt idx="1252">
                  <c:v>4.8191</c:v>
                </c:pt>
                <c:pt idx="1253">
                  <c:v>3.176839999999999</c:v>
                </c:pt>
                <c:pt idx="1254">
                  <c:v>3.963649999999999</c:v>
                </c:pt>
                <c:pt idx="1255">
                  <c:v>3.81692</c:v>
                </c:pt>
                <c:pt idx="1256">
                  <c:v>3.58</c:v>
                </c:pt>
                <c:pt idx="1257">
                  <c:v>2.12216</c:v>
                </c:pt>
                <c:pt idx="1258">
                  <c:v>4.32037</c:v>
                </c:pt>
                <c:pt idx="1259">
                  <c:v>2.77637</c:v>
                </c:pt>
                <c:pt idx="1260">
                  <c:v>4.07605</c:v>
                </c:pt>
                <c:pt idx="1261">
                  <c:v>3.90172</c:v>
                </c:pt>
                <c:pt idx="1262">
                  <c:v>6.72723</c:v>
                </c:pt>
                <c:pt idx="1263">
                  <c:v>4.27662</c:v>
                </c:pt>
                <c:pt idx="1264">
                  <c:v>5.687349999999998</c:v>
                </c:pt>
                <c:pt idx="1265">
                  <c:v>3.78596</c:v>
                </c:pt>
                <c:pt idx="1266">
                  <c:v>2.912999999999998</c:v>
                </c:pt>
                <c:pt idx="1267">
                  <c:v>5.45582</c:v>
                </c:pt>
                <c:pt idx="1268">
                  <c:v>5.28486</c:v>
                </c:pt>
                <c:pt idx="1269">
                  <c:v>4.45633</c:v>
                </c:pt>
                <c:pt idx="1270">
                  <c:v>3.06377</c:v>
                </c:pt>
                <c:pt idx="1271">
                  <c:v>5.42822</c:v>
                </c:pt>
                <c:pt idx="1272">
                  <c:v>4.114409999999975</c:v>
                </c:pt>
                <c:pt idx="1273">
                  <c:v>4.73093</c:v>
                </c:pt>
                <c:pt idx="1274">
                  <c:v>4.21133</c:v>
                </c:pt>
                <c:pt idx="1275">
                  <c:v>6.44858</c:v>
                </c:pt>
                <c:pt idx="1276">
                  <c:v>6.715109999999997</c:v>
                </c:pt>
                <c:pt idx="1277">
                  <c:v>3.34376</c:v>
                </c:pt>
                <c:pt idx="1278">
                  <c:v>3.58808</c:v>
                </c:pt>
                <c:pt idx="1279">
                  <c:v>2.73531</c:v>
                </c:pt>
                <c:pt idx="1280">
                  <c:v>5.634849999999996</c:v>
                </c:pt>
                <c:pt idx="1281">
                  <c:v>2.76829</c:v>
                </c:pt>
                <c:pt idx="1282">
                  <c:v>3.63856</c:v>
                </c:pt>
                <c:pt idx="1283">
                  <c:v>3.434619999999998</c:v>
                </c:pt>
                <c:pt idx="1284">
                  <c:v>3.41174</c:v>
                </c:pt>
                <c:pt idx="1285">
                  <c:v>2.79791</c:v>
                </c:pt>
                <c:pt idx="1286">
                  <c:v>3.44001</c:v>
                </c:pt>
                <c:pt idx="1287">
                  <c:v>3.592789999999999</c:v>
                </c:pt>
                <c:pt idx="1288">
                  <c:v>4.7592</c:v>
                </c:pt>
                <c:pt idx="1289">
                  <c:v>5.292939999999994</c:v>
                </c:pt>
                <c:pt idx="1290">
                  <c:v>4.97727</c:v>
                </c:pt>
                <c:pt idx="1291">
                  <c:v>3.718649999999997</c:v>
                </c:pt>
                <c:pt idx="1292">
                  <c:v>3.57394</c:v>
                </c:pt>
                <c:pt idx="1293">
                  <c:v>4.360749999999999</c:v>
                </c:pt>
                <c:pt idx="1294">
                  <c:v>4.892469999999998</c:v>
                </c:pt>
                <c:pt idx="1295">
                  <c:v>7.944119999999994</c:v>
                </c:pt>
                <c:pt idx="1296">
                  <c:v>7.2926</c:v>
                </c:pt>
                <c:pt idx="1297">
                  <c:v>5.140149999999998</c:v>
                </c:pt>
                <c:pt idx="1298">
                  <c:v>3.21924</c:v>
                </c:pt>
                <c:pt idx="1299">
                  <c:v>3.5477</c:v>
                </c:pt>
                <c:pt idx="1300">
                  <c:v>7.384809999999986</c:v>
                </c:pt>
                <c:pt idx="1301">
                  <c:v>5.94446</c:v>
                </c:pt>
                <c:pt idx="1302">
                  <c:v>4.87834</c:v>
                </c:pt>
                <c:pt idx="1303">
                  <c:v>2.65791</c:v>
                </c:pt>
                <c:pt idx="1304">
                  <c:v>6.41762</c:v>
                </c:pt>
                <c:pt idx="1305">
                  <c:v>2.651849999999996</c:v>
                </c:pt>
                <c:pt idx="1306">
                  <c:v>3.860669999999998</c:v>
                </c:pt>
                <c:pt idx="1307">
                  <c:v>6.03398</c:v>
                </c:pt>
                <c:pt idx="1308">
                  <c:v>3.84317</c:v>
                </c:pt>
                <c:pt idx="1309">
                  <c:v>1.89668</c:v>
                </c:pt>
                <c:pt idx="1310">
                  <c:v>4.267199999999995</c:v>
                </c:pt>
                <c:pt idx="1311">
                  <c:v>5.683989999999984</c:v>
                </c:pt>
                <c:pt idx="1312">
                  <c:v>5.4538</c:v>
                </c:pt>
                <c:pt idx="1313">
                  <c:v>5.23236</c:v>
                </c:pt>
                <c:pt idx="1314">
                  <c:v>3.27443</c:v>
                </c:pt>
                <c:pt idx="1315">
                  <c:v>1.78899</c:v>
                </c:pt>
                <c:pt idx="1316">
                  <c:v>8.974570000000003</c:v>
                </c:pt>
                <c:pt idx="1317">
                  <c:v>9.47869</c:v>
                </c:pt>
                <c:pt idx="1318">
                  <c:v>4.75045</c:v>
                </c:pt>
                <c:pt idx="1319">
                  <c:v>2.57647</c:v>
                </c:pt>
                <c:pt idx="1320">
                  <c:v>3.6951</c:v>
                </c:pt>
                <c:pt idx="1321">
                  <c:v>2.191479999999999</c:v>
                </c:pt>
                <c:pt idx="1322">
                  <c:v>3.434619999999998</c:v>
                </c:pt>
                <c:pt idx="1323">
                  <c:v>5.213519999999995</c:v>
                </c:pt>
                <c:pt idx="1324">
                  <c:v>2.39542</c:v>
                </c:pt>
                <c:pt idx="1325">
                  <c:v>4.45565</c:v>
                </c:pt>
                <c:pt idx="1326">
                  <c:v>2.14437</c:v>
                </c:pt>
                <c:pt idx="1327">
                  <c:v>1.64765</c:v>
                </c:pt>
                <c:pt idx="1328">
                  <c:v>3.66817</c:v>
                </c:pt>
                <c:pt idx="1329">
                  <c:v>3.73279</c:v>
                </c:pt>
                <c:pt idx="1330">
                  <c:v>3.38347</c:v>
                </c:pt>
                <c:pt idx="1331">
                  <c:v>6.13426</c:v>
                </c:pt>
                <c:pt idx="1332">
                  <c:v>3.79471</c:v>
                </c:pt>
                <c:pt idx="1333">
                  <c:v>3.24549</c:v>
                </c:pt>
                <c:pt idx="1334">
                  <c:v>5.066119999999994</c:v>
                </c:pt>
                <c:pt idx="1335">
                  <c:v>3.64394</c:v>
                </c:pt>
                <c:pt idx="1336">
                  <c:v>2.74204</c:v>
                </c:pt>
                <c:pt idx="1337">
                  <c:v>4.77805</c:v>
                </c:pt>
                <c:pt idx="1338">
                  <c:v>3.02069</c:v>
                </c:pt>
                <c:pt idx="1339">
                  <c:v>2.996459999999952</c:v>
                </c:pt>
                <c:pt idx="1340">
                  <c:v>4.85074</c:v>
                </c:pt>
                <c:pt idx="1341">
                  <c:v>4.160179999999976</c:v>
                </c:pt>
                <c:pt idx="1342">
                  <c:v>5.01227</c:v>
                </c:pt>
                <c:pt idx="1343">
                  <c:v>2.106679999999999</c:v>
                </c:pt>
                <c:pt idx="1344">
                  <c:v>3.01329</c:v>
                </c:pt>
                <c:pt idx="1345">
                  <c:v>4.054509999999985</c:v>
                </c:pt>
                <c:pt idx="1346">
                  <c:v>4.100949999999997</c:v>
                </c:pt>
                <c:pt idx="1347">
                  <c:v>4.63199</c:v>
                </c:pt>
                <c:pt idx="1348">
                  <c:v>2.390029999999998</c:v>
                </c:pt>
                <c:pt idx="1349">
                  <c:v>4.45161</c:v>
                </c:pt>
                <c:pt idx="1350">
                  <c:v>6.826169999999998</c:v>
                </c:pt>
                <c:pt idx="1351">
                  <c:v>4.5418</c:v>
                </c:pt>
                <c:pt idx="1352">
                  <c:v>2.16254</c:v>
                </c:pt>
                <c:pt idx="1353">
                  <c:v>4.18845</c:v>
                </c:pt>
                <c:pt idx="1354">
                  <c:v>2.76627</c:v>
                </c:pt>
                <c:pt idx="1355">
                  <c:v>4.87968</c:v>
                </c:pt>
                <c:pt idx="1356">
                  <c:v>3.516729999999999</c:v>
                </c:pt>
                <c:pt idx="1357">
                  <c:v>4.84737</c:v>
                </c:pt>
                <c:pt idx="1358">
                  <c:v>2.33619</c:v>
                </c:pt>
                <c:pt idx="1359">
                  <c:v>3.525479999999999</c:v>
                </c:pt>
                <c:pt idx="1360">
                  <c:v>1.63957</c:v>
                </c:pt>
                <c:pt idx="1361">
                  <c:v>2.78243</c:v>
                </c:pt>
                <c:pt idx="1362">
                  <c:v>1.96129</c:v>
                </c:pt>
                <c:pt idx="1363">
                  <c:v>6.47954</c:v>
                </c:pt>
                <c:pt idx="1364">
                  <c:v>2.47417</c:v>
                </c:pt>
                <c:pt idx="1365">
                  <c:v>3.60019</c:v>
                </c:pt>
                <c:pt idx="1366">
                  <c:v>2.49234</c:v>
                </c:pt>
                <c:pt idx="1367">
                  <c:v>3.4851</c:v>
                </c:pt>
                <c:pt idx="1368">
                  <c:v>2.837619999999998</c:v>
                </c:pt>
                <c:pt idx="1369">
                  <c:v>2.379259999999952</c:v>
                </c:pt>
                <c:pt idx="1370">
                  <c:v>1.84755</c:v>
                </c:pt>
                <c:pt idx="1371">
                  <c:v>2.354359999999998</c:v>
                </c:pt>
                <c:pt idx="1372">
                  <c:v>1.51708</c:v>
                </c:pt>
                <c:pt idx="1373">
                  <c:v>2.626949999999998</c:v>
                </c:pt>
                <c:pt idx="1374">
                  <c:v>4.629969999999996</c:v>
                </c:pt>
                <c:pt idx="1375">
                  <c:v>3.02204</c:v>
                </c:pt>
                <c:pt idx="1376">
                  <c:v>1.97543</c:v>
                </c:pt>
                <c:pt idx="1377">
                  <c:v>6.17868</c:v>
                </c:pt>
                <c:pt idx="1378">
                  <c:v>2.02389</c:v>
                </c:pt>
                <c:pt idx="1379">
                  <c:v>4.095569999999999</c:v>
                </c:pt>
                <c:pt idx="1380">
                  <c:v>5.217559999999994</c:v>
                </c:pt>
                <c:pt idx="1381">
                  <c:v>2.410899999999998</c:v>
                </c:pt>
                <c:pt idx="1382">
                  <c:v>2.48897</c:v>
                </c:pt>
                <c:pt idx="1383">
                  <c:v>2.28436</c:v>
                </c:pt>
                <c:pt idx="1384">
                  <c:v>5.226979999999997</c:v>
                </c:pt>
                <c:pt idx="1385">
                  <c:v>3.499239999999999</c:v>
                </c:pt>
                <c:pt idx="1386">
                  <c:v>3.112899999999998</c:v>
                </c:pt>
                <c:pt idx="1387">
                  <c:v>4.04172</c:v>
                </c:pt>
                <c:pt idx="1388">
                  <c:v>3.48847</c:v>
                </c:pt>
                <c:pt idx="1389">
                  <c:v>2.17802</c:v>
                </c:pt>
                <c:pt idx="1390">
                  <c:v>2.30052</c:v>
                </c:pt>
                <c:pt idx="1391">
                  <c:v>2.5233</c:v>
                </c:pt>
                <c:pt idx="1392">
                  <c:v>3.337699999999999</c:v>
                </c:pt>
                <c:pt idx="1393">
                  <c:v>2.50917</c:v>
                </c:pt>
                <c:pt idx="1394">
                  <c:v>2.031289999999998</c:v>
                </c:pt>
                <c:pt idx="1395">
                  <c:v>2.21773</c:v>
                </c:pt>
                <c:pt idx="1396">
                  <c:v>2.446569999999999</c:v>
                </c:pt>
                <c:pt idx="1397">
                  <c:v>3.272409999999998</c:v>
                </c:pt>
                <c:pt idx="1398">
                  <c:v>3.974419999999998</c:v>
                </c:pt>
                <c:pt idx="1399">
                  <c:v>1.47198</c:v>
                </c:pt>
                <c:pt idx="1400">
                  <c:v>2.47282</c:v>
                </c:pt>
                <c:pt idx="1401">
                  <c:v>2.22581</c:v>
                </c:pt>
                <c:pt idx="1402">
                  <c:v>1.46996</c:v>
                </c:pt>
                <c:pt idx="1403">
                  <c:v>3.02473</c:v>
                </c:pt>
                <c:pt idx="1404">
                  <c:v>1.54938</c:v>
                </c:pt>
                <c:pt idx="1405">
                  <c:v>2.66935</c:v>
                </c:pt>
                <c:pt idx="1406">
                  <c:v>1.81322</c:v>
                </c:pt>
                <c:pt idx="1407">
                  <c:v>1.68399</c:v>
                </c:pt>
                <c:pt idx="1408">
                  <c:v>1.63755</c:v>
                </c:pt>
                <c:pt idx="1409">
                  <c:v>2.85108</c:v>
                </c:pt>
                <c:pt idx="1410">
                  <c:v>1.49823</c:v>
                </c:pt>
                <c:pt idx="1411">
                  <c:v>2.98031</c:v>
                </c:pt>
                <c:pt idx="1412">
                  <c:v>3.110879999999999</c:v>
                </c:pt>
                <c:pt idx="1413">
                  <c:v>2.392729999999998</c:v>
                </c:pt>
                <c:pt idx="1414">
                  <c:v>1.403999999999999</c:v>
                </c:pt>
                <c:pt idx="1415">
                  <c:v>2.26081</c:v>
                </c:pt>
                <c:pt idx="1416">
                  <c:v>2.1861</c:v>
                </c:pt>
                <c:pt idx="1417">
                  <c:v>1.98889</c:v>
                </c:pt>
                <c:pt idx="1418">
                  <c:v>1.62948</c:v>
                </c:pt>
                <c:pt idx="1419">
                  <c:v>2.00033</c:v>
                </c:pt>
                <c:pt idx="1420">
                  <c:v>3.19232</c:v>
                </c:pt>
                <c:pt idx="1421">
                  <c:v>4.18777</c:v>
                </c:pt>
                <c:pt idx="1422">
                  <c:v>3.792019999999999</c:v>
                </c:pt>
                <c:pt idx="1423">
                  <c:v>2.84771</c:v>
                </c:pt>
                <c:pt idx="1424">
                  <c:v>1.40064</c:v>
                </c:pt>
                <c:pt idx="1425">
                  <c:v>1.24852</c:v>
                </c:pt>
                <c:pt idx="1426">
                  <c:v>2.50042</c:v>
                </c:pt>
                <c:pt idx="1427">
                  <c:v>1.30035</c:v>
                </c:pt>
                <c:pt idx="1428">
                  <c:v>2.03331</c:v>
                </c:pt>
                <c:pt idx="1429">
                  <c:v>2.54618</c:v>
                </c:pt>
                <c:pt idx="1430">
                  <c:v>1.7587</c:v>
                </c:pt>
                <c:pt idx="1431">
                  <c:v>1.56082</c:v>
                </c:pt>
                <c:pt idx="1432">
                  <c:v>1.55073</c:v>
                </c:pt>
                <c:pt idx="1433">
                  <c:v>1.36093</c:v>
                </c:pt>
                <c:pt idx="1434">
                  <c:v>3.66548</c:v>
                </c:pt>
                <c:pt idx="1435">
                  <c:v>3.20444</c:v>
                </c:pt>
                <c:pt idx="1436">
                  <c:v>2.29109</c:v>
                </c:pt>
                <c:pt idx="1437">
                  <c:v>1.23574</c:v>
                </c:pt>
                <c:pt idx="1438">
                  <c:v>1.79236</c:v>
                </c:pt>
                <c:pt idx="1439">
                  <c:v>2.058889999999999</c:v>
                </c:pt>
                <c:pt idx="1440">
                  <c:v>2.989059999999998</c:v>
                </c:pt>
                <c:pt idx="1441">
                  <c:v>1.55342</c:v>
                </c:pt>
                <c:pt idx="1442">
                  <c:v>1.50429</c:v>
                </c:pt>
                <c:pt idx="1443">
                  <c:v>3.43799</c:v>
                </c:pt>
                <c:pt idx="1444">
                  <c:v>1.78428</c:v>
                </c:pt>
                <c:pt idx="1445">
                  <c:v>2.30186</c:v>
                </c:pt>
                <c:pt idx="1446">
                  <c:v>1.99427</c:v>
                </c:pt>
                <c:pt idx="1447">
                  <c:v>1.87784</c:v>
                </c:pt>
                <c:pt idx="1448">
                  <c:v>2.22581</c:v>
                </c:pt>
                <c:pt idx="1449">
                  <c:v>3.38078</c:v>
                </c:pt>
                <c:pt idx="1450">
                  <c:v>3.394239999999999</c:v>
                </c:pt>
                <c:pt idx="1451">
                  <c:v>3.11626</c:v>
                </c:pt>
                <c:pt idx="1452">
                  <c:v>7.102789999999985</c:v>
                </c:pt>
                <c:pt idx="1453">
                  <c:v>3.37135</c:v>
                </c:pt>
                <c:pt idx="1454">
                  <c:v>1.95322</c:v>
                </c:pt>
                <c:pt idx="1455">
                  <c:v>4.0323</c:v>
                </c:pt>
                <c:pt idx="1456">
                  <c:v>2.398779999999999</c:v>
                </c:pt>
                <c:pt idx="1457">
                  <c:v>2.01447</c:v>
                </c:pt>
                <c:pt idx="1458">
                  <c:v>3.61971</c:v>
                </c:pt>
                <c:pt idx="1459">
                  <c:v>2.70233</c:v>
                </c:pt>
                <c:pt idx="1460">
                  <c:v>4.03836</c:v>
                </c:pt>
                <c:pt idx="1461">
                  <c:v>4.094889999999975</c:v>
                </c:pt>
                <c:pt idx="1462">
                  <c:v>2.134269999999999</c:v>
                </c:pt>
                <c:pt idx="1463">
                  <c:v>2.43109</c:v>
                </c:pt>
                <c:pt idx="1464">
                  <c:v>3.925949999999998</c:v>
                </c:pt>
                <c:pt idx="1465">
                  <c:v>3.39962</c:v>
                </c:pt>
                <c:pt idx="1466">
                  <c:v>3.70317</c:v>
                </c:pt>
                <c:pt idx="1467">
                  <c:v>4.6118</c:v>
                </c:pt>
                <c:pt idx="1468">
                  <c:v>7.15933</c:v>
                </c:pt>
                <c:pt idx="1469">
                  <c:v>2.86791</c:v>
                </c:pt>
                <c:pt idx="1470">
                  <c:v>4.10566</c:v>
                </c:pt>
                <c:pt idx="1471">
                  <c:v>1.52111</c:v>
                </c:pt>
                <c:pt idx="1472">
                  <c:v>1.34881</c:v>
                </c:pt>
                <c:pt idx="1473">
                  <c:v>3.22328</c:v>
                </c:pt>
                <c:pt idx="1474">
                  <c:v>2.77772</c:v>
                </c:pt>
                <c:pt idx="1475">
                  <c:v>2.952039999999998</c:v>
                </c:pt>
                <c:pt idx="1476">
                  <c:v>3.39828</c:v>
                </c:pt>
                <c:pt idx="1477">
                  <c:v>4.50075</c:v>
                </c:pt>
                <c:pt idx="1478">
                  <c:v>3.45481</c:v>
                </c:pt>
                <c:pt idx="1479">
                  <c:v>3.85461</c:v>
                </c:pt>
                <c:pt idx="1480">
                  <c:v>3.01329</c:v>
                </c:pt>
                <c:pt idx="1481">
                  <c:v>2.81271</c:v>
                </c:pt>
                <c:pt idx="1482">
                  <c:v>5.5938</c:v>
                </c:pt>
                <c:pt idx="1483">
                  <c:v>1.84957</c:v>
                </c:pt>
                <c:pt idx="1484">
                  <c:v>2.324749999999998</c:v>
                </c:pt>
                <c:pt idx="1485">
                  <c:v>6.87328</c:v>
                </c:pt>
                <c:pt idx="1486">
                  <c:v>6.09657</c:v>
                </c:pt>
                <c:pt idx="1487">
                  <c:v>3.9899</c:v>
                </c:pt>
                <c:pt idx="1488">
                  <c:v>3.43126</c:v>
                </c:pt>
                <c:pt idx="1489">
                  <c:v>3.832399999999998</c:v>
                </c:pt>
                <c:pt idx="1490">
                  <c:v>2.14504</c:v>
                </c:pt>
                <c:pt idx="1491">
                  <c:v>4.04105</c:v>
                </c:pt>
                <c:pt idx="1492">
                  <c:v>1.51909</c:v>
                </c:pt>
                <c:pt idx="1493">
                  <c:v>1.97476</c:v>
                </c:pt>
                <c:pt idx="1494">
                  <c:v>6.57983</c:v>
                </c:pt>
                <c:pt idx="1495">
                  <c:v>3.50799</c:v>
                </c:pt>
                <c:pt idx="1496">
                  <c:v>4.98131</c:v>
                </c:pt>
                <c:pt idx="1497">
                  <c:v>2.418979999999999</c:v>
                </c:pt>
                <c:pt idx="1498">
                  <c:v>1.51438</c:v>
                </c:pt>
                <c:pt idx="1499">
                  <c:v>1.29497</c:v>
                </c:pt>
                <c:pt idx="1500">
                  <c:v>4.7067</c:v>
                </c:pt>
                <c:pt idx="1501">
                  <c:v>14.8578</c:v>
                </c:pt>
                <c:pt idx="1502">
                  <c:v>9.8132</c:v>
                </c:pt>
                <c:pt idx="1503">
                  <c:v>6.175989999999985</c:v>
                </c:pt>
                <c:pt idx="1504">
                  <c:v>2.551569999999999</c:v>
                </c:pt>
                <c:pt idx="1505">
                  <c:v>2.921749999999998</c:v>
                </c:pt>
                <c:pt idx="1506">
                  <c:v>3.3027</c:v>
                </c:pt>
                <c:pt idx="1507">
                  <c:v>4.07807</c:v>
                </c:pt>
                <c:pt idx="1508">
                  <c:v>5.98013</c:v>
                </c:pt>
                <c:pt idx="1509">
                  <c:v>4.21806</c:v>
                </c:pt>
                <c:pt idx="1510">
                  <c:v>3.46827</c:v>
                </c:pt>
                <c:pt idx="1511">
                  <c:v>5.497549999999999</c:v>
                </c:pt>
                <c:pt idx="1512">
                  <c:v>4.265849999999999</c:v>
                </c:pt>
                <c:pt idx="1513">
                  <c:v>5.325919999999964</c:v>
                </c:pt>
                <c:pt idx="1514">
                  <c:v>4.814389999999975</c:v>
                </c:pt>
                <c:pt idx="1515">
                  <c:v>6.73396</c:v>
                </c:pt>
                <c:pt idx="1516">
                  <c:v>2.8531</c:v>
                </c:pt>
                <c:pt idx="1517">
                  <c:v>2.32946</c:v>
                </c:pt>
                <c:pt idx="1518">
                  <c:v>5.08025</c:v>
                </c:pt>
                <c:pt idx="1519">
                  <c:v>4.97795</c:v>
                </c:pt>
                <c:pt idx="1520">
                  <c:v>3.72134</c:v>
                </c:pt>
                <c:pt idx="1521">
                  <c:v>4.087489999999994</c:v>
                </c:pt>
                <c:pt idx="1522">
                  <c:v>4.90324</c:v>
                </c:pt>
                <c:pt idx="1523">
                  <c:v>4.366809999999996</c:v>
                </c:pt>
                <c:pt idx="1524">
                  <c:v>3.90374</c:v>
                </c:pt>
                <c:pt idx="1525">
                  <c:v>6.0535</c:v>
                </c:pt>
                <c:pt idx="1526">
                  <c:v>5.98888</c:v>
                </c:pt>
                <c:pt idx="1527">
                  <c:v>4.308929999999997</c:v>
                </c:pt>
                <c:pt idx="1528">
                  <c:v>5.95523</c:v>
                </c:pt>
                <c:pt idx="1529">
                  <c:v>7.61836</c:v>
                </c:pt>
                <c:pt idx="1530">
                  <c:v>3.04155</c:v>
                </c:pt>
                <c:pt idx="1531">
                  <c:v>3.28991</c:v>
                </c:pt>
                <c:pt idx="1532">
                  <c:v>5.924939999999975</c:v>
                </c:pt>
                <c:pt idx="1533">
                  <c:v>6.00167</c:v>
                </c:pt>
                <c:pt idx="1534">
                  <c:v>2.430419999999998</c:v>
                </c:pt>
                <c:pt idx="1535">
                  <c:v>4.123829999999995</c:v>
                </c:pt>
                <c:pt idx="1536">
                  <c:v>2.26888</c:v>
                </c:pt>
                <c:pt idx="1537">
                  <c:v>9.191969999999997</c:v>
                </c:pt>
                <c:pt idx="1538">
                  <c:v>3.26097</c:v>
                </c:pt>
                <c:pt idx="1539">
                  <c:v>4.52565</c:v>
                </c:pt>
                <c:pt idx="1540">
                  <c:v>2.94396</c:v>
                </c:pt>
                <c:pt idx="1541">
                  <c:v>5.0116</c:v>
                </c:pt>
                <c:pt idx="1542">
                  <c:v>4.896509999999997</c:v>
                </c:pt>
                <c:pt idx="1543">
                  <c:v>2.00302</c:v>
                </c:pt>
                <c:pt idx="1544">
                  <c:v>2.81339</c:v>
                </c:pt>
                <c:pt idx="1545">
                  <c:v>2.84839</c:v>
                </c:pt>
                <c:pt idx="1546">
                  <c:v>5.053999999999998</c:v>
                </c:pt>
                <c:pt idx="1547">
                  <c:v>2.70233</c:v>
                </c:pt>
                <c:pt idx="1548">
                  <c:v>4.17162</c:v>
                </c:pt>
                <c:pt idx="1549">
                  <c:v>3.32222</c:v>
                </c:pt>
                <c:pt idx="1550">
                  <c:v>3.34309</c:v>
                </c:pt>
                <c:pt idx="1551">
                  <c:v>6.06225</c:v>
                </c:pt>
                <c:pt idx="1552">
                  <c:v>4.967179999999995</c:v>
                </c:pt>
                <c:pt idx="1553">
                  <c:v>3.64529</c:v>
                </c:pt>
                <c:pt idx="1554">
                  <c:v>4.67372</c:v>
                </c:pt>
                <c:pt idx="1555">
                  <c:v>4.44682</c:v>
                </c:pt>
                <c:pt idx="1556">
                  <c:v>2.76425</c:v>
                </c:pt>
                <c:pt idx="1557">
                  <c:v>2.19552</c:v>
                </c:pt>
                <c:pt idx="1558">
                  <c:v>1.54467</c:v>
                </c:pt>
                <c:pt idx="1559">
                  <c:v>1.9687</c:v>
                </c:pt>
                <c:pt idx="1560">
                  <c:v>1.51236</c:v>
                </c:pt>
                <c:pt idx="1561">
                  <c:v>2.46205</c:v>
                </c:pt>
                <c:pt idx="1562">
                  <c:v>2.50311</c:v>
                </c:pt>
                <c:pt idx="1563">
                  <c:v>1.71092</c:v>
                </c:pt>
                <c:pt idx="1564">
                  <c:v>2.01581</c:v>
                </c:pt>
                <c:pt idx="1565">
                  <c:v>2.45734</c:v>
                </c:pt>
                <c:pt idx="1566">
                  <c:v>2.02524</c:v>
                </c:pt>
                <c:pt idx="1567">
                  <c:v>2.37725</c:v>
                </c:pt>
                <c:pt idx="1568">
                  <c:v>3.036169999999998</c:v>
                </c:pt>
                <c:pt idx="1569">
                  <c:v>3.414429999999998</c:v>
                </c:pt>
                <c:pt idx="1570">
                  <c:v>1.83005</c:v>
                </c:pt>
                <c:pt idx="1571">
                  <c:v>1.75063</c:v>
                </c:pt>
                <c:pt idx="1572">
                  <c:v>4.7168</c:v>
                </c:pt>
                <c:pt idx="1573">
                  <c:v>1.7614</c:v>
                </c:pt>
                <c:pt idx="1574">
                  <c:v>4.24768</c:v>
                </c:pt>
                <c:pt idx="1575">
                  <c:v>1.7614</c:v>
                </c:pt>
                <c:pt idx="1576">
                  <c:v>2.10196</c:v>
                </c:pt>
                <c:pt idx="1577">
                  <c:v>3.2502</c:v>
                </c:pt>
                <c:pt idx="1578">
                  <c:v>3.471639999999998</c:v>
                </c:pt>
                <c:pt idx="1579">
                  <c:v>4.191809999999998</c:v>
                </c:pt>
                <c:pt idx="1580">
                  <c:v>2.9581</c:v>
                </c:pt>
                <c:pt idx="1581">
                  <c:v>1.89466</c:v>
                </c:pt>
                <c:pt idx="1582">
                  <c:v>1.56486</c:v>
                </c:pt>
                <c:pt idx="1583">
                  <c:v>1.07353</c:v>
                </c:pt>
                <c:pt idx="1584">
                  <c:v>1.81053</c:v>
                </c:pt>
                <c:pt idx="1585">
                  <c:v>1.05132</c:v>
                </c:pt>
                <c:pt idx="1586">
                  <c:v>2.959439999999998</c:v>
                </c:pt>
                <c:pt idx="1587">
                  <c:v>1.39996</c:v>
                </c:pt>
                <c:pt idx="1588">
                  <c:v>1.50765</c:v>
                </c:pt>
                <c:pt idx="1589">
                  <c:v>1.35218</c:v>
                </c:pt>
                <c:pt idx="1590">
                  <c:v>1.3017</c:v>
                </c:pt>
                <c:pt idx="1591">
                  <c:v>2.47349</c:v>
                </c:pt>
                <c:pt idx="1592">
                  <c:v>1.00084</c:v>
                </c:pt>
                <c:pt idx="1593">
                  <c:v>3.57058</c:v>
                </c:pt>
                <c:pt idx="1594">
                  <c:v>0.979301</c:v>
                </c:pt>
                <c:pt idx="1595">
                  <c:v>1.38516</c:v>
                </c:pt>
                <c:pt idx="1596">
                  <c:v>0.886419</c:v>
                </c:pt>
                <c:pt idx="1597">
                  <c:v>0.774691</c:v>
                </c:pt>
                <c:pt idx="1598">
                  <c:v>1.21285</c:v>
                </c:pt>
                <c:pt idx="1599">
                  <c:v>1.46592</c:v>
                </c:pt>
                <c:pt idx="1600">
                  <c:v>1.70015</c:v>
                </c:pt>
                <c:pt idx="1601">
                  <c:v>2.386</c:v>
                </c:pt>
                <c:pt idx="1602">
                  <c:v>3.50193</c:v>
                </c:pt>
                <c:pt idx="1603">
                  <c:v>1.15564</c:v>
                </c:pt>
                <c:pt idx="1604">
                  <c:v>3.005879999999999</c:v>
                </c:pt>
                <c:pt idx="1605">
                  <c:v>1.73649</c:v>
                </c:pt>
                <c:pt idx="1606">
                  <c:v>1.02978</c:v>
                </c:pt>
                <c:pt idx="1607">
                  <c:v>1.37237</c:v>
                </c:pt>
                <c:pt idx="1608">
                  <c:v>1.54265</c:v>
                </c:pt>
                <c:pt idx="1609">
                  <c:v>2.75281</c:v>
                </c:pt>
                <c:pt idx="1610">
                  <c:v>2.95675</c:v>
                </c:pt>
                <c:pt idx="1611">
                  <c:v>1.49352</c:v>
                </c:pt>
                <c:pt idx="1612">
                  <c:v>1.54938</c:v>
                </c:pt>
                <c:pt idx="1613">
                  <c:v>2.05148</c:v>
                </c:pt>
                <c:pt idx="1614">
                  <c:v>1.91216</c:v>
                </c:pt>
                <c:pt idx="1615">
                  <c:v>1.43362</c:v>
                </c:pt>
                <c:pt idx="1616">
                  <c:v>2.88339</c:v>
                </c:pt>
                <c:pt idx="1617">
                  <c:v>3.2953</c:v>
                </c:pt>
                <c:pt idx="1618">
                  <c:v>1.85293</c:v>
                </c:pt>
                <c:pt idx="1619">
                  <c:v>2.1861</c:v>
                </c:pt>
                <c:pt idx="1620">
                  <c:v>2.18946</c:v>
                </c:pt>
                <c:pt idx="1621">
                  <c:v>2.893479999999998</c:v>
                </c:pt>
                <c:pt idx="1622">
                  <c:v>3.53491</c:v>
                </c:pt>
                <c:pt idx="1623">
                  <c:v>1.86572</c:v>
                </c:pt>
                <c:pt idx="1624">
                  <c:v>1.30843</c:v>
                </c:pt>
                <c:pt idx="1625">
                  <c:v>3.386829999999998</c:v>
                </c:pt>
                <c:pt idx="1626">
                  <c:v>2.23725</c:v>
                </c:pt>
                <c:pt idx="1627">
                  <c:v>4.28133</c:v>
                </c:pt>
                <c:pt idx="1628">
                  <c:v>3.36732</c:v>
                </c:pt>
                <c:pt idx="1629">
                  <c:v>3.6675</c:v>
                </c:pt>
                <c:pt idx="1630">
                  <c:v>2.78848</c:v>
                </c:pt>
                <c:pt idx="1631">
                  <c:v>1.87784</c:v>
                </c:pt>
                <c:pt idx="1632">
                  <c:v>4.27864</c:v>
                </c:pt>
                <c:pt idx="1633">
                  <c:v>2.446569999999999</c:v>
                </c:pt>
                <c:pt idx="1634">
                  <c:v>3.67894</c:v>
                </c:pt>
                <c:pt idx="1635">
                  <c:v>1.53525</c:v>
                </c:pt>
                <c:pt idx="1636">
                  <c:v>2.11071</c:v>
                </c:pt>
                <c:pt idx="1637">
                  <c:v>1.96062</c:v>
                </c:pt>
                <c:pt idx="1638">
                  <c:v>4.78814</c:v>
                </c:pt>
                <c:pt idx="1639">
                  <c:v>2.54484</c:v>
                </c:pt>
                <c:pt idx="1640">
                  <c:v>1.5164</c:v>
                </c:pt>
                <c:pt idx="1641">
                  <c:v>3.66615</c:v>
                </c:pt>
                <c:pt idx="1642">
                  <c:v>5.48005</c:v>
                </c:pt>
                <c:pt idx="1643">
                  <c:v>2.56301</c:v>
                </c:pt>
                <c:pt idx="1644">
                  <c:v>5.28217</c:v>
                </c:pt>
                <c:pt idx="1645">
                  <c:v>4.07268</c:v>
                </c:pt>
                <c:pt idx="1646">
                  <c:v>2.63099</c:v>
                </c:pt>
                <c:pt idx="1647">
                  <c:v>1.69678</c:v>
                </c:pt>
                <c:pt idx="1648">
                  <c:v>3.21722</c:v>
                </c:pt>
                <c:pt idx="1649">
                  <c:v>4.817759999999994</c:v>
                </c:pt>
                <c:pt idx="1650">
                  <c:v>6.527329999999997</c:v>
                </c:pt>
                <c:pt idx="1651">
                  <c:v>3.31549</c:v>
                </c:pt>
                <c:pt idx="1652">
                  <c:v>3.479039999999999</c:v>
                </c:pt>
                <c:pt idx="1653">
                  <c:v>3.13511</c:v>
                </c:pt>
                <c:pt idx="1654">
                  <c:v>3.89028</c:v>
                </c:pt>
                <c:pt idx="1655">
                  <c:v>3.915189999999999</c:v>
                </c:pt>
                <c:pt idx="1656">
                  <c:v>4.35133</c:v>
                </c:pt>
                <c:pt idx="1657">
                  <c:v>3.48308</c:v>
                </c:pt>
                <c:pt idx="1658">
                  <c:v>4.763909999999996</c:v>
                </c:pt>
                <c:pt idx="1659">
                  <c:v>6.98232</c:v>
                </c:pt>
                <c:pt idx="1660">
                  <c:v>3.545</c:v>
                </c:pt>
                <c:pt idx="1661">
                  <c:v>6.844339999999994</c:v>
                </c:pt>
                <c:pt idx="1662">
                  <c:v>2.402149999999998</c:v>
                </c:pt>
                <c:pt idx="1663">
                  <c:v>5.620049999999995</c:v>
                </c:pt>
                <c:pt idx="1664">
                  <c:v>3.37943</c:v>
                </c:pt>
                <c:pt idx="1665">
                  <c:v>4.4745</c:v>
                </c:pt>
                <c:pt idx="1666">
                  <c:v>2.11408</c:v>
                </c:pt>
                <c:pt idx="1667">
                  <c:v>6.2931</c:v>
                </c:pt>
                <c:pt idx="1668">
                  <c:v>3.22126</c:v>
                </c:pt>
                <c:pt idx="1669">
                  <c:v>1.98081</c:v>
                </c:pt>
                <c:pt idx="1670">
                  <c:v>4.7067</c:v>
                </c:pt>
                <c:pt idx="1671">
                  <c:v>8.02017</c:v>
                </c:pt>
                <c:pt idx="1672">
                  <c:v>3.328279999999999</c:v>
                </c:pt>
                <c:pt idx="1673">
                  <c:v>2.69089</c:v>
                </c:pt>
                <c:pt idx="1674">
                  <c:v>3.08059</c:v>
                </c:pt>
                <c:pt idx="1675">
                  <c:v>1.83274</c:v>
                </c:pt>
                <c:pt idx="1676">
                  <c:v>3.376739999999998</c:v>
                </c:pt>
                <c:pt idx="1677">
                  <c:v>7.03347</c:v>
                </c:pt>
                <c:pt idx="1678">
                  <c:v>3.685</c:v>
                </c:pt>
                <c:pt idx="1679">
                  <c:v>2.5132</c:v>
                </c:pt>
                <c:pt idx="1680">
                  <c:v>6.40887</c:v>
                </c:pt>
                <c:pt idx="1681">
                  <c:v>2.82281</c:v>
                </c:pt>
                <c:pt idx="1682">
                  <c:v>2.655889999999998</c:v>
                </c:pt>
                <c:pt idx="1683">
                  <c:v>3.07992</c:v>
                </c:pt>
                <c:pt idx="1684">
                  <c:v>2.816749999999952</c:v>
                </c:pt>
                <c:pt idx="1685">
                  <c:v>3.01934</c:v>
                </c:pt>
                <c:pt idx="1686">
                  <c:v>5.348129999999998</c:v>
                </c:pt>
                <c:pt idx="1687">
                  <c:v>2.15042</c:v>
                </c:pt>
                <c:pt idx="1688">
                  <c:v>3.24078</c:v>
                </c:pt>
                <c:pt idx="1689">
                  <c:v>4.5943</c:v>
                </c:pt>
                <c:pt idx="1690">
                  <c:v>6.840969999999999</c:v>
                </c:pt>
                <c:pt idx="1691">
                  <c:v>3.374049999999996</c:v>
                </c:pt>
                <c:pt idx="1692">
                  <c:v>2.45196</c:v>
                </c:pt>
                <c:pt idx="1693">
                  <c:v>1.89197</c:v>
                </c:pt>
                <c:pt idx="1694">
                  <c:v>3.03213</c:v>
                </c:pt>
                <c:pt idx="1695">
                  <c:v>4.764589999999964</c:v>
                </c:pt>
                <c:pt idx="1696">
                  <c:v>5.521109999999998</c:v>
                </c:pt>
                <c:pt idx="1697">
                  <c:v>2.96483</c:v>
                </c:pt>
                <c:pt idx="1698">
                  <c:v>2.229849999999999</c:v>
                </c:pt>
                <c:pt idx="1699">
                  <c:v>4.2046</c:v>
                </c:pt>
                <c:pt idx="1700">
                  <c:v>3.58741</c:v>
                </c:pt>
                <c:pt idx="1701">
                  <c:v>3.3801</c:v>
                </c:pt>
                <c:pt idx="1702">
                  <c:v>2.56368</c:v>
                </c:pt>
                <c:pt idx="1703">
                  <c:v>4.564019999999974</c:v>
                </c:pt>
                <c:pt idx="1704">
                  <c:v>3.4178</c:v>
                </c:pt>
                <c:pt idx="1705">
                  <c:v>2.19687</c:v>
                </c:pt>
                <c:pt idx="1706">
                  <c:v>2.808679999999998</c:v>
                </c:pt>
                <c:pt idx="1707">
                  <c:v>2.83223</c:v>
                </c:pt>
                <c:pt idx="1708">
                  <c:v>2.590609999999999</c:v>
                </c:pt>
                <c:pt idx="1709">
                  <c:v>4.84939</c:v>
                </c:pt>
                <c:pt idx="1710">
                  <c:v>4.837949999999997</c:v>
                </c:pt>
                <c:pt idx="1711">
                  <c:v>6.07705</c:v>
                </c:pt>
                <c:pt idx="1712">
                  <c:v>3.76307</c:v>
                </c:pt>
                <c:pt idx="1713">
                  <c:v>5.384469999999998</c:v>
                </c:pt>
                <c:pt idx="1714">
                  <c:v>5.683989999999984</c:v>
                </c:pt>
                <c:pt idx="1715">
                  <c:v>2.83223</c:v>
                </c:pt>
                <c:pt idx="1716">
                  <c:v>3.04021</c:v>
                </c:pt>
                <c:pt idx="1717">
                  <c:v>3.25424</c:v>
                </c:pt>
                <c:pt idx="1718">
                  <c:v>3.91249</c:v>
                </c:pt>
                <c:pt idx="1719">
                  <c:v>7.25154</c:v>
                </c:pt>
                <c:pt idx="1720">
                  <c:v>6.957409999999999</c:v>
                </c:pt>
                <c:pt idx="1721">
                  <c:v>3.878839999999998</c:v>
                </c:pt>
                <c:pt idx="1722">
                  <c:v>4.129889999999985</c:v>
                </c:pt>
                <c:pt idx="1723">
                  <c:v>4.895159999999985</c:v>
                </c:pt>
                <c:pt idx="1724">
                  <c:v>4.51017</c:v>
                </c:pt>
                <c:pt idx="1725">
                  <c:v>5.465909999999996</c:v>
                </c:pt>
                <c:pt idx="1726">
                  <c:v>3.811529999999998</c:v>
                </c:pt>
                <c:pt idx="1727">
                  <c:v>2.561659999999998</c:v>
                </c:pt>
                <c:pt idx="1728">
                  <c:v>3.35991</c:v>
                </c:pt>
                <c:pt idx="1729">
                  <c:v>4.13191</c:v>
                </c:pt>
                <c:pt idx="1730">
                  <c:v>4.27258</c:v>
                </c:pt>
                <c:pt idx="1731">
                  <c:v>3.76577</c:v>
                </c:pt>
                <c:pt idx="1732">
                  <c:v>4.893809999999997</c:v>
                </c:pt>
                <c:pt idx="1733">
                  <c:v>3.138479999999999</c:v>
                </c:pt>
                <c:pt idx="1734">
                  <c:v>3.15261</c:v>
                </c:pt>
                <c:pt idx="1735">
                  <c:v>7.57999</c:v>
                </c:pt>
                <c:pt idx="1736">
                  <c:v>5.42015</c:v>
                </c:pt>
                <c:pt idx="1737">
                  <c:v>6.63233</c:v>
                </c:pt>
                <c:pt idx="1738">
                  <c:v>3.565869999999999</c:v>
                </c:pt>
                <c:pt idx="1739">
                  <c:v>6.245989999999995</c:v>
                </c:pt>
                <c:pt idx="1740">
                  <c:v>3.77384</c:v>
                </c:pt>
                <c:pt idx="1741">
                  <c:v>4.2396</c:v>
                </c:pt>
                <c:pt idx="1742">
                  <c:v>3.595479999999998</c:v>
                </c:pt>
                <c:pt idx="1743">
                  <c:v>3.02473</c:v>
                </c:pt>
                <c:pt idx="1744">
                  <c:v>6.10263</c:v>
                </c:pt>
                <c:pt idx="1745">
                  <c:v>3.47433</c:v>
                </c:pt>
                <c:pt idx="1746">
                  <c:v>4.52902</c:v>
                </c:pt>
                <c:pt idx="1747">
                  <c:v>5.121309999999998</c:v>
                </c:pt>
                <c:pt idx="1748">
                  <c:v>4.665649999999998</c:v>
                </c:pt>
                <c:pt idx="1749">
                  <c:v>3.15732</c:v>
                </c:pt>
                <c:pt idx="1750">
                  <c:v>6.058879999999998</c:v>
                </c:pt>
                <c:pt idx="1751">
                  <c:v>12.4469</c:v>
                </c:pt>
                <c:pt idx="1752">
                  <c:v>7.93941</c:v>
                </c:pt>
                <c:pt idx="1753">
                  <c:v>7.67961</c:v>
                </c:pt>
                <c:pt idx="1754">
                  <c:v>8.39305</c:v>
                </c:pt>
                <c:pt idx="1755">
                  <c:v>6.025899999999996</c:v>
                </c:pt>
                <c:pt idx="1756">
                  <c:v>6.052149999999997</c:v>
                </c:pt>
                <c:pt idx="1757">
                  <c:v>5.23438</c:v>
                </c:pt>
                <c:pt idx="1758">
                  <c:v>4.43815</c:v>
                </c:pt>
                <c:pt idx="1759">
                  <c:v>3.76038</c:v>
                </c:pt>
                <c:pt idx="1760">
                  <c:v>3.63317</c:v>
                </c:pt>
                <c:pt idx="1761">
                  <c:v>3.053669999999999</c:v>
                </c:pt>
                <c:pt idx="1762">
                  <c:v>3.999989999999999</c:v>
                </c:pt>
                <c:pt idx="1763">
                  <c:v>3.52818</c:v>
                </c:pt>
                <c:pt idx="1764">
                  <c:v>3.355199999999999</c:v>
                </c:pt>
                <c:pt idx="1765">
                  <c:v>5.557449999999998</c:v>
                </c:pt>
                <c:pt idx="1766">
                  <c:v>5.38649</c:v>
                </c:pt>
                <c:pt idx="1767">
                  <c:v>8.185070000000001</c:v>
                </c:pt>
                <c:pt idx="1768">
                  <c:v>2.72589</c:v>
                </c:pt>
                <c:pt idx="1769">
                  <c:v>5.858979999999986</c:v>
                </c:pt>
                <c:pt idx="1770">
                  <c:v>3.91047</c:v>
                </c:pt>
                <c:pt idx="1771">
                  <c:v>7.99325</c:v>
                </c:pt>
                <c:pt idx="1772">
                  <c:v>3.139819999999998</c:v>
                </c:pt>
                <c:pt idx="1773">
                  <c:v>5.56216</c:v>
                </c:pt>
                <c:pt idx="1774">
                  <c:v>3.526829999999999</c:v>
                </c:pt>
                <c:pt idx="1775">
                  <c:v>3.925279999999999</c:v>
                </c:pt>
                <c:pt idx="1776">
                  <c:v>4.24027</c:v>
                </c:pt>
                <c:pt idx="1777">
                  <c:v>3.47501</c:v>
                </c:pt>
                <c:pt idx="1778">
                  <c:v>3.97778</c:v>
                </c:pt>
                <c:pt idx="1779">
                  <c:v>4.8817</c:v>
                </c:pt>
                <c:pt idx="1780">
                  <c:v>2.21033</c:v>
                </c:pt>
                <c:pt idx="1781">
                  <c:v>5.125349999999997</c:v>
                </c:pt>
                <c:pt idx="1782">
                  <c:v>3.64327</c:v>
                </c:pt>
                <c:pt idx="1783">
                  <c:v>5.823309999999997</c:v>
                </c:pt>
                <c:pt idx="1784">
                  <c:v>5.633509999999997</c:v>
                </c:pt>
                <c:pt idx="1785">
                  <c:v>1.94178</c:v>
                </c:pt>
                <c:pt idx="1786">
                  <c:v>2.911649999999952</c:v>
                </c:pt>
                <c:pt idx="1787">
                  <c:v>5.845519999999984</c:v>
                </c:pt>
                <c:pt idx="1788">
                  <c:v>4.244979999999996</c:v>
                </c:pt>
                <c:pt idx="1789">
                  <c:v>4.397769999999999</c:v>
                </c:pt>
                <c:pt idx="1790">
                  <c:v>4.58825</c:v>
                </c:pt>
                <c:pt idx="1791">
                  <c:v>4.784109999999996</c:v>
                </c:pt>
                <c:pt idx="1792">
                  <c:v>3.44943</c:v>
                </c:pt>
                <c:pt idx="1793">
                  <c:v>2.959439999999998</c:v>
                </c:pt>
                <c:pt idx="1794">
                  <c:v>9.71023</c:v>
                </c:pt>
                <c:pt idx="1795">
                  <c:v>6.29109</c:v>
                </c:pt>
                <c:pt idx="1796">
                  <c:v>4.444879999999999</c:v>
                </c:pt>
                <c:pt idx="1797">
                  <c:v>7.40096</c:v>
                </c:pt>
                <c:pt idx="1798">
                  <c:v>3.12434</c:v>
                </c:pt>
                <c:pt idx="1799">
                  <c:v>9.01563</c:v>
                </c:pt>
                <c:pt idx="1800">
                  <c:v>3.22328</c:v>
                </c:pt>
                <c:pt idx="1801">
                  <c:v>4.617859999999966</c:v>
                </c:pt>
                <c:pt idx="1802">
                  <c:v>8.29007</c:v>
                </c:pt>
                <c:pt idx="1803">
                  <c:v>4.514879999999986</c:v>
                </c:pt>
                <c:pt idx="1804">
                  <c:v>3.19299</c:v>
                </c:pt>
                <c:pt idx="1805">
                  <c:v>7.042889999999995</c:v>
                </c:pt>
                <c:pt idx="1806">
                  <c:v>2.08918</c:v>
                </c:pt>
                <c:pt idx="1807">
                  <c:v>7.8822</c:v>
                </c:pt>
                <c:pt idx="1808">
                  <c:v>7.59009</c:v>
                </c:pt>
                <c:pt idx="1809">
                  <c:v>6.010419999999995</c:v>
                </c:pt>
                <c:pt idx="1810">
                  <c:v>2.80127</c:v>
                </c:pt>
                <c:pt idx="1811">
                  <c:v>6.814049999999995</c:v>
                </c:pt>
                <c:pt idx="1812">
                  <c:v>5.55341</c:v>
                </c:pt>
                <c:pt idx="1813">
                  <c:v>3.40097</c:v>
                </c:pt>
                <c:pt idx="1814">
                  <c:v>5.808429999999999</c:v>
                </c:pt>
                <c:pt idx="1815">
                  <c:v>3.53087</c:v>
                </c:pt>
                <c:pt idx="1816">
                  <c:v>4.14874</c:v>
                </c:pt>
                <c:pt idx="1817">
                  <c:v>1.8738</c:v>
                </c:pt>
                <c:pt idx="1818">
                  <c:v>2.40821</c:v>
                </c:pt>
                <c:pt idx="1819">
                  <c:v>2.9554</c:v>
                </c:pt>
                <c:pt idx="1820">
                  <c:v>1.94985</c:v>
                </c:pt>
                <c:pt idx="1821">
                  <c:v>2.541469999999999</c:v>
                </c:pt>
                <c:pt idx="1822">
                  <c:v>2.87598</c:v>
                </c:pt>
                <c:pt idx="1823">
                  <c:v>1.78563</c:v>
                </c:pt>
                <c:pt idx="1824">
                  <c:v>3.23472</c:v>
                </c:pt>
                <c:pt idx="1825">
                  <c:v>1.58505</c:v>
                </c:pt>
                <c:pt idx="1826">
                  <c:v>1.68467</c:v>
                </c:pt>
                <c:pt idx="1827">
                  <c:v>3.82567</c:v>
                </c:pt>
                <c:pt idx="1828">
                  <c:v>4.00268</c:v>
                </c:pt>
                <c:pt idx="1829">
                  <c:v>1.90207</c:v>
                </c:pt>
                <c:pt idx="1830">
                  <c:v>2.315999999999998</c:v>
                </c:pt>
                <c:pt idx="1831">
                  <c:v>2.91031</c:v>
                </c:pt>
                <c:pt idx="1832">
                  <c:v>3.73077</c:v>
                </c:pt>
                <c:pt idx="1833">
                  <c:v>2.67003</c:v>
                </c:pt>
                <c:pt idx="1834">
                  <c:v>5.663789999999984</c:v>
                </c:pt>
                <c:pt idx="1835">
                  <c:v>2.75079</c:v>
                </c:pt>
                <c:pt idx="1836">
                  <c:v>2.20562</c:v>
                </c:pt>
                <c:pt idx="1837">
                  <c:v>1.96668</c:v>
                </c:pt>
                <c:pt idx="1838">
                  <c:v>2.54955</c:v>
                </c:pt>
                <c:pt idx="1839">
                  <c:v>1.98485</c:v>
                </c:pt>
                <c:pt idx="1840">
                  <c:v>3.5201</c:v>
                </c:pt>
                <c:pt idx="1841">
                  <c:v>1.71496</c:v>
                </c:pt>
                <c:pt idx="1842">
                  <c:v>3.490489999999998</c:v>
                </c:pt>
                <c:pt idx="1843">
                  <c:v>2.578489999999999</c:v>
                </c:pt>
                <c:pt idx="1844">
                  <c:v>1.31247</c:v>
                </c:pt>
                <c:pt idx="1845">
                  <c:v>1.36362</c:v>
                </c:pt>
                <c:pt idx="1846">
                  <c:v>2.74137</c:v>
                </c:pt>
                <c:pt idx="1847">
                  <c:v>1.41948</c:v>
                </c:pt>
                <c:pt idx="1848">
                  <c:v>1.34141</c:v>
                </c:pt>
                <c:pt idx="1849">
                  <c:v>1.27208</c:v>
                </c:pt>
                <c:pt idx="1850">
                  <c:v>1.5339</c:v>
                </c:pt>
                <c:pt idx="1851">
                  <c:v>2.11341</c:v>
                </c:pt>
                <c:pt idx="1852">
                  <c:v>2.48359</c:v>
                </c:pt>
                <c:pt idx="1853">
                  <c:v>1.93908</c:v>
                </c:pt>
                <c:pt idx="1854">
                  <c:v>1.24987</c:v>
                </c:pt>
                <c:pt idx="1855">
                  <c:v>4.24027</c:v>
                </c:pt>
                <c:pt idx="1856">
                  <c:v>2.72118</c:v>
                </c:pt>
                <c:pt idx="1857">
                  <c:v>1.12805</c:v>
                </c:pt>
                <c:pt idx="1858">
                  <c:v>1.95995</c:v>
                </c:pt>
                <c:pt idx="1859">
                  <c:v>1.64563</c:v>
                </c:pt>
                <c:pt idx="1860">
                  <c:v>2.51051</c:v>
                </c:pt>
                <c:pt idx="1861">
                  <c:v>2.11273</c:v>
                </c:pt>
                <c:pt idx="1862">
                  <c:v>1.67592</c:v>
                </c:pt>
                <c:pt idx="1863">
                  <c:v>2.5933</c:v>
                </c:pt>
                <c:pt idx="1864">
                  <c:v>4.99275</c:v>
                </c:pt>
                <c:pt idx="1865">
                  <c:v>1.39862</c:v>
                </c:pt>
                <c:pt idx="1866">
                  <c:v>2.126869999999998</c:v>
                </c:pt>
                <c:pt idx="1867">
                  <c:v>1.33064</c:v>
                </c:pt>
                <c:pt idx="1868">
                  <c:v>1.71765</c:v>
                </c:pt>
                <c:pt idx="1869">
                  <c:v>1.51304</c:v>
                </c:pt>
                <c:pt idx="1870">
                  <c:v>2.43109</c:v>
                </c:pt>
                <c:pt idx="1871">
                  <c:v>1.12266</c:v>
                </c:pt>
                <c:pt idx="1872">
                  <c:v>1.32862</c:v>
                </c:pt>
                <c:pt idx="1873">
                  <c:v>1.37641</c:v>
                </c:pt>
                <c:pt idx="1874">
                  <c:v>2.134269999999999</c:v>
                </c:pt>
                <c:pt idx="1875">
                  <c:v>2.36311</c:v>
                </c:pt>
                <c:pt idx="1876">
                  <c:v>2.90694</c:v>
                </c:pt>
                <c:pt idx="1877">
                  <c:v>2.67945</c:v>
                </c:pt>
                <c:pt idx="1878">
                  <c:v>2.246669999999999</c:v>
                </c:pt>
                <c:pt idx="1879">
                  <c:v>4.057199999999995</c:v>
                </c:pt>
                <c:pt idx="1880">
                  <c:v>3.51404</c:v>
                </c:pt>
                <c:pt idx="1881">
                  <c:v>4.914009999999998</c:v>
                </c:pt>
                <c:pt idx="1882">
                  <c:v>6.47685</c:v>
                </c:pt>
                <c:pt idx="1883">
                  <c:v>2.72791</c:v>
                </c:pt>
                <c:pt idx="1884">
                  <c:v>2.60339</c:v>
                </c:pt>
                <c:pt idx="1885">
                  <c:v>1.30775</c:v>
                </c:pt>
                <c:pt idx="1886">
                  <c:v>1.23978</c:v>
                </c:pt>
                <c:pt idx="1887">
                  <c:v>0.942956</c:v>
                </c:pt>
                <c:pt idx="1888">
                  <c:v>1.46188</c:v>
                </c:pt>
                <c:pt idx="1889">
                  <c:v>2.10398</c:v>
                </c:pt>
                <c:pt idx="1890">
                  <c:v>1.44371</c:v>
                </c:pt>
                <c:pt idx="1891">
                  <c:v>2.2534</c:v>
                </c:pt>
                <c:pt idx="1892">
                  <c:v>1.64226</c:v>
                </c:pt>
                <c:pt idx="1893">
                  <c:v>1.93505</c:v>
                </c:pt>
                <c:pt idx="1894">
                  <c:v>1.60996</c:v>
                </c:pt>
                <c:pt idx="1895">
                  <c:v>2.26417</c:v>
                </c:pt>
                <c:pt idx="1896">
                  <c:v>2.10937</c:v>
                </c:pt>
                <c:pt idx="1897">
                  <c:v>2.24802</c:v>
                </c:pt>
                <c:pt idx="1898">
                  <c:v>1.52246</c:v>
                </c:pt>
                <c:pt idx="1899">
                  <c:v>2.04341</c:v>
                </c:pt>
                <c:pt idx="1900">
                  <c:v>1.57361</c:v>
                </c:pt>
                <c:pt idx="1901">
                  <c:v>2.2009</c:v>
                </c:pt>
                <c:pt idx="1902">
                  <c:v>3.12098</c:v>
                </c:pt>
                <c:pt idx="1903">
                  <c:v>3.26501</c:v>
                </c:pt>
                <c:pt idx="1904">
                  <c:v>1.40602</c:v>
                </c:pt>
                <c:pt idx="1905">
                  <c:v>2.751469999999998</c:v>
                </c:pt>
                <c:pt idx="1906">
                  <c:v>3.44808</c:v>
                </c:pt>
                <c:pt idx="1907">
                  <c:v>2.172639999999999</c:v>
                </c:pt>
                <c:pt idx="1908">
                  <c:v>1.79841</c:v>
                </c:pt>
                <c:pt idx="1909">
                  <c:v>2.65387</c:v>
                </c:pt>
                <c:pt idx="1910">
                  <c:v>5.37169</c:v>
                </c:pt>
                <c:pt idx="1911">
                  <c:v>4.20931</c:v>
                </c:pt>
                <c:pt idx="1912">
                  <c:v>5.651009999999998</c:v>
                </c:pt>
                <c:pt idx="1913">
                  <c:v>5.016979999999998</c:v>
                </c:pt>
                <c:pt idx="1914">
                  <c:v>2.76897</c:v>
                </c:pt>
                <c:pt idx="1915">
                  <c:v>2.89887</c:v>
                </c:pt>
                <c:pt idx="1916">
                  <c:v>3.20107</c:v>
                </c:pt>
                <c:pt idx="1917">
                  <c:v>7.01866</c:v>
                </c:pt>
                <c:pt idx="1918">
                  <c:v>2.64849</c:v>
                </c:pt>
                <c:pt idx="1919">
                  <c:v>4.306909999999998</c:v>
                </c:pt>
                <c:pt idx="1920">
                  <c:v>3.556449999999952</c:v>
                </c:pt>
                <c:pt idx="1921">
                  <c:v>4.611129999999997</c:v>
                </c:pt>
                <c:pt idx="1922">
                  <c:v>3.91047</c:v>
                </c:pt>
                <c:pt idx="1923">
                  <c:v>4.645459999999994</c:v>
                </c:pt>
                <c:pt idx="1924">
                  <c:v>4.43748</c:v>
                </c:pt>
                <c:pt idx="1925">
                  <c:v>2.17465</c:v>
                </c:pt>
                <c:pt idx="1926">
                  <c:v>3.46895</c:v>
                </c:pt>
                <c:pt idx="1927">
                  <c:v>2.412239999999997</c:v>
                </c:pt>
                <c:pt idx="1928">
                  <c:v>2.73329</c:v>
                </c:pt>
                <c:pt idx="1929">
                  <c:v>3.85663</c:v>
                </c:pt>
                <c:pt idx="1930">
                  <c:v>4.67911</c:v>
                </c:pt>
                <c:pt idx="1931">
                  <c:v>2.58387</c:v>
                </c:pt>
                <c:pt idx="1932">
                  <c:v>2.826849999999952</c:v>
                </c:pt>
                <c:pt idx="1933">
                  <c:v>3.56991</c:v>
                </c:pt>
                <c:pt idx="1934">
                  <c:v>4.132579999999995</c:v>
                </c:pt>
                <c:pt idx="1935">
                  <c:v>4.80632</c:v>
                </c:pt>
                <c:pt idx="1936">
                  <c:v>7.10616</c:v>
                </c:pt>
                <c:pt idx="1937">
                  <c:v>3.54029</c:v>
                </c:pt>
                <c:pt idx="1938">
                  <c:v>1.58371</c:v>
                </c:pt>
                <c:pt idx="1939">
                  <c:v>4.70738</c:v>
                </c:pt>
                <c:pt idx="1940">
                  <c:v>3.76173</c:v>
                </c:pt>
                <c:pt idx="1941">
                  <c:v>3.06713</c:v>
                </c:pt>
                <c:pt idx="1942">
                  <c:v>2.31129</c:v>
                </c:pt>
                <c:pt idx="1943">
                  <c:v>3.13578</c:v>
                </c:pt>
                <c:pt idx="1944">
                  <c:v>3.66683</c:v>
                </c:pt>
                <c:pt idx="1945">
                  <c:v>4.54046</c:v>
                </c:pt>
                <c:pt idx="1946">
                  <c:v>5.58168</c:v>
                </c:pt>
                <c:pt idx="1947">
                  <c:v>4.620549999999985</c:v>
                </c:pt>
                <c:pt idx="1948">
                  <c:v>5.74927</c:v>
                </c:pt>
                <c:pt idx="1949">
                  <c:v>2.73868</c:v>
                </c:pt>
                <c:pt idx="1950">
                  <c:v>2.99983</c:v>
                </c:pt>
                <c:pt idx="1951">
                  <c:v>4.94093</c:v>
                </c:pt>
                <c:pt idx="1952">
                  <c:v>4.63469</c:v>
                </c:pt>
                <c:pt idx="1953">
                  <c:v>4.33585</c:v>
                </c:pt>
                <c:pt idx="1954">
                  <c:v>7.869409999999998</c:v>
                </c:pt>
                <c:pt idx="1955">
                  <c:v>4.47046</c:v>
                </c:pt>
                <c:pt idx="1956">
                  <c:v>3.30405</c:v>
                </c:pt>
                <c:pt idx="1957">
                  <c:v>5.25659</c:v>
                </c:pt>
                <c:pt idx="1958">
                  <c:v>6.294449999999999</c:v>
                </c:pt>
                <c:pt idx="1959">
                  <c:v>5.0015</c:v>
                </c:pt>
                <c:pt idx="1960">
                  <c:v>3.481059999999998</c:v>
                </c:pt>
                <c:pt idx="1961">
                  <c:v>6.7353</c:v>
                </c:pt>
                <c:pt idx="1962">
                  <c:v>4.88237</c:v>
                </c:pt>
                <c:pt idx="1963">
                  <c:v>4.25172</c:v>
                </c:pt>
                <c:pt idx="1964">
                  <c:v>5.867059999999975</c:v>
                </c:pt>
                <c:pt idx="1965">
                  <c:v>6.0185</c:v>
                </c:pt>
                <c:pt idx="1966">
                  <c:v>8.212</c:v>
                </c:pt>
                <c:pt idx="1967">
                  <c:v>2.54416</c:v>
                </c:pt>
                <c:pt idx="1968">
                  <c:v>3.1728</c:v>
                </c:pt>
                <c:pt idx="1969">
                  <c:v>2.22446</c:v>
                </c:pt>
                <c:pt idx="1970">
                  <c:v>2.33619</c:v>
                </c:pt>
                <c:pt idx="1971">
                  <c:v>5.47736</c:v>
                </c:pt>
                <c:pt idx="1972">
                  <c:v>3.83778</c:v>
                </c:pt>
                <c:pt idx="1973">
                  <c:v>3.20578</c:v>
                </c:pt>
                <c:pt idx="1974">
                  <c:v>4.142009999999996</c:v>
                </c:pt>
                <c:pt idx="1975">
                  <c:v>3.33434</c:v>
                </c:pt>
                <c:pt idx="1976">
                  <c:v>4.47383</c:v>
                </c:pt>
                <c:pt idx="1977">
                  <c:v>6.89886</c:v>
                </c:pt>
                <c:pt idx="1978">
                  <c:v>7.157989999999937</c:v>
                </c:pt>
                <c:pt idx="1979">
                  <c:v>4.91266</c:v>
                </c:pt>
                <c:pt idx="1980">
                  <c:v>3.70317</c:v>
                </c:pt>
                <c:pt idx="1981">
                  <c:v>4.374889999999985</c:v>
                </c:pt>
                <c:pt idx="1982">
                  <c:v>4.74507</c:v>
                </c:pt>
                <c:pt idx="1983">
                  <c:v>8.94496</c:v>
                </c:pt>
                <c:pt idx="1984">
                  <c:v>8.2369</c:v>
                </c:pt>
                <c:pt idx="1985">
                  <c:v>4.53777</c:v>
                </c:pt>
                <c:pt idx="1986">
                  <c:v>8.966500000000006</c:v>
                </c:pt>
                <c:pt idx="1987">
                  <c:v>9.798400000000001</c:v>
                </c:pt>
                <c:pt idx="1988">
                  <c:v>7.44202</c:v>
                </c:pt>
                <c:pt idx="1989">
                  <c:v>6.40214</c:v>
                </c:pt>
                <c:pt idx="1990">
                  <c:v>3.64394</c:v>
                </c:pt>
                <c:pt idx="1991">
                  <c:v>5.524469999999996</c:v>
                </c:pt>
                <c:pt idx="1992">
                  <c:v>4.6717</c:v>
                </c:pt>
                <c:pt idx="1993">
                  <c:v>5.3138</c:v>
                </c:pt>
                <c:pt idx="1994">
                  <c:v>5.847539999999975</c:v>
                </c:pt>
                <c:pt idx="1995">
                  <c:v>6.217719999999995</c:v>
                </c:pt>
                <c:pt idx="1996">
                  <c:v>4.025569999999997</c:v>
                </c:pt>
                <c:pt idx="1997">
                  <c:v>3.374719999999999</c:v>
                </c:pt>
                <c:pt idx="1998">
                  <c:v>5.30505</c:v>
                </c:pt>
                <c:pt idx="1999">
                  <c:v>4.33517</c:v>
                </c:pt>
                <c:pt idx="2000">
                  <c:v>4.24027</c:v>
                </c:pt>
                <c:pt idx="2001">
                  <c:v>3.83711</c:v>
                </c:pt>
                <c:pt idx="2002">
                  <c:v>4.47652</c:v>
                </c:pt>
                <c:pt idx="2003">
                  <c:v>4.7269</c:v>
                </c:pt>
                <c:pt idx="2004">
                  <c:v>5.06948</c:v>
                </c:pt>
                <c:pt idx="2005">
                  <c:v>4.06864</c:v>
                </c:pt>
                <c:pt idx="2006">
                  <c:v>5.55274</c:v>
                </c:pt>
                <c:pt idx="2007">
                  <c:v>6.087819999999994</c:v>
                </c:pt>
                <c:pt idx="2008">
                  <c:v>3.17953</c:v>
                </c:pt>
                <c:pt idx="2009">
                  <c:v>5.59178</c:v>
                </c:pt>
                <c:pt idx="2010">
                  <c:v>2.85781</c:v>
                </c:pt>
                <c:pt idx="2011">
                  <c:v>4.80228</c:v>
                </c:pt>
                <c:pt idx="2012">
                  <c:v>4.096909999999998</c:v>
                </c:pt>
                <c:pt idx="2013">
                  <c:v>6.363779999999997</c:v>
                </c:pt>
                <c:pt idx="2014">
                  <c:v>7.74557</c:v>
                </c:pt>
                <c:pt idx="2015">
                  <c:v>5.858309999999999</c:v>
                </c:pt>
                <c:pt idx="2016">
                  <c:v>4.42873</c:v>
                </c:pt>
                <c:pt idx="2017">
                  <c:v>4.43883</c:v>
                </c:pt>
                <c:pt idx="2018">
                  <c:v>4.816409999999998</c:v>
                </c:pt>
                <c:pt idx="2019">
                  <c:v>4.08614</c:v>
                </c:pt>
                <c:pt idx="2020">
                  <c:v>3.5026</c:v>
                </c:pt>
                <c:pt idx="2021">
                  <c:v>3.54231</c:v>
                </c:pt>
                <c:pt idx="2022">
                  <c:v>4.159509999999996</c:v>
                </c:pt>
                <c:pt idx="2023">
                  <c:v>5.45044</c:v>
                </c:pt>
                <c:pt idx="2024">
                  <c:v>6.98097</c:v>
                </c:pt>
                <c:pt idx="2025">
                  <c:v>4.633339999999999</c:v>
                </c:pt>
                <c:pt idx="2026">
                  <c:v>5.694749999999995</c:v>
                </c:pt>
                <c:pt idx="2027">
                  <c:v>1.8388</c:v>
                </c:pt>
                <c:pt idx="2028">
                  <c:v>4.45229</c:v>
                </c:pt>
                <c:pt idx="2029">
                  <c:v>5.01631</c:v>
                </c:pt>
                <c:pt idx="2030">
                  <c:v>4.30152</c:v>
                </c:pt>
                <c:pt idx="2031">
                  <c:v>4.896509999999997</c:v>
                </c:pt>
                <c:pt idx="2032">
                  <c:v>6.50916</c:v>
                </c:pt>
                <c:pt idx="2033">
                  <c:v>3.66615</c:v>
                </c:pt>
                <c:pt idx="2034">
                  <c:v>6.04946</c:v>
                </c:pt>
                <c:pt idx="2035">
                  <c:v>3.432599999999999</c:v>
                </c:pt>
                <c:pt idx="2036">
                  <c:v>2.91637</c:v>
                </c:pt>
                <c:pt idx="2037">
                  <c:v>3.176169999999999</c:v>
                </c:pt>
                <c:pt idx="2038">
                  <c:v>4.192489999999966</c:v>
                </c:pt>
                <c:pt idx="2039">
                  <c:v>5.27005</c:v>
                </c:pt>
                <c:pt idx="2040">
                  <c:v>6.682129999999986</c:v>
                </c:pt>
                <c:pt idx="2041">
                  <c:v>6.147719999999985</c:v>
                </c:pt>
                <c:pt idx="2042">
                  <c:v>6.60944</c:v>
                </c:pt>
                <c:pt idx="2043">
                  <c:v>7.087989999999984</c:v>
                </c:pt>
                <c:pt idx="2044">
                  <c:v>4.45902</c:v>
                </c:pt>
                <c:pt idx="2045">
                  <c:v>4.683149999999998</c:v>
                </c:pt>
                <c:pt idx="2046">
                  <c:v>4.49536</c:v>
                </c:pt>
                <c:pt idx="2047">
                  <c:v>7.29529</c:v>
                </c:pt>
                <c:pt idx="2048">
                  <c:v>2.54753</c:v>
                </c:pt>
                <c:pt idx="2049">
                  <c:v>6.58185</c:v>
                </c:pt>
                <c:pt idx="2050">
                  <c:v>3.261649999999999</c:v>
                </c:pt>
                <c:pt idx="2051">
                  <c:v>6.38128</c:v>
                </c:pt>
                <c:pt idx="2052">
                  <c:v>7.63182</c:v>
                </c:pt>
                <c:pt idx="2053">
                  <c:v>4.35267</c:v>
                </c:pt>
                <c:pt idx="2054">
                  <c:v>3.20982</c:v>
                </c:pt>
                <c:pt idx="2055">
                  <c:v>4.83728</c:v>
                </c:pt>
                <c:pt idx="2056">
                  <c:v>4.45969</c:v>
                </c:pt>
                <c:pt idx="2057">
                  <c:v>6.08109</c:v>
                </c:pt>
                <c:pt idx="2058">
                  <c:v>3.357219999999998</c:v>
                </c:pt>
                <c:pt idx="2059">
                  <c:v>4.33652</c:v>
                </c:pt>
                <c:pt idx="2060">
                  <c:v>5.39726</c:v>
                </c:pt>
                <c:pt idx="2061">
                  <c:v>4.193159999999994</c:v>
                </c:pt>
                <c:pt idx="2062">
                  <c:v>6.09522</c:v>
                </c:pt>
                <c:pt idx="2063">
                  <c:v>2.534069999999998</c:v>
                </c:pt>
                <c:pt idx="2064">
                  <c:v>3.43529</c:v>
                </c:pt>
                <c:pt idx="2065">
                  <c:v>4.70132</c:v>
                </c:pt>
                <c:pt idx="2066">
                  <c:v>5.4114</c:v>
                </c:pt>
                <c:pt idx="2067">
                  <c:v>4.613819999999976</c:v>
                </c:pt>
                <c:pt idx="2068">
                  <c:v>4.39306</c:v>
                </c:pt>
                <c:pt idx="2069">
                  <c:v>3.9697</c:v>
                </c:pt>
                <c:pt idx="2070">
                  <c:v>4.85949</c:v>
                </c:pt>
                <c:pt idx="2071">
                  <c:v>7.45952</c:v>
                </c:pt>
                <c:pt idx="2072">
                  <c:v>3.139819999999998</c:v>
                </c:pt>
                <c:pt idx="2073">
                  <c:v>2.76829</c:v>
                </c:pt>
                <c:pt idx="2074">
                  <c:v>2.48897</c:v>
                </c:pt>
                <c:pt idx="2075">
                  <c:v>3.76509</c:v>
                </c:pt>
                <c:pt idx="2076">
                  <c:v>3.13444</c:v>
                </c:pt>
                <c:pt idx="2077">
                  <c:v>2.14167</c:v>
                </c:pt>
                <c:pt idx="2078">
                  <c:v>5.782929999999998</c:v>
                </c:pt>
                <c:pt idx="2079">
                  <c:v>4.6394</c:v>
                </c:pt>
                <c:pt idx="2080">
                  <c:v>2.998479999999998</c:v>
                </c:pt>
                <c:pt idx="2081">
                  <c:v>4.26181</c:v>
                </c:pt>
                <c:pt idx="2082">
                  <c:v>3.12569</c:v>
                </c:pt>
                <c:pt idx="2083">
                  <c:v>3.37135</c:v>
                </c:pt>
                <c:pt idx="2084">
                  <c:v>3.26434</c:v>
                </c:pt>
                <c:pt idx="2085">
                  <c:v>3.413079999999999</c:v>
                </c:pt>
                <c:pt idx="2086">
                  <c:v>3.975089999999998</c:v>
                </c:pt>
                <c:pt idx="2087">
                  <c:v>4.061909999999997</c:v>
                </c:pt>
                <c:pt idx="2088">
                  <c:v>4.63267</c:v>
                </c:pt>
                <c:pt idx="2089">
                  <c:v>1.72169</c:v>
                </c:pt>
                <c:pt idx="2090">
                  <c:v>2.40619</c:v>
                </c:pt>
                <c:pt idx="2091">
                  <c:v>5.50966</c:v>
                </c:pt>
                <c:pt idx="2092">
                  <c:v>2.5233</c:v>
                </c:pt>
                <c:pt idx="2093">
                  <c:v>3.24751</c:v>
                </c:pt>
                <c:pt idx="2094">
                  <c:v>3.916529999999998</c:v>
                </c:pt>
                <c:pt idx="2095">
                  <c:v>2.20831</c:v>
                </c:pt>
                <c:pt idx="2096">
                  <c:v>1.68938</c:v>
                </c:pt>
                <c:pt idx="2097">
                  <c:v>2.76897</c:v>
                </c:pt>
                <c:pt idx="2098">
                  <c:v>1.91149</c:v>
                </c:pt>
                <c:pt idx="2099">
                  <c:v>1.98014</c:v>
                </c:pt>
                <c:pt idx="2100">
                  <c:v>2.52061</c:v>
                </c:pt>
                <c:pt idx="2101">
                  <c:v>3.878839999999998</c:v>
                </c:pt>
                <c:pt idx="2102">
                  <c:v>2.26417</c:v>
                </c:pt>
                <c:pt idx="2103">
                  <c:v>2.76493</c:v>
                </c:pt>
                <c:pt idx="2104">
                  <c:v>2.10533</c:v>
                </c:pt>
                <c:pt idx="2105">
                  <c:v>5.626779999999996</c:v>
                </c:pt>
                <c:pt idx="2106">
                  <c:v>4.38902</c:v>
                </c:pt>
                <c:pt idx="2107">
                  <c:v>6.60944</c:v>
                </c:pt>
                <c:pt idx="2108">
                  <c:v>2.0461</c:v>
                </c:pt>
                <c:pt idx="2109">
                  <c:v>3.139819999999998</c:v>
                </c:pt>
                <c:pt idx="2110">
                  <c:v>1.84687</c:v>
                </c:pt>
                <c:pt idx="2111">
                  <c:v>2.202249999999998</c:v>
                </c:pt>
                <c:pt idx="2112">
                  <c:v>2.98771</c:v>
                </c:pt>
                <c:pt idx="2113">
                  <c:v>3.838459999999976</c:v>
                </c:pt>
                <c:pt idx="2114">
                  <c:v>3.37001</c:v>
                </c:pt>
                <c:pt idx="2115">
                  <c:v>3.30472</c:v>
                </c:pt>
                <c:pt idx="2116">
                  <c:v>2.61753</c:v>
                </c:pt>
                <c:pt idx="2117">
                  <c:v>3.459519999999999</c:v>
                </c:pt>
                <c:pt idx="2118">
                  <c:v>3.392219999999996</c:v>
                </c:pt>
                <c:pt idx="2119">
                  <c:v>3.41106</c:v>
                </c:pt>
                <c:pt idx="2120">
                  <c:v>2.373209999999998</c:v>
                </c:pt>
                <c:pt idx="2121">
                  <c:v>3.535579999999999</c:v>
                </c:pt>
                <c:pt idx="2122">
                  <c:v>2.82146</c:v>
                </c:pt>
                <c:pt idx="2123">
                  <c:v>3.3027</c:v>
                </c:pt>
                <c:pt idx="2124">
                  <c:v>1.9162</c:v>
                </c:pt>
                <c:pt idx="2125">
                  <c:v>2.8531</c:v>
                </c:pt>
                <c:pt idx="2126">
                  <c:v>1.47063</c:v>
                </c:pt>
                <c:pt idx="2127">
                  <c:v>2.402149999999998</c:v>
                </c:pt>
                <c:pt idx="2128">
                  <c:v>2.03533</c:v>
                </c:pt>
                <c:pt idx="2129">
                  <c:v>4.41392</c:v>
                </c:pt>
                <c:pt idx="2130">
                  <c:v>1.80918</c:v>
                </c:pt>
                <c:pt idx="2131">
                  <c:v>1.76005</c:v>
                </c:pt>
                <c:pt idx="2132">
                  <c:v>1.72707</c:v>
                </c:pt>
                <c:pt idx="2133">
                  <c:v>2.37455</c:v>
                </c:pt>
                <c:pt idx="2134">
                  <c:v>3.90105</c:v>
                </c:pt>
                <c:pt idx="2135">
                  <c:v>3.54904</c:v>
                </c:pt>
                <c:pt idx="2136">
                  <c:v>1.81659</c:v>
                </c:pt>
                <c:pt idx="2137">
                  <c:v>2.90829</c:v>
                </c:pt>
                <c:pt idx="2138">
                  <c:v>2.22581</c:v>
                </c:pt>
                <c:pt idx="2139">
                  <c:v>2.96617</c:v>
                </c:pt>
                <c:pt idx="2140">
                  <c:v>2.16321</c:v>
                </c:pt>
                <c:pt idx="2141">
                  <c:v>1.90341</c:v>
                </c:pt>
                <c:pt idx="2142">
                  <c:v>3.70048</c:v>
                </c:pt>
                <c:pt idx="2143">
                  <c:v>3.40097</c:v>
                </c:pt>
                <c:pt idx="2144">
                  <c:v>3.74086</c:v>
                </c:pt>
                <c:pt idx="2145">
                  <c:v>1.51977</c:v>
                </c:pt>
                <c:pt idx="2146">
                  <c:v>2.04273</c:v>
                </c:pt>
                <c:pt idx="2147">
                  <c:v>2.44926</c:v>
                </c:pt>
                <c:pt idx="2148">
                  <c:v>4.28133</c:v>
                </c:pt>
                <c:pt idx="2149">
                  <c:v>2.96281</c:v>
                </c:pt>
                <c:pt idx="2150">
                  <c:v>3.00925</c:v>
                </c:pt>
                <c:pt idx="2151">
                  <c:v>2.12956</c:v>
                </c:pt>
                <c:pt idx="2152">
                  <c:v>3.326929999999999</c:v>
                </c:pt>
                <c:pt idx="2153">
                  <c:v>3.7873</c:v>
                </c:pt>
                <c:pt idx="2154">
                  <c:v>3.17347</c:v>
                </c:pt>
                <c:pt idx="2155">
                  <c:v>4.46036</c:v>
                </c:pt>
                <c:pt idx="2156">
                  <c:v>2.23254</c:v>
                </c:pt>
                <c:pt idx="2157">
                  <c:v>2.55763</c:v>
                </c:pt>
                <c:pt idx="2158">
                  <c:v>2.029269999999999</c:v>
                </c:pt>
                <c:pt idx="2159">
                  <c:v>2.551569999999999</c:v>
                </c:pt>
                <c:pt idx="2160">
                  <c:v>3.489809999999998</c:v>
                </c:pt>
                <c:pt idx="2161">
                  <c:v>1.85091</c:v>
                </c:pt>
                <c:pt idx="2162">
                  <c:v>3.94413</c:v>
                </c:pt>
                <c:pt idx="2163">
                  <c:v>3.58337</c:v>
                </c:pt>
                <c:pt idx="2164">
                  <c:v>2.530699999999999</c:v>
                </c:pt>
                <c:pt idx="2165">
                  <c:v>2.57647</c:v>
                </c:pt>
                <c:pt idx="2166">
                  <c:v>4.504789999999995</c:v>
                </c:pt>
                <c:pt idx="2167">
                  <c:v>2.32609</c:v>
                </c:pt>
                <c:pt idx="2168">
                  <c:v>1.28891</c:v>
                </c:pt>
                <c:pt idx="2169">
                  <c:v>2.0461</c:v>
                </c:pt>
                <c:pt idx="2170">
                  <c:v>2.71916</c:v>
                </c:pt>
                <c:pt idx="2171">
                  <c:v>2.08783</c:v>
                </c:pt>
                <c:pt idx="2172">
                  <c:v>1.45785</c:v>
                </c:pt>
                <c:pt idx="2173">
                  <c:v>1.68669</c:v>
                </c:pt>
                <c:pt idx="2174">
                  <c:v>0.843343</c:v>
                </c:pt>
                <c:pt idx="2175">
                  <c:v>1.21353</c:v>
                </c:pt>
                <c:pt idx="2176">
                  <c:v>1.08699</c:v>
                </c:pt>
                <c:pt idx="2177">
                  <c:v>0.756519</c:v>
                </c:pt>
                <c:pt idx="2178">
                  <c:v>1.18122</c:v>
                </c:pt>
                <c:pt idx="2179">
                  <c:v>0.529698</c:v>
                </c:pt>
                <c:pt idx="2180">
                  <c:v>0.850074</c:v>
                </c:pt>
                <c:pt idx="2181">
                  <c:v>3.9872</c:v>
                </c:pt>
                <c:pt idx="2182">
                  <c:v>2.894829999999998</c:v>
                </c:pt>
                <c:pt idx="2183">
                  <c:v>1.14689</c:v>
                </c:pt>
                <c:pt idx="2184">
                  <c:v>2.901559999999999</c:v>
                </c:pt>
                <c:pt idx="2185">
                  <c:v>3.129049999999999</c:v>
                </c:pt>
                <c:pt idx="2186">
                  <c:v>1.77284</c:v>
                </c:pt>
                <c:pt idx="2187">
                  <c:v>1.39458</c:v>
                </c:pt>
                <c:pt idx="2188">
                  <c:v>1.17853</c:v>
                </c:pt>
                <c:pt idx="2189">
                  <c:v>2.21638</c:v>
                </c:pt>
                <c:pt idx="2190">
                  <c:v>4.367479999999976</c:v>
                </c:pt>
                <c:pt idx="2191">
                  <c:v>2.1834</c:v>
                </c:pt>
                <c:pt idx="2192">
                  <c:v>1.82466</c:v>
                </c:pt>
                <c:pt idx="2193">
                  <c:v>0.981994</c:v>
                </c:pt>
                <c:pt idx="2194">
                  <c:v>1.73784</c:v>
                </c:pt>
                <c:pt idx="2195">
                  <c:v>2.239269999999999</c:v>
                </c:pt>
                <c:pt idx="2196">
                  <c:v>2.32071</c:v>
                </c:pt>
                <c:pt idx="2197">
                  <c:v>2.475509999999999</c:v>
                </c:pt>
                <c:pt idx="2198">
                  <c:v>1.7089</c:v>
                </c:pt>
                <c:pt idx="2199">
                  <c:v>2.354359999999998</c:v>
                </c:pt>
                <c:pt idx="2200">
                  <c:v>2.10129</c:v>
                </c:pt>
                <c:pt idx="2201">
                  <c:v>2.80127</c:v>
                </c:pt>
                <c:pt idx="2202">
                  <c:v>1.64226</c:v>
                </c:pt>
                <c:pt idx="2203">
                  <c:v>3.16674</c:v>
                </c:pt>
                <c:pt idx="2204">
                  <c:v>1.97678</c:v>
                </c:pt>
                <c:pt idx="2205">
                  <c:v>3.70385</c:v>
                </c:pt>
                <c:pt idx="2206">
                  <c:v>2.542819999999999</c:v>
                </c:pt>
                <c:pt idx="2207">
                  <c:v>2.02793</c:v>
                </c:pt>
                <c:pt idx="2208">
                  <c:v>1.50092</c:v>
                </c:pt>
                <c:pt idx="2209">
                  <c:v>3.06309</c:v>
                </c:pt>
                <c:pt idx="2210">
                  <c:v>1.82197</c:v>
                </c:pt>
                <c:pt idx="2211">
                  <c:v>2.57311</c:v>
                </c:pt>
                <c:pt idx="2212">
                  <c:v>1.80447</c:v>
                </c:pt>
                <c:pt idx="2213">
                  <c:v>1.67188</c:v>
                </c:pt>
                <c:pt idx="2214">
                  <c:v>1.70015</c:v>
                </c:pt>
                <c:pt idx="2215">
                  <c:v>1.79909</c:v>
                </c:pt>
                <c:pt idx="2216">
                  <c:v>1.28487</c:v>
                </c:pt>
                <c:pt idx="2217">
                  <c:v>2.05552</c:v>
                </c:pt>
                <c:pt idx="2218">
                  <c:v>2.32946</c:v>
                </c:pt>
                <c:pt idx="2219">
                  <c:v>2.24734</c:v>
                </c:pt>
                <c:pt idx="2220">
                  <c:v>1.15295</c:v>
                </c:pt>
                <c:pt idx="2221">
                  <c:v>0.868246</c:v>
                </c:pt>
                <c:pt idx="2222">
                  <c:v>2.03331</c:v>
                </c:pt>
                <c:pt idx="2223">
                  <c:v>2.01312</c:v>
                </c:pt>
                <c:pt idx="2224">
                  <c:v>1.4915</c:v>
                </c:pt>
                <c:pt idx="2225">
                  <c:v>3.252219999999999</c:v>
                </c:pt>
                <c:pt idx="2226">
                  <c:v>2.474839999999999</c:v>
                </c:pt>
                <c:pt idx="2227">
                  <c:v>1.80111</c:v>
                </c:pt>
                <c:pt idx="2228">
                  <c:v>2.369839999999999</c:v>
                </c:pt>
                <c:pt idx="2229">
                  <c:v>2.439169999999998</c:v>
                </c:pt>
                <c:pt idx="2230">
                  <c:v>2.60003</c:v>
                </c:pt>
                <c:pt idx="2231">
                  <c:v>1.83611</c:v>
                </c:pt>
                <c:pt idx="2232">
                  <c:v>2.65051</c:v>
                </c:pt>
                <c:pt idx="2233">
                  <c:v>2.11946</c:v>
                </c:pt>
                <c:pt idx="2234">
                  <c:v>2.39407</c:v>
                </c:pt>
                <c:pt idx="2235">
                  <c:v>1.579</c:v>
                </c:pt>
                <c:pt idx="2236">
                  <c:v>3.75702</c:v>
                </c:pt>
                <c:pt idx="2237">
                  <c:v>2.63099</c:v>
                </c:pt>
                <c:pt idx="2238">
                  <c:v>1.67457</c:v>
                </c:pt>
                <c:pt idx="2239">
                  <c:v>2.9655</c:v>
                </c:pt>
                <c:pt idx="2240">
                  <c:v>1.96803</c:v>
                </c:pt>
                <c:pt idx="2241">
                  <c:v>2.34696</c:v>
                </c:pt>
                <c:pt idx="2242">
                  <c:v>2.4533</c:v>
                </c:pt>
                <c:pt idx="2243">
                  <c:v>2.106679999999999</c:v>
                </c:pt>
                <c:pt idx="2244">
                  <c:v>4.33181</c:v>
                </c:pt>
                <c:pt idx="2245">
                  <c:v>4.308929999999997</c:v>
                </c:pt>
                <c:pt idx="2246">
                  <c:v>2.79387</c:v>
                </c:pt>
                <c:pt idx="2247">
                  <c:v>2.97492</c:v>
                </c:pt>
                <c:pt idx="2248">
                  <c:v>5.162359999999984</c:v>
                </c:pt>
                <c:pt idx="2249">
                  <c:v>1.76745</c:v>
                </c:pt>
                <c:pt idx="2250">
                  <c:v>1.65573</c:v>
                </c:pt>
                <c:pt idx="2251">
                  <c:v>3.35991</c:v>
                </c:pt>
                <c:pt idx="2252">
                  <c:v>3.337029999999999</c:v>
                </c:pt>
                <c:pt idx="2253">
                  <c:v>3.621059999999999</c:v>
                </c:pt>
                <c:pt idx="2254">
                  <c:v>3.450099999999999</c:v>
                </c:pt>
                <c:pt idx="2255">
                  <c:v>5.91148</c:v>
                </c:pt>
                <c:pt idx="2256">
                  <c:v>3.47568</c:v>
                </c:pt>
                <c:pt idx="2257">
                  <c:v>3.73817</c:v>
                </c:pt>
                <c:pt idx="2258">
                  <c:v>5.19333</c:v>
                </c:pt>
                <c:pt idx="2259">
                  <c:v>4.07605</c:v>
                </c:pt>
                <c:pt idx="2260">
                  <c:v>4.757179999999995</c:v>
                </c:pt>
                <c:pt idx="2261">
                  <c:v>3.699809999999997</c:v>
                </c:pt>
                <c:pt idx="2262">
                  <c:v>3.820279999999999</c:v>
                </c:pt>
                <c:pt idx="2263">
                  <c:v>1.80986</c:v>
                </c:pt>
                <c:pt idx="2264">
                  <c:v>3.2704</c:v>
                </c:pt>
                <c:pt idx="2265">
                  <c:v>2.80127</c:v>
                </c:pt>
                <c:pt idx="2266">
                  <c:v>2.409549999999999</c:v>
                </c:pt>
                <c:pt idx="2267">
                  <c:v>4.13931</c:v>
                </c:pt>
                <c:pt idx="2268">
                  <c:v>1.58977</c:v>
                </c:pt>
                <c:pt idx="2269">
                  <c:v>3.27443</c:v>
                </c:pt>
                <c:pt idx="2270">
                  <c:v>3.851249999999952</c:v>
                </c:pt>
                <c:pt idx="2271">
                  <c:v>4.27123</c:v>
                </c:pt>
                <c:pt idx="2272">
                  <c:v>4.683819999999994</c:v>
                </c:pt>
                <c:pt idx="2273">
                  <c:v>2.60137</c:v>
                </c:pt>
                <c:pt idx="2274">
                  <c:v>2.75416</c:v>
                </c:pt>
                <c:pt idx="2275">
                  <c:v>2.37792</c:v>
                </c:pt>
                <c:pt idx="2276">
                  <c:v>2.16927</c:v>
                </c:pt>
                <c:pt idx="2277">
                  <c:v>5.027079999999994</c:v>
                </c:pt>
                <c:pt idx="2278">
                  <c:v>5.612639999999994</c:v>
                </c:pt>
                <c:pt idx="2279">
                  <c:v>4.666989999999965</c:v>
                </c:pt>
                <c:pt idx="2280">
                  <c:v>3.63654</c:v>
                </c:pt>
                <c:pt idx="2281">
                  <c:v>2.76627</c:v>
                </c:pt>
                <c:pt idx="2282">
                  <c:v>2.353689999999998</c:v>
                </c:pt>
                <c:pt idx="2283">
                  <c:v>4.324409999999975</c:v>
                </c:pt>
                <c:pt idx="2284">
                  <c:v>3.65337</c:v>
                </c:pt>
                <c:pt idx="2285">
                  <c:v>3.1903</c:v>
                </c:pt>
                <c:pt idx="2286">
                  <c:v>2.56839</c:v>
                </c:pt>
                <c:pt idx="2287">
                  <c:v>4.79622</c:v>
                </c:pt>
                <c:pt idx="2288">
                  <c:v>5.27275</c:v>
                </c:pt>
                <c:pt idx="2289">
                  <c:v>2.71781</c:v>
                </c:pt>
                <c:pt idx="2290">
                  <c:v>3.95018</c:v>
                </c:pt>
                <c:pt idx="2291">
                  <c:v>3.7025</c:v>
                </c:pt>
                <c:pt idx="2292">
                  <c:v>4.70065</c:v>
                </c:pt>
                <c:pt idx="2293">
                  <c:v>6.07301</c:v>
                </c:pt>
                <c:pt idx="2294">
                  <c:v>5.066119999999994</c:v>
                </c:pt>
                <c:pt idx="2295">
                  <c:v>3.64058</c:v>
                </c:pt>
                <c:pt idx="2296">
                  <c:v>3.318179999999999</c:v>
                </c:pt>
                <c:pt idx="2297">
                  <c:v>3.04963</c:v>
                </c:pt>
                <c:pt idx="2298">
                  <c:v>2.64243</c:v>
                </c:pt>
                <c:pt idx="2299">
                  <c:v>1.7789</c:v>
                </c:pt>
                <c:pt idx="2300">
                  <c:v>1.85159</c:v>
                </c:pt>
                <c:pt idx="2301">
                  <c:v>2.72522</c:v>
                </c:pt>
                <c:pt idx="2302">
                  <c:v>4.024219999999985</c:v>
                </c:pt>
                <c:pt idx="2303">
                  <c:v>2.1336</c:v>
                </c:pt>
                <c:pt idx="2304">
                  <c:v>2.57647</c:v>
                </c:pt>
                <c:pt idx="2305">
                  <c:v>3.43866</c:v>
                </c:pt>
                <c:pt idx="2306">
                  <c:v>3.14117</c:v>
                </c:pt>
                <c:pt idx="2307">
                  <c:v>2.958769999999999</c:v>
                </c:pt>
                <c:pt idx="2308">
                  <c:v>4.49738</c:v>
                </c:pt>
                <c:pt idx="2309">
                  <c:v>3.44068</c:v>
                </c:pt>
                <c:pt idx="2310">
                  <c:v>3.50731</c:v>
                </c:pt>
                <c:pt idx="2311">
                  <c:v>2.27225</c:v>
                </c:pt>
                <c:pt idx="2312">
                  <c:v>2.78243</c:v>
                </c:pt>
                <c:pt idx="2313">
                  <c:v>2.911649999999952</c:v>
                </c:pt>
                <c:pt idx="2314">
                  <c:v>3.85461</c:v>
                </c:pt>
                <c:pt idx="2315">
                  <c:v>4.224789999999984</c:v>
                </c:pt>
                <c:pt idx="2316">
                  <c:v>5.522449999999997</c:v>
                </c:pt>
                <c:pt idx="2317">
                  <c:v>2.60137</c:v>
                </c:pt>
                <c:pt idx="2318">
                  <c:v>2.93454</c:v>
                </c:pt>
                <c:pt idx="2319">
                  <c:v>4.04643</c:v>
                </c:pt>
                <c:pt idx="2320">
                  <c:v>3.822299999999998</c:v>
                </c:pt>
                <c:pt idx="2321">
                  <c:v>3.820959999999999</c:v>
                </c:pt>
                <c:pt idx="2322">
                  <c:v>4.25912</c:v>
                </c:pt>
                <c:pt idx="2323">
                  <c:v>4.04643</c:v>
                </c:pt>
                <c:pt idx="2324">
                  <c:v>4.59228</c:v>
                </c:pt>
                <c:pt idx="2325">
                  <c:v>2.330799999999999</c:v>
                </c:pt>
                <c:pt idx="2326">
                  <c:v>7.8721</c:v>
                </c:pt>
                <c:pt idx="2327">
                  <c:v>4.047109999999996</c:v>
                </c:pt>
                <c:pt idx="2328">
                  <c:v>6.66058999999994</c:v>
                </c:pt>
                <c:pt idx="2329">
                  <c:v>3.92057</c:v>
                </c:pt>
                <c:pt idx="2330">
                  <c:v>4.615169999999995</c:v>
                </c:pt>
                <c:pt idx="2331">
                  <c:v>4.18643</c:v>
                </c:pt>
                <c:pt idx="2332">
                  <c:v>2.78579</c:v>
                </c:pt>
                <c:pt idx="2333">
                  <c:v>5.91081</c:v>
                </c:pt>
                <c:pt idx="2334">
                  <c:v>7.452109999999998</c:v>
                </c:pt>
                <c:pt idx="2335">
                  <c:v>6.27089</c:v>
                </c:pt>
                <c:pt idx="2336">
                  <c:v>5.97946</c:v>
                </c:pt>
                <c:pt idx="2337">
                  <c:v>5.698789999999985</c:v>
                </c:pt>
                <c:pt idx="2338">
                  <c:v>5.0217</c:v>
                </c:pt>
                <c:pt idx="2339">
                  <c:v>4.47248</c:v>
                </c:pt>
                <c:pt idx="2340">
                  <c:v>4.96987</c:v>
                </c:pt>
                <c:pt idx="2341">
                  <c:v>4.27998</c:v>
                </c:pt>
                <c:pt idx="2342">
                  <c:v>5.827349999999996</c:v>
                </c:pt>
                <c:pt idx="2343">
                  <c:v>3.365969999999999</c:v>
                </c:pt>
                <c:pt idx="2344">
                  <c:v>3.252899999999999</c:v>
                </c:pt>
                <c:pt idx="2345">
                  <c:v>3.82702</c:v>
                </c:pt>
                <c:pt idx="2346">
                  <c:v>2.41494</c:v>
                </c:pt>
                <c:pt idx="2347">
                  <c:v>4.588919999999995</c:v>
                </c:pt>
                <c:pt idx="2348">
                  <c:v>2.74877</c:v>
                </c:pt>
                <c:pt idx="2349">
                  <c:v>4.8817</c:v>
                </c:pt>
                <c:pt idx="2350">
                  <c:v>3.77855</c:v>
                </c:pt>
                <c:pt idx="2351">
                  <c:v>5.363609999999999</c:v>
                </c:pt>
                <c:pt idx="2352">
                  <c:v>4.526999999999997</c:v>
                </c:pt>
                <c:pt idx="2353">
                  <c:v>5.1765</c:v>
                </c:pt>
                <c:pt idx="2354">
                  <c:v>3.96836</c:v>
                </c:pt>
                <c:pt idx="2355">
                  <c:v>5.142169999999997</c:v>
                </c:pt>
                <c:pt idx="2356">
                  <c:v>2.49234</c:v>
                </c:pt>
                <c:pt idx="2357">
                  <c:v>7.18154</c:v>
                </c:pt>
                <c:pt idx="2358">
                  <c:v>2.45128</c:v>
                </c:pt>
                <c:pt idx="2359">
                  <c:v>3.03954</c:v>
                </c:pt>
                <c:pt idx="2360">
                  <c:v>6.927799999999999</c:v>
                </c:pt>
                <c:pt idx="2361">
                  <c:v>7.425189999999985</c:v>
                </c:pt>
                <c:pt idx="2362">
                  <c:v>4.24902</c:v>
                </c:pt>
                <c:pt idx="2363">
                  <c:v>3.06915</c:v>
                </c:pt>
                <c:pt idx="2364">
                  <c:v>2.79522</c:v>
                </c:pt>
                <c:pt idx="2365">
                  <c:v>9.10515</c:v>
                </c:pt>
                <c:pt idx="2366">
                  <c:v>3.88423</c:v>
                </c:pt>
                <c:pt idx="2367">
                  <c:v>6.168589999999964</c:v>
                </c:pt>
                <c:pt idx="2368">
                  <c:v>5.138809999999999</c:v>
                </c:pt>
                <c:pt idx="2369">
                  <c:v>2.826849999999952</c:v>
                </c:pt>
                <c:pt idx="2370">
                  <c:v>5.284189999999985</c:v>
                </c:pt>
                <c:pt idx="2371">
                  <c:v>4.58825</c:v>
                </c:pt>
                <c:pt idx="2372">
                  <c:v>2.49772</c:v>
                </c:pt>
                <c:pt idx="2373">
                  <c:v>4.58084</c:v>
                </c:pt>
                <c:pt idx="2374">
                  <c:v>2.76425</c:v>
                </c:pt>
                <c:pt idx="2375">
                  <c:v>4.7417</c:v>
                </c:pt>
                <c:pt idx="2376">
                  <c:v>2.60339</c:v>
                </c:pt>
                <c:pt idx="2377">
                  <c:v>4.862179999999975</c:v>
                </c:pt>
                <c:pt idx="2378">
                  <c:v>2.27494</c:v>
                </c:pt>
                <c:pt idx="2379">
                  <c:v>3.34039</c:v>
                </c:pt>
                <c:pt idx="2380">
                  <c:v>6.51656</c:v>
                </c:pt>
                <c:pt idx="2381">
                  <c:v>3.365969999999999</c:v>
                </c:pt>
                <c:pt idx="2382">
                  <c:v>2.561659999999998</c:v>
                </c:pt>
                <c:pt idx="2383">
                  <c:v>7.18962</c:v>
                </c:pt>
                <c:pt idx="2384">
                  <c:v>5.40601</c:v>
                </c:pt>
                <c:pt idx="2385">
                  <c:v>6.554919999999965</c:v>
                </c:pt>
                <c:pt idx="2386">
                  <c:v>3.25895</c:v>
                </c:pt>
                <c:pt idx="2387">
                  <c:v>4.74238</c:v>
                </c:pt>
                <c:pt idx="2388">
                  <c:v>7.48509</c:v>
                </c:pt>
                <c:pt idx="2389">
                  <c:v>4.53709</c:v>
                </c:pt>
                <c:pt idx="2390">
                  <c:v>3.053669999999999</c:v>
                </c:pt>
                <c:pt idx="2391">
                  <c:v>2.32138</c:v>
                </c:pt>
                <c:pt idx="2392">
                  <c:v>5.852919999999965</c:v>
                </c:pt>
                <c:pt idx="2393">
                  <c:v>5.082939999999994</c:v>
                </c:pt>
                <c:pt idx="2394">
                  <c:v>5.66177</c:v>
                </c:pt>
                <c:pt idx="2395">
                  <c:v>5.85764</c:v>
                </c:pt>
                <c:pt idx="2396">
                  <c:v>6.818089999999986</c:v>
                </c:pt>
                <c:pt idx="2397">
                  <c:v>9.26332</c:v>
                </c:pt>
                <c:pt idx="2398">
                  <c:v>6.192819999999966</c:v>
                </c:pt>
                <c:pt idx="2399">
                  <c:v>6.75146</c:v>
                </c:pt>
                <c:pt idx="2400">
                  <c:v>5.508989999999995</c:v>
                </c:pt>
                <c:pt idx="2401">
                  <c:v>4.115079999999995</c:v>
                </c:pt>
                <c:pt idx="2402">
                  <c:v>5.84956</c:v>
                </c:pt>
                <c:pt idx="2403">
                  <c:v>10.3294</c:v>
                </c:pt>
                <c:pt idx="2404">
                  <c:v>6.165219999999985</c:v>
                </c:pt>
                <c:pt idx="2405">
                  <c:v>7.652679999999996</c:v>
                </c:pt>
                <c:pt idx="2406">
                  <c:v>5.44438</c:v>
                </c:pt>
                <c:pt idx="2407">
                  <c:v>3.13242</c:v>
                </c:pt>
                <c:pt idx="2408">
                  <c:v>3.17953</c:v>
                </c:pt>
                <c:pt idx="2409">
                  <c:v>5.05266</c:v>
                </c:pt>
                <c:pt idx="2410">
                  <c:v>5.344089999999984</c:v>
                </c:pt>
                <c:pt idx="2411">
                  <c:v>4.37017</c:v>
                </c:pt>
                <c:pt idx="2412">
                  <c:v>5.25907</c:v>
                </c:pt>
                <c:pt idx="2413">
                  <c:v>1.35621</c:v>
                </c:pt>
                <c:pt idx="2414">
                  <c:v>2.18071</c:v>
                </c:pt>
                <c:pt idx="2415">
                  <c:v>2.03331</c:v>
                </c:pt>
                <c:pt idx="2416">
                  <c:v>2.001679999999999</c:v>
                </c:pt>
                <c:pt idx="2417">
                  <c:v>2.266859999999999</c:v>
                </c:pt>
                <c:pt idx="2418">
                  <c:v>2.84233</c:v>
                </c:pt>
                <c:pt idx="2419">
                  <c:v>4.54315</c:v>
                </c:pt>
                <c:pt idx="2420">
                  <c:v>2.364459999999998</c:v>
                </c:pt>
                <c:pt idx="2421">
                  <c:v>1.97274</c:v>
                </c:pt>
                <c:pt idx="2422">
                  <c:v>3.67154</c:v>
                </c:pt>
                <c:pt idx="2423">
                  <c:v>3.99057</c:v>
                </c:pt>
                <c:pt idx="2424">
                  <c:v>3.67221</c:v>
                </c:pt>
                <c:pt idx="2425">
                  <c:v>6.588579999999999</c:v>
                </c:pt>
                <c:pt idx="2426">
                  <c:v>3.526829999999999</c:v>
                </c:pt>
                <c:pt idx="2427">
                  <c:v>2.9406</c:v>
                </c:pt>
                <c:pt idx="2428">
                  <c:v>5.47736</c:v>
                </c:pt>
                <c:pt idx="2429">
                  <c:v>3.018</c:v>
                </c:pt>
                <c:pt idx="2430">
                  <c:v>2.86454</c:v>
                </c:pt>
                <c:pt idx="2431">
                  <c:v>2.98098</c:v>
                </c:pt>
                <c:pt idx="2432">
                  <c:v>4.24431</c:v>
                </c:pt>
                <c:pt idx="2433">
                  <c:v>4.37287</c:v>
                </c:pt>
                <c:pt idx="2434">
                  <c:v>3.838459999999976</c:v>
                </c:pt>
                <c:pt idx="2435">
                  <c:v>4.395079999999996</c:v>
                </c:pt>
                <c:pt idx="2436">
                  <c:v>6.55223</c:v>
                </c:pt>
                <c:pt idx="2437">
                  <c:v>3.26434</c:v>
                </c:pt>
                <c:pt idx="2438">
                  <c:v>3.0005</c:v>
                </c:pt>
                <c:pt idx="2439">
                  <c:v>4.47248</c:v>
                </c:pt>
                <c:pt idx="2440">
                  <c:v>6.540119999999995</c:v>
                </c:pt>
                <c:pt idx="2441">
                  <c:v>5.58505</c:v>
                </c:pt>
                <c:pt idx="2442">
                  <c:v>4.27595</c:v>
                </c:pt>
                <c:pt idx="2443">
                  <c:v>3.4952</c:v>
                </c:pt>
                <c:pt idx="2444">
                  <c:v>5.57764</c:v>
                </c:pt>
                <c:pt idx="2445">
                  <c:v>3.81355</c:v>
                </c:pt>
                <c:pt idx="2446">
                  <c:v>3.91115</c:v>
                </c:pt>
                <c:pt idx="2447">
                  <c:v>3.2953</c:v>
                </c:pt>
                <c:pt idx="2448">
                  <c:v>1.79774</c:v>
                </c:pt>
                <c:pt idx="2449">
                  <c:v>0.881035</c:v>
                </c:pt>
                <c:pt idx="2450">
                  <c:v>1.10247</c:v>
                </c:pt>
                <c:pt idx="2451">
                  <c:v>1.65034</c:v>
                </c:pt>
                <c:pt idx="2452">
                  <c:v>1.0843</c:v>
                </c:pt>
                <c:pt idx="2453">
                  <c:v>2.532719999999999</c:v>
                </c:pt>
                <c:pt idx="2454">
                  <c:v>1.05468</c:v>
                </c:pt>
                <c:pt idx="2455">
                  <c:v>1.06276</c:v>
                </c:pt>
                <c:pt idx="2456">
                  <c:v>2.64983</c:v>
                </c:pt>
                <c:pt idx="2457">
                  <c:v>2.03466</c:v>
                </c:pt>
                <c:pt idx="2458">
                  <c:v>4.99814</c:v>
                </c:pt>
                <c:pt idx="2459">
                  <c:v>5.33736</c:v>
                </c:pt>
                <c:pt idx="2460">
                  <c:v>4.28537</c:v>
                </c:pt>
                <c:pt idx="2461">
                  <c:v>1.32593</c:v>
                </c:pt>
                <c:pt idx="2462">
                  <c:v>0.768634</c:v>
                </c:pt>
                <c:pt idx="2463">
                  <c:v>2.04341</c:v>
                </c:pt>
                <c:pt idx="2464">
                  <c:v>1.54131</c:v>
                </c:pt>
                <c:pt idx="2465">
                  <c:v>1.09238</c:v>
                </c:pt>
                <c:pt idx="2466">
                  <c:v>1.58775</c:v>
                </c:pt>
                <c:pt idx="2467">
                  <c:v>4.98333</c:v>
                </c:pt>
                <c:pt idx="2468">
                  <c:v>1.7089</c:v>
                </c:pt>
                <c:pt idx="2469">
                  <c:v>2.116769999999998</c:v>
                </c:pt>
                <c:pt idx="2470">
                  <c:v>2.637049999999998</c:v>
                </c:pt>
                <c:pt idx="2471">
                  <c:v>4.324409999999975</c:v>
                </c:pt>
                <c:pt idx="2472">
                  <c:v>2.54551</c:v>
                </c:pt>
                <c:pt idx="2473">
                  <c:v>3.91922</c:v>
                </c:pt>
                <c:pt idx="2474">
                  <c:v>2.98973</c:v>
                </c:pt>
                <c:pt idx="2475">
                  <c:v>2.636369999999998</c:v>
                </c:pt>
                <c:pt idx="2476">
                  <c:v>2.49907</c:v>
                </c:pt>
                <c:pt idx="2477">
                  <c:v>3.356549999999952</c:v>
                </c:pt>
                <c:pt idx="2478">
                  <c:v>2.61214</c:v>
                </c:pt>
                <c:pt idx="2479">
                  <c:v>4.37421</c:v>
                </c:pt>
                <c:pt idx="2480">
                  <c:v>2.88742</c:v>
                </c:pt>
                <c:pt idx="2481">
                  <c:v>4.38565</c:v>
                </c:pt>
                <c:pt idx="2482">
                  <c:v>2.95271</c:v>
                </c:pt>
                <c:pt idx="2483">
                  <c:v>2.13158</c:v>
                </c:pt>
                <c:pt idx="2484">
                  <c:v>2.62022</c:v>
                </c:pt>
                <c:pt idx="2485">
                  <c:v>3.40164</c:v>
                </c:pt>
                <c:pt idx="2486">
                  <c:v>3.962969999999999</c:v>
                </c:pt>
                <c:pt idx="2487">
                  <c:v>5.8011</c:v>
                </c:pt>
                <c:pt idx="2488">
                  <c:v>3.052319999999999</c:v>
                </c:pt>
                <c:pt idx="2489">
                  <c:v>8.238919999999995</c:v>
                </c:pt>
                <c:pt idx="2490">
                  <c:v>4.63872</c:v>
                </c:pt>
                <c:pt idx="2491">
                  <c:v>7.643929999999996</c:v>
                </c:pt>
                <c:pt idx="2492">
                  <c:v>2.89617</c:v>
                </c:pt>
                <c:pt idx="2493">
                  <c:v>3.52077</c:v>
                </c:pt>
                <c:pt idx="2494">
                  <c:v>2.40753</c:v>
                </c:pt>
                <c:pt idx="2495">
                  <c:v>4.46238</c:v>
                </c:pt>
                <c:pt idx="2496">
                  <c:v>2.1834</c:v>
                </c:pt>
                <c:pt idx="2497">
                  <c:v>3.5127</c:v>
                </c:pt>
                <c:pt idx="2498">
                  <c:v>2.52666</c:v>
                </c:pt>
                <c:pt idx="2499">
                  <c:v>6.540119999999995</c:v>
                </c:pt>
                <c:pt idx="2500">
                  <c:v>3.58471</c:v>
                </c:pt>
                <c:pt idx="2501">
                  <c:v>4.67036</c:v>
                </c:pt>
                <c:pt idx="2502">
                  <c:v>4.58286</c:v>
                </c:pt>
                <c:pt idx="2503">
                  <c:v>3.45078</c:v>
                </c:pt>
                <c:pt idx="2504">
                  <c:v>4.294789999999995</c:v>
                </c:pt>
                <c:pt idx="2505">
                  <c:v>3.396929999999997</c:v>
                </c:pt>
                <c:pt idx="2506">
                  <c:v>4.870929999999999</c:v>
                </c:pt>
                <c:pt idx="2507">
                  <c:v>3.35453</c:v>
                </c:pt>
                <c:pt idx="2508">
                  <c:v>6.83626</c:v>
                </c:pt>
                <c:pt idx="2509">
                  <c:v>6.25676</c:v>
                </c:pt>
                <c:pt idx="2510">
                  <c:v>3.64731</c:v>
                </c:pt>
                <c:pt idx="2511">
                  <c:v>5.24044</c:v>
                </c:pt>
                <c:pt idx="2512">
                  <c:v>5.424179999999986</c:v>
                </c:pt>
                <c:pt idx="2513">
                  <c:v>3.40703</c:v>
                </c:pt>
                <c:pt idx="2514">
                  <c:v>4.14806</c:v>
                </c:pt>
                <c:pt idx="2515">
                  <c:v>2.14841</c:v>
                </c:pt>
                <c:pt idx="2516">
                  <c:v>3.452789999999998</c:v>
                </c:pt>
                <c:pt idx="2517">
                  <c:v>3.489809999999998</c:v>
                </c:pt>
                <c:pt idx="2518">
                  <c:v>4.128549999999985</c:v>
                </c:pt>
                <c:pt idx="2519">
                  <c:v>4.96112</c:v>
                </c:pt>
                <c:pt idx="2520">
                  <c:v>6.05686</c:v>
                </c:pt>
                <c:pt idx="2521">
                  <c:v>2.42974</c:v>
                </c:pt>
                <c:pt idx="2522">
                  <c:v>4.91939</c:v>
                </c:pt>
                <c:pt idx="2523">
                  <c:v>4.107679999999998</c:v>
                </c:pt>
                <c:pt idx="2524">
                  <c:v>3.5726</c:v>
                </c:pt>
                <c:pt idx="2525">
                  <c:v>3.42654</c:v>
                </c:pt>
                <c:pt idx="2526">
                  <c:v>4.91872</c:v>
                </c:pt>
                <c:pt idx="2527">
                  <c:v>4.891119999999995</c:v>
                </c:pt>
                <c:pt idx="2528">
                  <c:v>1.30304</c:v>
                </c:pt>
                <c:pt idx="2529">
                  <c:v>5.73379</c:v>
                </c:pt>
                <c:pt idx="2530">
                  <c:v>3.61567</c:v>
                </c:pt>
                <c:pt idx="2531">
                  <c:v>5.13612</c:v>
                </c:pt>
                <c:pt idx="2532">
                  <c:v>4.362769999999998</c:v>
                </c:pt>
                <c:pt idx="2533">
                  <c:v>4.964489999999984</c:v>
                </c:pt>
                <c:pt idx="2534">
                  <c:v>5.56957</c:v>
                </c:pt>
                <c:pt idx="2535">
                  <c:v>3.87211</c:v>
                </c:pt>
                <c:pt idx="2536">
                  <c:v>8.33449</c:v>
                </c:pt>
                <c:pt idx="2537">
                  <c:v>4.49873</c:v>
                </c:pt>
                <c:pt idx="2538">
                  <c:v>3.405679999999998</c:v>
                </c:pt>
                <c:pt idx="2539">
                  <c:v>5.22563</c:v>
                </c:pt>
                <c:pt idx="2540">
                  <c:v>2.89617</c:v>
                </c:pt>
                <c:pt idx="2541">
                  <c:v>6.368489999999976</c:v>
                </c:pt>
                <c:pt idx="2542">
                  <c:v>3.63856</c:v>
                </c:pt>
                <c:pt idx="2543">
                  <c:v>5.156979999999995</c:v>
                </c:pt>
                <c:pt idx="2544">
                  <c:v>3.338369999999998</c:v>
                </c:pt>
                <c:pt idx="2545">
                  <c:v>4.80834</c:v>
                </c:pt>
                <c:pt idx="2546">
                  <c:v>3.631149999999998</c:v>
                </c:pt>
                <c:pt idx="2547">
                  <c:v>7.40702</c:v>
                </c:pt>
                <c:pt idx="2548">
                  <c:v>3.576639999999998</c:v>
                </c:pt>
                <c:pt idx="2549">
                  <c:v>5.3488</c:v>
                </c:pt>
                <c:pt idx="2550">
                  <c:v>6.57646</c:v>
                </c:pt>
                <c:pt idx="2551">
                  <c:v>7.183559999999995</c:v>
                </c:pt>
                <c:pt idx="2552">
                  <c:v>5.3663</c:v>
                </c:pt>
                <c:pt idx="2553">
                  <c:v>3.64798</c:v>
                </c:pt>
                <c:pt idx="2554">
                  <c:v>3.376069999999952</c:v>
                </c:pt>
                <c:pt idx="2555">
                  <c:v>3.03886</c:v>
                </c:pt>
                <c:pt idx="2556">
                  <c:v>2.70435</c:v>
                </c:pt>
                <c:pt idx="2557">
                  <c:v>4.358729999999999</c:v>
                </c:pt>
                <c:pt idx="2558">
                  <c:v>5.57697</c:v>
                </c:pt>
                <c:pt idx="2559">
                  <c:v>6.28772</c:v>
                </c:pt>
                <c:pt idx="2560">
                  <c:v>6.328099999999996</c:v>
                </c:pt>
                <c:pt idx="2561">
                  <c:v>3.75634</c:v>
                </c:pt>
                <c:pt idx="2562">
                  <c:v>5.145539999999984</c:v>
                </c:pt>
                <c:pt idx="2563">
                  <c:v>5.362939999999964</c:v>
                </c:pt>
                <c:pt idx="2564">
                  <c:v>4.34527</c:v>
                </c:pt>
                <c:pt idx="2565">
                  <c:v>4.23422</c:v>
                </c:pt>
                <c:pt idx="2566">
                  <c:v>3.40837</c:v>
                </c:pt>
                <c:pt idx="2567">
                  <c:v>3.09675</c:v>
                </c:pt>
                <c:pt idx="2568">
                  <c:v>4.0747</c:v>
                </c:pt>
                <c:pt idx="2569">
                  <c:v>5.00823</c:v>
                </c:pt>
                <c:pt idx="2570">
                  <c:v>6.167239999999984</c:v>
                </c:pt>
                <c:pt idx="2571">
                  <c:v>6.2682</c:v>
                </c:pt>
                <c:pt idx="2572">
                  <c:v>4.67844</c:v>
                </c:pt>
                <c:pt idx="2573">
                  <c:v>6.066959999999995</c:v>
                </c:pt>
                <c:pt idx="2574">
                  <c:v>3.812879999999952</c:v>
                </c:pt>
                <c:pt idx="2575">
                  <c:v>6.41964</c:v>
                </c:pt>
                <c:pt idx="2576">
                  <c:v>3.364619999999999</c:v>
                </c:pt>
                <c:pt idx="2577">
                  <c:v>1.83207</c:v>
                </c:pt>
              </c:numCache>
            </c:numRef>
          </c:xVal>
          <c:yVal>
            <c:numRef>
              <c:f>Sheet1!$G$2:$G$2579</c:f>
              <c:numCache>
                <c:formatCode>General</c:formatCode>
                <c:ptCount val="2578"/>
                <c:pt idx="0">
                  <c:v>4.17557</c:v>
                </c:pt>
                <c:pt idx="1">
                  <c:v>5.347589999999966</c:v>
                </c:pt>
                <c:pt idx="2">
                  <c:v>6.88361</c:v>
                </c:pt>
                <c:pt idx="3">
                  <c:v>4.37257</c:v>
                </c:pt>
                <c:pt idx="4">
                  <c:v>7.28312</c:v>
                </c:pt>
                <c:pt idx="5">
                  <c:v>6.70811</c:v>
                </c:pt>
                <c:pt idx="6">
                  <c:v>10.1102</c:v>
                </c:pt>
                <c:pt idx="7">
                  <c:v>4.774579999999998</c:v>
                </c:pt>
                <c:pt idx="8">
                  <c:v>4.26857</c:v>
                </c:pt>
                <c:pt idx="9">
                  <c:v>3.932059999999952</c:v>
                </c:pt>
                <c:pt idx="10">
                  <c:v>6.364099999999976</c:v>
                </c:pt>
                <c:pt idx="11">
                  <c:v>8.36313</c:v>
                </c:pt>
                <c:pt idx="12">
                  <c:v>2.12853</c:v>
                </c:pt>
                <c:pt idx="13">
                  <c:v>4.896579999999997</c:v>
                </c:pt>
                <c:pt idx="14">
                  <c:v>4.664069999999985</c:v>
                </c:pt>
                <c:pt idx="15">
                  <c:v>4.864079999999975</c:v>
                </c:pt>
                <c:pt idx="16">
                  <c:v>3.651559999999998</c:v>
                </c:pt>
                <c:pt idx="17">
                  <c:v>2.33754</c:v>
                </c:pt>
                <c:pt idx="18">
                  <c:v>3.48606</c:v>
                </c:pt>
                <c:pt idx="19">
                  <c:v>1.87453</c:v>
                </c:pt>
                <c:pt idx="20">
                  <c:v>4.87958</c:v>
                </c:pt>
                <c:pt idx="21">
                  <c:v>3.15055</c:v>
                </c:pt>
                <c:pt idx="22">
                  <c:v>2.52204</c:v>
                </c:pt>
                <c:pt idx="23">
                  <c:v>9.946660000000001</c:v>
                </c:pt>
                <c:pt idx="24">
                  <c:v>3.60356</c:v>
                </c:pt>
                <c:pt idx="25">
                  <c:v>4.21607</c:v>
                </c:pt>
                <c:pt idx="26">
                  <c:v>2.96305</c:v>
                </c:pt>
                <c:pt idx="27">
                  <c:v>2.41704</c:v>
                </c:pt>
                <c:pt idx="28">
                  <c:v>7.615119999999964</c:v>
                </c:pt>
                <c:pt idx="29">
                  <c:v>5.060079999999997</c:v>
                </c:pt>
                <c:pt idx="30">
                  <c:v>3.63056</c:v>
                </c:pt>
                <c:pt idx="31">
                  <c:v>3.77006</c:v>
                </c:pt>
                <c:pt idx="32">
                  <c:v>2.04353</c:v>
                </c:pt>
                <c:pt idx="33">
                  <c:v>5.53609</c:v>
                </c:pt>
                <c:pt idx="34">
                  <c:v>3.33955</c:v>
                </c:pt>
                <c:pt idx="35">
                  <c:v>5.103079999999998</c:v>
                </c:pt>
                <c:pt idx="36">
                  <c:v>3.474559999999999</c:v>
                </c:pt>
                <c:pt idx="37">
                  <c:v>4.51507</c:v>
                </c:pt>
                <c:pt idx="38">
                  <c:v>4.71608</c:v>
                </c:pt>
                <c:pt idx="39">
                  <c:v>6.2721</c:v>
                </c:pt>
                <c:pt idx="40">
                  <c:v>7.37762</c:v>
                </c:pt>
                <c:pt idx="41">
                  <c:v>7.45362</c:v>
                </c:pt>
                <c:pt idx="42">
                  <c:v>3.90056</c:v>
                </c:pt>
                <c:pt idx="43">
                  <c:v>7.81063</c:v>
                </c:pt>
                <c:pt idx="44">
                  <c:v>3.615559999999998</c:v>
                </c:pt>
                <c:pt idx="45">
                  <c:v>9.51965</c:v>
                </c:pt>
                <c:pt idx="46">
                  <c:v>2.51454</c:v>
                </c:pt>
                <c:pt idx="47">
                  <c:v>3.20255</c:v>
                </c:pt>
                <c:pt idx="48">
                  <c:v>4.88908</c:v>
                </c:pt>
                <c:pt idx="49">
                  <c:v>3.20555</c:v>
                </c:pt>
                <c:pt idx="50">
                  <c:v>5.537589999999994</c:v>
                </c:pt>
                <c:pt idx="51">
                  <c:v>2.59904</c:v>
                </c:pt>
                <c:pt idx="52">
                  <c:v>6.0236</c:v>
                </c:pt>
                <c:pt idx="53">
                  <c:v>5.625589999999937</c:v>
                </c:pt>
                <c:pt idx="54">
                  <c:v>3.562559999999999</c:v>
                </c:pt>
                <c:pt idx="55">
                  <c:v>4.164069999999985</c:v>
                </c:pt>
                <c:pt idx="56">
                  <c:v>4.819579999999997</c:v>
                </c:pt>
                <c:pt idx="57">
                  <c:v>1.96503</c:v>
                </c:pt>
                <c:pt idx="58">
                  <c:v>1.54302</c:v>
                </c:pt>
                <c:pt idx="59">
                  <c:v>4.35307</c:v>
                </c:pt>
                <c:pt idx="60">
                  <c:v>2.52554</c:v>
                </c:pt>
                <c:pt idx="61">
                  <c:v>3.038549999999999</c:v>
                </c:pt>
                <c:pt idx="62">
                  <c:v>2.868549999999999</c:v>
                </c:pt>
                <c:pt idx="63">
                  <c:v>4.49757</c:v>
                </c:pt>
                <c:pt idx="64">
                  <c:v>5.195079999999995</c:v>
                </c:pt>
                <c:pt idx="65">
                  <c:v>4.54507</c:v>
                </c:pt>
                <c:pt idx="66">
                  <c:v>6.3296</c:v>
                </c:pt>
                <c:pt idx="67">
                  <c:v>6.015099999999999</c:v>
                </c:pt>
                <c:pt idx="68">
                  <c:v>5.643589999999984</c:v>
                </c:pt>
                <c:pt idx="69">
                  <c:v>2.90055</c:v>
                </c:pt>
                <c:pt idx="70">
                  <c:v>1.84603</c:v>
                </c:pt>
                <c:pt idx="71">
                  <c:v>3.730059999999999</c:v>
                </c:pt>
                <c:pt idx="72">
                  <c:v>5.694589999999933</c:v>
                </c:pt>
                <c:pt idx="73">
                  <c:v>5.78709</c:v>
                </c:pt>
                <c:pt idx="74">
                  <c:v>4.40007</c:v>
                </c:pt>
                <c:pt idx="75">
                  <c:v>3.157049999999999</c:v>
                </c:pt>
                <c:pt idx="76">
                  <c:v>6.4281</c:v>
                </c:pt>
                <c:pt idx="77">
                  <c:v>1.58703</c:v>
                </c:pt>
                <c:pt idx="78">
                  <c:v>3.48456</c:v>
                </c:pt>
                <c:pt idx="79">
                  <c:v>1.73203</c:v>
                </c:pt>
                <c:pt idx="80">
                  <c:v>2.43854</c:v>
                </c:pt>
                <c:pt idx="81">
                  <c:v>1.57453</c:v>
                </c:pt>
                <c:pt idx="82">
                  <c:v>7.40512</c:v>
                </c:pt>
                <c:pt idx="83">
                  <c:v>5.07558</c:v>
                </c:pt>
                <c:pt idx="84">
                  <c:v>5.70659</c:v>
                </c:pt>
                <c:pt idx="85">
                  <c:v>4.93608</c:v>
                </c:pt>
                <c:pt idx="86">
                  <c:v>2.84105</c:v>
                </c:pt>
                <c:pt idx="87">
                  <c:v>1.15802</c:v>
                </c:pt>
                <c:pt idx="88">
                  <c:v>1.69053</c:v>
                </c:pt>
                <c:pt idx="89">
                  <c:v>2.479039999999999</c:v>
                </c:pt>
                <c:pt idx="90">
                  <c:v>3.021049999999998</c:v>
                </c:pt>
                <c:pt idx="91">
                  <c:v>2.62654</c:v>
                </c:pt>
                <c:pt idx="92">
                  <c:v>1.38502</c:v>
                </c:pt>
                <c:pt idx="93">
                  <c:v>1.87553</c:v>
                </c:pt>
                <c:pt idx="94">
                  <c:v>4.00606</c:v>
                </c:pt>
                <c:pt idx="95">
                  <c:v>3.28955</c:v>
                </c:pt>
                <c:pt idx="96">
                  <c:v>3.048049999999999</c:v>
                </c:pt>
                <c:pt idx="97">
                  <c:v>3.09805</c:v>
                </c:pt>
                <c:pt idx="98">
                  <c:v>2.19404</c:v>
                </c:pt>
                <c:pt idx="99">
                  <c:v>3.49256</c:v>
                </c:pt>
                <c:pt idx="100">
                  <c:v>2.47054</c:v>
                </c:pt>
                <c:pt idx="101">
                  <c:v>1.76503</c:v>
                </c:pt>
                <c:pt idx="102">
                  <c:v>1.99203</c:v>
                </c:pt>
                <c:pt idx="103">
                  <c:v>3.716559999999998</c:v>
                </c:pt>
                <c:pt idx="104">
                  <c:v>5.9776</c:v>
                </c:pt>
                <c:pt idx="105">
                  <c:v>2.12253</c:v>
                </c:pt>
                <c:pt idx="106">
                  <c:v>3.00705</c:v>
                </c:pt>
                <c:pt idx="107">
                  <c:v>2.905549999999998</c:v>
                </c:pt>
                <c:pt idx="108">
                  <c:v>2.54254</c:v>
                </c:pt>
                <c:pt idx="109">
                  <c:v>2.96205</c:v>
                </c:pt>
                <c:pt idx="110">
                  <c:v>1.88153</c:v>
                </c:pt>
                <c:pt idx="111">
                  <c:v>3.22455</c:v>
                </c:pt>
                <c:pt idx="112">
                  <c:v>1.95503</c:v>
                </c:pt>
                <c:pt idx="113">
                  <c:v>4.750579999999998</c:v>
                </c:pt>
                <c:pt idx="114">
                  <c:v>1.74653</c:v>
                </c:pt>
                <c:pt idx="115">
                  <c:v>1.99803</c:v>
                </c:pt>
                <c:pt idx="116">
                  <c:v>1.51952</c:v>
                </c:pt>
                <c:pt idx="117">
                  <c:v>2.20904</c:v>
                </c:pt>
                <c:pt idx="118">
                  <c:v>2.45554</c:v>
                </c:pt>
                <c:pt idx="119">
                  <c:v>5.087079999999998</c:v>
                </c:pt>
                <c:pt idx="120">
                  <c:v>2.01703</c:v>
                </c:pt>
                <c:pt idx="121">
                  <c:v>2.62154</c:v>
                </c:pt>
                <c:pt idx="122">
                  <c:v>1.40752</c:v>
                </c:pt>
                <c:pt idx="123">
                  <c:v>2.56654</c:v>
                </c:pt>
                <c:pt idx="124">
                  <c:v>0.852014</c:v>
                </c:pt>
                <c:pt idx="125">
                  <c:v>0.569009</c:v>
                </c:pt>
                <c:pt idx="126">
                  <c:v>0.836513</c:v>
                </c:pt>
                <c:pt idx="127">
                  <c:v>1.06752</c:v>
                </c:pt>
                <c:pt idx="128">
                  <c:v>2.13853</c:v>
                </c:pt>
                <c:pt idx="129">
                  <c:v>1.58153</c:v>
                </c:pt>
                <c:pt idx="130">
                  <c:v>1.02552</c:v>
                </c:pt>
                <c:pt idx="131">
                  <c:v>0.717512</c:v>
                </c:pt>
                <c:pt idx="132">
                  <c:v>1.93203</c:v>
                </c:pt>
                <c:pt idx="133">
                  <c:v>0.720512</c:v>
                </c:pt>
                <c:pt idx="134">
                  <c:v>1.51202</c:v>
                </c:pt>
                <c:pt idx="135">
                  <c:v>2.452539999999999</c:v>
                </c:pt>
                <c:pt idx="136">
                  <c:v>2.959049999999972</c:v>
                </c:pt>
                <c:pt idx="137">
                  <c:v>2.73954</c:v>
                </c:pt>
                <c:pt idx="138">
                  <c:v>1.17202</c:v>
                </c:pt>
                <c:pt idx="139">
                  <c:v>2.53104</c:v>
                </c:pt>
                <c:pt idx="140">
                  <c:v>2.35304</c:v>
                </c:pt>
                <c:pt idx="141">
                  <c:v>1.75803</c:v>
                </c:pt>
                <c:pt idx="142">
                  <c:v>2.28804</c:v>
                </c:pt>
                <c:pt idx="143">
                  <c:v>0.62501</c:v>
                </c:pt>
                <c:pt idx="144">
                  <c:v>1.26452</c:v>
                </c:pt>
                <c:pt idx="145">
                  <c:v>1.86553</c:v>
                </c:pt>
                <c:pt idx="146">
                  <c:v>1.54002</c:v>
                </c:pt>
                <c:pt idx="147">
                  <c:v>3.032049999999952</c:v>
                </c:pt>
                <c:pt idx="148">
                  <c:v>1.91553</c:v>
                </c:pt>
                <c:pt idx="149">
                  <c:v>1.20552</c:v>
                </c:pt>
                <c:pt idx="150">
                  <c:v>4.313569999999999</c:v>
                </c:pt>
                <c:pt idx="151">
                  <c:v>2.33754</c:v>
                </c:pt>
                <c:pt idx="152">
                  <c:v>2.833549999999998</c:v>
                </c:pt>
                <c:pt idx="153">
                  <c:v>1.52852</c:v>
                </c:pt>
                <c:pt idx="154">
                  <c:v>4.13507</c:v>
                </c:pt>
                <c:pt idx="155">
                  <c:v>3.14005</c:v>
                </c:pt>
                <c:pt idx="156">
                  <c:v>2.86005</c:v>
                </c:pt>
                <c:pt idx="157">
                  <c:v>0.945515</c:v>
                </c:pt>
                <c:pt idx="158">
                  <c:v>0.823513</c:v>
                </c:pt>
                <c:pt idx="159">
                  <c:v>0.676511</c:v>
                </c:pt>
                <c:pt idx="160">
                  <c:v>1.17552</c:v>
                </c:pt>
                <c:pt idx="161">
                  <c:v>0.942015</c:v>
                </c:pt>
                <c:pt idx="162">
                  <c:v>1.96653</c:v>
                </c:pt>
                <c:pt idx="163">
                  <c:v>1.98403</c:v>
                </c:pt>
                <c:pt idx="164">
                  <c:v>1.57253</c:v>
                </c:pt>
                <c:pt idx="165">
                  <c:v>1.87753</c:v>
                </c:pt>
                <c:pt idx="166">
                  <c:v>3.15605</c:v>
                </c:pt>
                <c:pt idx="167">
                  <c:v>2.351539999999999</c:v>
                </c:pt>
                <c:pt idx="168">
                  <c:v>1.06752</c:v>
                </c:pt>
                <c:pt idx="169">
                  <c:v>1.70853</c:v>
                </c:pt>
                <c:pt idx="170">
                  <c:v>1.16002</c:v>
                </c:pt>
                <c:pt idx="171">
                  <c:v>4.44407</c:v>
                </c:pt>
                <c:pt idx="172">
                  <c:v>1.64653</c:v>
                </c:pt>
                <c:pt idx="173">
                  <c:v>3.057049999999998</c:v>
                </c:pt>
                <c:pt idx="174">
                  <c:v>3.77056</c:v>
                </c:pt>
                <c:pt idx="175">
                  <c:v>2.74504</c:v>
                </c:pt>
                <c:pt idx="176">
                  <c:v>1.55752</c:v>
                </c:pt>
                <c:pt idx="177">
                  <c:v>5.151579999999996</c:v>
                </c:pt>
                <c:pt idx="178">
                  <c:v>2.67904</c:v>
                </c:pt>
                <c:pt idx="179">
                  <c:v>2.68304</c:v>
                </c:pt>
                <c:pt idx="180">
                  <c:v>4.08057</c:v>
                </c:pt>
                <c:pt idx="181">
                  <c:v>5.166579999999985</c:v>
                </c:pt>
                <c:pt idx="182">
                  <c:v>0.939015</c:v>
                </c:pt>
                <c:pt idx="183">
                  <c:v>5.010579999999996</c:v>
                </c:pt>
                <c:pt idx="184">
                  <c:v>1.20552</c:v>
                </c:pt>
                <c:pt idx="185">
                  <c:v>4.67207</c:v>
                </c:pt>
                <c:pt idx="186">
                  <c:v>6.58961</c:v>
                </c:pt>
                <c:pt idx="187">
                  <c:v>3.24105</c:v>
                </c:pt>
                <c:pt idx="188">
                  <c:v>4.833579999999999</c:v>
                </c:pt>
                <c:pt idx="189">
                  <c:v>2.56904</c:v>
                </c:pt>
                <c:pt idx="190">
                  <c:v>1.21452</c:v>
                </c:pt>
                <c:pt idx="191">
                  <c:v>6.707109999999997</c:v>
                </c:pt>
                <c:pt idx="192">
                  <c:v>3.302049999999952</c:v>
                </c:pt>
                <c:pt idx="193">
                  <c:v>4.18357</c:v>
                </c:pt>
                <c:pt idx="194">
                  <c:v>2.475039999999999</c:v>
                </c:pt>
                <c:pt idx="195">
                  <c:v>6.0216</c:v>
                </c:pt>
                <c:pt idx="196">
                  <c:v>4.58707</c:v>
                </c:pt>
                <c:pt idx="197">
                  <c:v>5.715589999999985</c:v>
                </c:pt>
                <c:pt idx="198">
                  <c:v>7.47262</c:v>
                </c:pt>
                <c:pt idx="199">
                  <c:v>6.267599999999994</c:v>
                </c:pt>
                <c:pt idx="200">
                  <c:v>3.652559999999997</c:v>
                </c:pt>
                <c:pt idx="201">
                  <c:v>7.49962</c:v>
                </c:pt>
                <c:pt idx="202">
                  <c:v>2.79054</c:v>
                </c:pt>
                <c:pt idx="203">
                  <c:v>6.682109999999985</c:v>
                </c:pt>
                <c:pt idx="204">
                  <c:v>3.47406</c:v>
                </c:pt>
                <c:pt idx="205">
                  <c:v>0.777012</c:v>
                </c:pt>
                <c:pt idx="206">
                  <c:v>1.17402</c:v>
                </c:pt>
                <c:pt idx="207">
                  <c:v>4.90608</c:v>
                </c:pt>
                <c:pt idx="208">
                  <c:v>3.59506</c:v>
                </c:pt>
                <c:pt idx="209">
                  <c:v>4.07107</c:v>
                </c:pt>
                <c:pt idx="210">
                  <c:v>6.555109999999996</c:v>
                </c:pt>
                <c:pt idx="211">
                  <c:v>3.303049999999998</c:v>
                </c:pt>
                <c:pt idx="212">
                  <c:v>6.1566</c:v>
                </c:pt>
                <c:pt idx="213">
                  <c:v>3.442559999999998</c:v>
                </c:pt>
                <c:pt idx="214">
                  <c:v>1.09002</c:v>
                </c:pt>
                <c:pt idx="215">
                  <c:v>0.681011</c:v>
                </c:pt>
                <c:pt idx="216">
                  <c:v>0.410007</c:v>
                </c:pt>
                <c:pt idx="217">
                  <c:v>0.498508</c:v>
                </c:pt>
                <c:pt idx="218">
                  <c:v>1.63203</c:v>
                </c:pt>
                <c:pt idx="219">
                  <c:v>3.70956</c:v>
                </c:pt>
                <c:pt idx="220">
                  <c:v>2.57004</c:v>
                </c:pt>
                <c:pt idx="221">
                  <c:v>3.298049999999999</c:v>
                </c:pt>
                <c:pt idx="222">
                  <c:v>1.66203</c:v>
                </c:pt>
                <c:pt idx="223">
                  <c:v>6.627609999999985</c:v>
                </c:pt>
                <c:pt idx="224">
                  <c:v>5.887589999999975</c:v>
                </c:pt>
                <c:pt idx="225">
                  <c:v>4.17057</c:v>
                </c:pt>
                <c:pt idx="226">
                  <c:v>2.41754</c:v>
                </c:pt>
                <c:pt idx="227">
                  <c:v>3.949059999999998</c:v>
                </c:pt>
                <c:pt idx="228">
                  <c:v>2.936049999999952</c:v>
                </c:pt>
                <c:pt idx="229">
                  <c:v>5.49959</c:v>
                </c:pt>
                <c:pt idx="230">
                  <c:v>4.605069999999999</c:v>
                </c:pt>
                <c:pt idx="231">
                  <c:v>2.51154</c:v>
                </c:pt>
                <c:pt idx="232">
                  <c:v>1.47102</c:v>
                </c:pt>
                <c:pt idx="233">
                  <c:v>0.59601</c:v>
                </c:pt>
                <c:pt idx="234">
                  <c:v>3.64956</c:v>
                </c:pt>
                <c:pt idx="235">
                  <c:v>1.57953</c:v>
                </c:pt>
                <c:pt idx="236">
                  <c:v>7.99013</c:v>
                </c:pt>
                <c:pt idx="237">
                  <c:v>3.954559999999998</c:v>
                </c:pt>
                <c:pt idx="238">
                  <c:v>1.68303</c:v>
                </c:pt>
                <c:pt idx="239">
                  <c:v>5.59109</c:v>
                </c:pt>
                <c:pt idx="240">
                  <c:v>7.34662</c:v>
                </c:pt>
                <c:pt idx="241">
                  <c:v>8.678640000000001</c:v>
                </c:pt>
                <c:pt idx="242">
                  <c:v>4.10657</c:v>
                </c:pt>
                <c:pt idx="243">
                  <c:v>5.75309</c:v>
                </c:pt>
                <c:pt idx="244">
                  <c:v>3.908059999999999</c:v>
                </c:pt>
                <c:pt idx="245">
                  <c:v>4.805079999999998</c:v>
                </c:pt>
                <c:pt idx="246">
                  <c:v>4.26057</c:v>
                </c:pt>
                <c:pt idx="247">
                  <c:v>4.96658</c:v>
                </c:pt>
                <c:pt idx="248">
                  <c:v>7.40212</c:v>
                </c:pt>
                <c:pt idx="249">
                  <c:v>5.160079999999986</c:v>
                </c:pt>
                <c:pt idx="250">
                  <c:v>2.23354</c:v>
                </c:pt>
                <c:pt idx="251">
                  <c:v>5.540589999999995</c:v>
                </c:pt>
                <c:pt idx="252">
                  <c:v>1.66353</c:v>
                </c:pt>
                <c:pt idx="253">
                  <c:v>5.45209</c:v>
                </c:pt>
                <c:pt idx="254">
                  <c:v>3.76706</c:v>
                </c:pt>
                <c:pt idx="255">
                  <c:v>3.098549999999999</c:v>
                </c:pt>
                <c:pt idx="256">
                  <c:v>4.55857</c:v>
                </c:pt>
                <c:pt idx="257">
                  <c:v>8.05063</c:v>
                </c:pt>
                <c:pt idx="258">
                  <c:v>6.4791</c:v>
                </c:pt>
                <c:pt idx="259">
                  <c:v>11.5462</c:v>
                </c:pt>
                <c:pt idx="260">
                  <c:v>6.613109999999986</c:v>
                </c:pt>
                <c:pt idx="261">
                  <c:v>4.97658</c:v>
                </c:pt>
                <c:pt idx="262">
                  <c:v>8.652640000000006</c:v>
                </c:pt>
                <c:pt idx="263">
                  <c:v>4.625069999999995</c:v>
                </c:pt>
                <c:pt idx="264">
                  <c:v>3.71206</c:v>
                </c:pt>
                <c:pt idx="265">
                  <c:v>3.341549999999998</c:v>
                </c:pt>
                <c:pt idx="266">
                  <c:v>5.78709</c:v>
                </c:pt>
                <c:pt idx="267">
                  <c:v>5.120479999999985</c:v>
                </c:pt>
                <c:pt idx="268">
                  <c:v>1.93903</c:v>
                </c:pt>
                <c:pt idx="269">
                  <c:v>7.562619999999995</c:v>
                </c:pt>
                <c:pt idx="270">
                  <c:v>11.0942</c:v>
                </c:pt>
                <c:pt idx="271">
                  <c:v>5.41359</c:v>
                </c:pt>
                <c:pt idx="272">
                  <c:v>6.0691</c:v>
                </c:pt>
                <c:pt idx="273">
                  <c:v>13.9302</c:v>
                </c:pt>
                <c:pt idx="274">
                  <c:v>13.5722</c:v>
                </c:pt>
                <c:pt idx="275">
                  <c:v>9.10515</c:v>
                </c:pt>
                <c:pt idx="276">
                  <c:v>7.515119999999984</c:v>
                </c:pt>
                <c:pt idx="277">
                  <c:v>5.314589999999937</c:v>
                </c:pt>
                <c:pt idx="278">
                  <c:v>9.163150000000003</c:v>
                </c:pt>
                <c:pt idx="279">
                  <c:v>7.687119999999965</c:v>
                </c:pt>
                <c:pt idx="280">
                  <c:v>3.54056</c:v>
                </c:pt>
                <c:pt idx="281">
                  <c:v>5.047579999999996</c:v>
                </c:pt>
                <c:pt idx="282">
                  <c:v>4.41557</c:v>
                </c:pt>
                <c:pt idx="283">
                  <c:v>7.48912</c:v>
                </c:pt>
                <c:pt idx="284">
                  <c:v>6.4496</c:v>
                </c:pt>
                <c:pt idx="285">
                  <c:v>5.37609</c:v>
                </c:pt>
                <c:pt idx="286">
                  <c:v>6.737109999999999</c:v>
                </c:pt>
                <c:pt idx="287">
                  <c:v>3.42505</c:v>
                </c:pt>
                <c:pt idx="288">
                  <c:v>7.00361</c:v>
                </c:pt>
                <c:pt idx="289">
                  <c:v>7.07661</c:v>
                </c:pt>
                <c:pt idx="290">
                  <c:v>4.92308</c:v>
                </c:pt>
                <c:pt idx="291">
                  <c:v>6.95361</c:v>
                </c:pt>
                <c:pt idx="292">
                  <c:v>6.022099999999996</c:v>
                </c:pt>
                <c:pt idx="293">
                  <c:v>5.18608</c:v>
                </c:pt>
                <c:pt idx="294">
                  <c:v>6.3016</c:v>
                </c:pt>
                <c:pt idx="295">
                  <c:v>3.01155</c:v>
                </c:pt>
                <c:pt idx="296">
                  <c:v>4.878579999999999</c:v>
                </c:pt>
                <c:pt idx="297">
                  <c:v>6.1911</c:v>
                </c:pt>
                <c:pt idx="298">
                  <c:v>2.62554</c:v>
                </c:pt>
                <c:pt idx="299">
                  <c:v>7.320119999999965</c:v>
                </c:pt>
                <c:pt idx="300">
                  <c:v>10.1077</c:v>
                </c:pt>
                <c:pt idx="301">
                  <c:v>6.4111</c:v>
                </c:pt>
                <c:pt idx="302">
                  <c:v>6.82161</c:v>
                </c:pt>
                <c:pt idx="303">
                  <c:v>7.76362</c:v>
                </c:pt>
                <c:pt idx="304">
                  <c:v>7.88663</c:v>
                </c:pt>
                <c:pt idx="305">
                  <c:v>5.350089999999994</c:v>
                </c:pt>
                <c:pt idx="306">
                  <c:v>7.504119999999975</c:v>
                </c:pt>
                <c:pt idx="307">
                  <c:v>3.722059999999999</c:v>
                </c:pt>
                <c:pt idx="308">
                  <c:v>3.24105</c:v>
                </c:pt>
                <c:pt idx="309">
                  <c:v>4.42307</c:v>
                </c:pt>
                <c:pt idx="310">
                  <c:v>3.94756</c:v>
                </c:pt>
                <c:pt idx="311">
                  <c:v>5.9291</c:v>
                </c:pt>
                <c:pt idx="312">
                  <c:v>7.305119999999984</c:v>
                </c:pt>
                <c:pt idx="313">
                  <c:v>7.38612</c:v>
                </c:pt>
                <c:pt idx="314">
                  <c:v>12.3307</c:v>
                </c:pt>
                <c:pt idx="315">
                  <c:v>2.46354</c:v>
                </c:pt>
                <c:pt idx="316">
                  <c:v>7.33312</c:v>
                </c:pt>
                <c:pt idx="317">
                  <c:v>7.65062</c:v>
                </c:pt>
                <c:pt idx="318">
                  <c:v>4.03556</c:v>
                </c:pt>
                <c:pt idx="319">
                  <c:v>6.1496</c:v>
                </c:pt>
                <c:pt idx="320">
                  <c:v>8.20313</c:v>
                </c:pt>
                <c:pt idx="321">
                  <c:v>4.91358</c:v>
                </c:pt>
                <c:pt idx="322">
                  <c:v>4.717079999999997</c:v>
                </c:pt>
                <c:pt idx="323">
                  <c:v>2.36154</c:v>
                </c:pt>
                <c:pt idx="324">
                  <c:v>4.97508</c:v>
                </c:pt>
                <c:pt idx="325">
                  <c:v>11.9072</c:v>
                </c:pt>
                <c:pt idx="326">
                  <c:v>6.2596</c:v>
                </c:pt>
                <c:pt idx="327">
                  <c:v>5.29609</c:v>
                </c:pt>
                <c:pt idx="328">
                  <c:v>5.754589999999966</c:v>
                </c:pt>
                <c:pt idx="329">
                  <c:v>6.0106</c:v>
                </c:pt>
                <c:pt idx="330">
                  <c:v>8.96964</c:v>
                </c:pt>
                <c:pt idx="331">
                  <c:v>4.34507</c:v>
                </c:pt>
                <c:pt idx="332">
                  <c:v>6.655109999999976</c:v>
                </c:pt>
                <c:pt idx="333">
                  <c:v>4.25007</c:v>
                </c:pt>
                <c:pt idx="334">
                  <c:v>7.504119999999975</c:v>
                </c:pt>
                <c:pt idx="335">
                  <c:v>9.82066</c:v>
                </c:pt>
                <c:pt idx="336">
                  <c:v>4.05507</c:v>
                </c:pt>
                <c:pt idx="337">
                  <c:v>4.93758</c:v>
                </c:pt>
                <c:pt idx="338">
                  <c:v>5.77859</c:v>
                </c:pt>
                <c:pt idx="339">
                  <c:v>7.43162</c:v>
                </c:pt>
                <c:pt idx="340">
                  <c:v>3.58956</c:v>
                </c:pt>
                <c:pt idx="341">
                  <c:v>5.661589999999966</c:v>
                </c:pt>
                <c:pt idx="342">
                  <c:v>4.322569999999986</c:v>
                </c:pt>
                <c:pt idx="343">
                  <c:v>3.26805</c:v>
                </c:pt>
                <c:pt idx="344">
                  <c:v>4.766579999999998</c:v>
                </c:pt>
                <c:pt idx="345">
                  <c:v>5.71809</c:v>
                </c:pt>
                <c:pt idx="346">
                  <c:v>7.650119999999966</c:v>
                </c:pt>
                <c:pt idx="347">
                  <c:v>9.13715</c:v>
                </c:pt>
                <c:pt idx="348">
                  <c:v>2.52654</c:v>
                </c:pt>
                <c:pt idx="349">
                  <c:v>3.33855</c:v>
                </c:pt>
                <c:pt idx="350">
                  <c:v>5.09108</c:v>
                </c:pt>
                <c:pt idx="351">
                  <c:v>2.65304</c:v>
                </c:pt>
                <c:pt idx="352">
                  <c:v>1.35002</c:v>
                </c:pt>
                <c:pt idx="353">
                  <c:v>5.097579999999986</c:v>
                </c:pt>
                <c:pt idx="354">
                  <c:v>11.8092</c:v>
                </c:pt>
                <c:pt idx="355">
                  <c:v>3.60956</c:v>
                </c:pt>
                <c:pt idx="356">
                  <c:v>4.060569999999998</c:v>
                </c:pt>
                <c:pt idx="357">
                  <c:v>2.08903</c:v>
                </c:pt>
                <c:pt idx="358">
                  <c:v>2.51554</c:v>
                </c:pt>
                <c:pt idx="359">
                  <c:v>4.61107</c:v>
                </c:pt>
                <c:pt idx="360">
                  <c:v>6.63061</c:v>
                </c:pt>
                <c:pt idx="361">
                  <c:v>2.08753</c:v>
                </c:pt>
                <c:pt idx="362">
                  <c:v>2.71004</c:v>
                </c:pt>
                <c:pt idx="363">
                  <c:v>6.98811</c:v>
                </c:pt>
                <c:pt idx="364">
                  <c:v>6.80861</c:v>
                </c:pt>
                <c:pt idx="365">
                  <c:v>3.47556</c:v>
                </c:pt>
                <c:pt idx="366">
                  <c:v>5.512589999999975</c:v>
                </c:pt>
                <c:pt idx="367">
                  <c:v>0.999516</c:v>
                </c:pt>
                <c:pt idx="368">
                  <c:v>3.07005</c:v>
                </c:pt>
                <c:pt idx="369">
                  <c:v>2.335039999999998</c:v>
                </c:pt>
                <c:pt idx="370">
                  <c:v>3.00955</c:v>
                </c:pt>
                <c:pt idx="371">
                  <c:v>3.134049999999998</c:v>
                </c:pt>
                <c:pt idx="372">
                  <c:v>4.38707</c:v>
                </c:pt>
                <c:pt idx="373">
                  <c:v>3.10455</c:v>
                </c:pt>
                <c:pt idx="374">
                  <c:v>6.5321</c:v>
                </c:pt>
                <c:pt idx="375">
                  <c:v>6.113599999999995</c:v>
                </c:pt>
                <c:pt idx="376">
                  <c:v>5.714589999999966</c:v>
                </c:pt>
                <c:pt idx="377">
                  <c:v>4.94308</c:v>
                </c:pt>
                <c:pt idx="378">
                  <c:v>11.2147</c:v>
                </c:pt>
                <c:pt idx="379">
                  <c:v>3.83406</c:v>
                </c:pt>
                <c:pt idx="380">
                  <c:v>7.52562</c:v>
                </c:pt>
                <c:pt idx="381">
                  <c:v>8.633640000000001</c:v>
                </c:pt>
                <c:pt idx="382">
                  <c:v>6.643109999999996</c:v>
                </c:pt>
                <c:pt idx="383">
                  <c:v>8.30113</c:v>
                </c:pt>
                <c:pt idx="384">
                  <c:v>4.42007</c:v>
                </c:pt>
                <c:pt idx="385">
                  <c:v>4.25557</c:v>
                </c:pt>
                <c:pt idx="386">
                  <c:v>2.14953</c:v>
                </c:pt>
                <c:pt idx="387">
                  <c:v>1.62303</c:v>
                </c:pt>
                <c:pt idx="388">
                  <c:v>4.910579999999999</c:v>
                </c:pt>
                <c:pt idx="389">
                  <c:v>4.23407</c:v>
                </c:pt>
                <c:pt idx="390">
                  <c:v>3.08205</c:v>
                </c:pt>
                <c:pt idx="391">
                  <c:v>4.184569999999995</c:v>
                </c:pt>
                <c:pt idx="392">
                  <c:v>7.79263</c:v>
                </c:pt>
                <c:pt idx="393">
                  <c:v>3.86656</c:v>
                </c:pt>
                <c:pt idx="394">
                  <c:v>4.49407</c:v>
                </c:pt>
                <c:pt idx="395">
                  <c:v>8.45714</c:v>
                </c:pt>
                <c:pt idx="396">
                  <c:v>3.449059999999998</c:v>
                </c:pt>
                <c:pt idx="397">
                  <c:v>6.854109999999975</c:v>
                </c:pt>
                <c:pt idx="398">
                  <c:v>3.76206</c:v>
                </c:pt>
                <c:pt idx="399">
                  <c:v>4.90708</c:v>
                </c:pt>
                <c:pt idx="400">
                  <c:v>1.93653</c:v>
                </c:pt>
                <c:pt idx="401">
                  <c:v>3.650059999999998</c:v>
                </c:pt>
                <c:pt idx="402">
                  <c:v>0.733012</c:v>
                </c:pt>
                <c:pt idx="403">
                  <c:v>1.88503</c:v>
                </c:pt>
                <c:pt idx="404">
                  <c:v>2.54904</c:v>
                </c:pt>
                <c:pt idx="405">
                  <c:v>4.35157</c:v>
                </c:pt>
                <c:pt idx="406">
                  <c:v>4.38707</c:v>
                </c:pt>
                <c:pt idx="407">
                  <c:v>2.32004</c:v>
                </c:pt>
                <c:pt idx="408">
                  <c:v>2.80405</c:v>
                </c:pt>
                <c:pt idx="409">
                  <c:v>1.45402</c:v>
                </c:pt>
                <c:pt idx="410">
                  <c:v>3.06055</c:v>
                </c:pt>
                <c:pt idx="411">
                  <c:v>1.45902</c:v>
                </c:pt>
                <c:pt idx="412">
                  <c:v>3.59756</c:v>
                </c:pt>
                <c:pt idx="413">
                  <c:v>2.09653</c:v>
                </c:pt>
                <c:pt idx="414">
                  <c:v>3.60406</c:v>
                </c:pt>
                <c:pt idx="415">
                  <c:v>1.92503</c:v>
                </c:pt>
                <c:pt idx="416">
                  <c:v>4.00106</c:v>
                </c:pt>
                <c:pt idx="417">
                  <c:v>2.05453</c:v>
                </c:pt>
                <c:pt idx="418">
                  <c:v>2.03453</c:v>
                </c:pt>
                <c:pt idx="419">
                  <c:v>7.26862</c:v>
                </c:pt>
                <c:pt idx="420">
                  <c:v>4.967079999999997</c:v>
                </c:pt>
                <c:pt idx="421">
                  <c:v>5.51909</c:v>
                </c:pt>
                <c:pt idx="422">
                  <c:v>3.365549999999998</c:v>
                </c:pt>
                <c:pt idx="423">
                  <c:v>2.29554</c:v>
                </c:pt>
                <c:pt idx="424">
                  <c:v>1.48352</c:v>
                </c:pt>
                <c:pt idx="425">
                  <c:v>0.931015</c:v>
                </c:pt>
                <c:pt idx="426">
                  <c:v>3.35705</c:v>
                </c:pt>
                <c:pt idx="427">
                  <c:v>3.706059999999999</c:v>
                </c:pt>
                <c:pt idx="428">
                  <c:v>2.23304</c:v>
                </c:pt>
                <c:pt idx="429">
                  <c:v>1.40402</c:v>
                </c:pt>
                <c:pt idx="430">
                  <c:v>4.41007</c:v>
                </c:pt>
                <c:pt idx="431">
                  <c:v>1.83453</c:v>
                </c:pt>
                <c:pt idx="432">
                  <c:v>3.28855</c:v>
                </c:pt>
                <c:pt idx="433">
                  <c:v>1.26152</c:v>
                </c:pt>
                <c:pt idx="434">
                  <c:v>2.923049999999999</c:v>
                </c:pt>
                <c:pt idx="435">
                  <c:v>3.117049999999999</c:v>
                </c:pt>
                <c:pt idx="436">
                  <c:v>0.789013</c:v>
                </c:pt>
                <c:pt idx="437">
                  <c:v>2.00153</c:v>
                </c:pt>
                <c:pt idx="438">
                  <c:v>3.16255</c:v>
                </c:pt>
                <c:pt idx="439">
                  <c:v>0.590509</c:v>
                </c:pt>
                <c:pt idx="440">
                  <c:v>0.60651</c:v>
                </c:pt>
                <c:pt idx="441">
                  <c:v>0.63901</c:v>
                </c:pt>
                <c:pt idx="442">
                  <c:v>2.87955</c:v>
                </c:pt>
                <c:pt idx="443">
                  <c:v>1.14702</c:v>
                </c:pt>
                <c:pt idx="444">
                  <c:v>1.27652</c:v>
                </c:pt>
                <c:pt idx="445">
                  <c:v>0.859514</c:v>
                </c:pt>
                <c:pt idx="446">
                  <c:v>0.799013</c:v>
                </c:pt>
                <c:pt idx="447">
                  <c:v>2.27104</c:v>
                </c:pt>
                <c:pt idx="448">
                  <c:v>1.20452</c:v>
                </c:pt>
                <c:pt idx="449">
                  <c:v>5.90709</c:v>
                </c:pt>
                <c:pt idx="450">
                  <c:v>2.51254</c:v>
                </c:pt>
                <c:pt idx="451">
                  <c:v>1.80753</c:v>
                </c:pt>
                <c:pt idx="452">
                  <c:v>2.67704</c:v>
                </c:pt>
                <c:pt idx="453">
                  <c:v>1.75153</c:v>
                </c:pt>
                <c:pt idx="454">
                  <c:v>2.12103</c:v>
                </c:pt>
                <c:pt idx="455">
                  <c:v>1.54202</c:v>
                </c:pt>
                <c:pt idx="456">
                  <c:v>3.639559999999998</c:v>
                </c:pt>
                <c:pt idx="457">
                  <c:v>0.666011</c:v>
                </c:pt>
                <c:pt idx="458">
                  <c:v>1.99453</c:v>
                </c:pt>
                <c:pt idx="459">
                  <c:v>3.52856</c:v>
                </c:pt>
                <c:pt idx="460">
                  <c:v>4.55907</c:v>
                </c:pt>
                <c:pt idx="461">
                  <c:v>1.22152</c:v>
                </c:pt>
                <c:pt idx="462">
                  <c:v>2.48704</c:v>
                </c:pt>
                <c:pt idx="463">
                  <c:v>0.994516</c:v>
                </c:pt>
                <c:pt idx="464">
                  <c:v>2.00303</c:v>
                </c:pt>
                <c:pt idx="465">
                  <c:v>2.08103</c:v>
                </c:pt>
                <c:pt idx="466">
                  <c:v>4.620569999999986</c:v>
                </c:pt>
                <c:pt idx="467">
                  <c:v>3.62456</c:v>
                </c:pt>
                <c:pt idx="468">
                  <c:v>3.40505</c:v>
                </c:pt>
                <c:pt idx="469">
                  <c:v>5.195579999999985</c:v>
                </c:pt>
                <c:pt idx="470">
                  <c:v>4.05807</c:v>
                </c:pt>
                <c:pt idx="471">
                  <c:v>2.70304</c:v>
                </c:pt>
                <c:pt idx="472">
                  <c:v>1.65053</c:v>
                </c:pt>
                <c:pt idx="473">
                  <c:v>5.368089999999984</c:v>
                </c:pt>
                <c:pt idx="474">
                  <c:v>3.359049999999952</c:v>
                </c:pt>
                <c:pt idx="475">
                  <c:v>7.06161</c:v>
                </c:pt>
                <c:pt idx="476">
                  <c:v>3.56756</c:v>
                </c:pt>
                <c:pt idx="477">
                  <c:v>6.71911</c:v>
                </c:pt>
                <c:pt idx="478">
                  <c:v>1.89703</c:v>
                </c:pt>
                <c:pt idx="479">
                  <c:v>1.88753</c:v>
                </c:pt>
                <c:pt idx="480">
                  <c:v>4.815079999999996</c:v>
                </c:pt>
                <c:pt idx="481">
                  <c:v>2.63404</c:v>
                </c:pt>
                <c:pt idx="482">
                  <c:v>2.439039999999999</c:v>
                </c:pt>
                <c:pt idx="483">
                  <c:v>0.583509</c:v>
                </c:pt>
                <c:pt idx="484">
                  <c:v>4.763079999999999</c:v>
                </c:pt>
                <c:pt idx="485">
                  <c:v>3.614059999999998</c:v>
                </c:pt>
                <c:pt idx="486">
                  <c:v>3.38755</c:v>
                </c:pt>
                <c:pt idx="487">
                  <c:v>2.75404</c:v>
                </c:pt>
                <c:pt idx="488">
                  <c:v>2.936049999999952</c:v>
                </c:pt>
                <c:pt idx="489">
                  <c:v>3.45406</c:v>
                </c:pt>
                <c:pt idx="490">
                  <c:v>7.764619999999994</c:v>
                </c:pt>
                <c:pt idx="491">
                  <c:v>4.29107</c:v>
                </c:pt>
                <c:pt idx="492">
                  <c:v>5.002579999999996</c:v>
                </c:pt>
                <c:pt idx="493">
                  <c:v>6.59111</c:v>
                </c:pt>
                <c:pt idx="494">
                  <c:v>3.73306</c:v>
                </c:pt>
                <c:pt idx="495">
                  <c:v>2.77104</c:v>
                </c:pt>
                <c:pt idx="496">
                  <c:v>8.75014</c:v>
                </c:pt>
                <c:pt idx="497">
                  <c:v>3.12855</c:v>
                </c:pt>
                <c:pt idx="498">
                  <c:v>7.06061</c:v>
                </c:pt>
                <c:pt idx="499">
                  <c:v>3.35455</c:v>
                </c:pt>
                <c:pt idx="500">
                  <c:v>2.59704</c:v>
                </c:pt>
                <c:pt idx="501">
                  <c:v>5.04108</c:v>
                </c:pt>
                <c:pt idx="502">
                  <c:v>1.59003</c:v>
                </c:pt>
                <c:pt idx="503">
                  <c:v>5.48809</c:v>
                </c:pt>
                <c:pt idx="504">
                  <c:v>6.320099999999996</c:v>
                </c:pt>
                <c:pt idx="505">
                  <c:v>2.59704</c:v>
                </c:pt>
                <c:pt idx="506">
                  <c:v>1.83953</c:v>
                </c:pt>
                <c:pt idx="507">
                  <c:v>4.007559999999994</c:v>
                </c:pt>
                <c:pt idx="508">
                  <c:v>5.185079999999997</c:v>
                </c:pt>
                <c:pt idx="509">
                  <c:v>5.20308</c:v>
                </c:pt>
                <c:pt idx="510">
                  <c:v>6.848109999999997</c:v>
                </c:pt>
                <c:pt idx="511">
                  <c:v>7.47362</c:v>
                </c:pt>
                <c:pt idx="512">
                  <c:v>4.026559999999995</c:v>
                </c:pt>
                <c:pt idx="513">
                  <c:v>4.847579999999986</c:v>
                </c:pt>
                <c:pt idx="514">
                  <c:v>4.792079999999998</c:v>
                </c:pt>
                <c:pt idx="515">
                  <c:v>2.55854</c:v>
                </c:pt>
                <c:pt idx="516">
                  <c:v>6.4751</c:v>
                </c:pt>
                <c:pt idx="517">
                  <c:v>10.2007</c:v>
                </c:pt>
                <c:pt idx="518">
                  <c:v>6.5076</c:v>
                </c:pt>
                <c:pt idx="519">
                  <c:v>11.0117</c:v>
                </c:pt>
                <c:pt idx="520">
                  <c:v>5.79659</c:v>
                </c:pt>
                <c:pt idx="521">
                  <c:v>6.3861</c:v>
                </c:pt>
                <c:pt idx="522">
                  <c:v>4.17607</c:v>
                </c:pt>
                <c:pt idx="523">
                  <c:v>2.19154</c:v>
                </c:pt>
                <c:pt idx="524">
                  <c:v>6.4101</c:v>
                </c:pt>
                <c:pt idx="525">
                  <c:v>5.088579999999999</c:v>
                </c:pt>
                <c:pt idx="526">
                  <c:v>7.42912</c:v>
                </c:pt>
                <c:pt idx="527">
                  <c:v>5.13958</c:v>
                </c:pt>
                <c:pt idx="528">
                  <c:v>4.044559999999985</c:v>
                </c:pt>
                <c:pt idx="529">
                  <c:v>5.9896</c:v>
                </c:pt>
                <c:pt idx="530">
                  <c:v>5.18108</c:v>
                </c:pt>
                <c:pt idx="531">
                  <c:v>5.668089999999966</c:v>
                </c:pt>
                <c:pt idx="532">
                  <c:v>6.659109999999996</c:v>
                </c:pt>
                <c:pt idx="533">
                  <c:v>8.68364</c:v>
                </c:pt>
                <c:pt idx="534">
                  <c:v>7.67162</c:v>
                </c:pt>
                <c:pt idx="535">
                  <c:v>2.22654</c:v>
                </c:pt>
                <c:pt idx="536">
                  <c:v>4.53357</c:v>
                </c:pt>
                <c:pt idx="537">
                  <c:v>3.345849999999976</c:v>
                </c:pt>
                <c:pt idx="538">
                  <c:v>2.34704</c:v>
                </c:pt>
                <c:pt idx="539">
                  <c:v>7.49262</c:v>
                </c:pt>
                <c:pt idx="540">
                  <c:v>8.56414</c:v>
                </c:pt>
                <c:pt idx="541">
                  <c:v>7.152609999999997</c:v>
                </c:pt>
                <c:pt idx="542">
                  <c:v>4.177569999999998</c:v>
                </c:pt>
                <c:pt idx="543">
                  <c:v>9.46015</c:v>
                </c:pt>
                <c:pt idx="544">
                  <c:v>3.64156</c:v>
                </c:pt>
                <c:pt idx="545">
                  <c:v>4.808079999999999</c:v>
                </c:pt>
                <c:pt idx="546">
                  <c:v>4.34057</c:v>
                </c:pt>
                <c:pt idx="547">
                  <c:v>4.18007</c:v>
                </c:pt>
                <c:pt idx="548">
                  <c:v>5.367589999999937</c:v>
                </c:pt>
                <c:pt idx="549">
                  <c:v>6.99561</c:v>
                </c:pt>
                <c:pt idx="550">
                  <c:v>9.04415</c:v>
                </c:pt>
                <c:pt idx="551">
                  <c:v>10.2432</c:v>
                </c:pt>
                <c:pt idx="552">
                  <c:v>4.885579999999996</c:v>
                </c:pt>
                <c:pt idx="553">
                  <c:v>1.52402</c:v>
                </c:pt>
                <c:pt idx="554">
                  <c:v>4.95908</c:v>
                </c:pt>
                <c:pt idx="555">
                  <c:v>7.24062</c:v>
                </c:pt>
                <c:pt idx="556">
                  <c:v>5.28358</c:v>
                </c:pt>
                <c:pt idx="557">
                  <c:v>1.76653</c:v>
                </c:pt>
                <c:pt idx="558">
                  <c:v>4.26107</c:v>
                </c:pt>
                <c:pt idx="559">
                  <c:v>4.01156</c:v>
                </c:pt>
                <c:pt idx="560">
                  <c:v>3.61506</c:v>
                </c:pt>
                <c:pt idx="561">
                  <c:v>4.94958</c:v>
                </c:pt>
                <c:pt idx="562">
                  <c:v>6.522599999999994</c:v>
                </c:pt>
                <c:pt idx="563">
                  <c:v>2.43354</c:v>
                </c:pt>
                <c:pt idx="564">
                  <c:v>5.303589999999994</c:v>
                </c:pt>
                <c:pt idx="565">
                  <c:v>3.312049999999952</c:v>
                </c:pt>
                <c:pt idx="566">
                  <c:v>4.103569999999999</c:v>
                </c:pt>
                <c:pt idx="567">
                  <c:v>2.32704</c:v>
                </c:pt>
                <c:pt idx="568">
                  <c:v>8.48614</c:v>
                </c:pt>
                <c:pt idx="569">
                  <c:v>6.80261</c:v>
                </c:pt>
                <c:pt idx="570">
                  <c:v>6.798109999999998</c:v>
                </c:pt>
                <c:pt idx="571">
                  <c:v>5.48809</c:v>
                </c:pt>
                <c:pt idx="572">
                  <c:v>4.15157</c:v>
                </c:pt>
                <c:pt idx="573">
                  <c:v>3.759059999999998</c:v>
                </c:pt>
                <c:pt idx="574">
                  <c:v>4.45107</c:v>
                </c:pt>
                <c:pt idx="575">
                  <c:v>1.79103</c:v>
                </c:pt>
                <c:pt idx="576">
                  <c:v>4.887079999999996</c:v>
                </c:pt>
                <c:pt idx="577">
                  <c:v>3.579559999999999</c:v>
                </c:pt>
                <c:pt idx="578">
                  <c:v>3.251549999999999</c:v>
                </c:pt>
                <c:pt idx="579">
                  <c:v>2.75954</c:v>
                </c:pt>
                <c:pt idx="580">
                  <c:v>4.620569999999986</c:v>
                </c:pt>
                <c:pt idx="581">
                  <c:v>3.899059999999952</c:v>
                </c:pt>
                <c:pt idx="582">
                  <c:v>6.97211</c:v>
                </c:pt>
                <c:pt idx="583">
                  <c:v>5.650089999999984</c:v>
                </c:pt>
                <c:pt idx="584">
                  <c:v>1.84353</c:v>
                </c:pt>
                <c:pt idx="585">
                  <c:v>5.077579999999998</c:v>
                </c:pt>
                <c:pt idx="586">
                  <c:v>7.054109999999985</c:v>
                </c:pt>
                <c:pt idx="587">
                  <c:v>4.13157</c:v>
                </c:pt>
                <c:pt idx="588">
                  <c:v>3.598059999999998</c:v>
                </c:pt>
                <c:pt idx="589">
                  <c:v>7.54562</c:v>
                </c:pt>
                <c:pt idx="590">
                  <c:v>6.86661</c:v>
                </c:pt>
                <c:pt idx="591">
                  <c:v>5.78009</c:v>
                </c:pt>
                <c:pt idx="592">
                  <c:v>7.28062</c:v>
                </c:pt>
                <c:pt idx="593">
                  <c:v>3.454559999999998</c:v>
                </c:pt>
                <c:pt idx="594">
                  <c:v>2.05753</c:v>
                </c:pt>
                <c:pt idx="595">
                  <c:v>10.5222</c:v>
                </c:pt>
                <c:pt idx="596">
                  <c:v>3.19255</c:v>
                </c:pt>
                <c:pt idx="597">
                  <c:v>6.4091</c:v>
                </c:pt>
                <c:pt idx="598">
                  <c:v>8.815140000000004</c:v>
                </c:pt>
                <c:pt idx="599">
                  <c:v>6.678109999999997</c:v>
                </c:pt>
                <c:pt idx="600">
                  <c:v>3.92356</c:v>
                </c:pt>
                <c:pt idx="601">
                  <c:v>3.76906</c:v>
                </c:pt>
                <c:pt idx="602">
                  <c:v>2.73254</c:v>
                </c:pt>
                <c:pt idx="603">
                  <c:v>9.98916</c:v>
                </c:pt>
                <c:pt idx="604">
                  <c:v>7.41612</c:v>
                </c:pt>
                <c:pt idx="605">
                  <c:v>5.180079999999998</c:v>
                </c:pt>
                <c:pt idx="606">
                  <c:v>4.25407</c:v>
                </c:pt>
                <c:pt idx="607">
                  <c:v>1.40802</c:v>
                </c:pt>
                <c:pt idx="608">
                  <c:v>6.851109999999998</c:v>
                </c:pt>
                <c:pt idx="609">
                  <c:v>2.920049999999998</c:v>
                </c:pt>
                <c:pt idx="610">
                  <c:v>5.70909</c:v>
                </c:pt>
                <c:pt idx="611">
                  <c:v>2.63854</c:v>
                </c:pt>
                <c:pt idx="612">
                  <c:v>4.75608</c:v>
                </c:pt>
                <c:pt idx="613">
                  <c:v>2.36354</c:v>
                </c:pt>
                <c:pt idx="614">
                  <c:v>2.70654</c:v>
                </c:pt>
                <c:pt idx="615">
                  <c:v>2.77354</c:v>
                </c:pt>
                <c:pt idx="616">
                  <c:v>4.10657</c:v>
                </c:pt>
                <c:pt idx="617">
                  <c:v>6.4361</c:v>
                </c:pt>
                <c:pt idx="618">
                  <c:v>4.40057</c:v>
                </c:pt>
                <c:pt idx="619">
                  <c:v>4.30007</c:v>
                </c:pt>
                <c:pt idx="620">
                  <c:v>6.70961</c:v>
                </c:pt>
                <c:pt idx="621">
                  <c:v>4.04156</c:v>
                </c:pt>
                <c:pt idx="622">
                  <c:v>7.70012</c:v>
                </c:pt>
                <c:pt idx="623">
                  <c:v>6.1866</c:v>
                </c:pt>
                <c:pt idx="624">
                  <c:v>5.074079999999999</c:v>
                </c:pt>
                <c:pt idx="625">
                  <c:v>4.142069999999999</c:v>
                </c:pt>
                <c:pt idx="626">
                  <c:v>4.95808</c:v>
                </c:pt>
                <c:pt idx="627">
                  <c:v>3.55606</c:v>
                </c:pt>
                <c:pt idx="628">
                  <c:v>6.785109999999999</c:v>
                </c:pt>
                <c:pt idx="629">
                  <c:v>5.883589999999994</c:v>
                </c:pt>
                <c:pt idx="630">
                  <c:v>5.9706</c:v>
                </c:pt>
                <c:pt idx="631">
                  <c:v>5.012079999999997</c:v>
                </c:pt>
                <c:pt idx="632">
                  <c:v>5.180579999999996</c:v>
                </c:pt>
                <c:pt idx="633">
                  <c:v>2.92755</c:v>
                </c:pt>
                <c:pt idx="634">
                  <c:v>1.82553</c:v>
                </c:pt>
                <c:pt idx="635">
                  <c:v>9.446150000000001</c:v>
                </c:pt>
                <c:pt idx="636">
                  <c:v>6.4051</c:v>
                </c:pt>
                <c:pt idx="637">
                  <c:v>2.75054</c:v>
                </c:pt>
                <c:pt idx="638">
                  <c:v>4.27057</c:v>
                </c:pt>
                <c:pt idx="639">
                  <c:v>3.498559999999999</c:v>
                </c:pt>
                <c:pt idx="640">
                  <c:v>12.0942</c:v>
                </c:pt>
                <c:pt idx="641">
                  <c:v>6.1736</c:v>
                </c:pt>
                <c:pt idx="642">
                  <c:v>3.76306</c:v>
                </c:pt>
                <c:pt idx="643">
                  <c:v>9.757660000000001</c:v>
                </c:pt>
                <c:pt idx="644">
                  <c:v>6.3481</c:v>
                </c:pt>
                <c:pt idx="645">
                  <c:v>6.0031</c:v>
                </c:pt>
                <c:pt idx="646">
                  <c:v>7.87613</c:v>
                </c:pt>
                <c:pt idx="647">
                  <c:v>5.43859</c:v>
                </c:pt>
                <c:pt idx="648">
                  <c:v>3.71556</c:v>
                </c:pt>
                <c:pt idx="649">
                  <c:v>5.40259</c:v>
                </c:pt>
                <c:pt idx="650">
                  <c:v>4.014059999999994</c:v>
                </c:pt>
                <c:pt idx="651">
                  <c:v>3.282049999999999</c:v>
                </c:pt>
                <c:pt idx="652">
                  <c:v>4.565569999999997</c:v>
                </c:pt>
                <c:pt idx="653">
                  <c:v>6.3711</c:v>
                </c:pt>
                <c:pt idx="654">
                  <c:v>3.938559999999998</c:v>
                </c:pt>
                <c:pt idx="655">
                  <c:v>3.75956</c:v>
                </c:pt>
                <c:pt idx="656">
                  <c:v>1.64603</c:v>
                </c:pt>
                <c:pt idx="657">
                  <c:v>1.61903</c:v>
                </c:pt>
                <c:pt idx="658">
                  <c:v>3.11355</c:v>
                </c:pt>
                <c:pt idx="659">
                  <c:v>2.34254</c:v>
                </c:pt>
                <c:pt idx="660">
                  <c:v>4.88158</c:v>
                </c:pt>
                <c:pt idx="661">
                  <c:v>3.19355</c:v>
                </c:pt>
                <c:pt idx="662">
                  <c:v>3.24755</c:v>
                </c:pt>
                <c:pt idx="663">
                  <c:v>4.617069999999995</c:v>
                </c:pt>
                <c:pt idx="664">
                  <c:v>4.02006</c:v>
                </c:pt>
                <c:pt idx="665">
                  <c:v>4.91158</c:v>
                </c:pt>
                <c:pt idx="666">
                  <c:v>5.762589999999966</c:v>
                </c:pt>
                <c:pt idx="667">
                  <c:v>7.03911</c:v>
                </c:pt>
                <c:pt idx="668">
                  <c:v>3.95756</c:v>
                </c:pt>
                <c:pt idx="669">
                  <c:v>3.513059999999999</c:v>
                </c:pt>
                <c:pt idx="670">
                  <c:v>10.4812</c:v>
                </c:pt>
                <c:pt idx="671">
                  <c:v>4.77608</c:v>
                </c:pt>
                <c:pt idx="672">
                  <c:v>2.55354</c:v>
                </c:pt>
                <c:pt idx="673">
                  <c:v>4.363569999999997</c:v>
                </c:pt>
                <c:pt idx="674">
                  <c:v>2.28704</c:v>
                </c:pt>
                <c:pt idx="675">
                  <c:v>4.05807</c:v>
                </c:pt>
                <c:pt idx="676">
                  <c:v>2.77204</c:v>
                </c:pt>
                <c:pt idx="677">
                  <c:v>4.721579999999998</c:v>
                </c:pt>
                <c:pt idx="678">
                  <c:v>1.65303</c:v>
                </c:pt>
                <c:pt idx="679">
                  <c:v>3.70556</c:v>
                </c:pt>
                <c:pt idx="680">
                  <c:v>4.354069999999996</c:v>
                </c:pt>
                <c:pt idx="681">
                  <c:v>1.95953</c:v>
                </c:pt>
                <c:pt idx="682">
                  <c:v>5.452589999999994</c:v>
                </c:pt>
                <c:pt idx="683">
                  <c:v>4.31607</c:v>
                </c:pt>
                <c:pt idx="684">
                  <c:v>5.37659</c:v>
                </c:pt>
                <c:pt idx="685">
                  <c:v>3.497059999999998</c:v>
                </c:pt>
                <c:pt idx="686">
                  <c:v>4.08207</c:v>
                </c:pt>
                <c:pt idx="687">
                  <c:v>1.62503</c:v>
                </c:pt>
                <c:pt idx="688">
                  <c:v>1.82703</c:v>
                </c:pt>
                <c:pt idx="689">
                  <c:v>4.698079999999995</c:v>
                </c:pt>
                <c:pt idx="690">
                  <c:v>5.190079999999996</c:v>
                </c:pt>
                <c:pt idx="691">
                  <c:v>1.92953</c:v>
                </c:pt>
                <c:pt idx="692">
                  <c:v>3.978559999999999</c:v>
                </c:pt>
                <c:pt idx="693">
                  <c:v>3.17855</c:v>
                </c:pt>
                <c:pt idx="694">
                  <c:v>5.620589999999937</c:v>
                </c:pt>
                <c:pt idx="695">
                  <c:v>2.55104</c:v>
                </c:pt>
                <c:pt idx="696">
                  <c:v>5.361589999999984</c:v>
                </c:pt>
                <c:pt idx="697">
                  <c:v>3.397549999999998</c:v>
                </c:pt>
                <c:pt idx="698">
                  <c:v>4.71908</c:v>
                </c:pt>
                <c:pt idx="699">
                  <c:v>4.90808</c:v>
                </c:pt>
                <c:pt idx="700">
                  <c:v>4.397069999999998</c:v>
                </c:pt>
                <c:pt idx="701">
                  <c:v>3.950559999999998</c:v>
                </c:pt>
                <c:pt idx="702">
                  <c:v>4.07257</c:v>
                </c:pt>
                <c:pt idx="703">
                  <c:v>6.4176</c:v>
                </c:pt>
                <c:pt idx="704">
                  <c:v>3.03755</c:v>
                </c:pt>
                <c:pt idx="705">
                  <c:v>5.864589999999931</c:v>
                </c:pt>
                <c:pt idx="706">
                  <c:v>3.542559999999999</c:v>
                </c:pt>
                <c:pt idx="707">
                  <c:v>4.664569999999966</c:v>
                </c:pt>
                <c:pt idx="708">
                  <c:v>6.1416</c:v>
                </c:pt>
                <c:pt idx="709">
                  <c:v>1.87353</c:v>
                </c:pt>
                <c:pt idx="710">
                  <c:v>4.594069999999999</c:v>
                </c:pt>
                <c:pt idx="711">
                  <c:v>10.3342</c:v>
                </c:pt>
                <c:pt idx="712">
                  <c:v>7.222119999999975</c:v>
                </c:pt>
                <c:pt idx="713">
                  <c:v>7.41362</c:v>
                </c:pt>
                <c:pt idx="714">
                  <c:v>2.71804</c:v>
                </c:pt>
                <c:pt idx="715">
                  <c:v>7.702119999999994</c:v>
                </c:pt>
                <c:pt idx="716">
                  <c:v>3.64506</c:v>
                </c:pt>
                <c:pt idx="717">
                  <c:v>6.59911</c:v>
                </c:pt>
                <c:pt idx="718">
                  <c:v>9.83966</c:v>
                </c:pt>
                <c:pt idx="719">
                  <c:v>6.59961</c:v>
                </c:pt>
                <c:pt idx="720">
                  <c:v>4.45557</c:v>
                </c:pt>
                <c:pt idx="721">
                  <c:v>7.160109999999984</c:v>
                </c:pt>
                <c:pt idx="722">
                  <c:v>4.20657</c:v>
                </c:pt>
                <c:pt idx="723">
                  <c:v>6.744109999999996</c:v>
                </c:pt>
                <c:pt idx="724">
                  <c:v>3.14255</c:v>
                </c:pt>
                <c:pt idx="725">
                  <c:v>7.20462</c:v>
                </c:pt>
                <c:pt idx="726">
                  <c:v>6.98961</c:v>
                </c:pt>
                <c:pt idx="727">
                  <c:v>1.59653</c:v>
                </c:pt>
                <c:pt idx="728">
                  <c:v>1.51952</c:v>
                </c:pt>
                <c:pt idx="729">
                  <c:v>5.632589999999975</c:v>
                </c:pt>
                <c:pt idx="730">
                  <c:v>3.170049999999998</c:v>
                </c:pt>
                <c:pt idx="731">
                  <c:v>5.9501</c:v>
                </c:pt>
                <c:pt idx="732">
                  <c:v>4.614569999999976</c:v>
                </c:pt>
                <c:pt idx="733">
                  <c:v>2.81705</c:v>
                </c:pt>
                <c:pt idx="734">
                  <c:v>6.1096</c:v>
                </c:pt>
                <c:pt idx="735">
                  <c:v>3.98356</c:v>
                </c:pt>
                <c:pt idx="736">
                  <c:v>4.727579999999977</c:v>
                </c:pt>
                <c:pt idx="737">
                  <c:v>2.93555</c:v>
                </c:pt>
                <c:pt idx="738">
                  <c:v>2.70854</c:v>
                </c:pt>
                <c:pt idx="739">
                  <c:v>2.14953</c:v>
                </c:pt>
                <c:pt idx="740">
                  <c:v>3.252549999999998</c:v>
                </c:pt>
                <c:pt idx="741">
                  <c:v>2.38554</c:v>
                </c:pt>
                <c:pt idx="742">
                  <c:v>4.677579999999986</c:v>
                </c:pt>
                <c:pt idx="743">
                  <c:v>2.05653</c:v>
                </c:pt>
                <c:pt idx="744">
                  <c:v>1.93553</c:v>
                </c:pt>
                <c:pt idx="745">
                  <c:v>4.100569999999998</c:v>
                </c:pt>
                <c:pt idx="746">
                  <c:v>4.63807</c:v>
                </c:pt>
                <c:pt idx="747">
                  <c:v>5.323589999999966</c:v>
                </c:pt>
                <c:pt idx="748">
                  <c:v>3.791059999999998</c:v>
                </c:pt>
                <c:pt idx="749">
                  <c:v>7.46112</c:v>
                </c:pt>
                <c:pt idx="750">
                  <c:v>4.843579999999998</c:v>
                </c:pt>
                <c:pt idx="751">
                  <c:v>4.42807</c:v>
                </c:pt>
                <c:pt idx="752">
                  <c:v>9.329650000000002</c:v>
                </c:pt>
                <c:pt idx="753">
                  <c:v>2.59104</c:v>
                </c:pt>
                <c:pt idx="754">
                  <c:v>6.121599999999995</c:v>
                </c:pt>
                <c:pt idx="755">
                  <c:v>2.80955</c:v>
                </c:pt>
                <c:pt idx="756">
                  <c:v>3.000049999999999</c:v>
                </c:pt>
                <c:pt idx="757">
                  <c:v>8.09663</c:v>
                </c:pt>
                <c:pt idx="758">
                  <c:v>2.47554</c:v>
                </c:pt>
                <c:pt idx="759">
                  <c:v>6.2476</c:v>
                </c:pt>
                <c:pt idx="760">
                  <c:v>3.34655</c:v>
                </c:pt>
                <c:pt idx="761">
                  <c:v>5.350589999999975</c:v>
                </c:pt>
                <c:pt idx="762">
                  <c:v>2.56804</c:v>
                </c:pt>
                <c:pt idx="763">
                  <c:v>4.33057</c:v>
                </c:pt>
                <c:pt idx="764">
                  <c:v>6.0086</c:v>
                </c:pt>
                <c:pt idx="765">
                  <c:v>5.167079999999975</c:v>
                </c:pt>
                <c:pt idx="766">
                  <c:v>2.78304</c:v>
                </c:pt>
                <c:pt idx="767">
                  <c:v>2.52854</c:v>
                </c:pt>
                <c:pt idx="768">
                  <c:v>9.94716</c:v>
                </c:pt>
                <c:pt idx="769">
                  <c:v>5.163079999999995</c:v>
                </c:pt>
                <c:pt idx="770">
                  <c:v>5.675589999999984</c:v>
                </c:pt>
                <c:pt idx="771">
                  <c:v>6.68861</c:v>
                </c:pt>
                <c:pt idx="772">
                  <c:v>6.964109999999986</c:v>
                </c:pt>
                <c:pt idx="773">
                  <c:v>7.63612</c:v>
                </c:pt>
                <c:pt idx="774">
                  <c:v>6.89961</c:v>
                </c:pt>
                <c:pt idx="775">
                  <c:v>4.997079999999999</c:v>
                </c:pt>
                <c:pt idx="776">
                  <c:v>3.424049999999998</c:v>
                </c:pt>
                <c:pt idx="777">
                  <c:v>3.46356</c:v>
                </c:pt>
                <c:pt idx="778">
                  <c:v>2.44754</c:v>
                </c:pt>
                <c:pt idx="779">
                  <c:v>4.24607</c:v>
                </c:pt>
                <c:pt idx="780">
                  <c:v>6.3991</c:v>
                </c:pt>
                <c:pt idx="781">
                  <c:v>3.828059999999998</c:v>
                </c:pt>
                <c:pt idx="782">
                  <c:v>3.25705</c:v>
                </c:pt>
                <c:pt idx="783">
                  <c:v>3.76106</c:v>
                </c:pt>
                <c:pt idx="784">
                  <c:v>5.74359</c:v>
                </c:pt>
                <c:pt idx="785">
                  <c:v>5.228579999999996</c:v>
                </c:pt>
                <c:pt idx="786">
                  <c:v>6.054099999999996</c:v>
                </c:pt>
                <c:pt idx="787">
                  <c:v>4.58007</c:v>
                </c:pt>
                <c:pt idx="788">
                  <c:v>6.4296</c:v>
                </c:pt>
                <c:pt idx="789">
                  <c:v>5.540589999999995</c:v>
                </c:pt>
                <c:pt idx="790">
                  <c:v>1.59603</c:v>
                </c:pt>
                <c:pt idx="791">
                  <c:v>7.42262</c:v>
                </c:pt>
                <c:pt idx="792">
                  <c:v>4.104069999999997</c:v>
                </c:pt>
                <c:pt idx="793">
                  <c:v>4.65107</c:v>
                </c:pt>
                <c:pt idx="794">
                  <c:v>4.18357</c:v>
                </c:pt>
                <c:pt idx="795">
                  <c:v>1.92053</c:v>
                </c:pt>
                <c:pt idx="796">
                  <c:v>5.674589999999966</c:v>
                </c:pt>
                <c:pt idx="797">
                  <c:v>6.613609999999999</c:v>
                </c:pt>
                <c:pt idx="798">
                  <c:v>1.69553</c:v>
                </c:pt>
                <c:pt idx="799">
                  <c:v>4.28607</c:v>
                </c:pt>
                <c:pt idx="800">
                  <c:v>6.368099999999996</c:v>
                </c:pt>
                <c:pt idx="801">
                  <c:v>3.052049999999956</c:v>
                </c:pt>
                <c:pt idx="802">
                  <c:v>2.89855</c:v>
                </c:pt>
                <c:pt idx="803">
                  <c:v>9.282150000000001</c:v>
                </c:pt>
                <c:pt idx="804">
                  <c:v>3.472059999999952</c:v>
                </c:pt>
                <c:pt idx="805">
                  <c:v>3.48956</c:v>
                </c:pt>
                <c:pt idx="806">
                  <c:v>5.87009</c:v>
                </c:pt>
                <c:pt idx="807">
                  <c:v>3.79556</c:v>
                </c:pt>
                <c:pt idx="808">
                  <c:v>7.396119999999994</c:v>
                </c:pt>
                <c:pt idx="809">
                  <c:v>4.20957</c:v>
                </c:pt>
                <c:pt idx="810">
                  <c:v>5.21658</c:v>
                </c:pt>
                <c:pt idx="811">
                  <c:v>8.26263</c:v>
                </c:pt>
                <c:pt idx="812">
                  <c:v>5.23858</c:v>
                </c:pt>
                <c:pt idx="813">
                  <c:v>3.430559999999998</c:v>
                </c:pt>
                <c:pt idx="814">
                  <c:v>2.362039999999999</c:v>
                </c:pt>
                <c:pt idx="815">
                  <c:v>3.489059999999998</c:v>
                </c:pt>
                <c:pt idx="816">
                  <c:v>11.8207</c:v>
                </c:pt>
                <c:pt idx="817">
                  <c:v>2.95655</c:v>
                </c:pt>
                <c:pt idx="818">
                  <c:v>0.904515</c:v>
                </c:pt>
                <c:pt idx="819">
                  <c:v>2.21554</c:v>
                </c:pt>
                <c:pt idx="820">
                  <c:v>5.33959</c:v>
                </c:pt>
                <c:pt idx="821">
                  <c:v>1.33602</c:v>
                </c:pt>
                <c:pt idx="822">
                  <c:v>3.39155</c:v>
                </c:pt>
                <c:pt idx="823">
                  <c:v>4.98008</c:v>
                </c:pt>
                <c:pt idx="824">
                  <c:v>1.70103</c:v>
                </c:pt>
                <c:pt idx="825">
                  <c:v>2.03753</c:v>
                </c:pt>
                <c:pt idx="826">
                  <c:v>4.04306</c:v>
                </c:pt>
                <c:pt idx="827">
                  <c:v>2.50854</c:v>
                </c:pt>
                <c:pt idx="828">
                  <c:v>5.641589999999994</c:v>
                </c:pt>
                <c:pt idx="829">
                  <c:v>7.085109999999998</c:v>
                </c:pt>
                <c:pt idx="830">
                  <c:v>3.481059999999998</c:v>
                </c:pt>
                <c:pt idx="831">
                  <c:v>2.15653</c:v>
                </c:pt>
                <c:pt idx="832">
                  <c:v>3.14855</c:v>
                </c:pt>
                <c:pt idx="833">
                  <c:v>5.225079999999997</c:v>
                </c:pt>
                <c:pt idx="834">
                  <c:v>3.590059999999998</c:v>
                </c:pt>
                <c:pt idx="835">
                  <c:v>2.75704</c:v>
                </c:pt>
                <c:pt idx="836">
                  <c:v>3.73856</c:v>
                </c:pt>
                <c:pt idx="837">
                  <c:v>2.16103</c:v>
                </c:pt>
                <c:pt idx="838">
                  <c:v>1.14702</c:v>
                </c:pt>
                <c:pt idx="839">
                  <c:v>2.52004</c:v>
                </c:pt>
                <c:pt idx="840">
                  <c:v>7.03311</c:v>
                </c:pt>
                <c:pt idx="841">
                  <c:v>6.822609999999996</c:v>
                </c:pt>
                <c:pt idx="842">
                  <c:v>3.19505</c:v>
                </c:pt>
                <c:pt idx="843">
                  <c:v>3.870559999999998</c:v>
                </c:pt>
                <c:pt idx="844">
                  <c:v>3.75706</c:v>
                </c:pt>
                <c:pt idx="845">
                  <c:v>1.29452</c:v>
                </c:pt>
                <c:pt idx="846">
                  <c:v>1.80853</c:v>
                </c:pt>
                <c:pt idx="847">
                  <c:v>3.879059999999952</c:v>
                </c:pt>
                <c:pt idx="848">
                  <c:v>1.77103</c:v>
                </c:pt>
                <c:pt idx="849">
                  <c:v>3.356049999999952</c:v>
                </c:pt>
                <c:pt idx="850">
                  <c:v>2.12303</c:v>
                </c:pt>
                <c:pt idx="851">
                  <c:v>1.11702</c:v>
                </c:pt>
                <c:pt idx="852">
                  <c:v>0.858514</c:v>
                </c:pt>
                <c:pt idx="853">
                  <c:v>0.899514</c:v>
                </c:pt>
                <c:pt idx="854">
                  <c:v>0.498008</c:v>
                </c:pt>
                <c:pt idx="855">
                  <c:v>1.29402</c:v>
                </c:pt>
                <c:pt idx="856">
                  <c:v>1.40602</c:v>
                </c:pt>
                <c:pt idx="857">
                  <c:v>2.68804</c:v>
                </c:pt>
                <c:pt idx="858">
                  <c:v>3.58756</c:v>
                </c:pt>
                <c:pt idx="859">
                  <c:v>7.02661</c:v>
                </c:pt>
                <c:pt idx="860">
                  <c:v>4.22657</c:v>
                </c:pt>
                <c:pt idx="861">
                  <c:v>4.70208</c:v>
                </c:pt>
                <c:pt idx="862">
                  <c:v>1.59253</c:v>
                </c:pt>
                <c:pt idx="863">
                  <c:v>3.77806</c:v>
                </c:pt>
                <c:pt idx="864">
                  <c:v>3.64256</c:v>
                </c:pt>
                <c:pt idx="865">
                  <c:v>2.824549999999999</c:v>
                </c:pt>
                <c:pt idx="866">
                  <c:v>2.20254</c:v>
                </c:pt>
                <c:pt idx="867">
                  <c:v>6.198599999999995</c:v>
                </c:pt>
                <c:pt idx="868">
                  <c:v>2.07753</c:v>
                </c:pt>
                <c:pt idx="869">
                  <c:v>1.75703</c:v>
                </c:pt>
                <c:pt idx="870">
                  <c:v>2.436039999999998</c:v>
                </c:pt>
                <c:pt idx="871">
                  <c:v>6.157099999999986</c:v>
                </c:pt>
                <c:pt idx="872">
                  <c:v>3.67056</c:v>
                </c:pt>
                <c:pt idx="873">
                  <c:v>4.27707</c:v>
                </c:pt>
                <c:pt idx="874">
                  <c:v>1.10052</c:v>
                </c:pt>
                <c:pt idx="875">
                  <c:v>3.86756</c:v>
                </c:pt>
                <c:pt idx="876">
                  <c:v>6.890109999999995</c:v>
                </c:pt>
                <c:pt idx="877">
                  <c:v>3.32355</c:v>
                </c:pt>
                <c:pt idx="878">
                  <c:v>3.72356</c:v>
                </c:pt>
                <c:pt idx="879">
                  <c:v>4.228569999999999</c:v>
                </c:pt>
                <c:pt idx="880">
                  <c:v>6.64061</c:v>
                </c:pt>
                <c:pt idx="881">
                  <c:v>2.17253</c:v>
                </c:pt>
                <c:pt idx="882">
                  <c:v>4.29057</c:v>
                </c:pt>
                <c:pt idx="883">
                  <c:v>5.254579999999986</c:v>
                </c:pt>
                <c:pt idx="884">
                  <c:v>3.90706</c:v>
                </c:pt>
                <c:pt idx="885">
                  <c:v>7.45812</c:v>
                </c:pt>
                <c:pt idx="886">
                  <c:v>4.42507</c:v>
                </c:pt>
                <c:pt idx="887">
                  <c:v>3.38105</c:v>
                </c:pt>
                <c:pt idx="888">
                  <c:v>1.27702</c:v>
                </c:pt>
                <c:pt idx="889">
                  <c:v>1.10702</c:v>
                </c:pt>
                <c:pt idx="890">
                  <c:v>6.2746</c:v>
                </c:pt>
                <c:pt idx="891">
                  <c:v>3.126549999999999</c:v>
                </c:pt>
                <c:pt idx="892">
                  <c:v>3.09655</c:v>
                </c:pt>
                <c:pt idx="893">
                  <c:v>3.79706</c:v>
                </c:pt>
                <c:pt idx="894">
                  <c:v>2.32154</c:v>
                </c:pt>
                <c:pt idx="895">
                  <c:v>2.09553</c:v>
                </c:pt>
                <c:pt idx="896">
                  <c:v>2.73654</c:v>
                </c:pt>
                <c:pt idx="897">
                  <c:v>2.955049999999956</c:v>
                </c:pt>
                <c:pt idx="898">
                  <c:v>1.86653</c:v>
                </c:pt>
                <c:pt idx="899">
                  <c:v>2.34654</c:v>
                </c:pt>
                <c:pt idx="900">
                  <c:v>3.448059999999999</c:v>
                </c:pt>
                <c:pt idx="901">
                  <c:v>2.20054</c:v>
                </c:pt>
                <c:pt idx="902">
                  <c:v>1.52002</c:v>
                </c:pt>
                <c:pt idx="903">
                  <c:v>0.759512</c:v>
                </c:pt>
                <c:pt idx="904">
                  <c:v>2.38004</c:v>
                </c:pt>
                <c:pt idx="905">
                  <c:v>2.34454</c:v>
                </c:pt>
                <c:pt idx="906">
                  <c:v>1.51452</c:v>
                </c:pt>
                <c:pt idx="907">
                  <c:v>1.13602</c:v>
                </c:pt>
                <c:pt idx="908">
                  <c:v>0.835513</c:v>
                </c:pt>
                <c:pt idx="909">
                  <c:v>0.921015</c:v>
                </c:pt>
                <c:pt idx="910">
                  <c:v>1.45552</c:v>
                </c:pt>
                <c:pt idx="911">
                  <c:v>2.45854</c:v>
                </c:pt>
                <c:pt idx="912">
                  <c:v>0.62001</c:v>
                </c:pt>
                <c:pt idx="913">
                  <c:v>0.845014</c:v>
                </c:pt>
                <c:pt idx="914">
                  <c:v>1.19952</c:v>
                </c:pt>
                <c:pt idx="915">
                  <c:v>1.69753</c:v>
                </c:pt>
                <c:pt idx="916">
                  <c:v>1.20502</c:v>
                </c:pt>
                <c:pt idx="917">
                  <c:v>2.63554</c:v>
                </c:pt>
                <c:pt idx="918">
                  <c:v>3.17455</c:v>
                </c:pt>
                <c:pt idx="919">
                  <c:v>1.14652</c:v>
                </c:pt>
                <c:pt idx="920">
                  <c:v>2.70204</c:v>
                </c:pt>
                <c:pt idx="921">
                  <c:v>5.87109</c:v>
                </c:pt>
                <c:pt idx="922">
                  <c:v>1.46252</c:v>
                </c:pt>
                <c:pt idx="923">
                  <c:v>1.54702</c:v>
                </c:pt>
                <c:pt idx="924">
                  <c:v>1.42052</c:v>
                </c:pt>
                <c:pt idx="925">
                  <c:v>1.79853</c:v>
                </c:pt>
                <c:pt idx="926">
                  <c:v>2.25404</c:v>
                </c:pt>
                <c:pt idx="927">
                  <c:v>1.01452</c:v>
                </c:pt>
                <c:pt idx="928">
                  <c:v>2.25054</c:v>
                </c:pt>
                <c:pt idx="929">
                  <c:v>1.57353</c:v>
                </c:pt>
                <c:pt idx="930">
                  <c:v>3.271049999999998</c:v>
                </c:pt>
                <c:pt idx="931">
                  <c:v>1.20702</c:v>
                </c:pt>
                <c:pt idx="932">
                  <c:v>1.78603</c:v>
                </c:pt>
                <c:pt idx="933">
                  <c:v>2.21004</c:v>
                </c:pt>
                <c:pt idx="934">
                  <c:v>2.16303</c:v>
                </c:pt>
                <c:pt idx="935">
                  <c:v>1.76253</c:v>
                </c:pt>
                <c:pt idx="936">
                  <c:v>4.01156</c:v>
                </c:pt>
                <c:pt idx="937">
                  <c:v>1.10102</c:v>
                </c:pt>
                <c:pt idx="938">
                  <c:v>2.411039999999998</c:v>
                </c:pt>
                <c:pt idx="939">
                  <c:v>3.62456</c:v>
                </c:pt>
                <c:pt idx="940">
                  <c:v>1.82403</c:v>
                </c:pt>
                <c:pt idx="941">
                  <c:v>1.01502</c:v>
                </c:pt>
                <c:pt idx="942">
                  <c:v>4.06807</c:v>
                </c:pt>
                <c:pt idx="943">
                  <c:v>3.34655</c:v>
                </c:pt>
                <c:pt idx="944">
                  <c:v>6.2516</c:v>
                </c:pt>
                <c:pt idx="945">
                  <c:v>2.14853</c:v>
                </c:pt>
                <c:pt idx="946">
                  <c:v>3.48606</c:v>
                </c:pt>
                <c:pt idx="947">
                  <c:v>4.00506</c:v>
                </c:pt>
                <c:pt idx="948">
                  <c:v>5.27658</c:v>
                </c:pt>
                <c:pt idx="949">
                  <c:v>3.11605</c:v>
                </c:pt>
                <c:pt idx="950">
                  <c:v>2.41854</c:v>
                </c:pt>
                <c:pt idx="951">
                  <c:v>2.22554</c:v>
                </c:pt>
                <c:pt idx="952">
                  <c:v>3.60806</c:v>
                </c:pt>
                <c:pt idx="953">
                  <c:v>3.24455</c:v>
                </c:pt>
                <c:pt idx="954">
                  <c:v>4.96308</c:v>
                </c:pt>
                <c:pt idx="955">
                  <c:v>3.045049999999998</c:v>
                </c:pt>
                <c:pt idx="956">
                  <c:v>2.76654</c:v>
                </c:pt>
                <c:pt idx="957">
                  <c:v>1.90203</c:v>
                </c:pt>
                <c:pt idx="958">
                  <c:v>7.50912</c:v>
                </c:pt>
                <c:pt idx="959">
                  <c:v>4.90308</c:v>
                </c:pt>
                <c:pt idx="960">
                  <c:v>4.163569999999996</c:v>
                </c:pt>
                <c:pt idx="961">
                  <c:v>8.50214</c:v>
                </c:pt>
                <c:pt idx="962">
                  <c:v>5.224079999999986</c:v>
                </c:pt>
                <c:pt idx="963">
                  <c:v>3.872059999999952</c:v>
                </c:pt>
                <c:pt idx="964">
                  <c:v>5.09308</c:v>
                </c:pt>
                <c:pt idx="965">
                  <c:v>1.63553</c:v>
                </c:pt>
                <c:pt idx="966">
                  <c:v>4.645569999999997</c:v>
                </c:pt>
                <c:pt idx="967">
                  <c:v>4.98158</c:v>
                </c:pt>
                <c:pt idx="968">
                  <c:v>5.312589999999965</c:v>
                </c:pt>
                <c:pt idx="969">
                  <c:v>4.813079999999998</c:v>
                </c:pt>
                <c:pt idx="970">
                  <c:v>6.2916</c:v>
                </c:pt>
                <c:pt idx="971">
                  <c:v>4.46007</c:v>
                </c:pt>
                <c:pt idx="972">
                  <c:v>4.31007</c:v>
                </c:pt>
                <c:pt idx="973">
                  <c:v>3.22055</c:v>
                </c:pt>
                <c:pt idx="974">
                  <c:v>2.52004</c:v>
                </c:pt>
                <c:pt idx="975">
                  <c:v>2.38254</c:v>
                </c:pt>
                <c:pt idx="976">
                  <c:v>1.69753</c:v>
                </c:pt>
                <c:pt idx="977">
                  <c:v>1.98653</c:v>
                </c:pt>
                <c:pt idx="978">
                  <c:v>4.00206</c:v>
                </c:pt>
                <c:pt idx="979">
                  <c:v>7.60962</c:v>
                </c:pt>
                <c:pt idx="980">
                  <c:v>3.72256</c:v>
                </c:pt>
                <c:pt idx="981">
                  <c:v>2.31354</c:v>
                </c:pt>
                <c:pt idx="982">
                  <c:v>2.40754</c:v>
                </c:pt>
                <c:pt idx="983">
                  <c:v>3.36905</c:v>
                </c:pt>
                <c:pt idx="984">
                  <c:v>4.625569999999985</c:v>
                </c:pt>
                <c:pt idx="985">
                  <c:v>5.91059</c:v>
                </c:pt>
                <c:pt idx="986">
                  <c:v>8.36013</c:v>
                </c:pt>
                <c:pt idx="987">
                  <c:v>4.37557</c:v>
                </c:pt>
                <c:pt idx="988">
                  <c:v>3.254049999999999</c:v>
                </c:pt>
                <c:pt idx="989">
                  <c:v>5.355089999999985</c:v>
                </c:pt>
                <c:pt idx="990">
                  <c:v>8.09263</c:v>
                </c:pt>
                <c:pt idx="991">
                  <c:v>6.79661</c:v>
                </c:pt>
                <c:pt idx="992">
                  <c:v>10.7797</c:v>
                </c:pt>
                <c:pt idx="993">
                  <c:v>8.447140000000001</c:v>
                </c:pt>
                <c:pt idx="994">
                  <c:v>4.58207</c:v>
                </c:pt>
                <c:pt idx="995">
                  <c:v>4.24657</c:v>
                </c:pt>
                <c:pt idx="996">
                  <c:v>8.26663</c:v>
                </c:pt>
                <c:pt idx="997">
                  <c:v>7.13061</c:v>
                </c:pt>
                <c:pt idx="998">
                  <c:v>6.0406</c:v>
                </c:pt>
                <c:pt idx="999">
                  <c:v>3.298049999999999</c:v>
                </c:pt>
                <c:pt idx="1000">
                  <c:v>9.443650000000003</c:v>
                </c:pt>
                <c:pt idx="1001">
                  <c:v>6.826109999999995</c:v>
                </c:pt>
                <c:pt idx="1002">
                  <c:v>5.062579999999985</c:v>
                </c:pt>
                <c:pt idx="1003">
                  <c:v>5.362089999999966</c:v>
                </c:pt>
                <c:pt idx="1004">
                  <c:v>10.1797</c:v>
                </c:pt>
                <c:pt idx="1005">
                  <c:v>3.756559999999998</c:v>
                </c:pt>
                <c:pt idx="1006">
                  <c:v>4.36607</c:v>
                </c:pt>
                <c:pt idx="1007">
                  <c:v>7.829129999999997</c:v>
                </c:pt>
                <c:pt idx="1008">
                  <c:v>3.79306</c:v>
                </c:pt>
                <c:pt idx="1009">
                  <c:v>11.4762</c:v>
                </c:pt>
                <c:pt idx="1010">
                  <c:v>7.88063</c:v>
                </c:pt>
                <c:pt idx="1011">
                  <c:v>5.106579999999997</c:v>
                </c:pt>
                <c:pt idx="1012">
                  <c:v>3.78856</c:v>
                </c:pt>
                <c:pt idx="1013">
                  <c:v>6.1066</c:v>
                </c:pt>
                <c:pt idx="1014">
                  <c:v>5.052079999999997</c:v>
                </c:pt>
                <c:pt idx="1015">
                  <c:v>7.662619999999975</c:v>
                </c:pt>
                <c:pt idx="1016">
                  <c:v>2.50654</c:v>
                </c:pt>
                <c:pt idx="1017">
                  <c:v>5.20908</c:v>
                </c:pt>
                <c:pt idx="1018">
                  <c:v>6.4501</c:v>
                </c:pt>
                <c:pt idx="1019">
                  <c:v>12.3237</c:v>
                </c:pt>
                <c:pt idx="1020">
                  <c:v>4.40857</c:v>
                </c:pt>
                <c:pt idx="1021">
                  <c:v>6.358099999999998</c:v>
                </c:pt>
                <c:pt idx="1022">
                  <c:v>7.23562</c:v>
                </c:pt>
                <c:pt idx="1023">
                  <c:v>4.628069999999996</c:v>
                </c:pt>
                <c:pt idx="1024">
                  <c:v>5.25958</c:v>
                </c:pt>
                <c:pt idx="1025">
                  <c:v>5.03108</c:v>
                </c:pt>
                <c:pt idx="1026">
                  <c:v>5.173579999999998</c:v>
                </c:pt>
                <c:pt idx="1027">
                  <c:v>6.600109999999995</c:v>
                </c:pt>
                <c:pt idx="1028">
                  <c:v>6.527099999999995</c:v>
                </c:pt>
                <c:pt idx="1029">
                  <c:v>8.506640000000002</c:v>
                </c:pt>
                <c:pt idx="1030">
                  <c:v>4.60607</c:v>
                </c:pt>
                <c:pt idx="1031">
                  <c:v>6.3796</c:v>
                </c:pt>
                <c:pt idx="1032">
                  <c:v>7.37062</c:v>
                </c:pt>
                <c:pt idx="1033">
                  <c:v>7.33962</c:v>
                </c:pt>
                <c:pt idx="1034">
                  <c:v>7.68912</c:v>
                </c:pt>
                <c:pt idx="1035">
                  <c:v>6.5066</c:v>
                </c:pt>
                <c:pt idx="1036">
                  <c:v>4.904579999999997</c:v>
                </c:pt>
                <c:pt idx="1037">
                  <c:v>6.4831</c:v>
                </c:pt>
                <c:pt idx="1038">
                  <c:v>9.76566</c:v>
                </c:pt>
                <c:pt idx="1039">
                  <c:v>6.0346</c:v>
                </c:pt>
                <c:pt idx="1040">
                  <c:v>9.456150000000002</c:v>
                </c:pt>
                <c:pt idx="1041">
                  <c:v>9.907160000000001</c:v>
                </c:pt>
                <c:pt idx="1042">
                  <c:v>13.2082</c:v>
                </c:pt>
                <c:pt idx="1043">
                  <c:v>4.03506</c:v>
                </c:pt>
                <c:pt idx="1044">
                  <c:v>3.72056</c:v>
                </c:pt>
                <c:pt idx="1045">
                  <c:v>4.19907</c:v>
                </c:pt>
                <c:pt idx="1046">
                  <c:v>11.5542</c:v>
                </c:pt>
                <c:pt idx="1047">
                  <c:v>9.924160000000001</c:v>
                </c:pt>
                <c:pt idx="1048">
                  <c:v>4.50653</c:v>
                </c:pt>
                <c:pt idx="1049">
                  <c:v>5.9421</c:v>
                </c:pt>
                <c:pt idx="1050">
                  <c:v>4.47007</c:v>
                </c:pt>
                <c:pt idx="1051">
                  <c:v>8.10413</c:v>
                </c:pt>
                <c:pt idx="1052">
                  <c:v>7.653119999999975</c:v>
                </c:pt>
                <c:pt idx="1053">
                  <c:v>5.694589999999933</c:v>
                </c:pt>
                <c:pt idx="1054">
                  <c:v>8.38763</c:v>
                </c:pt>
                <c:pt idx="1055">
                  <c:v>3.95256</c:v>
                </c:pt>
                <c:pt idx="1056">
                  <c:v>3.97006</c:v>
                </c:pt>
                <c:pt idx="1057">
                  <c:v>10.7522</c:v>
                </c:pt>
                <c:pt idx="1058">
                  <c:v>10.0902</c:v>
                </c:pt>
                <c:pt idx="1059">
                  <c:v>10.0447</c:v>
                </c:pt>
                <c:pt idx="1060">
                  <c:v>4.90608</c:v>
                </c:pt>
                <c:pt idx="1061">
                  <c:v>4.897079999999986</c:v>
                </c:pt>
                <c:pt idx="1062">
                  <c:v>8.17463</c:v>
                </c:pt>
                <c:pt idx="1063">
                  <c:v>8.895140000000004</c:v>
                </c:pt>
                <c:pt idx="1064">
                  <c:v>4.752079999999998</c:v>
                </c:pt>
                <c:pt idx="1065">
                  <c:v>3.46706</c:v>
                </c:pt>
                <c:pt idx="1066">
                  <c:v>4.63607</c:v>
                </c:pt>
                <c:pt idx="1067">
                  <c:v>4.39157</c:v>
                </c:pt>
                <c:pt idx="1068">
                  <c:v>7.28912</c:v>
                </c:pt>
                <c:pt idx="1069">
                  <c:v>7.42262</c:v>
                </c:pt>
                <c:pt idx="1070">
                  <c:v>7.76562</c:v>
                </c:pt>
                <c:pt idx="1071">
                  <c:v>6.766109999999998</c:v>
                </c:pt>
                <c:pt idx="1072">
                  <c:v>6.1781</c:v>
                </c:pt>
                <c:pt idx="1073">
                  <c:v>7.125109999999975</c:v>
                </c:pt>
                <c:pt idx="1074">
                  <c:v>8.02013</c:v>
                </c:pt>
                <c:pt idx="1075">
                  <c:v>3.23105</c:v>
                </c:pt>
                <c:pt idx="1076">
                  <c:v>6.1736</c:v>
                </c:pt>
                <c:pt idx="1077">
                  <c:v>3.202049999999998</c:v>
                </c:pt>
                <c:pt idx="1078">
                  <c:v>6.3216</c:v>
                </c:pt>
                <c:pt idx="1079">
                  <c:v>4.844579999999985</c:v>
                </c:pt>
                <c:pt idx="1080">
                  <c:v>7.394119999999964</c:v>
                </c:pt>
                <c:pt idx="1081">
                  <c:v>4.17507</c:v>
                </c:pt>
                <c:pt idx="1082">
                  <c:v>4.43657</c:v>
                </c:pt>
                <c:pt idx="1083">
                  <c:v>7.922129999999997</c:v>
                </c:pt>
                <c:pt idx="1084">
                  <c:v>9.35265</c:v>
                </c:pt>
                <c:pt idx="1085">
                  <c:v>6.065599999999995</c:v>
                </c:pt>
                <c:pt idx="1086">
                  <c:v>10.3257</c:v>
                </c:pt>
                <c:pt idx="1087">
                  <c:v>6.74461</c:v>
                </c:pt>
                <c:pt idx="1088">
                  <c:v>5.43909</c:v>
                </c:pt>
                <c:pt idx="1089">
                  <c:v>3.22455</c:v>
                </c:pt>
                <c:pt idx="1090">
                  <c:v>5.24058</c:v>
                </c:pt>
                <c:pt idx="1091">
                  <c:v>3.036049999999952</c:v>
                </c:pt>
                <c:pt idx="1092">
                  <c:v>5.73859</c:v>
                </c:pt>
                <c:pt idx="1093">
                  <c:v>2.38054</c:v>
                </c:pt>
                <c:pt idx="1094">
                  <c:v>2.00403</c:v>
                </c:pt>
                <c:pt idx="1095">
                  <c:v>5.48659</c:v>
                </c:pt>
                <c:pt idx="1096">
                  <c:v>5.390089999999994</c:v>
                </c:pt>
                <c:pt idx="1097">
                  <c:v>5.88309</c:v>
                </c:pt>
                <c:pt idx="1098">
                  <c:v>3.41255</c:v>
                </c:pt>
                <c:pt idx="1099">
                  <c:v>2.16353</c:v>
                </c:pt>
                <c:pt idx="1100">
                  <c:v>10.0187</c:v>
                </c:pt>
                <c:pt idx="1101">
                  <c:v>5.00908</c:v>
                </c:pt>
                <c:pt idx="1102">
                  <c:v>7.334119999999975</c:v>
                </c:pt>
                <c:pt idx="1103">
                  <c:v>2.25304</c:v>
                </c:pt>
                <c:pt idx="1104">
                  <c:v>8.746640000000001</c:v>
                </c:pt>
                <c:pt idx="1105">
                  <c:v>8.623140000000001</c:v>
                </c:pt>
                <c:pt idx="1106">
                  <c:v>2.07053</c:v>
                </c:pt>
                <c:pt idx="1107">
                  <c:v>3.54856</c:v>
                </c:pt>
                <c:pt idx="1108">
                  <c:v>3.579559999999999</c:v>
                </c:pt>
                <c:pt idx="1109">
                  <c:v>5.39609</c:v>
                </c:pt>
                <c:pt idx="1110">
                  <c:v>3.47506</c:v>
                </c:pt>
                <c:pt idx="1111">
                  <c:v>1.21352</c:v>
                </c:pt>
                <c:pt idx="1112">
                  <c:v>5.54209</c:v>
                </c:pt>
                <c:pt idx="1113">
                  <c:v>4.25957</c:v>
                </c:pt>
                <c:pt idx="1114">
                  <c:v>4.15907</c:v>
                </c:pt>
                <c:pt idx="1115">
                  <c:v>4.52107</c:v>
                </c:pt>
                <c:pt idx="1116">
                  <c:v>2.57554</c:v>
                </c:pt>
                <c:pt idx="1117">
                  <c:v>2.32804</c:v>
                </c:pt>
                <c:pt idx="1118">
                  <c:v>2.38704</c:v>
                </c:pt>
                <c:pt idx="1119">
                  <c:v>2.41154</c:v>
                </c:pt>
                <c:pt idx="1120">
                  <c:v>2.72354</c:v>
                </c:pt>
                <c:pt idx="1121">
                  <c:v>3.24355</c:v>
                </c:pt>
                <c:pt idx="1122">
                  <c:v>1.14902</c:v>
                </c:pt>
                <c:pt idx="1123">
                  <c:v>4.48007</c:v>
                </c:pt>
                <c:pt idx="1124">
                  <c:v>3.832059999999952</c:v>
                </c:pt>
                <c:pt idx="1125">
                  <c:v>2.386039999999999</c:v>
                </c:pt>
                <c:pt idx="1126">
                  <c:v>1.51702</c:v>
                </c:pt>
                <c:pt idx="1127">
                  <c:v>1.24102</c:v>
                </c:pt>
                <c:pt idx="1128">
                  <c:v>8.807640000000002</c:v>
                </c:pt>
                <c:pt idx="1129">
                  <c:v>1.82153</c:v>
                </c:pt>
                <c:pt idx="1130">
                  <c:v>6.0746</c:v>
                </c:pt>
                <c:pt idx="1131">
                  <c:v>5.329589999999984</c:v>
                </c:pt>
                <c:pt idx="1132">
                  <c:v>2.26554</c:v>
                </c:pt>
                <c:pt idx="1133">
                  <c:v>0.826013</c:v>
                </c:pt>
                <c:pt idx="1134">
                  <c:v>2.78704</c:v>
                </c:pt>
                <c:pt idx="1135">
                  <c:v>0.669511</c:v>
                </c:pt>
                <c:pt idx="1136">
                  <c:v>0.939015</c:v>
                </c:pt>
                <c:pt idx="1137">
                  <c:v>2.58354</c:v>
                </c:pt>
                <c:pt idx="1138">
                  <c:v>3.282049999999999</c:v>
                </c:pt>
                <c:pt idx="1139">
                  <c:v>1.49452</c:v>
                </c:pt>
                <c:pt idx="1140">
                  <c:v>4.344569999999996</c:v>
                </c:pt>
                <c:pt idx="1141">
                  <c:v>1.57103</c:v>
                </c:pt>
                <c:pt idx="1142">
                  <c:v>1.68203</c:v>
                </c:pt>
                <c:pt idx="1143">
                  <c:v>3.109049999999999</c:v>
                </c:pt>
                <c:pt idx="1144">
                  <c:v>1.81253</c:v>
                </c:pt>
                <c:pt idx="1145">
                  <c:v>0.802013</c:v>
                </c:pt>
                <c:pt idx="1146">
                  <c:v>1.16452</c:v>
                </c:pt>
                <c:pt idx="1147">
                  <c:v>0.59501</c:v>
                </c:pt>
                <c:pt idx="1148">
                  <c:v>1.29102</c:v>
                </c:pt>
                <c:pt idx="1149">
                  <c:v>0.527008</c:v>
                </c:pt>
                <c:pt idx="1150">
                  <c:v>0.951015</c:v>
                </c:pt>
                <c:pt idx="1151">
                  <c:v>3.312049999999952</c:v>
                </c:pt>
                <c:pt idx="1152">
                  <c:v>4.30907</c:v>
                </c:pt>
                <c:pt idx="1153">
                  <c:v>2.071029999999999</c:v>
                </c:pt>
                <c:pt idx="1154">
                  <c:v>1.29252</c:v>
                </c:pt>
                <c:pt idx="1155">
                  <c:v>1.94853</c:v>
                </c:pt>
                <c:pt idx="1156">
                  <c:v>1.72353</c:v>
                </c:pt>
                <c:pt idx="1157">
                  <c:v>3.06955</c:v>
                </c:pt>
                <c:pt idx="1158">
                  <c:v>2.845549999999998</c:v>
                </c:pt>
                <c:pt idx="1159">
                  <c:v>2.42204</c:v>
                </c:pt>
                <c:pt idx="1160">
                  <c:v>1.52602</c:v>
                </c:pt>
                <c:pt idx="1161">
                  <c:v>0.842014</c:v>
                </c:pt>
                <c:pt idx="1162">
                  <c:v>2.900049999999998</c:v>
                </c:pt>
                <c:pt idx="1163">
                  <c:v>1.27852</c:v>
                </c:pt>
                <c:pt idx="1164">
                  <c:v>5.44409</c:v>
                </c:pt>
                <c:pt idx="1165">
                  <c:v>2.54654</c:v>
                </c:pt>
                <c:pt idx="1166">
                  <c:v>4.46407</c:v>
                </c:pt>
                <c:pt idx="1167">
                  <c:v>0.846014</c:v>
                </c:pt>
                <c:pt idx="1168">
                  <c:v>0.528508</c:v>
                </c:pt>
                <c:pt idx="1169">
                  <c:v>1.12852</c:v>
                </c:pt>
                <c:pt idx="1170">
                  <c:v>2.19104</c:v>
                </c:pt>
                <c:pt idx="1171">
                  <c:v>1.42052</c:v>
                </c:pt>
                <c:pt idx="1172">
                  <c:v>0.883014</c:v>
                </c:pt>
                <c:pt idx="1173">
                  <c:v>0.675011</c:v>
                </c:pt>
                <c:pt idx="1174">
                  <c:v>1.69053</c:v>
                </c:pt>
                <c:pt idx="1175">
                  <c:v>2.24154</c:v>
                </c:pt>
                <c:pt idx="1176">
                  <c:v>2.08053</c:v>
                </c:pt>
                <c:pt idx="1177">
                  <c:v>0.486508</c:v>
                </c:pt>
                <c:pt idx="1178">
                  <c:v>1.76953</c:v>
                </c:pt>
                <c:pt idx="1179">
                  <c:v>1.28302</c:v>
                </c:pt>
                <c:pt idx="1180">
                  <c:v>0.474508</c:v>
                </c:pt>
                <c:pt idx="1181">
                  <c:v>2.19354</c:v>
                </c:pt>
                <c:pt idx="1182">
                  <c:v>0.562509</c:v>
                </c:pt>
                <c:pt idx="1183">
                  <c:v>0.960015</c:v>
                </c:pt>
                <c:pt idx="1184">
                  <c:v>1.16352</c:v>
                </c:pt>
                <c:pt idx="1185">
                  <c:v>2.15253</c:v>
                </c:pt>
                <c:pt idx="1186">
                  <c:v>0.576009</c:v>
                </c:pt>
                <c:pt idx="1187">
                  <c:v>0.421507</c:v>
                </c:pt>
                <c:pt idx="1188">
                  <c:v>1.67103</c:v>
                </c:pt>
                <c:pt idx="1189">
                  <c:v>0.766512</c:v>
                </c:pt>
                <c:pt idx="1190">
                  <c:v>0.827013</c:v>
                </c:pt>
                <c:pt idx="1191">
                  <c:v>1.15202</c:v>
                </c:pt>
                <c:pt idx="1192">
                  <c:v>0.873514</c:v>
                </c:pt>
                <c:pt idx="1193">
                  <c:v>1.08602</c:v>
                </c:pt>
                <c:pt idx="1194">
                  <c:v>1.60453</c:v>
                </c:pt>
                <c:pt idx="1195">
                  <c:v>0.926515</c:v>
                </c:pt>
                <c:pt idx="1196">
                  <c:v>2.78354</c:v>
                </c:pt>
                <c:pt idx="1197">
                  <c:v>0.667511</c:v>
                </c:pt>
                <c:pt idx="1198">
                  <c:v>1.95703</c:v>
                </c:pt>
                <c:pt idx="1199">
                  <c:v>0.822013</c:v>
                </c:pt>
                <c:pt idx="1200">
                  <c:v>2.00853</c:v>
                </c:pt>
                <c:pt idx="1201">
                  <c:v>2.15553</c:v>
                </c:pt>
                <c:pt idx="1202">
                  <c:v>0.962015</c:v>
                </c:pt>
                <c:pt idx="1203">
                  <c:v>1.75153</c:v>
                </c:pt>
                <c:pt idx="1204">
                  <c:v>1.96753</c:v>
                </c:pt>
                <c:pt idx="1205">
                  <c:v>1.21302</c:v>
                </c:pt>
                <c:pt idx="1206">
                  <c:v>1.33852</c:v>
                </c:pt>
                <c:pt idx="1207">
                  <c:v>0.784513</c:v>
                </c:pt>
                <c:pt idx="1208">
                  <c:v>1.37252</c:v>
                </c:pt>
                <c:pt idx="1209">
                  <c:v>2.20604</c:v>
                </c:pt>
                <c:pt idx="1210">
                  <c:v>2.00003</c:v>
                </c:pt>
                <c:pt idx="1211">
                  <c:v>2.77354</c:v>
                </c:pt>
                <c:pt idx="1212">
                  <c:v>1.12052</c:v>
                </c:pt>
                <c:pt idx="1213">
                  <c:v>1.54902</c:v>
                </c:pt>
                <c:pt idx="1214">
                  <c:v>1.91053</c:v>
                </c:pt>
                <c:pt idx="1215">
                  <c:v>2.45704</c:v>
                </c:pt>
                <c:pt idx="1216">
                  <c:v>1.77403</c:v>
                </c:pt>
                <c:pt idx="1217">
                  <c:v>3.55606</c:v>
                </c:pt>
                <c:pt idx="1218">
                  <c:v>2.09253</c:v>
                </c:pt>
                <c:pt idx="1219">
                  <c:v>3.535559999999998</c:v>
                </c:pt>
                <c:pt idx="1220">
                  <c:v>2.68304</c:v>
                </c:pt>
                <c:pt idx="1221">
                  <c:v>2.57354</c:v>
                </c:pt>
                <c:pt idx="1222">
                  <c:v>4.017559999999984</c:v>
                </c:pt>
                <c:pt idx="1223">
                  <c:v>5.9606</c:v>
                </c:pt>
                <c:pt idx="1224">
                  <c:v>1.99603</c:v>
                </c:pt>
                <c:pt idx="1225">
                  <c:v>2.21304</c:v>
                </c:pt>
                <c:pt idx="1226">
                  <c:v>2.77754</c:v>
                </c:pt>
                <c:pt idx="1227">
                  <c:v>4.22007</c:v>
                </c:pt>
                <c:pt idx="1228">
                  <c:v>1.38852</c:v>
                </c:pt>
                <c:pt idx="1229">
                  <c:v>5.728589999999984</c:v>
                </c:pt>
                <c:pt idx="1230">
                  <c:v>1.06102</c:v>
                </c:pt>
                <c:pt idx="1231">
                  <c:v>4.45107</c:v>
                </c:pt>
                <c:pt idx="1232">
                  <c:v>3.75056</c:v>
                </c:pt>
                <c:pt idx="1233">
                  <c:v>2.71454</c:v>
                </c:pt>
                <c:pt idx="1234">
                  <c:v>4.09507</c:v>
                </c:pt>
                <c:pt idx="1235">
                  <c:v>4.675579999999996</c:v>
                </c:pt>
                <c:pt idx="1236">
                  <c:v>4.46007</c:v>
                </c:pt>
                <c:pt idx="1237">
                  <c:v>2.072029999999998</c:v>
                </c:pt>
                <c:pt idx="1238">
                  <c:v>2.08203</c:v>
                </c:pt>
                <c:pt idx="1239">
                  <c:v>4.74858</c:v>
                </c:pt>
                <c:pt idx="1240">
                  <c:v>4.018559999999995</c:v>
                </c:pt>
                <c:pt idx="1241">
                  <c:v>4.48057</c:v>
                </c:pt>
                <c:pt idx="1242">
                  <c:v>6.0101</c:v>
                </c:pt>
                <c:pt idx="1243">
                  <c:v>5.37209</c:v>
                </c:pt>
                <c:pt idx="1244">
                  <c:v>0.818013</c:v>
                </c:pt>
                <c:pt idx="1245">
                  <c:v>3.111549999999998</c:v>
                </c:pt>
                <c:pt idx="1246">
                  <c:v>1.44552</c:v>
                </c:pt>
                <c:pt idx="1247">
                  <c:v>2.94505</c:v>
                </c:pt>
                <c:pt idx="1248">
                  <c:v>2.50554</c:v>
                </c:pt>
                <c:pt idx="1249">
                  <c:v>4.09907</c:v>
                </c:pt>
                <c:pt idx="1250">
                  <c:v>4.88108</c:v>
                </c:pt>
                <c:pt idx="1251">
                  <c:v>5.315089999999985</c:v>
                </c:pt>
                <c:pt idx="1252">
                  <c:v>5.022079999999995</c:v>
                </c:pt>
                <c:pt idx="1253">
                  <c:v>2.908049999999998</c:v>
                </c:pt>
                <c:pt idx="1254">
                  <c:v>4.014059999999994</c:v>
                </c:pt>
                <c:pt idx="1255">
                  <c:v>3.41805</c:v>
                </c:pt>
                <c:pt idx="1256">
                  <c:v>3.075549999999998</c:v>
                </c:pt>
                <c:pt idx="1257">
                  <c:v>1.28352</c:v>
                </c:pt>
                <c:pt idx="1258">
                  <c:v>4.318569999999998</c:v>
                </c:pt>
                <c:pt idx="1259">
                  <c:v>2.29154</c:v>
                </c:pt>
                <c:pt idx="1260">
                  <c:v>4.324569999999976</c:v>
                </c:pt>
                <c:pt idx="1261">
                  <c:v>3.94206</c:v>
                </c:pt>
                <c:pt idx="1262">
                  <c:v>7.51762</c:v>
                </c:pt>
                <c:pt idx="1263">
                  <c:v>4.067569999999995</c:v>
                </c:pt>
                <c:pt idx="1264">
                  <c:v>6.3866</c:v>
                </c:pt>
                <c:pt idx="1265">
                  <c:v>3.60706</c:v>
                </c:pt>
                <c:pt idx="1266">
                  <c:v>2.49404</c:v>
                </c:pt>
                <c:pt idx="1267">
                  <c:v>5.526089999999995</c:v>
                </c:pt>
                <c:pt idx="1268">
                  <c:v>4.93808</c:v>
                </c:pt>
                <c:pt idx="1269">
                  <c:v>3.98206</c:v>
                </c:pt>
                <c:pt idx="1270">
                  <c:v>2.49754</c:v>
                </c:pt>
                <c:pt idx="1271">
                  <c:v>5.610089999999976</c:v>
                </c:pt>
                <c:pt idx="1272">
                  <c:v>3.666059999999998</c:v>
                </c:pt>
                <c:pt idx="1273">
                  <c:v>5.025579999999985</c:v>
                </c:pt>
                <c:pt idx="1274">
                  <c:v>4.09357</c:v>
                </c:pt>
                <c:pt idx="1275">
                  <c:v>6.5246</c:v>
                </c:pt>
                <c:pt idx="1276">
                  <c:v>6.67661</c:v>
                </c:pt>
                <c:pt idx="1277">
                  <c:v>3.138049999999998</c:v>
                </c:pt>
                <c:pt idx="1278">
                  <c:v>3.401549999999998</c:v>
                </c:pt>
                <c:pt idx="1279">
                  <c:v>2.20304</c:v>
                </c:pt>
                <c:pt idx="1280">
                  <c:v>6.0131</c:v>
                </c:pt>
                <c:pt idx="1281">
                  <c:v>1.92753</c:v>
                </c:pt>
                <c:pt idx="1282">
                  <c:v>3.362049999999976</c:v>
                </c:pt>
                <c:pt idx="1283">
                  <c:v>2.91305</c:v>
                </c:pt>
                <c:pt idx="1284">
                  <c:v>2.54054</c:v>
                </c:pt>
                <c:pt idx="1285">
                  <c:v>1.79353</c:v>
                </c:pt>
                <c:pt idx="1286">
                  <c:v>3.00855</c:v>
                </c:pt>
                <c:pt idx="1287">
                  <c:v>3.276549999999998</c:v>
                </c:pt>
                <c:pt idx="1288">
                  <c:v>5.355589999999966</c:v>
                </c:pt>
                <c:pt idx="1289">
                  <c:v>5.147579999999976</c:v>
                </c:pt>
                <c:pt idx="1290">
                  <c:v>5.242579999999998</c:v>
                </c:pt>
                <c:pt idx="1291">
                  <c:v>3.44156</c:v>
                </c:pt>
                <c:pt idx="1292">
                  <c:v>2.89855</c:v>
                </c:pt>
                <c:pt idx="1293">
                  <c:v>4.317069999999997</c:v>
                </c:pt>
                <c:pt idx="1294">
                  <c:v>4.42157</c:v>
                </c:pt>
                <c:pt idx="1295">
                  <c:v>8.979640000000006</c:v>
                </c:pt>
                <c:pt idx="1296">
                  <c:v>8.04613</c:v>
                </c:pt>
                <c:pt idx="1297">
                  <c:v>5.70959</c:v>
                </c:pt>
                <c:pt idx="1298">
                  <c:v>2.355539999999999</c:v>
                </c:pt>
                <c:pt idx="1299">
                  <c:v>2.978549999999998</c:v>
                </c:pt>
                <c:pt idx="1300">
                  <c:v>7.414119999999984</c:v>
                </c:pt>
                <c:pt idx="1301">
                  <c:v>5.808589999999985</c:v>
                </c:pt>
                <c:pt idx="1302">
                  <c:v>2.15179</c:v>
                </c:pt>
                <c:pt idx="1303">
                  <c:v>2.13703</c:v>
                </c:pt>
                <c:pt idx="1304">
                  <c:v>6.680109999999995</c:v>
                </c:pt>
                <c:pt idx="1305">
                  <c:v>2.18254</c:v>
                </c:pt>
                <c:pt idx="1306">
                  <c:v>3.91556</c:v>
                </c:pt>
                <c:pt idx="1307">
                  <c:v>6.94811</c:v>
                </c:pt>
                <c:pt idx="1308">
                  <c:v>4.012559999999985</c:v>
                </c:pt>
                <c:pt idx="1309">
                  <c:v>1.26802</c:v>
                </c:pt>
                <c:pt idx="1310">
                  <c:v>4.37107</c:v>
                </c:pt>
                <c:pt idx="1311">
                  <c:v>6.0331</c:v>
                </c:pt>
                <c:pt idx="1312">
                  <c:v>6.1791</c:v>
                </c:pt>
                <c:pt idx="1313">
                  <c:v>5.464089999999985</c:v>
                </c:pt>
                <c:pt idx="1314">
                  <c:v>3.369549999999998</c:v>
                </c:pt>
                <c:pt idx="1315">
                  <c:v>1.18402</c:v>
                </c:pt>
                <c:pt idx="1316">
                  <c:v>10.4712</c:v>
                </c:pt>
                <c:pt idx="1317">
                  <c:v>11.1267</c:v>
                </c:pt>
                <c:pt idx="1318">
                  <c:v>4.861079999999998</c:v>
                </c:pt>
                <c:pt idx="1319">
                  <c:v>2.20304</c:v>
                </c:pt>
                <c:pt idx="1320">
                  <c:v>3.20505</c:v>
                </c:pt>
                <c:pt idx="1321">
                  <c:v>1.47202</c:v>
                </c:pt>
                <c:pt idx="1322">
                  <c:v>3.489059999999998</c:v>
                </c:pt>
                <c:pt idx="1323">
                  <c:v>6.0131</c:v>
                </c:pt>
                <c:pt idx="1324">
                  <c:v>2.42204</c:v>
                </c:pt>
                <c:pt idx="1325">
                  <c:v>4.47157</c:v>
                </c:pt>
                <c:pt idx="1326">
                  <c:v>1.80703</c:v>
                </c:pt>
                <c:pt idx="1327">
                  <c:v>1.45652</c:v>
                </c:pt>
                <c:pt idx="1328">
                  <c:v>4.111569999999999</c:v>
                </c:pt>
                <c:pt idx="1329">
                  <c:v>3.72506</c:v>
                </c:pt>
                <c:pt idx="1330">
                  <c:v>3.31155</c:v>
                </c:pt>
                <c:pt idx="1331">
                  <c:v>6.4756</c:v>
                </c:pt>
                <c:pt idx="1332">
                  <c:v>3.41155</c:v>
                </c:pt>
                <c:pt idx="1333">
                  <c:v>2.60604</c:v>
                </c:pt>
                <c:pt idx="1334">
                  <c:v>4.96008</c:v>
                </c:pt>
                <c:pt idx="1335">
                  <c:v>4.09507</c:v>
                </c:pt>
                <c:pt idx="1336">
                  <c:v>1.93653</c:v>
                </c:pt>
                <c:pt idx="1337">
                  <c:v>5.212579999999996</c:v>
                </c:pt>
                <c:pt idx="1338">
                  <c:v>2.44854</c:v>
                </c:pt>
                <c:pt idx="1339">
                  <c:v>2.59854</c:v>
                </c:pt>
                <c:pt idx="1340">
                  <c:v>5.156079999999998</c:v>
                </c:pt>
                <c:pt idx="1341">
                  <c:v>3.891059999999952</c:v>
                </c:pt>
                <c:pt idx="1342">
                  <c:v>5.072579999999999</c:v>
                </c:pt>
                <c:pt idx="1343">
                  <c:v>1.50652</c:v>
                </c:pt>
                <c:pt idx="1344">
                  <c:v>2.909549999999999</c:v>
                </c:pt>
                <c:pt idx="1345">
                  <c:v>3.84506</c:v>
                </c:pt>
                <c:pt idx="1346">
                  <c:v>4.302569999999998</c:v>
                </c:pt>
                <c:pt idx="1347">
                  <c:v>4.708579999999999</c:v>
                </c:pt>
                <c:pt idx="1348">
                  <c:v>1.95203</c:v>
                </c:pt>
                <c:pt idx="1349">
                  <c:v>4.742579999999998</c:v>
                </c:pt>
                <c:pt idx="1350">
                  <c:v>8.16263</c:v>
                </c:pt>
                <c:pt idx="1351">
                  <c:v>4.98308</c:v>
                </c:pt>
                <c:pt idx="1352">
                  <c:v>1.909529999999999</c:v>
                </c:pt>
                <c:pt idx="1353">
                  <c:v>4.754579999999986</c:v>
                </c:pt>
                <c:pt idx="1354">
                  <c:v>2.03653</c:v>
                </c:pt>
                <c:pt idx="1355">
                  <c:v>5.13108</c:v>
                </c:pt>
                <c:pt idx="1356">
                  <c:v>3.32005</c:v>
                </c:pt>
                <c:pt idx="1357">
                  <c:v>4.90608</c:v>
                </c:pt>
                <c:pt idx="1358">
                  <c:v>1.64253</c:v>
                </c:pt>
                <c:pt idx="1359">
                  <c:v>3.408049999999998</c:v>
                </c:pt>
                <c:pt idx="1360">
                  <c:v>1.22752</c:v>
                </c:pt>
                <c:pt idx="1361">
                  <c:v>2.24454</c:v>
                </c:pt>
                <c:pt idx="1362">
                  <c:v>1.36102</c:v>
                </c:pt>
                <c:pt idx="1363">
                  <c:v>7.322619999999985</c:v>
                </c:pt>
                <c:pt idx="1364">
                  <c:v>1.64353</c:v>
                </c:pt>
                <c:pt idx="1365">
                  <c:v>3.56056</c:v>
                </c:pt>
                <c:pt idx="1366">
                  <c:v>1.91503</c:v>
                </c:pt>
                <c:pt idx="1367">
                  <c:v>3.134049999999998</c:v>
                </c:pt>
                <c:pt idx="1368">
                  <c:v>2.49004</c:v>
                </c:pt>
                <c:pt idx="1369">
                  <c:v>1.79903</c:v>
                </c:pt>
                <c:pt idx="1370">
                  <c:v>1.57103</c:v>
                </c:pt>
                <c:pt idx="1371">
                  <c:v>1.90903</c:v>
                </c:pt>
                <c:pt idx="1372">
                  <c:v>1.20552</c:v>
                </c:pt>
                <c:pt idx="1373">
                  <c:v>2.48254</c:v>
                </c:pt>
                <c:pt idx="1374">
                  <c:v>4.07907</c:v>
                </c:pt>
                <c:pt idx="1375">
                  <c:v>2.836549999999952</c:v>
                </c:pt>
                <c:pt idx="1376">
                  <c:v>1.63103</c:v>
                </c:pt>
                <c:pt idx="1377">
                  <c:v>6.337099999999999</c:v>
                </c:pt>
                <c:pt idx="1378">
                  <c:v>1.82653</c:v>
                </c:pt>
                <c:pt idx="1379">
                  <c:v>4.23957</c:v>
                </c:pt>
                <c:pt idx="1380">
                  <c:v>5.502089999999995</c:v>
                </c:pt>
                <c:pt idx="1381">
                  <c:v>2.20304</c:v>
                </c:pt>
                <c:pt idx="1382">
                  <c:v>2.04953</c:v>
                </c:pt>
                <c:pt idx="1383">
                  <c:v>2.051029999999999</c:v>
                </c:pt>
                <c:pt idx="1384">
                  <c:v>4.98008</c:v>
                </c:pt>
                <c:pt idx="1385">
                  <c:v>3.19505</c:v>
                </c:pt>
                <c:pt idx="1386">
                  <c:v>3.21205</c:v>
                </c:pt>
                <c:pt idx="1387">
                  <c:v>4.19607</c:v>
                </c:pt>
                <c:pt idx="1388">
                  <c:v>3.12855</c:v>
                </c:pt>
                <c:pt idx="1389">
                  <c:v>1.15652</c:v>
                </c:pt>
                <c:pt idx="1390">
                  <c:v>2.03753</c:v>
                </c:pt>
                <c:pt idx="1391">
                  <c:v>2.62604</c:v>
                </c:pt>
                <c:pt idx="1392">
                  <c:v>3.26105</c:v>
                </c:pt>
                <c:pt idx="1393">
                  <c:v>2.29854</c:v>
                </c:pt>
                <c:pt idx="1394">
                  <c:v>1.91653</c:v>
                </c:pt>
                <c:pt idx="1395">
                  <c:v>2.05653</c:v>
                </c:pt>
                <c:pt idx="1396">
                  <c:v>2.02353</c:v>
                </c:pt>
                <c:pt idx="1397">
                  <c:v>2.95555</c:v>
                </c:pt>
                <c:pt idx="1398">
                  <c:v>4.29257</c:v>
                </c:pt>
                <c:pt idx="1399">
                  <c:v>1.00152</c:v>
                </c:pt>
                <c:pt idx="1400">
                  <c:v>2.58704</c:v>
                </c:pt>
                <c:pt idx="1401">
                  <c:v>1.87353</c:v>
                </c:pt>
                <c:pt idx="1402">
                  <c:v>0.752012</c:v>
                </c:pt>
                <c:pt idx="1403">
                  <c:v>3.19105</c:v>
                </c:pt>
                <c:pt idx="1404">
                  <c:v>0.911015</c:v>
                </c:pt>
                <c:pt idx="1405">
                  <c:v>1.59253</c:v>
                </c:pt>
                <c:pt idx="1406">
                  <c:v>1.41602</c:v>
                </c:pt>
                <c:pt idx="1407">
                  <c:v>1.38052</c:v>
                </c:pt>
                <c:pt idx="1408">
                  <c:v>0.936515</c:v>
                </c:pt>
                <c:pt idx="1409">
                  <c:v>2.51304</c:v>
                </c:pt>
                <c:pt idx="1410">
                  <c:v>0.955515</c:v>
                </c:pt>
                <c:pt idx="1411">
                  <c:v>3.31705</c:v>
                </c:pt>
                <c:pt idx="1412">
                  <c:v>3.06855</c:v>
                </c:pt>
                <c:pt idx="1413">
                  <c:v>2.19204</c:v>
                </c:pt>
                <c:pt idx="1414">
                  <c:v>0.920015</c:v>
                </c:pt>
                <c:pt idx="1415">
                  <c:v>1.96803</c:v>
                </c:pt>
                <c:pt idx="1416">
                  <c:v>1.99603</c:v>
                </c:pt>
                <c:pt idx="1417">
                  <c:v>1.53102</c:v>
                </c:pt>
                <c:pt idx="1418">
                  <c:v>0.974516</c:v>
                </c:pt>
                <c:pt idx="1419">
                  <c:v>1.77603</c:v>
                </c:pt>
                <c:pt idx="1420">
                  <c:v>3.006549999999998</c:v>
                </c:pt>
                <c:pt idx="1421">
                  <c:v>3.436059999999952</c:v>
                </c:pt>
                <c:pt idx="1422">
                  <c:v>4.03956</c:v>
                </c:pt>
                <c:pt idx="1423">
                  <c:v>2.74904</c:v>
                </c:pt>
                <c:pt idx="1424">
                  <c:v>0.970016</c:v>
                </c:pt>
                <c:pt idx="1425">
                  <c:v>0.733012</c:v>
                </c:pt>
                <c:pt idx="1426">
                  <c:v>2.18104</c:v>
                </c:pt>
                <c:pt idx="1427">
                  <c:v>0.905015</c:v>
                </c:pt>
                <c:pt idx="1428">
                  <c:v>1.59703</c:v>
                </c:pt>
                <c:pt idx="1429">
                  <c:v>1.55102</c:v>
                </c:pt>
                <c:pt idx="1430">
                  <c:v>1.45852</c:v>
                </c:pt>
                <c:pt idx="1431">
                  <c:v>0.942515</c:v>
                </c:pt>
                <c:pt idx="1432">
                  <c:v>0.769012</c:v>
                </c:pt>
                <c:pt idx="1433">
                  <c:v>0.871514</c:v>
                </c:pt>
                <c:pt idx="1434">
                  <c:v>3.464059999999999</c:v>
                </c:pt>
                <c:pt idx="1435">
                  <c:v>3.181049999999999</c:v>
                </c:pt>
                <c:pt idx="1436">
                  <c:v>2.00453</c:v>
                </c:pt>
                <c:pt idx="1437">
                  <c:v>0.958515</c:v>
                </c:pt>
                <c:pt idx="1438">
                  <c:v>1.51252</c:v>
                </c:pt>
                <c:pt idx="1439">
                  <c:v>1.70103</c:v>
                </c:pt>
                <c:pt idx="1440">
                  <c:v>2.42004</c:v>
                </c:pt>
                <c:pt idx="1441">
                  <c:v>0.892514</c:v>
                </c:pt>
                <c:pt idx="1442">
                  <c:v>0.985016</c:v>
                </c:pt>
                <c:pt idx="1443">
                  <c:v>4.212569999999999</c:v>
                </c:pt>
                <c:pt idx="1444">
                  <c:v>1.53002</c:v>
                </c:pt>
                <c:pt idx="1445">
                  <c:v>2.40854</c:v>
                </c:pt>
                <c:pt idx="1446">
                  <c:v>1.78253</c:v>
                </c:pt>
                <c:pt idx="1447">
                  <c:v>1.22802</c:v>
                </c:pt>
                <c:pt idx="1448">
                  <c:v>1.53552</c:v>
                </c:pt>
                <c:pt idx="1449">
                  <c:v>3.10205</c:v>
                </c:pt>
                <c:pt idx="1450">
                  <c:v>3.31755</c:v>
                </c:pt>
                <c:pt idx="1451">
                  <c:v>2.856549999999952</c:v>
                </c:pt>
                <c:pt idx="1452">
                  <c:v>7.77162</c:v>
                </c:pt>
                <c:pt idx="1453">
                  <c:v>3.29305</c:v>
                </c:pt>
                <c:pt idx="1454">
                  <c:v>1.60153</c:v>
                </c:pt>
                <c:pt idx="1455">
                  <c:v>3.833559999999998</c:v>
                </c:pt>
                <c:pt idx="1456">
                  <c:v>1.56253</c:v>
                </c:pt>
                <c:pt idx="1457">
                  <c:v>1.49202</c:v>
                </c:pt>
                <c:pt idx="1458">
                  <c:v>3.54856</c:v>
                </c:pt>
                <c:pt idx="1459">
                  <c:v>2.41854</c:v>
                </c:pt>
                <c:pt idx="1460">
                  <c:v>3.670059999999998</c:v>
                </c:pt>
                <c:pt idx="1461">
                  <c:v>4.26207</c:v>
                </c:pt>
                <c:pt idx="1462">
                  <c:v>1.96553</c:v>
                </c:pt>
                <c:pt idx="1463">
                  <c:v>1.94603</c:v>
                </c:pt>
                <c:pt idx="1464">
                  <c:v>3.84656</c:v>
                </c:pt>
                <c:pt idx="1465">
                  <c:v>3.370049999999992</c:v>
                </c:pt>
                <c:pt idx="1466">
                  <c:v>3.290049999999999</c:v>
                </c:pt>
                <c:pt idx="1467">
                  <c:v>4.898579999999995</c:v>
                </c:pt>
                <c:pt idx="1468">
                  <c:v>8.14763</c:v>
                </c:pt>
                <c:pt idx="1469">
                  <c:v>2.70254</c:v>
                </c:pt>
                <c:pt idx="1470">
                  <c:v>4.43707</c:v>
                </c:pt>
                <c:pt idx="1471">
                  <c:v>1.04702</c:v>
                </c:pt>
                <c:pt idx="1472">
                  <c:v>0.921015</c:v>
                </c:pt>
                <c:pt idx="1473">
                  <c:v>2.96105</c:v>
                </c:pt>
                <c:pt idx="1474">
                  <c:v>2.63354</c:v>
                </c:pt>
                <c:pt idx="1475">
                  <c:v>2.72754</c:v>
                </c:pt>
                <c:pt idx="1476">
                  <c:v>3.466559999999998</c:v>
                </c:pt>
                <c:pt idx="1477">
                  <c:v>4.898579999999995</c:v>
                </c:pt>
                <c:pt idx="1478">
                  <c:v>3.67756</c:v>
                </c:pt>
                <c:pt idx="1479">
                  <c:v>4.14157</c:v>
                </c:pt>
                <c:pt idx="1480">
                  <c:v>3.07005</c:v>
                </c:pt>
                <c:pt idx="1481">
                  <c:v>2.89305</c:v>
                </c:pt>
                <c:pt idx="1482">
                  <c:v>6.2411</c:v>
                </c:pt>
                <c:pt idx="1483">
                  <c:v>1.57553</c:v>
                </c:pt>
                <c:pt idx="1484">
                  <c:v>1.92903</c:v>
                </c:pt>
                <c:pt idx="1485">
                  <c:v>7.653119999999975</c:v>
                </c:pt>
                <c:pt idx="1486">
                  <c:v>6.857109999999976</c:v>
                </c:pt>
                <c:pt idx="1487">
                  <c:v>4.357069999999997</c:v>
                </c:pt>
                <c:pt idx="1488">
                  <c:v>3.546559999999999</c:v>
                </c:pt>
                <c:pt idx="1489">
                  <c:v>4.127069999999986</c:v>
                </c:pt>
                <c:pt idx="1490">
                  <c:v>1.76203</c:v>
                </c:pt>
                <c:pt idx="1491">
                  <c:v>4.369569999999999</c:v>
                </c:pt>
                <c:pt idx="1492">
                  <c:v>1.00052</c:v>
                </c:pt>
                <c:pt idx="1493">
                  <c:v>1.44302</c:v>
                </c:pt>
                <c:pt idx="1494">
                  <c:v>6.682109999999985</c:v>
                </c:pt>
                <c:pt idx="1495">
                  <c:v>3.46556</c:v>
                </c:pt>
                <c:pt idx="1496">
                  <c:v>5.38009</c:v>
                </c:pt>
                <c:pt idx="1497">
                  <c:v>2.29904</c:v>
                </c:pt>
                <c:pt idx="1498">
                  <c:v>0.742512</c:v>
                </c:pt>
                <c:pt idx="1499">
                  <c:v>0.895514</c:v>
                </c:pt>
                <c:pt idx="1500">
                  <c:v>2.25204</c:v>
                </c:pt>
                <c:pt idx="1501">
                  <c:v>7.00911</c:v>
                </c:pt>
                <c:pt idx="1502">
                  <c:v>4.92008</c:v>
                </c:pt>
                <c:pt idx="1503">
                  <c:v>6.4506</c:v>
                </c:pt>
                <c:pt idx="1504">
                  <c:v>2.21354</c:v>
                </c:pt>
                <c:pt idx="1505">
                  <c:v>2.08703</c:v>
                </c:pt>
                <c:pt idx="1506">
                  <c:v>2.532039999999999</c:v>
                </c:pt>
                <c:pt idx="1507">
                  <c:v>3.68106</c:v>
                </c:pt>
                <c:pt idx="1508">
                  <c:v>7.065609999999999</c:v>
                </c:pt>
                <c:pt idx="1509">
                  <c:v>4.801579999999999</c:v>
                </c:pt>
                <c:pt idx="1510">
                  <c:v>2.63804</c:v>
                </c:pt>
                <c:pt idx="1511">
                  <c:v>5.620589999999937</c:v>
                </c:pt>
                <c:pt idx="1512">
                  <c:v>3.79556</c:v>
                </c:pt>
                <c:pt idx="1513">
                  <c:v>5.352089999999984</c:v>
                </c:pt>
                <c:pt idx="1514">
                  <c:v>5.10108</c:v>
                </c:pt>
                <c:pt idx="1515">
                  <c:v>7.71862</c:v>
                </c:pt>
                <c:pt idx="1516">
                  <c:v>2.712039999999999</c:v>
                </c:pt>
                <c:pt idx="1517">
                  <c:v>2.16203</c:v>
                </c:pt>
                <c:pt idx="1518">
                  <c:v>5.391589999999994</c:v>
                </c:pt>
                <c:pt idx="1519">
                  <c:v>4.54907</c:v>
                </c:pt>
                <c:pt idx="1520">
                  <c:v>3.321549999999998</c:v>
                </c:pt>
                <c:pt idx="1521">
                  <c:v>3.65056</c:v>
                </c:pt>
                <c:pt idx="1522">
                  <c:v>4.707079999999999</c:v>
                </c:pt>
                <c:pt idx="1523">
                  <c:v>4.83908</c:v>
                </c:pt>
                <c:pt idx="1524">
                  <c:v>4.192569999999995</c:v>
                </c:pt>
                <c:pt idx="1525">
                  <c:v>6.877109999999996</c:v>
                </c:pt>
                <c:pt idx="1526">
                  <c:v>6.4596</c:v>
                </c:pt>
                <c:pt idx="1527">
                  <c:v>4.21607</c:v>
                </c:pt>
                <c:pt idx="1528">
                  <c:v>6.2086</c:v>
                </c:pt>
                <c:pt idx="1529">
                  <c:v>8.62964</c:v>
                </c:pt>
                <c:pt idx="1530">
                  <c:v>2.72104</c:v>
                </c:pt>
                <c:pt idx="1531">
                  <c:v>3.198049999999998</c:v>
                </c:pt>
                <c:pt idx="1532">
                  <c:v>6.4506</c:v>
                </c:pt>
                <c:pt idx="1533">
                  <c:v>6.5211</c:v>
                </c:pt>
                <c:pt idx="1534">
                  <c:v>1.33202</c:v>
                </c:pt>
                <c:pt idx="1535">
                  <c:v>3.47406</c:v>
                </c:pt>
                <c:pt idx="1536">
                  <c:v>1.65303</c:v>
                </c:pt>
                <c:pt idx="1537">
                  <c:v>9.902660000000002</c:v>
                </c:pt>
                <c:pt idx="1538">
                  <c:v>3.095549999999998</c:v>
                </c:pt>
                <c:pt idx="1539">
                  <c:v>4.44307</c:v>
                </c:pt>
                <c:pt idx="1540">
                  <c:v>2.62304</c:v>
                </c:pt>
                <c:pt idx="1541">
                  <c:v>5.30159</c:v>
                </c:pt>
                <c:pt idx="1542">
                  <c:v>4.925079999999999</c:v>
                </c:pt>
                <c:pt idx="1543">
                  <c:v>1.31602</c:v>
                </c:pt>
                <c:pt idx="1544">
                  <c:v>2.54654</c:v>
                </c:pt>
                <c:pt idx="1545">
                  <c:v>2.27154</c:v>
                </c:pt>
                <c:pt idx="1546">
                  <c:v>5.44359</c:v>
                </c:pt>
                <c:pt idx="1547">
                  <c:v>2.15953</c:v>
                </c:pt>
                <c:pt idx="1548">
                  <c:v>4.09707</c:v>
                </c:pt>
                <c:pt idx="1549">
                  <c:v>3.00855</c:v>
                </c:pt>
                <c:pt idx="1550">
                  <c:v>2.76804</c:v>
                </c:pt>
                <c:pt idx="1551">
                  <c:v>6.557609999999999</c:v>
                </c:pt>
                <c:pt idx="1552">
                  <c:v>4.734579999999997</c:v>
                </c:pt>
                <c:pt idx="1553">
                  <c:v>2.72304</c:v>
                </c:pt>
                <c:pt idx="1554">
                  <c:v>4.10607</c:v>
                </c:pt>
                <c:pt idx="1555">
                  <c:v>5.28076</c:v>
                </c:pt>
                <c:pt idx="1556">
                  <c:v>1.81953</c:v>
                </c:pt>
                <c:pt idx="1557">
                  <c:v>1.63803</c:v>
                </c:pt>
                <c:pt idx="1558">
                  <c:v>0.998516</c:v>
                </c:pt>
                <c:pt idx="1559">
                  <c:v>1.82903</c:v>
                </c:pt>
                <c:pt idx="1560">
                  <c:v>1.37302</c:v>
                </c:pt>
                <c:pt idx="1561">
                  <c:v>2.22854</c:v>
                </c:pt>
                <c:pt idx="1562">
                  <c:v>1.89003</c:v>
                </c:pt>
                <c:pt idx="1563">
                  <c:v>1.46602</c:v>
                </c:pt>
                <c:pt idx="1564">
                  <c:v>1.74053</c:v>
                </c:pt>
                <c:pt idx="1565">
                  <c:v>2.81455</c:v>
                </c:pt>
                <c:pt idx="1566">
                  <c:v>1.89453</c:v>
                </c:pt>
                <c:pt idx="1567">
                  <c:v>2.37054</c:v>
                </c:pt>
                <c:pt idx="1568">
                  <c:v>3.18755</c:v>
                </c:pt>
                <c:pt idx="1569">
                  <c:v>3.47556</c:v>
                </c:pt>
                <c:pt idx="1570">
                  <c:v>1.52402</c:v>
                </c:pt>
                <c:pt idx="1571">
                  <c:v>1.22752</c:v>
                </c:pt>
                <c:pt idx="1572">
                  <c:v>5.41359</c:v>
                </c:pt>
                <c:pt idx="1573">
                  <c:v>1.23952</c:v>
                </c:pt>
                <c:pt idx="1574">
                  <c:v>4.747579999999997</c:v>
                </c:pt>
                <c:pt idx="1575">
                  <c:v>1.52552</c:v>
                </c:pt>
                <c:pt idx="1576">
                  <c:v>1.56703</c:v>
                </c:pt>
                <c:pt idx="1577">
                  <c:v>3.32755</c:v>
                </c:pt>
                <c:pt idx="1578">
                  <c:v>3.43556</c:v>
                </c:pt>
                <c:pt idx="1579">
                  <c:v>4.55057</c:v>
                </c:pt>
                <c:pt idx="1580">
                  <c:v>2.10853</c:v>
                </c:pt>
                <c:pt idx="1581">
                  <c:v>1.66203</c:v>
                </c:pt>
                <c:pt idx="1582">
                  <c:v>1.06252</c:v>
                </c:pt>
                <c:pt idx="1583">
                  <c:v>0.62051</c:v>
                </c:pt>
                <c:pt idx="1584">
                  <c:v>1.80653</c:v>
                </c:pt>
                <c:pt idx="1585">
                  <c:v>0.63801</c:v>
                </c:pt>
                <c:pt idx="1586">
                  <c:v>2.931049999999952</c:v>
                </c:pt>
                <c:pt idx="1587">
                  <c:v>0.887514</c:v>
                </c:pt>
                <c:pt idx="1588">
                  <c:v>1.12702</c:v>
                </c:pt>
                <c:pt idx="1589">
                  <c:v>0.950015</c:v>
                </c:pt>
                <c:pt idx="1590">
                  <c:v>0.889014</c:v>
                </c:pt>
                <c:pt idx="1591">
                  <c:v>1.36152</c:v>
                </c:pt>
                <c:pt idx="1592">
                  <c:v>0.655011</c:v>
                </c:pt>
                <c:pt idx="1593">
                  <c:v>2.11803</c:v>
                </c:pt>
                <c:pt idx="1594">
                  <c:v>0.467007</c:v>
                </c:pt>
                <c:pt idx="1595">
                  <c:v>0.851014</c:v>
                </c:pt>
                <c:pt idx="1596">
                  <c:v>0.398506</c:v>
                </c:pt>
                <c:pt idx="1597">
                  <c:v>0.299005</c:v>
                </c:pt>
                <c:pt idx="1598">
                  <c:v>0.60001</c:v>
                </c:pt>
                <c:pt idx="1599">
                  <c:v>1.01402</c:v>
                </c:pt>
                <c:pt idx="1600">
                  <c:v>1.10152</c:v>
                </c:pt>
                <c:pt idx="1601">
                  <c:v>1.40202</c:v>
                </c:pt>
                <c:pt idx="1602">
                  <c:v>1.36802</c:v>
                </c:pt>
                <c:pt idx="1603">
                  <c:v>0.559009</c:v>
                </c:pt>
                <c:pt idx="1604">
                  <c:v>1.71253</c:v>
                </c:pt>
                <c:pt idx="1605">
                  <c:v>1.25202</c:v>
                </c:pt>
                <c:pt idx="1606">
                  <c:v>0.479508</c:v>
                </c:pt>
                <c:pt idx="1607">
                  <c:v>0.673011</c:v>
                </c:pt>
                <c:pt idx="1608">
                  <c:v>1.06602</c:v>
                </c:pt>
                <c:pt idx="1609">
                  <c:v>1.31452</c:v>
                </c:pt>
                <c:pt idx="1610">
                  <c:v>2.38704</c:v>
                </c:pt>
                <c:pt idx="1611">
                  <c:v>1.20402</c:v>
                </c:pt>
                <c:pt idx="1612">
                  <c:v>1.17802</c:v>
                </c:pt>
                <c:pt idx="1613">
                  <c:v>1.69503</c:v>
                </c:pt>
                <c:pt idx="1614">
                  <c:v>1.44002</c:v>
                </c:pt>
                <c:pt idx="1615">
                  <c:v>0.952015</c:v>
                </c:pt>
                <c:pt idx="1616">
                  <c:v>2.82105</c:v>
                </c:pt>
                <c:pt idx="1617">
                  <c:v>2.395039999999998</c:v>
                </c:pt>
                <c:pt idx="1618">
                  <c:v>1.52552</c:v>
                </c:pt>
                <c:pt idx="1619">
                  <c:v>2.14653</c:v>
                </c:pt>
                <c:pt idx="1620">
                  <c:v>1.12952</c:v>
                </c:pt>
                <c:pt idx="1621">
                  <c:v>2.53104</c:v>
                </c:pt>
                <c:pt idx="1622">
                  <c:v>4.01656</c:v>
                </c:pt>
                <c:pt idx="1623">
                  <c:v>1.91053</c:v>
                </c:pt>
                <c:pt idx="1624">
                  <c:v>0.949015</c:v>
                </c:pt>
                <c:pt idx="1625">
                  <c:v>3.698059999999998</c:v>
                </c:pt>
                <c:pt idx="1626">
                  <c:v>1.88403</c:v>
                </c:pt>
                <c:pt idx="1627">
                  <c:v>4.841579999999999</c:v>
                </c:pt>
                <c:pt idx="1628">
                  <c:v>3.48306</c:v>
                </c:pt>
                <c:pt idx="1629">
                  <c:v>3.77006</c:v>
                </c:pt>
                <c:pt idx="1630">
                  <c:v>2.63004</c:v>
                </c:pt>
                <c:pt idx="1631">
                  <c:v>1.73803</c:v>
                </c:pt>
                <c:pt idx="1632">
                  <c:v>4.98858</c:v>
                </c:pt>
                <c:pt idx="1633">
                  <c:v>2.452039999999998</c:v>
                </c:pt>
                <c:pt idx="1634">
                  <c:v>3.060049999999999</c:v>
                </c:pt>
                <c:pt idx="1635">
                  <c:v>1.14152</c:v>
                </c:pt>
                <c:pt idx="1636">
                  <c:v>1.87103</c:v>
                </c:pt>
                <c:pt idx="1637">
                  <c:v>1.84603</c:v>
                </c:pt>
                <c:pt idx="1638">
                  <c:v>5.13958</c:v>
                </c:pt>
                <c:pt idx="1639">
                  <c:v>2.76904</c:v>
                </c:pt>
                <c:pt idx="1640">
                  <c:v>1.09702</c:v>
                </c:pt>
                <c:pt idx="1641">
                  <c:v>3.870559999999998</c:v>
                </c:pt>
                <c:pt idx="1642">
                  <c:v>6.393099999999999</c:v>
                </c:pt>
                <c:pt idx="1643">
                  <c:v>2.64654</c:v>
                </c:pt>
                <c:pt idx="1644">
                  <c:v>5.79309</c:v>
                </c:pt>
                <c:pt idx="1645">
                  <c:v>4.747579999999997</c:v>
                </c:pt>
                <c:pt idx="1646">
                  <c:v>2.26604</c:v>
                </c:pt>
                <c:pt idx="1647">
                  <c:v>1.08502</c:v>
                </c:pt>
                <c:pt idx="1648">
                  <c:v>2.74004</c:v>
                </c:pt>
                <c:pt idx="1649">
                  <c:v>4.823079999999996</c:v>
                </c:pt>
                <c:pt idx="1650">
                  <c:v>7.28562</c:v>
                </c:pt>
                <c:pt idx="1651">
                  <c:v>3.10605</c:v>
                </c:pt>
                <c:pt idx="1652">
                  <c:v>3.210049999999999</c:v>
                </c:pt>
                <c:pt idx="1653">
                  <c:v>3.27155</c:v>
                </c:pt>
                <c:pt idx="1654">
                  <c:v>4.612069999999996</c:v>
                </c:pt>
                <c:pt idx="1655">
                  <c:v>4.317069999999997</c:v>
                </c:pt>
                <c:pt idx="1656">
                  <c:v>4.63307</c:v>
                </c:pt>
                <c:pt idx="1657">
                  <c:v>3.23105</c:v>
                </c:pt>
                <c:pt idx="1658">
                  <c:v>5.414089999999994</c:v>
                </c:pt>
                <c:pt idx="1659">
                  <c:v>8.24063</c:v>
                </c:pt>
                <c:pt idx="1660">
                  <c:v>3.69606</c:v>
                </c:pt>
                <c:pt idx="1661">
                  <c:v>7.712119999999984</c:v>
                </c:pt>
                <c:pt idx="1662">
                  <c:v>2.26504</c:v>
                </c:pt>
                <c:pt idx="1663">
                  <c:v>6.0731</c:v>
                </c:pt>
                <c:pt idx="1664">
                  <c:v>3.42856</c:v>
                </c:pt>
                <c:pt idx="1665">
                  <c:v>4.94958</c:v>
                </c:pt>
                <c:pt idx="1666">
                  <c:v>1.91303</c:v>
                </c:pt>
                <c:pt idx="1667">
                  <c:v>7.062109999999985</c:v>
                </c:pt>
                <c:pt idx="1668">
                  <c:v>3.08355</c:v>
                </c:pt>
                <c:pt idx="1669">
                  <c:v>1.56253</c:v>
                </c:pt>
                <c:pt idx="1670">
                  <c:v>4.54707</c:v>
                </c:pt>
                <c:pt idx="1671">
                  <c:v>9.35965</c:v>
                </c:pt>
                <c:pt idx="1672">
                  <c:v>2.97005</c:v>
                </c:pt>
                <c:pt idx="1673">
                  <c:v>2.28604</c:v>
                </c:pt>
                <c:pt idx="1674">
                  <c:v>2.97905</c:v>
                </c:pt>
                <c:pt idx="1675">
                  <c:v>1.11602</c:v>
                </c:pt>
                <c:pt idx="1676">
                  <c:v>2.50604</c:v>
                </c:pt>
                <c:pt idx="1677">
                  <c:v>7.507119999999984</c:v>
                </c:pt>
                <c:pt idx="1678">
                  <c:v>3.75756</c:v>
                </c:pt>
                <c:pt idx="1679">
                  <c:v>2.25754</c:v>
                </c:pt>
                <c:pt idx="1680">
                  <c:v>6.696109999999995</c:v>
                </c:pt>
                <c:pt idx="1681">
                  <c:v>2.76104</c:v>
                </c:pt>
                <c:pt idx="1682">
                  <c:v>2.22054</c:v>
                </c:pt>
                <c:pt idx="1683">
                  <c:v>2.892549999999952</c:v>
                </c:pt>
                <c:pt idx="1684">
                  <c:v>2.46104</c:v>
                </c:pt>
                <c:pt idx="1685">
                  <c:v>2.64804</c:v>
                </c:pt>
                <c:pt idx="1686">
                  <c:v>5.600589999999975</c:v>
                </c:pt>
                <c:pt idx="1687">
                  <c:v>1.73803</c:v>
                </c:pt>
                <c:pt idx="1688">
                  <c:v>3.106549999999999</c:v>
                </c:pt>
                <c:pt idx="1689">
                  <c:v>5.025079999999996</c:v>
                </c:pt>
                <c:pt idx="1690">
                  <c:v>7.73362</c:v>
                </c:pt>
                <c:pt idx="1691">
                  <c:v>3.28455</c:v>
                </c:pt>
                <c:pt idx="1692">
                  <c:v>1.89303</c:v>
                </c:pt>
                <c:pt idx="1693">
                  <c:v>1.18502</c:v>
                </c:pt>
                <c:pt idx="1694">
                  <c:v>3.02705</c:v>
                </c:pt>
                <c:pt idx="1695">
                  <c:v>5.063079999999998</c:v>
                </c:pt>
                <c:pt idx="1696">
                  <c:v>6.1351</c:v>
                </c:pt>
                <c:pt idx="1697">
                  <c:v>2.78854</c:v>
                </c:pt>
                <c:pt idx="1698">
                  <c:v>1.76003</c:v>
                </c:pt>
                <c:pt idx="1699">
                  <c:v>4.659569999999999</c:v>
                </c:pt>
                <c:pt idx="1700">
                  <c:v>3.78906</c:v>
                </c:pt>
                <c:pt idx="1701">
                  <c:v>2.88905</c:v>
                </c:pt>
                <c:pt idx="1702">
                  <c:v>2.12953</c:v>
                </c:pt>
                <c:pt idx="1703">
                  <c:v>5.08508</c:v>
                </c:pt>
                <c:pt idx="1704">
                  <c:v>3.16855</c:v>
                </c:pt>
                <c:pt idx="1705">
                  <c:v>1.70603</c:v>
                </c:pt>
                <c:pt idx="1706">
                  <c:v>2.73254</c:v>
                </c:pt>
                <c:pt idx="1707">
                  <c:v>2.354039999999999</c:v>
                </c:pt>
                <c:pt idx="1708">
                  <c:v>2.318039999999998</c:v>
                </c:pt>
                <c:pt idx="1709">
                  <c:v>5.09308</c:v>
                </c:pt>
                <c:pt idx="1710">
                  <c:v>5.056579999999999</c:v>
                </c:pt>
                <c:pt idx="1711">
                  <c:v>6.93361</c:v>
                </c:pt>
                <c:pt idx="1712">
                  <c:v>3.87956</c:v>
                </c:pt>
                <c:pt idx="1713">
                  <c:v>5.528089999999994</c:v>
                </c:pt>
                <c:pt idx="1714">
                  <c:v>5.877589999999984</c:v>
                </c:pt>
                <c:pt idx="1715">
                  <c:v>2.432039999999998</c:v>
                </c:pt>
                <c:pt idx="1716">
                  <c:v>3.04055</c:v>
                </c:pt>
                <c:pt idx="1717">
                  <c:v>3.12705</c:v>
                </c:pt>
                <c:pt idx="1718">
                  <c:v>4.06607</c:v>
                </c:pt>
                <c:pt idx="1719">
                  <c:v>7.724119999999964</c:v>
                </c:pt>
                <c:pt idx="1720">
                  <c:v>6.97761</c:v>
                </c:pt>
                <c:pt idx="1721">
                  <c:v>3.34805</c:v>
                </c:pt>
                <c:pt idx="1722">
                  <c:v>4.062069999999999</c:v>
                </c:pt>
                <c:pt idx="1723">
                  <c:v>4.810079999999997</c:v>
                </c:pt>
                <c:pt idx="1724">
                  <c:v>4.39907</c:v>
                </c:pt>
                <c:pt idx="1725">
                  <c:v>5.114579999999965</c:v>
                </c:pt>
                <c:pt idx="1726">
                  <c:v>3.72956</c:v>
                </c:pt>
                <c:pt idx="1727">
                  <c:v>2.46054</c:v>
                </c:pt>
                <c:pt idx="1728">
                  <c:v>3.342049999999956</c:v>
                </c:pt>
                <c:pt idx="1729">
                  <c:v>4.20307</c:v>
                </c:pt>
                <c:pt idx="1730">
                  <c:v>4.38807</c:v>
                </c:pt>
                <c:pt idx="1731">
                  <c:v>3.76106</c:v>
                </c:pt>
                <c:pt idx="1732">
                  <c:v>5.41909</c:v>
                </c:pt>
                <c:pt idx="1733">
                  <c:v>3.03905</c:v>
                </c:pt>
                <c:pt idx="1734">
                  <c:v>3.04355</c:v>
                </c:pt>
                <c:pt idx="1735">
                  <c:v>8.56014</c:v>
                </c:pt>
                <c:pt idx="1736">
                  <c:v>5.852089999999984</c:v>
                </c:pt>
                <c:pt idx="1737">
                  <c:v>7.05111</c:v>
                </c:pt>
                <c:pt idx="1738">
                  <c:v>3.16705</c:v>
                </c:pt>
                <c:pt idx="1739">
                  <c:v>6.661109999999986</c:v>
                </c:pt>
                <c:pt idx="1740">
                  <c:v>3.79006</c:v>
                </c:pt>
                <c:pt idx="1741">
                  <c:v>4.47207</c:v>
                </c:pt>
                <c:pt idx="1742">
                  <c:v>3.276549999999998</c:v>
                </c:pt>
                <c:pt idx="1743">
                  <c:v>2.844549999999999</c:v>
                </c:pt>
                <c:pt idx="1744">
                  <c:v>6.835109999999998</c:v>
                </c:pt>
                <c:pt idx="1745">
                  <c:v>3.54206</c:v>
                </c:pt>
                <c:pt idx="1746">
                  <c:v>4.48957</c:v>
                </c:pt>
                <c:pt idx="1747">
                  <c:v>5.30959</c:v>
                </c:pt>
                <c:pt idx="1748">
                  <c:v>4.64607</c:v>
                </c:pt>
                <c:pt idx="1749">
                  <c:v>3.17755</c:v>
                </c:pt>
                <c:pt idx="1750">
                  <c:v>7.012109999999995</c:v>
                </c:pt>
                <c:pt idx="1751">
                  <c:v>14.2297</c:v>
                </c:pt>
                <c:pt idx="1752">
                  <c:v>8.989640000000004</c:v>
                </c:pt>
                <c:pt idx="1753">
                  <c:v>9.33765</c:v>
                </c:pt>
                <c:pt idx="1754">
                  <c:v>9.428650000000001</c:v>
                </c:pt>
                <c:pt idx="1755">
                  <c:v>6.2281</c:v>
                </c:pt>
                <c:pt idx="1756">
                  <c:v>6.2601</c:v>
                </c:pt>
                <c:pt idx="1757">
                  <c:v>5.300589999999985</c:v>
                </c:pt>
                <c:pt idx="1758">
                  <c:v>4.83808</c:v>
                </c:pt>
                <c:pt idx="1759">
                  <c:v>3.88606</c:v>
                </c:pt>
                <c:pt idx="1760">
                  <c:v>3.76956</c:v>
                </c:pt>
                <c:pt idx="1761">
                  <c:v>3.53206</c:v>
                </c:pt>
                <c:pt idx="1762">
                  <c:v>4.31107</c:v>
                </c:pt>
                <c:pt idx="1763">
                  <c:v>3.77006</c:v>
                </c:pt>
                <c:pt idx="1764">
                  <c:v>2.96305</c:v>
                </c:pt>
                <c:pt idx="1765">
                  <c:v>5.9436</c:v>
                </c:pt>
                <c:pt idx="1766">
                  <c:v>5.858589999999975</c:v>
                </c:pt>
                <c:pt idx="1767">
                  <c:v>9.686160000000001</c:v>
                </c:pt>
                <c:pt idx="1768">
                  <c:v>2.55904</c:v>
                </c:pt>
                <c:pt idx="1769">
                  <c:v>7.029109999999998</c:v>
                </c:pt>
                <c:pt idx="1770">
                  <c:v>4.13057</c:v>
                </c:pt>
                <c:pt idx="1771">
                  <c:v>8.51364</c:v>
                </c:pt>
                <c:pt idx="1772">
                  <c:v>2.87955</c:v>
                </c:pt>
                <c:pt idx="1773">
                  <c:v>6.660609999999996</c:v>
                </c:pt>
                <c:pt idx="1774">
                  <c:v>3.389549999999998</c:v>
                </c:pt>
                <c:pt idx="1775">
                  <c:v>3.400049999999998</c:v>
                </c:pt>
                <c:pt idx="1776">
                  <c:v>4.46607</c:v>
                </c:pt>
                <c:pt idx="1777">
                  <c:v>2.98705</c:v>
                </c:pt>
                <c:pt idx="1778">
                  <c:v>4.012559999999985</c:v>
                </c:pt>
                <c:pt idx="1779">
                  <c:v>5.128579999999975</c:v>
                </c:pt>
                <c:pt idx="1780">
                  <c:v>1.38302</c:v>
                </c:pt>
                <c:pt idx="1781">
                  <c:v>5.308589999999985</c:v>
                </c:pt>
                <c:pt idx="1782">
                  <c:v>3.26405</c:v>
                </c:pt>
                <c:pt idx="1783">
                  <c:v>6.4191</c:v>
                </c:pt>
                <c:pt idx="1784">
                  <c:v>6.2726</c:v>
                </c:pt>
                <c:pt idx="1785">
                  <c:v>1.30002</c:v>
                </c:pt>
                <c:pt idx="1786">
                  <c:v>2.54854</c:v>
                </c:pt>
                <c:pt idx="1787">
                  <c:v>6.124099999999975</c:v>
                </c:pt>
                <c:pt idx="1788">
                  <c:v>4.320569999999996</c:v>
                </c:pt>
                <c:pt idx="1789">
                  <c:v>4.31957</c:v>
                </c:pt>
                <c:pt idx="1790">
                  <c:v>4.555569999999999</c:v>
                </c:pt>
                <c:pt idx="1791">
                  <c:v>5.00108</c:v>
                </c:pt>
                <c:pt idx="1792">
                  <c:v>2.92355</c:v>
                </c:pt>
                <c:pt idx="1793">
                  <c:v>2.59054</c:v>
                </c:pt>
                <c:pt idx="1794">
                  <c:v>11.1292</c:v>
                </c:pt>
                <c:pt idx="1795">
                  <c:v>6.4821</c:v>
                </c:pt>
                <c:pt idx="1796">
                  <c:v>4.71808</c:v>
                </c:pt>
                <c:pt idx="1797">
                  <c:v>8.12363</c:v>
                </c:pt>
                <c:pt idx="1798">
                  <c:v>3.04055</c:v>
                </c:pt>
                <c:pt idx="1799">
                  <c:v>9.386650000000002</c:v>
                </c:pt>
                <c:pt idx="1800">
                  <c:v>2.970549999999998</c:v>
                </c:pt>
                <c:pt idx="1801">
                  <c:v>4.823079999999996</c:v>
                </c:pt>
                <c:pt idx="1802">
                  <c:v>9.068150000000001</c:v>
                </c:pt>
                <c:pt idx="1803">
                  <c:v>4.50957</c:v>
                </c:pt>
                <c:pt idx="1804">
                  <c:v>3.216549999999998</c:v>
                </c:pt>
                <c:pt idx="1805">
                  <c:v>7.91313</c:v>
                </c:pt>
                <c:pt idx="1806">
                  <c:v>1.53952</c:v>
                </c:pt>
                <c:pt idx="1807">
                  <c:v>8.716640000000003</c:v>
                </c:pt>
                <c:pt idx="1808">
                  <c:v>6.5416</c:v>
                </c:pt>
                <c:pt idx="1809">
                  <c:v>5.9741</c:v>
                </c:pt>
                <c:pt idx="1810">
                  <c:v>2.30854</c:v>
                </c:pt>
                <c:pt idx="1811">
                  <c:v>6.963109999999999</c:v>
                </c:pt>
                <c:pt idx="1812">
                  <c:v>5.193579999999995</c:v>
                </c:pt>
                <c:pt idx="1813">
                  <c:v>2.54704</c:v>
                </c:pt>
                <c:pt idx="1814">
                  <c:v>5.39985</c:v>
                </c:pt>
                <c:pt idx="1815">
                  <c:v>3.48056</c:v>
                </c:pt>
                <c:pt idx="1816">
                  <c:v>3.998559999999999</c:v>
                </c:pt>
                <c:pt idx="1817">
                  <c:v>1.50102</c:v>
                </c:pt>
                <c:pt idx="1818">
                  <c:v>1.61653</c:v>
                </c:pt>
                <c:pt idx="1819">
                  <c:v>2.95155</c:v>
                </c:pt>
                <c:pt idx="1820">
                  <c:v>1.74353</c:v>
                </c:pt>
                <c:pt idx="1821">
                  <c:v>2.21604</c:v>
                </c:pt>
                <c:pt idx="1822">
                  <c:v>2.854049999999956</c:v>
                </c:pt>
                <c:pt idx="1823">
                  <c:v>1.76753</c:v>
                </c:pt>
                <c:pt idx="1824">
                  <c:v>3.05255</c:v>
                </c:pt>
                <c:pt idx="1825">
                  <c:v>1.31552</c:v>
                </c:pt>
                <c:pt idx="1826">
                  <c:v>1.63503</c:v>
                </c:pt>
                <c:pt idx="1827">
                  <c:v>4.58307</c:v>
                </c:pt>
                <c:pt idx="1828">
                  <c:v>4.09007</c:v>
                </c:pt>
                <c:pt idx="1829">
                  <c:v>1.55702</c:v>
                </c:pt>
                <c:pt idx="1830">
                  <c:v>1.91653</c:v>
                </c:pt>
                <c:pt idx="1831">
                  <c:v>2.05003</c:v>
                </c:pt>
                <c:pt idx="1832">
                  <c:v>3.977059999999998</c:v>
                </c:pt>
                <c:pt idx="1833">
                  <c:v>2.30754</c:v>
                </c:pt>
                <c:pt idx="1834">
                  <c:v>6.0401</c:v>
                </c:pt>
                <c:pt idx="1835">
                  <c:v>2.536039999999999</c:v>
                </c:pt>
                <c:pt idx="1836">
                  <c:v>1.73953</c:v>
                </c:pt>
                <c:pt idx="1837">
                  <c:v>1.52652</c:v>
                </c:pt>
                <c:pt idx="1838">
                  <c:v>2.60404</c:v>
                </c:pt>
                <c:pt idx="1839">
                  <c:v>1.61703</c:v>
                </c:pt>
                <c:pt idx="1840">
                  <c:v>3.78906</c:v>
                </c:pt>
                <c:pt idx="1841">
                  <c:v>1.73403</c:v>
                </c:pt>
                <c:pt idx="1842">
                  <c:v>3.84256</c:v>
                </c:pt>
                <c:pt idx="1843">
                  <c:v>2.78504</c:v>
                </c:pt>
                <c:pt idx="1844">
                  <c:v>0.990516</c:v>
                </c:pt>
                <c:pt idx="1845">
                  <c:v>1.02252</c:v>
                </c:pt>
                <c:pt idx="1846">
                  <c:v>2.76854</c:v>
                </c:pt>
                <c:pt idx="1847">
                  <c:v>1.14202</c:v>
                </c:pt>
                <c:pt idx="1848">
                  <c:v>0.967016</c:v>
                </c:pt>
                <c:pt idx="1849">
                  <c:v>0.832513</c:v>
                </c:pt>
                <c:pt idx="1850">
                  <c:v>1.17952</c:v>
                </c:pt>
                <c:pt idx="1851">
                  <c:v>1.86253</c:v>
                </c:pt>
                <c:pt idx="1852">
                  <c:v>2.956049999999952</c:v>
                </c:pt>
                <c:pt idx="1853">
                  <c:v>1.73403</c:v>
                </c:pt>
                <c:pt idx="1854">
                  <c:v>0.862514</c:v>
                </c:pt>
                <c:pt idx="1855">
                  <c:v>4.317569999999995</c:v>
                </c:pt>
                <c:pt idx="1856">
                  <c:v>2.93555</c:v>
                </c:pt>
                <c:pt idx="1857">
                  <c:v>0.869514</c:v>
                </c:pt>
                <c:pt idx="1858">
                  <c:v>1.47552</c:v>
                </c:pt>
                <c:pt idx="1859">
                  <c:v>1.32602</c:v>
                </c:pt>
                <c:pt idx="1860">
                  <c:v>2.58104</c:v>
                </c:pt>
                <c:pt idx="1861">
                  <c:v>1.98253</c:v>
                </c:pt>
                <c:pt idx="1862">
                  <c:v>1.45702</c:v>
                </c:pt>
                <c:pt idx="1863">
                  <c:v>2.70004</c:v>
                </c:pt>
                <c:pt idx="1864">
                  <c:v>5.166579999999985</c:v>
                </c:pt>
                <c:pt idx="1865">
                  <c:v>0.793013</c:v>
                </c:pt>
                <c:pt idx="1866">
                  <c:v>1.77053</c:v>
                </c:pt>
                <c:pt idx="1867">
                  <c:v>0.760512</c:v>
                </c:pt>
                <c:pt idx="1868">
                  <c:v>1.62503</c:v>
                </c:pt>
                <c:pt idx="1869">
                  <c:v>1.26552</c:v>
                </c:pt>
                <c:pt idx="1870">
                  <c:v>1.51302</c:v>
                </c:pt>
                <c:pt idx="1871">
                  <c:v>0.818013</c:v>
                </c:pt>
                <c:pt idx="1872">
                  <c:v>1.14502</c:v>
                </c:pt>
                <c:pt idx="1873">
                  <c:v>0.944015</c:v>
                </c:pt>
                <c:pt idx="1874">
                  <c:v>1.84053</c:v>
                </c:pt>
                <c:pt idx="1875">
                  <c:v>2.29304</c:v>
                </c:pt>
                <c:pt idx="1876">
                  <c:v>2.88005</c:v>
                </c:pt>
                <c:pt idx="1877">
                  <c:v>1.91053</c:v>
                </c:pt>
                <c:pt idx="1878">
                  <c:v>2.35354</c:v>
                </c:pt>
                <c:pt idx="1879">
                  <c:v>4.50857</c:v>
                </c:pt>
                <c:pt idx="1880">
                  <c:v>3.58806</c:v>
                </c:pt>
                <c:pt idx="1881">
                  <c:v>5.09108</c:v>
                </c:pt>
                <c:pt idx="1882">
                  <c:v>7.077109999999998</c:v>
                </c:pt>
                <c:pt idx="1883">
                  <c:v>2.74254</c:v>
                </c:pt>
                <c:pt idx="1884">
                  <c:v>2.49304</c:v>
                </c:pt>
                <c:pt idx="1885">
                  <c:v>0.932015</c:v>
                </c:pt>
                <c:pt idx="1886">
                  <c:v>0.806013</c:v>
                </c:pt>
                <c:pt idx="1887">
                  <c:v>0.501508</c:v>
                </c:pt>
                <c:pt idx="1888">
                  <c:v>1.12002</c:v>
                </c:pt>
                <c:pt idx="1889">
                  <c:v>1.52652</c:v>
                </c:pt>
                <c:pt idx="1890">
                  <c:v>1.01602</c:v>
                </c:pt>
                <c:pt idx="1891">
                  <c:v>1.88103</c:v>
                </c:pt>
                <c:pt idx="1892">
                  <c:v>1.26802</c:v>
                </c:pt>
                <c:pt idx="1893">
                  <c:v>1.58003</c:v>
                </c:pt>
                <c:pt idx="1894">
                  <c:v>1.24152</c:v>
                </c:pt>
                <c:pt idx="1895">
                  <c:v>2.02653</c:v>
                </c:pt>
                <c:pt idx="1896">
                  <c:v>2.075029999999999</c:v>
                </c:pt>
                <c:pt idx="1897">
                  <c:v>1.40002</c:v>
                </c:pt>
                <c:pt idx="1898">
                  <c:v>1.25902</c:v>
                </c:pt>
                <c:pt idx="1899">
                  <c:v>1.69603</c:v>
                </c:pt>
                <c:pt idx="1900">
                  <c:v>1.20752</c:v>
                </c:pt>
                <c:pt idx="1901">
                  <c:v>2.056029999999998</c:v>
                </c:pt>
                <c:pt idx="1902">
                  <c:v>3.061049999999998</c:v>
                </c:pt>
                <c:pt idx="1903">
                  <c:v>3.54456</c:v>
                </c:pt>
                <c:pt idx="1904">
                  <c:v>0.870014</c:v>
                </c:pt>
                <c:pt idx="1905">
                  <c:v>2.71854</c:v>
                </c:pt>
                <c:pt idx="1906">
                  <c:v>3.58856</c:v>
                </c:pt>
                <c:pt idx="1907">
                  <c:v>1.46802</c:v>
                </c:pt>
                <c:pt idx="1908">
                  <c:v>1.27702</c:v>
                </c:pt>
                <c:pt idx="1909">
                  <c:v>2.19904</c:v>
                </c:pt>
                <c:pt idx="1910">
                  <c:v>5.27108</c:v>
                </c:pt>
                <c:pt idx="1911">
                  <c:v>3.03805</c:v>
                </c:pt>
                <c:pt idx="1912">
                  <c:v>7.025609999999999</c:v>
                </c:pt>
                <c:pt idx="1913">
                  <c:v>5.43009</c:v>
                </c:pt>
                <c:pt idx="1914">
                  <c:v>3.000049999999999</c:v>
                </c:pt>
                <c:pt idx="1915">
                  <c:v>2.49754</c:v>
                </c:pt>
                <c:pt idx="1916">
                  <c:v>3.71306</c:v>
                </c:pt>
                <c:pt idx="1917">
                  <c:v>7.897629999999999</c:v>
                </c:pt>
                <c:pt idx="1918">
                  <c:v>2.49754</c:v>
                </c:pt>
                <c:pt idx="1919">
                  <c:v>4.610569999999996</c:v>
                </c:pt>
                <c:pt idx="1920">
                  <c:v>3.542559999999999</c:v>
                </c:pt>
                <c:pt idx="1921">
                  <c:v>4.888079999999999</c:v>
                </c:pt>
                <c:pt idx="1922">
                  <c:v>4.157069999999996</c:v>
                </c:pt>
                <c:pt idx="1923">
                  <c:v>4.97958</c:v>
                </c:pt>
                <c:pt idx="1924">
                  <c:v>5.072579999999999</c:v>
                </c:pt>
                <c:pt idx="1925">
                  <c:v>1.97803</c:v>
                </c:pt>
                <c:pt idx="1926">
                  <c:v>3.66906</c:v>
                </c:pt>
                <c:pt idx="1927">
                  <c:v>2.33354</c:v>
                </c:pt>
                <c:pt idx="1928">
                  <c:v>2.853549999999998</c:v>
                </c:pt>
                <c:pt idx="1929">
                  <c:v>4.04706</c:v>
                </c:pt>
                <c:pt idx="1930">
                  <c:v>5.004079999999997</c:v>
                </c:pt>
                <c:pt idx="1931">
                  <c:v>2.44354</c:v>
                </c:pt>
                <c:pt idx="1932">
                  <c:v>2.359039999999998</c:v>
                </c:pt>
                <c:pt idx="1933">
                  <c:v>3.77706</c:v>
                </c:pt>
                <c:pt idx="1934">
                  <c:v>4.49057</c:v>
                </c:pt>
                <c:pt idx="1935">
                  <c:v>5.457589999999985</c:v>
                </c:pt>
                <c:pt idx="1936">
                  <c:v>7.70912</c:v>
                </c:pt>
                <c:pt idx="1937">
                  <c:v>3.18255</c:v>
                </c:pt>
                <c:pt idx="1938">
                  <c:v>1.57503</c:v>
                </c:pt>
                <c:pt idx="1939">
                  <c:v>4.682079999999995</c:v>
                </c:pt>
                <c:pt idx="1940">
                  <c:v>3.76056</c:v>
                </c:pt>
                <c:pt idx="1941">
                  <c:v>2.71904</c:v>
                </c:pt>
                <c:pt idx="1942">
                  <c:v>2.13853</c:v>
                </c:pt>
                <c:pt idx="1943">
                  <c:v>3.26955</c:v>
                </c:pt>
                <c:pt idx="1944">
                  <c:v>3.706059999999999</c:v>
                </c:pt>
                <c:pt idx="1945">
                  <c:v>4.964579999999994</c:v>
                </c:pt>
                <c:pt idx="1946">
                  <c:v>6.182099999999997</c:v>
                </c:pt>
                <c:pt idx="1947">
                  <c:v>4.687579999999976</c:v>
                </c:pt>
                <c:pt idx="1948">
                  <c:v>6.198099999999997</c:v>
                </c:pt>
                <c:pt idx="1949">
                  <c:v>2.350039999999999</c:v>
                </c:pt>
                <c:pt idx="1950">
                  <c:v>2.58954</c:v>
                </c:pt>
                <c:pt idx="1951">
                  <c:v>4.794079999999996</c:v>
                </c:pt>
                <c:pt idx="1952">
                  <c:v>4.64107</c:v>
                </c:pt>
                <c:pt idx="1953">
                  <c:v>4.142069999999999</c:v>
                </c:pt>
                <c:pt idx="1954">
                  <c:v>8.677140000000001</c:v>
                </c:pt>
                <c:pt idx="1955">
                  <c:v>4.58707</c:v>
                </c:pt>
                <c:pt idx="1956">
                  <c:v>2.72754</c:v>
                </c:pt>
                <c:pt idx="1957">
                  <c:v>5.77409</c:v>
                </c:pt>
                <c:pt idx="1958">
                  <c:v>6.817109999999976</c:v>
                </c:pt>
                <c:pt idx="1959">
                  <c:v>5.463589999999995</c:v>
                </c:pt>
                <c:pt idx="1960">
                  <c:v>3.32005</c:v>
                </c:pt>
                <c:pt idx="1961">
                  <c:v>7.562119999999974</c:v>
                </c:pt>
                <c:pt idx="1962">
                  <c:v>5.227579999999985</c:v>
                </c:pt>
                <c:pt idx="1963">
                  <c:v>4.664569999999966</c:v>
                </c:pt>
                <c:pt idx="1964">
                  <c:v>6.3011</c:v>
                </c:pt>
                <c:pt idx="1965">
                  <c:v>6.562609999999998</c:v>
                </c:pt>
                <c:pt idx="1966">
                  <c:v>9.075650000000004</c:v>
                </c:pt>
                <c:pt idx="1967">
                  <c:v>1.93053</c:v>
                </c:pt>
                <c:pt idx="1968">
                  <c:v>2.42404</c:v>
                </c:pt>
                <c:pt idx="1969">
                  <c:v>1.36752</c:v>
                </c:pt>
                <c:pt idx="1970">
                  <c:v>1.66003</c:v>
                </c:pt>
                <c:pt idx="1971">
                  <c:v>5.90859</c:v>
                </c:pt>
                <c:pt idx="1972">
                  <c:v>3.864059999999998</c:v>
                </c:pt>
                <c:pt idx="1973">
                  <c:v>3.28405</c:v>
                </c:pt>
                <c:pt idx="1974">
                  <c:v>4.637069999999999</c:v>
                </c:pt>
                <c:pt idx="1975">
                  <c:v>2.99255</c:v>
                </c:pt>
                <c:pt idx="1976">
                  <c:v>4.71158</c:v>
                </c:pt>
                <c:pt idx="1977">
                  <c:v>7.77662</c:v>
                </c:pt>
                <c:pt idx="1978">
                  <c:v>7.61662</c:v>
                </c:pt>
                <c:pt idx="1979">
                  <c:v>4.51157</c:v>
                </c:pt>
                <c:pt idx="1980">
                  <c:v>3.31055</c:v>
                </c:pt>
                <c:pt idx="1981">
                  <c:v>4.29207</c:v>
                </c:pt>
                <c:pt idx="1982">
                  <c:v>4.695079999999986</c:v>
                </c:pt>
                <c:pt idx="1983">
                  <c:v>9.733159999999996</c:v>
                </c:pt>
                <c:pt idx="1984">
                  <c:v>8.712140000000001</c:v>
                </c:pt>
                <c:pt idx="1985">
                  <c:v>4.524569999999994</c:v>
                </c:pt>
                <c:pt idx="1986">
                  <c:v>10.4667</c:v>
                </c:pt>
                <c:pt idx="1987">
                  <c:v>11.0687</c:v>
                </c:pt>
                <c:pt idx="1988">
                  <c:v>7.92613</c:v>
                </c:pt>
                <c:pt idx="1989">
                  <c:v>7.029109999999998</c:v>
                </c:pt>
                <c:pt idx="1990">
                  <c:v>3.20005</c:v>
                </c:pt>
                <c:pt idx="1991">
                  <c:v>5.632589999999975</c:v>
                </c:pt>
                <c:pt idx="1992">
                  <c:v>4.664069999999985</c:v>
                </c:pt>
                <c:pt idx="1993">
                  <c:v>5.312589999999965</c:v>
                </c:pt>
                <c:pt idx="1994">
                  <c:v>6.734109999999998</c:v>
                </c:pt>
                <c:pt idx="1995">
                  <c:v>7.03511</c:v>
                </c:pt>
                <c:pt idx="1996">
                  <c:v>4.23957</c:v>
                </c:pt>
                <c:pt idx="1997">
                  <c:v>2.88905</c:v>
                </c:pt>
                <c:pt idx="1998">
                  <c:v>5.302589999999975</c:v>
                </c:pt>
                <c:pt idx="1999">
                  <c:v>4.737579999999998</c:v>
                </c:pt>
                <c:pt idx="2000">
                  <c:v>3.97956</c:v>
                </c:pt>
                <c:pt idx="2001">
                  <c:v>3.162049999999998</c:v>
                </c:pt>
                <c:pt idx="2002">
                  <c:v>4.07257</c:v>
                </c:pt>
                <c:pt idx="2003">
                  <c:v>4.95508</c:v>
                </c:pt>
                <c:pt idx="2004">
                  <c:v>5.28158</c:v>
                </c:pt>
                <c:pt idx="2005">
                  <c:v>3.20505</c:v>
                </c:pt>
                <c:pt idx="2006">
                  <c:v>5.601589999999994</c:v>
                </c:pt>
                <c:pt idx="2007">
                  <c:v>6.3966</c:v>
                </c:pt>
                <c:pt idx="2008">
                  <c:v>2.973549999999999</c:v>
                </c:pt>
                <c:pt idx="2009">
                  <c:v>6.3266</c:v>
                </c:pt>
                <c:pt idx="2010">
                  <c:v>2.54504</c:v>
                </c:pt>
                <c:pt idx="2011">
                  <c:v>4.765579999999995</c:v>
                </c:pt>
                <c:pt idx="2012">
                  <c:v>3.993059999999998</c:v>
                </c:pt>
                <c:pt idx="2013">
                  <c:v>7.01911</c:v>
                </c:pt>
                <c:pt idx="2014">
                  <c:v>8.644640000000001</c:v>
                </c:pt>
                <c:pt idx="2015">
                  <c:v>5.655589999999964</c:v>
                </c:pt>
                <c:pt idx="2016">
                  <c:v>3.833559999999998</c:v>
                </c:pt>
                <c:pt idx="2017">
                  <c:v>3.89156</c:v>
                </c:pt>
                <c:pt idx="2018">
                  <c:v>4.94658</c:v>
                </c:pt>
                <c:pt idx="2019">
                  <c:v>4.31807</c:v>
                </c:pt>
                <c:pt idx="2020">
                  <c:v>2.812549999999952</c:v>
                </c:pt>
                <c:pt idx="2021">
                  <c:v>3.11505</c:v>
                </c:pt>
                <c:pt idx="2022">
                  <c:v>3.56356</c:v>
                </c:pt>
                <c:pt idx="2023">
                  <c:v>6.105139999999984</c:v>
                </c:pt>
                <c:pt idx="2024">
                  <c:v>7.022109999999985</c:v>
                </c:pt>
                <c:pt idx="2025">
                  <c:v>4.294569999999998</c:v>
                </c:pt>
                <c:pt idx="2026">
                  <c:v>5.78659</c:v>
                </c:pt>
                <c:pt idx="2027">
                  <c:v>1.22152</c:v>
                </c:pt>
                <c:pt idx="2028">
                  <c:v>4.624569999999966</c:v>
                </c:pt>
                <c:pt idx="2029">
                  <c:v>5.196079999999998</c:v>
                </c:pt>
                <c:pt idx="2030">
                  <c:v>4.59857</c:v>
                </c:pt>
                <c:pt idx="2031">
                  <c:v>4.874079999999997</c:v>
                </c:pt>
                <c:pt idx="2032">
                  <c:v>7.27762</c:v>
                </c:pt>
                <c:pt idx="2033">
                  <c:v>2.37354</c:v>
                </c:pt>
                <c:pt idx="2034">
                  <c:v>6.1706</c:v>
                </c:pt>
                <c:pt idx="2035">
                  <c:v>3.338049999999956</c:v>
                </c:pt>
                <c:pt idx="2036">
                  <c:v>2.14503</c:v>
                </c:pt>
                <c:pt idx="2037">
                  <c:v>3.195549999999999</c:v>
                </c:pt>
                <c:pt idx="2038">
                  <c:v>4.41557</c:v>
                </c:pt>
                <c:pt idx="2039">
                  <c:v>5.425589999999985</c:v>
                </c:pt>
                <c:pt idx="2040">
                  <c:v>7.58262</c:v>
                </c:pt>
                <c:pt idx="2041">
                  <c:v>6.494099999999999</c:v>
                </c:pt>
                <c:pt idx="2042">
                  <c:v>7.55662</c:v>
                </c:pt>
                <c:pt idx="2043">
                  <c:v>8.414140000000001</c:v>
                </c:pt>
                <c:pt idx="2044">
                  <c:v>4.07757</c:v>
                </c:pt>
                <c:pt idx="2045">
                  <c:v>4.56307</c:v>
                </c:pt>
                <c:pt idx="2046">
                  <c:v>4.53757</c:v>
                </c:pt>
                <c:pt idx="2047">
                  <c:v>6.94761</c:v>
                </c:pt>
                <c:pt idx="2048">
                  <c:v>2.176029999999999</c:v>
                </c:pt>
                <c:pt idx="2049">
                  <c:v>7.326119999999975</c:v>
                </c:pt>
                <c:pt idx="2050">
                  <c:v>3.28955</c:v>
                </c:pt>
                <c:pt idx="2051">
                  <c:v>6.877109999999996</c:v>
                </c:pt>
                <c:pt idx="2052">
                  <c:v>9.07665</c:v>
                </c:pt>
                <c:pt idx="2053">
                  <c:v>4.43007</c:v>
                </c:pt>
                <c:pt idx="2054">
                  <c:v>3.18055</c:v>
                </c:pt>
                <c:pt idx="2055">
                  <c:v>4.869579999999996</c:v>
                </c:pt>
                <c:pt idx="2056">
                  <c:v>4.51107</c:v>
                </c:pt>
                <c:pt idx="2057">
                  <c:v>6.651109999999996</c:v>
                </c:pt>
                <c:pt idx="2058">
                  <c:v>2.94255</c:v>
                </c:pt>
                <c:pt idx="2059">
                  <c:v>4.22957</c:v>
                </c:pt>
                <c:pt idx="2060">
                  <c:v>5.80109</c:v>
                </c:pt>
                <c:pt idx="2061">
                  <c:v>4.392569999999996</c:v>
                </c:pt>
                <c:pt idx="2062">
                  <c:v>6.672109999999995</c:v>
                </c:pt>
                <c:pt idx="2063">
                  <c:v>1.88503</c:v>
                </c:pt>
                <c:pt idx="2064">
                  <c:v>3.14555</c:v>
                </c:pt>
                <c:pt idx="2065">
                  <c:v>4.767079999999995</c:v>
                </c:pt>
                <c:pt idx="2066">
                  <c:v>5.85909</c:v>
                </c:pt>
                <c:pt idx="2067">
                  <c:v>4.90508</c:v>
                </c:pt>
                <c:pt idx="2068">
                  <c:v>4.68108</c:v>
                </c:pt>
                <c:pt idx="2069">
                  <c:v>3.74956</c:v>
                </c:pt>
                <c:pt idx="2070">
                  <c:v>5.08108</c:v>
                </c:pt>
                <c:pt idx="2071">
                  <c:v>7.63612</c:v>
                </c:pt>
                <c:pt idx="2072">
                  <c:v>3.099549999999998</c:v>
                </c:pt>
                <c:pt idx="2073">
                  <c:v>2.70904</c:v>
                </c:pt>
                <c:pt idx="2074">
                  <c:v>2.00703</c:v>
                </c:pt>
                <c:pt idx="2075">
                  <c:v>3.71956</c:v>
                </c:pt>
                <c:pt idx="2076">
                  <c:v>2.66204</c:v>
                </c:pt>
                <c:pt idx="2077">
                  <c:v>1.79703</c:v>
                </c:pt>
                <c:pt idx="2078">
                  <c:v>6.467099999999998</c:v>
                </c:pt>
                <c:pt idx="2079">
                  <c:v>4.91808</c:v>
                </c:pt>
                <c:pt idx="2080">
                  <c:v>2.67504</c:v>
                </c:pt>
                <c:pt idx="2081">
                  <c:v>4.24907</c:v>
                </c:pt>
                <c:pt idx="2082">
                  <c:v>2.839049999999952</c:v>
                </c:pt>
                <c:pt idx="2083">
                  <c:v>2.854049999999956</c:v>
                </c:pt>
                <c:pt idx="2084">
                  <c:v>2.92855</c:v>
                </c:pt>
                <c:pt idx="2085">
                  <c:v>3.20555</c:v>
                </c:pt>
                <c:pt idx="2086">
                  <c:v>4.180569999999999</c:v>
                </c:pt>
                <c:pt idx="2087">
                  <c:v>4.155569999999996</c:v>
                </c:pt>
                <c:pt idx="2088">
                  <c:v>5.44409</c:v>
                </c:pt>
                <c:pt idx="2089">
                  <c:v>1.56603</c:v>
                </c:pt>
                <c:pt idx="2090">
                  <c:v>2.72904</c:v>
                </c:pt>
                <c:pt idx="2091">
                  <c:v>6.627609999999985</c:v>
                </c:pt>
                <c:pt idx="2092">
                  <c:v>2.00503</c:v>
                </c:pt>
                <c:pt idx="2093">
                  <c:v>3.47656</c:v>
                </c:pt>
                <c:pt idx="2094">
                  <c:v>3.79006</c:v>
                </c:pt>
                <c:pt idx="2095">
                  <c:v>2.17353</c:v>
                </c:pt>
                <c:pt idx="2096">
                  <c:v>1.40502</c:v>
                </c:pt>
                <c:pt idx="2097">
                  <c:v>2.70604</c:v>
                </c:pt>
                <c:pt idx="2098">
                  <c:v>1.54352</c:v>
                </c:pt>
                <c:pt idx="2099">
                  <c:v>1.30902</c:v>
                </c:pt>
                <c:pt idx="2100">
                  <c:v>2.33854</c:v>
                </c:pt>
                <c:pt idx="2101">
                  <c:v>3.95806</c:v>
                </c:pt>
                <c:pt idx="2102">
                  <c:v>1.97003</c:v>
                </c:pt>
                <c:pt idx="2103">
                  <c:v>2.72354</c:v>
                </c:pt>
                <c:pt idx="2104">
                  <c:v>2.03003</c:v>
                </c:pt>
                <c:pt idx="2105">
                  <c:v>6.168599999999985</c:v>
                </c:pt>
                <c:pt idx="2106">
                  <c:v>4.712579999999995</c:v>
                </c:pt>
                <c:pt idx="2107">
                  <c:v>7.267119999999966</c:v>
                </c:pt>
                <c:pt idx="2108">
                  <c:v>2.01353</c:v>
                </c:pt>
                <c:pt idx="2109">
                  <c:v>2.88755</c:v>
                </c:pt>
                <c:pt idx="2110">
                  <c:v>1.60403</c:v>
                </c:pt>
                <c:pt idx="2111">
                  <c:v>2.52504</c:v>
                </c:pt>
                <c:pt idx="2112">
                  <c:v>3.121049999999999</c:v>
                </c:pt>
                <c:pt idx="2113">
                  <c:v>4.47557</c:v>
                </c:pt>
                <c:pt idx="2114">
                  <c:v>3.384049999999997</c:v>
                </c:pt>
                <c:pt idx="2115">
                  <c:v>3.06955</c:v>
                </c:pt>
                <c:pt idx="2116">
                  <c:v>2.55754</c:v>
                </c:pt>
                <c:pt idx="2117">
                  <c:v>3.566059999999998</c:v>
                </c:pt>
                <c:pt idx="2118">
                  <c:v>3.33555</c:v>
                </c:pt>
                <c:pt idx="2119">
                  <c:v>3.23855</c:v>
                </c:pt>
                <c:pt idx="2120">
                  <c:v>1.99203</c:v>
                </c:pt>
                <c:pt idx="2121">
                  <c:v>3.40655</c:v>
                </c:pt>
                <c:pt idx="2122">
                  <c:v>2.91805</c:v>
                </c:pt>
                <c:pt idx="2123">
                  <c:v>3.367049999999998</c:v>
                </c:pt>
                <c:pt idx="2124">
                  <c:v>1.56003</c:v>
                </c:pt>
                <c:pt idx="2125">
                  <c:v>2.83955</c:v>
                </c:pt>
                <c:pt idx="2126">
                  <c:v>0.908515</c:v>
                </c:pt>
                <c:pt idx="2127">
                  <c:v>2.07003</c:v>
                </c:pt>
                <c:pt idx="2128">
                  <c:v>1.40852</c:v>
                </c:pt>
                <c:pt idx="2129">
                  <c:v>4.634569999999996</c:v>
                </c:pt>
                <c:pt idx="2130">
                  <c:v>1.39152</c:v>
                </c:pt>
                <c:pt idx="2131">
                  <c:v>1.44702</c:v>
                </c:pt>
                <c:pt idx="2132">
                  <c:v>1.49402</c:v>
                </c:pt>
                <c:pt idx="2133">
                  <c:v>2.13153</c:v>
                </c:pt>
                <c:pt idx="2134">
                  <c:v>3.383049999999998</c:v>
                </c:pt>
                <c:pt idx="2135">
                  <c:v>3.72356</c:v>
                </c:pt>
                <c:pt idx="2136">
                  <c:v>1.62003</c:v>
                </c:pt>
                <c:pt idx="2137">
                  <c:v>3.00955</c:v>
                </c:pt>
                <c:pt idx="2138">
                  <c:v>1.90703</c:v>
                </c:pt>
                <c:pt idx="2139">
                  <c:v>2.99655</c:v>
                </c:pt>
                <c:pt idx="2140">
                  <c:v>1.72153</c:v>
                </c:pt>
                <c:pt idx="2141">
                  <c:v>1.75353</c:v>
                </c:pt>
                <c:pt idx="2142">
                  <c:v>3.66806</c:v>
                </c:pt>
                <c:pt idx="2143">
                  <c:v>3.61056</c:v>
                </c:pt>
                <c:pt idx="2144">
                  <c:v>4.154569999999985</c:v>
                </c:pt>
                <c:pt idx="2145">
                  <c:v>0.924515</c:v>
                </c:pt>
                <c:pt idx="2146">
                  <c:v>1.66703</c:v>
                </c:pt>
                <c:pt idx="2147">
                  <c:v>2.19654</c:v>
                </c:pt>
                <c:pt idx="2148">
                  <c:v>4.91908</c:v>
                </c:pt>
                <c:pt idx="2149">
                  <c:v>3.18805</c:v>
                </c:pt>
                <c:pt idx="2150">
                  <c:v>2.53304</c:v>
                </c:pt>
                <c:pt idx="2151">
                  <c:v>1.22252</c:v>
                </c:pt>
                <c:pt idx="2152">
                  <c:v>3.24805</c:v>
                </c:pt>
                <c:pt idx="2153">
                  <c:v>4.09907</c:v>
                </c:pt>
                <c:pt idx="2154">
                  <c:v>2.980049999999998</c:v>
                </c:pt>
                <c:pt idx="2155">
                  <c:v>4.692079999999985</c:v>
                </c:pt>
                <c:pt idx="2156">
                  <c:v>1.80803</c:v>
                </c:pt>
                <c:pt idx="2157">
                  <c:v>2.00203</c:v>
                </c:pt>
                <c:pt idx="2158">
                  <c:v>1.45102</c:v>
                </c:pt>
                <c:pt idx="2159">
                  <c:v>2.14203</c:v>
                </c:pt>
                <c:pt idx="2160">
                  <c:v>3.68656</c:v>
                </c:pt>
                <c:pt idx="2161">
                  <c:v>1.50202</c:v>
                </c:pt>
                <c:pt idx="2162">
                  <c:v>4.22957</c:v>
                </c:pt>
                <c:pt idx="2163">
                  <c:v>3.66906</c:v>
                </c:pt>
                <c:pt idx="2164">
                  <c:v>2.52554</c:v>
                </c:pt>
                <c:pt idx="2165">
                  <c:v>2.31854</c:v>
                </c:pt>
                <c:pt idx="2166">
                  <c:v>5.00508</c:v>
                </c:pt>
                <c:pt idx="2167">
                  <c:v>2.572039999999999</c:v>
                </c:pt>
                <c:pt idx="2168">
                  <c:v>1.33502</c:v>
                </c:pt>
                <c:pt idx="2169">
                  <c:v>2.27804</c:v>
                </c:pt>
                <c:pt idx="2170">
                  <c:v>2.860549999999999</c:v>
                </c:pt>
                <c:pt idx="2171">
                  <c:v>1.69053</c:v>
                </c:pt>
                <c:pt idx="2172">
                  <c:v>0.61701</c:v>
                </c:pt>
                <c:pt idx="2173">
                  <c:v>0.955015</c:v>
                </c:pt>
                <c:pt idx="2174">
                  <c:v>0.473008</c:v>
                </c:pt>
                <c:pt idx="2175">
                  <c:v>0.790513</c:v>
                </c:pt>
                <c:pt idx="2176">
                  <c:v>0.786513</c:v>
                </c:pt>
                <c:pt idx="2177">
                  <c:v>0.352506</c:v>
                </c:pt>
                <c:pt idx="2178">
                  <c:v>0.809013</c:v>
                </c:pt>
                <c:pt idx="2179">
                  <c:v>0.235004</c:v>
                </c:pt>
                <c:pt idx="2180">
                  <c:v>0.476508</c:v>
                </c:pt>
                <c:pt idx="2181">
                  <c:v>2.75054</c:v>
                </c:pt>
                <c:pt idx="2182">
                  <c:v>3.216549999999998</c:v>
                </c:pt>
                <c:pt idx="2183">
                  <c:v>0.719012</c:v>
                </c:pt>
                <c:pt idx="2184">
                  <c:v>2.70504</c:v>
                </c:pt>
                <c:pt idx="2185">
                  <c:v>2.57704</c:v>
                </c:pt>
                <c:pt idx="2186">
                  <c:v>1.43702</c:v>
                </c:pt>
                <c:pt idx="2187">
                  <c:v>1.00852</c:v>
                </c:pt>
                <c:pt idx="2188">
                  <c:v>0.857014</c:v>
                </c:pt>
                <c:pt idx="2189">
                  <c:v>1.71703</c:v>
                </c:pt>
                <c:pt idx="2190">
                  <c:v>4.56007</c:v>
                </c:pt>
                <c:pt idx="2191">
                  <c:v>1.84503</c:v>
                </c:pt>
                <c:pt idx="2192">
                  <c:v>1.58603</c:v>
                </c:pt>
                <c:pt idx="2193">
                  <c:v>0.658511</c:v>
                </c:pt>
                <c:pt idx="2194">
                  <c:v>1.59553</c:v>
                </c:pt>
                <c:pt idx="2195">
                  <c:v>1.82853</c:v>
                </c:pt>
                <c:pt idx="2196">
                  <c:v>2.13753</c:v>
                </c:pt>
                <c:pt idx="2197">
                  <c:v>2.382039999999999</c:v>
                </c:pt>
                <c:pt idx="2198">
                  <c:v>1.57203</c:v>
                </c:pt>
                <c:pt idx="2199">
                  <c:v>2.62604</c:v>
                </c:pt>
                <c:pt idx="2200">
                  <c:v>1.79103</c:v>
                </c:pt>
                <c:pt idx="2201">
                  <c:v>3.23355</c:v>
                </c:pt>
                <c:pt idx="2202">
                  <c:v>1.45602</c:v>
                </c:pt>
                <c:pt idx="2203">
                  <c:v>3.064049999999999</c:v>
                </c:pt>
                <c:pt idx="2204">
                  <c:v>1.55702</c:v>
                </c:pt>
                <c:pt idx="2205">
                  <c:v>3.71156</c:v>
                </c:pt>
                <c:pt idx="2206">
                  <c:v>2.65504</c:v>
                </c:pt>
                <c:pt idx="2207">
                  <c:v>1.61953</c:v>
                </c:pt>
                <c:pt idx="2208">
                  <c:v>0.925515</c:v>
                </c:pt>
                <c:pt idx="2209">
                  <c:v>2.57354</c:v>
                </c:pt>
                <c:pt idx="2210">
                  <c:v>1.19952</c:v>
                </c:pt>
                <c:pt idx="2211">
                  <c:v>1.85503</c:v>
                </c:pt>
                <c:pt idx="2212">
                  <c:v>1.40602</c:v>
                </c:pt>
                <c:pt idx="2213">
                  <c:v>1.19752</c:v>
                </c:pt>
                <c:pt idx="2214">
                  <c:v>0.840013</c:v>
                </c:pt>
                <c:pt idx="2215">
                  <c:v>1.38952</c:v>
                </c:pt>
                <c:pt idx="2216">
                  <c:v>0.731012</c:v>
                </c:pt>
                <c:pt idx="2217">
                  <c:v>1.65703</c:v>
                </c:pt>
                <c:pt idx="2218">
                  <c:v>2.01353</c:v>
                </c:pt>
                <c:pt idx="2219">
                  <c:v>1.73953</c:v>
                </c:pt>
                <c:pt idx="2220">
                  <c:v>0.691511</c:v>
                </c:pt>
                <c:pt idx="2221">
                  <c:v>0.483008</c:v>
                </c:pt>
                <c:pt idx="2222">
                  <c:v>1.78253</c:v>
                </c:pt>
                <c:pt idx="2223">
                  <c:v>1.70803</c:v>
                </c:pt>
                <c:pt idx="2224">
                  <c:v>1.17102</c:v>
                </c:pt>
                <c:pt idx="2225">
                  <c:v>2.78504</c:v>
                </c:pt>
                <c:pt idx="2226">
                  <c:v>2.36504</c:v>
                </c:pt>
                <c:pt idx="2227">
                  <c:v>1.64853</c:v>
                </c:pt>
                <c:pt idx="2228">
                  <c:v>2.16303</c:v>
                </c:pt>
                <c:pt idx="2229">
                  <c:v>2.390039999999999</c:v>
                </c:pt>
                <c:pt idx="2230">
                  <c:v>2.85155</c:v>
                </c:pt>
                <c:pt idx="2231">
                  <c:v>1.34602</c:v>
                </c:pt>
                <c:pt idx="2232">
                  <c:v>2.46754</c:v>
                </c:pt>
                <c:pt idx="2233">
                  <c:v>1.75953</c:v>
                </c:pt>
                <c:pt idx="2234">
                  <c:v>2.25354</c:v>
                </c:pt>
                <c:pt idx="2235">
                  <c:v>0.958515</c:v>
                </c:pt>
                <c:pt idx="2236">
                  <c:v>3.81556</c:v>
                </c:pt>
                <c:pt idx="2237">
                  <c:v>2.70804</c:v>
                </c:pt>
                <c:pt idx="2238">
                  <c:v>1.39352</c:v>
                </c:pt>
                <c:pt idx="2239">
                  <c:v>3.04755</c:v>
                </c:pt>
                <c:pt idx="2240">
                  <c:v>1.80603</c:v>
                </c:pt>
                <c:pt idx="2241">
                  <c:v>2.11753</c:v>
                </c:pt>
                <c:pt idx="2242">
                  <c:v>2.00953</c:v>
                </c:pt>
                <c:pt idx="2243">
                  <c:v>2.05453</c:v>
                </c:pt>
                <c:pt idx="2244">
                  <c:v>4.994079999999998</c:v>
                </c:pt>
                <c:pt idx="2245">
                  <c:v>4.44107</c:v>
                </c:pt>
                <c:pt idx="2246">
                  <c:v>3.344549999999999</c:v>
                </c:pt>
                <c:pt idx="2247">
                  <c:v>3.10755</c:v>
                </c:pt>
                <c:pt idx="2248">
                  <c:v>4.30057</c:v>
                </c:pt>
                <c:pt idx="2249">
                  <c:v>1.54352</c:v>
                </c:pt>
                <c:pt idx="2250">
                  <c:v>0.988016</c:v>
                </c:pt>
                <c:pt idx="2251">
                  <c:v>3.41555</c:v>
                </c:pt>
                <c:pt idx="2252">
                  <c:v>3.64256</c:v>
                </c:pt>
                <c:pt idx="2253">
                  <c:v>4.21057</c:v>
                </c:pt>
                <c:pt idx="2254">
                  <c:v>3.29605</c:v>
                </c:pt>
                <c:pt idx="2255">
                  <c:v>6.825609999999997</c:v>
                </c:pt>
                <c:pt idx="2256">
                  <c:v>4.05157</c:v>
                </c:pt>
                <c:pt idx="2257">
                  <c:v>4.26307</c:v>
                </c:pt>
                <c:pt idx="2258">
                  <c:v>5.962099999999999</c:v>
                </c:pt>
                <c:pt idx="2259">
                  <c:v>4.00056</c:v>
                </c:pt>
                <c:pt idx="2260">
                  <c:v>5.034579999999996</c:v>
                </c:pt>
                <c:pt idx="2261">
                  <c:v>3.27855</c:v>
                </c:pt>
                <c:pt idx="2262">
                  <c:v>4.05607</c:v>
                </c:pt>
                <c:pt idx="2263">
                  <c:v>1.71903</c:v>
                </c:pt>
                <c:pt idx="2264">
                  <c:v>3.44756</c:v>
                </c:pt>
                <c:pt idx="2265">
                  <c:v>2.75404</c:v>
                </c:pt>
                <c:pt idx="2266">
                  <c:v>2.035029999999999</c:v>
                </c:pt>
                <c:pt idx="2267">
                  <c:v>4.44757</c:v>
                </c:pt>
                <c:pt idx="2268">
                  <c:v>1.27252</c:v>
                </c:pt>
                <c:pt idx="2269">
                  <c:v>3.40855</c:v>
                </c:pt>
                <c:pt idx="2270">
                  <c:v>3.89656</c:v>
                </c:pt>
                <c:pt idx="2271">
                  <c:v>4.20307</c:v>
                </c:pt>
                <c:pt idx="2272">
                  <c:v>5.121079999999997</c:v>
                </c:pt>
                <c:pt idx="2273">
                  <c:v>2.01953</c:v>
                </c:pt>
                <c:pt idx="2274">
                  <c:v>2.36904</c:v>
                </c:pt>
                <c:pt idx="2275">
                  <c:v>1.60353</c:v>
                </c:pt>
                <c:pt idx="2276">
                  <c:v>2.18554</c:v>
                </c:pt>
                <c:pt idx="2277">
                  <c:v>5.382089999999994</c:v>
                </c:pt>
                <c:pt idx="2278">
                  <c:v>6.629109999999986</c:v>
                </c:pt>
                <c:pt idx="2279">
                  <c:v>5.111079999999999</c:v>
                </c:pt>
                <c:pt idx="2280">
                  <c:v>3.10305</c:v>
                </c:pt>
                <c:pt idx="2281">
                  <c:v>2.359039999999998</c:v>
                </c:pt>
                <c:pt idx="2282">
                  <c:v>1.85203</c:v>
                </c:pt>
                <c:pt idx="2283">
                  <c:v>4.43657</c:v>
                </c:pt>
                <c:pt idx="2284">
                  <c:v>3.870559999999998</c:v>
                </c:pt>
                <c:pt idx="2285">
                  <c:v>3.28555</c:v>
                </c:pt>
                <c:pt idx="2286">
                  <c:v>2.46304</c:v>
                </c:pt>
                <c:pt idx="2287">
                  <c:v>4.92908</c:v>
                </c:pt>
                <c:pt idx="2288">
                  <c:v>4.627069999999985</c:v>
                </c:pt>
                <c:pt idx="2289">
                  <c:v>2.452039999999998</c:v>
                </c:pt>
                <c:pt idx="2290">
                  <c:v>4.50057</c:v>
                </c:pt>
                <c:pt idx="2291">
                  <c:v>4.060569999999998</c:v>
                </c:pt>
                <c:pt idx="2292">
                  <c:v>4.79008</c:v>
                </c:pt>
                <c:pt idx="2293">
                  <c:v>6.723109999999997</c:v>
                </c:pt>
                <c:pt idx="2294">
                  <c:v>5.44659</c:v>
                </c:pt>
                <c:pt idx="2295">
                  <c:v>3.433559999999999</c:v>
                </c:pt>
                <c:pt idx="2296">
                  <c:v>2.96105</c:v>
                </c:pt>
                <c:pt idx="2297">
                  <c:v>2.66154</c:v>
                </c:pt>
                <c:pt idx="2298">
                  <c:v>2.17053</c:v>
                </c:pt>
                <c:pt idx="2299">
                  <c:v>0.965515</c:v>
                </c:pt>
                <c:pt idx="2300">
                  <c:v>1.34152</c:v>
                </c:pt>
                <c:pt idx="2301">
                  <c:v>2.65504</c:v>
                </c:pt>
                <c:pt idx="2302">
                  <c:v>4.50357</c:v>
                </c:pt>
                <c:pt idx="2303">
                  <c:v>1.95953</c:v>
                </c:pt>
                <c:pt idx="2304">
                  <c:v>2.11003</c:v>
                </c:pt>
                <c:pt idx="2305">
                  <c:v>3.593059999999999</c:v>
                </c:pt>
                <c:pt idx="2306">
                  <c:v>2.99805</c:v>
                </c:pt>
                <c:pt idx="2307">
                  <c:v>2.50404</c:v>
                </c:pt>
                <c:pt idx="2308">
                  <c:v>4.78508</c:v>
                </c:pt>
                <c:pt idx="2309">
                  <c:v>2.74804</c:v>
                </c:pt>
                <c:pt idx="2310">
                  <c:v>3.49906</c:v>
                </c:pt>
                <c:pt idx="2311">
                  <c:v>1.92003</c:v>
                </c:pt>
                <c:pt idx="2312">
                  <c:v>2.40804</c:v>
                </c:pt>
                <c:pt idx="2313">
                  <c:v>2.48304</c:v>
                </c:pt>
                <c:pt idx="2314">
                  <c:v>4.10957</c:v>
                </c:pt>
                <c:pt idx="2315">
                  <c:v>4.15907</c:v>
                </c:pt>
                <c:pt idx="2316">
                  <c:v>6.2561</c:v>
                </c:pt>
                <c:pt idx="2317">
                  <c:v>2.52704</c:v>
                </c:pt>
                <c:pt idx="2318">
                  <c:v>2.70304</c:v>
                </c:pt>
                <c:pt idx="2319">
                  <c:v>3.51506</c:v>
                </c:pt>
                <c:pt idx="2320">
                  <c:v>3.79006</c:v>
                </c:pt>
                <c:pt idx="2321">
                  <c:v>3.652559999999997</c:v>
                </c:pt>
                <c:pt idx="2322">
                  <c:v>3.97406</c:v>
                </c:pt>
                <c:pt idx="2323">
                  <c:v>4.20657</c:v>
                </c:pt>
                <c:pt idx="2324">
                  <c:v>4.49657</c:v>
                </c:pt>
                <c:pt idx="2325">
                  <c:v>1.86703</c:v>
                </c:pt>
                <c:pt idx="2326">
                  <c:v>8.922640000000002</c:v>
                </c:pt>
                <c:pt idx="2327">
                  <c:v>3.65606</c:v>
                </c:pt>
                <c:pt idx="2328">
                  <c:v>7.741119999999999</c:v>
                </c:pt>
                <c:pt idx="2329">
                  <c:v>3.611559999999998</c:v>
                </c:pt>
                <c:pt idx="2330">
                  <c:v>4.50207</c:v>
                </c:pt>
                <c:pt idx="2331">
                  <c:v>4.18107</c:v>
                </c:pt>
                <c:pt idx="2332">
                  <c:v>2.21004</c:v>
                </c:pt>
                <c:pt idx="2333">
                  <c:v>6.395099999999997</c:v>
                </c:pt>
                <c:pt idx="2334">
                  <c:v>7.64562</c:v>
                </c:pt>
                <c:pt idx="2335">
                  <c:v>6.611109999999996</c:v>
                </c:pt>
                <c:pt idx="2336">
                  <c:v>6.128099999999995</c:v>
                </c:pt>
                <c:pt idx="2337">
                  <c:v>5.9951</c:v>
                </c:pt>
                <c:pt idx="2338">
                  <c:v>4.90508</c:v>
                </c:pt>
                <c:pt idx="2339">
                  <c:v>4.874079999999997</c:v>
                </c:pt>
                <c:pt idx="2340">
                  <c:v>5.161579999999986</c:v>
                </c:pt>
                <c:pt idx="2341">
                  <c:v>5.07108</c:v>
                </c:pt>
                <c:pt idx="2342">
                  <c:v>5.697089999999965</c:v>
                </c:pt>
                <c:pt idx="2343">
                  <c:v>2.73904</c:v>
                </c:pt>
                <c:pt idx="2344">
                  <c:v>2.76954</c:v>
                </c:pt>
                <c:pt idx="2345">
                  <c:v>3.47106</c:v>
                </c:pt>
                <c:pt idx="2346">
                  <c:v>1.69603</c:v>
                </c:pt>
                <c:pt idx="2347">
                  <c:v>4.44457</c:v>
                </c:pt>
                <c:pt idx="2348">
                  <c:v>2.156029999999999</c:v>
                </c:pt>
                <c:pt idx="2349">
                  <c:v>5.168579999999984</c:v>
                </c:pt>
                <c:pt idx="2350">
                  <c:v>3.799059999999998</c:v>
                </c:pt>
                <c:pt idx="2351">
                  <c:v>5.520589999999975</c:v>
                </c:pt>
                <c:pt idx="2352">
                  <c:v>4.56907</c:v>
                </c:pt>
                <c:pt idx="2353">
                  <c:v>5.73609</c:v>
                </c:pt>
                <c:pt idx="2354">
                  <c:v>4.494569999999999</c:v>
                </c:pt>
                <c:pt idx="2355">
                  <c:v>4.885079999999998</c:v>
                </c:pt>
                <c:pt idx="2356">
                  <c:v>2.68254</c:v>
                </c:pt>
                <c:pt idx="2357">
                  <c:v>8.70264</c:v>
                </c:pt>
                <c:pt idx="2358">
                  <c:v>1.96703</c:v>
                </c:pt>
                <c:pt idx="2359">
                  <c:v>3.114549999999999</c:v>
                </c:pt>
                <c:pt idx="2360">
                  <c:v>7.38862</c:v>
                </c:pt>
                <c:pt idx="2361">
                  <c:v>8.02513</c:v>
                </c:pt>
                <c:pt idx="2362">
                  <c:v>3.944059999999999</c:v>
                </c:pt>
                <c:pt idx="2363">
                  <c:v>2.49354</c:v>
                </c:pt>
                <c:pt idx="2364">
                  <c:v>1.95503</c:v>
                </c:pt>
                <c:pt idx="2365">
                  <c:v>10.5052</c:v>
                </c:pt>
                <c:pt idx="2366">
                  <c:v>3.59906</c:v>
                </c:pt>
                <c:pt idx="2367">
                  <c:v>6.84911</c:v>
                </c:pt>
                <c:pt idx="2368">
                  <c:v>5.40609</c:v>
                </c:pt>
                <c:pt idx="2369">
                  <c:v>2.38054</c:v>
                </c:pt>
                <c:pt idx="2370">
                  <c:v>5.175579999999997</c:v>
                </c:pt>
                <c:pt idx="2371">
                  <c:v>5.07208</c:v>
                </c:pt>
                <c:pt idx="2372">
                  <c:v>2.19154</c:v>
                </c:pt>
                <c:pt idx="2373">
                  <c:v>4.77858</c:v>
                </c:pt>
                <c:pt idx="2374">
                  <c:v>2.415039999999998</c:v>
                </c:pt>
                <c:pt idx="2375">
                  <c:v>4.610069999999998</c:v>
                </c:pt>
                <c:pt idx="2376">
                  <c:v>2.21454</c:v>
                </c:pt>
                <c:pt idx="2377">
                  <c:v>5.113079999999997</c:v>
                </c:pt>
                <c:pt idx="2378">
                  <c:v>2.00753</c:v>
                </c:pt>
                <c:pt idx="2379">
                  <c:v>2.976049999999952</c:v>
                </c:pt>
                <c:pt idx="2380">
                  <c:v>7.47012</c:v>
                </c:pt>
                <c:pt idx="2381">
                  <c:v>2.946549999999998</c:v>
                </c:pt>
                <c:pt idx="2382">
                  <c:v>2.26754</c:v>
                </c:pt>
                <c:pt idx="2383">
                  <c:v>8.17163</c:v>
                </c:pt>
                <c:pt idx="2384">
                  <c:v>5.53009</c:v>
                </c:pt>
                <c:pt idx="2385">
                  <c:v>6.5216</c:v>
                </c:pt>
                <c:pt idx="2386">
                  <c:v>2.881549999999998</c:v>
                </c:pt>
                <c:pt idx="2387">
                  <c:v>4.99658</c:v>
                </c:pt>
                <c:pt idx="2388">
                  <c:v>8.853140000000006</c:v>
                </c:pt>
                <c:pt idx="2389">
                  <c:v>4.190069999999999</c:v>
                </c:pt>
                <c:pt idx="2390">
                  <c:v>2.712039999999999</c:v>
                </c:pt>
                <c:pt idx="2391">
                  <c:v>1.61003</c:v>
                </c:pt>
                <c:pt idx="2392">
                  <c:v>6.2921</c:v>
                </c:pt>
                <c:pt idx="2393">
                  <c:v>5.33909</c:v>
                </c:pt>
                <c:pt idx="2394">
                  <c:v>6.0721</c:v>
                </c:pt>
                <c:pt idx="2395">
                  <c:v>6.055099999999999</c:v>
                </c:pt>
                <c:pt idx="2396">
                  <c:v>7.093109999999998</c:v>
                </c:pt>
                <c:pt idx="2397">
                  <c:v>9.911160000000001</c:v>
                </c:pt>
                <c:pt idx="2398">
                  <c:v>6.4936</c:v>
                </c:pt>
                <c:pt idx="2399">
                  <c:v>7.59212</c:v>
                </c:pt>
                <c:pt idx="2400">
                  <c:v>5.75009</c:v>
                </c:pt>
                <c:pt idx="2401">
                  <c:v>3.66856</c:v>
                </c:pt>
                <c:pt idx="2402">
                  <c:v>5.9231</c:v>
                </c:pt>
                <c:pt idx="2403">
                  <c:v>11.5577</c:v>
                </c:pt>
                <c:pt idx="2404">
                  <c:v>6.5011</c:v>
                </c:pt>
                <c:pt idx="2405">
                  <c:v>8.340630000000002</c:v>
                </c:pt>
                <c:pt idx="2406">
                  <c:v>5.78859</c:v>
                </c:pt>
                <c:pt idx="2407">
                  <c:v>2.57954</c:v>
                </c:pt>
                <c:pt idx="2408">
                  <c:v>2.67704</c:v>
                </c:pt>
                <c:pt idx="2409">
                  <c:v>5.24508</c:v>
                </c:pt>
                <c:pt idx="2410">
                  <c:v>5.724589999999964</c:v>
                </c:pt>
                <c:pt idx="2411">
                  <c:v>4.41657</c:v>
                </c:pt>
                <c:pt idx="2412">
                  <c:v>5.122719999999974</c:v>
                </c:pt>
                <c:pt idx="2413">
                  <c:v>0.967516</c:v>
                </c:pt>
                <c:pt idx="2414">
                  <c:v>1.95453</c:v>
                </c:pt>
                <c:pt idx="2415">
                  <c:v>2.07703</c:v>
                </c:pt>
                <c:pt idx="2416">
                  <c:v>1.70153</c:v>
                </c:pt>
                <c:pt idx="2417">
                  <c:v>1.97603</c:v>
                </c:pt>
                <c:pt idx="2418">
                  <c:v>2.32404</c:v>
                </c:pt>
                <c:pt idx="2419">
                  <c:v>4.154569999999985</c:v>
                </c:pt>
                <c:pt idx="2420">
                  <c:v>1.71453</c:v>
                </c:pt>
                <c:pt idx="2421">
                  <c:v>1.48002</c:v>
                </c:pt>
                <c:pt idx="2422">
                  <c:v>3.72956</c:v>
                </c:pt>
                <c:pt idx="2423">
                  <c:v>3.94456</c:v>
                </c:pt>
                <c:pt idx="2424">
                  <c:v>3.27305</c:v>
                </c:pt>
                <c:pt idx="2425">
                  <c:v>6.57011</c:v>
                </c:pt>
                <c:pt idx="2426">
                  <c:v>3.40455</c:v>
                </c:pt>
                <c:pt idx="2427">
                  <c:v>2.96305</c:v>
                </c:pt>
                <c:pt idx="2428">
                  <c:v>6.724609999999997</c:v>
                </c:pt>
                <c:pt idx="2429">
                  <c:v>2.79004</c:v>
                </c:pt>
                <c:pt idx="2430">
                  <c:v>2.23404</c:v>
                </c:pt>
                <c:pt idx="2431">
                  <c:v>2.70004</c:v>
                </c:pt>
                <c:pt idx="2432">
                  <c:v>4.41107</c:v>
                </c:pt>
                <c:pt idx="2433">
                  <c:v>4.17707</c:v>
                </c:pt>
                <c:pt idx="2434">
                  <c:v>4.095569999999999</c:v>
                </c:pt>
                <c:pt idx="2435">
                  <c:v>4.27607</c:v>
                </c:pt>
                <c:pt idx="2436">
                  <c:v>7.25662</c:v>
                </c:pt>
                <c:pt idx="2437">
                  <c:v>3.071549999999998</c:v>
                </c:pt>
                <c:pt idx="2438">
                  <c:v>2.32054</c:v>
                </c:pt>
                <c:pt idx="2439">
                  <c:v>4.22657</c:v>
                </c:pt>
                <c:pt idx="2440">
                  <c:v>6.95911</c:v>
                </c:pt>
                <c:pt idx="2441">
                  <c:v>6.025099999999997</c:v>
                </c:pt>
                <c:pt idx="2442">
                  <c:v>4.23157</c:v>
                </c:pt>
                <c:pt idx="2443">
                  <c:v>3.62906</c:v>
                </c:pt>
                <c:pt idx="2444">
                  <c:v>5.847089999999985</c:v>
                </c:pt>
                <c:pt idx="2445">
                  <c:v>3.812059999999952</c:v>
                </c:pt>
                <c:pt idx="2446">
                  <c:v>3.460059999999999</c:v>
                </c:pt>
                <c:pt idx="2447">
                  <c:v>2.50204</c:v>
                </c:pt>
                <c:pt idx="2448">
                  <c:v>1.12602</c:v>
                </c:pt>
                <c:pt idx="2449">
                  <c:v>0.507008</c:v>
                </c:pt>
                <c:pt idx="2450">
                  <c:v>0.60551</c:v>
                </c:pt>
                <c:pt idx="2451">
                  <c:v>1.12352</c:v>
                </c:pt>
                <c:pt idx="2452">
                  <c:v>0.725012</c:v>
                </c:pt>
                <c:pt idx="2453">
                  <c:v>2.46804</c:v>
                </c:pt>
                <c:pt idx="2454">
                  <c:v>0.61401</c:v>
                </c:pt>
                <c:pt idx="2455">
                  <c:v>0.847514</c:v>
                </c:pt>
                <c:pt idx="2456">
                  <c:v>2.47804</c:v>
                </c:pt>
                <c:pt idx="2457">
                  <c:v>1.58603</c:v>
                </c:pt>
                <c:pt idx="2458">
                  <c:v>5.359589999999994</c:v>
                </c:pt>
                <c:pt idx="2459">
                  <c:v>5.9491</c:v>
                </c:pt>
                <c:pt idx="2460">
                  <c:v>4.680579999999995</c:v>
                </c:pt>
                <c:pt idx="2461">
                  <c:v>0.892514</c:v>
                </c:pt>
                <c:pt idx="2462">
                  <c:v>0.418007</c:v>
                </c:pt>
                <c:pt idx="2463">
                  <c:v>1.83403</c:v>
                </c:pt>
                <c:pt idx="2464">
                  <c:v>1.35202</c:v>
                </c:pt>
                <c:pt idx="2465">
                  <c:v>0.64251</c:v>
                </c:pt>
                <c:pt idx="2466">
                  <c:v>0.923515</c:v>
                </c:pt>
                <c:pt idx="2467">
                  <c:v>5.317589999999964</c:v>
                </c:pt>
                <c:pt idx="2468">
                  <c:v>1.36952</c:v>
                </c:pt>
                <c:pt idx="2469">
                  <c:v>1.82603</c:v>
                </c:pt>
                <c:pt idx="2470">
                  <c:v>2.35454</c:v>
                </c:pt>
                <c:pt idx="2471">
                  <c:v>4.44957</c:v>
                </c:pt>
                <c:pt idx="2472">
                  <c:v>2.56804</c:v>
                </c:pt>
                <c:pt idx="2473">
                  <c:v>4.154069999999995</c:v>
                </c:pt>
                <c:pt idx="2474">
                  <c:v>2.823049999999998</c:v>
                </c:pt>
                <c:pt idx="2475">
                  <c:v>2.305039999999999</c:v>
                </c:pt>
                <c:pt idx="2476">
                  <c:v>2.17303</c:v>
                </c:pt>
                <c:pt idx="2477">
                  <c:v>3.06055</c:v>
                </c:pt>
                <c:pt idx="2478">
                  <c:v>2.47404</c:v>
                </c:pt>
                <c:pt idx="2479">
                  <c:v>4.74208</c:v>
                </c:pt>
                <c:pt idx="2480">
                  <c:v>2.55104</c:v>
                </c:pt>
                <c:pt idx="2481">
                  <c:v>4.727079999999995</c:v>
                </c:pt>
                <c:pt idx="2482">
                  <c:v>2.48704</c:v>
                </c:pt>
                <c:pt idx="2483">
                  <c:v>1.28552</c:v>
                </c:pt>
                <c:pt idx="2484">
                  <c:v>2.06203</c:v>
                </c:pt>
                <c:pt idx="2485">
                  <c:v>3.22155</c:v>
                </c:pt>
                <c:pt idx="2486">
                  <c:v>3.859059999999952</c:v>
                </c:pt>
                <c:pt idx="2487">
                  <c:v>6.2841</c:v>
                </c:pt>
                <c:pt idx="2488">
                  <c:v>2.64754</c:v>
                </c:pt>
                <c:pt idx="2489">
                  <c:v>9.55715</c:v>
                </c:pt>
                <c:pt idx="2490">
                  <c:v>4.99008</c:v>
                </c:pt>
                <c:pt idx="2491">
                  <c:v>8.739140000000001</c:v>
                </c:pt>
                <c:pt idx="2492">
                  <c:v>2.64804</c:v>
                </c:pt>
                <c:pt idx="2493">
                  <c:v>3.28005</c:v>
                </c:pt>
                <c:pt idx="2494">
                  <c:v>2.32404</c:v>
                </c:pt>
                <c:pt idx="2495">
                  <c:v>4.41057</c:v>
                </c:pt>
                <c:pt idx="2496">
                  <c:v>1.23102</c:v>
                </c:pt>
                <c:pt idx="2497">
                  <c:v>3.02855</c:v>
                </c:pt>
                <c:pt idx="2498">
                  <c:v>1.91653</c:v>
                </c:pt>
                <c:pt idx="2499">
                  <c:v>6.94361</c:v>
                </c:pt>
                <c:pt idx="2500">
                  <c:v>3.26155</c:v>
                </c:pt>
                <c:pt idx="2501">
                  <c:v>4.76908</c:v>
                </c:pt>
                <c:pt idx="2502">
                  <c:v>4.25507</c:v>
                </c:pt>
                <c:pt idx="2503">
                  <c:v>3.62706</c:v>
                </c:pt>
                <c:pt idx="2504">
                  <c:v>4.58357</c:v>
                </c:pt>
                <c:pt idx="2505">
                  <c:v>3.55356</c:v>
                </c:pt>
                <c:pt idx="2506">
                  <c:v>4.78308</c:v>
                </c:pt>
                <c:pt idx="2507">
                  <c:v>3.231549999999999</c:v>
                </c:pt>
                <c:pt idx="2508">
                  <c:v>7.867129999999975</c:v>
                </c:pt>
                <c:pt idx="2509">
                  <c:v>6.745109999999999</c:v>
                </c:pt>
                <c:pt idx="2510">
                  <c:v>3.83406</c:v>
                </c:pt>
                <c:pt idx="2511">
                  <c:v>5.720589999999984</c:v>
                </c:pt>
                <c:pt idx="2512">
                  <c:v>5.649589999999994</c:v>
                </c:pt>
                <c:pt idx="2513">
                  <c:v>3.091549999999998</c:v>
                </c:pt>
                <c:pt idx="2514">
                  <c:v>4.45857</c:v>
                </c:pt>
                <c:pt idx="2515">
                  <c:v>1.55502</c:v>
                </c:pt>
                <c:pt idx="2516">
                  <c:v>3.72306</c:v>
                </c:pt>
                <c:pt idx="2517">
                  <c:v>3.28955</c:v>
                </c:pt>
                <c:pt idx="2518">
                  <c:v>4.26007</c:v>
                </c:pt>
                <c:pt idx="2519">
                  <c:v>4.45207</c:v>
                </c:pt>
                <c:pt idx="2520">
                  <c:v>6.818109999999995</c:v>
                </c:pt>
                <c:pt idx="2521">
                  <c:v>1.47952</c:v>
                </c:pt>
                <c:pt idx="2522">
                  <c:v>4.79808</c:v>
                </c:pt>
                <c:pt idx="2523">
                  <c:v>3.473059999999998</c:v>
                </c:pt>
                <c:pt idx="2524">
                  <c:v>3.169049999999999</c:v>
                </c:pt>
                <c:pt idx="2525">
                  <c:v>3.00455</c:v>
                </c:pt>
                <c:pt idx="2526">
                  <c:v>4.816579999999996</c:v>
                </c:pt>
                <c:pt idx="2527">
                  <c:v>4.813079999999998</c:v>
                </c:pt>
                <c:pt idx="2528">
                  <c:v>1.33602</c:v>
                </c:pt>
                <c:pt idx="2529">
                  <c:v>6.2526</c:v>
                </c:pt>
                <c:pt idx="2530">
                  <c:v>2.855049999999952</c:v>
                </c:pt>
                <c:pt idx="2531">
                  <c:v>4.90608</c:v>
                </c:pt>
                <c:pt idx="2532">
                  <c:v>4.022559999999975</c:v>
                </c:pt>
                <c:pt idx="2533">
                  <c:v>5.00008</c:v>
                </c:pt>
                <c:pt idx="2534">
                  <c:v>5.9951</c:v>
                </c:pt>
                <c:pt idx="2535">
                  <c:v>3.57356</c:v>
                </c:pt>
                <c:pt idx="2536">
                  <c:v>9.437650000000001</c:v>
                </c:pt>
                <c:pt idx="2537">
                  <c:v>4.48607</c:v>
                </c:pt>
                <c:pt idx="2538">
                  <c:v>2.867049999999998</c:v>
                </c:pt>
                <c:pt idx="2539">
                  <c:v>4.944579999999998</c:v>
                </c:pt>
                <c:pt idx="2540">
                  <c:v>2.23604</c:v>
                </c:pt>
                <c:pt idx="2541">
                  <c:v>6.1191</c:v>
                </c:pt>
                <c:pt idx="2542">
                  <c:v>3.28755</c:v>
                </c:pt>
                <c:pt idx="2543">
                  <c:v>5.63959</c:v>
                </c:pt>
                <c:pt idx="2544">
                  <c:v>2.65554</c:v>
                </c:pt>
                <c:pt idx="2545">
                  <c:v>4.66107</c:v>
                </c:pt>
                <c:pt idx="2546">
                  <c:v>3.48956</c:v>
                </c:pt>
                <c:pt idx="2547">
                  <c:v>7.884129999999986</c:v>
                </c:pt>
                <c:pt idx="2548">
                  <c:v>3.32655</c:v>
                </c:pt>
                <c:pt idx="2549">
                  <c:v>5.04308</c:v>
                </c:pt>
                <c:pt idx="2550">
                  <c:v>6.93511</c:v>
                </c:pt>
                <c:pt idx="2551">
                  <c:v>8.05663</c:v>
                </c:pt>
                <c:pt idx="2552">
                  <c:v>5.257079999999998</c:v>
                </c:pt>
                <c:pt idx="2553">
                  <c:v>3.385549999999998</c:v>
                </c:pt>
                <c:pt idx="2554">
                  <c:v>2.72254</c:v>
                </c:pt>
                <c:pt idx="2555">
                  <c:v>2.43804</c:v>
                </c:pt>
                <c:pt idx="2556">
                  <c:v>2.62504</c:v>
                </c:pt>
                <c:pt idx="2557">
                  <c:v>4.187069999999998</c:v>
                </c:pt>
                <c:pt idx="2558">
                  <c:v>5.924599999999995</c:v>
                </c:pt>
                <c:pt idx="2559">
                  <c:v>6.87861</c:v>
                </c:pt>
                <c:pt idx="2560">
                  <c:v>6.75161</c:v>
                </c:pt>
                <c:pt idx="2561">
                  <c:v>3.44456</c:v>
                </c:pt>
                <c:pt idx="2562">
                  <c:v>5.110579999999985</c:v>
                </c:pt>
                <c:pt idx="2563">
                  <c:v>5.70309</c:v>
                </c:pt>
                <c:pt idx="2564">
                  <c:v>4.010559999999995</c:v>
                </c:pt>
                <c:pt idx="2565">
                  <c:v>4.27107</c:v>
                </c:pt>
                <c:pt idx="2566">
                  <c:v>2.838049999999956</c:v>
                </c:pt>
                <c:pt idx="2567">
                  <c:v>2.56254</c:v>
                </c:pt>
                <c:pt idx="2568">
                  <c:v>4.144569999999995</c:v>
                </c:pt>
                <c:pt idx="2569">
                  <c:v>5.125579999999966</c:v>
                </c:pt>
                <c:pt idx="2570">
                  <c:v>6.56361</c:v>
                </c:pt>
                <c:pt idx="2571">
                  <c:v>6.4786</c:v>
                </c:pt>
                <c:pt idx="2572">
                  <c:v>4.384569999999996</c:v>
                </c:pt>
                <c:pt idx="2573">
                  <c:v>5.812589999999965</c:v>
                </c:pt>
                <c:pt idx="2574">
                  <c:v>3.45656</c:v>
                </c:pt>
                <c:pt idx="2575">
                  <c:v>6.4181</c:v>
                </c:pt>
                <c:pt idx="2576">
                  <c:v>2.94755</c:v>
                </c:pt>
                <c:pt idx="2577">
                  <c:v>0.84943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0BE-49D3-9011-1B0C15153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4477560"/>
        <c:axId val="2084484888"/>
      </c:scatterChart>
      <c:valAx>
        <c:axId val="20844775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picate-1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84484888"/>
        <c:crosses val="autoZero"/>
        <c:crossBetween val="midCat"/>
      </c:valAx>
      <c:valAx>
        <c:axId val="208448488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plicate-2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8447756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RJKB-T23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ip.m.rep2</c:v>
                </c:pt>
              </c:strCache>
            </c:strRef>
          </c:tx>
          <c:spPr>
            <a:ln w="47625">
              <a:noFill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E$2:$E$2579</c:f>
              <c:numCache>
                <c:formatCode>General</c:formatCode>
                <c:ptCount val="2578"/>
                <c:pt idx="0">
                  <c:v>4.100539999999985</c:v>
                </c:pt>
                <c:pt idx="1">
                  <c:v>5.050989999999985</c:v>
                </c:pt>
                <c:pt idx="2">
                  <c:v>6.04287</c:v>
                </c:pt>
                <c:pt idx="3">
                  <c:v>4.59348</c:v>
                </c:pt>
                <c:pt idx="4">
                  <c:v>6.20673</c:v>
                </c:pt>
                <c:pt idx="5">
                  <c:v>5.59043</c:v>
                </c:pt>
                <c:pt idx="6">
                  <c:v>9.44288</c:v>
                </c:pt>
                <c:pt idx="7">
                  <c:v>4.23632</c:v>
                </c:pt>
                <c:pt idx="8">
                  <c:v>4.11066</c:v>
                </c:pt>
                <c:pt idx="9">
                  <c:v>3.90538</c:v>
                </c:pt>
                <c:pt idx="10">
                  <c:v>5.36904</c:v>
                </c:pt>
                <c:pt idx="11">
                  <c:v>6.74248</c:v>
                </c:pt>
                <c:pt idx="12">
                  <c:v>2.4293</c:v>
                </c:pt>
                <c:pt idx="13">
                  <c:v>4.71914</c:v>
                </c:pt>
                <c:pt idx="14">
                  <c:v>4.30674</c:v>
                </c:pt>
                <c:pt idx="15">
                  <c:v>3.90952</c:v>
                </c:pt>
                <c:pt idx="16">
                  <c:v>3.66696</c:v>
                </c:pt>
                <c:pt idx="17">
                  <c:v>2.655289999999998</c:v>
                </c:pt>
                <c:pt idx="18">
                  <c:v>4.46185</c:v>
                </c:pt>
                <c:pt idx="19">
                  <c:v>2.579349999999998</c:v>
                </c:pt>
                <c:pt idx="20">
                  <c:v>4.072</c:v>
                </c:pt>
                <c:pt idx="21">
                  <c:v>3.28954</c:v>
                </c:pt>
                <c:pt idx="22">
                  <c:v>3.01844</c:v>
                </c:pt>
                <c:pt idx="23">
                  <c:v>6.394059999999984</c:v>
                </c:pt>
                <c:pt idx="24">
                  <c:v>3.54821</c:v>
                </c:pt>
                <c:pt idx="25">
                  <c:v>4.32377</c:v>
                </c:pt>
                <c:pt idx="26">
                  <c:v>3.62508</c:v>
                </c:pt>
                <c:pt idx="27">
                  <c:v>3.50495</c:v>
                </c:pt>
                <c:pt idx="28">
                  <c:v>6.52155</c:v>
                </c:pt>
                <c:pt idx="29">
                  <c:v>5.24062</c:v>
                </c:pt>
                <c:pt idx="30">
                  <c:v>4.385899999999999</c:v>
                </c:pt>
                <c:pt idx="31">
                  <c:v>3.542689999999999</c:v>
                </c:pt>
                <c:pt idx="32">
                  <c:v>2.734459999999998</c:v>
                </c:pt>
                <c:pt idx="33">
                  <c:v>5.177109999999995</c:v>
                </c:pt>
                <c:pt idx="34">
                  <c:v>3.52014</c:v>
                </c:pt>
                <c:pt idx="35">
                  <c:v>4.71546</c:v>
                </c:pt>
                <c:pt idx="36">
                  <c:v>3.63152</c:v>
                </c:pt>
                <c:pt idx="37">
                  <c:v>4.52629</c:v>
                </c:pt>
                <c:pt idx="38">
                  <c:v>5.144429999999986</c:v>
                </c:pt>
                <c:pt idx="39">
                  <c:v>5.583979999999999</c:v>
                </c:pt>
                <c:pt idx="40">
                  <c:v>7.124499999999975</c:v>
                </c:pt>
                <c:pt idx="41">
                  <c:v>6.13953</c:v>
                </c:pt>
                <c:pt idx="42">
                  <c:v>3.77421</c:v>
                </c:pt>
                <c:pt idx="43">
                  <c:v>7.065589999999966</c:v>
                </c:pt>
                <c:pt idx="44">
                  <c:v>4.29247</c:v>
                </c:pt>
                <c:pt idx="45">
                  <c:v>7.45314</c:v>
                </c:pt>
                <c:pt idx="46">
                  <c:v>3.01108</c:v>
                </c:pt>
                <c:pt idx="47">
                  <c:v>3.873619999999998</c:v>
                </c:pt>
                <c:pt idx="48">
                  <c:v>5.87579</c:v>
                </c:pt>
                <c:pt idx="49">
                  <c:v>3.316239999999996</c:v>
                </c:pt>
                <c:pt idx="50">
                  <c:v>5.06526</c:v>
                </c:pt>
                <c:pt idx="51">
                  <c:v>3.41474</c:v>
                </c:pt>
                <c:pt idx="52">
                  <c:v>5.827469999999995</c:v>
                </c:pt>
                <c:pt idx="53">
                  <c:v>5.40724</c:v>
                </c:pt>
                <c:pt idx="54">
                  <c:v>4.37854</c:v>
                </c:pt>
                <c:pt idx="55">
                  <c:v>4.63077</c:v>
                </c:pt>
                <c:pt idx="56">
                  <c:v>4.357829999999986</c:v>
                </c:pt>
                <c:pt idx="57">
                  <c:v>2.31239</c:v>
                </c:pt>
                <c:pt idx="58">
                  <c:v>2.76115</c:v>
                </c:pt>
                <c:pt idx="59">
                  <c:v>4.45264</c:v>
                </c:pt>
                <c:pt idx="60">
                  <c:v>3.08702</c:v>
                </c:pt>
                <c:pt idx="61">
                  <c:v>3.18414</c:v>
                </c:pt>
                <c:pt idx="62">
                  <c:v>3.38574</c:v>
                </c:pt>
                <c:pt idx="63">
                  <c:v>4.52997</c:v>
                </c:pt>
                <c:pt idx="64">
                  <c:v>4.88207</c:v>
                </c:pt>
                <c:pt idx="65">
                  <c:v>3.36503</c:v>
                </c:pt>
                <c:pt idx="66">
                  <c:v>4.05911</c:v>
                </c:pt>
                <c:pt idx="67">
                  <c:v>4.86965</c:v>
                </c:pt>
                <c:pt idx="68">
                  <c:v>4.28004</c:v>
                </c:pt>
                <c:pt idx="69">
                  <c:v>2.839399999999999</c:v>
                </c:pt>
                <c:pt idx="70">
                  <c:v>2.35151</c:v>
                </c:pt>
                <c:pt idx="71">
                  <c:v>3.606669999999998</c:v>
                </c:pt>
                <c:pt idx="72">
                  <c:v>5.43302</c:v>
                </c:pt>
                <c:pt idx="73">
                  <c:v>5.24523</c:v>
                </c:pt>
                <c:pt idx="74">
                  <c:v>4.09639</c:v>
                </c:pt>
                <c:pt idx="75">
                  <c:v>2.929609999999998</c:v>
                </c:pt>
                <c:pt idx="76">
                  <c:v>5.44682</c:v>
                </c:pt>
                <c:pt idx="77">
                  <c:v>2.61571</c:v>
                </c:pt>
                <c:pt idx="78">
                  <c:v>3.97534</c:v>
                </c:pt>
                <c:pt idx="79">
                  <c:v>2.70776</c:v>
                </c:pt>
                <c:pt idx="80">
                  <c:v>2.65759</c:v>
                </c:pt>
                <c:pt idx="81">
                  <c:v>2.56646</c:v>
                </c:pt>
                <c:pt idx="82">
                  <c:v>6.464479999999996</c:v>
                </c:pt>
                <c:pt idx="83">
                  <c:v>5.07216</c:v>
                </c:pt>
                <c:pt idx="84">
                  <c:v>5.287109999999998</c:v>
                </c:pt>
                <c:pt idx="85">
                  <c:v>4.72696</c:v>
                </c:pt>
                <c:pt idx="86">
                  <c:v>3.74383</c:v>
                </c:pt>
                <c:pt idx="87">
                  <c:v>1.89032</c:v>
                </c:pt>
                <c:pt idx="88">
                  <c:v>2.27097</c:v>
                </c:pt>
                <c:pt idx="89">
                  <c:v>3.46997</c:v>
                </c:pt>
                <c:pt idx="90">
                  <c:v>2.329419999999998</c:v>
                </c:pt>
                <c:pt idx="91">
                  <c:v>2.905679999999998</c:v>
                </c:pt>
                <c:pt idx="92">
                  <c:v>2.131969999999999</c:v>
                </c:pt>
                <c:pt idx="93">
                  <c:v>2.57014</c:v>
                </c:pt>
                <c:pt idx="94">
                  <c:v>4.63031</c:v>
                </c:pt>
                <c:pt idx="95">
                  <c:v>3.5878</c:v>
                </c:pt>
                <c:pt idx="96">
                  <c:v>3.5855</c:v>
                </c:pt>
                <c:pt idx="97">
                  <c:v>3.58872</c:v>
                </c:pt>
                <c:pt idx="98">
                  <c:v>2.8371</c:v>
                </c:pt>
                <c:pt idx="99">
                  <c:v>3.66558</c:v>
                </c:pt>
                <c:pt idx="100">
                  <c:v>3.4534</c:v>
                </c:pt>
                <c:pt idx="101">
                  <c:v>2.49466</c:v>
                </c:pt>
                <c:pt idx="102">
                  <c:v>2.896929999999997</c:v>
                </c:pt>
                <c:pt idx="103">
                  <c:v>3.36641</c:v>
                </c:pt>
                <c:pt idx="104">
                  <c:v>6.012029999999998</c:v>
                </c:pt>
                <c:pt idx="105">
                  <c:v>2.37637</c:v>
                </c:pt>
                <c:pt idx="106">
                  <c:v>4.254729999999999</c:v>
                </c:pt>
                <c:pt idx="107">
                  <c:v>4.78588</c:v>
                </c:pt>
                <c:pt idx="108">
                  <c:v>2.79383</c:v>
                </c:pt>
                <c:pt idx="109">
                  <c:v>3.389879999999997</c:v>
                </c:pt>
                <c:pt idx="110">
                  <c:v>2.69902</c:v>
                </c:pt>
                <c:pt idx="111">
                  <c:v>3.713449999999999</c:v>
                </c:pt>
                <c:pt idx="112">
                  <c:v>3.57399</c:v>
                </c:pt>
                <c:pt idx="113">
                  <c:v>6.78943</c:v>
                </c:pt>
                <c:pt idx="114">
                  <c:v>2.46658</c:v>
                </c:pt>
                <c:pt idx="115">
                  <c:v>2.59592</c:v>
                </c:pt>
                <c:pt idx="116">
                  <c:v>1.95154</c:v>
                </c:pt>
                <c:pt idx="117">
                  <c:v>2.89555</c:v>
                </c:pt>
                <c:pt idx="118">
                  <c:v>2.458759999999998</c:v>
                </c:pt>
                <c:pt idx="119">
                  <c:v>5.404939999999995</c:v>
                </c:pt>
                <c:pt idx="120">
                  <c:v>2.24427</c:v>
                </c:pt>
                <c:pt idx="121">
                  <c:v>2.82697</c:v>
                </c:pt>
                <c:pt idx="122">
                  <c:v>1.97133</c:v>
                </c:pt>
                <c:pt idx="123">
                  <c:v>2.84262</c:v>
                </c:pt>
                <c:pt idx="124">
                  <c:v>1.76191</c:v>
                </c:pt>
                <c:pt idx="125">
                  <c:v>1.12582</c:v>
                </c:pt>
                <c:pt idx="126">
                  <c:v>1.58056</c:v>
                </c:pt>
                <c:pt idx="127">
                  <c:v>1.67952</c:v>
                </c:pt>
                <c:pt idx="128">
                  <c:v>2.353359999999999</c:v>
                </c:pt>
                <c:pt idx="129">
                  <c:v>1.95798</c:v>
                </c:pt>
                <c:pt idx="130">
                  <c:v>1.60818</c:v>
                </c:pt>
                <c:pt idx="131">
                  <c:v>1.60036</c:v>
                </c:pt>
                <c:pt idx="132">
                  <c:v>1.89263</c:v>
                </c:pt>
                <c:pt idx="133">
                  <c:v>1.42131</c:v>
                </c:pt>
                <c:pt idx="134">
                  <c:v>2.11356</c:v>
                </c:pt>
                <c:pt idx="135">
                  <c:v>3.27758</c:v>
                </c:pt>
                <c:pt idx="136">
                  <c:v>3.24075</c:v>
                </c:pt>
                <c:pt idx="137">
                  <c:v>2.9494</c:v>
                </c:pt>
                <c:pt idx="138">
                  <c:v>1.54927</c:v>
                </c:pt>
                <c:pt idx="139">
                  <c:v>2.63228</c:v>
                </c:pt>
                <c:pt idx="140">
                  <c:v>2.836639999999996</c:v>
                </c:pt>
                <c:pt idx="141">
                  <c:v>2.16142</c:v>
                </c:pt>
                <c:pt idx="142">
                  <c:v>2.5973</c:v>
                </c:pt>
                <c:pt idx="143">
                  <c:v>1.52625</c:v>
                </c:pt>
                <c:pt idx="144">
                  <c:v>2.24289</c:v>
                </c:pt>
                <c:pt idx="145">
                  <c:v>2.19226</c:v>
                </c:pt>
                <c:pt idx="146">
                  <c:v>2.19686</c:v>
                </c:pt>
                <c:pt idx="147">
                  <c:v>3.11878</c:v>
                </c:pt>
                <c:pt idx="148">
                  <c:v>2.21251</c:v>
                </c:pt>
                <c:pt idx="149">
                  <c:v>1.82911</c:v>
                </c:pt>
                <c:pt idx="150">
                  <c:v>4.17096</c:v>
                </c:pt>
                <c:pt idx="151">
                  <c:v>2.60098</c:v>
                </c:pt>
                <c:pt idx="152">
                  <c:v>2.76714</c:v>
                </c:pt>
                <c:pt idx="153">
                  <c:v>1.79597</c:v>
                </c:pt>
                <c:pt idx="154">
                  <c:v>4.1774</c:v>
                </c:pt>
                <c:pt idx="155">
                  <c:v>3.60575</c:v>
                </c:pt>
                <c:pt idx="156">
                  <c:v>3.472729999999999</c:v>
                </c:pt>
                <c:pt idx="157">
                  <c:v>1.65237</c:v>
                </c:pt>
                <c:pt idx="158">
                  <c:v>1.24871</c:v>
                </c:pt>
                <c:pt idx="159">
                  <c:v>1.54788</c:v>
                </c:pt>
                <c:pt idx="160">
                  <c:v>1.75409</c:v>
                </c:pt>
                <c:pt idx="161">
                  <c:v>1.47102</c:v>
                </c:pt>
                <c:pt idx="162">
                  <c:v>2.25394</c:v>
                </c:pt>
                <c:pt idx="163">
                  <c:v>2.22954</c:v>
                </c:pt>
                <c:pt idx="164">
                  <c:v>1.92208</c:v>
                </c:pt>
                <c:pt idx="165">
                  <c:v>1.96765</c:v>
                </c:pt>
                <c:pt idx="166">
                  <c:v>3.29138</c:v>
                </c:pt>
                <c:pt idx="167">
                  <c:v>2.60328</c:v>
                </c:pt>
                <c:pt idx="168">
                  <c:v>1.79183</c:v>
                </c:pt>
                <c:pt idx="169">
                  <c:v>2.091</c:v>
                </c:pt>
                <c:pt idx="170">
                  <c:v>1.67354</c:v>
                </c:pt>
                <c:pt idx="171">
                  <c:v>4.084429999999998</c:v>
                </c:pt>
                <c:pt idx="172">
                  <c:v>2.06799</c:v>
                </c:pt>
                <c:pt idx="173">
                  <c:v>2.66174</c:v>
                </c:pt>
                <c:pt idx="174">
                  <c:v>3.68307</c:v>
                </c:pt>
                <c:pt idx="175">
                  <c:v>2.631819999999998</c:v>
                </c:pt>
                <c:pt idx="176">
                  <c:v>2.23553</c:v>
                </c:pt>
                <c:pt idx="177">
                  <c:v>4.74353</c:v>
                </c:pt>
                <c:pt idx="178">
                  <c:v>2.874839999999998</c:v>
                </c:pt>
                <c:pt idx="179">
                  <c:v>2.65437</c:v>
                </c:pt>
                <c:pt idx="180">
                  <c:v>4.018149999999999</c:v>
                </c:pt>
                <c:pt idx="181">
                  <c:v>5.04961</c:v>
                </c:pt>
                <c:pt idx="182">
                  <c:v>1.81852</c:v>
                </c:pt>
                <c:pt idx="183">
                  <c:v>4.98517</c:v>
                </c:pt>
                <c:pt idx="184">
                  <c:v>1.61186</c:v>
                </c:pt>
                <c:pt idx="185">
                  <c:v>3.99283</c:v>
                </c:pt>
                <c:pt idx="186">
                  <c:v>5.062959999999975</c:v>
                </c:pt>
                <c:pt idx="187">
                  <c:v>3.01016</c:v>
                </c:pt>
                <c:pt idx="188">
                  <c:v>3.901699999999999</c:v>
                </c:pt>
                <c:pt idx="189">
                  <c:v>2.775879999999998</c:v>
                </c:pt>
                <c:pt idx="190">
                  <c:v>1.83739</c:v>
                </c:pt>
                <c:pt idx="191">
                  <c:v>5.50804</c:v>
                </c:pt>
                <c:pt idx="192">
                  <c:v>2.6424</c:v>
                </c:pt>
                <c:pt idx="193">
                  <c:v>3.306109999999999</c:v>
                </c:pt>
                <c:pt idx="194">
                  <c:v>2.12414</c:v>
                </c:pt>
                <c:pt idx="195">
                  <c:v>4.116189999999984</c:v>
                </c:pt>
                <c:pt idx="196">
                  <c:v>3.12016</c:v>
                </c:pt>
                <c:pt idx="197">
                  <c:v>4.68922</c:v>
                </c:pt>
                <c:pt idx="198">
                  <c:v>5.25075</c:v>
                </c:pt>
                <c:pt idx="199">
                  <c:v>5.43394</c:v>
                </c:pt>
                <c:pt idx="200">
                  <c:v>3.34708</c:v>
                </c:pt>
                <c:pt idx="201">
                  <c:v>5.96509</c:v>
                </c:pt>
                <c:pt idx="202">
                  <c:v>3.371929999999998</c:v>
                </c:pt>
                <c:pt idx="203">
                  <c:v>4.07844</c:v>
                </c:pt>
                <c:pt idx="204">
                  <c:v>3.525659999999998</c:v>
                </c:pt>
                <c:pt idx="205">
                  <c:v>1.7412</c:v>
                </c:pt>
                <c:pt idx="206">
                  <c:v>1.71036</c:v>
                </c:pt>
                <c:pt idx="207">
                  <c:v>4.30167</c:v>
                </c:pt>
                <c:pt idx="208">
                  <c:v>3.312559999999952</c:v>
                </c:pt>
                <c:pt idx="209">
                  <c:v>3.74107</c:v>
                </c:pt>
                <c:pt idx="210">
                  <c:v>5.51172</c:v>
                </c:pt>
                <c:pt idx="211">
                  <c:v>2.809019999999998</c:v>
                </c:pt>
                <c:pt idx="212">
                  <c:v>5.825159999999975</c:v>
                </c:pt>
                <c:pt idx="213">
                  <c:v>3.19749</c:v>
                </c:pt>
                <c:pt idx="214">
                  <c:v>1.2639</c:v>
                </c:pt>
                <c:pt idx="215">
                  <c:v>1.29888</c:v>
                </c:pt>
                <c:pt idx="216">
                  <c:v>0.929743</c:v>
                </c:pt>
                <c:pt idx="217">
                  <c:v>1.11661</c:v>
                </c:pt>
                <c:pt idx="218">
                  <c:v>2.07397</c:v>
                </c:pt>
                <c:pt idx="219">
                  <c:v>3.37699</c:v>
                </c:pt>
                <c:pt idx="220">
                  <c:v>1.23306</c:v>
                </c:pt>
                <c:pt idx="221">
                  <c:v>2.820069999999998</c:v>
                </c:pt>
                <c:pt idx="222">
                  <c:v>1.92438</c:v>
                </c:pt>
                <c:pt idx="223">
                  <c:v>6.557909999999985</c:v>
                </c:pt>
                <c:pt idx="224">
                  <c:v>5.344179999999985</c:v>
                </c:pt>
                <c:pt idx="225">
                  <c:v>4.37486</c:v>
                </c:pt>
                <c:pt idx="226">
                  <c:v>2.69119</c:v>
                </c:pt>
                <c:pt idx="227">
                  <c:v>4.01078</c:v>
                </c:pt>
                <c:pt idx="228">
                  <c:v>3.17033</c:v>
                </c:pt>
                <c:pt idx="229">
                  <c:v>4.49038</c:v>
                </c:pt>
                <c:pt idx="230">
                  <c:v>3.65085</c:v>
                </c:pt>
                <c:pt idx="231">
                  <c:v>2.95447</c:v>
                </c:pt>
                <c:pt idx="232">
                  <c:v>1.76835</c:v>
                </c:pt>
                <c:pt idx="233">
                  <c:v>1.37252</c:v>
                </c:pt>
                <c:pt idx="234">
                  <c:v>4.78173</c:v>
                </c:pt>
                <c:pt idx="235">
                  <c:v>2.38511</c:v>
                </c:pt>
                <c:pt idx="236">
                  <c:v>6.21639</c:v>
                </c:pt>
                <c:pt idx="237">
                  <c:v>3.85521</c:v>
                </c:pt>
                <c:pt idx="238">
                  <c:v>2.65437</c:v>
                </c:pt>
                <c:pt idx="239">
                  <c:v>5.22129</c:v>
                </c:pt>
                <c:pt idx="240">
                  <c:v>6.690009999999995</c:v>
                </c:pt>
                <c:pt idx="241">
                  <c:v>7.525859999999994</c:v>
                </c:pt>
                <c:pt idx="242">
                  <c:v>4.97229</c:v>
                </c:pt>
                <c:pt idx="243">
                  <c:v>5.40264</c:v>
                </c:pt>
                <c:pt idx="244">
                  <c:v>4.20226</c:v>
                </c:pt>
                <c:pt idx="245">
                  <c:v>4.93408</c:v>
                </c:pt>
                <c:pt idx="246">
                  <c:v>3.19703</c:v>
                </c:pt>
                <c:pt idx="247">
                  <c:v>4.57599</c:v>
                </c:pt>
                <c:pt idx="248">
                  <c:v>6.690009999999995</c:v>
                </c:pt>
                <c:pt idx="249">
                  <c:v>4.8632</c:v>
                </c:pt>
                <c:pt idx="250">
                  <c:v>3.13397</c:v>
                </c:pt>
                <c:pt idx="251">
                  <c:v>4.685999999999995</c:v>
                </c:pt>
                <c:pt idx="252">
                  <c:v>2.69672</c:v>
                </c:pt>
                <c:pt idx="253">
                  <c:v>5.13522</c:v>
                </c:pt>
                <c:pt idx="254">
                  <c:v>3.993749999999999</c:v>
                </c:pt>
                <c:pt idx="255">
                  <c:v>3.57951</c:v>
                </c:pt>
                <c:pt idx="256">
                  <c:v>3.83496</c:v>
                </c:pt>
                <c:pt idx="257">
                  <c:v>6.2882</c:v>
                </c:pt>
                <c:pt idx="258">
                  <c:v>5.40954</c:v>
                </c:pt>
                <c:pt idx="259">
                  <c:v>9.204460000000001</c:v>
                </c:pt>
                <c:pt idx="260">
                  <c:v>6.226519999999994</c:v>
                </c:pt>
                <c:pt idx="261">
                  <c:v>4.81902</c:v>
                </c:pt>
                <c:pt idx="262">
                  <c:v>7.45083</c:v>
                </c:pt>
                <c:pt idx="263">
                  <c:v>4.52122</c:v>
                </c:pt>
                <c:pt idx="264">
                  <c:v>3.858439999999998</c:v>
                </c:pt>
                <c:pt idx="265">
                  <c:v>4.28602</c:v>
                </c:pt>
                <c:pt idx="266">
                  <c:v>5.85324</c:v>
                </c:pt>
                <c:pt idx="267">
                  <c:v>4.73678</c:v>
                </c:pt>
                <c:pt idx="268">
                  <c:v>2.67416</c:v>
                </c:pt>
                <c:pt idx="269">
                  <c:v>6.441</c:v>
                </c:pt>
                <c:pt idx="270">
                  <c:v>8.64845</c:v>
                </c:pt>
                <c:pt idx="271">
                  <c:v>5.45603</c:v>
                </c:pt>
                <c:pt idx="272">
                  <c:v>4.91936</c:v>
                </c:pt>
                <c:pt idx="273">
                  <c:v>11.4202</c:v>
                </c:pt>
                <c:pt idx="274">
                  <c:v>10.8347</c:v>
                </c:pt>
                <c:pt idx="275">
                  <c:v>8.15827</c:v>
                </c:pt>
                <c:pt idx="276">
                  <c:v>6.29004</c:v>
                </c:pt>
                <c:pt idx="277">
                  <c:v>5.52369</c:v>
                </c:pt>
                <c:pt idx="278">
                  <c:v>7.96956</c:v>
                </c:pt>
                <c:pt idx="279">
                  <c:v>6.2348</c:v>
                </c:pt>
                <c:pt idx="280">
                  <c:v>3.461679999999999</c:v>
                </c:pt>
                <c:pt idx="281">
                  <c:v>4.832819999999995</c:v>
                </c:pt>
                <c:pt idx="282">
                  <c:v>4.163129999999986</c:v>
                </c:pt>
                <c:pt idx="283">
                  <c:v>6.57724</c:v>
                </c:pt>
                <c:pt idx="284">
                  <c:v>6.10363</c:v>
                </c:pt>
                <c:pt idx="285">
                  <c:v>4.41674</c:v>
                </c:pt>
                <c:pt idx="286">
                  <c:v>6.227899999999996</c:v>
                </c:pt>
                <c:pt idx="287">
                  <c:v>3.81517</c:v>
                </c:pt>
                <c:pt idx="288">
                  <c:v>6.41339</c:v>
                </c:pt>
                <c:pt idx="289">
                  <c:v>5.93701</c:v>
                </c:pt>
                <c:pt idx="290">
                  <c:v>5.148109999999996</c:v>
                </c:pt>
                <c:pt idx="291">
                  <c:v>6.545949999999999</c:v>
                </c:pt>
                <c:pt idx="292">
                  <c:v>5.07953</c:v>
                </c:pt>
                <c:pt idx="293">
                  <c:v>5.00082</c:v>
                </c:pt>
                <c:pt idx="294">
                  <c:v>5.44268</c:v>
                </c:pt>
                <c:pt idx="295">
                  <c:v>3.60114</c:v>
                </c:pt>
                <c:pt idx="296">
                  <c:v>5.13154</c:v>
                </c:pt>
                <c:pt idx="297">
                  <c:v>5.824239999999984</c:v>
                </c:pt>
                <c:pt idx="298">
                  <c:v>3.16251</c:v>
                </c:pt>
                <c:pt idx="299">
                  <c:v>6.58967</c:v>
                </c:pt>
                <c:pt idx="300">
                  <c:v>8.990430000000006</c:v>
                </c:pt>
                <c:pt idx="301">
                  <c:v>6.00421</c:v>
                </c:pt>
                <c:pt idx="302">
                  <c:v>6.25229</c:v>
                </c:pt>
                <c:pt idx="303">
                  <c:v>6.694149999999976</c:v>
                </c:pt>
                <c:pt idx="304">
                  <c:v>6.98274</c:v>
                </c:pt>
                <c:pt idx="305">
                  <c:v>5.665449999999986</c:v>
                </c:pt>
                <c:pt idx="306">
                  <c:v>7.159939999999994</c:v>
                </c:pt>
                <c:pt idx="307">
                  <c:v>4.38959</c:v>
                </c:pt>
                <c:pt idx="308">
                  <c:v>3.94957</c:v>
                </c:pt>
                <c:pt idx="309">
                  <c:v>4.7555</c:v>
                </c:pt>
                <c:pt idx="310">
                  <c:v>3.852449999999952</c:v>
                </c:pt>
                <c:pt idx="311">
                  <c:v>6.404179999999998</c:v>
                </c:pt>
                <c:pt idx="312">
                  <c:v>6.417529999999997</c:v>
                </c:pt>
                <c:pt idx="313">
                  <c:v>7.01726</c:v>
                </c:pt>
                <c:pt idx="314">
                  <c:v>10.4002</c:v>
                </c:pt>
                <c:pt idx="315">
                  <c:v>3.16665</c:v>
                </c:pt>
                <c:pt idx="316">
                  <c:v>6.99517</c:v>
                </c:pt>
                <c:pt idx="317">
                  <c:v>7.115759999999995</c:v>
                </c:pt>
                <c:pt idx="318">
                  <c:v>4.53641</c:v>
                </c:pt>
                <c:pt idx="319">
                  <c:v>5.75981</c:v>
                </c:pt>
                <c:pt idx="320">
                  <c:v>7.59996</c:v>
                </c:pt>
                <c:pt idx="321">
                  <c:v>5.387909999999985</c:v>
                </c:pt>
                <c:pt idx="322">
                  <c:v>5.30138</c:v>
                </c:pt>
                <c:pt idx="323">
                  <c:v>3.28402</c:v>
                </c:pt>
                <c:pt idx="324">
                  <c:v>4.464149999999996</c:v>
                </c:pt>
                <c:pt idx="325">
                  <c:v>9.576360000000001</c:v>
                </c:pt>
                <c:pt idx="326">
                  <c:v>5.66177</c:v>
                </c:pt>
                <c:pt idx="327">
                  <c:v>6.48013</c:v>
                </c:pt>
                <c:pt idx="328">
                  <c:v>6.70658</c:v>
                </c:pt>
                <c:pt idx="329">
                  <c:v>5.77822</c:v>
                </c:pt>
                <c:pt idx="330">
                  <c:v>8.53293</c:v>
                </c:pt>
                <c:pt idx="331">
                  <c:v>6.27163</c:v>
                </c:pt>
                <c:pt idx="332">
                  <c:v>7.0168</c:v>
                </c:pt>
                <c:pt idx="333">
                  <c:v>5.467079999999997</c:v>
                </c:pt>
                <c:pt idx="334">
                  <c:v>6.225139999999985</c:v>
                </c:pt>
                <c:pt idx="335">
                  <c:v>7.634019999999976</c:v>
                </c:pt>
                <c:pt idx="336">
                  <c:v>4.27544</c:v>
                </c:pt>
                <c:pt idx="337">
                  <c:v>4.621559999999984</c:v>
                </c:pt>
                <c:pt idx="338">
                  <c:v>5.52185</c:v>
                </c:pt>
                <c:pt idx="339">
                  <c:v>7.28146</c:v>
                </c:pt>
                <c:pt idx="340">
                  <c:v>3.52612</c:v>
                </c:pt>
                <c:pt idx="341">
                  <c:v>5.44912</c:v>
                </c:pt>
                <c:pt idx="342">
                  <c:v>4.187529999999994</c:v>
                </c:pt>
                <c:pt idx="343">
                  <c:v>3.51507</c:v>
                </c:pt>
                <c:pt idx="344">
                  <c:v>4.98471</c:v>
                </c:pt>
                <c:pt idx="345">
                  <c:v>5.381</c:v>
                </c:pt>
                <c:pt idx="346">
                  <c:v>6.97262</c:v>
                </c:pt>
                <c:pt idx="347">
                  <c:v>8.686660000000001</c:v>
                </c:pt>
                <c:pt idx="348">
                  <c:v>3.32498</c:v>
                </c:pt>
                <c:pt idx="349">
                  <c:v>3.655</c:v>
                </c:pt>
                <c:pt idx="350">
                  <c:v>5.33958</c:v>
                </c:pt>
                <c:pt idx="351">
                  <c:v>4.100079999999997</c:v>
                </c:pt>
                <c:pt idx="352">
                  <c:v>2.27787</c:v>
                </c:pt>
                <c:pt idx="353">
                  <c:v>4.10974</c:v>
                </c:pt>
                <c:pt idx="354">
                  <c:v>10.5144</c:v>
                </c:pt>
                <c:pt idx="355">
                  <c:v>3.34063</c:v>
                </c:pt>
                <c:pt idx="356">
                  <c:v>4.054969999999996</c:v>
                </c:pt>
                <c:pt idx="357">
                  <c:v>2.48775</c:v>
                </c:pt>
                <c:pt idx="358">
                  <c:v>2.37821</c:v>
                </c:pt>
                <c:pt idx="359">
                  <c:v>4.84617</c:v>
                </c:pt>
                <c:pt idx="360">
                  <c:v>5.842189999999976</c:v>
                </c:pt>
                <c:pt idx="361">
                  <c:v>2.60834</c:v>
                </c:pt>
                <c:pt idx="362">
                  <c:v>2.96367</c:v>
                </c:pt>
                <c:pt idx="363">
                  <c:v>6.84604</c:v>
                </c:pt>
                <c:pt idx="364">
                  <c:v>5.94253</c:v>
                </c:pt>
                <c:pt idx="365">
                  <c:v>6.59934</c:v>
                </c:pt>
                <c:pt idx="366">
                  <c:v>5.356149999999999</c:v>
                </c:pt>
                <c:pt idx="367">
                  <c:v>1.73015</c:v>
                </c:pt>
                <c:pt idx="368">
                  <c:v>4.78035</c:v>
                </c:pt>
                <c:pt idx="369">
                  <c:v>3.12615</c:v>
                </c:pt>
                <c:pt idx="370">
                  <c:v>3.416119999999998</c:v>
                </c:pt>
                <c:pt idx="371">
                  <c:v>4.8563</c:v>
                </c:pt>
                <c:pt idx="372">
                  <c:v>3.52474</c:v>
                </c:pt>
                <c:pt idx="373">
                  <c:v>3.71943</c:v>
                </c:pt>
                <c:pt idx="374">
                  <c:v>6.424899999999996</c:v>
                </c:pt>
                <c:pt idx="375">
                  <c:v>6.13631</c:v>
                </c:pt>
                <c:pt idx="376">
                  <c:v>5.253509999999999</c:v>
                </c:pt>
                <c:pt idx="377">
                  <c:v>5.07677</c:v>
                </c:pt>
                <c:pt idx="378">
                  <c:v>9.43045</c:v>
                </c:pt>
                <c:pt idx="379">
                  <c:v>4.46001</c:v>
                </c:pt>
                <c:pt idx="380">
                  <c:v>5.399879999999999</c:v>
                </c:pt>
                <c:pt idx="381">
                  <c:v>7.57281</c:v>
                </c:pt>
                <c:pt idx="382">
                  <c:v>7.23037</c:v>
                </c:pt>
                <c:pt idx="383">
                  <c:v>7.167309999999985</c:v>
                </c:pt>
                <c:pt idx="384">
                  <c:v>4.75228</c:v>
                </c:pt>
                <c:pt idx="385">
                  <c:v>4.660219999999985</c:v>
                </c:pt>
                <c:pt idx="386">
                  <c:v>4.134599999999994</c:v>
                </c:pt>
                <c:pt idx="387">
                  <c:v>2.6622</c:v>
                </c:pt>
                <c:pt idx="388">
                  <c:v>5.58582</c:v>
                </c:pt>
                <c:pt idx="389">
                  <c:v>6.17727</c:v>
                </c:pt>
                <c:pt idx="390">
                  <c:v>4.639509999999999</c:v>
                </c:pt>
                <c:pt idx="391">
                  <c:v>4.22665</c:v>
                </c:pt>
                <c:pt idx="392">
                  <c:v>7.03613</c:v>
                </c:pt>
                <c:pt idx="393">
                  <c:v>4.164509999999964</c:v>
                </c:pt>
                <c:pt idx="394">
                  <c:v>4.837429999999999</c:v>
                </c:pt>
                <c:pt idx="395">
                  <c:v>7.37305</c:v>
                </c:pt>
                <c:pt idx="396">
                  <c:v>4.054509999999985</c:v>
                </c:pt>
                <c:pt idx="397">
                  <c:v>5.45235</c:v>
                </c:pt>
                <c:pt idx="398">
                  <c:v>3.799059999999998</c:v>
                </c:pt>
                <c:pt idx="399">
                  <c:v>5.003579999999999</c:v>
                </c:pt>
                <c:pt idx="400">
                  <c:v>2.325279999999998</c:v>
                </c:pt>
                <c:pt idx="401">
                  <c:v>3.37331</c:v>
                </c:pt>
                <c:pt idx="402">
                  <c:v>1.21603</c:v>
                </c:pt>
                <c:pt idx="403">
                  <c:v>2.513069999999999</c:v>
                </c:pt>
                <c:pt idx="404">
                  <c:v>3.16665</c:v>
                </c:pt>
                <c:pt idx="405">
                  <c:v>4.46139</c:v>
                </c:pt>
                <c:pt idx="406">
                  <c:v>4.23079</c:v>
                </c:pt>
                <c:pt idx="407">
                  <c:v>2.905679999999998</c:v>
                </c:pt>
                <c:pt idx="408">
                  <c:v>3.17355</c:v>
                </c:pt>
                <c:pt idx="409">
                  <c:v>2.22908</c:v>
                </c:pt>
                <c:pt idx="410">
                  <c:v>3.395859999999952</c:v>
                </c:pt>
                <c:pt idx="411">
                  <c:v>2.54667</c:v>
                </c:pt>
                <c:pt idx="412">
                  <c:v>3.68215</c:v>
                </c:pt>
                <c:pt idx="413">
                  <c:v>3.00003</c:v>
                </c:pt>
                <c:pt idx="414">
                  <c:v>4.111579999999996</c:v>
                </c:pt>
                <c:pt idx="415">
                  <c:v>2.46796</c:v>
                </c:pt>
                <c:pt idx="416">
                  <c:v>4.73157</c:v>
                </c:pt>
                <c:pt idx="417">
                  <c:v>2.880819999999999</c:v>
                </c:pt>
                <c:pt idx="418">
                  <c:v>2.836639999999996</c:v>
                </c:pt>
                <c:pt idx="419">
                  <c:v>8.76398</c:v>
                </c:pt>
                <c:pt idx="420">
                  <c:v>4.58382</c:v>
                </c:pt>
                <c:pt idx="421">
                  <c:v>5.49147</c:v>
                </c:pt>
                <c:pt idx="422">
                  <c:v>3.07091</c:v>
                </c:pt>
                <c:pt idx="423">
                  <c:v>3.08979</c:v>
                </c:pt>
                <c:pt idx="424">
                  <c:v>2.21435</c:v>
                </c:pt>
                <c:pt idx="425">
                  <c:v>1.96765</c:v>
                </c:pt>
                <c:pt idx="426">
                  <c:v>3.80735</c:v>
                </c:pt>
                <c:pt idx="427">
                  <c:v>3.49298</c:v>
                </c:pt>
                <c:pt idx="428">
                  <c:v>2.88036</c:v>
                </c:pt>
                <c:pt idx="429">
                  <c:v>2.473949999999999</c:v>
                </c:pt>
                <c:pt idx="430">
                  <c:v>5.53704</c:v>
                </c:pt>
                <c:pt idx="431">
                  <c:v>2.4316</c:v>
                </c:pt>
                <c:pt idx="432">
                  <c:v>2.78739</c:v>
                </c:pt>
                <c:pt idx="433">
                  <c:v>1.43282</c:v>
                </c:pt>
                <c:pt idx="434">
                  <c:v>2.20331</c:v>
                </c:pt>
                <c:pt idx="435">
                  <c:v>3.328209999999999</c:v>
                </c:pt>
                <c:pt idx="436">
                  <c:v>1.49818</c:v>
                </c:pt>
                <c:pt idx="437">
                  <c:v>2.43298</c:v>
                </c:pt>
                <c:pt idx="438">
                  <c:v>3.117859999999999</c:v>
                </c:pt>
                <c:pt idx="439">
                  <c:v>1.16448</c:v>
                </c:pt>
                <c:pt idx="440">
                  <c:v>1.54696</c:v>
                </c:pt>
                <c:pt idx="441">
                  <c:v>1.36838</c:v>
                </c:pt>
                <c:pt idx="442">
                  <c:v>2.77174</c:v>
                </c:pt>
                <c:pt idx="443">
                  <c:v>1.76789</c:v>
                </c:pt>
                <c:pt idx="444">
                  <c:v>1.75224</c:v>
                </c:pt>
                <c:pt idx="445">
                  <c:v>1.36654</c:v>
                </c:pt>
                <c:pt idx="446">
                  <c:v>1.19394</c:v>
                </c:pt>
                <c:pt idx="447">
                  <c:v>2.49052</c:v>
                </c:pt>
                <c:pt idx="448">
                  <c:v>1.75731</c:v>
                </c:pt>
                <c:pt idx="449">
                  <c:v>5.24108</c:v>
                </c:pt>
                <c:pt idx="450">
                  <c:v>2.78049</c:v>
                </c:pt>
                <c:pt idx="451">
                  <c:v>2.066609999999998</c:v>
                </c:pt>
                <c:pt idx="452">
                  <c:v>2.24105</c:v>
                </c:pt>
                <c:pt idx="453">
                  <c:v>2.99313</c:v>
                </c:pt>
                <c:pt idx="454">
                  <c:v>2.841699999999999</c:v>
                </c:pt>
                <c:pt idx="455">
                  <c:v>2.10159</c:v>
                </c:pt>
                <c:pt idx="456">
                  <c:v>3.4534</c:v>
                </c:pt>
                <c:pt idx="457">
                  <c:v>1.24779</c:v>
                </c:pt>
                <c:pt idx="458">
                  <c:v>2.911659999999952</c:v>
                </c:pt>
                <c:pt idx="459">
                  <c:v>2.804879999999998</c:v>
                </c:pt>
                <c:pt idx="460">
                  <c:v>3.69734</c:v>
                </c:pt>
                <c:pt idx="461">
                  <c:v>2.23553</c:v>
                </c:pt>
                <c:pt idx="462">
                  <c:v>2.69165</c:v>
                </c:pt>
                <c:pt idx="463">
                  <c:v>1.27909</c:v>
                </c:pt>
                <c:pt idx="464">
                  <c:v>2.58671</c:v>
                </c:pt>
                <c:pt idx="465">
                  <c:v>2.43758</c:v>
                </c:pt>
                <c:pt idx="466">
                  <c:v>4.062329999999998</c:v>
                </c:pt>
                <c:pt idx="467">
                  <c:v>3.534409999999998</c:v>
                </c:pt>
                <c:pt idx="468">
                  <c:v>3.68123</c:v>
                </c:pt>
                <c:pt idx="469">
                  <c:v>5.76533</c:v>
                </c:pt>
                <c:pt idx="470">
                  <c:v>3.912749999999976</c:v>
                </c:pt>
                <c:pt idx="471">
                  <c:v>3.23569</c:v>
                </c:pt>
                <c:pt idx="472">
                  <c:v>2.43298</c:v>
                </c:pt>
                <c:pt idx="473">
                  <c:v>4.5157</c:v>
                </c:pt>
                <c:pt idx="474">
                  <c:v>3.029949999999999</c:v>
                </c:pt>
                <c:pt idx="475">
                  <c:v>5.780979999999999</c:v>
                </c:pt>
                <c:pt idx="476">
                  <c:v>3.2449</c:v>
                </c:pt>
                <c:pt idx="477">
                  <c:v>5.764409999999986</c:v>
                </c:pt>
                <c:pt idx="478">
                  <c:v>3.65822</c:v>
                </c:pt>
                <c:pt idx="479">
                  <c:v>3.36503</c:v>
                </c:pt>
                <c:pt idx="480">
                  <c:v>5.653019999999985</c:v>
                </c:pt>
                <c:pt idx="481">
                  <c:v>4.022749999999998</c:v>
                </c:pt>
                <c:pt idx="482">
                  <c:v>3.406909999999999</c:v>
                </c:pt>
                <c:pt idx="483">
                  <c:v>1.01996</c:v>
                </c:pt>
                <c:pt idx="484">
                  <c:v>4.43653</c:v>
                </c:pt>
                <c:pt idx="485">
                  <c:v>3.75303</c:v>
                </c:pt>
                <c:pt idx="486">
                  <c:v>2.95677</c:v>
                </c:pt>
                <c:pt idx="487">
                  <c:v>3.26561</c:v>
                </c:pt>
                <c:pt idx="488">
                  <c:v>3.23753</c:v>
                </c:pt>
                <c:pt idx="489">
                  <c:v>3.938979999999999</c:v>
                </c:pt>
                <c:pt idx="490">
                  <c:v>6.48841</c:v>
                </c:pt>
                <c:pt idx="491">
                  <c:v>4.414439999999995</c:v>
                </c:pt>
                <c:pt idx="492">
                  <c:v>4.91107</c:v>
                </c:pt>
                <c:pt idx="493">
                  <c:v>5.51724</c:v>
                </c:pt>
                <c:pt idx="494">
                  <c:v>3.91045</c:v>
                </c:pt>
                <c:pt idx="495">
                  <c:v>2.9135</c:v>
                </c:pt>
                <c:pt idx="496">
                  <c:v>7.13371</c:v>
                </c:pt>
                <c:pt idx="497">
                  <c:v>3.04836</c:v>
                </c:pt>
                <c:pt idx="498">
                  <c:v>3.658679999999998</c:v>
                </c:pt>
                <c:pt idx="499">
                  <c:v>3.384819999999999</c:v>
                </c:pt>
                <c:pt idx="500">
                  <c:v>2.672779999999999</c:v>
                </c:pt>
                <c:pt idx="501">
                  <c:v>4.52997</c:v>
                </c:pt>
                <c:pt idx="502">
                  <c:v>2.359799999999999</c:v>
                </c:pt>
                <c:pt idx="503">
                  <c:v>4.603149999999998</c:v>
                </c:pt>
                <c:pt idx="504">
                  <c:v>5.212089999999995</c:v>
                </c:pt>
                <c:pt idx="505">
                  <c:v>3.08887</c:v>
                </c:pt>
                <c:pt idx="506">
                  <c:v>2.675079999999998</c:v>
                </c:pt>
                <c:pt idx="507">
                  <c:v>4.29477</c:v>
                </c:pt>
                <c:pt idx="508">
                  <c:v>5.71056</c:v>
                </c:pt>
                <c:pt idx="509">
                  <c:v>4.77391</c:v>
                </c:pt>
                <c:pt idx="510">
                  <c:v>5.568789999999995</c:v>
                </c:pt>
                <c:pt idx="511">
                  <c:v>6.064959999999965</c:v>
                </c:pt>
                <c:pt idx="512">
                  <c:v>3.209</c:v>
                </c:pt>
                <c:pt idx="513">
                  <c:v>4.163589999999965</c:v>
                </c:pt>
                <c:pt idx="514">
                  <c:v>4.93546</c:v>
                </c:pt>
                <c:pt idx="515">
                  <c:v>1.4342</c:v>
                </c:pt>
                <c:pt idx="516">
                  <c:v>6.185089999999994</c:v>
                </c:pt>
                <c:pt idx="517">
                  <c:v>6.70152</c:v>
                </c:pt>
                <c:pt idx="518">
                  <c:v>5.86935</c:v>
                </c:pt>
                <c:pt idx="519">
                  <c:v>7.30309</c:v>
                </c:pt>
                <c:pt idx="520">
                  <c:v>3.57307</c:v>
                </c:pt>
                <c:pt idx="521">
                  <c:v>6.222379999999998</c:v>
                </c:pt>
                <c:pt idx="522">
                  <c:v>4.15117</c:v>
                </c:pt>
                <c:pt idx="523">
                  <c:v>2.576589999999999</c:v>
                </c:pt>
                <c:pt idx="524">
                  <c:v>6.00329</c:v>
                </c:pt>
                <c:pt idx="525">
                  <c:v>4.61328</c:v>
                </c:pt>
                <c:pt idx="526">
                  <c:v>5.94575</c:v>
                </c:pt>
                <c:pt idx="527">
                  <c:v>5.615279999999998</c:v>
                </c:pt>
                <c:pt idx="528">
                  <c:v>3.75856</c:v>
                </c:pt>
                <c:pt idx="529">
                  <c:v>6.23665</c:v>
                </c:pt>
                <c:pt idx="530">
                  <c:v>4.494989999999984</c:v>
                </c:pt>
                <c:pt idx="531">
                  <c:v>4.94237</c:v>
                </c:pt>
                <c:pt idx="532">
                  <c:v>5.47352</c:v>
                </c:pt>
                <c:pt idx="533">
                  <c:v>6.93533</c:v>
                </c:pt>
                <c:pt idx="534">
                  <c:v>6.53904</c:v>
                </c:pt>
                <c:pt idx="535">
                  <c:v>3.03409</c:v>
                </c:pt>
                <c:pt idx="536">
                  <c:v>4.153009999999997</c:v>
                </c:pt>
                <c:pt idx="537">
                  <c:v>4.47602</c:v>
                </c:pt>
                <c:pt idx="538">
                  <c:v>3.3793</c:v>
                </c:pt>
                <c:pt idx="539">
                  <c:v>6.76181</c:v>
                </c:pt>
                <c:pt idx="540">
                  <c:v>7.126339999999995</c:v>
                </c:pt>
                <c:pt idx="541">
                  <c:v>6.834989999999975</c:v>
                </c:pt>
                <c:pt idx="542">
                  <c:v>4.41122</c:v>
                </c:pt>
                <c:pt idx="543">
                  <c:v>7.70352</c:v>
                </c:pt>
                <c:pt idx="544">
                  <c:v>3.85291</c:v>
                </c:pt>
                <c:pt idx="545">
                  <c:v>5.37088</c:v>
                </c:pt>
                <c:pt idx="546">
                  <c:v>4.77989</c:v>
                </c:pt>
                <c:pt idx="547">
                  <c:v>4.77621</c:v>
                </c:pt>
                <c:pt idx="548">
                  <c:v>4.872409999999999</c:v>
                </c:pt>
                <c:pt idx="549">
                  <c:v>6.33468</c:v>
                </c:pt>
                <c:pt idx="550">
                  <c:v>8.11638</c:v>
                </c:pt>
                <c:pt idx="551">
                  <c:v>8.64155</c:v>
                </c:pt>
                <c:pt idx="552">
                  <c:v>4.894499999999986</c:v>
                </c:pt>
                <c:pt idx="553">
                  <c:v>2.88497</c:v>
                </c:pt>
                <c:pt idx="554">
                  <c:v>4.86136</c:v>
                </c:pt>
                <c:pt idx="555">
                  <c:v>5.157769999999998</c:v>
                </c:pt>
                <c:pt idx="556">
                  <c:v>4.75734</c:v>
                </c:pt>
                <c:pt idx="557">
                  <c:v>1.85949</c:v>
                </c:pt>
                <c:pt idx="558">
                  <c:v>3.93162</c:v>
                </c:pt>
                <c:pt idx="559">
                  <c:v>4.244139999999994</c:v>
                </c:pt>
                <c:pt idx="560">
                  <c:v>4.01723</c:v>
                </c:pt>
                <c:pt idx="561">
                  <c:v>4.31364</c:v>
                </c:pt>
                <c:pt idx="562">
                  <c:v>6.03827</c:v>
                </c:pt>
                <c:pt idx="563">
                  <c:v>3.01752</c:v>
                </c:pt>
                <c:pt idx="564">
                  <c:v>5.328069999999998</c:v>
                </c:pt>
                <c:pt idx="565">
                  <c:v>3.8391</c:v>
                </c:pt>
                <c:pt idx="566">
                  <c:v>4.09317</c:v>
                </c:pt>
                <c:pt idx="567">
                  <c:v>3.46721</c:v>
                </c:pt>
                <c:pt idx="568">
                  <c:v>7.57557</c:v>
                </c:pt>
                <c:pt idx="569">
                  <c:v>6.610379999999997</c:v>
                </c:pt>
                <c:pt idx="570">
                  <c:v>8.589540000000004</c:v>
                </c:pt>
                <c:pt idx="571">
                  <c:v>5.25995</c:v>
                </c:pt>
                <c:pt idx="572">
                  <c:v>4.44344</c:v>
                </c:pt>
                <c:pt idx="573">
                  <c:v>3.79538</c:v>
                </c:pt>
                <c:pt idx="574">
                  <c:v>4.17096</c:v>
                </c:pt>
                <c:pt idx="575">
                  <c:v>2.473949999999999</c:v>
                </c:pt>
                <c:pt idx="576">
                  <c:v>4.76424</c:v>
                </c:pt>
                <c:pt idx="577">
                  <c:v>4.367949999999976</c:v>
                </c:pt>
                <c:pt idx="578">
                  <c:v>3.380679999999999</c:v>
                </c:pt>
                <c:pt idx="579">
                  <c:v>2.954009999999998</c:v>
                </c:pt>
                <c:pt idx="580">
                  <c:v>4.5157</c:v>
                </c:pt>
                <c:pt idx="581">
                  <c:v>4.93546</c:v>
                </c:pt>
                <c:pt idx="582">
                  <c:v>7.27547</c:v>
                </c:pt>
                <c:pt idx="583">
                  <c:v>5.526909999999996</c:v>
                </c:pt>
                <c:pt idx="584">
                  <c:v>2.39754</c:v>
                </c:pt>
                <c:pt idx="585">
                  <c:v>3.571689999999998</c:v>
                </c:pt>
                <c:pt idx="586">
                  <c:v>6.094879999999987</c:v>
                </c:pt>
                <c:pt idx="587">
                  <c:v>4.52997</c:v>
                </c:pt>
                <c:pt idx="588">
                  <c:v>4.35</c:v>
                </c:pt>
                <c:pt idx="589">
                  <c:v>6.194759999999984</c:v>
                </c:pt>
                <c:pt idx="590">
                  <c:v>6.71302</c:v>
                </c:pt>
                <c:pt idx="591">
                  <c:v>6.94408</c:v>
                </c:pt>
                <c:pt idx="592">
                  <c:v>8.034919999999997</c:v>
                </c:pt>
                <c:pt idx="593">
                  <c:v>4.267609999999999</c:v>
                </c:pt>
                <c:pt idx="594">
                  <c:v>2.64701</c:v>
                </c:pt>
                <c:pt idx="595">
                  <c:v>7.316899999999999</c:v>
                </c:pt>
                <c:pt idx="596">
                  <c:v>3.19473</c:v>
                </c:pt>
                <c:pt idx="597">
                  <c:v>5.74508</c:v>
                </c:pt>
                <c:pt idx="598">
                  <c:v>7.82365</c:v>
                </c:pt>
                <c:pt idx="599">
                  <c:v>6.220539999999994</c:v>
                </c:pt>
                <c:pt idx="600">
                  <c:v>3.91597</c:v>
                </c:pt>
                <c:pt idx="601">
                  <c:v>3.77144</c:v>
                </c:pt>
                <c:pt idx="602">
                  <c:v>3.499429999999998</c:v>
                </c:pt>
                <c:pt idx="603">
                  <c:v>8.60473</c:v>
                </c:pt>
                <c:pt idx="604">
                  <c:v>6.4746</c:v>
                </c:pt>
                <c:pt idx="605">
                  <c:v>5.43256</c:v>
                </c:pt>
                <c:pt idx="606">
                  <c:v>4.344019999999976</c:v>
                </c:pt>
                <c:pt idx="607">
                  <c:v>2.044049999999999</c:v>
                </c:pt>
                <c:pt idx="608">
                  <c:v>6.377949999999998</c:v>
                </c:pt>
                <c:pt idx="609">
                  <c:v>3.09255</c:v>
                </c:pt>
                <c:pt idx="610">
                  <c:v>5.24615</c:v>
                </c:pt>
                <c:pt idx="611">
                  <c:v>3.47595</c:v>
                </c:pt>
                <c:pt idx="612">
                  <c:v>5.04179</c:v>
                </c:pt>
                <c:pt idx="613">
                  <c:v>2.5347</c:v>
                </c:pt>
                <c:pt idx="614">
                  <c:v>3.29138</c:v>
                </c:pt>
                <c:pt idx="615">
                  <c:v>3.2136</c:v>
                </c:pt>
                <c:pt idx="616">
                  <c:v>3.873619999999998</c:v>
                </c:pt>
                <c:pt idx="617">
                  <c:v>5.38239</c:v>
                </c:pt>
                <c:pt idx="618">
                  <c:v>4.20088</c:v>
                </c:pt>
                <c:pt idx="619">
                  <c:v>4.43837</c:v>
                </c:pt>
                <c:pt idx="620">
                  <c:v>5.669589999999966</c:v>
                </c:pt>
                <c:pt idx="621">
                  <c:v>3.380679999999999</c:v>
                </c:pt>
                <c:pt idx="622">
                  <c:v>6.43134</c:v>
                </c:pt>
                <c:pt idx="623">
                  <c:v>5.57064</c:v>
                </c:pt>
                <c:pt idx="624">
                  <c:v>4.50143</c:v>
                </c:pt>
                <c:pt idx="625">
                  <c:v>3.74797</c:v>
                </c:pt>
                <c:pt idx="626">
                  <c:v>4.70349</c:v>
                </c:pt>
                <c:pt idx="627">
                  <c:v>2.89325</c:v>
                </c:pt>
                <c:pt idx="628">
                  <c:v>6.023539999999985</c:v>
                </c:pt>
                <c:pt idx="629">
                  <c:v>5.23924</c:v>
                </c:pt>
                <c:pt idx="630">
                  <c:v>5.54854</c:v>
                </c:pt>
                <c:pt idx="631">
                  <c:v>4.50097</c:v>
                </c:pt>
                <c:pt idx="632">
                  <c:v>4.54516</c:v>
                </c:pt>
                <c:pt idx="633">
                  <c:v>3.37469</c:v>
                </c:pt>
                <c:pt idx="634">
                  <c:v>2.62031</c:v>
                </c:pt>
                <c:pt idx="635">
                  <c:v>7.97186</c:v>
                </c:pt>
                <c:pt idx="636">
                  <c:v>6.48887</c:v>
                </c:pt>
                <c:pt idx="637">
                  <c:v>2.859189999999999</c:v>
                </c:pt>
                <c:pt idx="638">
                  <c:v>4.00572</c:v>
                </c:pt>
                <c:pt idx="639">
                  <c:v>3.845549999999998</c:v>
                </c:pt>
                <c:pt idx="640">
                  <c:v>8.382420000000006</c:v>
                </c:pt>
                <c:pt idx="641">
                  <c:v>4.97183</c:v>
                </c:pt>
                <c:pt idx="642">
                  <c:v>5.107609999999998</c:v>
                </c:pt>
                <c:pt idx="643">
                  <c:v>8.14998</c:v>
                </c:pt>
                <c:pt idx="644">
                  <c:v>5.855079999999996</c:v>
                </c:pt>
                <c:pt idx="645">
                  <c:v>5.352009999999995</c:v>
                </c:pt>
                <c:pt idx="646">
                  <c:v>7.186179999999998</c:v>
                </c:pt>
                <c:pt idx="647">
                  <c:v>5.24431</c:v>
                </c:pt>
                <c:pt idx="648">
                  <c:v>4.03702</c:v>
                </c:pt>
                <c:pt idx="649">
                  <c:v>6.95835</c:v>
                </c:pt>
                <c:pt idx="650">
                  <c:v>4.47934</c:v>
                </c:pt>
                <c:pt idx="651">
                  <c:v>3.391259999999952</c:v>
                </c:pt>
                <c:pt idx="652">
                  <c:v>4.821779999999999</c:v>
                </c:pt>
                <c:pt idx="653">
                  <c:v>6.13032</c:v>
                </c:pt>
                <c:pt idx="654">
                  <c:v>3.898019999999998</c:v>
                </c:pt>
                <c:pt idx="655">
                  <c:v>3.60253</c:v>
                </c:pt>
                <c:pt idx="656">
                  <c:v>2.45692</c:v>
                </c:pt>
                <c:pt idx="657">
                  <c:v>2.4293</c:v>
                </c:pt>
                <c:pt idx="658">
                  <c:v>3.959229999999998</c:v>
                </c:pt>
                <c:pt idx="659">
                  <c:v>2.94618</c:v>
                </c:pt>
                <c:pt idx="660">
                  <c:v>4.882529999999996</c:v>
                </c:pt>
                <c:pt idx="661">
                  <c:v>4.128149999999994</c:v>
                </c:pt>
                <c:pt idx="662">
                  <c:v>3.534409999999998</c:v>
                </c:pt>
                <c:pt idx="663">
                  <c:v>4.847089999999985</c:v>
                </c:pt>
                <c:pt idx="664">
                  <c:v>4.04853</c:v>
                </c:pt>
                <c:pt idx="665">
                  <c:v>5.09196</c:v>
                </c:pt>
                <c:pt idx="666">
                  <c:v>5.49653</c:v>
                </c:pt>
                <c:pt idx="667">
                  <c:v>6.558829999999999</c:v>
                </c:pt>
                <c:pt idx="668">
                  <c:v>3.339249999999952</c:v>
                </c:pt>
                <c:pt idx="669">
                  <c:v>3.82714</c:v>
                </c:pt>
                <c:pt idx="670">
                  <c:v>8.241119999999997</c:v>
                </c:pt>
                <c:pt idx="671">
                  <c:v>5.307819999999984</c:v>
                </c:pt>
                <c:pt idx="672">
                  <c:v>3.6283</c:v>
                </c:pt>
                <c:pt idx="673">
                  <c:v>4.4172</c:v>
                </c:pt>
                <c:pt idx="674">
                  <c:v>3.072299999999998</c:v>
                </c:pt>
                <c:pt idx="675">
                  <c:v>2.63044</c:v>
                </c:pt>
                <c:pt idx="676">
                  <c:v>3.81103</c:v>
                </c:pt>
                <c:pt idx="677">
                  <c:v>4.51662</c:v>
                </c:pt>
                <c:pt idx="678">
                  <c:v>2.405829999999999</c:v>
                </c:pt>
                <c:pt idx="679">
                  <c:v>4.34724</c:v>
                </c:pt>
                <c:pt idx="680">
                  <c:v>4.52352</c:v>
                </c:pt>
                <c:pt idx="681">
                  <c:v>2.94526</c:v>
                </c:pt>
                <c:pt idx="682">
                  <c:v>5.17803</c:v>
                </c:pt>
                <c:pt idx="683">
                  <c:v>3.8032</c:v>
                </c:pt>
                <c:pt idx="684">
                  <c:v>4.17924</c:v>
                </c:pt>
                <c:pt idx="685">
                  <c:v>3.54867</c:v>
                </c:pt>
                <c:pt idx="686">
                  <c:v>4.18937</c:v>
                </c:pt>
                <c:pt idx="687">
                  <c:v>2.46658</c:v>
                </c:pt>
                <c:pt idx="688">
                  <c:v>2.850909999999998</c:v>
                </c:pt>
                <c:pt idx="689">
                  <c:v>4.9014</c:v>
                </c:pt>
                <c:pt idx="690">
                  <c:v>4.9976</c:v>
                </c:pt>
                <c:pt idx="691">
                  <c:v>2.76898</c:v>
                </c:pt>
                <c:pt idx="692">
                  <c:v>3.5924</c:v>
                </c:pt>
                <c:pt idx="693">
                  <c:v>3.812409999999952</c:v>
                </c:pt>
                <c:pt idx="694">
                  <c:v>5.87717</c:v>
                </c:pt>
                <c:pt idx="695">
                  <c:v>3.51047</c:v>
                </c:pt>
                <c:pt idx="696">
                  <c:v>5.83805</c:v>
                </c:pt>
                <c:pt idx="697">
                  <c:v>4.3408</c:v>
                </c:pt>
                <c:pt idx="698">
                  <c:v>5.13338</c:v>
                </c:pt>
                <c:pt idx="699">
                  <c:v>5.03949</c:v>
                </c:pt>
                <c:pt idx="700">
                  <c:v>4.195349999999999</c:v>
                </c:pt>
                <c:pt idx="701">
                  <c:v>4.366569999999998</c:v>
                </c:pt>
                <c:pt idx="702">
                  <c:v>4.17096</c:v>
                </c:pt>
                <c:pt idx="703">
                  <c:v>6.15334</c:v>
                </c:pt>
                <c:pt idx="704">
                  <c:v>3.676629999999998</c:v>
                </c:pt>
                <c:pt idx="705">
                  <c:v>5.33176</c:v>
                </c:pt>
                <c:pt idx="706">
                  <c:v>3.911369999999998</c:v>
                </c:pt>
                <c:pt idx="707">
                  <c:v>4.795539999999994</c:v>
                </c:pt>
                <c:pt idx="708">
                  <c:v>5.5039</c:v>
                </c:pt>
                <c:pt idx="709">
                  <c:v>2.92225</c:v>
                </c:pt>
                <c:pt idx="710">
                  <c:v>4.84111</c:v>
                </c:pt>
                <c:pt idx="711">
                  <c:v>7.50837</c:v>
                </c:pt>
                <c:pt idx="712">
                  <c:v>6.260119999999985</c:v>
                </c:pt>
                <c:pt idx="713">
                  <c:v>6.36368</c:v>
                </c:pt>
                <c:pt idx="714">
                  <c:v>2.98024</c:v>
                </c:pt>
                <c:pt idx="715">
                  <c:v>6.22836</c:v>
                </c:pt>
                <c:pt idx="716">
                  <c:v>3.851989999999998</c:v>
                </c:pt>
                <c:pt idx="717">
                  <c:v>6.365059999999985</c:v>
                </c:pt>
                <c:pt idx="718">
                  <c:v>8.422460000000002</c:v>
                </c:pt>
                <c:pt idx="719">
                  <c:v>6.20074</c:v>
                </c:pt>
                <c:pt idx="720">
                  <c:v>4.49315</c:v>
                </c:pt>
                <c:pt idx="721">
                  <c:v>6.348949999999998</c:v>
                </c:pt>
                <c:pt idx="722">
                  <c:v>4.320549999999995</c:v>
                </c:pt>
                <c:pt idx="723">
                  <c:v>5.642439999999984</c:v>
                </c:pt>
                <c:pt idx="724">
                  <c:v>4.03058</c:v>
                </c:pt>
                <c:pt idx="725">
                  <c:v>5.468</c:v>
                </c:pt>
                <c:pt idx="726">
                  <c:v>5.6765</c:v>
                </c:pt>
                <c:pt idx="727">
                  <c:v>1.1562</c:v>
                </c:pt>
                <c:pt idx="728">
                  <c:v>2.09883</c:v>
                </c:pt>
                <c:pt idx="729">
                  <c:v>4.68646</c:v>
                </c:pt>
                <c:pt idx="730">
                  <c:v>3.56801</c:v>
                </c:pt>
                <c:pt idx="731">
                  <c:v>4.83375</c:v>
                </c:pt>
                <c:pt idx="732">
                  <c:v>3.346159999999998</c:v>
                </c:pt>
                <c:pt idx="733">
                  <c:v>3.04238</c:v>
                </c:pt>
                <c:pt idx="734">
                  <c:v>4.99806</c:v>
                </c:pt>
                <c:pt idx="735">
                  <c:v>4.33389</c:v>
                </c:pt>
                <c:pt idx="736">
                  <c:v>4.49038</c:v>
                </c:pt>
                <c:pt idx="737">
                  <c:v>3.22142</c:v>
                </c:pt>
                <c:pt idx="738">
                  <c:v>2.841699999999999</c:v>
                </c:pt>
                <c:pt idx="739">
                  <c:v>2.34737</c:v>
                </c:pt>
                <c:pt idx="740">
                  <c:v>3.36641</c:v>
                </c:pt>
                <c:pt idx="741">
                  <c:v>3.98225</c:v>
                </c:pt>
                <c:pt idx="742">
                  <c:v>4.38682</c:v>
                </c:pt>
                <c:pt idx="743">
                  <c:v>2.89969</c:v>
                </c:pt>
                <c:pt idx="744">
                  <c:v>2.611569999999999</c:v>
                </c:pt>
                <c:pt idx="745">
                  <c:v>4.01677</c:v>
                </c:pt>
                <c:pt idx="746">
                  <c:v>4.693819999999984</c:v>
                </c:pt>
                <c:pt idx="747">
                  <c:v>5.107609999999998</c:v>
                </c:pt>
                <c:pt idx="748">
                  <c:v>4.104679999999997</c:v>
                </c:pt>
                <c:pt idx="749">
                  <c:v>6.825789999999984</c:v>
                </c:pt>
                <c:pt idx="750">
                  <c:v>5.38929</c:v>
                </c:pt>
                <c:pt idx="751">
                  <c:v>3.84647</c:v>
                </c:pt>
                <c:pt idx="752">
                  <c:v>7.46464</c:v>
                </c:pt>
                <c:pt idx="753">
                  <c:v>3.19012</c:v>
                </c:pt>
                <c:pt idx="754">
                  <c:v>5.4146</c:v>
                </c:pt>
                <c:pt idx="755">
                  <c:v>5.220829999999999</c:v>
                </c:pt>
                <c:pt idx="756">
                  <c:v>3.65039</c:v>
                </c:pt>
                <c:pt idx="757">
                  <c:v>7.190319999999994</c:v>
                </c:pt>
                <c:pt idx="758">
                  <c:v>2.676</c:v>
                </c:pt>
                <c:pt idx="759">
                  <c:v>5.53059</c:v>
                </c:pt>
                <c:pt idx="760">
                  <c:v>3.36134</c:v>
                </c:pt>
                <c:pt idx="761">
                  <c:v>5.143509999999996</c:v>
                </c:pt>
                <c:pt idx="762">
                  <c:v>3.57445</c:v>
                </c:pt>
                <c:pt idx="763">
                  <c:v>4.40293</c:v>
                </c:pt>
                <c:pt idx="764">
                  <c:v>5.08735</c:v>
                </c:pt>
                <c:pt idx="765">
                  <c:v>5.214849999999998</c:v>
                </c:pt>
                <c:pt idx="766">
                  <c:v>3.310249999999952</c:v>
                </c:pt>
                <c:pt idx="767">
                  <c:v>2.60834</c:v>
                </c:pt>
                <c:pt idx="768">
                  <c:v>6.75721</c:v>
                </c:pt>
                <c:pt idx="769">
                  <c:v>4.935</c:v>
                </c:pt>
                <c:pt idx="770">
                  <c:v>5.651179999999996</c:v>
                </c:pt>
                <c:pt idx="771">
                  <c:v>5.79801</c:v>
                </c:pt>
                <c:pt idx="772">
                  <c:v>5.98212</c:v>
                </c:pt>
                <c:pt idx="773">
                  <c:v>6.33238</c:v>
                </c:pt>
                <c:pt idx="774">
                  <c:v>6.25506</c:v>
                </c:pt>
                <c:pt idx="775">
                  <c:v>5.78466</c:v>
                </c:pt>
                <c:pt idx="776">
                  <c:v>3.68814</c:v>
                </c:pt>
                <c:pt idx="777">
                  <c:v>3.018899999999999</c:v>
                </c:pt>
                <c:pt idx="778">
                  <c:v>2.99037</c:v>
                </c:pt>
                <c:pt idx="779">
                  <c:v>4.53089</c:v>
                </c:pt>
                <c:pt idx="780">
                  <c:v>6.50038</c:v>
                </c:pt>
                <c:pt idx="781">
                  <c:v>4.077519999999994</c:v>
                </c:pt>
                <c:pt idx="782">
                  <c:v>2.8035</c:v>
                </c:pt>
                <c:pt idx="783">
                  <c:v>4.640429999999998</c:v>
                </c:pt>
                <c:pt idx="784">
                  <c:v>5.87579</c:v>
                </c:pt>
                <c:pt idx="785">
                  <c:v>5.265479999999997</c:v>
                </c:pt>
                <c:pt idx="786">
                  <c:v>5.25029</c:v>
                </c:pt>
                <c:pt idx="787">
                  <c:v>4.21146</c:v>
                </c:pt>
                <c:pt idx="788">
                  <c:v>5.860139999999975</c:v>
                </c:pt>
                <c:pt idx="789">
                  <c:v>5.71608</c:v>
                </c:pt>
                <c:pt idx="790">
                  <c:v>2.56692</c:v>
                </c:pt>
                <c:pt idx="791">
                  <c:v>7.720089999999994</c:v>
                </c:pt>
                <c:pt idx="792">
                  <c:v>3.65454</c:v>
                </c:pt>
                <c:pt idx="793">
                  <c:v>3.6642</c:v>
                </c:pt>
                <c:pt idx="794">
                  <c:v>4.3095</c:v>
                </c:pt>
                <c:pt idx="795">
                  <c:v>3.036389999999999</c:v>
                </c:pt>
                <c:pt idx="796">
                  <c:v>5.25673</c:v>
                </c:pt>
                <c:pt idx="797">
                  <c:v>5.45235</c:v>
                </c:pt>
                <c:pt idx="798">
                  <c:v>2.394779999999999</c:v>
                </c:pt>
                <c:pt idx="799">
                  <c:v>4.05635</c:v>
                </c:pt>
                <c:pt idx="800">
                  <c:v>5.3718</c:v>
                </c:pt>
                <c:pt idx="801">
                  <c:v>2.651149999999998</c:v>
                </c:pt>
                <c:pt idx="802">
                  <c:v>2.91765</c:v>
                </c:pt>
                <c:pt idx="803">
                  <c:v>6.174969999999997</c:v>
                </c:pt>
                <c:pt idx="804">
                  <c:v>3.56432</c:v>
                </c:pt>
                <c:pt idx="805">
                  <c:v>3.52198</c:v>
                </c:pt>
                <c:pt idx="806">
                  <c:v>5.48318</c:v>
                </c:pt>
                <c:pt idx="807">
                  <c:v>3.93346</c:v>
                </c:pt>
                <c:pt idx="808">
                  <c:v>6.77516</c:v>
                </c:pt>
                <c:pt idx="809">
                  <c:v>4.124009999999974</c:v>
                </c:pt>
                <c:pt idx="810">
                  <c:v>4.34586</c:v>
                </c:pt>
                <c:pt idx="811">
                  <c:v>6.52155</c:v>
                </c:pt>
                <c:pt idx="812">
                  <c:v>4.21238</c:v>
                </c:pt>
                <c:pt idx="813">
                  <c:v>3.389419999999998</c:v>
                </c:pt>
                <c:pt idx="814">
                  <c:v>3.06309</c:v>
                </c:pt>
                <c:pt idx="815">
                  <c:v>2.43989</c:v>
                </c:pt>
                <c:pt idx="816">
                  <c:v>4.31824</c:v>
                </c:pt>
                <c:pt idx="817">
                  <c:v>3.85429</c:v>
                </c:pt>
                <c:pt idx="818">
                  <c:v>1.92623</c:v>
                </c:pt>
                <c:pt idx="819">
                  <c:v>1.89631</c:v>
                </c:pt>
                <c:pt idx="820">
                  <c:v>4.184769999999999</c:v>
                </c:pt>
                <c:pt idx="821">
                  <c:v>2.22724</c:v>
                </c:pt>
                <c:pt idx="822">
                  <c:v>3.536709999999998</c:v>
                </c:pt>
                <c:pt idx="823">
                  <c:v>4.715919999999984</c:v>
                </c:pt>
                <c:pt idx="824">
                  <c:v>2.92777</c:v>
                </c:pt>
                <c:pt idx="825">
                  <c:v>2.4652</c:v>
                </c:pt>
                <c:pt idx="826">
                  <c:v>3.61219</c:v>
                </c:pt>
                <c:pt idx="827">
                  <c:v>2.36578</c:v>
                </c:pt>
                <c:pt idx="828">
                  <c:v>4.79324</c:v>
                </c:pt>
                <c:pt idx="829">
                  <c:v>5.87625</c:v>
                </c:pt>
                <c:pt idx="830">
                  <c:v>3.16757</c:v>
                </c:pt>
                <c:pt idx="831">
                  <c:v>2.418709999999999</c:v>
                </c:pt>
                <c:pt idx="832">
                  <c:v>3.55972</c:v>
                </c:pt>
                <c:pt idx="833">
                  <c:v>4.724199999999985</c:v>
                </c:pt>
                <c:pt idx="834">
                  <c:v>2.96551</c:v>
                </c:pt>
                <c:pt idx="835">
                  <c:v>2.90384</c:v>
                </c:pt>
                <c:pt idx="836">
                  <c:v>4.04116</c:v>
                </c:pt>
                <c:pt idx="837">
                  <c:v>2.46566</c:v>
                </c:pt>
                <c:pt idx="838">
                  <c:v>1.9566</c:v>
                </c:pt>
                <c:pt idx="839">
                  <c:v>3.16527</c:v>
                </c:pt>
                <c:pt idx="840">
                  <c:v>6.2012</c:v>
                </c:pt>
                <c:pt idx="841">
                  <c:v>6.114669999999998</c:v>
                </c:pt>
                <c:pt idx="842">
                  <c:v>3.90032</c:v>
                </c:pt>
                <c:pt idx="843">
                  <c:v>3.71437</c:v>
                </c:pt>
                <c:pt idx="844">
                  <c:v>3.87731</c:v>
                </c:pt>
                <c:pt idx="845">
                  <c:v>1.75501</c:v>
                </c:pt>
                <c:pt idx="846">
                  <c:v>2.28293</c:v>
                </c:pt>
                <c:pt idx="847">
                  <c:v>3.75718</c:v>
                </c:pt>
                <c:pt idx="848">
                  <c:v>2.17247</c:v>
                </c:pt>
                <c:pt idx="849">
                  <c:v>3.151</c:v>
                </c:pt>
                <c:pt idx="850">
                  <c:v>2.50432</c:v>
                </c:pt>
                <c:pt idx="851">
                  <c:v>1.9879</c:v>
                </c:pt>
                <c:pt idx="852">
                  <c:v>1.30026</c:v>
                </c:pt>
                <c:pt idx="853">
                  <c:v>1.63303</c:v>
                </c:pt>
                <c:pt idx="854">
                  <c:v>1.17507</c:v>
                </c:pt>
                <c:pt idx="855">
                  <c:v>1.62419</c:v>
                </c:pt>
                <c:pt idx="856">
                  <c:v>2.8035</c:v>
                </c:pt>
                <c:pt idx="857">
                  <c:v>3.12707</c:v>
                </c:pt>
                <c:pt idx="858">
                  <c:v>4.018149999999999</c:v>
                </c:pt>
                <c:pt idx="859">
                  <c:v>6.77654</c:v>
                </c:pt>
                <c:pt idx="860">
                  <c:v>3.48654</c:v>
                </c:pt>
                <c:pt idx="861">
                  <c:v>5.965549999999999</c:v>
                </c:pt>
                <c:pt idx="862">
                  <c:v>1.84752</c:v>
                </c:pt>
                <c:pt idx="863">
                  <c:v>3.51784</c:v>
                </c:pt>
                <c:pt idx="864">
                  <c:v>3.913209999999998</c:v>
                </c:pt>
                <c:pt idx="865">
                  <c:v>2.60834</c:v>
                </c:pt>
                <c:pt idx="866">
                  <c:v>3.12937</c:v>
                </c:pt>
                <c:pt idx="867">
                  <c:v>6.58323</c:v>
                </c:pt>
                <c:pt idx="868">
                  <c:v>2.77634</c:v>
                </c:pt>
                <c:pt idx="869">
                  <c:v>2.02012</c:v>
                </c:pt>
                <c:pt idx="870">
                  <c:v>3.05158</c:v>
                </c:pt>
                <c:pt idx="871">
                  <c:v>4.687839999999975</c:v>
                </c:pt>
                <c:pt idx="872">
                  <c:v>3.31808</c:v>
                </c:pt>
                <c:pt idx="873">
                  <c:v>3.969819999999999</c:v>
                </c:pt>
                <c:pt idx="874">
                  <c:v>1.36976</c:v>
                </c:pt>
                <c:pt idx="875">
                  <c:v>3.38436</c:v>
                </c:pt>
                <c:pt idx="876">
                  <c:v>5.294929999999995</c:v>
                </c:pt>
                <c:pt idx="877">
                  <c:v>3.299669999999999</c:v>
                </c:pt>
                <c:pt idx="878">
                  <c:v>3.51599</c:v>
                </c:pt>
                <c:pt idx="879">
                  <c:v>4.00066</c:v>
                </c:pt>
                <c:pt idx="880">
                  <c:v>4.8319</c:v>
                </c:pt>
                <c:pt idx="881">
                  <c:v>2.10343</c:v>
                </c:pt>
                <c:pt idx="882">
                  <c:v>3.83542</c:v>
                </c:pt>
                <c:pt idx="883">
                  <c:v>4.767929999999985</c:v>
                </c:pt>
                <c:pt idx="884">
                  <c:v>3.91413</c:v>
                </c:pt>
                <c:pt idx="885">
                  <c:v>7.41862</c:v>
                </c:pt>
                <c:pt idx="886">
                  <c:v>4.1438</c:v>
                </c:pt>
                <c:pt idx="887">
                  <c:v>3.52796</c:v>
                </c:pt>
                <c:pt idx="888">
                  <c:v>1.80748</c:v>
                </c:pt>
                <c:pt idx="889">
                  <c:v>1.69287</c:v>
                </c:pt>
                <c:pt idx="890">
                  <c:v>4.87287</c:v>
                </c:pt>
                <c:pt idx="891">
                  <c:v>2.958149999999998</c:v>
                </c:pt>
                <c:pt idx="892">
                  <c:v>3.805959999999998</c:v>
                </c:pt>
                <c:pt idx="893">
                  <c:v>3.78709</c:v>
                </c:pt>
                <c:pt idx="894">
                  <c:v>2.23599</c:v>
                </c:pt>
                <c:pt idx="895">
                  <c:v>2.75563</c:v>
                </c:pt>
                <c:pt idx="896">
                  <c:v>3.479169999999999</c:v>
                </c:pt>
                <c:pt idx="897">
                  <c:v>3.1487</c:v>
                </c:pt>
                <c:pt idx="898">
                  <c:v>2.173849999999998</c:v>
                </c:pt>
                <c:pt idx="899">
                  <c:v>2.91074</c:v>
                </c:pt>
                <c:pt idx="900">
                  <c:v>3.34201</c:v>
                </c:pt>
                <c:pt idx="901">
                  <c:v>2.78831</c:v>
                </c:pt>
                <c:pt idx="902">
                  <c:v>1.91564</c:v>
                </c:pt>
                <c:pt idx="903">
                  <c:v>1.25193</c:v>
                </c:pt>
                <c:pt idx="904">
                  <c:v>3.442349999999998</c:v>
                </c:pt>
                <c:pt idx="905">
                  <c:v>2.79613</c:v>
                </c:pt>
                <c:pt idx="906">
                  <c:v>2.30825</c:v>
                </c:pt>
                <c:pt idx="907">
                  <c:v>1.74396</c:v>
                </c:pt>
                <c:pt idx="908">
                  <c:v>1.53454</c:v>
                </c:pt>
                <c:pt idx="909">
                  <c:v>1.70254</c:v>
                </c:pt>
                <c:pt idx="910">
                  <c:v>2.2636</c:v>
                </c:pt>
                <c:pt idx="911">
                  <c:v>2.808559999999999</c:v>
                </c:pt>
                <c:pt idx="912">
                  <c:v>1.66709</c:v>
                </c:pt>
                <c:pt idx="913">
                  <c:v>1.57412</c:v>
                </c:pt>
                <c:pt idx="914">
                  <c:v>1.64086</c:v>
                </c:pt>
                <c:pt idx="915">
                  <c:v>2.288</c:v>
                </c:pt>
                <c:pt idx="916">
                  <c:v>2.0192</c:v>
                </c:pt>
                <c:pt idx="917">
                  <c:v>3.51323</c:v>
                </c:pt>
                <c:pt idx="918">
                  <c:v>3.316699999999976</c:v>
                </c:pt>
                <c:pt idx="919">
                  <c:v>2.09883</c:v>
                </c:pt>
                <c:pt idx="920">
                  <c:v>2.94388</c:v>
                </c:pt>
                <c:pt idx="921">
                  <c:v>5.627249999999996</c:v>
                </c:pt>
                <c:pt idx="922">
                  <c:v>2.45922</c:v>
                </c:pt>
                <c:pt idx="923">
                  <c:v>2.20377</c:v>
                </c:pt>
                <c:pt idx="924">
                  <c:v>1.81162</c:v>
                </c:pt>
                <c:pt idx="925">
                  <c:v>2.20331</c:v>
                </c:pt>
                <c:pt idx="926">
                  <c:v>2.41779</c:v>
                </c:pt>
                <c:pt idx="927">
                  <c:v>1.60036</c:v>
                </c:pt>
                <c:pt idx="928">
                  <c:v>2.51813</c:v>
                </c:pt>
                <c:pt idx="929">
                  <c:v>1.93681</c:v>
                </c:pt>
                <c:pt idx="930">
                  <c:v>3.05066</c:v>
                </c:pt>
                <c:pt idx="931">
                  <c:v>1.45491</c:v>
                </c:pt>
                <c:pt idx="932">
                  <c:v>1.44663</c:v>
                </c:pt>
                <c:pt idx="933">
                  <c:v>2.5057</c:v>
                </c:pt>
                <c:pt idx="934">
                  <c:v>3.5878</c:v>
                </c:pt>
                <c:pt idx="935">
                  <c:v>2.65391</c:v>
                </c:pt>
                <c:pt idx="936">
                  <c:v>3.416119999999998</c:v>
                </c:pt>
                <c:pt idx="937">
                  <c:v>1.80241</c:v>
                </c:pt>
                <c:pt idx="938">
                  <c:v>2.97242</c:v>
                </c:pt>
                <c:pt idx="939">
                  <c:v>3.24075</c:v>
                </c:pt>
                <c:pt idx="940">
                  <c:v>2.557249999999998</c:v>
                </c:pt>
                <c:pt idx="941">
                  <c:v>1.74212</c:v>
                </c:pt>
                <c:pt idx="942">
                  <c:v>2.9379</c:v>
                </c:pt>
                <c:pt idx="943">
                  <c:v>2.309169999999999</c:v>
                </c:pt>
                <c:pt idx="944">
                  <c:v>2.884049999999997</c:v>
                </c:pt>
                <c:pt idx="945">
                  <c:v>3.395399999999999</c:v>
                </c:pt>
                <c:pt idx="946">
                  <c:v>4.03426</c:v>
                </c:pt>
                <c:pt idx="947">
                  <c:v>4.79969</c:v>
                </c:pt>
                <c:pt idx="948">
                  <c:v>5.59227</c:v>
                </c:pt>
                <c:pt idx="949">
                  <c:v>4.78726</c:v>
                </c:pt>
                <c:pt idx="950">
                  <c:v>3.314859999999952</c:v>
                </c:pt>
                <c:pt idx="951">
                  <c:v>3.12293</c:v>
                </c:pt>
                <c:pt idx="952">
                  <c:v>3.441889999999999</c:v>
                </c:pt>
                <c:pt idx="953">
                  <c:v>3.65776</c:v>
                </c:pt>
                <c:pt idx="954">
                  <c:v>4.853079999999998</c:v>
                </c:pt>
                <c:pt idx="955">
                  <c:v>3.07138</c:v>
                </c:pt>
                <c:pt idx="956">
                  <c:v>3.00326</c:v>
                </c:pt>
                <c:pt idx="957">
                  <c:v>2.179829999999999</c:v>
                </c:pt>
                <c:pt idx="958">
                  <c:v>6.13677</c:v>
                </c:pt>
                <c:pt idx="959">
                  <c:v>3.14088</c:v>
                </c:pt>
                <c:pt idx="960">
                  <c:v>2.67877</c:v>
                </c:pt>
                <c:pt idx="961">
                  <c:v>4.73203</c:v>
                </c:pt>
                <c:pt idx="962">
                  <c:v>3.858439999999998</c:v>
                </c:pt>
                <c:pt idx="963">
                  <c:v>3.303809999999999</c:v>
                </c:pt>
                <c:pt idx="964">
                  <c:v>3.490219999999998</c:v>
                </c:pt>
                <c:pt idx="965">
                  <c:v>2.07857</c:v>
                </c:pt>
                <c:pt idx="966">
                  <c:v>4.135519999999985</c:v>
                </c:pt>
                <c:pt idx="967">
                  <c:v>4.99668</c:v>
                </c:pt>
                <c:pt idx="968">
                  <c:v>5.05606</c:v>
                </c:pt>
                <c:pt idx="969">
                  <c:v>4.122169999999985</c:v>
                </c:pt>
                <c:pt idx="970">
                  <c:v>5.49009</c:v>
                </c:pt>
                <c:pt idx="971">
                  <c:v>5.112209999999997</c:v>
                </c:pt>
                <c:pt idx="972">
                  <c:v>3.946349999999998</c:v>
                </c:pt>
                <c:pt idx="973">
                  <c:v>3.06769</c:v>
                </c:pt>
                <c:pt idx="974">
                  <c:v>3.272969999999999</c:v>
                </c:pt>
                <c:pt idx="975">
                  <c:v>2.71559</c:v>
                </c:pt>
                <c:pt idx="976">
                  <c:v>1.90505</c:v>
                </c:pt>
                <c:pt idx="977">
                  <c:v>2.5011</c:v>
                </c:pt>
                <c:pt idx="978">
                  <c:v>4.07522</c:v>
                </c:pt>
                <c:pt idx="979">
                  <c:v>6.162999999999966</c:v>
                </c:pt>
                <c:pt idx="980">
                  <c:v>3.335109999999998</c:v>
                </c:pt>
                <c:pt idx="981">
                  <c:v>2.96091</c:v>
                </c:pt>
                <c:pt idx="982">
                  <c:v>2.96459</c:v>
                </c:pt>
                <c:pt idx="983">
                  <c:v>3.42762</c:v>
                </c:pt>
                <c:pt idx="984">
                  <c:v>4.690139999999975</c:v>
                </c:pt>
                <c:pt idx="985">
                  <c:v>5.20058</c:v>
                </c:pt>
                <c:pt idx="986">
                  <c:v>6.88424</c:v>
                </c:pt>
                <c:pt idx="987">
                  <c:v>4.49683</c:v>
                </c:pt>
                <c:pt idx="988">
                  <c:v>2.94204</c:v>
                </c:pt>
                <c:pt idx="989">
                  <c:v>4.68968</c:v>
                </c:pt>
                <c:pt idx="990">
                  <c:v>6.42075</c:v>
                </c:pt>
                <c:pt idx="991">
                  <c:v>5.654399999999986</c:v>
                </c:pt>
                <c:pt idx="992">
                  <c:v>9.045210000000001</c:v>
                </c:pt>
                <c:pt idx="993">
                  <c:v>7.78177</c:v>
                </c:pt>
                <c:pt idx="994">
                  <c:v>4.06141</c:v>
                </c:pt>
                <c:pt idx="995">
                  <c:v>4.193969999999998</c:v>
                </c:pt>
                <c:pt idx="996">
                  <c:v>6.81935</c:v>
                </c:pt>
                <c:pt idx="997">
                  <c:v>5.848179999999997</c:v>
                </c:pt>
                <c:pt idx="998">
                  <c:v>5.746</c:v>
                </c:pt>
                <c:pt idx="999">
                  <c:v>3.79584</c:v>
                </c:pt>
                <c:pt idx="1000">
                  <c:v>7.11944</c:v>
                </c:pt>
                <c:pt idx="1001">
                  <c:v>6.41845</c:v>
                </c:pt>
                <c:pt idx="1002">
                  <c:v>4.49821</c:v>
                </c:pt>
                <c:pt idx="1003">
                  <c:v>4.725119999999975</c:v>
                </c:pt>
                <c:pt idx="1004">
                  <c:v>8.666870000000001</c:v>
                </c:pt>
                <c:pt idx="1005">
                  <c:v>4.00342</c:v>
                </c:pt>
                <c:pt idx="1006">
                  <c:v>5.37962</c:v>
                </c:pt>
                <c:pt idx="1007">
                  <c:v>7.79327</c:v>
                </c:pt>
                <c:pt idx="1008">
                  <c:v>4.13828</c:v>
                </c:pt>
                <c:pt idx="1009">
                  <c:v>9.138640000000001</c:v>
                </c:pt>
                <c:pt idx="1010">
                  <c:v>7.79604</c:v>
                </c:pt>
                <c:pt idx="1011">
                  <c:v>6.950979999999999</c:v>
                </c:pt>
                <c:pt idx="1012">
                  <c:v>3.94543</c:v>
                </c:pt>
                <c:pt idx="1013">
                  <c:v>5.20104</c:v>
                </c:pt>
                <c:pt idx="1014">
                  <c:v>3.60391</c:v>
                </c:pt>
                <c:pt idx="1015">
                  <c:v>5.91906</c:v>
                </c:pt>
                <c:pt idx="1016">
                  <c:v>2.97196</c:v>
                </c:pt>
                <c:pt idx="1017">
                  <c:v>5.14673</c:v>
                </c:pt>
                <c:pt idx="1018">
                  <c:v>5.387909999999985</c:v>
                </c:pt>
                <c:pt idx="1019">
                  <c:v>8.12927</c:v>
                </c:pt>
                <c:pt idx="1020">
                  <c:v>4.05911</c:v>
                </c:pt>
                <c:pt idx="1021">
                  <c:v>4.90831</c:v>
                </c:pt>
                <c:pt idx="1022">
                  <c:v>5.98028</c:v>
                </c:pt>
                <c:pt idx="1023">
                  <c:v>3.94451</c:v>
                </c:pt>
                <c:pt idx="1024">
                  <c:v>4.634909999999976</c:v>
                </c:pt>
                <c:pt idx="1025">
                  <c:v>4.95802</c:v>
                </c:pt>
                <c:pt idx="1026">
                  <c:v>4.37302</c:v>
                </c:pt>
                <c:pt idx="1027">
                  <c:v>4.36105</c:v>
                </c:pt>
                <c:pt idx="1028">
                  <c:v>6.656409999999997</c:v>
                </c:pt>
                <c:pt idx="1029">
                  <c:v>5.450509999999999</c:v>
                </c:pt>
                <c:pt idx="1030">
                  <c:v>4.48946</c:v>
                </c:pt>
                <c:pt idx="1031">
                  <c:v>6.09948</c:v>
                </c:pt>
                <c:pt idx="1032">
                  <c:v>5.7888</c:v>
                </c:pt>
                <c:pt idx="1033">
                  <c:v>6.017099999999997</c:v>
                </c:pt>
                <c:pt idx="1034">
                  <c:v>7.159019999999995</c:v>
                </c:pt>
                <c:pt idx="1035">
                  <c:v>5.67696</c:v>
                </c:pt>
                <c:pt idx="1036">
                  <c:v>4.284179999999997</c:v>
                </c:pt>
                <c:pt idx="1037">
                  <c:v>4.30305</c:v>
                </c:pt>
                <c:pt idx="1038">
                  <c:v>6.06128</c:v>
                </c:pt>
                <c:pt idx="1039">
                  <c:v>6.342969999999998</c:v>
                </c:pt>
                <c:pt idx="1040">
                  <c:v>8.83624</c:v>
                </c:pt>
                <c:pt idx="1041">
                  <c:v>8.27195</c:v>
                </c:pt>
                <c:pt idx="1042">
                  <c:v>10.2543</c:v>
                </c:pt>
                <c:pt idx="1043">
                  <c:v>3.9758</c:v>
                </c:pt>
                <c:pt idx="1044">
                  <c:v>4.33021</c:v>
                </c:pt>
                <c:pt idx="1045">
                  <c:v>4.24828</c:v>
                </c:pt>
                <c:pt idx="1046">
                  <c:v>9.723640000000001</c:v>
                </c:pt>
                <c:pt idx="1047">
                  <c:v>7.50469</c:v>
                </c:pt>
                <c:pt idx="1048">
                  <c:v>4.98241</c:v>
                </c:pt>
                <c:pt idx="1049">
                  <c:v>5.95588</c:v>
                </c:pt>
                <c:pt idx="1050">
                  <c:v>4.94927</c:v>
                </c:pt>
                <c:pt idx="1051">
                  <c:v>6.79863</c:v>
                </c:pt>
                <c:pt idx="1052">
                  <c:v>6.659169999999999</c:v>
                </c:pt>
                <c:pt idx="1053">
                  <c:v>5.02936</c:v>
                </c:pt>
                <c:pt idx="1054">
                  <c:v>7.98981</c:v>
                </c:pt>
                <c:pt idx="1055">
                  <c:v>4.04576</c:v>
                </c:pt>
                <c:pt idx="1056">
                  <c:v>4.04853</c:v>
                </c:pt>
                <c:pt idx="1057">
                  <c:v>8.375050000000006</c:v>
                </c:pt>
                <c:pt idx="1058">
                  <c:v>7.818589999999975</c:v>
                </c:pt>
                <c:pt idx="1059">
                  <c:v>8.39991</c:v>
                </c:pt>
                <c:pt idx="1060">
                  <c:v>4.850779999999998</c:v>
                </c:pt>
                <c:pt idx="1061">
                  <c:v>4.96538</c:v>
                </c:pt>
                <c:pt idx="1062">
                  <c:v>7.75921</c:v>
                </c:pt>
                <c:pt idx="1063">
                  <c:v>7.49318</c:v>
                </c:pt>
                <c:pt idx="1064">
                  <c:v>4.45034</c:v>
                </c:pt>
                <c:pt idx="1065">
                  <c:v>3.94727</c:v>
                </c:pt>
                <c:pt idx="1066">
                  <c:v>4.64826</c:v>
                </c:pt>
                <c:pt idx="1067">
                  <c:v>4.392349999999999</c:v>
                </c:pt>
                <c:pt idx="1068">
                  <c:v>7.321499999999999</c:v>
                </c:pt>
                <c:pt idx="1069">
                  <c:v>6.8778</c:v>
                </c:pt>
                <c:pt idx="1070">
                  <c:v>7.09182</c:v>
                </c:pt>
                <c:pt idx="1071">
                  <c:v>5.97567</c:v>
                </c:pt>
                <c:pt idx="1072">
                  <c:v>5.78696</c:v>
                </c:pt>
                <c:pt idx="1073">
                  <c:v>6.754909999999985</c:v>
                </c:pt>
                <c:pt idx="1074">
                  <c:v>7.74541</c:v>
                </c:pt>
                <c:pt idx="1075">
                  <c:v>3.91689</c:v>
                </c:pt>
                <c:pt idx="1076">
                  <c:v>4.638589999999985</c:v>
                </c:pt>
                <c:pt idx="1077">
                  <c:v>3.3144</c:v>
                </c:pt>
                <c:pt idx="1078">
                  <c:v>5.40126</c:v>
                </c:pt>
                <c:pt idx="1079">
                  <c:v>4.57323</c:v>
                </c:pt>
                <c:pt idx="1080">
                  <c:v>5.815499999999997</c:v>
                </c:pt>
                <c:pt idx="1081">
                  <c:v>4.28004</c:v>
                </c:pt>
                <c:pt idx="1082">
                  <c:v>5.11865</c:v>
                </c:pt>
                <c:pt idx="1083">
                  <c:v>6.614989999999927</c:v>
                </c:pt>
                <c:pt idx="1084">
                  <c:v>6.643979999999995</c:v>
                </c:pt>
                <c:pt idx="1085">
                  <c:v>5.53704</c:v>
                </c:pt>
                <c:pt idx="1086">
                  <c:v>5.64106</c:v>
                </c:pt>
                <c:pt idx="1087">
                  <c:v>5.48687</c:v>
                </c:pt>
                <c:pt idx="1088">
                  <c:v>4.72926</c:v>
                </c:pt>
                <c:pt idx="1089">
                  <c:v>3.41888</c:v>
                </c:pt>
                <c:pt idx="1090">
                  <c:v>4.92764</c:v>
                </c:pt>
                <c:pt idx="1091">
                  <c:v>3.457079999999999</c:v>
                </c:pt>
                <c:pt idx="1092">
                  <c:v>5.555909999999995</c:v>
                </c:pt>
                <c:pt idx="1093">
                  <c:v>2.71743</c:v>
                </c:pt>
                <c:pt idx="1094">
                  <c:v>2.450009999999998</c:v>
                </c:pt>
                <c:pt idx="1095">
                  <c:v>4.624319999999937</c:v>
                </c:pt>
                <c:pt idx="1096">
                  <c:v>5.022919999999965</c:v>
                </c:pt>
                <c:pt idx="1097">
                  <c:v>5.31104</c:v>
                </c:pt>
                <c:pt idx="1098">
                  <c:v>4.0361</c:v>
                </c:pt>
                <c:pt idx="1099">
                  <c:v>2.94848</c:v>
                </c:pt>
                <c:pt idx="1100">
                  <c:v>7.2925</c:v>
                </c:pt>
                <c:pt idx="1101">
                  <c:v>3.457079999999999</c:v>
                </c:pt>
                <c:pt idx="1102">
                  <c:v>6.428579999999997</c:v>
                </c:pt>
                <c:pt idx="1103">
                  <c:v>2.6378</c:v>
                </c:pt>
                <c:pt idx="1104">
                  <c:v>6.34021</c:v>
                </c:pt>
                <c:pt idx="1105">
                  <c:v>7.754609999999999</c:v>
                </c:pt>
                <c:pt idx="1106">
                  <c:v>2.72755</c:v>
                </c:pt>
                <c:pt idx="1107">
                  <c:v>3.402309999999999</c:v>
                </c:pt>
                <c:pt idx="1108">
                  <c:v>2.94894</c:v>
                </c:pt>
                <c:pt idx="1109">
                  <c:v>4.86965</c:v>
                </c:pt>
                <c:pt idx="1110">
                  <c:v>3.07874</c:v>
                </c:pt>
                <c:pt idx="1111">
                  <c:v>1.8199</c:v>
                </c:pt>
                <c:pt idx="1112">
                  <c:v>5.264559999999975</c:v>
                </c:pt>
                <c:pt idx="1113">
                  <c:v>3.92655</c:v>
                </c:pt>
                <c:pt idx="1114">
                  <c:v>3.83312</c:v>
                </c:pt>
                <c:pt idx="1115">
                  <c:v>4.53963</c:v>
                </c:pt>
                <c:pt idx="1116">
                  <c:v>2.734</c:v>
                </c:pt>
                <c:pt idx="1117">
                  <c:v>2.56646</c:v>
                </c:pt>
                <c:pt idx="1118">
                  <c:v>2.754249999999998</c:v>
                </c:pt>
                <c:pt idx="1119">
                  <c:v>2.426079999999998</c:v>
                </c:pt>
                <c:pt idx="1120">
                  <c:v>2.841239999999999</c:v>
                </c:pt>
                <c:pt idx="1121">
                  <c:v>3.85061</c:v>
                </c:pt>
                <c:pt idx="1122">
                  <c:v>1.84246</c:v>
                </c:pt>
                <c:pt idx="1123">
                  <c:v>3.84831</c:v>
                </c:pt>
                <c:pt idx="1124">
                  <c:v>3.7719</c:v>
                </c:pt>
                <c:pt idx="1125">
                  <c:v>2.859189999999999</c:v>
                </c:pt>
                <c:pt idx="1126">
                  <c:v>2.22126</c:v>
                </c:pt>
                <c:pt idx="1127">
                  <c:v>2.009069999999999</c:v>
                </c:pt>
                <c:pt idx="1128">
                  <c:v>5.2038</c:v>
                </c:pt>
                <c:pt idx="1129">
                  <c:v>2.27603</c:v>
                </c:pt>
                <c:pt idx="1130">
                  <c:v>6.44515</c:v>
                </c:pt>
                <c:pt idx="1131">
                  <c:v>5.78052</c:v>
                </c:pt>
                <c:pt idx="1132">
                  <c:v>3.11234</c:v>
                </c:pt>
                <c:pt idx="1133">
                  <c:v>2.714669999999999</c:v>
                </c:pt>
                <c:pt idx="1134">
                  <c:v>5.5352</c:v>
                </c:pt>
                <c:pt idx="1135">
                  <c:v>1.32511</c:v>
                </c:pt>
                <c:pt idx="1136">
                  <c:v>1.52625</c:v>
                </c:pt>
                <c:pt idx="1137">
                  <c:v>2.70684</c:v>
                </c:pt>
                <c:pt idx="1138">
                  <c:v>2.27097</c:v>
                </c:pt>
                <c:pt idx="1139">
                  <c:v>1.85673</c:v>
                </c:pt>
                <c:pt idx="1140">
                  <c:v>4.09363</c:v>
                </c:pt>
                <c:pt idx="1141">
                  <c:v>2.16741</c:v>
                </c:pt>
                <c:pt idx="1142">
                  <c:v>2.1872</c:v>
                </c:pt>
                <c:pt idx="1143">
                  <c:v>3.435909999999998</c:v>
                </c:pt>
                <c:pt idx="1144">
                  <c:v>1.86823</c:v>
                </c:pt>
                <c:pt idx="1145">
                  <c:v>1.48207</c:v>
                </c:pt>
                <c:pt idx="1146">
                  <c:v>2.60328</c:v>
                </c:pt>
                <c:pt idx="1147">
                  <c:v>1.35411</c:v>
                </c:pt>
                <c:pt idx="1148">
                  <c:v>2.300419999999999</c:v>
                </c:pt>
                <c:pt idx="1149">
                  <c:v>1.41072</c:v>
                </c:pt>
                <c:pt idx="1150">
                  <c:v>1.55295</c:v>
                </c:pt>
                <c:pt idx="1151">
                  <c:v>3.84002</c:v>
                </c:pt>
                <c:pt idx="1152">
                  <c:v>4.620179999999975</c:v>
                </c:pt>
                <c:pt idx="1153">
                  <c:v>2.49052</c:v>
                </c:pt>
                <c:pt idx="1154">
                  <c:v>1.74258</c:v>
                </c:pt>
                <c:pt idx="1155">
                  <c:v>2.1918</c:v>
                </c:pt>
                <c:pt idx="1156">
                  <c:v>2.46474</c:v>
                </c:pt>
                <c:pt idx="1157">
                  <c:v>2.80718</c:v>
                </c:pt>
                <c:pt idx="1158">
                  <c:v>2.975179999999999</c:v>
                </c:pt>
                <c:pt idx="1159">
                  <c:v>2.95953</c:v>
                </c:pt>
                <c:pt idx="1160">
                  <c:v>1.7191</c:v>
                </c:pt>
                <c:pt idx="1161">
                  <c:v>1.53039</c:v>
                </c:pt>
                <c:pt idx="1162">
                  <c:v>4.274519999999995</c:v>
                </c:pt>
                <c:pt idx="1163">
                  <c:v>2.47072</c:v>
                </c:pt>
                <c:pt idx="1164">
                  <c:v>4.75044</c:v>
                </c:pt>
                <c:pt idx="1165">
                  <c:v>3.5206</c:v>
                </c:pt>
                <c:pt idx="1166">
                  <c:v>4.07016</c:v>
                </c:pt>
                <c:pt idx="1167">
                  <c:v>1.81714</c:v>
                </c:pt>
                <c:pt idx="1168">
                  <c:v>1.35687</c:v>
                </c:pt>
                <c:pt idx="1169">
                  <c:v>1.97824</c:v>
                </c:pt>
                <c:pt idx="1170">
                  <c:v>2.42009</c:v>
                </c:pt>
                <c:pt idx="1171">
                  <c:v>2.00401</c:v>
                </c:pt>
                <c:pt idx="1172">
                  <c:v>2.29122</c:v>
                </c:pt>
                <c:pt idx="1173">
                  <c:v>1.53684</c:v>
                </c:pt>
                <c:pt idx="1174">
                  <c:v>1.60036</c:v>
                </c:pt>
                <c:pt idx="1175">
                  <c:v>2.348749999999999</c:v>
                </c:pt>
                <c:pt idx="1176">
                  <c:v>2.56508</c:v>
                </c:pt>
                <c:pt idx="1177">
                  <c:v>1.09406</c:v>
                </c:pt>
                <c:pt idx="1178">
                  <c:v>2.48637</c:v>
                </c:pt>
                <c:pt idx="1179">
                  <c:v>1.82911</c:v>
                </c:pt>
                <c:pt idx="1180">
                  <c:v>1.08577</c:v>
                </c:pt>
                <c:pt idx="1181">
                  <c:v>3.58504</c:v>
                </c:pt>
                <c:pt idx="1182">
                  <c:v>1.18151</c:v>
                </c:pt>
                <c:pt idx="1183">
                  <c:v>1.7863</c:v>
                </c:pt>
                <c:pt idx="1184">
                  <c:v>1.9092</c:v>
                </c:pt>
                <c:pt idx="1185">
                  <c:v>2.9494</c:v>
                </c:pt>
                <c:pt idx="1186">
                  <c:v>1.21971</c:v>
                </c:pt>
                <c:pt idx="1187">
                  <c:v>1.12812</c:v>
                </c:pt>
                <c:pt idx="1188">
                  <c:v>2.38419</c:v>
                </c:pt>
                <c:pt idx="1189">
                  <c:v>1.35779</c:v>
                </c:pt>
                <c:pt idx="1190">
                  <c:v>1.48621</c:v>
                </c:pt>
                <c:pt idx="1191">
                  <c:v>2.375449999999952</c:v>
                </c:pt>
                <c:pt idx="1192">
                  <c:v>1.52763</c:v>
                </c:pt>
                <c:pt idx="1193">
                  <c:v>2.12184</c:v>
                </c:pt>
                <c:pt idx="1194">
                  <c:v>2.21343</c:v>
                </c:pt>
                <c:pt idx="1195">
                  <c:v>1.59437</c:v>
                </c:pt>
                <c:pt idx="1196">
                  <c:v>3.88053</c:v>
                </c:pt>
                <c:pt idx="1197">
                  <c:v>1.30947</c:v>
                </c:pt>
                <c:pt idx="1198">
                  <c:v>3.27021</c:v>
                </c:pt>
                <c:pt idx="1199">
                  <c:v>1.32696</c:v>
                </c:pt>
                <c:pt idx="1200">
                  <c:v>3.53947</c:v>
                </c:pt>
                <c:pt idx="1201">
                  <c:v>2.502479999999998</c:v>
                </c:pt>
                <c:pt idx="1202">
                  <c:v>1.64776</c:v>
                </c:pt>
                <c:pt idx="1203">
                  <c:v>3.52888</c:v>
                </c:pt>
                <c:pt idx="1204">
                  <c:v>3.25318</c:v>
                </c:pt>
                <c:pt idx="1205">
                  <c:v>1.77388</c:v>
                </c:pt>
                <c:pt idx="1206">
                  <c:v>2.11171</c:v>
                </c:pt>
                <c:pt idx="1207">
                  <c:v>1.61094</c:v>
                </c:pt>
                <c:pt idx="1208">
                  <c:v>1.6022</c:v>
                </c:pt>
                <c:pt idx="1209">
                  <c:v>2.80764</c:v>
                </c:pt>
                <c:pt idx="1210">
                  <c:v>2.19824</c:v>
                </c:pt>
                <c:pt idx="1211">
                  <c:v>2.66588</c:v>
                </c:pt>
                <c:pt idx="1212">
                  <c:v>1.83831</c:v>
                </c:pt>
                <c:pt idx="1213">
                  <c:v>2.26038</c:v>
                </c:pt>
                <c:pt idx="1214">
                  <c:v>2.45922</c:v>
                </c:pt>
                <c:pt idx="1215">
                  <c:v>2.83434</c:v>
                </c:pt>
                <c:pt idx="1216">
                  <c:v>1.99204</c:v>
                </c:pt>
                <c:pt idx="1217">
                  <c:v>3.51277</c:v>
                </c:pt>
                <c:pt idx="1218">
                  <c:v>2.40813</c:v>
                </c:pt>
                <c:pt idx="1219">
                  <c:v>4.45817</c:v>
                </c:pt>
                <c:pt idx="1220">
                  <c:v>2.931909999999998</c:v>
                </c:pt>
                <c:pt idx="1221">
                  <c:v>3.06631</c:v>
                </c:pt>
                <c:pt idx="1222">
                  <c:v>3.80873</c:v>
                </c:pt>
                <c:pt idx="1223">
                  <c:v>5.7101</c:v>
                </c:pt>
                <c:pt idx="1224">
                  <c:v>2.0864</c:v>
                </c:pt>
                <c:pt idx="1225">
                  <c:v>2.833419999999998</c:v>
                </c:pt>
                <c:pt idx="1226">
                  <c:v>2.61525</c:v>
                </c:pt>
                <c:pt idx="1227">
                  <c:v>3.60391</c:v>
                </c:pt>
                <c:pt idx="1228">
                  <c:v>2.23</c:v>
                </c:pt>
                <c:pt idx="1229">
                  <c:v>4.691979999999995</c:v>
                </c:pt>
                <c:pt idx="1230">
                  <c:v>1.4678</c:v>
                </c:pt>
                <c:pt idx="1231">
                  <c:v>4.5111</c:v>
                </c:pt>
                <c:pt idx="1232">
                  <c:v>3.54545</c:v>
                </c:pt>
                <c:pt idx="1233">
                  <c:v>3.37331</c:v>
                </c:pt>
                <c:pt idx="1234">
                  <c:v>3.6665</c:v>
                </c:pt>
                <c:pt idx="1235">
                  <c:v>3.391259999999952</c:v>
                </c:pt>
                <c:pt idx="1236">
                  <c:v>4.267149999999996</c:v>
                </c:pt>
                <c:pt idx="1237">
                  <c:v>2.542069999999998</c:v>
                </c:pt>
                <c:pt idx="1238">
                  <c:v>2.72571</c:v>
                </c:pt>
                <c:pt idx="1239">
                  <c:v>4.67633</c:v>
                </c:pt>
                <c:pt idx="1240">
                  <c:v>3.76638</c:v>
                </c:pt>
                <c:pt idx="1241">
                  <c:v>4.21606</c:v>
                </c:pt>
                <c:pt idx="1242">
                  <c:v>5.114969999999976</c:v>
                </c:pt>
                <c:pt idx="1243">
                  <c:v>5.9927</c:v>
                </c:pt>
                <c:pt idx="1244">
                  <c:v>2.17201</c:v>
                </c:pt>
                <c:pt idx="1245">
                  <c:v>2.92133</c:v>
                </c:pt>
                <c:pt idx="1246">
                  <c:v>2.05832</c:v>
                </c:pt>
                <c:pt idx="1247">
                  <c:v>2.61755</c:v>
                </c:pt>
                <c:pt idx="1248">
                  <c:v>2.596379999999999</c:v>
                </c:pt>
                <c:pt idx="1249">
                  <c:v>4.181999999999999</c:v>
                </c:pt>
                <c:pt idx="1250">
                  <c:v>4.21376</c:v>
                </c:pt>
                <c:pt idx="1251">
                  <c:v>5.11727</c:v>
                </c:pt>
                <c:pt idx="1252">
                  <c:v>4.71914</c:v>
                </c:pt>
                <c:pt idx="1253">
                  <c:v>2.54759</c:v>
                </c:pt>
                <c:pt idx="1254">
                  <c:v>3.58043</c:v>
                </c:pt>
                <c:pt idx="1255">
                  <c:v>4.03196</c:v>
                </c:pt>
                <c:pt idx="1256">
                  <c:v>2.942499999999999</c:v>
                </c:pt>
                <c:pt idx="1257">
                  <c:v>2.20837</c:v>
                </c:pt>
                <c:pt idx="1258">
                  <c:v>4.26347</c:v>
                </c:pt>
                <c:pt idx="1259">
                  <c:v>2.60604</c:v>
                </c:pt>
                <c:pt idx="1260">
                  <c:v>4.008939999999996</c:v>
                </c:pt>
                <c:pt idx="1261">
                  <c:v>3.94727</c:v>
                </c:pt>
                <c:pt idx="1262">
                  <c:v>6.47829</c:v>
                </c:pt>
                <c:pt idx="1263">
                  <c:v>3.98777</c:v>
                </c:pt>
                <c:pt idx="1264">
                  <c:v>4.9617</c:v>
                </c:pt>
                <c:pt idx="1265">
                  <c:v>4.102839999999984</c:v>
                </c:pt>
                <c:pt idx="1266">
                  <c:v>3.05803</c:v>
                </c:pt>
                <c:pt idx="1267">
                  <c:v>5.71332</c:v>
                </c:pt>
                <c:pt idx="1268">
                  <c:v>4.29707</c:v>
                </c:pt>
                <c:pt idx="1269">
                  <c:v>4.842489999999985</c:v>
                </c:pt>
                <c:pt idx="1270">
                  <c:v>3.52382</c:v>
                </c:pt>
                <c:pt idx="1271">
                  <c:v>5.271</c:v>
                </c:pt>
                <c:pt idx="1272">
                  <c:v>3.77467</c:v>
                </c:pt>
                <c:pt idx="1273">
                  <c:v>4.69566</c:v>
                </c:pt>
                <c:pt idx="1274">
                  <c:v>4.043</c:v>
                </c:pt>
                <c:pt idx="1275">
                  <c:v>6.32824</c:v>
                </c:pt>
                <c:pt idx="1276">
                  <c:v>6.32455999999994</c:v>
                </c:pt>
                <c:pt idx="1277">
                  <c:v>2.56508</c:v>
                </c:pt>
                <c:pt idx="1278">
                  <c:v>3.856129999999998</c:v>
                </c:pt>
                <c:pt idx="1279">
                  <c:v>3.08104</c:v>
                </c:pt>
                <c:pt idx="1280">
                  <c:v>5.58306</c:v>
                </c:pt>
                <c:pt idx="1281">
                  <c:v>2.92823</c:v>
                </c:pt>
                <c:pt idx="1282">
                  <c:v>3.895259999999952</c:v>
                </c:pt>
                <c:pt idx="1283">
                  <c:v>3.551439999999999</c:v>
                </c:pt>
                <c:pt idx="1284">
                  <c:v>3.40645</c:v>
                </c:pt>
                <c:pt idx="1285">
                  <c:v>2.86333</c:v>
                </c:pt>
                <c:pt idx="1286">
                  <c:v>3.02075</c:v>
                </c:pt>
                <c:pt idx="1287">
                  <c:v>3.15837</c:v>
                </c:pt>
                <c:pt idx="1288">
                  <c:v>4.53273</c:v>
                </c:pt>
                <c:pt idx="1289">
                  <c:v>5.368579999999985</c:v>
                </c:pt>
                <c:pt idx="1290">
                  <c:v>5.13706</c:v>
                </c:pt>
                <c:pt idx="1291">
                  <c:v>3.356279999999952</c:v>
                </c:pt>
                <c:pt idx="1292">
                  <c:v>3.776969999999999</c:v>
                </c:pt>
                <c:pt idx="1293">
                  <c:v>4.652399999999996</c:v>
                </c:pt>
                <c:pt idx="1294">
                  <c:v>4.38682</c:v>
                </c:pt>
                <c:pt idx="1295">
                  <c:v>7.34681</c:v>
                </c:pt>
                <c:pt idx="1296">
                  <c:v>6.307529999999986</c:v>
                </c:pt>
                <c:pt idx="1297">
                  <c:v>5.18861</c:v>
                </c:pt>
                <c:pt idx="1298">
                  <c:v>3.54729</c:v>
                </c:pt>
                <c:pt idx="1299">
                  <c:v>4.1415</c:v>
                </c:pt>
                <c:pt idx="1300">
                  <c:v>7.187099999999996</c:v>
                </c:pt>
                <c:pt idx="1301">
                  <c:v>5.49009</c:v>
                </c:pt>
                <c:pt idx="1302">
                  <c:v>4.978</c:v>
                </c:pt>
                <c:pt idx="1303">
                  <c:v>2.99773</c:v>
                </c:pt>
                <c:pt idx="1304">
                  <c:v>7.00207</c:v>
                </c:pt>
                <c:pt idx="1305">
                  <c:v>2.72157</c:v>
                </c:pt>
                <c:pt idx="1306">
                  <c:v>4.652859999999975</c:v>
                </c:pt>
                <c:pt idx="1307">
                  <c:v>5.51264</c:v>
                </c:pt>
                <c:pt idx="1308">
                  <c:v>3.512309999999998</c:v>
                </c:pt>
                <c:pt idx="1309">
                  <c:v>2.119079999999999</c:v>
                </c:pt>
                <c:pt idx="1310">
                  <c:v>3.94773</c:v>
                </c:pt>
                <c:pt idx="1311">
                  <c:v>5.69905</c:v>
                </c:pt>
                <c:pt idx="1312">
                  <c:v>5.41184</c:v>
                </c:pt>
                <c:pt idx="1313">
                  <c:v>5.104379999999995</c:v>
                </c:pt>
                <c:pt idx="1314">
                  <c:v>3.97811</c:v>
                </c:pt>
                <c:pt idx="1315">
                  <c:v>2.22494</c:v>
                </c:pt>
                <c:pt idx="1316">
                  <c:v>6.827629999999996</c:v>
                </c:pt>
                <c:pt idx="1317">
                  <c:v>7.628499999999986</c:v>
                </c:pt>
                <c:pt idx="1318">
                  <c:v>3.435909999999998</c:v>
                </c:pt>
                <c:pt idx="1319">
                  <c:v>2.752409999999998</c:v>
                </c:pt>
                <c:pt idx="1320">
                  <c:v>3.702859999999998</c:v>
                </c:pt>
                <c:pt idx="1321">
                  <c:v>2.36486</c:v>
                </c:pt>
                <c:pt idx="1322">
                  <c:v>3.7268</c:v>
                </c:pt>
                <c:pt idx="1323">
                  <c:v>5.654859999999965</c:v>
                </c:pt>
                <c:pt idx="1324">
                  <c:v>2.59776</c:v>
                </c:pt>
                <c:pt idx="1325">
                  <c:v>4.27406</c:v>
                </c:pt>
                <c:pt idx="1326">
                  <c:v>3.021669999999999</c:v>
                </c:pt>
                <c:pt idx="1327">
                  <c:v>1.69977</c:v>
                </c:pt>
                <c:pt idx="1328">
                  <c:v>4.698889999999975</c:v>
                </c:pt>
                <c:pt idx="1329">
                  <c:v>2.86425</c:v>
                </c:pt>
                <c:pt idx="1330">
                  <c:v>3.05527</c:v>
                </c:pt>
                <c:pt idx="1331">
                  <c:v>5.677879999999995</c:v>
                </c:pt>
                <c:pt idx="1332">
                  <c:v>3.51784</c:v>
                </c:pt>
                <c:pt idx="1333">
                  <c:v>3.55005</c:v>
                </c:pt>
                <c:pt idx="1334">
                  <c:v>5.457409999999999</c:v>
                </c:pt>
                <c:pt idx="1335">
                  <c:v>3.606669999999998</c:v>
                </c:pt>
                <c:pt idx="1336">
                  <c:v>3.36042</c:v>
                </c:pt>
                <c:pt idx="1337">
                  <c:v>4.43055</c:v>
                </c:pt>
                <c:pt idx="1338">
                  <c:v>3.12707</c:v>
                </c:pt>
                <c:pt idx="1339">
                  <c:v>3.19795</c:v>
                </c:pt>
                <c:pt idx="1340">
                  <c:v>5.183549999999999</c:v>
                </c:pt>
                <c:pt idx="1341">
                  <c:v>4.25657</c:v>
                </c:pt>
                <c:pt idx="1342">
                  <c:v>5.14627</c:v>
                </c:pt>
                <c:pt idx="1343">
                  <c:v>2.445409999999998</c:v>
                </c:pt>
                <c:pt idx="1344">
                  <c:v>3.64487</c:v>
                </c:pt>
                <c:pt idx="1345">
                  <c:v>4.13644</c:v>
                </c:pt>
                <c:pt idx="1346">
                  <c:v>3.96614</c:v>
                </c:pt>
                <c:pt idx="1347">
                  <c:v>4.51984</c:v>
                </c:pt>
                <c:pt idx="1348">
                  <c:v>2.96597</c:v>
                </c:pt>
                <c:pt idx="1349">
                  <c:v>4.0697</c:v>
                </c:pt>
                <c:pt idx="1350">
                  <c:v>6.572179999999999</c:v>
                </c:pt>
                <c:pt idx="1351">
                  <c:v>5.26087</c:v>
                </c:pt>
                <c:pt idx="1352">
                  <c:v>2.36716</c:v>
                </c:pt>
                <c:pt idx="1353">
                  <c:v>4.263009999999999</c:v>
                </c:pt>
                <c:pt idx="1354">
                  <c:v>2.982079999999998</c:v>
                </c:pt>
                <c:pt idx="1355">
                  <c:v>4.72604</c:v>
                </c:pt>
                <c:pt idx="1356">
                  <c:v>3.54867</c:v>
                </c:pt>
                <c:pt idx="1357">
                  <c:v>4.93823</c:v>
                </c:pt>
                <c:pt idx="1358">
                  <c:v>2.36716</c:v>
                </c:pt>
                <c:pt idx="1359">
                  <c:v>3.4939</c:v>
                </c:pt>
                <c:pt idx="1360">
                  <c:v>1.6786</c:v>
                </c:pt>
                <c:pt idx="1361">
                  <c:v>3.13581</c:v>
                </c:pt>
                <c:pt idx="1362">
                  <c:v>2.77404</c:v>
                </c:pt>
                <c:pt idx="1363">
                  <c:v>6.017559999999984</c:v>
                </c:pt>
                <c:pt idx="1364">
                  <c:v>2.57521</c:v>
                </c:pt>
                <c:pt idx="1365">
                  <c:v>3.59792</c:v>
                </c:pt>
                <c:pt idx="1366">
                  <c:v>2.432519999999998</c:v>
                </c:pt>
                <c:pt idx="1367">
                  <c:v>2.960449999999998</c:v>
                </c:pt>
                <c:pt idx="1368">
                  <c:v>2.86702</c:v>
                </c:pt>
                <c:pt idx="1369">
                  <c:v>2.55818</c:v>
                </c:pt>
                <c:pt idx="1370">
                  <c:v>2.18536</c:v>
                </c:pt>
                <c:pt idx="1371">
                  <c:v>2.58027</c:v>
                </c:pt>
                <c:pt idx="1372">
                  <c:v>1.79551</c:v>
                </c:pt>
                <c:pt idx="1373">
                  <c:v>2.63918</c:v>
                </c:pt>
                <c:pt idx="1374">
                  <c:v>4.3836</c:v>
                </c:pt>
                <c:pt idx="1375">
                  <c:v>2.909819999999998</c:v>
                </c:pt>
                <c:pt idx="1376">
                  <c:v>1.99343</c:v>
                </c:pt>
                <c:pt idx="1377">
                  <c:v>5.93977</c:v>
                </c:pt>
                <c:pt idx="1378">
                  <c:v>2.20331</c:v>
                </c:pt>
                <c:pt idx="1379">
                  <c:v>4.21376</c:v>
                </c:pt>
                <c:pt idx="1380">
                  <c:v>6.198439999999985</c:v>
                </c:pt>
                <c:pt idx="1381">
                  <c:v>2.705</c:v>
                </c:pt>
                <c:pt idx="1382">
                  <c:v>3.24213</c:v>
                </c:pt>
                <c:pt idx="1383">
                  <c:v>2.6401</c:v>
                </c:pt>
                <c:pt idx="1384">
                  <c:v>4.263929999999998</c:v>
                </c:pt>
                <c:pt idx="1385">
                  <c:v>3.393559999999999</c:v>
                </c:pt>
                <c:pt idx="1386">
                  <c:v>3.02121</c:v>
                </c:pt>
                <c:pt idx="1387">
                  <c:v>3.9284</c:v>
                </c:pt>
                <c:pt idx="1388">
                  <c:v>3.12753</c:v>
                </c:pt>
                <c:pt idx="1389">
                  <c:v>2.16741</c:v>
                </c:pt>
                <c:pt idx="1390">
                  <c:v>2.63044</c:v>
                </c:pt>
                <c:pt idx="1391">
                  <c:v>3.179079999999999</c:v>
                </c:pt>
                <c:pt idx="1392">
                  <c:v>3.67985</c:v>
                </c:pt>
                <c:pt idx="1393">
                  <c:v>2.369</c:v>
                </c:pt>
                <c:pt idx="1394">
                  <c:v>2.131969999999999</c:v>
                </c:pt>
                <c:pt idx="1395">
                  <c:v>2.42516</c:v>
                </c:pt>
                <c:pt idx="1396">
                  <c:v>2.60144</c:v>
                </c:pt>
                <c:pt idx="1397">
                  <c:v>3.48424</c:v>
                </c:pt>
                <c:pt idx="1398">
                  <c:v>4.199949999999998</c:v>
                </c:pt>
                <c:pt idx="1399">
                  <c:v>2.366699999999998</c:v>
                </c:pt>
                <c:pt idx="1400">
                  <c:v>2.47533</c:v>
                </c:pt>
                <c:pt idx="1401">
                  <c:v>2.85597</c:v>
                </c:pt>
                <c:pt idx="1402">
                  <c:v>1.81346</c:v>
                </c:pt>
                <c:pt idx="1403">
                  <c:v>3.7719</c:v>
                </c:pt>
                <c:pt idx="1404">
                  <c:v>1.70944</c:v>
                </c:pt>
                <c:pt idx="1405">
                  <c:v>2.874379999999999</c:v>
                </c:pt>
                <c:pt idx="1406">
                  <c:v>1.91334</c:v>
                </c:pt>
                <c:pt idx="1407">
                  <c:v>2.03439</c:v>
                </c:pt>
                <c:pt idx="1408">
                  <c:v>1.99665</c:v>
                </c:pt>
                <c:pt idx="1409">
                  <c:v>3.061249999999998</c:v>
                </c:pt>
                <c:pt idx="1410">
                  <c:v>1.76789</c:v>
                </c:pt>
                <c:pt idx="1411">
                  <c:v>3.494819999999998</c:v>
                </c:pt>
                <c:pt idx="1412">
                  <c:v>3.2472</c:v>
                </c:pt>
                <c:pt idx="1413">
                  <c:v>2.48453</c:v>
                </c:pt>
                <c:pt idx="1414">
                  <c:v>1.923</c:v>
                </c:pt>
                <c:pt idx="1415">
                  <c:v>2.24335</c:v>
                </c:pt>
                <c:pt idx="1416">
                  <c:v>2.13611</c:v>
                </c:pt>
                <c:pt idx="1417">
                  <c:v>2.05234</c:v>
                </c:pt>
                <c:pt idx="1418">
                  <c:v>1.7076</c:v>
                </c:pt>
                <c:pt idx="1419">
                  <c:v>2.07029</c:v>
                </c:pt>
                <c:pt idx="1420">
                  <c:v>3.216819999999998</c:v>
                </c:pt>
                <c:pt idx="1421">
                  <c:v>3.67479</c:v>
                </c:pt>
                <c:pt idx="1422">
                  <c:v>3.58826</c:v>
                </c:pt>
                <c:pt idx="1423">
                  <c:v>3.336949999999952</c:v>
                </c:pt>
                <c:pt idx="1424">
                  <c:v>1.75593</c:v>
                </c:pt>
                <c:pt idx="1425">
                  <c:v>1.29105</c:v>
                </c:pt>
                <c:pt idx="1426">
                  <c:v>2.386029999999998</c:v>
                </c:pt>
                <c:pt idx="1427">
                  <c:v>1.57826</c:v>
                </c:pt>
                <c:pt idx="1428">
                  <c:v>2.037609999999999</c:v>
                </c:pt>
                <c:pt idx="1429">
                  <c:v>2.33218</c:v>
                </c:pt>
                <c:pt idx="1430">
                  <c:v>1.9115</c:v>
                </c:pt>
                <c:pt idx="1431">
                  <c:v>1.69241</c:v>
                </c:pt>
                <c:pt idx="1432">
                  <c:v>1.78446</c:v>
                </c:pt>
                <c:pt idx="1433">
                  <c:v>1.44847</c:v>
                </c:pt>
                <c:pt idx="1434">
                  <c:v>3.639349999999998</c:v>
                </c:pt>
                <c:pt idx="1435">
                  <c:v>3.151</c:v>
                </c:pt>
                <c:pt idx="1436">
                  <c:v>2.56002</c:v>
                </c:pt>
                <c:pt idx="1437">
                  <c:v>1.64914</c:v>
                </c:pt>
                <c:pt idx="1438">
                  <c:v>1.89032</c:v>
                </c:pt>
                <c:pt idx="1439">
                  <c:v>2.274649999999998</c:v>
                </c:pt>
                <c:pt idx="1440">
                  <c:v>3.06769</c:v>
                </c:pt>
                <c:pt idx="1441">
                  <c:v>2.09837</c:v>
                </c:pt>
                <c:pt idx="1442">
                  <c:v>1.5083</c:v>
                </c:pt>
                <c:pt idx="1443">
                  <c:v>2.824209999999999</c:v>
                </c:pt>
                <c:pt idx="1444">
                  <c:v>2.90752</c:v>
                </c:pt>
                <c:pt idx="1445">
                  <c:v>2.933749999999998</c:v>
                </c:pt>
                <c:pt idx="1446">
                  <c:v>1.79321</c:v>
                </c:pt>
                <c:pt idx="1447">
                  <c:v>1.92577</c:v>
                </c:pt>
                <c:pt idx="1448">
                  <c:v>2.499719999999999</c:v>
                </c:pt>
                <c:pt idx="1449">
                  <c:v>3.57031</c:v>
                </c:pt>
                <c:pt idx="1450">
                  <c:v>3.311179999999998</c:v>
                </c:pt>
                <c:pt idx="1451">
                  <c:v>3.18138</c:v>
                </c:pt>
                <c:pt idx="1452">
                  <c:v>6.629709999999997</c:v>
                </c:pt>
                <c:pt idx="1453">
                  <c:v>3.32038</c:v>
                </c:pt>
                <c:pt idx="1454">
                  <c:v>2.434359999999998</c:v>
                </c:pt>
                <c:pt idx="1455">
                  <c:v>4.10606</c:v>
                </c:pt>
                <c:pt idx="1456">
                  <c:v>2.78739</c:v>
                </c:pt>
                <c:pt idx="1457">
                  <c:v>2.16603</c:v>
                </c:pt>
                <c:pt idx="1458">
                  <c:v>4.20548</c:v>
                </c:pt>
                <c:pt idx="1459">
                  <c:v>4.180159999999995</c:v>
                </c:pt>
                <c:pt idx="1460">
                  <c:v>4.104679999999997</c:v>
                </c:pt>
                <c:pt idx="1461">
                  <c:v>4.94513</c:v>
                </c:pt>
                <c:pt idx="1462">
                  <c:v>2.00401</c:v>
                </c:pt>
                <c:pt idx="1463">
                  <c:v>2.65897</c:v>
                </c:pt>
                <c:pt idx="1464">
                  <c:v>3.80182</c:v>
                </c:pt>
                <c:pt idx="1465">
                  <c:v>3.422099999999999</c:v>
                </c:pt>
                <c:pt idx="1466">
                  <c:v>3.214059999999999</c:v>
                </c:pt>
                <c:pt idx="1467">
                  <c:v>4.97827</c:v>
                </c:pt>
                <c:pt idx="1468">
                  <c:v>6.27945</c:v>
                </c:pt>
                <c:pt idx="1469">
                  <c:v>2.56462</c:v>
                </c:pt>
                <c:pt idx="1470">
                  <c:v>4.33435</c:v>
                </c:pt>
                <c:pt idx="1471">
                  <c:v>1.87652</c:v>
                </c:pt>
                <c:pt idx="1472">
                  <c:v>1.58517</c:v>
                </c:pt>
                <c:pt idx="1473">
                  <c:v>3.43223</c:v>
                </c:pt>
                <c:pt idx="1474">
                  <c:v>2.82329</c:v>
                </c:pt>
                <c:pt idx="1475">
                  <c:v>2.902919999999999</c:v>
                </c:pt>
                <c:pt idx="1476">
                  <c:v>3.496199999999999</c:v>
                </c:pt>
                <c:pt idx="1477">
                  <c:v>5.562809999999986</c:v>
                </c:pt>
                <c:pt idx="1478">
                  <c:v>3.47411</c:v>
                </c:pt>
                <c:pt idx="1479">
                  <c:v>4.01539</c:v>
                </c:pt>
                <c:pt idx="1480">
                  <c:v>3.40829</c:v>
                </c:pt>
                <c:pt idx="1481">
                  <c:v>2.88681</c:v>
                </c:pt>
                <c:pt idx="1482">
                  <c:v>5.92504</c:v>
                </c:pt>
                <c:pt idx="1483">
                  <c:v>1.92531</c:v>
                </c:pt>
                <c:pt idx="1484">
                  <c:v>2.43758</c:v>
                </c:pt>
                <c:pt idx="1485">
                  <c:v>6.86077</c:v>
                </c:pt>
                <c:pt idx="1486">
                  <c:v>5.25305</c:v>
                </c:pt>
                <c:pt idx="1487">
                  <c:v>3.5183</c:v>
                </c:pt>
                <c:pt idx="1488">
                  <c:v>3.83772</c:v>
                </c:pt>
                <c:pt idx="1489">
                  <c:v>3.95601</c:v>
                </c:pt>
                <c:pt idx="1490">
                  <c:v>2.36302</c:v>
                </c:pt>
                <c:pt idx="1491">
                  <c:v>3.917349999999999</c:v>
                </c:pt>
                <c:pt idx="1492">
                  <c:v>1.56584</c:v>
                </c:pt>
                <c:pt idx="1493">
                  <c:v>2.18029</c:v>
                </c:pt>
                <c:pt idx="1494">
                  <c:v>5.90663</c:v>
                </c:pt>
                <c:pt idx="1495">
                  <c:v>3.24029</c:v>
                </c:pt>
                <c:pt idx="1496">
                  <c:v>4.6616</c:v>
                </c:pt>
                <c:pt idx="1497">
                  <c:v>2.51399</c:v>
                </c:pt>
                <c:pt idx="1498">
                  <c:v>1.55249</c:v>
                </c:pt>
                <c:pt idx="1499">
                  <c:v>1.41349</c:v>
                </c:pt>
                <c:pt idx="1500">
                  <c:v>4.07614</c:v>
                </c:pt>
                <c:pt idx="1501">
                  <c:v>12.3232</c:v>
                </c:pt>
                <c:pt idx="1502">
                  <c:v>8.401290000000001</c:v>
                </c:pt>
                <c:pt idx="1503">
                  <c:v>6.0912</c:v>
                </c:pt>
                <c:pt idx="1504">
                  <c:v>2.353359999999999</c:v>
                </c:pt>
                <c:pt idx="1505">
                  <c:v>2.33955</c:v>
                </c:pt>
                <c:pt idx="1506">
                  <c:v>2.70316</c:v>
                </c:pt>
                <c:pt idx="1507">
                  <c:v>3.52704</c:v>
                </c:pt>
                <c:pt idx="1508">
                  <c:v>5.217149999999997</c:v>
                </c:pt>
                <c:pt idx="1509">
                  <c:v>4.21652</c:v>
                </c:pt>
                <c:pt idx="1510">
                  <c:v>3.89894</c:v>
                </c:pt>
                <c:pt idx="1511">
                  <c:v>4.96584</c:v>
                </c:pt>
                <c:pt idx="1512">
                  <c:v>3.6909</c:v>
                </c:pt>
                <c:pt idx="1513">
                  <c:v>3.821149999999998</c:v>
                </c:pt>
                <c:pt idx="1514">
                  <c:v>4.50926</c:v>
                </c:pt>
                <c:pt idx="1515">
                  <c:v>5.51909</c:v>
                </c:pt>
                <c:pt idx="1516">
                  <c:v>4.24092</c:v>
                </c:pt>
                <c:pt idx="1517">
                  <c:v>2.39156</c:v>
                </c:pt>
                <c:pt idx="1518">
                  <c:v>4.835129999999999</c:v>
                </c:pt>
                <c:pt idx="1519">
                  <c:v>5.00543</c:v>
                </c:pt>
                <c:pt idx="1520">
                  <c:v>3.901699999999999</c:v>
                </c:pt>
                <c:pt idx="1521">
                  <c:v>4.37302</c:v>
                </c:pt>
                <c:pt idx="1522">
                  <c:v>4.75182</c:v>
                </c:pt>
                <c:pt idx="1523">
                  <c:v>4.34908</c:v>
                </c:pt>
                <c:pt idx="1524">
                  <c:v>3.62922</c:v>
                </c:pt>
                <c:pt idx="1525">
                  <c:v>5.810899999999997</c:v>
                </c:pt>
                <c:pt idx="1526">
                  <c:v>6.361839999999995</c:v>
                </c:pt>
                <c:pt idx="1527">
                  <c:v>4.23586</c:v>
                </c:pt>
                <c:pt idx="1528">
                  <c:v>5.94299</c:v>
                </c:pt>
                <c:pt idx="1529">
                  <c:v>7.08124</c:v>
                </c:pt>
                <c:pt idx="1530">
                  <c:v>3.113259999999999</c:v>
                </c:pt>
                <c:pt idx="1531">
                  <c:v>2.734</c:v>
                </c:pt>
                <c:pt idx="1532">
                  <c:v>4.38636</c:v>
                </c:pt>
                <c:pt idx="1533">
                  <c:v>5.320709999999996</c:v>
                </c:pt>
                <c:pt idx="1534">
                  <c:v>2.35658</c:v>
                </c:pt>
                <c:pt idx="1535">
                  <c:v>3.3793</c:v>
                </c:pt>
                <c:pt idx="1536">
                  <c:v>1.97824</c:v>
                </c:pt>
                <c:pt idx="1537">
                  <c:v>5.862449999999995</c:v>
                </c:pt>
                <c:pt idx="1538">
                  <c:v>2.98254</c:v>
                </c:pt>
                <c:pt idx="1539">
                  <c:v>3.51277</c:v>
                </c:pt>
                <c:pt idx="1540">
                  <c:v>2.74228</c:v>
                </c:pt>
                <c:pt idx="1541">
                  <c:v>3.68721</c:v>
                </c:pt>
                <c:pt idx="1542">
                  <c:v>4.197189999999964</c:v>
                </c:pt>
                <c:pt idx="1543">
                  <c:v>2.08272</c:v>
                </c:pt>
                <c:pt idx="1544">
                  <c:v>2.58211</c:v>
                </c:pt>
                <c:pt idx="1545">
                  <c:v>3.23983</c:v>
                </c:pt>
                <c:pt idx="1546">
                  <c:v>4.06602</c:v>
                </c:pt>
                <c:pt idx="1547">
                  <c:v>2.502479999999998</c:v>
                </c:pt>
                <c:pt idx="1548">
                  <c:v>3.80735</c:v>
                </c:pt>
                <c:pt idx="1549">
                  <c:v>3.54959</c:v>
                </c:pt>
                <c:pt idx="1550">
                  <c:v>3.1441</c:v>
                </c:pt>
                <c:pt idx="1551">
                  <c:v>5.4413</c:v>
                </c:pt>
                <c:pt idx="1552">
                  <c:v>3.994209999999998</c:v>
                </c:pt>
                <c:pt idx="1553">
                  <c:v>3.944049999999998</c:v>
                </c:pt>
                <c:pt idx="1554">
                  <c:v>4.63997</c:v>
                </c:pt>
                <c:pt idx="1555">
                  <c:v>3.73347</c:v>
                </c:pt>
                <c:pt idx="1556">
                  <c:v>2.95723</c:v>
                </c:pt>
                <c:pt idx="1557">
                  <c:v>2.38005</c:v>
                </c:pt>
                <c:pt idx="1558">
                  <c:v>1.7458</c:v>
                </c:pt>
                <c:pt idx="1559">
                  <c:v>1.90505</c:v>
                </c:pt>
                <c:pt idx="1560">
                  <c:v>1.31269</c:v>
                </c:pt>
                <c:pt idx="1561">
                  <c:v>2.94848</c:v>
                </c:pt>
                <c:pt idx="1562">
                  <c:v>2.62629</c:v>
                </c:pt>
                <c:pt idx="1563">
                  <c:v>1.72831</c:v>
                </c:pt>
                <c:pt idx="1564">
                  <c:v>1.99481</c:v>
                </c:pt>
                <c:pt idx="1565">
                  <c:v>2.48453</c:v>
                </c:pt>
                <c:pt idx="1566">
                  <c:v>2.17293</c:v>
                </c:pt>
                <c:pt idx="1567">
                  <c:v>2.53884</c:v>
                </c:pt>
                <c:pt idx="1568">
                  <c:v>2.81731</c:v>
                </c:pt>
                <c:pt idx="1569">
                  <c:v>3.579969999999999</c:v>
                </c:pt>
                <c:pt idx="1570">
                  <c:v>2.08732</c:v>
                </c:pt>
                <c:pt idx="1571">
                  <c:v>1.94049</c:v>
                </c:pt>
                <c:pt idx="1572">
                  <c:v>4.807049999999998</c:v>
                </c:pt>
                <c:pt idx="1573">
                  <c:v>4.124469999999985</c:v>
                </c:pt>
                <c:pt idx="1574">
                  <c:v>5.23142</c:v>
                </c:pt>
                <c:pt idx="1575">
                  <c:v>2.421479999999998</c:v>
                </c:pt>
                <c:pt idx="1576">
                  <c:v>2.14393</c:v>
                </c:pt>
                <c:pt idx="1577">
                  <c:v>3.41289</c:v>
                </c:pt>
                <c:pt idx="1578">
                  <c:v>2.95953</c:v>
                </c:pt>
                <c:pt idx="1579">
                  <c:v>3.46398</c:v>
                </c:pt>
                <c:pt idx="1580">
                  <c:v>3.06263</c:v>
                </c:pt>
                <c:pt idx="1581">
                  <c:v>2.092839999999998</c:v>
                </c:pt>
                <c:pt idx="1582">
                  <c:v>1.64178</c:v>
                </c:pt>
                <c:pt idx="1583">
                  <c:v>1.21281</c:v>
                </c:pt>
                <c:pt idx="1584">
                  <c:v>2.0818</c:v>
                </c:pt>
                <c:pt idx="1585">
                  <c:v>1.38219</c:v>
                </c:pt>
                <c:pt idx="1586">
                  <c:v>2.16557</c:v>
                </c:pt>
                <c:pt idx="1587">
                  <c:v>1.73199</c:v>
                </c:pt>
                <c:pt idx="1588">
                  <c:v>1.79183</c:v>
                </c:pt>
                <c:pt idx="1589">
                  <c:v>1.63902</c:v>
                </c:pt>
                <c:pt idx="1590">
                  <c:v>1.33202</c:v>
                </c:pt>
                <c:pt idx="1591">
                  <c:v>2.1849</c:v>
                </c:pt>
                <c:pt idx="1592">
                  <c:v>1.90137</c:v>
                </c:pt>
                <c:pt idx="1593">
                  <c:v>3.51599</c:v>
                </c:pt>
                <c:pt idx="1594">
                  <c:v>0.988198</c:v>
                </c:pt>
                <c:pt idx="1595">
                  <c:v>1.40612</c:v>
                </c:pt>
                <c:pt idx="1596">
                  <c:v>0.808693</c:v>
                </c:pt>
                <c:pt idx="1597">
                  <c:v>0.349804</c:v>
                </c:pt>
                <c:pt idx="1598">
                  <c:v>0.788901</c:v>
                </c:pt>
                <c:pt idx="1599">
                  <c:v>0.790282</c:v>
                </c:pt>
                <c:pt idx="1600">
                  <c:v>1.7863</c:v>
                </c:pt>
                <c:pt idx="1601">
                  <c:v>2.099749999999998</c:v>
                </c:pt>
                <c:pt idx="1602">
                  <c:v>3.039159999999999</c:v>
                </c:pt>
                <c:pt idx="1603">
                  <c:v>1.1898</c:v>
                </c:pt>
                <c:pt idx="1604">
                  <c:v>2.1941</c:v>
                </c:pt>
                <c:pt idx="1605">
                  <c:v>1.46412</c:v>
                </c:pt>
                <c:pt idx="1606">
                  <c:v>1.06506</c:v>
                </c:pt>
                <c:pt idx="1607">
                  <c:v>1.5999</c:v>
                </c:pt>
                <c:pt idx="1608">
                  <c:v>1.4388</c:v>
                </c:pt>
                <c:pt idx="1609">
                  <c:v>2.32574</c:v>
                </c:pt>
                <c:pt idx="1610">
                  <c:v>2.59316</c:v>
                </c:pt>
                <c:pt idx="1611">
                  <c:v>1.7458</c:v>
                </c:pt>
                <c:pt idx="1612">
                  <c:v>1.54512</c:v>
                </c:pt>
                <c:pt idx="1613">
                  <c:v>2.20745</c:v>
                </c:pt>
                <c:pt idx="1614">
                  <c:v>2.01414</c:v>
                </c:pt>
                <c:pt idx="1615">
                  <c:v>1.68551</c:v>
                </c:pt>
                <c:pt idx="1616">
                  <c:v>2.971499999999998</c:v>
                </c:pt>
                <c:pt idx="1617">
                  <c:v>3.38758</c:v>
                </c:pt>
                <c:pt idx="1618">
                  <c:v>2.1582</c:v>
                </c:pt>
                <c:pt idx="1619">
                  <c:v>2.4293</c:v>
                </c:pt>
                <c:pt idx="1620">
                  <c:v>2.30181</c:v>
                </c:pt>
                <c:pt idx="1621">
                  <c:v>2.94986</c:v>
                </c:pt>
                <c:pt idx="1622">
                  <c:v>3.61863</c:v>
                </c:pt>
                <c:pt idx="1623">
                  <c:v>1.92991</c:v>
                </c:pt>
                <c:pt idx="1624">
                  <c:v>1.61416</c:v>
                </c:pt>
                <c:pt idx="1625">
                  <c:v>3.60943</c:v>
                </c:pt>
                <c:pt idx="1626">
                  <c:v>2.526419999999999</c:v>
                </c:pt>
                <c:pt idx="1627">
                  <c:v>4.66667</c:v>
                </c:pt>
                <c:pt idx="1628">
                  <c:v>3.655</c:v>
                </c:pt>
                <c:pt idx="1629">
                  <c:v>3.68998</c:v>
                </c:pt>
                <c:pt idx="1630">
                  <c:v>3.27159</c:v>
                </c:pt>
                <c:pt idx="1631">
                  <c:v>2.00171</c:v>
                </c:pt>
                <c:pt idx="1632">
                  <c:v>4.72926</c:v>
                </c:pt>
                <c:pt idx="1633">
                  <c:v>3.27712</c:v>
                </c:pt>
                <c:pt idx="1634">
                  <c:v>3.66374</c:v>
                </c:pt>
                <c:pt idx="1635">
                  <c:v>1.69977</c:v>
                </c:pt>
                <c:pt idx="1636">
                  <c:v>2.08226</c:v>
                </c:pt>
                <c:pt idx="1637">
                  <c:v>2.10711</c:v>
                </c:pt>
                <c:pt idx="1638">
                  <c:v>4.57876</c:v>
                </c:pt>
                <c:pt idx="1639">
                  <c:v>2.513069999999999</c:v>
                </c:pt>
                <c:pt idx="1640">
                  <c:v>1.68504</c:v>
                </c:pt>
                <c:pt idx="1641">
                  <c:v>3.46076</c:v>
                </c:pt>
                <c:pt idx="1642">
                  <c:v>5.57064</c:v>
                </c:pt>
                <c:pt idx="1643">
                  <c:v>2.859189999999999</c:v>
                </c:pt>
                <c:pt idx="1644">
                  <c:v>5.61022</c:v>
                </c:pt>
                <c:pt idx="1645">
                  <c:v>4.357829999999986</c:v>
                </c:pt>
                <c:pt idx="1646">
                  <c:v>2.66128</c:v>
                </c:pt>
                <c:pt idx="1647">
                  <c:v>2.20193</c:v>
                </c:pt>
                <c:pt idx="1648">
                  <c:v>3.33419</c:v>
                </c:pt>
                <c:pt idx="1649">
                  <c:v>4.63537</c:v>
                </c:pt>
                <c:pt idx="1650">
                  <c:v>6.87228</c:v>
                </c:pt>
                <c:pt idx="1651">
                  <c:v>3.376529999999998</c:v>
                </c:pt>
                <c:pt idx="1652">
                  <c:v>3.60713</c:v>
                </c:pt>
                <c:pt idx="1653">
                  <c:v>3.556039999999999</c:v>
                </c:pt>
                <c:pt idx="1654">
                  <c:v>4.685079999999996</c:v>
                </c:pt>
                <c:pt idx="1655">
                  <c:v>4.120789999999984</c:v>
                </c:pt>
                <c:pt idx="1656">
                  <c:v>4.59072</c:v>
                </c:pt>
                <c:pt idx="1657">
                  <c:v>3.62278</c:v>
                </c:pt>
                <c:pt idx="1658">
                  <c:v>4.870109999999999</c:v>
                </c:pt>
                <c:pt idx="1659">
                  <c:v>7.99027</c:v>
                </c:pt>
                <c:pt idx="1660">
                  <c:v>4.53227</c:v>
                </c:pt>
                <c:pt idx="1661">
                  <c:v>6.683109999999996</c:v>
                </c:pt>
                <c:pt idx="1662">
                  <c:v>2.68797</c:v>
                </c:pt>
                <c:pt idx="1663">
                  <c:v>5.358449999999999</c:v>
                </c:pt>
                <c:pt idx="1664">
                  <c:v>3.395859999999952</c:v>
                </c:pt>
                <c:pt idx="1665">
                  <c:v>4.93454</c:v>
                </c:pt>
                <c:pt idx="1666">
                  <c:v>2.90015</c:v>
                </c:pt>
                <c:pt idx="1667">
                  <c:v>6.7411</c:v>
                </c:pt>
                <c:pt idx="1668">
                  <c:v>3.66098</c:v>
                </c:pt>
                <c:pt idx="1669">
                  <c:v>2.436199999999999</c:v>
                </c:pt>
                <c:pt idx="1670">
                  <c:v>5.627709999999975</c:v>
                </c:pt>
                <c:pt idx="1671">
                  <c:v>7.28882</c:v>
                </c:pt>
                <c:pt idx="1672">
                  <c:v>3.439589999999999</c:v>
                </c:pt>
                <c:pt idx="1673">
                  <c:v>3.310249999999952</c:v>
                </c:pt>
                <c:pt idx="1674">
                  <c:v>3.21728</c:v>
                </c:pt>
                <c:pt idx="1675">
                  <c:v>1.7168</c:v>
                </c:pt>
                <c:pt idx="1676">
                  <c:v>3.21452</c:v>
                </c:pt>
                <c:pt idx="1677">
                  <c:v>6.41661</c:v>
                </c:pt>
                <c:pt idx="1678">
                  <c:v>4.08028</c:v>
                </c:pt>
                <c:pt idx="1679">
                  <c:v>2.64194</c:v>
                </c:pt>
                <c:pt idx="1680">
                  <c:v>6.0194</c:v>
                </c:pt>
                <c:pt idx="1681">
                  <c:v>3.321759999999998</c:v>
                </c:pt>
                <c:pt idx="1682">
                  <c:v>2.26084</c:v>
                </c:pt>
                <c:pt idx="1683">
                  <c:v>3.13443</c:v>
                </c:pt>
                <c:pt idx="1684">
                  <c:v>3.08058</c:v>
                </c:pt>
                <c:pt idx="1685">
                  <c:v>2.97196</c:v>
                </c:pt>
                <c:pt idx="1686">
                  <c:v>5.9881</c:v>
                </c:pt>
                <c:pt idx="1687">
                  <c:v>2.36762</c:v>
                </c:pt>
                <c:pt idx="1688">
                  <c:v>3.12016</c:v>
                </c:pt>
                <c:pt idx="1689">
                  <c:v>3.81931</c:v>
                </c:pt>
                <c:pt idx="1690">
                  <c:v>6.221919999999995</c:v>
                </c:pt>
                <c:pt idx="1691">
                  <c:v>3.56755</c:v>
                </c:pt>
                <c:pt idx="1692">
                  <c:v>2.37223</c:v>
                </c:pt>
                <c:pt idx="1693">
                  <c:v>2.21021</c:v>
                </c:pt>
                <c:pt idx="1694">
                  <c:v>2.07627</c:v>
                </c:pt>
                <c:pt idx="1695">
                  <c:v>5.9881</c:v>
                </c:pt>
                <c:pt idx="1696">
                  <c:v>5.625869999999995</c:v>
                </c:pt>
                <c:pt idx="1697">
                  <c:v>3.303809999999999</c:v>
                </c:pt>
                <c:pt idx="1698">
                  <c:v>2.38281</c:v>
                </c:pt>
                <c:pt idx="1699">
                  <c:v>4.628469999999996</c:v>
                </c:pt>
                <c:pt idx="1700">
                  <c:v>3.954629999999999</c:v>
                </c:pt>
                <c:pt idx="1701">
                  <c:v>2.94802</c:v>
                </c:pt>
                <c:pt idx="1702">
                  <c:v>2.68705</c:v>
                </c:pt>
                <c:pt idx="1703">
                  <c:v>4.55574</c:v>
                </c:pt>
                <c:pt idx="1704">
                  <c:v>3.49712</c:v>
                </c:pt>
                <c:pt idx="1705">
                  <c:v>2.36946</c:v>
                </c:pt>
                <c:pt idx="1706">
                  <c:v>2.804879999999998</c:v>
                </c:pt>
                <c:pt idx="1707">
                  <c:v>2.954009999999998</c:v>
                </c:pt>
                <c:pt idx="1708">
                  <c:v>3.05711</c:v>
                </c:pt>
                <c:pt idx="1709">
                  <c:v>4.54746</c:v>
                </c:pt>
                <c:pt idx="1710">
                  <c:v>4.97183</c:v>
                </c:pt>
                <c:pt idx="1711">
                  <c:v>6.38577</c:v>
                </c:pt>
                <c:pt idx="1712">
                  <c:v>3.64303</c:v>
                </c:pt>
                <c:pt idx="1713">
                  <c:v>5.6162</c:v>
                </c:pt>
                <c:pt idx="1714">
                  <c:v>5.89374</c:v>
                </c:pt>
                <c:pt idx="1715">
                  <c:v>3.612649999999952</c:v>
                </c:pt>
                <c:pt idx="1716">
                  <c:v>2.91672</c:v>
                </c:pt>
                <c:pt idx="1717">
                  <c:v>3.398169999999999</c:v>
                </c:pt>
                <c:pt idx="1718">
                  <c:v>4.114799999999986</c:v>
                </c:pt>
                <c:pt idx="1719">
                  <c:v>6.819809999999999</c:v>
                </c:pt>
                <c:pt idx="1720">
                  <c:v>6.8014</c:v>
                </c:pt>
                <c:pt idx="1721">
                  <c:v>3.88375</c:v>
                </c:pt>
                <c:pt idx="1722">
                  <c:v>3.64671</c:v>
                </c:pt>
                <c:pt idx="1723">
                  <c:v>4.98149</c:v>
                </c:pt>
                <c:pt idx="1724">
                  <c:v>5.323929999999986</c:v>
                </c:pt>
                <c:pt idx="1725">
                  <c:v>5.555909999999995</c:v>
                </c:pt>
                <c:pt idx="1726">
                  <c:v>3.5901</c:v>
                </c:pt>
                <c:pt idx="1727">
                  <c:v>2.79936</c:v>
                </c:pt>
                <c:pt idx="1728">
                  <c:v>3.328209999999999</c:v>
                </c:pt>
                <c:pt idx="1729">
                  <c:v>3.886969999999998</c:v>
                </c:pt>
                <c:pt idx="1730">
                  <c:v>4.71361</c:v>
                </c:pt>
                <c:pt idx="1731">
                  <c:v>3.525659999999998</c:v>
                </c:pt>
                <c:pt idx="1732">
                  <c:v>4.7532</c:v>
                </c:pt>
                <c:pt idx="1733">
                  <c:v>2.84262</c:v>
                </c:pt>
                <c:pt idx="1734">
                  <c:v>3.46491</c:v>
                </c:pt>
                <c:pt idx="1735">
                  <c:v>7.55301</c:v>
                </c:pt>
                <c:pt idx="1736">
                  <c:v>5.49699</c:v>
                </c:pt>
                <c:pt idx="1737">
                  <c:v>6.52063</c:v>
                </c:pt>
                <c:pt idx="1738">
                  <c:v>2.841699999999999</c:v>
                </c:pt>
                <c:pt idx="1739">
                  <c:v>4.79048</c:v>
                </c:pt>
                <c:pt idx="1740">
                  <c:v>3.29921</c:v>
                </c:pt>
                <c:pt idx="1741">
                  <c:v>4.883909999999997</c:v>
                </c:pt>
                <c:pt idx="1742">
                  <c:v>3.44465</c:v>
                </c:pt>
                <c:pt idx="1743">
                  <c:v>2.59822</c:v>
                </c:pt>
                <c:pt idx="1744">
                  <c:v>5.09104</c:v>
                </c:pt>
                <c:pt idx="1745">
                  <c:v>2.812239999999996</c:v>
                </c:pt>
                <c:pt idx="1746">
                  <c:v>4.27268</c:v>
                </c:pt>
                <c:pt idx="1747">
                  <c:v>3.05711</c:v>
                </c:pt>
                <c:pt idx="1748">
                  <c:v>4.22021</c:v>
                </c:pt>
                <c:pt idx="1749">
                  <c:v>3.54177</c:v>
                </c:pt>
                <c:pt idx="1750">
                  <c:v>5.257189999999984</c:v>
                </c:pt>
                <c:pt idx="1751">
                  <c:v>12.1456</c:v>
                </c:pt>
                <c:pt idx="1752">
                  <c:v>7.39928</c:v>
                </c:pt>
                <c:pt idx="1753">
                  <c:v>6.90311</c:v>
                </c:pt>
                <c:pt idx="1754">
                  <c:v>7.42736</c:v>
                </c:pt>
                <c:pt idx="1755">
                  <c:v>5.675119999999985</c:v>
                </c:pt>
                <c:pt idx="1756">
                  <c:v>5.87902</c:v>
                </c:pt>
                <c:pt idx="1757">
                  <c:v>4.95756</c:v>
                </c:pt>
                <c:pt idx="1758">
                  <c:v>4.38913</c:v>
                </c:pt>
                <c:pt idx="1759">
                  <c:v>4.06325</c:v>
                </c:pt>
                <c:pt idx="1760">
                  <c:v>3.610809999999998</c:v>
                </c:pt>
                <c:pt idx="1761">
                  <c:v>2.68613</c:v>
                </c:pt>
                <c:pt idx="1762">
                  <c:v>4.563109999999996</c:v>
                </c:pt>
                <c:pt idx="1763">
                  <c:v>4.28188</c:v>
                </c:pt>
                <c:pt idx="1764">
                  <c:v>3.32038</c:v>
                </c:pt>
                <c:pt idx="1765">
                  <c:v>5.32025</c:v>
                </c:pt>
                <c:pt idx="1766">
                  <c:v>5.507119999999984</c:v>
                </c:pt>
                <c:pt idx="1767">
                  <c:v>7.322419999999965</c:v>
                </c:pt>
                <c:pt idx="1768">
                  <c:v>3.48654</c:v>
                </c:pt>
                <c:pt idx="1769">
                  <c:v>5.72529</c:v>
                </c:pt>
                <c:pt idx="1770">
                  <c:v>4.20272</c:v>
                </c:pt>
                <c:pt idx="1771">
                  <c:v>7.48029</c:v>
                </c:pt>
                <c:pt idx="1772">
                  <c:v>3.27896</c:v>
                </c:pt>
                <c:pt idx="1773">
                  <c:v>4.3477</c:v>
                </c:pt>
                <c:pt idx="1774">
                  <c:v>3.71437</c:v>
                </c:pt>
                <c:pt idx="1775">
                  <c:v>3.78479</c:v>
                </c:pt>
                <c:pt idx="1776">
                  <c:v>3.78479</c:v>
                </c:pt>
                <c:pt idx="1777">
                  <c:v>3.42578</c:v>
                </c:pt>
                <c:pt idx="1778">
                  <c:v>3.92655</c:v>
                </c:pt>
                <c:pt idx="1779">
                  <c:v>4.54884</c:v>
                </c:pt>
                <c:pt idx="1780">
                  <c:v>2.73998</c:v>
                </c:pt>
                <c:pt idx="1781">
                  <c:v>5.104379999999995</c:v>
                </c:pt>
                <c:pt idx="1782">
                  <c:v>3.94819</c:v>
                </c:pt>
                <c:pt idx="1783">
                  <c:v>4.94329</c:v>
                </c:pt>
                <c:pt idx="1784">
                  <c:v>5.46477</c:v>
                </c:pt>
                <c:pt idx="1785">
                  <c:v>2.21804</c:v>
                </c:pt>
                <c:pt idx="1786">
                  <c:v>3.08841</c:v>
                </c:pt>
                <c:pt idx="1787">
                  <c:v>5.644279999999997</c:v>
                </c:pt>
                <c:pt idx="1788">
                  <c:v>4.274979999999998</c:v>
                </c:pt>
                <c:pt idx="1789">
                  <c:v>3.612649999999952</c:v>
                </c:pt>
                <c:pt idx="1790">
                  <c:v>4.562189999999974</c:v>
                </c:pt>
                <c:pt idx="1791">
                  <c:v>4.13644</c:v>
                </c:pt>
                <c:pt idx="1792">
                  <c:v>3.42716</c:v>
                </c:pt>
                <c:pt idx="1793">
                  <c:v>3.25318</c:v>
                </c:pt>
                <c:pt idx="1794">
                  <c:v>9.096300000000001</c:v>
                </c:pt>
                <c:pt idx="1795">
                  <c:v>6.05714</c:v>
                </c:pt>
                <c:pt idx="1796">
                  <c:v>4.495909999999998</c:v>
                </c:pt>
                <c:pt idx="1797">
                  <c:v>6.758129999999999</c:v>
                </c:pt>
                <c:pt idx="1798">
                  <c:v>4.814869999999995</c:v>
                </c:pt>
                <c:pt idx="1799">
                  <c:v>8.67699</c:v>
                </c:pt>
                <c:pt idx="1800">
                  <c:v>3.33971</c:v>
                </c:pt>
                <c:pt idx="1801">
                  <c:v>4.18845</c:v>
                </c:pt>
                <c:pt idx="1802">
                  <c:v>7.603179999999996</c:v>
                </c:pt>
                <c:pt idx="1803">
                  <c:v>3.79308</c:v>
                </c:pt>
                <c:pt idx="1804">
                  <c:v>3.172169999999999</c:v>
                </c:pt>
                <c:pt idx="1805">
                  <c:v>6.324099999999976</c:v>
                </c:pt>
                <c:pt idx="1806">
                  <c:v>2.19456</c:v>
                </c:pt>
                <c:pt idx="1807">
                  <c:v>7.09919</c:v>
                </c:pt>
                <c:pt idx="1808">
                  <c:v>7.05869</c:v>
                </c:pt>
                <c:pt idx="1809">
                  <c:v>5.96463</c:v>
                </c:pt>
                <c:pt idx="1810">
                  <c:v>3.001409999999999</c:v>
                </c:pt>
                <c:pt idx="1811">
                  <c:v>6.3715</c:v>
                </c:pt>
                <c:pt idx="1812">
                  <c:v>4.43745</c:v>
                </c:pt>
                <c:pt idx="1813">
                  <c:v>3.43223</c:v>
                </c:pt>
                <c:pt idx="1814">
                  <c:v>4.508579999999998</c:v>
                </c:pt>
                <c:pt idx="1815">
                  <c:v>3.95095</c:v>
                </c:pt>
                <c:pt idx="1816">
                  <c:v>3.42808</c:v>
                </c:pt>
                <c:pt idx="1817">
                  <c:v>1.83233</c:v>
                </c:pt>
                <c:pt idx="1818">
                  <c:v>2.15544</c:v>
                </c:pt>
                <c:pt idx="1819">
                  <c:v>2.44265</c:v>
                </c:pt>
                <c:pt idx="1820">
                  <c:v>1.76467</c:v>
                </c:pt>
                <c:pt idx="1821">
                  <c:v>2.20929</c:v>
                </c:pt>
                <c:pt idx="1822">
                  <c:v>2.331259999999952</c:v>
                </c:pt>
                <c:pt idx="1823">
                  <c:v>2.022879999999998</c:v>
                </c:pt>
                <c:pt idx="1824">
                  <c:v>2.32574</c:v>
                </c:pt>
                <c:pt idx="1825">
                  <c:v>1.87237</c:v>
                </c:pt>
                <c:pt idx="1826">
                  <c:v>1.41257</c:v>
                </c:pt>
                <c:pt idx="1827">
                  <c:v>4.24506</c:v>
                </c:pt>
                <c:pt idx="1828">
                  <c:v>4.01032</c:v>
                </c:pt>
                <c:pt idx="1829">
                  <c:v>1.71036</c:v>
                </c:pt>
                <c:pt idx="1830">
                  <c:v>2.51261</c:v>
                </c:pt>
                <c:pt idx="1831">
                  <c:v>3.115559999999999</c:v>
                </c:pt>
                <c:pt idx="1832">
                  <c:v>3.360879999999998</c:v>
                </c:pt>
                <c:pt idx="1833">
                  <c:v>2.04451</c:v>
                </c:pt>
                <c:pt idx="1834">
                  <c:v>5.648419999999985</c:v>
                </c:pt>
                <c:pt idx="1835">
                  <c:v>1.96075</c:v>
                </c:pt>
                <c:pt idx="1836">
                  <c:v>1.93313</c:v>
                </c:pt>
                <c:pt idx="1837">
                  <c:v>2.17431</c:v>
                </c:pt>
                <c:pt idx="1838">
                  <c:v>3.019359999999998</c:v>
                </c:pt>
                <c:pt idx="1839">
                  <c:v>2.19364</c:v>
                </c:pt>
                <c:pt idx="1840">
                  <c:v>3.75395</c:v>
                </c:pt>
                <c:pt idx="1841">
                  <c:v>2.03439</c:v>
                </c:pt>
                <c:pt idx="1842">
                  <c:v>3.232009999999998</c:v>
                </c:pt>
                <c:pt idx="1843">
                  <c:v>2.118619999999999</c:v>
                </c:pt>
                <c:pt idx="1844">
                  <c:v>1.55709</c:v>
                </c:pt>
                <c:pt idx="1845">
                  <c:v>1.82174</c:v>
                </c:pt>
                <c:pt idx="1846">
                  <c:v>2.756089999999999</c:v>
                </c:pt>
                <c:pt idx="1847">
                  <c:v>1.10326</c:v>
                </c:pt>
                <c:pt idx="1848">
                  <c:v>0.989578</c:v>
                </c:pt>
                <c:pt idx="1849">
                  <c:v>1.28047</c:v>
                </c:pt>
                <c:pt idx="1850">
                  <c:v>1.79781</c:v>
                </c:pt>
                <c:pt idx="1851">
                  <c:v>2.537459999999998</c:v>
                </c:pt>
                <c:pt idx="1852">
                  <c:v>3.85015</c:v>
                </c:pt>
                <c:pt idx="1853">
                  <c:v>1.96121</c:v>
                </c:pt>
                <c:pt idx="1854">
                  <c:v>1.40612</c:v>
                </c:pt>
                <c:pt idx="1855">
                  <c:v>3.66328</c:v>
                </c:pt>
                <c:pt idx="1856">
                  <c:v>2.17063</c:v>
                </c:pt>
                <c:pt idx="1857">
                  <c:v>1.0982</c:v>
                </c:pt>
                <c:pt idx="1858">
                  <c:v>3.352599999999998</c:v>
                </c:pt>
                <c:pt idx="1859">
                  <c:v>2.02702</c:v>
                </c:pt>
                <c:pt idx="1860">
                  <c:v>2.37407</c:v>
                </c:pt>
                <c:pt idx="1861">
                  <c:v>2.23461</c:v>
                </c:pt>
                <c:pt idx="1862">
                  <c:v>2.073049999999998</c:v>
                </c:pt>
                <c:pt idx="1863">
                  <c:v>2.291679999999999</c:v>
                </c:pt>
                <c:pt idx="1864">
                  <c:v>4.78312</c:v>
                </c:pt>
                <c:pt idx="1865">
                  <c:v>1.36056</c:v>
                </c:pt>
                <c:pt idx="1866">
                  <c:v>2.359339999999999</c:v>
                </c:pt>
                <c:pt idx="1867">
                  <c:v>1.50646</c:v>
                </c:pt>
                <c:pt idx="1868">
                  <c:v>1.76605</c:v>
                </c:pt>
                <c:pt idx="1869">
                  <c:v>1.56952</c:v>
                </c:pt>
                <c:pt idx="1870">
                  <c:v>2.38696</c:v>
                </c:pt>
                <c:pt idx="1871">
                  <c:v>1.27817</c:v>
                </c:pt>
                <c:pt idx="1872">
                  <c:v>1.54052</c:v>
                </c:pt>
                <c:pt idx="1873">
                  <c:v>1.43006</c:v>
                </c:pt>
                <c:pt idx="1874">
                  <c:v>2.22126</c:v>
                </c:pt>
                <c:pt idx="1875">
                  <c:v>2.478089999999999</c:v>
                </c:pt>
                <c:pt idx="1876">
                  <c:v>2.55771</c:v>
                </c:pt>
                <c:pt idx="1877">
                  <c:v>3.034549999999999</c:v>
                </c:pt>
                <c:pt idx="1878">
                  <c:v>2.28754</c:v>
                </c:pt>
                <c:pt idx="1879">
                  <c:v>2.381429999999999</c:v>
                </c:pt>
                <c:pt idx="1880">
                  <c:v>3.551899999999998</c:v>
                </c:pt>
                <c:pt idx="1881">
                  <c:v>4.49545</c:v>
                </c:pt>
                <c:pt idx="1882">
                  <c:v>5.984879999999999</c:v>
                </c:pt>
                <c:pt idx="1883">
                  <c:v>2.488669999999999</c:v>
                </c:pt>
                <c:pt idx="1884">
                  <c:v>2.92869</c:v>
                </c:pt>
                <c:pt idx="1885">
                  <c:v>1.38311</c:v>
                </c:pt>
                <c:pt idx="1886">
                  <c:v>1.5686</c:v>
                </c:pt>
                <c:pt idx="1887">
                  <c:v>1.17</c:v>
                </c:pt>
                <c:pt idx="1888">
                  <c:v>1.73015</c:v>
                </c:pt>
                <c:pt idx="1889">
                  <c:v>1.83601</c:v>
                </c:pt>
                <c:pt idx="1890">
                  <c:v>1.19118</c:v>
                </c:pt>
                <c:pt idx="1891">
                  <c:v>1.72693</c:v>
                </c:pt>
                <c:pt idx="1892">
                  <c:v>1.71818</c:v>
                </c:pt>
                <c:pt idx="1893">
                  <c:v>1.92669</c:v>
                </c:pt>
                <c:pt idx="1894">
                  <c:v>1.29013</c:v>
                </c:pt>
                <c:pt idx="1895">
                  <c:v>2.14762</c:v>
                </c:pt>
                <c:pt idx="1896">
                  <c:v>2.116779999999999</c:v>
                </c:pt>
                <c:pt idx="1897">
                  <c:v>2.23783</c:v>
                </c:pt>
                <c:pt idx="1898">
                  <c:v>1.27034</c:v>
                </c:pt>
                <c:pt idx="1899">
                  <c:v>1.62797</c:v>
                </c:pt>
                <c:pt idx="1900">
                  <c:v>1.6717</c:v>
                </c:pt>
                <c:pt idx="1901">
                  <c:v>2.00723</c:v>
                </c:pt>
                <c:pt idx="1902">
                  <c:v>2.7653</c:v>
                </c:pt>
                <c:pt idx="1903">
                  <c:v>3.56985</c:v>
                </c:pt>
                <c:pt idx="1904">
                  <c:v>1.66479</c:v>
                </c:pt>
                <c:pt idx="1905">
                  <c:v>2.82283</c:v>
                </c:pt>
                <c:pt idx="1906">
                  <c:v>3.29</c:v>
                </c:pt>
                <c:pt idx="1907">
                  <c:v>2.49742</c:v>
                </c:pt>
                <c:pt idx="1908">
                  <c:v>1.93635</c:v>
                </c:pt>
                <c:pt idx="1909">
                  <c:v>3.07782</c:v>
                </c:pt>
                <c:pt idx="1910">
                  <c:v>5.7414</c:v>
                </c:pt>
                <c:pt idx="1911">
                  <c:v>3.52382</c:v>
                </c:pt>
                <c:pt idx="1912">
                  <c:v>4.9594</c:v>
                </c:pt>
                <c:pt idx="1913">
                  <c:v>4.795079999999999</c:v>
                </c:pt>
                <c:pt idx="1914">
                  <c:v>2.74827</c:v>
                </c:pt>
                <c:pt idx="1915">
                  <c:v>3.05711</c:v>
                </c:pt>
                <c:pt idx="1916">
                  <c:v>2.93468</c:v>
                </c:pt>
                <c:pt idx="1917">
                  <c:v>4.870109999999999</c:v>
                </c:pt>
                <c:pt idx="1918">
                  <c:v>2.379589999999998</c:v>
                </c:pt>
                <c:pt idx="1919">
                  <c:v>4.54239</c:v>
                </c:pt>
                <c:pt idx="1920">
                  <c:v>3.51093</c:v>
                </c:pt>
                <c:pt idx="1921">
                  <c:v>5.14074</c:v>
                </c:pt>
                <c:pt idx="1922">
                  <c:v>5.07078</c:v>
                </c:pt>
                <c:pt idx="1923">
                  <c:v>4.16866</c:v>
                </c:pt>
                <c:pt idx="1924">
                  <c:v>3.511849999999956</c:v>
                </c:pt>
                <c:pt idx="1925">
                  <c:v>2.25118</c:v>
                </c:pt>
                <c:pt idx="1926">
                  <c:v>3.90492</c:v>
                </c:pt>
                <c:pt idx="1927">
                  <c:v>2.616629999999997</c:v>
                </c:pt>
                <c:pt idx="1928">
                  <c:v>2.52319</c:v>
                </c:pt>
                <c:pt idx="1929">
                  <c:v>3.60759</c:v>
                </c:pt>
                <c:pt idx="1930">
                  <c:v>4.73064</c:v>
                </c:pt>
                <c:pt idx="1931">
                  <c:v>3.55742</c:v>
                </c:pt>
                <c:pt idx="1932">
                  <c:v>2.72663</c:v>
                </c:pt>
                <c:pt idx="1933">
                  <c:v>4.03748</c:v>
                </c:pt>
                <c:pt idx="1934">
                  <c:v>4.00664</c:v>
                </c:pt>
                <c:pt idx="1935">
                  <c:v>4.91521</c:v>
                </c:pt>
                <c:pt idx="1936">
                  <c:v>6.173589999999995</c:v>
                </c:pt>
                <c:pt idx="1937">
                  <c:v>3.378369999999998</c:v>
                </c:pt>
                <c:pt idx="1938">
                  <c:v>1.39139</c:v>
                </c:pt>
                <c:pt idx="1939">
                  <c:v>4.4126</c:v>
                </c:pt>
                <c:pt idx="1940">
                  <c:v>3.61173</c:v>
                </c:pt>
                <c:pt idx="1941">
                  <c:v>3.28678</c:v>
                </c:pt>
                <c:pt idx="1942">
                  <c:v>2.96183</c:v>
                </c:pt>
                <c:pt idx="1943">
                  <c:v>3.40185</c:v>
                </c:pt>
                <c:pt idx="1944">
                  <c:v>3.71069</c:v>
                </c:pt>
                <c:pt idx="1945">
                  <c:v>3.80228</c:v>
                </c:pt>
                <c:pt idx="1946">
                  <c:v>4.76563</c:v>
                </c:pt>
                <c:pt idx="1947">
                  <c:v>5.33774</c:v>
                </c:pt>
                <c:pt idx="1948">
                  <c:v>5.3092</c:v>
                </c:pt>
                <c:pt idx="1949">
                  <c:v>2.34093</c:v>
                </c:pt>
                <c:pt idx="1950">
                  <c:v>3.1533</c:v>
                </c:pt>
                <c:pt idx="1951">
                  <c:v>4.4867</c:v>
                </c:pt>
                <c:pt idx="1952">
                  <c:v>3.6886</c:v>
                </c:pt>
                <c:pt idx="1953">
                  <c:v>4.16129</c:v>
                </c:pt>
                <c:pt idx="1954">
                  <c:v>6.805079999999998</c:v>
                </c:pt>
                <c:pt idx="1955">
                  <c:v>4.344479999999995</c:v>
                </c:pt>
                <c:pt idx="1956">
                  <c:v>3.34339</c:v>
                </c:pt>
                <c:pt idx="1957">
                  <c:v>4.92764</c:v>
                </c:pt>
                <c:pt idx="1958">
                  <c:v>6.162539999999937</c:v>
                </c:pt>
                <c:pt idx="1959">
                  <c:v>4.50926</c:v>
                </c:pt>
                <c:pt idx="1960">
                  <c:v>3.20946</c:v>
                </c:pt>
                <c:pt idx="1961">
                  <c:v>6.314889999999965</c:v>
                </c:pt>
                <c:pt idx="1962">
                  <c:v>4.87379</c:v>
                </c:pt>
                <c:pt idx="1963">
                  <c:v>3.57629</c:v>
                </c:pt>
                <c:pt idx="1964">
                  <c:v>5.27146</c:v>
                </c:pt>
                <c:pt idx="1965">
                  <c:v>3.941279999999999</c:v>
                </c:pt>
                <c:pt idx="1966">
                  <c:v>5.76625</c:v>
                </c:pt>
                <c:pt idx="1967">
                  <c:v>2.01874</c:v>
                </c:pt>
                <c:pt idx="1968">
                  <c:v>3.08979</c:v>
                </c:pt>
                <c:pt idx="1969">
                  <c:v>2.69211</c:v>
                </c:pt>
                <c:pt idx="1970">
                  <c:v>2.324819999999999</c:v>
                </c:pt>
                <c:pt idx="1971">
                  <c:v>5.316109999999997</c:v>
                </c:pt>
                <c:pt idx="1972">
                  <c:v>3.72312</c:v>
                </c:pt>
                <c:pt idx="1973">
                  <c:v>2.57981</c:v>
                </c:pt>
                <c:pt idx="1974">
                  <c:v>4.03242</c:v>
                </c:pt>
                <c:pt idx="1975">
                  <c:v>3.52152</c:v>
                </c:pt>
                <c:pt idx="1976">
                  <c:v>4.20548</c:v>
                </c:pt>
                <c:pt idx="1977">
                  <c:v>6.724529999999985</c:v>
                </c:pt>
                <c:pt idx="1978">
                  <c:v>6.93395</c:v>
                </c:pt>
                <c:pt idx="1979">
                  <c:v>5.010489999999995</c:v>
                </c:pt>
                <c:pt idx="1980">
                  <c:v>4.113879999999996</c:v>
                </c:pt>
                <c:pt idx="1981">
                  <c:v>4.26347</c:v>
                </c:pt>
                <c:pt idx="1982">
                  <c:v>4.024129999999984</c:v>
                </c:pt>
                <c:pt idx="1983">
                  <c:v>7.58661</c:v>
                </c:pt>
                <c:pt idx="1984">
                  <c:v>7.728839999999995</c:v>
                </c:pt>
                <c:pt idx="1985">
                  <c:v>4.263009999999999</c:v>
                </c:pt>
                <c:pt idx="1986">
                  <c:v>8.40451</c:v>
                </c:pt>
                <c:pt idx="1987">
                  <c:v>9.177300000000001</c:v>
                </c:pt>
                <c:pt idx="1988">
                  <c:v>8.323500000000002</c:v>
                </c:pt>
                <c:pt idx="1989">
                  <c:v>5.820559999999975</c:v>
                </c:pt>
                <c:pt idx="1990">
                  <c:v>3.75119</c:v>
                </c:pt>
                <c:pt idx="1991">
                  <c:v>5.502519999999985</c:v>
                </c:pt>
                <c:pt idx="1992">
                  <c:v>5.00312</c:v>
                </c:pt>
                <c:pt idx="1993">
                  <c:v>4.74307</c:v>
                </c:pt>
                <c:pt idx="1994">
                  <c:v>5.43163</c:v>
                </c:pt>
                <c:pt idx="1995">
                  <c:v>5.097939999999975</c:v>
                </c:pt>
                <c:pt idx="1996">
                  <c:v>4.188909999999995</c:v>
                </c:pt>
                <c:pt idx="1997">
                  <c:v>3.52428</c:v>
                </c:pt>
                <c:pt idx="1998">
                  <c:v>5.17112</c:v>
                </c:pt>
                <c:pt idx="1999">
                  <c:v>4.465529999999998</c:v>
                </c:pt>
                <c:pt idx="2000">
                  <c:v>4.24644</c:v>
                </c:pt>
                <c:pt idx="2001">
                  <c:v>3.711609999999998</c:v>
                </c:pt>
                <c:pt idx="2002">
                  <c:v>4.654699999999996</c:v>
                </c:pt>
                <c:pt idx="2003">
                  <c:v>5.104379999999995</c:v>
                </c:pt>
                <c:pt idx="2004">
                  <c:v>4.811189999999994</c:v>
                </c:pt>
                <c:pt idx="2005">
                  <c:v>4.73893</c:v>
                </c:pt>
                <c:pt idx="2006">
                  <c:v>5.885919999999984</c:v>
                </c:pt>
                <c:pt idx="2007">
                  <c:v>5.40816</c:v>
                </c:pt>
                <c:pt idx="2008">
                  <c:v>3.14502</c:v>
                </c:pt>
                <c:pt idx="2009">
                  <c:v>5.252129999999998</c:v>
                </c:pt>
                <c:pt idx="2010">
                  <c:v>4.30766</c:v>
                </c:pt>
                <c:pt idx="2011">
                  <c:v>4.74445</c:v>
                </c:pt>
                <c:pt idx="2012">
                  <c:v>5.09196</c:v>
                </c:pt>
                <c:pt idx="2013">
                  <c:v>6.45297</c:v>
                </c:pt>
                <c:pt idx="2014">
                  <c:v>7.84529</c:v>
                </c:pt>
                <c:pt idx="2015">
                  <c:v>5.15639</c:v>
                </c:pt>
                <c:pt idx="2016">
                  <c:v>4.54147</c:v>
                </c:pt>
                <c:pt idx="2017">
                  <c:v>4.70349</c:v>
                </c:pt>
                <c:pt idx="2018">
                  <c:v>5.212089999999995</c:v>
                </c:pt>
                <c:pt idx="2019">
                  <c:v>4.14564</c:v>
                </c:pt>
                <c:pt idx="2020">
                  <c:v>4.75642</c:v>
                </c:pt>
                <c:pt idx="2021">
                  <c:v>4.245979999999999</c:v>
                </c:pt>
                <c:pt idx="2022">
                  <c:v>4.2018</c:v>
                </c:pt>
                <c:pt idx="2023">
                  <c:v>5.81637</c:v>
                </c:pt>
                <c:pt idx="2024">
                  <c:v>6.342969999999998</c:v>
                </c:pt>
                <c:pt idx="2025">
                  <c:v>4.25565</c:v>
                </c:pt>
                <c:pt idx="2026">
                  <c:v>5.119109999999996</c:v>
                </c:pt>
                <c:pt idx="2027">
                  <c:v>2.27787</c:v>
                </c:pt>
                <c:pt idx="2028">
                  <c:v>4.697509999999966</c:v>
                </c:pt>
                <c:pt idx="2029">
                  <c:v>6.24677</c:v>
                </c:pt>
                <c:pt idx="2030">
                  <c:v>3.993749999999999</c:v>
                </c:pt>
                <c:pt idx="2031">
                  <c:v>4.58382</c:v>
                </c:pt>
                <c:pt idx="2032">
                  <c:v>6.028139999999985</c:v>
                </c:pt>
                <c:pt idx="2033">
                  <c:v>3.35352</c:v>
                </c:pt>
                <c:pt idx="2034">
                  <c:v>5.629549999999996</c:v>
                </c:pt>
                <c:pt idx="2035">
                  <c:v>3.98225</c:v>
                </c:pt>
                <c:pt idx="2036">
                  <c:v>2.78647</c:v>
                </c:pt>
                <c:pt idx="2037">
                  <c:v>3.38022</c:v>
                </c:pt>
                <c:pt idx="2038">
                  <c:v>4.517079999999996</c:v>
                </c:pt>
                <c:pt idx="2039">
                  <c:v>5.653479999999996</c:v>
                </c:pt>
                <c:pt idx="2040">
                  <c:v>6.227899999999996</c:v>
                </c:pt>
                <c:pt idx="2041">
                  <c:v>6.187859999999985</c:v>
                </c:pt>
                <c:pt idx="2042">
                  <c:v>5.594569999999996</c:v>
                </c:pt>
                <c:pt idx="2043">
                  <c:v>7.30953</c:v>
                </c:pt>
                <c:pt idx="2044">
                  <c:v>4.70809</c:v>
                </c:pt>
                <c:pt idx="2045">
                  <c:v>3.8276</c:v>
                </c:pt>
                <c:pt idx="2046">
                  <c:v>4.35322</c:v>
                </c:pt>
                <c:pt idx="2047">
                  <c:v>7.04396</c:v>
                </c:pt>
                <c:pt idx="2048">
                  <c:v>2.116779999999999</c:v>
                </c:pt>
                <c:pt idx="2049">
                  <c:v>4.53917</c:v>
                </c:pt>
                <c:pt idx="2050">
                  <c:v>2.833419999999998</c:v>
                </c:pt>
                <c:pt idx="2051">
                  <c:v>4.87103</c:v>
                </c:pt>
                <c:pt idx="2052">
                  <c:v>7.45636</c:v>
                </c:pt>
                <c:pt idx="2053">
                  <c:v>4.08074</c:v>
                </c:pt>
                <c:pt idx="2054">
                  <c:v>3.1464</c:v>
                </c:pt>
                <c:pt idx="2055">
                  <c:v>4.46231</c:v>
                </c:pt>
                <c:pt idx="2056">
                  <c:v>3.66098</c:v>
                </c:pt>
                <c:pt idx="2057">
                  <c:v>4.1415</c:v>
                </c:pt>
                <c:pt idx="2058">
                  <c:v>3.3839</c:v>
                </c:pt>
                <c:pt idx="2059">
                  <c:v>4.25335</c:v>
                </c:pt>
                <c:pt idx="2060">
                  <c:v>5.014169999999996</c:v>
                </c:pt>
                <c:pt idx="2061">
                  <c:v>4.52168</c:v>
                </c:pt>
                <c:pt idx="2062">
                  <c:v>5.5826</c:v>
                </c:pt>
                <c:pt idx="2063">
                  <c:v>2.62537</c:v>
                </c:pt>
                <c:pt idx="2064">
                  <c:v>3.58964</c:v>
                </c:pt>
                <c:pt idx="2065">
                  <c:v>4.73249</c:v>
                </c:pt>
                <c:pt idx="2066">
                  <c:v>5.71562</c:v>
                </c:pt>
                <c:pt idx="2067">
                  <c:v>4.52536</c:v>
                </c:pt>
                <c:pt idx="2068">
                  <c:v>4.3431</c:v>
                </c:pt>
                <c:pt idx="2069">
                  <c:v>3.73554</c:v>
                </c:pt>
                <c:pt idx="2070">
                  <c:v>4.90785</c:v>
                </c:pt>
                <c:pt idx="2071">
                  <c:v>7.13371</c:v>
                </c:pt>
                <c:pt idx="2072">
                  <c:v>3.38344</c:v>
                </c:pt>
                <c:pt idx="2073">
                  <c:v>2.64931</c:v>
                </c:pt>
                <c:pt idx="2074">
                  <c:v>2.2659</c:v>
                </c:pt>
                <c:pt idx="2075">
                  <c:v>3.90768</c:v>
                </c:pt>
                <c:pt idx="2076">
                  <c:v>2.519969999999998</c:v>
                </c:pt>
                <c:pt idx="2077">
                  <c:v>2.557249999999998</c:v>
                </c:pt>
                <c:pt idx="2078">
                  <c:v>5.51126</c:v>
                </c:pt>
                <c:pt idx="2079">
                  <c:v>3.27113</c:v>
                </c:pt>
                <c:pt idx="2080">
                  <c:v>3.459379999999999</c:v>
                </c:pt>
                <c:pt idx="2081">
                  <c:v>3.586879999999998</c:v>
                </c:pt>
                <c:pt idx="2082">
                  <c:v>3.04744</c:v>
                </c:pt>
                <c:pt idx="2083">
                  <c:v>3.50771</c:v>
                </c:pt>
                <c:pt idx="2084">
                  <c:v>3.39448</c:v>
                </c:pt>
                <c:pt idx="2085">
                  <c:v>3.51323</c:v>
                </c:pt>
                <c:pt idx="2086">
                  <c:v>3.88099</c:v>
                </c:pt>
                <c:pt idx="2087">
                  <c:v>4.01078</c:v>
                </c:pt>
                <c:pt idx="2088">
                  <c:v>5.20564</c:v>
                </c:pt>
                <c:pt idx="2089">
                  <c:v>2.58671</c:v>
                </c:pt>
                <c:pt idx="2090">
                  <c:v>2.884049999999997</c:v>
                </c:pt>
                <c:pt idx="2091">
                  <c:v>4.882989999999975</c:v>
                </c:pt>
                <c:pt idx="2092">
                  <c:v>2.309629999999998</c:v>
                </c:pt>
                <c:pt idx="2093">
                  <c:v>3.19979</c:v>
                </c:pt>
                <c:pt idx="2094">
                  <c:v>4.13874</c:v>
                </c:pt>
                <c:pt idx="2095">
                  <c:v>2.24013</c:v>
                </c:pt>
                <c:pt idx="2096">
                  <c:v>1.60542</c:v>
                </c:pt>
                <c:pt idx="2097">
                  <c:v>3.16481</c:v>
                </c:pt>
                <c:pt idx="2098">
                  <c:v>2.13473</c:v>
                </c:pt>
                <c:pt idx="2099">
                  <c:v>2.27051</c:v>
                </c:pt>
                <c:pt idx="2100">
                  <c:v>2.77772</c:v>
                </c:pt>
                <c:pt idx="2101">
                  <c:v>4.106519999999994</c:v>
                </c:pt>
                <c:pt idx="2102">
                  <c:v>2.40721</c:v>
                </c:pt>
                <c:pt idx="2103">
                  <c:v>3.1464</c:v>
                </c:pt>
                <c:pt idx="2104">
                  <c:v>1.96673</c:v>
                </c:pt>
                <c:pt idx="2105">
                  <c:v>4.55942</c:v>
                </c:pt>
                <c:pt idx="2106">
                  <c:v>4.1484</c:v>
                </c:pt>
                <c:pt idx="2107">
                  <c:v>5.623569999999995</c:v>
                </c:pt>
                <c:pt idx="2108">
                  <c:v>2.67002</c:v>
                </c:pt>
                <c:pt idx="2109">
                  <c:v>3.44097</c:v>
                </c:pt>
                <c:pt idx="2110">
                  <c:v>2.20009</c:v>
                </c:pt>
                <c:pt idx="2111">
                  <c:v>3.13673</c:v>
                </c:pt>
                <c:pt idx="2112">
                  <c:v>4.14564</c:v>
                </c:pt>
                <c:pt idx="2113">
                  <c:v>4.43331</c:v>
                </c:pt>
                <c:pt idx="2114">
                  <c:v>3.586419999999999</c:v>
                </c:pt>
                <c:pt idx="2115">
                  <c:v>3.06447</c:v>
                </c:pt>
                <c:pt idx="2116">
                  <c:v>2.857349999999998</c:v>
                </c:pt>
                <c:pt idx="2117">
                  <c:v>3.359039999999998</c:v>
                </c:pt>
                <c:pt idx="2118">
                  <c:v>3.429</c:v>
                </c:pt>
                <c:pt idx="2119">
                  <c:v>3.501269999999999</c:v>
                </c:pt>
                <c:pt idx="2120">
                  <c:v>2.71421</c:v>
                </c:pt>
                <c:pt idx="2121">
                  <c:v>3.48332</c:v>
                </c:pt>
                <c:pt idx="2122">
                  <c:v>3.3236</c:v>
                </c:pt>
                <c:pt idx="2123">
                  <c:v>3.06171</c:v>
                </c:pt>
                <c:pt idx="2124">
                  <c:v>2.22402</c:v>
                </c:pt>
                <c:pt idx="2125">
                  <c:v>3.09301</c:v>
                </c:pt>
                <c:pt idx="2126">
                  <c:v>1.535</c:v>
                </c:pt>
                <c:pt idx="2127">
                  <c:v>3.1441</c:v>
                </c:pt>
                <c:pt idx="2128">
                  <c:v>2.00171</c:v>
                </c:pt>
                <c:pt idx="2129">
                  <c:v>4.25427</c:v>
                </c:pt>
                <c:pt idx="2130">
                  <c:v>1.94187</c:v>
                </c:pt>
                <c:pt idx="2131">
                  <c:v>1.8176</c:v>
                </c:pt>
                <c:pt idx="2132">
                  <c:v>1.76099</c:v>
                </c:pt>
                <c:pt idx="2133">
                  <c:v>2.39202</c:v>
                </c:pt>
                <c:pt idx="2134">
                  <c:v>3.6352</c:v>
                </c:pt>
                <c:pt idx="2135">
                  <c:v>2.44863</c:v>
                </c:pt>
                <c:pt idx="2136">
                  <c:v>1.75869</c:v>
                </c:pt>
                <c:pt idx="2137">
                  <c:v>3.00418</c:v>
                </c:pt>
                <c:pt idx="2138">
                  <c:v>2.20883</c:v>
                </c:pt>
                <c:pt idx="2139">
                  <c:v>3.025809999999999</c:v>
                </c:pt>
                <c:pt idx="2140">
                  <c:v>2.40399</c:v>
                </c:pt>
                <c:pt idx="2141">
                  <c:v>1.98606</c:v>
                </c:pt>
                <c:pt idx="2142">
                  <c:v>3.30289</c:v>
                </c:pt>
                <c:pt idx="2143">
                  <c:v>3.72726</c:v>
                </c:pt>
                <c:pt idx="2144">
                  <c:v>3.965679999999999</c:v>
                </c:pt>
                <c:pt idx="2145">
                  <c:v>1.54328</c:v>
                </c:pt>
                <c:pt idx="2146">
                  <c:v>2.33218</c:v>
                </c:pt>
                <c:pt idx="2147">
                  <c:v>2.32712</c:v>
                </c:pt>
                <c:pt idx="2148">
                  <c:v>3.42164</c:v>
                </c:pt>
                <c:pt idx="2149">
                  <c:v>3.029949999999999</c:v>
                </c:pt>
                <c:pt idx="2150">
                  <c:v>2.77818</c:v>
                </c:pt>
                <c:pt idx="2151">
                  <c:v>1.46227</c:v>
                </c:pt>
                <c:pt idx="2152">
                  <c:v>2.61479</c:v>
                </c:pt>
                <c:pt idx="2153">
                  <c:v>4.17188</c:v>
                </c:pt>
                <c:pt idx="2154">
                  <c:v>3.67801</c:v>
                </c:pt>
                <c:pt idx="2155">
                  <c:v>4.534109999999997</c:v>
                </c:pt>
                <c:pt idx="2156">
                  <c:v>2.405829999999999</c:v>
                </c:pt>
                <c:pt idx="2157">
                  <c:v>2.65483</c:v>
                </c:pt>
                <c:pt idx="2158">
                  <c:v>2.26084</c:v>
                </c:pt>
                <c:pt idx="2159">
                  <c:v>2.76161</c:v>
                </c:pt>
                <c:pt idx="2160">
                  <c:v>2.98945</c:v>
                </c:pt>
                <c:pt idx="2161">
                  <c:v>2.232759999999999</c:v>
                </c:pt>
                <c:pt idx="2162">
                  <c:v>4.2446</c:v>
                </c:pt>
                <c:pt idx="2163">
                  <c:v>3.73002</c:v>
                </c:pt>
                <c:pt idx="2164">
                  <c:v>3.00694</c:v>
                </c:pt>
                <c:pt idx="2165">
                  <c:v>2.85367</c:v>
                </c:pt>
                <c:pt idx="2166">
                  <c:v>4.147479999999986</c:v>
                </c:pt>
                <c:pt idx="2167">
                  <c:v>2.3957</c:v>
                </c:pt>
                <c:pt idx="2168">
                  <c:v>1.34629</c:v>
                </c:pt>
                <c:pt idx="2169">
                  <c:v>2.0818</c:v>
                </c:pt>
                <c:pt idx="2170">
                  <c:v>3.09669</c:v>
                </c:pt>
                <c:pt idx="2171">
                  <c:v>2.259</c:v>
                </c:pt>
                <c:pt idx="2172">
                  <c:v>1.47378</c:v>
                </c:pt>
                <c:pt idx="2173">
                  <c:v>1.99204</c:v>
                </c:pt>
                <c:pt idx="2174">
                  <c:v>1.23582</c:v>
                </c:pt>
                <c:pt idx="2175">
                  <c:v>1.88204</c:v>
                </c:pt>
                <c:pt idx="2176">
                  <c:v>1.49495</c:v>
                </c:pt>
                <c:pt idx="2177">
                  <c:v>1.99619</c:v>
                </c:pt>
                <c:pt idx="2178">
                  <c:v>1.81622</c:v>
                </c:pt>
                <c:pt idx="2179">
                  <c:v>1.07979</c:v>
                </c:pt>
                <c:pt idx="2180">
                  <c:v>1.2303</c:v>
                </c:pt>
                <c:pt idx="2181">
                  <c:v>3.95601</c:v>
                </c:pt>
                <c:pt idx="2182">
                  <c:v>3.48424</c:v>
                </c:pt>
                <c:pt idx="2183">
                  <c:v>2.34783</c:v>
                </c:pt>
                <c:pt idx="2184">
                  <c:v>3.139489999999999</c:v>
                </c:pt>
                <c:pt idx="2185">
                  <c:v>3.81793</c:v>
                </c:pt>
                <c:pt idx="2186">
                  <c:v>2.16649</c:v>
                </c:pt>
                <c:pt idx="2187">
                  <c:v>1.62061</c:v>
                </c:pt>
                <c:pt idx="2188">
                  <c:v>1.56307</c:v>
                </c:pt>
                <c:pt idx="2189">
                  <c:v>2.40352</c:v>
                </c:pt>
                <c:pt idx="2190">
                  <c:v>4.184769999999999</c:v>
                </c:pt>
                <c:pt idx="2191">
                  <c:v>2.32804</c:v>
                </c:pt>
                <c:pt idx="2192">
                  <c:v>1.6694</c:v>
                </c:pt>
                <c:pt idx="2193">
                  <c:v>1.09498</c:v>
                </c:pt>
                <c:pt idx="2194">
                  <c:v>1.65559</c:v>
                </c:pt>
                <c:pt idx="2195">
                  <c:v>2.26729</c:v>
                </c:pt>
                <c:pt idx="2196">
                  <c:v>2.40445</c:v>
                </c:pt>
                <c:pt idx="2197">
                  <c:v>2.66634</c:v>
                </c:pt>
                <c:pt idx="2198">
                  <c:v>1.70622</c:v>
                </c:pt>
                <c:pt idx="2199">
                  <c:v>2.36946</c:v>
                </c:pt>
                <c:pt idx="2200">
                  <c:v>2.22678</c:v>
                </c:pt>
                <c:pt idx="2201">
                  <c:v>2.812699999999976</c:v>
                </c:pt>
                <c:pt idx="2202">
                  <c:v>1.73153</c:v>
                </c:pt>
                <c:pt idx="2203">
                  <c:v>3.60299</c:v>
                </c:pt>
                <c:pt idx="2204">
                  <c:v>2.18536</c:v>
                </c:pt>
                <c:pt idx="2205">
                  <c:v>3.93116</c:v>
                </c:pt>
                <c:pt idx="2206">
                  <c:v>3.12569</c:v>
                </c:pt>
                <c:pt idx="2207">
                  <c:v>1.98514</c:v>
                </c:pt>
                <c:pt idx="2208">
                  <c:v>1.64684</c:v>
                </c:pt>
                <c:pt idx="2209">
                  <c:v>2.561859999999998</c:v>
                </c:pt>
                <c:pt idx="2210">
                  <c:v>1.99803</c:v>
                </c:pt>
                <c:pt idx="2211">
                  <c:v>2.488669999999999</c:v>
                </c:pt>
                <c:pt idx="2212">
                  <c:v>1.95338</c:v>
                </c:pt>
                <c:pt idx="2213">
                  <c:v>1.80932</c:v>
                </c:pt>
                <c:pt idx="2214">
                  <c:v>1.8061</c:v>
                </c:pt>
                <c:pt idx="2215">
                  <c:v>1.91426</c:v>
                </c:pt>
                <c:pt idx="2216">
                  <c:v>1.50738</c:v>
                </c:pt>
                <c:pt idx="2217">
                  <c:v>2.305489999999998</c:v>
                </c:pt>
                <c:pt idx="2218">
                  <c:v>2.430219999999998</c:v>
                </c:pt>
                <c:pt idx="2219">
                  <c:v>2.29076</c:v>
                </c:pt>
                <c:pt idx="2220">
                  <c:v>1.28001</c:v>
                </c:pt>
                <c:pt idx="2221">
                  <c:v>0.978072</c:v>
                </c:pt>
                <c:pt idx="2222">
                  <c:v>2.10527</c:v>
                </c:pt>
                <c:pt idx="2223">
                  <c:v>2.07904</c:v>
                </c:pt>
                <c:pt idx="2224">
                  <c:v>1.68182</c:v>
                </c:pt>
                <c:pt idx="2225">
                  <c:v>3.314859999999952</c:v>
                </c:pt>
                <c:pt idx="2226">
                  <c:v>2.70546</c:v>
                </c:pt>
                <c:pt idx="2227">
                  <c:v>2.41549</c:v>
                </c:pt>
                <c:pt idx="2228">
                  <c:v>2.619849999999956</c:v>
                </c:pt>
                <c:pt idx="2229">
                  <c:v>2.536999999999999</c:v>
                </c:pt>
                <c:pt idx="2230">
                  <c:v>2.47072</c:v>
                </c:pt>
                <c:pt idx="2231">
                  <c:v>1.89907</c:v>
                </c:pt>
                <c:pt idx="2232">
                  <c:v>3.01844</c:v>
                </c:pt>
                <c:pt idx="2233">
                  <c:v>2.21113</c:v>
                </c:pt>
                <c:pt idx="2234">
                  <c:v>2.61571</c:v>
                </c:pt>
                <c:pt idx="2235">
                  <c:v>1.67446</c:v>
                </c:pt>
                <c:pt idx="2236">
                  <c:v>3.64073</c:v>
                </c:pt>
                <c:pt idx="2237">
                  <c:v>3.19565</c:v>
                </c:pt>
                <c:pt idx="2238">
                  <c:v>2.19824</c:v>
                </c:pt>
                <c:pt idx="2239">
                  <c:v>3.06631</c:v>
                </c:pt>
                <c:pt idx="2240">
                  <c:v>1.88296</c:v>
                </c:pt>
                <c:pt idx="2241">
                  <c:v>2.56968</c:v>
                </c:pt>
                <c:pt idx="2242">
                  <c:v>2.618009999999999</c:v>
                </c:pt>
                <c:pt idx="2243">
                  <c:v>2.16649</c:v>
                </c:pt>
                <c:pt idx="2244">
                  <c:v>4.5447</c:v>
                </c:pt>
                <c:pt idx="2245">
                  <c:v>5.37364</c:v>
                </c:pt>
                <c:pt idx="2246">
                  <c:v>2.97242</c:v>
                </c:pt>
                <c:pt idx="2247">
                  <c:v>2.97656</c:v>
                </c:pt>
                <c:pt idx="2248">
                  <c:v>4.624779999999966</c:v>
                </c:pt>
                <c:pt idx="2249">
                  <c:v>1.71266</c:v>
                </c:pt>
                <c:pt idx="2250">
                  <c:v>1.65605</c:v>
                </c:pt>
                <c:pt idx="2251">
                  <c:v>2.96367</c:v>
                </c:pt>
                <c:pt idx="2252">
                  <c:v>2.93974</c:v>
                </c:pt>
                <c:pt idx="2253">
                  <c:v>2.30457</c:v>
                </c:pt>
                <c:pt idx="2254">
                  <c:v>3.42762</c:v>
                </c:pt>
                <c:pt idx="2255">
                  <c:v>5.40218</c:v>
                </c:pt>
                <c:pt idx="2256">
                  <c:v>3.461679999999999</c:v>
                </c:pt>
                <c:pt idx="2257">
                  <c:v>4.22067</c:v>
                </c:pt>
                <c:pt idx="2258">
                  <c:v>5.08321</c:v>
                </c:pt>
                <c:pt idx="2259">
                  <c:v>4.01953</c:v>
                </c:pt>
                <c:pt idx="2260">
                  <c:v>3.32222</c:v>
                </c:pt>
                <c:pt idx="2261">
                  <c:v>3.74797</c:v>
                </c:pt>
                <c:pt idx="2262">
                  <c:v>4.06187</c:v>
                </c:pt>
                <c:pt idx="2263">
                  <c:v>2.2254</c:v>
                </c:pt>
                <c:pt idx="2264">
                  <c:v>3.16665</c:v>
                </c:pt>
                <c:pt idx="2265">
                  <c:v>2.802579999999998</c:v>
                </c:pt>
                <c:pt idx="2266">
                  <c:v>2.462899999999999</c:v>
                </c:pt>
                <c:pt idx="2267">
                  <c:v>4.08121</c:v>
                </c:pt>
                <c:pt idx="2268">
                  <c:v>1.83831</c:v>
                </c:pt>
                <c:pt idx="2269">
                  <c:v>3.05158</c:v>
                </c:pt>
                <c:pt idx="2270">
                  <c:v>4.08397</c:v>
                </c:pt>
                <c:pt idx="2271">
                  <c:v>4.44436</c:v>
                </c:pt>
                <c:pt idx="2272">
                  <c:v>4.4821</c:v>
                </c:pt>
                <c:pt idx="2273">
                  <c:v>2.69303</c:v>
                </c:pt>
                <c:pt idx="2274">
                  <c:v>3.338789999999999</c:v>
                </c:pt>
                <c:pt idx="2275">
                  <c:v>2.880819999999999</c:v>
                </c:pt>
                <c:pt idx="2276">
                  <c:v>2.23783</c:v>
                </c:pt>
                <c:pt idx="2277">
                  <c:v>5.7796</c:v>
                </c:pt>
                <c:pt idx="2278">
                  <c:v>5.643819999999994</c:v>
                </c:pt>
                <c:pt idx="2279">
                  <c:v>4.49407</c:v>
                </c:pt>
                <c:pt idx="2280">
                  <c:v>3.876389999999998</c:v>
                </c:pt>
                <c:pt idx="2281">
                  <c:v>2.92869</c:v>
                </c:pt>
                <c:pt idx="2282">
                  <c:v>2.361639999999999</c:v>
                </c:pt>
                <c:pt idx="2283">
                  <c:v>4.43791</c:v>
                </c:pt>
                <c:pt idx="2284">
                  <c:v>3.50909</c:v>
                </c:pt>
                <c:pt idx="2285">
                  <c:v>4.802449999999999</c:v>
                </c:pt>
                <c:pt idx="2286">
                  <c:v>4.154849999999985</c:v>
                </c:pt>
                <c:pt idx="2287">
                  <c:v>4.72144</c:v>
                </c:pt>
                <c:pt idx="2288">
                  <c:v>4.88161</c:v>
                </c:pt>
                <c:pt idx="2289">
                  <c:v>3.34892</c:v>
                </c:pt>
                <c:pt idx="2290">
                  <c:v>4.27084</c:v>
                </c:pt>
                <c:pt idx="2291">
                  <c:v>4.22573</c:v>
                </c:pt>
                <c:pt idx="2292">
                  <c:v>4.663909999999975</c:v>
                </c:pt>
                <c:pt idx="2293">
                  <c:v>6.77424</c:v>
                </c:pt>
                <c:pt idx="2294">
                  <c:v>5.192289999999994</c:v>
                </c:pt>
                <c:pt idx="2295">
                  <c:v>4.21238</c:v>
                </c:pt>
                <c:pt idx="2296">
                  <c:v>3.472729999999999</c:v>
                </c:pt>
                <c:pt idx="2297">
                  <c:v>3.20439</c:v>
                </c:pt>
                <c:pt idx="2298">
                  <c:v>2.70362</c:v>
                </c:pt>
                <c:pt idx="2299">
                  <c:v>2.31101</c:v>
                </c:pt>
                <c:pt idx="2300">
                  <c:v>2.2231</c:v>
                </c:pt>
                <c:pt idx="2301">
                  <c:v>3.0051</c:v>
                </c:pt>
                <c:pt idx="2302">
                  <c:v>4.44252</c:v>
                </c:pt>
                <c:pt idx="2303">
                  <c:v>3.01982</c:v>
                </c:pt>
                <c:pt idx="2304">
                  <c:v>2.72433</c:v>
                </c:pt>
                <c:pt idx="2305">
                  <c:v>4.691979999999995</c:v>
                </c:pt>
                <c:pt idx="2306">
                  <c:v>4.44252</c:v>
                </c:pt>
                <c:pt idx="2307">
                  <c:v>2.86702</c:v>
                </c:pt>
                <c:pt idx="2308">
                  <c:v>4.4821</c:v>
                </c:pt>
                <c:pt idx="2309">
                  <c:v>4.682319999999985</c:v>
                </c:pt>
                <c:pt idx="2310">
                  <c:v>4.95342</c:v>
                </c:pt>
                <c:pt idx="2311">
                  <c:v>3.04882</c:v>
                </c:pt>
                <c:pt idx="2312">
                  <c:v>3.34339</c:v>
                </c:pt>
                <c:pt idx="2313">
                  <c:v>3.40599</c:v>
                </c:pt>
                <c:pt idx="2314">
                  <c:v>4.917969999999999</c:v>
                </c:pt>
                <c:pt idx="2315">
                  <c:v>4.16866</c:v>
                </c:pt>
                <c:pt idx="2316">
                  <c:v>5.28389</c:v>
                </c:pt>
                <c:pt idx="2317">
                  <c:v>3.26239</c:v>
                </c:pt>
                <c:pt idx="2318">
                  <c:v>3.06631</c:v>
                </c:pt>
                <c:pt idx="2319">
                  <c:v>4.05681</c:v>
                </c:pt>
                <c:pt idx="2320">
                  <c:v>3.66512</c:v>
                </c:pt>
                <c:pt idx="2321">
                  <c:v>3.77144</c:v>
                </c:pt>
                <c:pt idx="2322">
                  <c:v>4.269919999999995</c:v>
                </c:pt>
                <c:pt idx="2323">
                  <c:v>4.04346</c:v>
                </c:pt>
                <c:pt idx="2324">
                  <c:v>4.622939999999937</c:v>
                </c:pt>
                <c:pt idx="2325">
                  <c:v>2.48407</c:v>
                </c:pt>
                <c:pt idx="2326">
                  <c:v>7.168689999999994</c:v>
                </c:pt>
                <c:pt idx="2327">
                  <c:v>3.92563</c:v>
                </c:pt>
                <c:pt idx="2328">
                  <c:v>6.677119999999975</c:v>
                </c:pt>
                <c:pt idx="2329">
                  <c:v>4.1705</c:v>
                </c:pt>
                <c:pt idx="2330">
                  <c:v>4.794159999999985</c:v>
                </c:pt>
                <c:pt idx="2331">
                  <c:v>4.72972</c:v>
                </c:pt>
                <c:pt idx="2332">
                  <c:v>3.0456</c:v>
                </c:pt>
                <c:pt idx="2333">
                  <c:v>5.66867</c:v>
                </c:pt>
                <c:pt idx="2334">
                  <c:v>7.04304</c:v>
                </c:pt>
                <c:pt idx="2335">
                  <c:v>5.44406</c:v>
                </c:pt>
                <c:pt idx="2336">
                  <c:v>5.58122</c:v>
                </c:pt>
                <c:pt idx="2337">
                  <c:v>5.624949999999964</c:v>
                </c:pt>
                <c:pt idx="2338">
                  <c:v>5.40632</c:v>
                </c:pt>
                <c:pt idx="2339">
                  <c:v>4.74906</c:v>
                </c:pt>
                <c:pt idx="2340">
                  <c:v>5.617119999999937</c:v>
                </c:pt>
                <c:pt idx="2341">
                  <c:v>4.59348</c:v>
                </c:pt>
                <c:pt idx="2342">
                  <c:v>5.604699999999997</c:v>
                </c:pt>
                <c:pt idx="2343">
                  <c:v>3.35582</c:v>
                </c:pt>
                <c:pt idx="2344">
                  <c:v>3.35766</c:v>
                </c:pt>
                <c:pt idx="2345">
                  <c:v>3.95371</c:v>
                </c:pt>
                <c:pt idx="2346">
                  <c:v>2.6309</c:v>
                </c:pt>
                <c:pt idx="2347">
                  <c:v>4.60867</c:v>
                </c:pt>
                <c:pt idx="2348">
                  <c:v>2.675079999999998</c:v>
                </c:pt>
                <c:pt idx="2349">
                  <c:v>4.618339999999994</c:v>
                </c:pt>
                <c:pt idx="2350">
                  <c:v>3.77605</c:v>
                </c:pt>
                <c:pt idx="2351">
                  <c:v>5.142129999999995</c:v>
                </c:pt>
                <c:pt idx="2352">
                  <c:v>4.691519999999984</c:v>
                </c:pt>
                <c:pt idx="2353">
                  <c:v>5.01187</c:v>
                </c:pt>
                <c:pt idx="2354">
                  <c:v>4.177859999999995</c:v>
                </c:pt>
                <c:pt idx="2355">
                  <c:v>4.594869999999998</c:v>
                </c:pt>
                <c:pt idx="2356">
                  <c:v>3.28862</c:v>
                </c:pt>
                <c:pt idx="2357">
                  <c:v>6.32226</c:v>
                </c:pt>
                <c:pt idx="2358">
                  <c:v>2.225859999999999</c:v>
                </c:pt>
                <c:pt idx="2359">
                  <c:v>3.04422</c:v>
                </c:pt>
                <c:pt idx="2360">
                  <c:v>6.00467</c:v>
                </c:pt>
                <c:pt idx="2361">
                  <c:v>6.9496</c:v>
                </c:pt>
                <c:pt idx="2362">
                  <c:v>4.09087</c:v>
                </c:pt>
                <c:pt idx="2363">
                  <c:v>2.96137</c:v>
                </c:pt>
                <c:pt idx="2364">
                  <c:v>2.732159999999999</c:v>
                </c:pt>
                <c:pt idx="2365">
                  <c:v>6.20811</c:v>
                </c:pt>
                <c:pt idx="2366">
                  <c:v>3.316239999999996</c:v>
                </c:pt>
                <c:pt idx="2367">
                  <c:v>4.33389</c:v>
                </c:pt>
                <c:pt idx="2368">
                  <c:v>3.77605</c:v>
                </c:pt>
                <c:pt idx="2369">
                  <c:v>2.03255</c:v>
                </c:pt>
                <c:pt idx="2370">
                  <c:v>5.05329</c:v>
                </c:pt>
                <c:pt idx="2371">
                  <c:v>4.49867</c:v>
                </c:pt>
                <c:pt idx="2372">
                  <c:v>2.531019999999998</c:v>
                </c:pt>
                <c:pt idx="2373">
                  <c:v>4.00526</c:v>
                </c:pt>
                <c:pt idx="2374">
                  <c:v>3.001409999999999</c:v>
                </c:pt>
                <c:pt idx="2375">
                  <c:v>4.134599999999994</c:v>
                </c:pt>
                <c:pt idx="2376">
                  <c:v>2.75057</c:v>
                </c:pt>
                <c:pt idx="2377">
                  <c:v>4.73985</c:v>
                </c:pt>
                <c:pt idx="2378">
                  <c:v>2.40399</c:v>
                </c:pt>
                <c:pt idx="2379">
                  <c:v>3.55466</c:v>
                </c:pt>
                <c:pt idx="2380">
                  <c:v>6.157019999999966</c:v>
                </c:pt>
                <c:pt idx="2381">
                  <c:v>3.21544</c:v>
                </c:pt>
                <c:pt idx="2382">
                  <c:v>3.51599</c:v>
                </c:pt>
                <c:pt idx="2383">
                  <c:v>6.45803</c:v>
                </c:pt>
                <c:pt idx="2384">
                  <c:v>5.09978</c:v>
                </c:pt>
                <c:pt idx="2385">
                  <c:v>6.33008</c:v>
                </c:pt>
                <c:pt idx="2386">
                  <c:v>4.29845</c:v>
                </c:pt>
                <c:pt idx="2387">
                  <c:v>4.49223</c:v>
                </c:pt>
                <c:pt idx="2388">
                  <c:v>6.74524</c:v>
                </c:pt>
                <c:pt idx="2389">
                  <c:v>5.10346</c:v>
                </c:pt>
                <c:pt idx="2390">
                  <c:v>2.911659999999952</c:v>
                </c:pt>
                <c:pt idx="2391">
                  <c:v>2.45139</c:v>
                </c:pt>
                <c:pt idx="2392">
                  <c:v>6.45113</c:v>
                </c:pt>
                <c:pt idx="2393">
                  <c:v>4.044839999999994</c:v>
                </c:pt>
                <c:pt idx="2394">
                  <c:v>5.0915</c:v>
                </c:pt>
                <c:pt idx="2395">
                  <c:v>5.49653</c:v>
                </c:pt>
                <c:pt idx="2396">
                  <c:v>6.087979999999995</c:v>
                </c:pt>
                <c:pt idx="2397">
                  <c:v>8.1486</c:v>
                </c:pt>
                <c:pt idx="2398">
                  <c:v>5.892819999999975</c:v>
                </c:pt>
                <c:pt idx="2399">
                  <c:v>4.48532</c:v>
                </c:pt>
                <c:pt idx="2400">
                  <c:v>5.88132</c:v>
                </c:pt>
                <c:pt idx="2401">
                  <c:v>4.247819999999995</c:v>
                </c:pt>
                <c:pt idx="2402">
                  <c:v>6.028139999999985</c:v>
                </c:pt>
                <c:pt idx="2403">
                  <c:v>8.367690000000004</c:v>
                </c:pt>
                <c:pt idx="2404">
                  <c:v>5.647959999999966</c:v>
                </c:pt>
                <c:pt idx="2405">
                  <c:v>7.617449999999986</c:v>
                </c:pt>
                <c:pt idx="2406">
                  <c:v>5.055589999999984</c:v>
                </c:pt>
                <c:pt idx="2407">
                  <c:v>3.41013</c:v>
                </c:pt>
                <c:pt idx="2408">
                  <c:v>3.571689999999998</c:v>
                </c:pt>
                <c:pt idx="2409">
                  <c:v>4.684619999999985</c:v>
                </c:pt>
                <c:pt idx="2410">
                  <c:v>5.63139</c:v>
                </c:pt>
                <c:pt idx="2411">
                  <c:v>4.662989999999927</c:v>
                </c:pt>
                <c:pt idx="2412">
                  <c:v>4.42574</c:v>
                </c:pt>
                <c:pt idx="2413">
                  <c:v>1.34675</c:v>
                </c:pt>
                <c:pt idx="2414">
                  <c:v>2.16649</c:v>
                </c:pt>
                <c:pt idx="2415">
                  <c:v>1.94556</c:v>
                </c:pt>
                <c:pt idx="2416">
                  <c:v>2.24059</c:v>
                </c:pt>
                <c:pt idx="2417">
                  <c:v>2.212969999999999</c:v>
                </c:pt>
                <c:pt idx="2418">
                  <c:v>2.1582</c:v>
                </c:pt>
                <c:pt idx="2419">
                  <c:v>3.036849999999952</c:v>
                </c:pt>
                <c:pt idx="2420">
                  <c:v>1.90689</c:v>
                </c:pt>
                <c:pt idx="2421">
                  <c:v>2.23092</c:v>
                </c:pt>
                <c:pt idx="2422">
                  <c:v>3.873619999999998</c:v>
                </c:pt>
                <c:pt idx="2423">
                  <c:v>3.853829999999998</c:v>
                </c:pt>
                <c:pt idx="2424">
                  <c:v>3.873619999999998</c:v>
                </c:pt>
                <c:pt idx="2425">
                  <c:v>6.3356</c:v>
                </c:pt>
                <c:pt idx="2426">
                  <c:v>3.886509999999999</c:v>
                </c:pt>
                <c:pt idx="2427">
                  <c:v>2.96183</c:v>
                </c:pt>
                <c:pt idx="2428">
                  <c:v>5.37134</c:v>
                </c:pt>
                <c:pt idx="2429">
                  <c:v>2.16004</c:v>
                </c:pt>
                <c:pt idx="2430">
                  <c:v>2.11079</c:v>
                </c:pt>
                <c:pt idx="2431">
                  <c:v>3.70378</c:v>
                </c:pt>
                <c:pt idx="2432">
                  <c:v>4.110199999999995</c:v>
                </c:pt>
                <c:pt idx="2433">
                  <c:v>3.910909999999999</c:v>
                </c:pt>
                <c:pt idx="2434">
                  <c:v>3.79814</c:v>
                </c:pt>
                <c:pt idx="2435">
                  <c:v>4.658379999999997</c:v>
                </c:pt>
                <c:pt idx="2436">
                  <c:v>6.38163</c:v>
                </c:pt>
                <c:pt idx="2437">
                  <c:v>3.522899999999999</c:v>
                </c:pt>
                <c:pt idx="2438">
                  <c:v>4.34172</c:v>
                </c:pt>
                <c:pt idx="2439">
                  <c:v>4.567709999999995</c:v>
                </c:pt>
                <c:pt idx="2440">
                  <c:v>5.621729999999998</c:v>
                </c:pt>
                <c:pt idx="2441">
                  <c:v>4.96676</c:v>
                </c:pt>
                <c:pt idx="2442">
                  <c:v>3.978569999999999</c:v>
                </c:pt>
                <c:pt idx="2443">
                  <c:v>2.48637</c:v>
                </c:pt>
                <c:pt idx="2444">
                  <c:v>4.79692</c:v>
                </c:pt>
                <c:pt idx="2445">
                  <c:v>3.402309999999999</c:v>
                </c:pt>
                <c:pt idx="2446">
                  <c:v>3.63889</c:v>
                </c:pt>
                <c:pt idx="2447">
                  <c:v>3.50311</c:v>
                </c:pt>
                <c:pt idx="2448">
                  <c:v>1.68597</c:v>
                </c:pt>
                <c:pt idx="2449">
                  <c:v>1.0264</c:v>
                </c:pt>
                <c:pt idx="2450">
                  <c:v>1.22892</c:v>
                </c:pt>
                <c:pt idx="2451">
                  <c:v>1.71174</c:v>
                </c:pt>
                <c:pt idx="2452">
                  <c:v>1.24227</c:v>
                </c:pt>
                <c:pt idx="2453">
                  <c:v>2.78049</c:v>
                </c:pt>
                <c:pt idx="2454">
                  <c:v>1.22892</c:v>
                </c:pt>
                <c:pt idx="2455">
                  <c:v>0.965184</c:v>
                </c:pt>
                <c:pt idx="2456">
                  <c:v>2.316069999999952</c:v>
                </c:pt>
                <c:pt idx="2457">
                  <c:v>2.25854</c:v>
                </c:pt>
                <c:pt idx="2458">
                  <c:v>4.91567</c:v>
                </c:pt>
                <c:pt idx="2459">
                  <c:v>4.223889999999995</c:v>
                </c:pt>
                <c:pt idx="2460">
                  <c:v>3.03179</c:v>
                </c:pt>
                <c:pt idx="2461">
                  <c:v>1.62567</c:v>
                </c:pt>
                <c:pt idx="2462">
                  <c:v>0.857021</c:v>
                </c:pt>
                <c:pt idx="2463">
                  <c:v>2.14992</c:v>
                </c:pt>
                <c:pt idx="2464">
                  <c:v>1.64546</c:v>
                </c:pt>
                <c:pt idx="2465">
                  <c:v>1.18013</c:v>
                </c:pt>
                <c:pt idx="2466">
                  <c:v>1.86777</c:v>
                </c:pt>
                <c:pt idx="2467">
                  <c:v>5.17158</c:v>
                </c:pt>
                <c:pt idx="2468">
                  <c:v>2.099749999999998</c:v>
                </c:pt>
                <c:pt idx="2469">
                  <c:v>2.18582</c:v>
                </c:pt>
                <c:pt idx="2470">
                  <c:v>2.61525</c:v>
                </c:pt>
                <c:pt idx="2471">
                  <c:v>4.16175</c:v>
                </c:pt>
                <c:pt idx="2472">
                  <c:v>2.50847</c:v>
                </c:pt>
                <c:pt idx="2473">
                  <c:v>3.58273</c:v>
                </c:pt>
                <c:pt idx="2474">
                  <c:v>3.019359999999998</c:v>
                </c:pt>
                <c:pt idx="2475">
                  <c:v>2.86656</c:v>
                </c:pt>
                <c:pt idx="2476">
                  <c:v>2.41089</c:v>
                </c:pt>
                <c:pt idx="2477">
                  <c:v>3.67801</c:v>
                </c:pt>
                <c:pt idx="2478">
                  <c:v>2.992669999999952</c:v>
                </c:pt>
                <c:pt idx="2479">
                  <c:v>4.663909999999975</c:v>
                </c:pt>
                <c:pt idx="2480">
                  <c:v>2.872539999999998</c:v>
                </c:pt>
                <c:pt idx="2481">
                  <c:v>4.085809999999999</c:v>
                </c:pt>
                <c:pt idx="2482">
                  <c:v>2.99037</c:v>
                </c:pt>
                <c:pt idx="2483">
                  <c:v>1.98514</c:v>
                </c:pt>
                <c:pt idx="2484">
                  <c:v>2.806259999999976</c:v>
                </c:pt>
                <c:pt idx="2485">
                  <c:v>3.481009999999999</c:v>
                </c:pt>
                <c:pt idx="2486">
                  <c:v>4.06325</c:v>
                </c:pt>
                <c:pt idx="2487">
                  <c:v>5.26087</c:v>
                </c:pt>
                <c:pt idx="2488">
                  <c:v>3.24398</c:v>
                </c:pt>
                <c:pt idx="2489">
                  <c:v>9.00378</c:v>
                </c:pt>
                <c:pt idx="2490">
                  <c:v>4.861819999999994</c:v>
                </c:pt>
                <c:pt idx="2491">
                  <c:v>7.33024</c:v>
                </c:pt>
                <c:pt idx="2492">
                  <c:v>3.07414</c:v>
                </c:pt>
                <c:pt idx="2493">
                  <c:v>4.489</c:v>
                </c:pt>
                <c:pt idx="2494">
                  <c:v>2.19917</c:v>
                </c:pt>
                <c:pt idx="2495">
                  <c:v>4.01309</c:v>
                </c:pt>
                <c:pt idx="2496">
                  <c:v>2.86425</c:v>
                </c:pt>
                <c:pt idx="2497">
                  <c:v>2.97012</c:v>
                </c:pt>
                <c:pt idx="2498">
                  <c:v>2.714669999999999</c:v>
                </c:pt>
                <c:pt idx="2499">
                  <c:v>6.428579999999997</c:v>
                </c:pt>
                <c:pt idx="2500">
                  <c:v>3.639349999999998</c:v>
                </c:pt>
                <c:pt idx="2501">
                  <c:v>4.61144</c:v>
                </c:pt>
                <c:pt idx="2502">
                  <c:v>4.4821</c:v>
                </c:pt>
                <c:pt idx="2503">
                  <c:v>3.30887</c:v>
                </c:pt>
                <c:pt idx="2504">
                  <c:v>4.130909999999997</c:v>
                </c:pt>
                <c:pt idx="2505">
                  <c:v>3.40139</c:v>
                </c:pt>
                <c:pt idx="2506">
                  <c:v>4.767929999999985</c:v>
                </c:pt>
                <c:pt idx="2507">
                  <c:v>2.98991</c:v>
                </c:pt>
                <c:pt idx="2508">
                  <c:v>6.615909999999975</c:v>
                </c:pt>
                <c:pt idx="2509">
                  <c:v>6.91232</c:v>
                </c:pt>
                <c:pt idx="2510">
                  <c:v>3.95969</c:v>
                </c:pt>
                <c:pt idx="2511">
                  <c:v>5.07723</c:v>
                </c:pt>
                <c:pt idx="2512">
                  <c:v>4.652859999999975</c:v>
                </c:pt>
                <c:pt idx="2513">
                  <c:v>2.971499999999998</c:v>
                </c:pt>
                <c:pt idx="2514">
                  <c:v>3.319459999999952</c:v>
                </c:pt>
                <c:pt idx="2515">
                  <c:v>2.42194</c:v>
                </c:pt>
                <c:pt idx="2516">
                  <c:v>3.621859999999998</c:v>
                </c:pt>
                <c:pt idx="2517">
                  <c:v>3.74521</c:v>
                </c:pt>
                <c:pt idx="2518">
                  <c:v>4.211</c:v>
                </c:pt>
                <c:pt idx="2519">
                  <c:v>4.47289</c:v>
                </c:pt>
                <c:pt idx="2520">
                  <c:v>6.41569</c:v>
                </c:pt>
                <c:pt idx="2521">
                  <c:v>2.808559999999999</c:v>
                </c:pt>
                <c:pt idx="2522">
                  <c:v>4.81027</c:v>
                </c:pt>
                <c:pt idx="2523">
                  <c:v>3.82023</c:v>
                </c:pt>
                <c:pt idx="2524">
                  <c:v>3.9284</c:v>
                </c:pt>
                <c:pt idx="2525">
                  <c:v>3.64855</c:v>
                </c:pt>
                <c:pt idx="2526">
                  <c:v>5.192749999999998</c:v>
                </c:pt>
                <c:pt idx="2527">
                  <c:v>5.014629999999999</c:v>
                </c:pt>
                <c:pt idx="2528">
                  <c:v>2.002629999999999</c:v>
                </c:pt>
                <c:pt idx="2529">
                  <c:v>5.334519999999975</c:v>
                </c:pt>
                <c:pt idx="2530">
                  <c:v>3.470889999999998</c:v>
                </c:pt>
                <c:pt idx="2531">
                  <c:v>4.894039999999975</c:v>
                </c:pt>
                <c:pt idx="2532">
                  <c:v>4.315939999999975</c:v>
                </c:pt>
                <c:pt idx="2533">
                  <c:v>4.843409999999999</c:v>
                </c:pt>
                <c:pt idx="2534">
                  <c:v>5.47904</c:v>
                </c:pt>
                <c:pt idx="2535">
                  <c:v>4.01907</c:v>
                </c:pt>
                <c:pt idx="2536">
                  <c:v>7.50146</c:v>
                </c:pt>
                <c:pt idx="2537">
                  <c:v>4.52536</c:v>
                </c:pt>
                <c:pt idx="2538">
                  <c:v>3.52336</c:v>
                </c:pt>
                <c:pt idx="2539">
                  <c:v>5.29724</c:v>
                </c:pt>
                <c:pt idx="2540">
                  <c:v>3.13489</c:v>
                </c:pt>
                <c:pt idx="2541">
                  <c:v>6.012949999999996</c:v>
                </c:pt>
                <c:pt idx="2542">
                  <c:v>3.79124</c:v>
                </c:pt>
                <c:pt idx="2543">
                  <c:v>5.028439999999994</c:v>
                </c:pt>
                <c:pt idx="2544">
                  <c:v>3.61863</c:v>
                </c:pt>
                <c:pt idx="2545">
                  <c:v>4.77805</c:v>
                </c:pt>
                <c:pt idx="2546">
                  <c:v>3.51323</c:v>
                </c:pt>
                <c:pt idx="2547">
                  <c:v>6.515109999999996</c:v>
                </c:pt>
                <c:pt idx="2548">
                  <c:v>3.74153</c:v>
                </c:pt>
                <c:pt idx="2549">
                  <c:v>5.17342</c:v>
                </c:pt>
                <c:pt idx="2550">
                  <c:v>6.010189999999985</c:v>
                </c:pt>
                <c:pt idx="2551">
                  <c:v>7.162249999999998</c:v>
                </c:pt>
                <c:pt idx="2552">
                  <c:v>4.852619999999995</c:v>
                </c:pt>
                <c:pt idx="2553">
                  <c:v>3.68031</c:v>
                </c:pt>
                <c:pt idx="2554">
                  <c:v>2.63274</c:v>
                </c:pt>
                <c:pt idx="2555">
                  <c:v>3.00326</c:v>
                </c:pt>
                <c:pt idx="2556">
                  <c:v>2.884049999999997</c:v>
                </c:pt>
                <c:pt idx="2557">
                  <c:v>4.267609999999999</c:v>
                </c:pt>
                <c:pt idx="2558">
                  <c:v>5.391589999999994</c:v>
                </c:pt>
                <c:pt idx="2559">
                  <c:v>5.93517</c:v>
                </c:pt>
                <c:pt idx="2560">
                  <c:v>6.517409999999995</c:v>
                </c:pt>
                <c:pt idx="2561">
                  <c:v>3.86442</c:v>
                </c:pt>
                <c:pt idx="2562">
                  <c:v>4.98241</c:v>
                </c:pt>
                <c:pt idx="2563">
                  <c:v>4.98932</c:v>
                </c:pt>
                <c:pt idx="2564">
                  <c:v>4.355069999999999</c:v>
                </c:pt>
                <c:pt idx="2565">
                  <c:v>4.27912</c:v>
                </c:pt>
                <c:pt idx="2566">
                  <c:v>3.511849999999956</c:v>
                </c:pt>
                <c:pt idx="2567">
                  <c:v>3.4534</c:v>
                </c:pt>
                <c:pt idx="2568">
                  <c:v>4.69566</c:v>
                </c:pt>
                <c:pt idx="2569">
                  <c:v>4.78588</c:v>
                </c:pt>
                <c:pt idx="2570">
                  <c:v>6.77424</c:v>
                </c:pt>
                <c:pt idx="2571">
                  <c:v>5.897889999999966</c:v>
                </c:pt>
                <c:pt idx="2572">
                  <c:v>5.2305</c:v>
                </c:pt>
                <c:pt idx="2573">
                  <c:v>4.97413</c:v>
                </c:pt>
                <c:pt idx="2574">
                  <c:v>3.91367</c:v>
                </c:pt>
                <c:pt idx="2575">
                  <c:v>5.677879999999995</c:v>
                </c:pt>
                <c:pt idx="2576">
                  <c:v>3.54407</c:v>
                </c:pt>
                <c:pt idx="2577">
                  <c:v>1.6527</c:v>
                </c:pt>
              </c:numCache>
            </c:numRef>
          </c:xVal>
          <c:yVal>
            <c:numRef>
              <c:f>Sheet1!$H$2:$H$2579</c:f>
              <c:numCache>
                <c:formatCode>General</c:formatCode>
                <c:ptCount val="2578"/>
                <c:pt idx="0">
                  <c:v>3.87149</c:v>
                </c:pt>
                <c:pt idx="1">
                  <c:v>4.94272</c:v>
                </c:pt>
                <c:pt idx="2">
                  <c:v>6.228009999999998</c:v>
                </c:pt>
                <c:pt idx="3">
                  <c:v>4.784549999999998</c:v>
                </c:pt>
                <c:pt idx="4">
                  <c:v>6.21096</c:v>
                </c:pt>
                <c:pt idx="5">
                  <c:v>6.199589999999985</c:v>
                </c:pt>
                <c:pt idx="6">
                  <c:v>9.733420000000001</c:v>
                </c:pt>
                <c:pt idx="7">
                  <c:v>4.38816</c:v>
                </c:pt>
                <c:pt idx="8">
                  <c:v>4.184519999999964</c:v>
                </c:pt>
                <c:pt idx="9">
                  <c:v>3.74315</c:v>
                </c:pt>
                <c:pt idx="10">
                  <c:v>5.870929999999999</c:v>
                </c:pt>
                <c:pt idx="11">
                  <c:v>7.054399999999998</c:v>
                </c:pt>
                <c:pt idx="12">
                  <c:v>2.22534</c:v>
                </c:pt>
                <c:pt idx="13">
                  <c:v>4.802539999999984</c:v>
                </c:pt>
                <c:pt idx="14">
                  <c:v>4.25698</c:v>
                </c:pt>
                <c:pt idx="15">
                  <c:v>3.87433</c:v>
                </c:pt>
                <c:pt idx="16">
                  <c:v>3.48079</c:v>
                </c:pt>
                <c:pt idx="17">
                  <c:v>2.43276</c:v>
                </c:pt>
                <c:pt idx="18">
                  <c:v>4.014039999999985</c:v>
                </c:pt>
                <c:pt idx="19">
                  <c:v>2.39062</c:v>
                </c:pt>
                <c:pt idx="20">
                  <c:v>4.09028</c:v>
                </c:pt>
                <c:pt idx="21">
                  <c:v>3.08772</c:v>
                </c:pt>
                <c:pt idx="22">
                  <c:v>2.751479999999999</c:v>
                </c:pt>
                <c:pt idx="23">
                  <c:v>6.54199</c:v>
                </c:pt>
                <c:pt idx="24">
                  <c:v>3.72752</c:v>
                </c:pt>
                <c:pt idx="25">
                  <c:v>3.93163</c:v>
                </c:pt>
                <c:pt idx="26">
                  <c:v>3.441959999999999</c:v>
                </c:pt>
                <c:pt idx="27">
                  <c:v>3.02095</c:v>
                </c:pt>
                <c:pt idx="28">
                  <c:v>6.84366</c:v>
                </c:pt>
                <c:pt idx="29">
                  <c:v>5.05117</c:v>
                </c:pt>
                <c:pt idx="30">
                  <c:v>4.15137</c:v>
                </c:pt>
                <c:pt idx="31">
                  <c:v>3.4287</c:v>
                </c:pt>
                <c:pt idx="32">
                  <c:v>2.422349999999998</c:v>
                </c:pt>
                <c:pt idx="33">
                  <c:v>5.152989999999964</c:v>
                </c:pt>
                <c:pt idx="34">
                  <c:v>3.53194</c:v>
                </c:pt>
                <c:pt idx="35">
                  <c:v>5.08669</c:v>
                </c:pt>
                <c:pt idx="36">
                  <c:v>3.43343</c:v>
                </c:pt>
                <c:pt idx="37">
                  <c:v>4.37017</c:v>
                </c:pt>
                <c:pt idx="38">
                  <c:v>4.80586</c:v>
                </c:pt>
                <c:pt idx="39">
                  <c:v>6.132819999999985</c:v>
                </c:pt>
                <c:pt idx="40">
                  <c:v>7.53224</c:v>
                </c:pt>
                <c:pt idx="41">
                  <c:v>6.60024</c:v>
                </c:pt>
                <c:pt idx="42">
                  <c:v>3.75452</c:v>
                </c:pt>
                <c:pt idx="43">
                  <c:v>7.38354</c:v>
                </c:pt>
                <c:pt idx="44">
                  <c:v>4.134799999999998</c:v>
                </c:pt>
                <c:pt idx="45">
                  <c:v>8.314110000000001</c:v>
                </c:pt>
                <c:pt idx="46">
                  <c:v>3.0522</c:v>
                </c:pt>
                <c:pt idx="47">
                  <c:v>3.70195</c:v>
                </c:pt>
                <c:pt idx="48">
                  <c:v>6.129979999999994</c:v>
                </c:pt>
                <c:pt idx="49">
                  <c:v>3.24116</c:v>
                </c:pt>
                <c:pt idx="50">
                  <c:v>5.26144</c:v>
                </c:pt>
                <c:pt idx="51">
                  <c:v>3.10808</c:v>
                </c:pt>
                <c:pt idx="52">
                  <c:v>5.90929</c:v>
                </c:pt>
                <c:pt idx="53">
                  <c:v>5.44329</c:v>
                </c:pt>
                <c:pt idx="54">
                  <c:v>3.93495</c:v>
                </c:pt>
                <c:pt idx="55">
                  <c:v>4.860319999999985</c:v>
                </c:pt>
                <c:pt idx="56">
                  <c:v>4.605059999999995</c:v>
                </c:pt>
                <c:pt idx="57">
                  <c:v>2.22865</c:v>
                </c:pt>
                <c:pt idx="58">
                  <c:v>2.23434</c:v>
                </c:pt>
                <c:pt idx="59">
                  <c:v>4.427</c:v>
                </c:pt>
                <c:pt idx="60">
                  <c:v>2.70554</c:v>
                </c:pt>
                <c:pt idx="61">
                  <c:v>3.0541</c:v>
                </c:pt>
                <c:pt idx="62">
                  <c:v>3.28568</c:v>
                </c:pt>
                <c:pt idx="63">
                  <c:v>4.606009999999999</c:v>
                </c:pt>
                <c:pt idx="64">
                  <c:v>5.224499999999995</c:v>
                </c:pt>
                <c:pt idx="65">
                  <c:v>3.6257</c:v>
                </c:pt>
                <c:pt idx="66">
                  <c:v>4.0022</c:v>
                </c:pt>
                <c:pt idx="67">
                  <c:v>5.21645</c:v>
                </c:pt>
                <c:pt idx="68">
                  <c:v>4.2925</c:v>
                </c:pt>
                <c:pt idx="69">
                  <c:v>2.93712</c:v>
                </c:pt>
                <c:pt idx="70">
                  <c:v>2.303949999999999</c:v>
                </c:pt>
                <c:pt idx="71">
                  <c:v>4.01641</c:v>
                </c:pt>
                <c:pt idx="72">
                  <c:v>5.71939</c:v>
                </c:pt>
                <c:pt idx="73">
                  <c:v>5.610939999999966</c:v>
                </c:pt>
                <c:pt idx="74">
                  <c:v>4.384849999999997</c:v>
                </c:pt>
                <c:pt idx="75">
                  <c:v>2.926699999999998</c:v>
                </c:pt>
                <c:pt idx="76">
                  <c:v>5.672499999999998</c:v>
                </c:pt>
                <c:pt idx="77">
                  <c:v>2.065269999999999</c:v>
                </c:pt>
                <c:pt idx="78">
                  <c:v>3.72894</c:v>
                </c:pt>
                <c:pt idx="79">
                  <c:v>2.28832</c:v>
                </c:pt>
                <c:pt idx="80">
                  <c:v>2.303949999999999</c:v>
                </c:pt>
                <c:pt idx="81">
                  <c:v>2.08184</c:v>
                </c:pt>
                <c:pt idx="82">
                  <c:v>6.45722</c:v>
                </c:pt>
                <c:pt idx="83">
                  <c:v>5.015179999999996</c:v>
                </c:pt>
                <c:pt idx="84">
                  <c:v>5.29222</c:v>
                </c:pt>
                <c:pt idx="85">
                  <c:v>4.665679999999996</c:v>
                </c:pt>
                <c:pt idx="86">
                  <c:v>3.60913</c:v>
                </c:pt>
                <c:pt idx="87">
                  <c:v>1.77023</c:v>
                </c:pt>
                <c:pt idx="88">
                  <c:v>2.07995</c:v>
                </c:pt>
                <c:pt idx="89">
                  <c:v>3.42017</c:v>
                </c:pt>
                <c:pt idx="90">
                  <c:v>2.17893</c:v>
                </c:pt>
                <c:pt idx="91">
                  <c:v>2.482019999999999</c:v>
                </c:pt>
                <c:pt idx="92">
                  <c:v>1.76692</c:v>
                </c:pt>
                <c:pt idx="93">
                  <c:v>2.111209999999998</c:v>
                </c:pt>
                <c:pt idx="94">
                  <c:v>4.43126</c:v>
                </c:pt>
                <c:pt idx="95">
                  <c:v>3.7943</c:v>
                </c:pt>
                <c:pt idx="96">
                  <c:v>3.579289999999999</c:v>
                </c:pt>
                <c:pt idx="97">
                  <c:v>3.21748</c:v>
                </c:pt>
                <c:pt idx="98">
                  <c:v>2.57342</c:v>
                </c:pt>
                <c:pt idx="99">
                  <c:v>3.437689999999999</c:v>
                </c:pt>
                <c:pt idx="100">
                  <c:v>2.90539</c:v>
                </c:pt>
                <c:pt idx="101">
                  <c:v>2.26086</c:v>
                </c:pt>
                <c:pt idx="102">
                  <c:v>2.53932</c:v>
                </c:pt>
                <c:pt idx="103">
                  <c:v>3.35198</c:v>
                </c:pt>
                <c:pt idx="104">
                  <c:v>6.093509999999998</c:v>
                </c:pt>
                <c:pt idx="105">
                  <c:v>2.350839999999998</c:v>
                </c:pt>
                <c:pt idx="106">
                  <c:v>4.13669</c:v>
                </c:pt>
                <c:pt idx="107">
                  <c:v>4.41374</c:v>
                </c:pt>
                <c:pt idx="108">
                  <c:v>2.552109999999999</c:v>
                </c:pt>
                <c:pt idx="109">
                  <c:v>3.13839</c:v>
                </c:pt>
                <c:pt idx="110">
                  <c:v>2.48723</c:v>
                </c:pt>
                <c:pt idx="111">
                  <c:v>3.80235</c:v>
                </c:pt>
                <c:pt idx="112">
                  <c:v>3.378969999999998</c:v>
                </c:pt>
                <c:pt idx="113">
                  <c:v>7.4612</c:v>
                </c:pt>
                <c:pt idx="114">
                  <c:v>2.176089999999999</c:v>
                </c:pt>
                <c:pt idx="115">
                  <c:v>2.22392</c:v>
                </c:pt>
                <c:pt idx="116">
                  <c:v>1.91088</c:v>
                </c:pt>
                <c:pt idx="117">
                  <c:v>2.56679</c:v>
                </c:pt>
                <c:pt idx="118">
                  <c:v>2.45692</c:v>
                </c:pt>
                <c:pt idx="119">
                  <c:v>5.45797</c:v>
                </c:pt>
                <c:pt idx="120">
                  <c:v>2.19834</c:v>
                </c:pt>
                <c:pt idx="121">
                  <c:v>2.819199999999999</c:v>
                </c:pt>
                <c:pt idx="122">
                  <c:v>1.69209</c:v>
                </c:pt>
                <c:pt idx="123">
                  <c:v>2.815409999999956</c:v>
                </c:pt>
                <c:pt idx="124">
                  <c:v>1.53865</c:v>
                </c:pt>
                <c:pt idx="125">
                  <c:v>0.828759</c:v>
                </c:pt>
                <c:pt idx="126">
                  <c:v>1.28955</c:v>
                </c:pt>
                <c:pt idx="127">
                  <c:v>1.56328</c:v>
                </c:pt>
                <c:pt idx="128">
                  <c:v>2.311999999999998</c:v>
                </c:pt>
                <c:pt idx="129">
                  <c:v>1.82422</c:v>
                </c:pt>
                <c:pt idx="130">
                  <c:v>1.45104</c:v>
                </c:pt>
                <c:pt idx="131">
                  <c:v>1.29286</c:v>
                </c:pt>
                <c:pt idx="132">
                  <c:v>1.91941</c:v>
                </c:pt>
                <c:pt idx="133">
                  <c:v>1.31654</c:v>
                </c:pt>
                <c:pt idx="134">
                  <c:v>1.83511</c:v>
                </c:pt>
                <c:pt idx="135">
                  <c:v>3.26437</c:v>
                </c:pt>
                <c:pt idx="136">
                  <c:v>3.32782</c:v>
                </c:pt>
                <c:pt idx="137">
                  <c:v>2.76806</c:v>
                </c:pt>
                <c:pt idx="138">
                  <c:v>1.49271</c:v>
                </c:pt>
                <c:pt idx="139">
                  <c:v>2.7278</c:v>
                </c:pt>
                <c:pt idx="140">
                  <c:v>2.582889999999999</c:v>
                </c:pt>
                <c:pt idx="141">
                  <c:v>2.05343</c:v>
                </c:pt>
                <c:pt idx="142">
                  <c:v>2.57247</c:v>
                </c:pt>
                <c:pt idx="143">
                  <c:v>1.13043</c:v>
                </c:pt>
                <c:pt idx="144">
                  <c:v>1.96771</c:v>
                </c:pt>
                <c:pt idx="145">
                  <c:v>2.031639999999999</c:v>
                </c:pt>
                <c:pt idx="146">
                  <c:v>2.11405</c:v>
                </c:pt>
                <c:pt idx="147">
                  <c:v>3.04983</c:v>
                </c:pt>
                <c:pt idx="148">
                  <c:v>2.033069999999999</c:v>
                </c:pt>
                <c:pt idx="149">
                  <c:v>1.51876</c:v>
                </c:pt>
                <c:pt idx="150">
                  <c:v>4.28256</c:v>
                </c:pt>
                <c:pt idx="151">
                  <c:v>2.62882</c:v>
                </c:pt>
                <c:pt idx="152">
                  <c:v>2.79979</c:v>
                </c:pt>
                <c:pt idx="153">
                  <c:v>1.72287</c:v>
                </c:pt>
                <c:pt idx="154">
                  <c:v>4.23425</c:v>
                </c:pt>
                <c:pt idx="155">
                  <c:v>3.611019999999998</c:v>
                </c:pt>
                <c:pt idx="156">
                  <c:v>2.98495</c:v>
                </c:pt>
                <c:pt idx="157">
                  <c:v>1.39563</c:v>
                </c:pt>
                <c:pt idx="158">
                  <c:v>1.03855</c:v>
                </c:pt>
                <c:pt idx="159">
                  <c:v>1.19341</c:v>
                </c:pt>
                <c:pt idx="160">
                  <c:v>1.47709</c:v>
                </c:pt>
                <c:pt idx="161">
                  <c:v>1.39658</c:v>
                </c:pt>
                <c:pt idx="162">
                  <c:v>2.04443</c:v>
                </c:pt>
                <c:pt idx="163">
                  <c:v>2.09463</c:v>
                </c:pt>
                <c:pt idx="164">
                  <c:v>2.12257</c:v>
                </c:pt>
                <c:pt idx="165">
                  <c:v>2.01554</c:v>
                </c:pt>
                <c:pt idx="166">
                  <c:v>3.35719</c:v>
                </c:pt>
                <c:pt idx="167">
                  <c:v>2.50238</c:v>
                </c:pt>
                <c:pt idx="168">
                  <c:v>1.41457</c:v>
                </c:pt>
                <c:pt idx="169">
                  <c:v>1.93361</c:v>
                </c:pt>
                <c:pt idx="170">
                  <c:v>1.51545</c:v>
                </c:pt>
                <c:pt idx="171">
                  <c:v>4.326119999999975</c:v>
                </c:pt>
                <c:pt idx="172">
                  <c:v>1.96866</c:v>
                </c:pt>
                <c:pt idx="173">
                  <c:v>2.53885</c:v>
                </c:pt>
                <c:pt idx="174">
                  <c:v>3.652699999999998</c:v>
                </c:pt>
                <c:pt idx="175">
                  <c:v>2.7117</c:v>
                </c:pt>
                <c:pt idx="176">
                  <c:v>2.10031</c:v>
                </c:pt>
                <c:pt idx="177">
                  <c:v>5.53375</c:v>
                </c:pt>
                <c:pt idx="178">
                  <c:v>2.60325</c:v>
                </c:pt>
                <c:pt idx="179">
                  <c:v>2.791259999999998</c:v>
                </c:pt>
                <c:pt idx="180">
                  <c:v>4.2333</c:v>
                </c:pt>
                <c:pt idx="181">
                  <c:v>5.04833</c:v>
                </c:pt>
                <c:pt idx="182">
                  <c:v>1.41315</c:v>
                </c:pt>
                <c:pt idx="183">
                  <c:v>5.102789999999985</c:v>
                </c:pt>
                <c:pt idx="184">
                  <c:v>1.53439</c:v>
                </c:pt>
                <c:pt idx="185">
                  <c:v>4.324699999999995</c:v>
                </c:pt>
                <c:pt idx="186">
                  <c:v>5.72886</c:v>
                </c:pt>
                <c:pt idx="187">
                  <c:v>3.17959</c:v>
                </c:pt>
                <c:pt idx="188">
                  <c:v>4.042929999999997</c:v>
                </c:pt>
                <c:pt idx="189">
                  <c:v>2.7136</c:v>
                </c:pt>
                <c:pt idx="190">
                  <c:v>1.78633</c:v>
                </c:pt>
                <c:pt idx="191">
                  <c:v>5.95286</c:v>
                </c:pt>
                <c:pt idx="192">
                  <c:v>2.78937</c:v>
                </c:pt>
                <c:pt idx="193">
                  <c:v>3.412119999999998</c:v>
                </c:pt>
                <c:pt idx="194">
                  <c:v>2.01175</c:v>
                </c:pt>
                <c:pt idx="195">
                  <c:v>4.2584</c:v>
                </c:pt>
                <c:pt idx="196">
                  <c:v>3.11093</c:v>
                </c:pt>
                <c:pt idx="197">
                  <c:v>4.9342</c:v>
                </c:pt>
                <c:pt idx="198">
                  <c:v>5.49018</c:v>
                </c:pt>
                <c:pt idx="199">
                  <c:v>5.644089999999966</c:v>
                </c:pt>
                <c:pt idx="200">
                  <c:v>3.407859999999999</c:v>
                </c:pt>
                <c:pt idx="201">
                  <c:v>6.460539999999995</c:v>
                </c:pt>
                <c:pt idx="202">
                  <c:v>3.52767</c:v>
                </c:pt>
                <c:pt idx="203">
                  <c:v>4.394319999999976</c:v>
                </c:pt>
                <c:pt idx="204">
                  <c:v>3.39365</c:v>
                </c:pt>
                <c:pt idx="205">
                  <c:v>1.51592</c:v>
                </c:pt>
                <c:pt idx="206">
                  <c:v>1.67551</c:v>
                </c:pt>
                <c:pt idx="207">
                  <c:v>4.326119999999975</c:v>
                </c:pt>
                <c:pt idx="208">
                  <c:v>3.3515</c:v>
                </c:pt>
                <c:pt idx="209">
                  <c:v>3.92879</c:v>
                </c:pt>
                <c:pt idx="210">
                  <c:v>6.10677</c:v>
                </c:pt>
                <c:pt idx="211">
                  <c:v>2.75101</c:v>
                </c:pt>
                <c:pt idx="212">
                  <c:v>6.064149999999985</c:v>
                </c:pt>
                <c:pt idx="213">
                  <c:v>3.236899999999999</c:v>
                </c:pt>
                <c:pt idx="214">
                  <c:v>1.18868</c:v>
                </c:pt>
                <c:pt idx="215">
                  <c:v>1.11764</c:v>
                </c:pt>
                <c:pt idx="216">
                  <c:v>0.786611</c:v>
                </c:pt>
                <c:pt idx="217">
                  <c:v>0.863331</c:v>
                </c:pt>
                <c:pt idx="218">
                  <c:v>1.97387</c:v>
                </c:pt>
                <c:pt idx="219">
                  <c:v>3.437689999999999</c:v>
                </c:pt>
                <c:pt idx="220">
                  <c:v>1.21709</c:v>
                </c:pt>
                <c:pt idx="221">
                  <c:v>2.76758</c:v>
                </c:pt>
                <c:pt idx="222">
                  <c:v>1.78112</c:v>
                </c:pt>
                <c:pt idx="223">
                  <c:v>7.169009999999997</c:v>
                </c:pt>
                <c:pt idx="224">
                  <c:v>5.88988</c:v>
                </c:pt>
                <c:pt idx="225">
                  <c:v>4.38769</c:v>
                </c:pt>
                <c:pt idx="226">
                  <c:v>2.84193</c:v>
                </c:pt>
                <c:pt idx="227">
                  <c:v>4.2693</c:v>
                </c:pt>
                <c:pt idx="228">
                  <c:v>3.20848</c:v>
                </c:pt>
                <c:pt idx="229">
                  <c:v>4.695039999999984</c:v>
                </c:pt>
                <c:pt idx="230">
                  <c:v>3.78009</c:v>
                </c:pt>
                <c:pt idx="231">
                  <c:v>2.934759999999998</c:v>
                </c:pt>
                <c:pt idx="232">
                  <c:v>1.55759</c:v>
                </c:pt>
                <c:pt idx="233">
                  <c:v>1.17542</c:v>
                </c:pt>
                <c:pt idx="234">
                  <c:v>4.365899999999995</c:v>
                </c:pt>
                <c:pt idx="235">
                  <c:v>2.137249999999999</c:v>
                </c:pt>
                <c:pt idx="236">
                  <c:v>6.74279</c:v>
                </c:pt>
                <c:pt idx="237">
                  <c:v>3.83881</c:v>
                </c:pt>
                <c:pt idx="238">
                  <c:v>2.408609999999999</c:v>
                </c:pt>
                <c:pt idx="239">
                  <c:v>5.393569999999999</c:v>
                </c:pt>
                <c:pt idx="240">
                  <c:v>7.24857</c:v>
                </c:pt>
                <c:pt idx="241">
                  <c:v>8.058860000000001</c:v>
                </c:pt>
                <c:pt idx="242">
                  <c:v>4.88873</c:v>
                </c:pt>
                <c:pt idx="243">
                  <c:v>5.42245</c:v>
                </c:pt>
                <c:pt idx="244">
                  <c:v>4.08365</c:v>
                </c:pt>
                <c:pt idx="245">
                  <c:v>5.020389999999995</c:v>
                </c:pt>
                <c:pt idx="246">
                  <c:v>3.25774</c:v>
                </c:pt>
                <c:pt idx="247">
                  <c:v>4.41137</c:v>
                </c:pt>
                <c:pt idx="248">
                  <c:v>6.78778</c:v>
                </c:pt>
                <c:pt idx="249">
                  <c:v>5.020389999999995</c:v>
                </c:pt>
                <c:pt idx="250">
                  <c:v>2.796</c:v>
                </c:pt>
                <c:pt idx="251">
                  <c:v>5.25954</c:v>
                </c:pt>
                <c:pt idx="252">
                  <c:v>2.486749999999998</c:v>
                </c:pt>
                <c:pt idx="253">
                  <c:v>5.61567</c:v>
                </c:pt>
                <c:pt idx="254">
                  <c:v>3.926429999999999</c:v>
                </c:pt>
                <c:pt idx="255">
                  <c:v>3.68443</c:v>
                </c:pt>
                <c:pt idx="256">
                  <c:v>3.94253</c:v>
                </c:pt>
                <c:pt idx="257">
                  <c:v>7.0113</c:v>
                </c:pt>
                <c:pt idx="258">
                  <c:v>5.67061</c:v>
                </c:pt>
                <c:pt idx="259">
                  <c:v>9.67423</c:v>
                </c:pt>
                <c:pt idx="260">
                  <c:v>6.394709999999987</c:v>
                </c:pt>
                <c:pt idx="261">
                  <c:v>4.91383</c:v>
                </c:pt>
                <c:pt idx="262">
                  <c:v>7.91063</c:v>
                </c:pt>
                <c:pt idx="263">
                  <c:v>4.55676</c:v>
                </c:pt>
                <c:pt idx="264">
                  <c:v>4.132429999999998</c:v>
                </c:pt>
                <c:pt idx="265">
                  <c:v>3.9089</c:v>
                </c:pt>
                <c:pt idx="266">
                  <c:v>5.73407</c:v>
                </c:pt>
                <c:pt idx="267">
                  <c:v>4.7931</c:v>
                </c:pt>
                <c:pt idx="268">
                  <c:v>2.47349</c:v>
                </c:pt>
                <c:pt idx="269">
                  <c:v>6.890539999999984</c:v>
                </c:pt>
                <c:pt idx="270">
                  <c:v>9.3934</c:v>
                </c:pt>
                <c:pt idx="271">
                  <c:v>5.38125</c:v>
                </c:pt>
                <c:pt idx="272">
                  <c:v>5.344789999999985</c:v>
                </c:pt>
                <c:pt idx="273">
                  <c:v>12.0393</c:v>
                </c:pt>
                <c:pt idx="274">
                  <c:v>11.6149</c:v>
                </c:pt>
                <c:pt idx="275">
                  <c:v>8.694400000000001</c:v>
                </c:pt>
                <c:pt idx="276">
                  <c:v>6.63339</c:v>
                </c:pt>
                <c:pt idx="277">
                  <c:v>5.46697</c:v>
                </c:pt>
                <c:pt idx="278">
                  <c:v>8.01955</c:v>
                </c:pt>
                <c:pt idx="279">
                  <c:v>6.43212</c:v>
                </c:pt>
                <c:pt idx="280">
                  <c:v>3.36382</c:v>
                </c:pt>
                <c:pt idx="281">
                  <c:v>5.07769</c:v>
                </c:pt>
                <c:pt idx="282">
                  <c:v>4.20157</c:v>
                </c:pt>
                <c:pt idx="283">
                  <c:v>6.70585</c:v>
                </c:pt>
                <c:pt idx="284">
                  <c:v>6.166439999999985</c:v>
                </c:pt>
                <c:pt idx="285">
                  <c:v>4.7514</c:v>
                </c:pt>
                <c:pt idx="286">
                  <c:v>6.29194</c:v>
                </c:pt>
                <c:pt idx="287">
                  <c:v>3.60345</c:v>
                </c:pt>
                <c:pt idx="288">
                  <c:v>6.714849999999997</c:v>
                </c:pt>
                <c:pt idx="289">
                  <c:v>6.257839999999994</c:v>
                </c:pt>
                <c:pt idx="290">
                  <c:v>4.80917</c:v>
                </c:pt>
                <c:pt idx="291">
                  <c:v>6.72905</c:v>
                </c:pt>
                <c:pt idx="292">
                  <c:v>5.50817</c:v>
                </c:pt>
                <c:pt idx="293">
                  <c:v>4.9162</c:v>
                </c:pt>
                <c:pt idx="294">
                  <c:v>5.95144</c:v>
                </c:pt>
                <c:pt idx="295">
                  <c:v>3.48316</c:v>
                </c:pt>
                <c:pt idx="296">
                  <c:v>4.914309999999999</c:v>
                </c:pt>
                <c:pt idx="297">
                  <c:v>6.04805</c:v>
                </c:pt>
                <c:pt idx="298">
                  <c:v>3.08299</c:v>
                </c:pt>
                <c:pt idx="299">
                  <c:v>6.73474</c:v>
                </c:pt>
                <c:pt idx="300">
                  <c:v>9.250850000000001</c:v>
                </c:pt>
                <c:pt idx="301">
                  <c:v>6.10725</c:v>
                </c:pt>
                <c:pt idx="302">
                  <c:v>6.5884</c:v>
                </c:pt>
                <c:pt idx="303">
                  <c:v>6.96821</c:v>
                </c:pt>
                <c:pt idx="304">
                  <c:v>7.2282</c:v>
                </c:pt>
                <c:pt idx="305">
                  <c:v>5.47834</c:v>
                </c:pt>
                <c:pt idx="306">
                  <c:v>7.351809999999999</c:v>
                </c:pt>
                <c:pt idx="307">
                  <c:v>4.022559999999975</c:v>
                </c:pt>
                <c:pt idx="308">
                  <c:v>3.69674</c:v>
                </c:pt>
                <c:pt idx="309">
                  <c:v>4.59843</c:v>
                </c:pt>
                <c:pt idx="310">
                  <c:v>3.7261</c:v>
                </c:pt>
                <c:pt idx="311">
                  <c:v>6.310409999999996</c:v>
                </c:pt>
                <c:pt idx="312">
                  <c:v>6.99947</c:v>
                </c:pt>
                <c:pt idx="313">
                  <c:v>7.017939999999975</c:v>
                </c:pt>
                <c:pt idx="314">
                  <c:v>11.1996</c:v>
                </c:pt>
                <c:pt idx="315">
                  <c:v>3.41875</c:v>
                </c:pt>
                <c:pt idx="316">
                  <c:v>7.07334</c:v>
                </c:pt>
                <c:pt idx="317">
                  <c:v>7.44794</c:v>
                </c:pt>
                <c:pt idx="318">
                  <c:v>4.89347</c:v>
                </c:pt>
                <c:pt idx="319">
                  <c:v>6.0078</c:v>
                </c:pt>
                <c:pt idx="320">
                  <c:v>8.19383</c:v>
                </c:pt>
                <c:pt idx="321">
                  <c:v>5.518589999999985</c:v>
                </c:pt>
                <c:pt idx="322">
                  <c:v>4.77697</c:v>
                </c:pt>
                <c:pt idx="323">
                  <c:v>2.79363</c:v>
                </c:pt>
                <c:pt idx="324">
                  <c:v>4.84564</c:v>
                </c:pt>
                <c:pt idx="325">
                  <c:v>10.4329</c:v>
                </c:pt>
                <c:pt idx="326">
                  <c:v>5.878979999999998</c:v>
                </c:pt>
                <c:pt idx="327">
                  <c:v>6.99473</c:v>
                </c:pt>
                <c:pt idx="328">
                  <c:v>7.395379999999998</c:v>
                </c:pt>
                <c:pt idx="329">
                  <c:v>6.0992</c:v>
                </c:pt>
                <c:pt idx="330">
                  <c:v>9.06189</c:v>
                </c:pt>
                <c:pt idx="331">
                  <c:v>6.2479</c:v>
                </c:pt>
                <c:pt idx="332">
                  <c:v>7.24809</c:v>
                </c:pt>
                <c:pt idx="333">
                  <c:v>5.45276</c:v>
                </c:pt>
                <c:pt idx="334">
                  <c:v>6.7622</c:v>
                </c:pt>
                <c:pt idx="335">
                  <c:v>7.9793</c:v>
                </c:pt>
                <c:pt idx="336">
                  <c:v>4.126749999999999</c:v>
                </c:pt>
                <c:pt idx="337">
                  <c:v>4.59843</c:v>
                </c:pt>
                <c:pt idx="338">
                  <c:v>5.547009999999998</c:v>
                </c:pt>
                <c:pt idx="339">
                  <c:v>7.680939999999984</c:v>
                </c:pt>
                <c:pt idx="340">
                  <c:v>3.64086</c:v>
                </c:pt>
                <c:pt idx="341">
                  <c:v>5.653559999999984</c:v>
                </c:pt>
                <c:pt idx="342">
                  <c:v>4.23993</c:v>
                </c:pt>
                <c:pt idx="343">
                  <c:v>3.612919999999998</c:v>
                </c:pt>
                <c:pt idx="344">
                  <c:v>5.20035</c:v>
                </c:pt>
                <c:pt idx="345">
                  <c:v>6.06936</c:v>
                </c:pt>
                <c:pt idx="346">
                  <c:v>7.321969999999998</c:v>
                </c:pt>
                <c:pt idx="347">
                  <c:v>9.1836</c:v>
                </c:pt>
                <c:pt idx="348">
                  <c:v>3.42964</c:v>
                </c:pt>
                <c:pt idx="349">
                  <c:v>3.52436</c:v>
                </c:pt>
                <c:pt idx="350">
                  <c:v>5.40919</c:v>
                </c:pt>
                <c:pt idx="351">
                  <c:v>3.955789999999999</c:v>
                </c:pt>
                <c:pt idx="352">
                  <c:v>1.86116</c:v>
                </c:pt>
                <c:pt idx="353">
                  <c:v>4.44404</c:v>
                </c:pt>
                <c:pt idx="354">
                  <c:v>11.122</c:v>
                </c:pt>
                <c:pt idx="355">
                  <c:v>3.3927</c:v>
                </c:pt>
                <c:pt idx="356">
                  <c:v>4.01688</c:v>
                </c:pt>
                <c:pt idx="357">
                  <c:v>2.47065</c:v>
                </c:pt>
                <c:pt idx="358">
                  <c:v>2.57389</c:v>
                </c:pt>
                <c:pt idx="359">
                  <c:v>4.866479999999997</c:v>
                </c:pt>
                <c:pt idx="360">
                  <c:v>6.057989999999966</c:v>
                </c:pt>
                <c:pt idx="361">
                  <c:v>2.39819</c:v>
                </c:pt>
                <c:pt idx="362">
                  <c:v>2.86514</c:v>
                </c:pt>
                <c:pt idx="363">
                  <c:v>7.13633</c:v>
                </c:pt>
                <c:pt idx="364">
                  <c:v>6.4127</c:v>
                </c:pt>
                <c:pt idx="365">
                  <c:v>6.9952</c:v>
                </c:pt>
                <c:pt idx="366">
                  <c:v>5.864299999999996</c:v>
                </c:pt>
                <c:pt idx="367">
                  <c:v>1.59974</c:v>
                </c:pt>
                <c:pt idx="368">
                  <c:v>5.147309999999996</c:v>
                </c:pt>
                <c:pt idx="369">
                  <c:v>2.94849</c:v>
                </c:pt>
                <c:pt idx="370">
                  <c:v>3.312669999999952</c:v>
                </c:pt>
                <c:pt idx="371">
                  <c:v>4.524079999999985</c:v>
                </c:pt>
                <c:pt idx="372">
                  <c:v>3.90322</c:v>
                </c:pt>
                <c:pt idx="373">
                  <c:v>3.96668</c:v>
                </c:pt>
                <c:pt idx="374">
                  <c:v>7.20358</c:v>
                </c:pt>
                <c:pt idx="375">
                  <c:v>6.01727</c:v>
                </c:pt>
                <c:pt idx="376">
                  <c:v>5.46602</c:v>
                </c:pt>
                <c:pt idx="377">
                  <c:v>5.328209999999999</c:v>
                </c:pt>
                <c:pt idx="378">
                  <c:v>10.1701</c:v>
                </c:pt>
                <c:pt idx="379">
                  <c:v>4.48619</c:v>
                </c:pt>
                <c:pt idx="380">
                  <c:v>5.56926</c:v>
                </c:pt>
                <c:pt idx="381">
                  <c:v>8.181510000000001</c:v>
                </c:pt>
                <c:pt idx="382">
                  <c:v>7.74203</c:v>
                </c:pt>
                <c:pt idx="383">
                  <c:v>7.608489999999985</c:v>
                </c:pt>
                <c:pt idx="384">
                  <c:v>4.85606</c:v>
                </c:pt>
                <c:pt idx="385">
                  <c:v>5.02323</c:v>
                </c:pt>
                <c:pt idx="386">
                  <c:v>3.96668</c:v>
                </c:pt>
                <c:pt idx="387">
                  <c:v>2.479169999999999</c:v>
                </c:pt>
                <c:pt idx="388">
                  <c:v>6.020109999999995</c:v>
                </c:pt>
                <c:pt idx="389">
                  <c:v>6.41981</c:v>
                </c:pt>
                <c:pt idx="390">
                  <c:v>4.91762</c:v>
                </c:pt>
                <c:pt idx="391">
                  <c:v>4.44404</c:v>
                </c:pt>
                <c:pt idx="392">
                  <c:v>7.524189999999964</c:v>
                </c:pt>
                <c:pt idx="393">
                  <c:v>4.21199</c:v>
                </c:pt>
                <c:pt idx="394">
                  <c:v>5.03649</c:v>
                </c:pt>
                <c:pt idx="395">
                  <c:v>7.77897</c:v>
                </c:pt>
                <c:pt idx="396">
                  <c:v>3.86581</c:v>
                </c:pt>
                <c:pt idx="397">
                  <c:v>5.94576</c:v>
                </c:pt>
                <c:pt idx="398">
                  <c:v>3.89896</c:v>
                </c:pt>
                <c:pt idx="399">
                  <c:v>5.09142</c:v>
                </c:pt>
                <c:pt idx="400">
                  <c:v>2.379719999999998</c:v>
                </c:pt>
                <c:pt idx="401">
                  <c:v>3.586869999999998</c:v>
                </c:pt>
                <c:pt idx="402">
                  <c:v>1.11527</c:v>
                </c:pt>
                <c:pt idx="403">
                  <c:v>2.442239999999999</c:v>
                </c:pt>
                <c:pt idx="404">
                  <c:v>3.01716</c:v>
                </c:pt>
                <c:pt idx="405">
                  <c:v>4.366849999999999</c:v>
                </c:pt>
                <c:pt idx="406">
                  <c:v>4.132899999999998</c:v>
                </c:pt>
                <c:pt idx="407">
                  <c:v>2.75764</c:v>
                </c:pt>
                <c:pt idx="408">
                  <c:v>3.10903</c:v>
                </c:pt>
                <c:pt idx="409">
                  <c:v>1.90236</c:v>
                </c:pt>
                <c:pt idx="410">
                  <c:v>3.10335</c:v>
                </c:pt>
                <c:pt idx="411">
                  <c:v>2.19503</c:v>
                </c:pt>
                <c:pt idx="412">
                  <c:v>3.7422</c:v>
                </c:pt>
                <c:pt idx="413">
                  <c:v>2.76758</c:v>
                </c:pt>
                <c:pt idx="414">
                  <c:v>3.849229999999999</c:v>
                </c:pt>
                <c:pt idx="415">
                  <c:v>2.3532</c:v>
                </c:pt>
                <c:pt idx="416">
                  <c:v>4.36258999999994</c:v>
                </c:pt>
                <c:pt idx="417">
                  <c:v>2.4304</c:v>
                </c:pt>
                <c:pt idx="418">
                  <c:v>2.50522</c:v>
                </c:pt>
                <c:pt idx="419">
                  <c:v>8.84973</c:v>
                </c:pt>
                <c:pt idx="420">
                  <c:v>4.48809</c:v>
                </c:pt>
                <c:pt idx="421">
                  <c:v>5.73691</c:v>
                </c:pt>
                <c:pt idx="422">
                  <c:v>3.25631</c:v>
                </c:pt>
                <c:pt idx="423">
                  <c:v>2.991579999999999</c:v>
                </c:pt>
                <c:pt idx="424">
                  <c:v>2.01791</c:v>
                </c:pt>
                <c:pt idx="425">
                  <c:v>1.5898</c:v>
                </c:pt>
                <c:pt idx="426">
                  <c:v>3.63896</c:v>
                </c:pt>
                <c:pt idx="427">
                  <c:v>3.615759999999998</c:v>
                </c:pt>
                <c:pt idx="428">
                  <c:v>2.900659999999998</c:v>
                </c:pt>
                <c:pt idx="429">
                  <c:v>2.39156</c:v>
                </c:pt>
                <c:pt idx="430">
                  <c:v>5.94907</c:v>
                </c:pt>
                <c:pt idx="431">
                  <c:v>2.39488</c:v>
                </c:pt>
                <c:pt idx="432">
                  <c:v>2.815409999999956</c:v>
                </c:pt>
                <c:pt idx="433">
                  <c:v>1.371</c:v>
                </c:pt>
                <c:pt idx="434">
                  <c:v>2.19787</c:v>
                </c:pt>
                <c:pt idx="435">
                  <c:v>3.272889999999999</c:v>
                </c:pt>
                <c:pt idx="436">
                  <c:v>1.27534</c:v>
                </c:pt>
                <c:pt idx="437">
                  <c:v>2.43797</c:v>
                </c:pt>
                <c:pt idx="438">
                  <c:v>3.26957</c:v>
                </c:pt>
                <c:pt idx="439">
                  <c:v>1.12901</c:v>
                </c:pt>
                <c:pt idx="440">
                  <c:v>1.16595</c:v>
                </c:pt>
                <c:pt idx="441">
                  <c:v>1.22609</c:v>
                </c:pt>
                <c:pt idx="442">
                  <c:v>2.91344</c:v>
                </c:pt>
                <c:pt idx="443">
                  <c:v>1.68451</c:v>
                </c:pt>
                <c:pt idx="444">
                  <c:v>1.67031</c:v>
                </c:pt>
                <c:pt idx="445">
                  <c:v>1.20336</c:v>
                </c:pt>
                <c:pt idx="446">
                  <c:v>1.13232</c:v>
                </c:pt>
                <c:pt idx="447">
                  <c:v>2.482019999999999</c:v>
                </c:pt>
                <c:pt idx="448">
                  <c:v>1.67551</c:v>
                </c:pt>
                <c:pt idx="449">
                  <c:v>5.67629</c:v>
                </c:pt>
                <c:pt idx="450">
                  <c:v>2.81447</c:v>
                </c:pt>
                <c:pt idx="451">
                  <c:v>2.12731</c:v>
                </c:pt>
                <c:pt idx="452">
                  <c:v>2.199759999999999</c:v>
                </c:pt>
                <c:pt idx="453">
                  <c:v>2.6023</c:v>
                </c:pt>
                <c:pt idx="454">
                  <c:v>2.618409999999998</c:v>
                </c:pt>
                <c:pt idx="455">
                  <c:v>1.96676</c:v>
                </c:pt>
                <c:pt idx="456">
                  <c:v>3.66548</c:v>
                </c:pt>
                <c:pt idx="457">
                  <c:v>1.27534</c:v>
                </c:pt>
                <c:pt idx="458">
                  <c:v>2.890709999999998</c:v>
                </c:pt>
                <c:pt idx="459">
                  <c:v>2.68139</c:v>
                </c:pt>
                <c:pt idx="460">
                  <c:v>3.70384</c:v>
                </c:pt>
                <c:pt idx="461">
                  <c:v>1.60543</c:v>
                </c:pt>
                <c:pt idx="462">
                  <c:v>2.57578</c:v>
                </c:pt>
                <c:pt idx="463">
                  <c:v>1.11954</c:v>
                </c:pt>
                <c:pt idx="464">
                  <c:v>2.40103</c:v>
                </c:pt>
                <c:pt idx="465">
                  <c:v>2.29969</c:v>
                </c:pt>
                <c:pt idx="466">
                  <c:v>4.32139</c:v>
                </c:pt>
                <c:pt idx="467">
                  <c:v>3.56272</c:v>
                </c:pt>
                <c:pt idx="468">
                  <c:v>3.82792</c:v>
                </c:pt>
                <c:pt idx="469">
                  <c:v>5.9486</c:v>
                </c:pt>
                <c:pt idx="470">
                  <c:v>3.96763</c:v>
                </c:pt>
                <c:pt idx="471">
                  <c:v>2.97454</c:v>
                </c:pt>
                <c:pt idx="472">
                  <c:v>2.36741</c:v>
                </c:pt>
                <c:pt idx="473">
                  <c:v>4.33465</c:v>
                </c:pt>
                <c:pt idx="474">
                  <c:v>3.27715</c:v>
                </c:pt>
                <c:pt idx="475">
                  <c:v>6.44112</c:v>
                </c:pt>
                <c:pt idx="476">
                  <c:v>3.6186</c:v>
                </c:pt>
                <c:pt idx="477">
                  <c:v>6.157919999999937</c:v>
                </c:pt>
                <c:pt idx="478">
                  <c:v>2.80121</c:v>
                </c:pt>
                <c:pt idx="479">
                  <c:v>2.925759999999999</c:v>
                </c:pt>
                <c:pt idx="480">
                  <c:v>5.4002</c:v>
                </c:pt>
                <c:pt idx="481">
                  <c:v>3.68774</c:v>
                </c:pt>
                <c:pt idx="482">
                  <c:v>3.343449999999998</c:v>
                </c:pt>
                <c:pt idx="483">
                  <c:v>0.914477</c:v>
                </c:pt>
                <c:pt idx="484">
                  <c:v>4.60932</c:v>
                </c:pt>
                <c:pt idx="485">
                  <c:v>3.518679999999998</c:v>
                </c:pt>
                <c:pt idx="486">
                  <c:v>3.165859999999999</c:v>
                </c:pt>
                <c:pt idx="487">
                  <c:v>3.3946</c:v>
                </c:pt>
                <c:pt idx="488">
                  <c:v>3.275259999999998</c:v>
                </c:pt>
                <c:pt idx="489">
                  <c:v>3.7853</c:v>
                </c:pt>
                <c:pt idx="490">
                  <c:v>7.10034</c:v>
                </c:pt>
                <c:pt idx="491">
                  <c:v>4.55107</c:v>
                </c:pt>
                <c:pt idx="492">
                  <c:v>4.954089999999995</c:v>
                </c:pt>
                <c:pt idx="493">
                  <c:v>5.97843</c:v>
                </c:pt>
                <c:pt idx="494">
                  <c:v>3.952469999999952</c:v>
                </c:pt>
                <c:pt idx="495">
                  <c:v>2.896869999999952</c:v>
                </c:pt>
                <c:pt idx="496">
                  <c:v>7.89642</c:v>
                </c:pt>
                <c:pt idx="497">
                  <c:v>3.04226</c:v>
                </c:pt>
                <c:pt idx="498">
                  <c:v>3.89659</c:v>
                </c:pt>
                <c:pt idx="499">
                  <c:v>3.445269999999998</c:v>
                </c:pt>
                <c:pt idx="500">
                  <c:v>2.545949999999999</c:v>
                </c:pt>
                <c:pt idx="501">
                  <c:v>4.28682</c:v>
                </c:pt>
                <c:pt idx="502">
                  <c:v>2.05674</c:v>
                </c:pt>
                <c:pt idx="503">
                  <c:v>4.828589999999965</c:v>
                </c:pt>
                <c:pt idx="504">
                  <c:v>5.545109999999998</c:v>
                </c:pt>
                <c:pt idx="505">
                  <c:v>2.826779999999998</c:v>
                </c:pt>
                <c:pt idx="506">
                  <c:v>2.59757</c:v>
                </c:pt>
                <c:pt idx="507">
                  <c:v>4.4412</c:v>
                </c:pt>
                <c:pt idx="508">
                  <c:v>6.121929999999995</c:v>
                </c:pt>
                <c:pt idx="509">
                  <c:v>4.9986</c:v>
                </c:pt>
                <c:pt idx="510">
                  <c:v>6.07268</c:v>
                </c:pt>
                <c:pt idx="511">
                  <c:v>6.352089999999984</c:v>
                </c:pt>
                <c:pt idx="512">
                  <c:v>3.38892</c:v>
                </c:pt>
                <c:pt idx="513">
                  <c:v>4.34317</c:v>
                </c:pt>
                <c:pt idx="514">
                  <c:v>4.90815</c:v>
                </c:pt>
                <c:pt idx="515">
                  <c:v>1.64142</c:v>
                </c:pt>
                <c:pt idx="516">
                  <c:v>6.91043</c:v>
                </c:pt>
                <c:pt idx="517">
                  <c:v>7.23531</c:v>
                </c:pt>
                <c:pt idx="518">
                  <c:v>5.78427</c:v>
                </c:pt>
                <c:pt idx="519">
                  <c:v>8.01908</c:v>
                </c:pt>
                <c:pt idx="520">
                  <c:v>3.69011</c:v>
                </c:pt>
                <c:pt idx="521">
                  <c:v>6.675539999999985</c:v>
                </c:pt>
                <c:pt idx="522">
                  <c:v>4.14901</c:v>
                </c:pt>
                <c:pt idx="523">
                  <c:v>2.554469999999998</c:v>
                </c:pt>
                <c:pt idx="524">
                  <c:v>6.24932</c:v>
                </c:pt>
                <c:pt idx="525">
                  <c:v>5.07059</c:v>
                </c:pt>
                <c:pt idx="526">
                  <c:v>6.46764</c:v>
                </c:pt>
                <c:pt idx="527">
                  <c:v>5.78995</c:v>
                </c:pt>
                <c:pt idx="528">
                  <c:v>3.716159999999999</c:v>
                </c:pt>
                <c:pt idx="529">
                  <c:v>6.10156</c:v>
                </c:pt>
                <c:pt idx="530">
                  <c:v>4.528819999999985</c:v>
                </c:pt>
                <c:pt idx="531">
                  <c:v>5.03696</c:v>
                </c:pt>
                <c:pt idx="532">
                  <c:v>5.611889999999994</c:v>
                </c:pt>
                <c:pt idx="533">
                  <c:v>7.43942</c:v>
                </c:pt>
                <c:pt idx="534">
                  <c:v>7.20926</c:v>
                </c:pt>
                <c:pt idx="535">
                  <c:v>3.05931</c:v>
                </c:pt>
                <c:pt idx="536">
                  <c:v>4.10165</c:v>
                </c:pt>
                <c:pt idx="537">
                  <c:v>3.356879999999952</c:v>
                </c:pt>
                <c:pt idx="538">
                  <c:v>2.67713</c:v>
                </c:pt>
                <c:pt idx="539">
                  <c:v>6.814299999999998</c:v>
                </c:pt>
                <c:pt idx="540">
                  <c:v>7.34234</c:v>
                </c:pt>
                <c:pt idx="541">
                  <c:v>6.865439999999976</c:v>
                </c:pt>
                <c:pt idx="542">
                  <c:v>4.028719999999995</c:v>
                </c:pt>
                <c:pt idx="543">
                  <c:v>8.374260000000001</c:v>
                </c:pt>
                <c:pt idx="544">
                  <c:v>4.14143</c:v>
                </c:pt>
                <c:pt idx="545">
                  <c:v>5.40067</c:v>
                </c:pt>
                <c:pt idx="546">
                  <c:v>4.70357</c:v>
                </c:pt>
                <c:pt idx="547">
                  <c:v>4.35264</c:v>
                </c:pt>
                <c:pt idx="548">
                  <c:v>4.840899999999999</c:v>
                </c:pt>
                <c:pt idx="549">
                  <c:v>6.49321</c:v>
                </c:pt>
                <c:pt idx="550">
                  <c:v>8.40883</c:v>
                </c:pt>
                <c:pt idx="551">
                  <c:v>8.97475</c:v>
                </c:pt>
                <c:pt idx="552">
                  <c:v>4.794489999999985</c:v>
                </c:pt>
                <c:pt idx="553">
                  <c:v>2.378299999999998</c:v>
                </c:pt>
                <c:pt idx="554">
                  <c:v>4.70214</c:v>
                </c:pt>
                <c:pt idx="555">
                  <c:v>5.222129999999995</c:v>
                </c:pt>
                <c:pt idx="556">
                  <c:v>4.59275</c:v>
                </c:pt>
                <c:pt idx="557">
                  <c:v>1.7636</c:v>
                </c:pt>
                <c:pt idx="558">
                  <c:v>3.66264</c:v>
                </c:pt>
                <c:pt idx="559">
                  <c:v>4.34507</c:v>
                </c:pt>
                <c:pt idx="560">
                  <c:v>3.916479999999976</c:v>
                </c:pt>
                <c:pt idx="561">
                  <c:v>4.42321</c:v>
                </c:pt>
                <c:pt idx="562">
                  <c:v>6.087829999999999</c:v>
                </c:pt>
                <c:pt idx="563">
                  <c:v>2.68518</c:v>
                </c:pt>
                <c:pt idx="564">
                  <c:v>5.23965</c:v>
                </c:pt>
                <c:pt idx="565">
                  <c:v>3.579769999999999</c:v>
                </c:pt>
                <c:pt idx="566">
                  <c:v>3.93921</c:v>
                </c:pt>
                <c:pt idx="567">
                  <c:v>2.91439</c:v>
                </c:pt>
                <c:pt idx="568">
                  <c:v>7.696099999999998</c:v>
                </c:pt>
                <c:pt idx="569">
                  <c:v>6.5311</c:v>
                </c:pt>
                <c:pt idx="570">
                  <c:v>8.92834</c:v>
                </c:pt>
                <c:pt idx="571">
                  <c:v>5.34337</c:v>
                </c:pt>
                <c:pt idx="572">
                  <c:v>4.30339</c:v>
                </c:pt>
                <c:pt idx="573">
                  <c:v>3.68774</c:v>
                </c:pt>
                <c:pt idx="574">
                  <c:v>4.23236</c:v>
                </c:pt>
                <c:pt idx="575">
                  <c:v>2.16709</c:v>
                </c:pt>
                <c:pt idx="576">
                  <c:v>4.83901</c:v>
                </c:pt>
                <c:pt idx="577">
                  <c:v>4.1831</c:v>
                </c:pt>
                <c:pt idx="578">
                  <c:v>3.36003</c:v>
                </c:pt>
                <c:pt idx="579">
                  <c:v>2.69323</c:v>
                </c:pt>
                <c:pt idx="580">
                  <c:v>4.134329999999998</c:v>
                </c:pt>
                <c:pt idx="581">
                  <c:v>5.40256</c:v>
                </c:pt>
                <c:pt idx="582">
                  <c:v>8.088219999999996</c:v>
                </c:pt>
                <c:pt idx="583">
                  <c:v>5.57447</c:v>
                </c:pt>
                <c:pt idx="584">
                  <c:v>2.303949999999999</c:v>
                </c:pt>
                <c:pt idx="585">
                  <c:v>3.445749999999999</c:v>
                </c:pt>
                <c:pt idx="586">
                  <c:v>6.058939999999994</c:v>
                </c:pt>
                <c:pt idx="587">
                  <c:v>4.166059999999995</c:v>
                </c:pt>
                <c:pt idx="588">
                  <c:v>3.72658</c:v>
                </c:pt>
                <c:pt idx="589">
                  <c:v>6.45201</c:v>
                </c:pt>
                <c:pt idx="590">
                  <c:v>6.97579</c:v>
                </c:pt>
                <c:pt idx="591">
                  <c:v>7.144849999999995</c:v>
                </c:pt>
                <c:pt idx="592">
                  <c:v>8.324060000000001</c:v>
                </c:pt>
                <c:pt idx="593">
                  <c:v>4.2442</c:v>
                </c:pt>
                <c:pt idx="594">
                  <c:v>2.441759999999999</c:v>
                </c:pt>
                <c:pt idx="595">
                  <c:v>8.078750000000001</c:v>
                </c:pt>
                <c:pt idx="596">
                  <c:v>3.20943</c:v>
                </c:pt>
                <c:pt idx="597">
                  <c:v>6.45817</c:v>
                </c:pt>
                <c:pt idx="598">
                  <c:v>8.524379999999998</c:v>
                </c:pt>
                <c:pt idx="599">
                  <c:v>6.61634</c:v>
                </c:pt>
                <c:pt idx="600">
                  <c:v>3.97236</c:v>
                </c:pt>
                <c:pt idx="601">
                  <c:v>3.78435</c:v>
                </c:pt>
                <c:pt idx="602">
                  <c:v>3.39933</c:v>
                </c:pt>
                <c:pt idx="603">
                  <c:v>8.860150000000002</c:v>
                </c:pt>
                <c:pt idx="604">
                  <c:v>6.917539999999994</c:v>
                </c:pt>
                <c:pt idx="605">
                  <c:v>5.362309999999995</c:v>
                </c:pt>
                <c:pt idx="606">
                  <c:v>4.18879</c:v>
                </c:pt>
                <c:pt idx="607">
                  <c:v>1.93503</c:v>
                </c:pt>
                <c:pt idx="608">
                  <c:v>6.51642</c:v>
                </c:pt>
                <c:pt idx="609">
                  <c:v>2.91629</c:v>
                </c:pt>
                <c:pt idx="610">
                  <c:v>5.842989999999975</c:v>
                </c:pt>
                <c:pt idx="611">
                  <c:v>3.20754</c:v>
                </c:pt>
                <c:pt idx="612">
                  <c:v>4.794019999999985</c:v>
                </c:pt>
                <c:pt idx="613">
                  <c:v>2.484859999999998</c:v>
                </c:pt>
                <c:pt idx="614">
                  <c:v>3.28568</c:v>
                </c:pt>
                <c:pt idx="615">
                  <c:v>3.32546</c:v>
                </c:pt>
                <c:pt idx="616">
                  <c:v>3.952949999999976</c:v>
                </c:pt>
                <c:pt idx="617">
                  <c:v>6.10156</c:v>
                </c:pt>
                <c:pt idx="618">
                  <c:v>4.31334</c:v>
                </c:pt>
                <c:pt idx="619">
                  <c:v>4.597959999999984</c:v>
                </c:pt>
                <c:pt idx="620">
                  <c:v>5.694759999999976</c:v>
                </c:pt>
                <c:pt idx="621">
                  <c:v>3.35577</c:v>
                </c:pt>
                <c:pt idx="622">
                  <c:v>6.88154</c:v>
                </c:pt>
                <c:pt idx="623">
                  <c:v>5.6062</c:v>
                </c:pt>
                <c:pt idx="624">
                  <c:v>4.61169</c:v>
                </c:pt>
                <c:pt idx="625">
                  <c:v>3.70384</c:v>
                </c:pt>
                <c:pt idx="626">
                  <c:v>4.7926</c:v>
                </c:pt>
                <c:pt idx="627">
                  <c:v>2.81589</c:v>
                </c:pt>
                <c:pt idx="628">
                  <c:v>6.362979999999966</c:v>
                </c:pt>
                <c:pt idx="629">
                  <c:v>5.327269999999999</c:v>
                </c:pt>
                <c:pt idx="630">
                  <c:v>5.79658</c:v>
                </c:pt>
                <c:pt idx="631">
                  <c:v>4.674199999999994</c:v>
                </c:pt>
                <c:pt idx="632">
                  <c:v>4.96024</c:v>
                </c:pt>
                <c:pt idx="633">
                  <c:v>2.955589999999999</c:v>
                </c:pt>
                <c:pt idx="634">
                  <c:v>2.29259</c:v>
                </c:pt>
                <c:pt idx="635">
                  <c:v>8.35532</c:v>
                </c:pt>
                <c:pt idx="636">
                  <c:v>6.68975</c:v>
                </c:pt>
                <c:pt idx="637">
                  <c:v>2.80452</c:v>
                </c:pt>
                <c:pt idx="638">
                  <c:v>4.04103</c:v>
                </c:pt>
                <c:pt idx="639">
                  <c:v>3.70432</c:v>
                </c:pt>
                <c:pt idx="640">
                  <c:v>9.042</c:v>
                </c:pt>
                <c:pt idx="641">
                  <c:v>5.31637</c:v>
                </c:pt>
                <c:pt idx="642">
                  <c:v>4.87168</c:v>
                </c:pt>
                <c:pt idx="643">
                  <c:v>8.733229999999998</c:v>
                </c:pt>
                <c:pt idx="644">
                  <c:v>6.148919999999976</c:v>
                </c:pt>
                <c:pt idx="645">
                  <c:v>5.680079999999997</c:v>
                </c:pt>
                <c:pt idx="646">
                  <c:v>7.32907</c:v>
                </c:pt>
                <c:pt idx="647">
                  <c:v>5.212189999999985</c:v>
                </c:pt>
                <c:pt idx="648">
                  <c:v>3.88759</c:v>
                </c:pt>
                <c:pt idx="649">
                  <c:v>7.258989999999994</c:v>
                </c:pt>
                <c:pt idx="650">
                  <c:v>4.129119999999975</c:v>
                </c:pt>
                <c:pt idx="651">
                  <c:v>3.338719999999999</c:v>
                </c:pt>
                <c:pt idx="652">
                  <c:v>4.625419999999964</c:v>
                </c:pt>
                <c:pt idx="653">
                  <c:v>6.322249999999999</c:v>
                </c:pt>
                <c:pt idx="654">
                  <c:v>3.78577</c:v>
                </c:pt>
                <c:pt idx="655">
                  <c:v>3.136029999999999</c:v>
                </c:pt>
                <c:pt idx="656">
                  <c:v>2.06811</c:v>
                </c:pt>
                <c:pt idx="657">
                  <c:v>1.99376</c:v>
                </c:pt>
                <c:pt idx="658">
                  <c:v>3.63328</c:v>
                </c:pt>
                <c:pt idx="659">
                  <c:v>2.70223</c:v>
                </c:pt>
                <c:pt idx="660">
                  <c:v>4.90057</c:v>
                </c:pt>
                <c:pt idx="661">
                  <c:v>3.7171</c:v>
                </c:pt>
                <c:pt idx="662">
                  <c:v>3.39176</c:v>
                </c:pt>
                <c:pt idx="663">
                  <c:v>4.55155</c:v>
                </c:pt>
                <c:pt idx="664">
                  <c:v>4.06945</c:v>
                </c:pt>
                <c:pt idx="665">
                  <c:v>5.06064</c:v>
                </c:pt>
                <c:pt idx="666">
                  <c:v>5.83352</c:v>
                </c:pt>
                <c:pt idx="667">
                  <c:v>6.72574</c:v>
                </c:pt>
                <c:pt idx="668">
                  <c:v>3.54898</c:v>
                </c:pt>
                <c:pt idx="669">
                  <c:v>3.94016</c:v>
                </c:pt>
                <c:pt idx="670">
                  <c:v>9.149500000000001</c:v>
                </c:pt>
                <c:pt idx="671">
                  <c:v>5.43619</c:v>
                </c:pt>
                <c:pt idx="672">
                  <c:v>3.45901</c:v>
                </c:pt>
                <c:pt idx="673">
                  <c:v>4.513189999999994</c:v>
                </c:pt>
                <c:pt idx="674">
                  <c:v>2.78084</c:v>
                </c:pt>
                <c:pt idx="675">
                  <c:v>2.76379</c:v>
                </c:pt>
                <c:pt idx="676">
                  <c:v>3.653649999999998</c:v>
                </c:pt>
                <c:pt idx="677">
                  <c:v>4.662359999999984</c:v>
                </c:pt>
                <c:pt idx="678">
                  <c:v>2.12494</c:v>
                </c:pt>
                <c:pt idx="679">
                  <c:v>3.87575</c:v>
                </c:pt>
                <c:pt idx="680">
                  <c:v>4.38769</c:v>
                </c:pt>
                <c:pt idx="681">
                  <c:v>2.48959</c:v>
                </c:pt>
                <c:pt idx="682">
                  <c:v>5.17619</c:v>
                </c:pt>
                <c:pt idx="683">
                  <c:v>3.79714</c:v>
                </c:pt>
                <c:pt idx="684">
                  <c:v>4.4019</c:v>
                </c:pt>
                <c:pt idx="685">
                  <c:v>3.76541</c:v>
                </c:pt>
                <c:pt idx="686">
                  <c:v>4.18263</c:v>
                </c:pt>
                <c:pt idx="687">
                  <c:v>2.15809</c:v>
                </c:pt>
                <c:pt idx="688">
                  <c:v>2.536</c:v>
                </c:pt>
                <c:pt idx="689">
                  <c:v>4.740979999999999</c:v>
                </c:pt>
                <c:pt idx="690">
                  <c:v>4.78976</c:v>
                </c:pt>
                <c:pt idx="691">
                  <c:v>2.53032</c:v>
                </c:pt>
                <c:pt idx="692">
                  <c:v>3.613859999999998</c:v>
                </c:pt>
                <c:pt idx="693">
                  <c:v>3.42538</c:v>
                </c:pt>
                <c:pt idx="694">
                  <c:v>5.90456</c:v>
                </c:pt>
                <c:pt idx="695">
                  <c:v>3.171069999999998</c:v>
                </c:pt>
                <c:pt idx="696">
                  <c:v>6.147969999999995</c:v>
                </c:pt>
                <c:pt idx="697">
                  <c:v>3.853969999999999</c:v>
                </c:pt>
                <c:pt idx="698">
                  <c:v>4.7746</c:v>
                </c:pt>
                <c:pt idx="699">
                  <c:v>5.125049999999995</c:v>
                </c:pt>
                <c:pt idx="700">
                  <c:v>4.26077</c:v>
                </c:pt>
                <c:pt idx="701">
                  <c:v>4.104019999999966</c:v>
                </c:pt>
                <c:pt idx="702">
                  <c:v>4.054759999999995</c:v>
                </c:pt>
                <c:pt idx="703">
                  <c:v>6.337409999999997</c:v>
                </c:pt>
                <c:pt idx="704">
                  <c:v>3.41638</c:v>
                </c:pt>
                <c:pt idx="705">
                  <c:v>5.49065</c:v>
                </c:pt>
                <c:pt idx="706">
                  <c:v>3.76494</c:v>
                </c:pt>
                <c:pt idx="707">
                  <c:v>4.555809999999997</c:v>
                </c:pt>
                <c:pt idx="708">
                  <c:v>5.84157</c:v>
                </c:pt>
                <c:pt idx="709">
                  <c:v>2.552109999999999</c:v>
                </c:pt>
                <c:pt idx="710">
                  <c:v>4.685099999999997</c:v>
                </c:pt>
                <c:pt idx="711">
                  <c:v>8.299910000000001</c:v>
                </c:pt>
                <c:pt idx="712">
                  <c:v>6.693529999999995</c:v>
                </c:pt>
                <c:pt idx="713">
                  <c:v>6.83466</c:v>
                </c:pt>
                <c:pt idx="714">
                  <c:v>2.84051</c:v>
                </c:pt>
                <c:pt idx="715">
                  <c:v>6.696379999999999</c:v>
                </c:pt>
                <c:pt idx="716">
                  <c:v>3.69864</c:v>
                </c:pt>
                <c:pt idx="717">
                  <c:v>6.68975</c:v>
                </c:pt>
                <c:pt idx="718">
                  <c:v>9.049110000000001</c:v>
                </c:pt>
                <c:pt idx="719">
                  <c:v>6.34309</c:v>
                </c:pt>
                <c:pt idx="720">
                  <c:v>4.29345</c:v>
                </c:pt>
                <c:pt idx="721">
                  <c:v>6.6869</c:v>
                </c:pt>
                <c:pt idx="722">
                  <c:v>4.37301</c:v>
                </c:pt>
                <c:pt idx="723">
                  <c:v>5.84536</c:v>
                </c:pt>
                <c:pt idx="724">
                  <c:v>3.90796</c:v>
                </c:pt>
                <c:pt idx="725">
                  <c:v>6.044729999999999</c:v>
                </c:pt>
                <c:pt idx="726">
                  <c:v>6.292889999999995</c:v>
                </c:pt>
                <c:pt idx="727">
                  <c:v>1.09444</c:v>
                </c:pt>
                <c:pt idx="728">
                  <c:v>1.90378</c:v>
                </c:pt>
                <c:pt idx="729">
                  <c:v>5.067749999999998</c:v>
                </c:pt>
                <c:pt idx="730">
                  <c:v>3.619549999999998</c:v>
                </c:pt>
                <c:pt idx="731">
                  <c:v>5.07674</c:v>
                </c:pt>
                <c:pt idx="732">
                  <c:v>3.43533</c:v>
                </c:pt>
                <c:pt idx="733">
                  <c:v>3.1687</c:v>
                </c:pt>
                <c:pt idx="734">
                  <c:v>5.520489999999985</c:v>
                </c:pt>
                <c:pt idx="735">
                  <c:v>4.27545</c:v>
                </c:pt>
                <c:pt idx="736">
                  <c:v>4.407579999999998</c:v>
                </c:pt>
                <c:pt idx="737">
                  <c:v>3.06309</c:v>
                </c:pt>
                <c:pt idx="738">
                  <c:v>2.69513</c:v>
                </c:pt>
                <c:pt idx="739">
                  <c:v>2.1131</c:v>
                </c:pt>
                <c:pt idx="740">
                  <c:v>3.42775</c:v>
                </c:pt>
                <c:pt idx="741">
                  <c:v>3.98373</c:v>
                </c:pt>
                <c:pt idx="742">
                  <c:v>4.8087</c:v>
                </c:pt>
                <c:pt idx="743">
                  <c:v>2.91487</c:v>
                </c:pt>
                <c:pt idx="744">
                  <c:v>2.27459</c:v>
                </c:pt>
                <c:pt idx="745">
                  <c:v>4.07323</c:v>
                </c:pt>
                <c:pt idx="746">
                  <c:v>4.93372</c:v>
                </c:pt>
                <c:pt idx="747">
                  <c:v>5.25007</c:v>
                </c:pt>
                <c:pt idx="748">
                  <c:v>4.113009999999996</c:v>
                </c:pt>
                <c:pt idx="749">
                  <c:v>7.30634</c:v>
                </c:pt>
                <c:pt idx="750">
                  <c:v>5.165299999999998</c:v>
                </c:pt>
                <c:pt idx="751">
                  <c:v>3.996039999999998</c:v>
                </c:pt>
                <c:pt idx="752">
                  <c:v>8.160200000000001</c:v>
                </c:pt>
                <c:pt idx="753">
                  <c:v>3.24732</c:v>
                </c:pt>
                <c:pt idx="754">
                  <c:v>5.86667</c:v>
                </c:pt>
                <c:pt idx="755">
                  <c:v>5.368469999999998</c:v>
                </c:pt>
                <c:pt idx="756">
                  <c:v>3.58308</c:v>
                </c:pt>
                <c:pt idx="757">
                  <c:v>7.47399</c:v>
                </c:pt>
                <c:pt idx="758">
                  <c:v>2.49386</c:v>
                </c:pt>
                <c:pt idx="759">
                  <c:v>5.665399999999995</c:v>
                </c:pt>
                <c:pt idx="760">
                  <c:v>3.69343</c:v>
                </c:pt>
                <c:pt idx="761">
                  <c:v>5.09332</c:v>
                </c:pt>
                <c:pt idx="762">
                  <c:v>3.36382</c:v>
                </c:pt>
                <c:pt idx="763">
                  <c:v>4.30908</c:v>
                </c:pt>
                <c:pt idx="764">
                  <c:v>5.334839999999994</c:v>
                </c:pt>
                <c:pt idx="765">
                  <c:v>5.64077</c:v>
                </c:pt>
                <c:pt idx="766">
                  <c:v>3.01905</c:v>
                </c:pt>
                <c:pt idx="767">
                  <c:v>2.53269</c:v>
                </c:pt>
                <c:pt idx="768">
                  <c:v>7.67337</c:v>
                </c:pt>
                <c:pt idx="769">
                  <c:v>4.992919999999994</c:v>
                </c:pt>
                <c:pt idx="770">
                  <c:v>5.80605</c:v>
                </c:pt>
                <c:pt idx="771">
                  <c:v>6.3303</c:v>
                </c:pt>
                <c:pt idx="772">
                  <c:v>6.30425</c:v>
                </c:pt>
                <c:pt idx="773">
                  <c:v>6.97958</c:v>
                </c:pt>
                <c:pt idx="774">
                  <c:v>6.767889999999975</c:v>
                </c:pt>
                <c:pt idx="775">
                  <c:v>5.96565</c:v>
                </c:pt>
                <c:pt idx="776">
                  <c:v>3.826499999999998</c:v>
                </c:pt>
                <c:pt idx="777">
                  <c:v>3.300829999999999</c:v>
                </c:pt>
                <c:pt idx="778">
                  <c:v>2.76143</c:v>
                </c:pt>
                <c:pt idx="779">
                  <c:v>4.642469999999998</c:v>
                </c:pt>
                <c:pt idx="780">
                  <c:v>6.55904</c:v>
                </c:pt>
                <c:pt idx="781">
                  <c:v>4.07702</c:v>
                </c:pt>
                <c:pt idx="782">
                  <c:v>2.996789999999998</c:v>
                </c:pt>
                <c:pt idx="783">
                  <c:v>4.71872</c:v>
                </c:pt>
                <c:pt idx="784">
                  <c:v>6.372919999999985</c:v>
                </c:pt>
                <c:pt idx="785">
                  <c:v>5.27943</c:v>
                </c:pt>
                <c:pt idx="786">
                  <c:v>5.897929999999985</c:v>
                </c:pt>
                <c:pt idx="787">
                  <c:v>4.51177</c:v>
                </c:pt>
                <c:pt idx="788">
                  <c:v>6.4468</c:v>
                </c:pt>
                <c:pt idx="789">
                  <c:v>6.30804</c:v>
                </c:pt>
                <c:pt idx="790">
                  <c:v>2.827249999999998</c:v>
                </c:pt>
                <c:pt idx="791">
                  <c:v>8.45713</c:v>
                </c:pt>
                <c:pt idx="792">
                  <c:v>4.023039999999996</c:v>
                </c:pt>
                <c:pt idx="793">
                  <c:v>3.80187</c:v>
                </c:pt>
                <c:pt idx="794">
                  <c:v>3.87859</c:v>
                </c:pt>
                <c:pt idx="795">
                  <c:v>2.67571</c:v>
                </c:pt>
                <c:pt idx="796">
                  <c:v>5.22261</c:v>
                </c:pt>
                <c:pt idx="797">
                  <c:v>5.762959999999984</c:v>
                </c:pt>
                <c:pt idx="798">
                  <c:v>2.18319</c:v>
                </c:pt>
                <c:pt idx="799">
                  <c:v>3.952949999999976</c:v>
                </c:pt>
                <c:pt idx="800">
                  <c:v>5.77906</c:v>
                </c:pt>
                <c:pt idx="801">
                  <c:v>2.338049999999956</c:v>
                </c:pt>
                <c:pt idx="802">
                  <c:v>2.73443</c:v>
                </c:pt>
                <c:pt idx="803">
                  <c:v>6.40655</c:v>
                </c:pt>
                <c:pt idx="804">
                  <c:v>3.3534</c:v>
                </c:pt>
                <c:pt idx="805">
                  <c:v>3.52104</c:v>
                </c:pt>
                <c:pt idx="806">
                  <c:v>5.564049999999995</c:v>
                </c:pt>
                <c:pt idx="807">
                  <c:v>3.895169999999998</c:v>
                </c:pt>
                <c:pt idx="808">
                  <c:v>7.067189999999965</c:v>
                </c:pt>
                <c:pt idx="809">
                  <c:v>4.067079999999986</c:v>
                </c:pt>
                <c:pt idx="810">
                  <c:v>4.769389999999999</c:v>
                </c:pt>
                <c:pt idx="811">
                  <c:v>6.99473</c:v>
                </c:pt>
                <c:pt idx="812">
                  <c:v>4.45304</c:v>
                </c:pt>
                <c:pt idx="813">
                  <c:v>3.813709999999999</c:v>
                </c:pt>
                <c:pt idx="814">
                  <c:v>3.071149999999998</c:v>
                </c:pt>
                <c:pt idx="815">
                  <c:v>2.53174</c:v>
                </c:pt>
                <c:pt idx="816">
                  <c:v>4.98724</c:v>
                </c:pt>
                <c:pt idx="817">
                  <c:v>4.00267</c:v>
                </c:pt>
                <c:pt idx="818">
                  <c:v>1.68025</c:v>
                </c:pt>
                <c:pt idx="819">
                  <c:v>1.88342</c:v>
                </c:pt>
                <c:pt idx="820">
                  <c:v>4.604589999999937</c:v>
                </c:pt>
                <c:pt idx="821">
                  <c:v>2.01838</c:v>
                </c:pt>
                <c:pt idx="822">
                  <c:v>3.64702</c:v>
                </c:pt>
                <c:pt idx="823">
                  <c:v>4.88116</c:v>
                </c:pt>
                <c:pt idx="824">
                  <c:v>2.87556</c:v>
                </c:pt>
                <c:pt idx="825">
                  <c:v>2.29779</c:v>
                </c:pt>
                <c:pt idx="826">
                  <c:v>3.816079999999952</c:v>
                </c:pt>
                <c:pt idx="827">
                  <c:v>2.517059999999999</c:v>
                </c:pt>
                <c:pt idx="828">
                  <c:v>5.08195</c:v>
                </c:pt>
                <c:pt idx="829">
                  <c:v>6.53347</c:v>
                </c:pt>
                <c:pt idx="830">
                  <c:v>3.36382</c:v>
                </c:pt>
                <c:pt idx="831">
                  <c:v>2.27412</c:v>
                </c:pt>
                <c:pt idx="832">
                  <c:v>3.59492</c:v>
                </c:pt>
                <c:pt idx="833">
                  <c:v>4.690779999999997</c:v>
                </c:pt>
                <c:pt idx="834">
                  <c:v>2.90681</c:v>
                </c:pt>
                <c:pt idx="835">
                  <c:v>2.93949</c:v>
                </c:pt>
                <c:pt idx="836">
                  <c:v>3.96384</c:v>
                </c:pt>
                <c:pt idx="837">
                  <c:v>2.43371</c:v>
                </c:pt>
                <c:pt idx="838">
                  <c:v>1.73613</c:v>
                </c:pt>
                <c:pt idx="839">
                  <c:v>2.8462</c:v>
                </c:pt>
                <c:pt idx="840">
                  <c:v>6.48753</c:v>
                </c:pt>
                <c:pt idx="841">
                  <c:v>6.344509999999977</c:v>
                </c:pt>
                <c:pt idx="842">
                  <c:v>3.90796</c:v>
                </c:pt>
                <c:pt idx="843">
                  <c:v>3.88712</c:v>
                </c:pt>
                <c:pt idx="844">
                  <c:v>3.72516</c:v>
                </c:pt>
                <c:pt idx="845">
                  <c:v>1.60353</c:v>
                </c:pt>
                <c:pt idx="846">
                  <c:v>1.95114</c:v>
                </c:pt>
                <c:pt idx="847">
                  <c:v>3.87338</c:v>
                </c:pt>
                <c:pt idx="848">
                  <c:v>2.10836</c:v>
                </c:pt>
                <c:pt idx="849">
                  <c:v>3.25916</c:v>
                </c:pt>
                <c:pt idx="850">
                  <c:v>2.408609999999999</c:v>
                </c:pt>
                <c:pt idx="851">
                  <c:v>1.87489</c:v>
                </c:pt>
                <c:pt idx="852">
                  <c:v>1.12285</c:v>
                </c:pt>
                <c:pt idx="853">
                  <c:v>1.50313</c:v>
                </c:pt>
                <c:pt idx="854">
                  <c:v>1.08165</c:v>
                </c:pt>
                <c:pt idx="855">
                  <c:v>1.45343</c:v>
                </c:pt>
                <c:pt idx="856">
                  <c:v>2.17324</c:v>
                </c:pt>
                <c:pt idx="857">
                  <c:v>2.96885</c:v>
                </c:pt>
                <c:pt idx="858">
                  <c:v>3.63802</c:v>
                </c:pt>
                <c:pt idx="859">
                  <c:v>7.06577</c:v>
                </c:pt>
                <c:pt idx="860">
                  <c:v>3.89943</c:v>
                </c:pt>
                <c:pt idx="861">
                  <c:v>5.91971</c:v>
                </c:pt>
                <c:pt idx="862">
                  <c:v>1.59359</c:v>
                </c:pt>
                <c:pt idx="863">
                  <c:v>3.67306</c:v>
                </c:pt>
                <c:pt idx="864">
                  <c:v>4.193999999999995</c:v>
                </c:pt>
                <c:pt idx="865">
                  <c:v>2.71028</c:v>
                </c:pt>
                <c:pt idx="866">
                  <c:v>2.79884</c:v>
                </c:pt>
                <c:pt idx="867">
                  <c:v>6.96158</c:v>
                </c:pt>
                <c:pt idx="868">
                  <c:v>2.49291</c:v>
                </c:pt>
                <c:pt idx="869">
                  <c:v>2.15193</c:v>
                </c:pt>
                <c:pt idx="870">
                  <c:v>3.01148</c:v>
                </c:pt>
                <c:pt idx="871">
                  <c:v>4.98913</c:v>
                </c:pt>
                <c:pt idx="872">
                  <c:v>3.15686</c:v>
                </c:pt>
                <c:pt idx="873">
                  <c:v>4.344119999999966</c:v>
                </c:pt>
                <c:pt idx="874">
                  <c:v>1.2133</c:v>
                </c:pt>
                <c:pt idx="875">
                  <c:v>3.826029999999998</c:v>
                </c:pt>
                <c:pt idx="876">
                  <c:v>5.76959</c:v>
                </c:pt>
                <c:pt idx="877">
                  <c:v>3.42254</c:v>
                </c:pt>
                <c:pt idx="878">
                  <c:v>3.59824</c:v>
                </c:pt>
                <c:pt idx="879">
                  <c:v>4.312389999999985</c:v>
                </c:pt>
                <c:pt idx="880">
                  <c:v>4.93325</c:v>
                </c:pt>
                <c:pt idx="881">
                  <c:v>2.070949999999999</c:v>
                </c:pt>
                <c:pt idx="882">
                  <c:v>3.7943</c:v>
                </c:pt>
                <c:pt idx="883">
                  <c:v>4.93325</c:v>
                </c:pt>
                <c:pt idx="884">
                  <c:v>3.855389999999998</c:v>
                </c:pt>
                <c:pt idx="885">
                  <c:v>7.85332</c:v>
                </c:pt>
                <c:pt idx="886">
                  <c:v>4.34317</c:v>
                </c:pt>
                <c:pt idx="887">
                  <c:v>3.47132</c:v>
                </c:pt>
                <c:pt idx="888">
                  <c:v>1.72761</c:v>
                </c:pt>
                <c:pt idx="889">
                  <c:v>1.52113</c:v>
                </c:pt>
                <c:pt idx="890">
                  <c:v>5.062059999999994</c:v>
                </c:pt>
                <c:pt idx="891">
                  <c:v>3.09388</c:v>
                </c:pt>
                <c:pt idx="892">
                  <c:v>3.90322</c:v>
                </c:pt>
                <c:pt idx="893">
                  <c:v>3.889489999999998</c:v>
                </c:pt>
                <c:pt idx="894">
                  <c:v>2.2135</c:v>
                </c:pt>
                <c:pt idx="895">
                  <c:v>2.63972</c:v>
                </c:pt>
                <c:pt idx="896">
                  <c:v>3.472739999999999</c:v>
                </c:pt>
                <c:pt idx="897">
                  <c:v>2.98259</c:v>
                </c:pt>
                <c:pt idx="898">
                  <c:v>2.26464</c:v>
                </c:pt>
                <c:pt idx="899">
                  <c:v>3.01953</c:v>
                </c:pt>
                <c:pt idx="900">
                  <c:v>3.445269999999998</c:v>
                </c:pt>
                <c:pt idx="901">
                  <c:v>2.60941</c:v>
                </c:pt>
                <c:pt idx="902">
                  <c:v>1.63526</c:v>
                </c:pt>
                <c:pt idx="903">
                  <c:v>1.05466</c:v>
                </c:pt>
                <c:pt idx="904">
                  <c:v>3.4287</c:v>
                </c:pt>
                <c:pt idx="905">
                  <c:v>2.69702</c:v>
                </c:pt>
                <c:pt idx="906">
                  <c:v>2.101259999999999</c:v>
                </c:pt>
                <c:pt idx="907">
                  <c:v>1.42026</c:v>
                </c:pt>
                <c:pt idx="908">
                  <c:v>1.36201</c:v>
                </c:pt>
                <c:pt idx="909">
                  <c:v>1.48466</c:v>
                </c:pt>
                <c:pt idx="910">
                  <c:v>2.08847</c:v>
                </c:pt>
                <c:pt idx="911">
                  <c:v>2.63309</c:v>
                </c:pt>
                <c:pt idx="912">
                  <c:v>1.36674</c:v>
                </c:pt>
                <c:pt idx="913">
                  <c:v>1.31796</c:v>
                </c:pt>
                <c:pt idx="914">
                  <c:v>1.38569</c:v>
                </c:pt>
                <c:pt idx="915">
                  <c:v>2.23102</c:v>
                </c:pt>
                <c:pt idx="916">
                  <c:v>1.77781</c:v>
                </c:pt>
                <c:pt idx="917">
                  <c:v>3.2871</c:v>
                </c:pt>
                <c:pt idx="918">
                  <c:v>3.31598</c:v>
                </c:pt>
                <c:pt idx="919">
                  <c:v>1.855</c:v>
                </c:pt>
                <c:pt idx="920">
                  <c:v>2.91297</c:v>
                </c:pt>
                <c:pt idx="921">
                  <c:v>5.90503</c:v>
                </c:pt>
                <c:pt idx="922">
                  <c:v>2.49338</c:v>
                </c:pt>
                <c:pt idx="923">
                  <c:v>2.2135</c:v>
                </c:pt>
                <c:pt idx="924">
                  <c:v>1.60448</c:v>
                </c:pt>
                <c:pt idx="925">
                  <c:v>2.04396</c:v>
                </c:pt>
                <c:pt idx="926">
                  <c:v>2.377359999999999</c:v>
                </c:pt>
                <c:pt idx="927">
                  <c:v>1.5628</c:v>
                </c:pt>
                <c:pt idx="928">
                  <c:v>2.46828</c:v>
                </c:pt>
                <c:pt idx="929">
                  <c:v>1.77781</c:v>
                </c:pt>
                <c:pt idx="930">
                  <c:v>3.28141</c:v>
                </c:pt>
                <c:pt idx="931">
                  <c:v>1.18299</c:v>
                </c:pt>
                <c:pt idx="932">
                  <c:v>1.37669</c:v>
                </c:pt>
                <c:pt idx="933">
                  <c:v>2.712649999999976</c:v>
                </c:pt>
                <c:pt idx="934">
                  <c:v>3.31409</c:v>
                </c:pt>
                <c:pt idx="935">
                  <c:v>2.24807</c:v>
                </c:pt>
                <c:pt idx="936">
                  <c:v>3.482209999999998</c:v>
                </c:pt>
                <c:pt idx="937">
                  <c:v>1.65562</c:v>
                </c:pt>
                <c:pt idx="938">
                  <c:v>2.920069999999999</c:v>
                </c:pt>
                <c:pt idx="939">
                  <c:v>3.49263</c:v>
                </c:pt>
                <c:pt idx="940">
                  <c:v>2.32574</c:v>
                </c:pt>
                <c:pt idx="941">
                  <c:v>1.55665</c:v>
                </c:pt>
                <c:pt idx="942">
                  <c:v>3.0702</c:v>
                </c:pt>
                <c:pt idx="943">
                  <c:v>2.28169</c:v>
                </c:pt>
                <c:pt idx="944">
                  <c:v>3.08014</c:v>
                </c:pt>
                <c:pt idx="945">
                  <c:v>3.36808</c:v>
                </c:pt>
                <c:pt idx="946">
                  <c:v>4.13196</c:v>
                </c:pt>
                <c:pt idx="947">
                  <c:v>5.152989999999964</c:v>
                </c:pt>
                <c:pt idx="948">
                  <c:v>5.89035</c:v>
                </c:pt>
                <c:pt idx="949">
                  <c:v>5.021809999999999</c:v>
                </c:pt>
                <c:pt idx="950">
                  <c:v>3.21559</c:v>
                </c:pt>
                <c:pt idx="951">
                  <c:v>2.72828</c:v>
                </c:pt>
                <c:pt idx="952">
                  <c:v>3.372339999999999</c:v>
                </c:pt>
                <c:pt idx="953">
                  <c:v>3.73557</c:v>
                </c:pt>
                <c:pt idx="954">
                  <c:v>4.814859999999975</c:v>
                </c:pt>
                <c:pt idx="955">
                  <c:v>3.02284</c:v>
                </c:pt>
                <c:pt idx="956">
                  <c:v>3.08488</c:v>
                </c:pt>
                <c:pt idx="957">
                  <c:v>2.22865</c:v>
                </c:pt>
                <c:pt idx="958">
                  <c:v>6.78825</c:v>
                </c:pt>
                <c:pt idx="959">
                  <c:v>3.46564</c:v>
                </c:pt>
                <c:pt idx="960">
                  <c:v>2.63356</c:v>
                </c:pt>
                <c:pt idx="961">
                  <c:v>5.11937</c:v>
                </c:pt>
                <c:pt idx="962">
                  <c:v>4.315709999999997</c:v>
                </c:pt>
                <c:pt idx="963">
                  <c:v>3.582609999999999</c:v>
                </c:pt>
                <c:pt idx="964">
                  <c:v>3.60771</c:v>
                </c:pt>
                <c:pt idx="965">
                  <c:v>1.97813</c:v>
                </c:pt>
                <c:pt idx="966">
                  <c:v>4.159429999999999</c:v>
                </c:pt>
                <c:pt idx="967">
                  <c:v>5.191819999999995</c:v>
                </c:pt>
                <c:pt idx="968">
                  <c:v>5.108949999999997</c:v>
                </c:pt>
                <c:pt idx="969">
                  <c:v>4.23709</c:v>
                </c:pt>
                <c:pt idx="970">
                  <c:v>6.052789999999995</c:v>
                </c:pt>
                <c:pt idx="971">
                  <c:v>5.137839999999994</c:v>
                </c:pt>
                <c:pt idx="972">
                  <c:v>4.0003</c:v>
                </c:pt>
                <c:pt idx="973">
                  <c:v>2.891189999999999</c:v>
                </c:pt>
                <c:pt idx="974">
                  <c:v>3.035629999999998</c:v>
                </c:pt>
                <c:pt idx="975">
                  <c:v>2.515639999999999</c:v>
                </c:pt>
                <c:pt idx="976">
                  <c:v>1.65847</c:v>
                </c:pt>
                <c:pt idx="977">
                  <c:v>2.21302</c:v>
                </c:pt>
                <c:pt idx="978">
                  <c:v>4.095489999999994</c:v>
                </c:pt>
                <c:pt idx="979">
                  <c:v>6.45722</c:v>
                </c:pt>
                <c:pt idx="980">
                  <c:v>3.335399999999999</c:v>
                </c:pt>
                <c:pt idx="981">
                  <c:v>2.72922</c:v>
                </c:pt>
                <c:pt idx="982">
                  <c:v>2.86561</c:v>
                </c:pt>
                <c:pt idx="983">
                  <c:v>3.43106</c:v>
                </c:pt>
                <c:pt idx="984">
                  <c:v>4.73387</c:v>
                </c:pt>
                <c:pt idx="985">
                  <c:v>5.83589</c:v>
                </c:pt>
                <c:pt idx="986">
                  <c:v>7.74393</c:v>
                </c:pt>
                <c:pt idx="987">
                  <c:v>5.10184</c:v>
                </c:pt>
                <c:pt idx="988">
                  <c:v>3.00863</c:v>
                </c:pt>
                <c:pt idx="989">
                  <c:v>4.87358</c:v>
                </c:pt>
                <c:pt idx="990">
                  <c:v>7.06387</c:v>
                </c:pt>
                <c:pt idx="991">
                  <c:v>6.517839999999985</c:v>
                </c:pt>
                <c:pt idx="992">
                  <c:v>10.0067</c:v>
                </c:pt>
                <c:pt idx="993">
                  <c:v>8.25492</c:v>
                </c:pt>
                <c:pt idx="994">
                  <c:v>4.621159999999985</c:v>
                </c:pt>
                <c:pt idx="995">
                  <c:v>4.39337</c:v>
                </c:pt>
                <c:pt idx="996">
                  <c:v>7.29166</c:v>
                </c:pt>
                <c:pt idx="997">
                  <c:v>6.28484</c:v>
                </c:pt>
                <c:pt idx="998">
                  <c:v>5.630829999999999</c:v>
                </c:pt>
                <c:pt idx="999">
                  <c:v>3.71758</c:v>
                </c:pt>
                <c:pt idx="1000">
                  <c:v>7.688989999999975</c:v>
                </c:pt>
                <c:pt idx="1001">
                  <c:v>6.835129999999999</c:v>
                </c:pt>
                <c:pt idx="1002">
                  <c:v>4.654309999999985</c:v>
                </c:pt>
                <c:pt idx="1003">
                  <c:v>4.97682</c:v>
                </c:pt>
                <c:pt idx="1004">
                  <c:v>9.400500000000002</c:v>
                </c:pt>
                <c:pt idx="1005">
                  <c:v>3.87717</c:v>
                </c:pt>
                <c:pt idx="1006">
                  <c:v>5.60336</c:v>
                </c:pt>
                <c:pt idx="1007">
                  <c:v>8.150260000000001</c:v>
                </c:pt>
                <c:pt idx="1008">
                  <c:v>3.996509999999998</c:v>
                </c:pt>
                <c:pt idx="1009">
                  <c:v>9.992470000000002</c:v>
                </c:pt>
                <c:pt idx="1010">
                  <c:v>8.67735</c:v>
                </c:pt>
                <c:pt idx="1011">
                  <c:v>7.26183</c:v>
                </c:pt>
                <c:pt idx="1012">
                  <c:v>3.68159</c:v>
                </c:pt>
                <c:pt idx="1013">
                  <c:v>5.63983</c:v>
                </c:pt>
                <c:pt idx="1014">
                  <c:v>3.83313</c:v>
                </c:pt>
                <c:pt idx="1015">
                  <c:v>6.41223</c:v>
                </c:pt>
                <c:pt idx="1016">
                  <c:v>3.07209</c:v>
                </c:pt>
                <c:pt idx="1017">
                  <c:v>5.44897</c:v>
                </c:pt>
                <c:pt idx="1018">
                  <c:v>5.630829999999999</c:v>
                </c:pt>
                <c:pt idx="1019">
                  <c:v>8.818470000000001</c:v>
                </c:pt>
                <c:pt idx="1020">
                  <c:v>4.35833</c:v>
                </c:pt>
                <c:pt idx="1021">
                  <c:v>5.27091</c:v>
                </c:pt>
                <c:pt idx="1022">
                  <c:v>6.64807</c:v>
                </c:pt>
                <c:pt idx="1023">
                  <c:v>3.97094</c:v>
                </c:pt>
                <c:pt idx="1024">
                  <c:v>4.80349</c:v>
                </c:pt>
                <c:pt idx="1025">
                  <c:v>4.93136</c:v>
                </c:pt>
                <c:pt idx="1026">
                  <c:v>4.79544</c:v>
                </c:pt>
                <c:pt idx="1027">
                  <c:v>4.695989999999964</c:v>
                </c:pt>
                <c:pt idx="1028">
                  <c:v>6.640969999999998</c:v>
                </c:pt>
                <c:pt idx="1029">
                  <c:v>5.9576</c:v>
                </c:pt>
                <c:pt idx="1030">
                  <c:v>4.48335</c:v>
                </c:pt>
                <c:pt idx="1031">
                  <c:v>6.29147</c:v>
                </c:pt>
                <c:pt idx="1032">
                  <c:v>6.174969999999997</c:v>
                </c:pt>
                <c:pt idx="1033">
                  <c:v>6.40229</c:v>
                </c:pt>
                <c:pt idx="1034">
                  <c:v>7.25946</c:v>
                </c:pt>
                <c:pt idx="1035">
                  <c:v>5.96139</c:v>
                </c:pt>
                <c:pt idx="1036">
                  <c:v>4.825749999999997</c:v>
                </c:pt>
                <c:pt idx="1037">
                  <c:v>4.823849999999997</c:v>
                </c:pt>
                <c:pt idx="1038">
                  <c:v>6.45959</c:v>
                </c:pt>
                <c:pt idx="1039">
                  <c:v>7.151959999999995</c:v>
                </c:pt>
                <c:pt idx="1040">
                  <c:v>9.38724</c:v>
                </c:pt>
                <c:pt idx="1041">
                  <c:v>8.78674</c:v>
                </c:pt>
                <c:pt idx="1042">
                  <c:v>11.2318</c:v>
                </c:pt>
                <c:pt idx="1043">
                  <c:v>3.701</c:v>
                </c:pt>
                <c:pt idx="1044">
                  <c:v>4.07986</c:v>
                </c:pt>
                <c:pt idx="1045">
                  <c:v>4.48714</c:v>
                </c:pt>
                <c:pt idx="1046">
                  <c:v>10.4708</c:v>
                </c:pt>
                <c:pt idx="1047">
                  <c:v>7.822069999999996</c:v>
                </c:pt>
                <c:pt idx="1048">
                  <c:v>4.67935</c:v>
                </c:pt>
                <c:pt idx="1049">
                  <c:v>5.610459999999985</c:v>
                </c:pt>
                <c:pt idx="1050">
                  <c:v>4.9915</c:v>
                </c:pt>
                <c:pt idx="1051">
                  <c:v>6.98952</c:v>
                </c:pt>
                <c:pt idx="1052">
                  <c:v>6.663699999999999</c:v>
                </c:pt>
                <c:pt idx="1053">
                  <c:v>5.09</c:v>
                </c:pt>
                <c:pt idx="1054">
                  <c:v>8.792900000000001</c:v>
                </c:pt>
                <c:pt idx="1055">
                  <c:v>4.044819999999985</c:v>
                </c:pt>
                <c:pt idx="1056">
                  <c:v>3.922159999999999</c:v>
                </c:pt>
                <c:pt idx="1057">
                  <c:v>8.97523</c:v>
                </c:pt>
                <c:pt idx="1058">
                  <c:v>8.567950000000001</c:v>
                </c:pt>
                <c:pt idx="1059">
                  <c:v>8.95771</c:v>
                </c:pt>
                <c:pt idx="1060">
                  <c:v>4.92804</c:v>
                </c:pt>
                <c:pt idx="1061">
                  <c:v>5.07343</c:v>
                </c:pt>
                <c:pt idx="1062">
                  <c:v>8.045120000000001</c:v>
                </c:pt>
                <c:pt idx="1063">
                  <c:v>8.19098</c:v>
                </c:pt>
                <c:pt idx="1064">
                  <c:v>4.444989999999994</c:v>
                </c:pt>
                <c:pt idx="1065">
                  <c:v>3.84402</c:v>
                </c:pt>
                <c:pt idx="1066">
                  <c:v>4.76276</c:v>
                </c:pt>
                <c:pt idx="1067">
                  <c:v>4.177889999999985</c:v>
                </c:pt>
                <c:pt idx="1068">
                  <c:v>7.567279999999998</c:v>
                </c:pt>
                <c:pt idx="1069">
                  <c:v>7.391109999999998</c:v>
                </c:pt>
                <c:pt idx="1070">
                  <c:v>7.260879999999998</c:v>
                </c:pt>
                <c:pt idx="1071">
                  <c:v>6.220909999999995</c:v>
                </c:pt>
                <c:pt idx="1072">
                  <c:v>6.03195</c:v>
                </c:pt>
                <c:pt idx="1073">
                  <c:v>7.08187</c:v>
                </c:pt>
                <c:pt idx="1074">
                  <c:v>7.806909999999998</c:v>
                </c:pt>
                <c:pt idx="1075">
                  <c:v>3.676849999999952</c:v>
                </c:pt>
                <c:pt idx="1076">
                  <c:v>5.129779999999998</c:v>
                </c:pt>
                <c:pt idx="1077">
                  <c:v>3.35766</c:v>
                </c:pt>
                <c:pt idx="1078">
                  <c:v>5.547949999999997</c:v>
                </c:pt>
                <c:pt idx="1079">
                  <c:v>4.7083</c:v>
                </c:pt>
                <c:pt idx="1080">
                  <c:v>6.21285</c:v>
                </c:pt>
                <c:pt idx="1081">
                  <c:v>4.310499999999998</c:v>
                </c:pt>
                <c:pt idx="1082">
                  <c:v>5.25954</c:v>
                </c:pt>
                <c:pt idx="1083">
                  <c:v>7.190319999999994</c:v>
                </c:pt>
                <c:pt idx="1084">
                  <c:v>7.19174</c:v>
                </c:pt>
                <c:pt idx="1085">
                  <c:v>5.892719999999985</c:v>
                </c:pt>
                <c:pt idx="1086">
                  <c:v>6.07173</c:v>
                </c:pt>
                <c:pt idx="1087">
                  <c:v>5.645509999999985</c:v>
                </c:pt>
                <c:pt idx="1088">
                  <c:v>5.196079999999998</c:v>
                </c:pt>
                <c:pt idx="1089">
                  <c:v>3.299879999999999</c:v>
                </c:pt>
                <c:pt idx="1090">
                  <c:v>5.061119999999995</c:v>
                </c:pt>
                <c:pt idx="1091">
                  <c:v>3.27952</c:v>
                </c:pt>
                <c:pt idx="1092">
                  <c:v>5.48023</c:v>
                </c:pt>
                <c:pt idx="1093">
                  <c:v>2.73727</c:v>
                </c:pt>
                <c:pt idx="1094">
                  <c:v>2.32432</c:v>
                </c:pt>
                <c:pt idx="1095">
                  <c:v>4.837109999999996</c:v>
                </c:pt>
                <c:pt idx="1096">
                  <c:v>5.01328</c:v>
                </c:pt>
                <c:pt idx="1097">
                  <c:v>5.43856</c:v>
                </c:pt>
                <c:pt idx="1098">
                  <c:v>3.718049999999998</c:v>
                </c:pt>
                <c:pt idx="1099">
                  <c:v>2.512799999999999</c:v>
                </c:pt>
                <c:pt idx="1100">
                  <c:v>7.96225</c:v>
                </c:pt>
                <c:pt idx="1101">
                  <c:v>3.416859999999952</c:v>
                </c:pt>
                <c:pt idx="1102">
                  <c:v>6.727159999999984</c:v>
                </c:pt>
                <c:pt idx="1103">
                  <c:v>2.4877</c:v>
                </c:pt>
                <c:pt idx="1104">
                  <c:v>6.74373</c:v>
                </c:pt>
                <c:pt idx="1105">
                  <c:v>8.33211</c:v>
                </c:pt>
                <c:pt idx="1106">
                  <c:v>2.59378</c:v>
                </c:pt>
                <c:pt idx="1107">
                  <c:v>3.40123</c:v>
                </c:pt>
                <c:pt idx="1108">
                  <c:v>3.01716</c:v>
                </c:pt>
                <c:pt idx="1109">
                  <c:v>5.092849999999999</c:v>
                </c:pt>
                <c:pt idx="1110">
                  <c:v>3.06878</c:v>
                </c:pt>
                <c:pt idx="1111">
                  <c:v>1.5988</c:v>
                </c:pt>
                <c:pt idx="1112">
                  <c:v>5.3912</c:v>
                </c:pt>
                <c:pt idx="1113">
                  <c:v>3.94726</c:v>
                </c:pt>
                <c:pt idx="1114">
                  <c:v>3.68348</c:v>
                </c:pt>
                <c:pt idx="1115">
                  <c:v>4.56149</c:v>
                </c:pt>
                <c:pt idx="1116">
                  <c:v>2.66671</c:v>
                </c:pt>
                <c:pt idx="1117">
                  <c:v>2.490069999999998</c:v>
                </c:pt>
                <c:pt idx="1118">
                  <c:v>2.57578</c:v>
                </c:pt>
                <c:pt idx="1119">
                  <c:v>2.4536</c:v>
                </c:pt>
                <c:pt idx="1120">
                  <c:v>2.73491</c:v>
                </c:pt>
                <c:pt idx="1121">
                  <c:v>3.80708</c:v>
                </c:pt>
                <c:pt idx="1122">
                  <c:v>1.60069</c:v>
                </c:pt>
                <c:pt idx="1123">
                  <c:v>4.29629</c:v>
                </c:pt>
                <c:pt idx="1124">
                  <c:v>3.7673</c:v>
                </c:pt>
                <c:pt idx="1125">
                  <c:v>2.77895</c:v>
                </c:pt>
                <c:pt idx="1126">
                  <c:v>1.86163</c:v>
                </c:pt>
                <c:pt idx="1127">
                  <c:v>1.62058</c:v>
                </c:pt>
                <c:pt idx="1128">
                  <c:v>5.85862</c:v>
                </c:pt>
                <c:pt idx="1129">
                  <c:v>2.14009</c:v>
                </c:pt>
                <c:pt idx="1130">
                  <c:v>6.42644</c:v>
                </c:pt>
                <c:pt idx="1131">
                  <c:v>5.600049999999999</c:v>
                </c:pt>
                <c:pt idx="1132">
                  <c:v>2.959859999999952</c:v>
                </c:pt>
                <c:pt idx="1133">
                  <c:v>2.57484</c:v>
                </c:pt>
                <c:pt idx="1134">
                  <c:v>5.742119999999994</c:v>
                </c:pt>
                <c:pt idx="1135">
                  <c:v>1.35254</c:v>
                </c:pt>
                <c:pt idx="1136">
                  <c:v>1.33407</c:v>
                </c:pt>
                <c:pt idx="1137">
                  <c:v>2.5289</c:v>
                </c:pt>
                <c:pt idx="1138">
                  <c:v>2.307269999999999</c:v>
                </c:pt>
                <c:pt idx="1139">
                  <c:v>1.69635</c:v>
                </c:pt>
                <c:pt idx="1140">
                  <c:v>4.364009999999975</c:v>
                </c:pt>
                <c:pt idx="1141">
                  <c:v>1.91514</c:v>
                </c:pt>
                <c:pt idx="1142">
                  <c:v>1.9284</c:v>
                </c:pt>
                <c:pt idx="1143">
                  <c:v>3.64039</c:v>
                </c:pt>
                <c:pt idx="1144">
                  <c:v>1.76786</c:v>
                </c:pt>
                <c:pt idx="1145">
                  <c:v>1.31086</c:v>
                </c:pt>
                <c:pt idx="1146">
                  <c:v>2.12399</c:v>
                </c:pt>
                <c:pt idx="1147">
                  <c:v>1.06886</c:v>
                </c:pt>
                <c:pt idx="1148">
                  <c:v>2.16283</c:v>
                </c:pt>
                <c:pt idx="1149">
                  <c:v>1.25356</c:v>
                </c:pt>
                <c:pt idx="1150">
                  <c:v>1.32886</c:v>
                </c:pt>
                <c:pt idx="1151">
                  <c:v>3.8336</c:v>
                </c:pt>
                <c:pt idx="1152">
                  <c:v>4.98392</c:v>
                </c:pt>
                <c:pt idx="1153">
                  <c:v>2.441759999999999</c:v>
                </c:pt>
                <c:pt idx="1154">
                  <c:v>1.49177</c:v>
                </c:pt>
                <c:pt idx="1155">
                  <c:v>2.1633</c:v>
                </c:pt>
                <c:pt idx="1156">
                  <c:v>2.488649999999998</c:v>
                </c:pt>
                <c:pt idx="1157">
                  <c:v>2.69702</c:v>
                </c:pt>
                <c:pt idx="1158">
                  <c:v>2.98306</c:v>
                </c:pt>
                <c:pt idx="1159">
                  <c:v>3.032789999999999</c:v>
                </c:pt>
                <c:pt idx="1160">
                  <c:v>1.72571</c:v>
                </c:pt>
                <c:pt idx="1161">
                  <c:v>1.28197</c:v>
                </c:pt>
                <c:pt idx="1162">
                  <c:v>4.47435</c:v>
                </c:pt>
                <c:pt idx="1163">
                  <c:v>2.370249999999956</c:v>
                </c:pt>
                <c:pt idx="1164">
                  <c:v>4.965929999999997</c:v>
                </c:pt>
                <c:pt idx="1165">
                  <c:v>3.552299999999998</c:v>
                </c:pt>
                <c:pt idx="1166">
                  <c:v>4.150429999999996</c:v>
                </c:pt>
                <c:pt idx="1167">
                  <c:v>1.60164</c:v>
                </c:pt>
                <c:pt idx="1168">
                  <c:v>1.21141</c:v>
                </c:pt>
                <c:pt idx="1169">
                  <c:v>1.75697</c:v>
                </c:pt>
                <c:pt idx="1170">
                  <c:v>2.49764</c:v>
                </c:pt>
                <c:pt idx="1171">
                  <c:v>1.74182</c:v>
                </c:pt>
                <c:pt idx="1172">
                  <c:v>2.14151</c:v>
                </c:pt>
                <c:pt idx="1173">
                  <c:v>1.21046</c:v>
                </c:pt>
                <c:pt idx="1174">
                  <c:v>1.34969</c:v>
                </c:pt>
                <c:pt idx="1175">
                  <c:v>2.44318</c:v>
                </c:pt>
                <c:pt idx="1176">
                  <c:v>2.41714</c:v>
                </c:pt>
                <c:pt idx="1177">
                  <c:v>0.955204</c:v>
                </c:pt>
                <c:pt idx="1178">
                  <c:v>2.15288</c:v>
                </c:pt>
                <c:pt idx="1179">
                  <c:v>1.61584</c:v>
                </c:pt>
                <c:pt idx="1180">
                  <c:v>0.811237</c:v>
                </c:pt>
                <c:pt idx="1181">
                  <c:v>3.09814</c:v>
                </c:pt>
                <c:pt idx="1182">
                  <c:v>0.963729</c:v>
                </c:pt>
                <c:pt idx="1183">
                  <c:v>1.49887</c:v>
                </c:pt>
                <c:pt idx="1184">
                  <c:v>1.72903</c:v>
                </c:pt>
                <c:pt idx="1185">
                  <c:v>2.86751</c:v>
                </c:pt>
                <c:pt idx="1186">
                  <c:v>0.944786</c:v>
                </c:pt>
                <c:pt idx="1187">
                  <c:v>0.884168</c:v>
                </c:pt>
                <c:pt idx="1188">
                  <c:v>2.1453</c:v>
                </c:pt>
                <c:pt idx="1189">
                  <c:v>1.16121</c:v>
                </c:pt>
                <c:pt idx="1190">
                  <c:v>1.31039</c:v>
                </c:pt>
                <c:pt idx="1191">
                  <c:v>1.91799</c:v>
                </c:pt>
                <c:pt idx="1192">
                  <c:v>1.35206</c:v>
                </c:pt>
                <c:pt idx="1193">
                  <c:v>1.8711</c:v>
                </c:pt>
                <c:pt idx="1194">
                  <c:v>1.9284</c:v>
                </c:pt>
                <c:pt idx="1195">
                  <c:v>1.35206</c:v>
                </c:pt>
                <c:pt idx="1196">
                  <c:v>3.63233</c:v>
                </c:pt>
                <c:pt idx="1197">
                  <c:v>1.21141</c:v>
                </c:pt>
                <c:pt idx="1198">
                  <c:v>2.85093</c:v>
                </c:pt>
                <c:pt idx="1199">
                  <c:v>1.1721</c:v>
                </c:pt>
                <c:pt idx="1200">
                  <c:v>3.15355</c:v>
                </c:pt>
                <c:pt idx="1201">
                  <c:v>2.46355</c:v>
                </c:pt>
                <c:pt idx="1202">
                  <c:v>1.51213</c:v>
                </c:pt>
                <c:pt idx="1203">
                  <c:v>3.64891</c:v>
                </c:pt>
                <c:pt idx="1204">
                  <c:v>2.88124</c:v>
                </c:pt>
                <c:pt idx="1205">
                  <c:v>1.56328</c:v>
                </c:pt>
                <c:pt idx="1206">
                  <c:v>1.97766</c:v>
                </c:pt>
                <c:pt idx="1207">
                  <c:v>1.46856</c:v>
                </c:pt>
                <c:pt idx="1208">
                  <c:v>1.54954</c:v>
                </c:pt>
                <c:pt idx="1209">
                  <c:v>2.75953</c:v>
                </c:pt>
                <c:pt idx="1210">
                  <c:v>2.39961</c:v>
                </c:pt>
                <c:pt idx="1211">
                  <c:v>2.90018</c:v>
                </c:pt>
                <c:pt idx="1212">
                  <c:v>1.73992</c:v>
                </c:pt>
                <c:pt idx="1213">
                  <c:v>2.307269999999999</c:v>
                </c:pt>
                <c:pt idx="1214">
                  <c:v>2.12447</c:v>
                </c:pt>
                <c:pt idx="1215">
                  <c:v>2.682809999999998</c:v>
                </c:pt>
                <c:pt idx="1216">
                  <c:v>1.9303</c:v>
                </c:pt>
                <c:pt idx="1217">
                  <c:v>3.53478</c:v>
                </c:pt>
                <c:pt idx="1218">
                  <c:v>2.26654</c:v>
                </c:pt>
                <c:pt idx="1219">
                  <c:v>4.32376</c:v>
                </c:pt>
                <c:pt idx="1220">
                  <c:v>2.87461</c:v>
                </c:pt>
                <c:pt idx="1221">
                  <c:v>3.276679999999998</c:v>
                </c:pt>
                <c:pt idx="1222">
                  <c:v>3.820819999999999</c:v>
                </c:pt>
                <c:pt idx="1223">
                  <c:v>6.2318</c:v>
                </c:pt>
                <c:pt idx="1224">
                  <c:v>2.24523</c:v>
                </c:pt>
                <c:pt idx="1225">
                  <c:v>2.60088</c:v>
                </c:pt>
                <c:pt idx="1226">
                  <c:v>2.62598</c:v>
                </c:pt>
                <c:pt idx="1227">
                  <c:v>3.823659999999998</c:v>
                </c:pt>
                <c:pt idx="1228">
                  <c:v>1.87394</c:v>
                </c:pt>
                <c:pt idx="1229">
                  <c:v>4.93088</c:v>
                </c:pt>
                <c:pt idx="1230">
                  <c:v>1.21188</c:v>
                </c:pt>
                <c:pt idx="1231">
                  <c:v>4.113959999999985</c:v>
                </c:pt>
                <c:pt idx="1232">
                  <c:v>3.42065</c:v>
                </c:pt>
                <c:pt idx="1233">
                  <c:v>3.28236</c:v>
                </c:pt>
                <c:pt idx="1234">
                  <c:v>3.76541</c:v>
                </c:pt>
                <c:pt idx="1235">
                  <c:v>3.44811</c:v>
                </c:pt>
                <c:pt idx="1236">
                  <c:v>4.297709999999999</c:v>
                </c:pt>
                <c:pt idx="1237">
                  <c:v>2.22581</c:v>
                </c:pt>
                <c:pt idx="1238">
                  <c:v>2.410029999999999</c:v>
                </c:pt>
                <c:pt idx="1239">
                  <c:v>4.625899999999976</c:v>
                </c:pt>
                <c:pt idx="1240">
                  <c:v>3.87291</c:v>
                </c:pt>
                <c:pt idx="1241">
                  <c:v>4.24041</c:v>
                </c:pt>
                <c:pt idx="1242">
                  <c:v>5.16625</c:v>
                </c:pt>
                <c:pt idx="1243">
                  <c:v>6.08357</c:v>
                </c:pt>
                <c:pt idx="1244">
                  <c:v>1.70251</c:v>
                </c:pt>
                <c:pt idx="1245">
                  <c:v>2.77137</c:v>
                </c:pt>
                <c:pt idx="1246">
                  <c:v>1.96866</c:v>
                </c:pt>
                <c:pt idx="1247">
                  <c:v>2.52369</c:v>
                </c:pt>
                <c:pt idx="1248">
                  <c:v>2.15193</c:v>
                </c:pt>
                <c:pt idx="1249">
                  <c:v>4.067549999999986</c:v>
                </c:pt>
                <c:pt idx="1250">
                  <c:v>4.418</c:v>
                </c:pt>
                <c:pt idx="1251">
                  <c:v>5.38694</c:v>
                </c:pt>
                <c:pt idx="1252">
                  <c:v>4.73293</c:v>
                </c:pt>
                <c:pt idx="1253">
                  <c:v>2.304899999999999</c:v>
                </c:pt>
                <c:pt idx="1254">
                  <c:v>3.48979</c:v>
                </c:pt>
                <c:pt idx="1255">
                  <c:v>3.66548</c:v>
                </c:pt>
                <c:pt idx="1256">
                  <c:v>2.79316</c:v>
                </c:pt>
                <c:pt idx="1257">
                  <c:v>1.81854</c:v>
                </c:pt>
                <c:pt idx="1258">
                  <c:v>4.382009999999997</c:v>
                </c:pt>
                <c:pt idx="1259">
                  <c:v>2.339469999999952</c:v>
                </c:pt>
                <c:pt idx="1260">
                  <c:v>3.956259999999952</c:v>
                </c:pt>
                <c:pt idx="1261">
                  <c:v>3.78577</c:v>
                </c:pt>
                <c:pt idx="1262">
                  <c:v>6.692109999999975</c:v>
                </c:pt>
                <c:pt idx="1263">
                  <c:v>3.83787</c:v>
                </c:pt>
                <c:pt idx="1264">
                  <c:v>5.262389999999995</c:v>
                </c:pt>
                <c:pt idx="1265">
                  <c:v>3.83787</c:v>
                </c:pt>
                <c:pt idx="1266">
                  <c:v>2.815409999999956</c:v>
                </c:pt>
                <c:pt idx="1267">
                  <c:v>5.6583</c:v>
                </c:pt>
                <c:pt idx="1268">
                  <c:v>4.054759999999995</c:v>
                </c:pt>
                <c:pt idx="1269">
                  <c:v>4.44073</c:v>
                </c:pt>
                <c:pt idx="1270">
                  <c:v>3.12134</c:v>
                </c:pt>
                <c:pt idx="1271">
                  <c:v>5.312109999999985</c:v>
                </c:pt>
                <c:pt idx="1272">
                  <c:v>3.4538</c:v>
                </c:pt>
                <c:pt idx="1273">
                  <c:v>5.04786</c:v>
                </c:pt>
                <c:pt idx="1274">
                  <c:v>3.7692</c:v>
                </c:pt>
                <c:pt idx="1275">
                  <c:v>6.2569</c:v>
                </c:pt>
                <c:pt idx="1276">
                  <c:v>6.224219999999995</c:v>
                </c:pt>
                <c:pt idx="1277">
                  <c:v>2.32384</c:v>
                </c:pt>
                <c:pt idx="1278">
                  <c:v>3.49073</c:v>
                </c:pt>
                <c:pt idx="1279">
                  <c:v>2.55731</c:v>
                </c:pt>
                <c:pt idx="1280">
                  <c:v>5.574</c:v>
                </c:pt>
                <c:pt idx="1281">
                  <c:v>2.26796</c:v>
                </c:pt>
                <c:pt idx="1282">
                  <c:v>3.49831</c:v>
                </c:pt>
                <c:pt idx="1283">
                  <c:v>3.10003</c:v>
                </c:pt>
                <c:pt idx="1284">
                  <c:v>2.79552</c:v>
                </c:pt>
                <c:pt idx="1285">
                  <c:v>2.22913</c:v>
                </c:pt>
                <c:pt idx="1286">
                  <c:v>2.923859999999999</c:v>
                </c:pt>
                <c:pt idx="1287">
                  <c:v>3.05504</c:v>
                </c:pt>
                <c:pt idx="1288">
                  <c:v>4.674679999999999</c:v>
                </c:pt>
                <c:pt idx="1289">
                  <c:v>5.321109999999996</c:v>
                </c:pt>
                <c:pt idx="1290">
                  <c:v>5.45229</c:v>
                </c:pt>
                <c:pt idx="1291">
                  <c:v>3.271469999999999</c:v>
                </c:pt>
                <c:pt idx="1292">
                  <c:v>3.578349999999999</c:v>
                </c:pt>
                <c:pt idx="1293">
                  <c:v>4.615009999999986</c:v>
                </c:pt>
                <c:pt idx="1294">
                  <c:v>4.112069999999997</c:v>
                </c:pt>
                <c:pt idx="1295">
                  <c:v>7.73446</c:v>
                </c:pt>
                <c:pt idx="1296">
                  <c:v>6.72148</c:v>
                </c:pt>
                <c:pt idx="1297">
                  <c:v>5.26144</c:v>
                </c:pt>
                <c:pt idx="1298">
                  <c:v>2.90208</c:v>
                </c:pt>
                <c:pt idx="1299">
                  <c:v>4.13385</c:v>
                </c:pt>
                <c:pt idx="1300">
                  <c:v>7.058189999999994</c:v>
                </c:pt>
                <c:pt idx="1301">
                  <c:v>5.25386</c:v>
                </c:pt>
                <c:pt idx="1302">
                  <c:v>4.612399999999996</c:v>
                </c:pt>
                <c:pt idx="1303">
                  <c:v>2.510899999999999</c:v>
                </c:pt>
                <c:pt idx="1304">
                  <c:v>6.99947</c:v>
                </c:pt>
                <c:pt idx="1305">
                  <c:v>2.42092</c:v>
                </c:pt>
                <c:pt idx="1306">
                  <c:v>4.625419999999964</c:v>
                </c:pt>
                <c:pt idx="1307">
                  <c:v>5.94765</c:v>
                </c:pt>
                <c:pt idx="1308">
                  <c:v>3.46895</c:v>
                </c:pt>
                <c:pt idx="1309">
                  <c:v>1.74892</c:v>
                </c:pt>
                <c:pt idx="1310">
                  <c:v>4.21625</c:v>
                </c:pt>
                <c:pt idx="1311">
                  <c:v>5.83115</c:v>
                </c:pt>
                <c:pt idx="1312">
                  <c:v>5.912129999999999</c:v>
                </c:pt>
                <c:pt idx="1313">
                  <c:v>5.22876</c:v>
                </c:pt>
                <c:pt idx="1314">
                  <c:v>3.92974</c:v>
                </c:pt>
                <c:pt idx="1315">
                  <c:v>1.86873</c:v>
                </c:pt>
                <c:pt idx="1316">
                  <c:v>7.57628</c:v>
                </c:pt>
                <c:pt idx="1317">
                  <c:v>8.572690000000006</c:v>
                </c:pt>
                <c:pt idx="1318">
                  <c:v>3.48695</c:v>
                </c:pt>
                <c:pt idx="1319">
                  <c:v>2.59899</c:v>
                </c:pt>
                <c:pt idx="1320">
                  <c:v>3.66122</c:v>
                </c:pt>
                <c:pt idx="1321">
                  <c:v>2.09416</c:v>
                </c:pt>
                <c:pt idx="1322">
                  <c:v>3.70479</c:v>
                </c:pt>
                <c:pt idx="1323">
                  <c:v>6.117669999999999</c:v>
                </c:pt>
                <c:pt idx="1324">
                  <c:v>2.60893</c:v>
                </c:pt>
                <c:pt idx="1325">
                  <c:v>4.34933</c:v>
                </c:pt>
                <c:pt idx="1326">
                  <c:v>2.95038</c:v>
                </c:pt>
                <c:pt idx="1327">
                  <c:v>1.6059</c:v>
                </c:pt>
                <c:pt idx="1328">
                  <c:v>5.197979999999966</c:v>
                </c:pt>
                <c:pt idx="1329">
                  <c:v>2.7439</c:v>
                </c:pt>
                <c:pt idx="1330">
                  <c:v>3.038</c:v>
                </c:pt>
                <c:pt idx="1331">
                  <c:v>5.752539999999985</c:v>
                </c:pt>
                <c:pt idx="1332">
                  <c:v>3.1687</c:v>
                </c:pt>
                <c:pt idx="1333">
                  <c:v>3.17154</c:v>
                </c:pt>
                <c:pt idx="1334">
                  <c:v>5.150149999999996</c:v>
                </c:pt>
                <c:pt idx="1335">
                  <c:v>3.8696</c:v>
                </c:pt>
                <c:pt idx="1336">
                  <c:v>2.920069999999999</c:v>
                </c:pt>
                <c:pt idx="1337">
                  <c:v>4.54113</c:v>
                </c:pt>
                <c:pt idx="1338">
                  <c:v>2.74722</c:v>
                </c:pt>
                <c:pt idx="1339">
                  <c:v>2.96412</c:v>
                </c:pt>
                <c:pt idx="1340">
                  <c:v>5.321109999999996</c:v>
                </c:pt>
                <c:pt idx="1341">
                  <c:v>3.94632</c:v>
                </c:pt>
                <c:pt idx="1342">
                  <c:v>5.24486</c:v>
                </c:pt>
                <c:pt idx="1343">
                  <c:v>2.0127</c:v>
                </c:pt>
                <c:pt idx="1344">
                  <c:v>3.8033</c:v>
                </c:pt>
                <c:pt idx="1345">
                  <c:v>4.152319999999984</c:v>
                </c:pt>
                <c:pt idx="1346">
                  <c:v>4.042929999999997</c:v>
                </c:pt>
                <c:pt idx="1347">
                  <c:v>4.51177</c:v>
                </c:pt>
                <c:pt idx="1348">
                  <c:v>2.821099999999999</c:v>
                </c:pt>
                <c:pt idx="1349">
                  <c:v>4.220989999999984</c:v>
                </c:pt>
                <c:pt idx="1350">
                  <c:v>7.13065</c:v>
                </c:pt>
                <c:pt idx="1351">
                  <c:v>5.54322</c:v>
                </c:pt>
                <c:pt idx="1352">
                  <c:v>2.26701</c:v>
                </c:pt>
                <c:pt idx="1353">
                  <c:v>4.507499999999999</c:v>
                </c:pt>
                <c:pt idx="1354">
                  <c:v>2.52985</c:v>
                </c:pt>
                <c:pt idx="1355">
                  <c:v>4.792119999999985</c:v>
                </c:pt>
                <c:pt idx="1356">
                  <c:v>3.54614</c:v>
                </c:pt>
                <c:pt idx="1357">
                  <c:v>4.90768</c:v>
                </c:pt>
                <c:pt idx="1358">
                  <c:v>1.91657</c:v>
                </c:pt>
                <c:pt idx="1359">
                  <c:v>3.2208</c:v>
                </c:pt>
                <c:pt idx="1360">
                  <c:v>1.48703</c:v>
                </c:pt>
                <c:pt idx="1361">
                  <c:v>2.70081</c:v>
                </c:pt>
                <c:pt idx="1362">
                  <c:v>2.374039999999999</c:v>
                </c:pt>
                <c:pt idx="1363">
                  <c:v>6.21948</c:v>
                </c:pt>
                <c:pt idx="1364">
                  <c:v>2.02644</c:v>
                </c:pt>
                <c:pt idx="1365">
                  <c:v>3.331139999999999</c:v>
                </c:pt>
                <c:pt idx="1366">
                  <c:v>2.002279999999999</c:v>
                </c:pt>
                <c:pt idx="1367">
                  <c:v>2.73538</c:v>
                </c:pt>
                <c:pt idx="1368">
                  <c:v>2.68234</c:v>
                </c:pt>
                <c:pt idx="1369">
                  <c:v>2.135359999999999</c:v>
                </c:pt>
                <c:pt idx="1370">
                  <c:v>1.91467</c:v>
                </c:pt>
                <c:pt idx="1371">
                  <c:v>2.33237</c:v>
                </c:pt>
                <c:pt idx="1372">
                  <c:v>1.68735</c:v>
                </c:pt>
                <c:pt idx="1373">
                  <c:v>2.60467</c:v>
                </c:pt>
                <c:pt idx="1374">
                  <c:v>4.324229999999996</c:v>
                </c:pt>
                <c:pt idx="1375">
                  <c:v>2.96364</c:v>
                </c:pt>
                <c:pt idx="1376">
                  <c:v>1.68262</c:v>
                </c:pt>
                <c:pt idx="1377">
                  <c:v>5.827839999999965</c:v>
                </c:pt>
                <c:pt idx="1378">
                  <c:v>2.16709</c:v>
                </c:pt>
                <c:pt idx="1379">
                  <c:v>4.367799999999995</c:v>
                </c:pt>
                <c:pt idx="1380">
                  <c:v>6.08262</c:v>
                </c:pt>
                <c:pt idx="1381">
                  <c:v>2.59236</c:v>
                </c:pt>
                <c:pt idx="1382">
                  <c:v>3.06357</c:v>
                </c:pt>
                <c:pt idx="1383">
                  <c:v>2.54879</c:v>
                </c:pt>
                <c:pt idx="1384">
                  <c:v>4.13622</c:v>
                </c:pt>
                <c:pt idx="1385">
                  <c:v>3.12608</c:v>
                </c:pt>
                <c:pt idx="1386">
                  <c:v>3.08677</c:v>
                </c:pt>
                <c:pt idx="1387">
                  <c:v>3.84308</c:v>
                </c:pt>
                <c:pt idx="1388">
                  <c:v>2.898759999999997</c:v>
                </c:pt>
                <c:pt idx="1389">
                  <c:v>1.56186</c:v>
                </c:pt>
                <c:pt idx="1390">
                  <c:v>2.448869999999999</c:v>
                </c:pt>
                <c:pt idx="1391">
                  <c:v>3.02379</c:v>
                </c:pt>
                <c:pt idx="1392">
                  <c:v>3.72279</c:v>
                </c:pt>
                <c:pt idx="1393">
                  <c:v>2.43513</c:v>
                </c:pt>
                <c:pt idx="1394">
                  <c:v>2.08753</c:v>
                </c:pt>
                <c:pt idx="1395">
                  <c:v>2.18366</c:v>
                </c:pt>
                <c:pt idx="1396">
                  <c:v>2.311529999999998</c:v>
                </c:pt>
                <c:pt idx="1397">
                  <c:v>3.45616</c:v>
                </c:pt>
                <c:pt idx="1398">
                  <c:v>4.274979999999998</c:v>
                </c:pt>
                <c:pt idx="1399">
                  <c:v>2.15667</c:v>
                </c:pt>
                <c:pt idx="1400">
                  <c:v>2.40056</c:v>
                </c:pt>
                <c:pt idx="1401">
                  <c:v>2.50238</c:v>
                </c:pt>
                <c:pt idx="1402">
                  <c:v>1.2796</c:v>
                </c:pt>
                <c:pt idx="1403">
                  <c:v>3.78909</c:v>
                </c:pt>
                <c:pt idx="1404">
                  <c:v>1.28955</c:v>
                </c:pt>
                <c:pt idx="1405">
                  <c:v>2.38351</c:v>
                </c:pt>
                <c:pt idx="1406">
                  <c:v>1.69683</c:v>
                </c:pt>
                <c:pt idx="1407">
                  <c:v>1.69067</c:v>
                </c:pt>
                <c:pt idx="1408">
                  <c:v>1.60116</c:v>
                </c:pt>
                <c:pt idx="1409">
                  <c:v>2.81778</c:v>
                </c:pt>
                <c:pt idx="1410">
                  <c:v>1.40416</c:v>
                </c:pt>
                <c:pt idx="1411">
                  <c:v>3.39839</c:v>
                </c:pt>
                <c:pt idx="1412">
                  <c:v>3.18386</c:v>
                </c:pt>
                <c:pt idx="1413">
                  <c:v>2.32384</c:v>
                </c:pt>
                <c:pt idx="1414">
                  <c:v>1.631</c:v>
                </c:pt>
                <c:pt idx="1415">
                  <c:v>2.25186</c:v>
                </c:pt>
                <c:pt idx="1416">
                  <c:v>2.03354</c:v>
                </c:pt>
                <c:pt idx="1417">
                  <c:v>1.84127</c:v>
                </c:pt>
                <c:pt idx="1418">
                  <c:v>1.44772</c:v>
                </c:pt>
                <c:pt idx="1419">
                  <c:v>1.82564</c:v>
                </c:pt>
                <c:pt idx="1420">
                  <c:v>3.20801</c:v>
                </c:pt>
                <c:pt idx="1421">
                  <c:v>3.955309999999999</c:v>
                </c:pt>
                <c:pt idx="1422">
                  <c:v>3.755459999999998</c:v>
                </c:pt>
                <c:pt idx="1423">
                  <c:v>3.279049999999998</c:v>
                </c:pt>
                <c:pt idx="1424">
                  <c:v>1.72524</c:v>
                </c:pt>
                <c:pt idx="1425">
                  <c:v>1.15884</c:v>
                </c:pt>
                <c:pt idx="1426">
                  <c:v>2.30348</c:v>
                </c:pt>
                <c:pt idx="1427">
                  <c:v>1.45625</c:v>
                </c:pt>
                <c:pt idx="1428">
                  <c:v>1.89005</c:v>
                </c:pt>
                <c:pt idx="1429">
                  <c:v>2.16803</c:v>
                </c:pt>
                <c:pt idx="1430">
                  <c:v>1.77923</c:v>
                </c:pt>
                <c:pt idx="1431">
                  <c:v>1.38284</c:v>
                </c:pt>
                <c:pt idx="1432">
                  <c:v>1.46477</c:v>
                </c:pt>
                <c:pt idx="1433">
                  <c:v>1.24787</c:v>
                </c:pt>
                <c:pt idx="1434">
                  <c:v>3.48884</c:v>
                </c:pt>
                <c:pt idx="1435">
                  <c:v>3.26863</c:v>
                </c:pt>
                <c:pt idx="1436">
                  <c:v>2.422349999999998</c:v>
                </c:pt>
                <c:pt idx="1437">
                  <c:v>1.61395</c:v>
                </c:pt>
                <c:pt idx="1438">
                  <c:v>1.94309</c:v>
                </c:pt>
                <c:pt idx="1439">
                  <c:v>1.89999</c:v>
                </c:pt>
                <c:pt idx="1440">
                  <c:v>2.68471</c:v>
                </c:pt>
                <c:pt idx="1441">
                  <c:v>1.67504</c:v>
                </c:pt>
                <c:pt idx="1442">
                  <c:v>1.27487</c:v>
                </c:pt>
                <c:pt idx="1443">
                  <c:v>3.038469999999998</c:v>
                </c:pt>
                <c:pt idx="1444">
                  <c:v>2.70886</c:v>
                </c:pt>
                <c:pt idx="1445">
                  <c:v>3.059779999999999</c:v>
                </c:pt>
                <c:pt idx="1446">
                  <c:v>1.63289</c:v>
                </c:pt>
                <c:pt idx="1447">
                  <c:v>1.61774</c:v>
                </c:pt>
                <c:pt idx="1448">
                  <c:v>1.97245</c:v>
                </c:pt>
                <c:pt idx="1449">
                  <c:v>3.42396</c:v>
                </c:pt>
                <c:pt idx="1450">
                  <c:v>3.340609999999998</c:v>
                </c:pt>
                <c:pt idx="1451">
                  <c:v>3.02521</c:v>
                </c:pt>
                <c:pt idx="1452">
                  <c:v>7.144379999999995</c:v>
                </c:pt>
                <c:pt idx="1453">
                  <c:v>3.23879</c:v>
                </c:pt>
                <c:pt idx="1454">
                  <c:v>1.95445</c:v>
                </c:pt>
                <c:pt idx="1455">
                  <c:v>3.74978</c:v>
                </c:pt>
                <c:pt idx="1456">
                  <c:v>2.309159999999998</c:v>
                </c:pt>
                <c:pt idx="1457">
                  <c:v>1.89431</c:v>
                </c:pt>
                <c:pt idx="1458">
                  <c:v>4.2101</c:v>
                </c:pt>
                <c:pt idx="1459">
                  <c:v>3.81277</c:v>
                </c:pt>
                <c:pt idx="1460">
                  <c:v>3.89848</c:v>
                </c:pt>
                <c:pt idx="1461">
                  <c:v>5.03696</c:v>
                </c:pt>
                <c:pt idx="1462">
                  <c:v>2.070949999999999</c:v>
                </c:pt>
                <c:pt idx="1463">
                  <c:v>2.582409999999999</c:v>
                </c:pt>
                <c:pt idx="1464">
                  <c:v>3.76778</c:v>
                </c:pt>
                <c:pt idx="1465">
                  <c:v>3.52104</c:v>
                </c:pt>
                <c:pt idx="1466">
                  <c:v>2.855669999999952</c:v>
                </c:pt>
                <c:pt idx="1467">
                  <c:v>5.087159999999995</c:v>
                </c:pt>
                <c:pt idx="1468">
                  <c:v>6.44301</c:v>
                </c:pt>
                <c:pt idx="1469">
                  <c:v>2.477749999999999</c:v>
                </c:pt>
                <c:pt idx="1470">
                  <c:v>4.42226</c:v>
                </c:pt>
                <c:pt idx="1471">
                  <c:v>1.62816</c:v>
                </c:pt>
                <c:pt idx="1472">
                  <c:v>1.29334</c:v>
                </c:pt>
                <c:pt idx="1473">
                  <c:v>3.25537</c:v>
                </c:pt>
                <c:pt idx="1474">
                  <c:v>2.69749</c:v>
                </c:pt>
                <c:pt idx="1475">
                  <c:v>2.57294</c:v>
                </c:pt>
                <c:pt idx="1476">
                  <c:v>3.49216</c:v>
                </c:pt>
                <c:pt idx="1477">
                  <c:v>5.87377</c:v>
                </c:pt>
                <c:pt idx="1478">
                  <c:v>3.46327</c:v>
                </c:pt>
                <c:pt idx="1479">
                  <c:v>3.993669999999998</c:v>
                </c:pt>
                <c:pt idx="1480">
                  <c:v>3.34393</c:v>
                </c:pt>
                <c:pt idx="1481">
                  <c:v>2.825359999999998</c:v>
                </c:pt>
                <c:pt idx="1482">
                  <c:v>6.3052</c:v>
                </c:pt>
                <c:pt idx="1483">
                  <c:v>1.73282</c:v>
                </c:pt>
                <c:pt idx="1484">
                  <c:v>2.28501</c:v>
                </c:pt>
                <c:pt idx="1485">
                  <c:v>7.30776</c:v>
                </c:pt>
                <c:pt idx="1486">
                  <c:v>5.50722</c:v>
                </c:pt>
                <c:pt idx="1487">
                  <c:v>3.64512</c:v>
                </c:pt>
                <c:pt idx="1488">
                  <c:v>4.022089999999984</c:v>
                </c:pt>
                <c:pt idx="1489">
                  <c:v>4.050979999999996</c:v>
                </c:pt>
                <c:pt idx="1490">
                  <c:v>2.10884</c:v>
                </c:pt>
                <c:pt idx="1491">
                  <c:v>3.966209999999998</c:v>
                </c:pt>
                <c:pt idx="1492">
                  <c:v>1.34543</c:v>
                </c:pt>
                <c:pt idx="1493">
                  <c:v>1.89478</c:v>
                </c:pt>
                <c:pt idx="1494">
                  <c:v>6.03242</c:v>
                </c:pt>
                <c:pt idx="1495">
                  <c:v>2.955589999999999</c:v>
                </c:pt>
                <c:pt idx="1496">
                  <c:v>4.79875</c:v>
                </c:pt>
                <c:pt idx="1497">
                  <c:v>2.53222</c:v>
                </c:pt>
                <c:pt idx="1498">
                  <c:v>1.23604</c:v>
                </c:pt>
                <c:pt idx="1499">
                  <c:v>1.22846</c:v>
                </c:pt>
                <c:pt idx="1500">
                  <c:v>3.542349999999999</c:v>
                </c:pt>
                <c:pt idx="1501">
                  <c:v>10.1426</c:v>
                </c:pt>
                <c:pt idx="1502">
                  <c:v>7.20263</c:v>
                </c:pt>
                <c:pt idx="1503">
                  <c:v>6.2891</c:v>
                </c:pt>
                <c:pt idx="1504">
                  <c:v>2.315319999999998</c:v>
                </c:pt>
                <c:pt idx="1505">
                  <c:v>2.05769</c:v>
                </c:pt>
                <c:pt idx="1506">
                  <c:v>2.308689999999999</c:v>
                </c:pt>
                <c:pt idx="1507">
                  <c:v>3.29089</c:v>
                </c:pt>
                <c:pt idx="1508">
                  <c:v>5.714179999999986</c:v>
                </c:pt>
                <c:pt idx="1509">
                  <c:v>4.75613</c:v>
                </c:pt>
                <c:pt idx="1510">
                  <c:v>3.79761</c:v>
                </c:pt>
                <c:pt idx="1511">
                  <c:v>5.11131</c:v>
                </c:pt>
                <c:pt idx="1512">
                  <c:v>3.477949999999999</c:v>
                </c:pt>
                <c:pt idx="1513">
                  <c:v>3.94158</c:v>
                </c:pt>
                <c:pt idx="1514">
                  <c:v>4.728189999999984</c:v>
                </c:pt>
                <c:pt idx="1515">
                  <c:v>5.79516</c:v>
                </c:pt>
                <c:pt idx="1516">
                  <c:v>4.202519999999994</c:v>
                </c:pt>
                <c:pt idx="1517">
                  <c:v>2.305369999999999</c:v>
                </c:pt>
                <c:pt idx="1518">
                  <c:v>5.01423</c:v>
                </c:pt>
                <c:pt idx="1519">
                  <c:v>4.62969</c:v>
                </c:pt>
                <c:pt idx="1520">
                  <c:v>3.6257</c:v>
                </c:pt>
                <c:pt idx="1521">
                  <c:v>4.14569</c:v>
                </c:pt>
                <c:pt idx="1522">
                  <c:v>4.72914</c:v>
                </c:pt>
                <c:pt idx="1523">
                  <c:v>4.815329999999999</c:v>
                </c:pt>
                <c:pt idx="1524">
                  <c:v>3.78009</c:v>
                </c:pt>
                <c:pt idx="1525">
                  <c:v>6.184909999999975</c:v>
                </c:pt>
                <c:pt idx="1526">
                  <c:v>6.58887</c:v>
                </c:pt>
                <c:pt idx="1527">
                  <c:v>4.014979999999976</c:v>
                </c:pt>
                <c:pt idx="1528">
                  <c:v>5.850089999999994</c:v>
                </c:pt>
                <c:pt idx="1529">
                  <c:v>7.515189999999984</c:v>
                </c:pt>
                <c:pt idx="1530">
                  <c:v>2.97832</c:v>
                </c:pt>
                <c:pt idx="1531">
                  <c:v>2.855669999999952</c:v>
                </c:pt>
                <c:pt idx="1532">
                  <c:v>4.78549</c:v>
                </c:pt>
                <c:pt idx="1533">
                  <c:v>5.68624</c:v>
                </c:pt>
                <c:pt idx="1534">
                  <c:v>1.85311</c:v>
                </c:pt>
                <c:pt idx="1535">
                  <c:v>3.20517</c:v>
                </c:pt>
                <c:pt idx="1536">
                  <c:v>1.74655</c:v>
                </c:pt>
                <c:pt idx="1537">
                  <c:v>6.00732</c:v>
                </c:pt>
                <c:pt idx="1538">
                  <c:v>3.065459999999999</c:v>
                </c:pt>
                <c:pt idx="1539">
                  <c:v>3.675899999999999</c:v>
                </c:pt>
                <c:pt idx="1540">
                  <c:v>2.75859</c:v>
                </c:pt>
                <c:pt idx="1541">
                  <c:v>4.060449999999999</c:v>
                </c:pt>
                <c:pt idx="1542">
                  <c:v>4.17363</c:v>
                </c:pt>
                <c:pt idx="1543">
                  <c:v>1.71577</c:v>
                </c:pt>
                <c:pt idx="1544">
                  <c:v>2.6544</c:v>
                </c:pt>
                <c:pt idx="1545">
                  <c:v>3.1294</c:v>
                </c:pt>
                <c:pt idx="1546">
                  <c:v>4.156579999999995</c:v>
                </c:pt>
                <c:pt idx="1547">
                  <c:v>2.4195</c:v>
                </c:pt>
                <c:pt idx="1548">
                  <c:v>3.86533</c:v>
                </c:pt>
                <c:pt idx="1549">
                  <c:v>3.55798</c:v>
                </c:pt>
                <c:pt idx="1550">
                  <c:v>2.832939999999998</c:v>
                </c:pt>
                <c:pt idx="1551">
                  <c:v>5.83873</c:v>
                </c:pt>
                <c:pt idx="1552">
                  <c:v>3.962419999999998</c:v>
                </c:pt>
                <c:pt idx="1553">
                  <c:v>3.56745</c:v>
                </c:pt>
                <c:pt idx="1554">
                  <c:v>4.324699999999995</c:v>
                </c:pt>
                <c:pt idx="1555">
                  <c:v>3.70439</c:v>
                </c:pt>
                <c:pt idx="1556">
                  <c:v>2.309629999999998</c:v>
                </c:pt>
                <c:pt idx="1557">
                  <c:v>1.92083</c:v>
                </c:pt>
                <c:pt idx="1558">
                  <c:v>1.43588</c:v>
                </c:pt>
                <c:pt idx="1559">
                  <c:v>1.88057</c:v>
                </c:pt>
                <c:pt idx="1560">
                  <c:v>1.21946</c:v>
                </c:pt>
                <c:pt idx="1561">
                  <c:v>2.91392</c:v>
                </c:pt>
                <c:pt idx="1562">
                  <c:v>2.26749</c:v>
                </c:pt>
                <c:pt idx="1563">
                  <c:v>1.47188</c:v>
                </c:pt>
                <c:pt idx="1564">
                  <c:v>1.76692</c:v>
                </c:pt>
                <c:pt idx="1565">
                  <c:v>2.50143</c:v>
                </c:pt>
                <c:pt idx="1566">
                  <c:v>2.102679999999999</c:v>
                </c:pt>
                <c:pt idx="1567">
                  <c:v>2.42092</c:v>
                </c:pt>
                <c:pt idx="1568">
                  <c:v>2.98353</c:v>
                </c:pt>
                <c:pt idx="1569">
                  <c:v>3.64938</c:v>
                </c:pt>
                <c:pt idx="1570">
                  <c:v>2.04775</c:v>
                </c:pt>
                <c:pt idx="1571">
                  <c:v>1.61963</c:v>
                </c:pt>
                <c:pt idx="1572">
                  <c:v>5.09805</c:v>
                </c:pt>
                <c:pt idx="1573">
                  <c:v>3.850649999999952</c:v>
                </c:pt>
                <c:pt idx="1574">
                  <c:v>5.517169999999997</c:v>
                </c:pt>
                <c:pt idx="1575">
                  <c:v>2.345629999999998</c:v>
                </c:pt>
                <c:pt idx="1576">
                  <c:v>1.83416</c:v>
                </c:pt>
                <c:pt idx="1577">
                  <c:v>3.38892</c:v>
                </c:pt>
                <c:pt idx="1578">
                  <c:v>2.84667</c:v>
                </c:pt>
                <c:pt idx="1579">
                  <c:v>3.540459999999999</c:v>
                </c:pt>
                <c:pt idx="1580">
                  <c:v>2.76332</c:v>
                </c:pt>
                <c:pt idx="1581">
                  <c:v>2.07474</c:v>
                </c:pt>
                <c:pt idx="1582">
                  <c:v>1.37621</c:v>
                </c:pt>
                <c:pt idx="1583">
                  <c:v>0.951889</c:v>
                </c:pt>
                <c:pt idx="1584">
                  <c:v>2.07711</c:v>
                </c:pt>
                <c:pt idx="1585">
                  <c:v>1.09822</c:v>
                </c:pt>
                <c:pt idx="1586">
                  <c:v>1.92035</c:v>
                </c:pt>
                <c:pt idx="1587">
                  <c:v>1.38284</c:v>
                </c:pt>
                <c:pt idx="1588">
                  <c:v>1.65184</c:v>
                </c:pt>
                <c:pt idx="1589">
                  <c:v>1.45293</c:v>
                </c:pt>
                <c:pt idx="1590">
                  <c:v>1.12948</c:v>
                </c:pt>
                <c:pt idx="1591">
                  <c:v>1.85074</c:v>
                </c:pt>
                <c:pt idx="1592">
                  <c:v>1.59785</c:v>
                </c:pt>
                <c:pt idx="1593">
                  <c:v>3.23453</c:v>
                </c:pt>
                <c:pt idx="1594">
                  <c:v>0.93342</c:v>
                </c:pt>
                <c:pt idx="1595">
                  <c:v>1.389</c:v>
                </c:pt>
                <c:pt idx="1596">
                  <c:v>0.557874</c:v>
                </c:pt>
                <c:pt idx="1597">
                  <c:v>0.212162</c:v>
                </c:pt>
                <c:pt idx="1598">
                  <c:v>0.6739</c:v>
                </c:pt>
                <c:pt idx="1599">
                  <c:v>0.706577</c:v>
                </c:pt>
                <c:pt idx="1600">
                  <c:v>1.7636</c:v>
                </c:pt>
                <c:pt idx="1601">
                  <c:v>1.855</c:v>
                </c:pt>
                <c:pt idx="1602">
                  <c:v>2.242859999999999</c:v>
                </c:pt>
                <c:pt idx="1603">
                  <c:v>0.912109</c:v>
                </c:pt>
                <c:pt idx="1604">
                  <c:v>1.91562</c:v>
                </c:pt>
                <c:pt idx="1605">
                  <c:v>1.33785</c:v>
                </c:pt>
                <c:pt idx="1606">
                  <c:v>0.802239</c:v>
                </c:pt>
                <c:pt idx="1607">
                  <c:v>1.40037</c:v>
                </c:pt>
                <c:pt idx="1608">
                  <c:v>1.14748</c:v>
                </c:pt>
                <c:pt idx="1609">
                  <c:v>2.05248</c:v>
                </c:pt>
                <c:pt idx="1610">
                  <c:v>2.71454</c:v>
                </c:pt>
                <c:pt idx="1611">
                  <c:v>1.42452</c:v>
                </c:pt>
                <c:pt idx="1612">
                  <c:v>1.30755</c:v>
                </c:pt>
                <c:pt idx="1613">
                  <c:v>1.91893</c:v>
                </c:pt>
                <c:pt idx="1614">
                  <c:v>1.89336</c:v>
                </c:pt>
                <c:pt idx="1615">
                  <c:v>1.4051</c:v>
                </c:pt>
                <c:pt idx="1616">
                  <c:v>2.827249999999998</c:v>
                </c:pt>
                <c:pt idx="1617">
                  <c:v>2.998209999999998</c:v>
                </c:pt>
                <c:pt idx="1618">
                  <c:v>2.036849999999952</c:v>
                </c:pt>
                <c:pt idx="1619">
                  <c:v>2.39109</c:v>
                </c:pt>
                <c:pt idx="1620">
                  <c:v>1.79864</c:v>
                </c:pt>
                <c:pt idx="1621">
                  <c:v>3.00769</c:v>
                </c:pt>
                <c:pt idx="1622">
                  <c:v>3.77441</c:v>
                </c:pt>
                <c:pt idx="1623">
                  <c:v>1.92888</c:v>
                </c:pt>
                <c:pt idx="1624">
                  <c:v>1.43873</c:v>
                </c:pt>
                <c:pt idx="1625">
                  <c:v>3.84734</c:v>
                </c:pt>
                <c:pt idx="1626">
                  <c:v>2.39156</c:v>
                </c:pt>
                <c:pt idx="1627">
                  <c:v>4.96119</c:v>
                </c:pt>
                <c:pt idx="1628">
                  <c:v>3.69485</c:v>
                </c:pt>
                <c:pt idx="1629">
                  <c:v>3.76352</c:v>
                </c:pt>
                <c:pt idx="1630">
                  <c:v>3.21511</c:v>
                </c:pt>
                <c:pt idx="1631">
                  <c:v>1.9715</c:v>
                </c:pt>
                <c:pt idx="1632">
                  <c:v>5.126469999999999</c:v>
                </c:pt>
                <c:pt idx="1633">
                  <c:v>3.270049999999999</c:v>
                </c:pt>
                <c:pt idx="1634">
                  <c:v>3.45332</c:v>
                </c:pt>
                <c:pt idx="1635">
                  <c:v>1.56233</c:v>
                </c:pt>
                <c:pt idx="1636">
                  <c:v>2.11405</c:v>
                </c:pt>
                <c:pt idx="1637">
                  <c:v>2.07521</c:v>
                </c:pt>
                <c:pt idx="1638">
                  <c:v>4.684619999999985</c:v>
                </c:pt>
                <c:pt idx="1639">
                  <c:v>2.59331</c:v>
                </c:pt>
                <c:pt idx="1640">
                  <c:v>1.50834</c:v>
                </c:pt>
                <c:pt idx="1641">
                  <c:v>3.58403</c:v>
                </c:pt>
                <c:pt idx="1642">
                  <c:v>6.07362</c:v>
                </c:pt>
                <c:pt idx="1643">
                  <c:v>2.93949</c:v>
                </c:pt>
                <c:pt idx="1644">
                  <c:v>5.92918</c:v>
                </c:pt>
                <c:pt idx="1645">
                  <c:v>4.625419999999964</c:v>
                </c:pt>
                <c:pt idx="1646">
                  <c:v>2.4967</c:v>
                </c:pt>
                <c:pt idx="1647">
                  <c:v>1.85169</c:v>
                </c:pt>
                <c:pt idx="1648">
                  <c:v>2.98164</c:v>
                </c:pt>
                <c:pt idx="1649">
                  <c:v>4.604109999999975</c:v>
                </c:pt>
                <c:pt idx="1650">
                  <c:v>7.045879999999999</c:v>
                </c:pt>
                <c:pt idx="1651">
                  <c:v>3.32735</c:v>
                </c:pt>
                <c:pt idx="1652">
                  <c:v>3.55751</c:v>
                </c:pt>
                <c:pt idx="1653">
                  <c:v>3.49073</c:v>
                </c:pt>
                <c:pt idx="1654">
                  <c:v>4.94888</c:v>
                </c:pt>
                <c:pt idx="1655">
                  <c:v>4.30623</c:v>
                </c:pt>
                <c:pt idx="1656">
                  <c:v>4.75329</c:v>
                </c:pt>
                <c:pt idx="1657">
                  <c:v>3.656489999999997</c:v>
                </c:pt>
                <c:pt idx="1658">
                  <c:v>5.01044</c:v>
                </c:pt>
                <c:pt idx="1659">
                  <c:v>8.522020000000001</c:v>
                </c:pt>
                <c:pt idx="1660">
                  <c:v>4.663309999999996</c:v>
                </c:pt>
                <c:pt idx="1661">
                  <c:v>7.13396</c:v>
                </c:pt>
                <c:pt idx="1662">
                  <c:v>2.712649999999976</c:v>
                </c:pt>
                <c:pt idx="1663">
                  <c:v>5.47976</c:v>
                </c:pt>
                <c:pt idx="1664">
                  <c:v>3.48174</c:v>
                </c:pt>
                <c:pt idx="1665">
                  <c:v>5.17335</c:v>
                </c:pt>
                <c:pt idx="1666">
                  <c:v>2.78416</c:v>
                </c:pt>
                <c:pt idx="1667">
                  <c:v>7.2282</c:v>
                </c:pt>
                <c:pt idx="1668">
                  <c:v>3.56414</c:v>
                </c:pt>
                <c:pt idx="1669">
                  <c:v>2.23007</c:v>
                </c:pt>
                <c:pt idx="1670">
                  <c:v>5.630829999999999</c:v>
                </c:pt>
                <c:pt idx="1671">
                  <c:v>7.71078</c:v>
                </c:pt>
                <c:pt idx="1672">
                  <c:v>3.45806</c:v>
                </c:pt>
                <c:pt idx="1673">
                  <c:v>3.14787</c:v>
                </c:pt>
                <c:pt idx="1674">
                  <c:v>3.20754</c:v>
                </c:pt>
                <c:pt idx="1675">
                  <c:v>1.43162</c:v>
                </c:pt>
                <c:pt idx="1676">
                  <c:v>2.892129999999998</c:v>
                </c:pt>
                <c:pt idx="1677">
                  <c:v>6.5903</c:v>
                </c:pt>
                <c:pt idx="1678">
                  <c:v>4.097859999999994</c:v>
                </c:pt>
                <c:pt idx="1679">
                  <c:v>2.511379999999999</c:v>
                </c:pt>
                <c:pt idx="1680">
                  <c:v>6.057519999999966</c:v>
                </c:pt>
                <c:pt idx="1681">
                  <c:v>3.3444</c:v>
                </c:pt>
                <c:pt idx="1682">
                  <c:v>2.04822</c:v>
                </c:pt>
                <c:pt idx="1683">
                  <c:v>3.166809999999999</c:v>
                </c:pt>
                <c:pt idx="1684">
                  <c:v>2.891189999999999</c:v>
                </c:pt>
                <c:pt idx="1685">
                  <c:v>2.71075</c:v>
                </c:pt>
                <c:pt idx="1686">
                  <c:v>5.9074</c:v>
                </c:pt>
                <c:pt idx="1687">
                  <c:v>2.1614</c:v>
                </c:pt>
                <c:pt idx="1688">
                  <c:v>3.16539</c:v>
                </c:pt>
                <c:pt idx="1689">
                  <c:v>4.05619</c:v>
                </c:pt>
                <c:pt idx="1690">
                  <c:v>6.77168</c:v>
                </c:pt>
                <c:pt idx="1691">
                  <c:v>3.376129999999998</c:v>
                </c:pt>
                <c:pt idx="1692">
                  <c:v>2.1633</c:v>
                </c:pt>
                <c:pt idx="1693">
                  <c:v>1.75508</c:v>
                </c:pt>
                <c:pt idx="1694">
                  <c:v>1.95493</c:v>
                </c:pt>
                <c:pt idx="1695">
                  <c:v>6.34924</c:v>
                </c:pt>
                <c:pt idx="1696">
                  <c:v>5.80605</c:v>
                </c:pt>
                <c:pt idx="1697">
                  <c:v>3.16444</c:v>
                </c:pt>
                <c:pt idx="1698">
                  <c:v>2.18082</c:v>
                </c:pt>
                <c:pt idx="1699">
                  <c:v>4.87879</c:v>
                </c:pt>
                <c:pt idx="1700">
                  <c:v>3.94347</c:v>
                </c:pt>
                <c:pt idx="1701">
                  <c:v>2.716439999999999</c:v>
                </c:pt>
                <c:pt idx="1702">
                  <c:v>2.49954</c:v>
                </c:pt>
                <c:pt idx="1703">
                  <c:v>4.928989999999994</c:v>
                </c:pt>
                <c:pt idx="1704">
                  <c:v>3.45474</c:v>
                </c:pt>
                <c:pt idx="1705">
                  <c:v>2.0449</c:v>
                </c:pt>
                <c:pt idx="1706">
                  <c:v>2.78795</c:v>
                </c:pt>
                <c:pt idx="1707">
                  <c:v>2.77232</c:v>
                </c:pt>
                <c:pt idx="1708">
                  <c:v>2.90397</c:v>
                </c:pt>
                <c:pt idx="1709">
                  <c:v>4.73482</c:v>
                </c:pt>
                <c:pt idx="1710">
                  <c:v>5.159149999999999</c:v>
                </c:pt>
                <c:pt idx="1711">
                  <c:v>6.737579999999998</c:v>
                </c:pt>
                <c:pt idx="1712">
                  <c:v>3.71332</c:v>
                </c:pt>
                <c:pt idx="1713">
                  <c:v>5.624199999999964</c:v>
                </c:pt>
                <c:pt idx="1714">
                  <c:v>5.9557</c:v>
                </c:pt>
                <c:pt idx="1715">
                  <c:v>3.413069999999998</c:v>
                </c:pt>
                <c:pt idx="1716">
                  <c:v>2.91913</c:v>
                </c:pt>
                <c:pt idx="1717">
                  <c:v>3.24211</c:v>
                </c:pt>
                <c:pt idx="1718">
                  <c:v>4.14995</c:v>
                </c:pt>
                <c:pt idx="1719">
                  <c:v>6.9308</c:v>
                </c:pt>
                <c:pt idx="1720">
                  <c:v>6.79583</c:v>
                </c:pt>
                <c:pt idx="1721">
                  <c:v>3.54993</c:v>
                </c:pt>
                <c:pt idx="1722">
                  <c:v>3.440059999999999</c:v>
                </c:pt>
                <c:pt idx="1723">
                  <c:v>4.73956</c:v>
                </c:pt>
                <c:pt idx="1724">
                  <c:v>5.11037</c:v>
                </c:pt>
                <c:pt idx="1725">
                  <c:v>5.03365</c:v>
                </c:pt>
                <c:pt idx="1726">
                  <c:v>3.52957</c:v>
                </c:pt>
                <c:pt idx="1727">
                  <c:v>2.97406</c:v>
                </c:pt>
                <c:pt idx="1728">
                  <c:v>3.49026</c:v>
                </c:pt>
                <c:pt idx="1729">
                  <c:v>3.8336</c:v>
                </c:pt>
                <c:pt idx="1730">
                  <c:v>4.79307</c:v>
                </c:pt>
                <c:pt idx="1731">
                  <c:v>3.52246</c:v>
                </c:pt>
                <c:pt idx="1732">
                  <c:v>4.94604</c:v>
                </c:pt>
                <c:pt idx="1733">
                  <c:v>2.84667</c:v>
                </c:pt>
                <c:pt idx="1734">
                  <c:v>3.56982</c:v>
                </c:pt>
                <c:pt idx="1735">
                  <c:v>8.074010000000001</c:v>
                </c:pt>
                <c:pt idx="1736">
                  <c:v>5.705179999999999</c:v>
                </c:pt>
                <c:pt idx="1737">
                  <c:v>6.954479999999998</c:v>
                </c:pt>
                <c:pt idx="1738">
                  <c:v>2.5862</c:v>
                </c:pt>
                <c:pt idx="1739">
                  <c:v>5.27233</c:v>
                </c:pt>
                <c:pt idx="1740">
                  <c:v>3.617649999999997</c:v>
                </c:pt>
                <c:pt idx="1741">
                  <c:v>5.165299999999998</c:v>
                </c:pt>
                <c:pt idx="1742">
                  <c:v>3.513469999999999</c:v>
                </c:pt>
                <c:pt idx="1743">
                  <c:v>2.48391</c:v>
                </c:pt>
                <c:pt idx="1744">
                  <c:v>5.23444</c:v>
                </c:pt>
                <c:pt idx="1745">
                  <c:v>2.998209999999998</c:v>
                </c:pt>
                <c:pt idx="1746">
                  <c:v>4.397159999999975</c:v>
                </c:pt>
                <c:pt idx="1747">
                  <c:v>2.98732</c:v>
                </c:pt>
                <c:pt idx="1748">
                  <c:v>4.324699999999995</c:v>
                </c:pt>
                <c:pt idx="1749">
                  <c:v>3.825079999999998</c:v>
                </c:pt>
                <c:pt idx="1750">
                  <c:v>5.90929</c:v>
                </c:pt>
                <c:pt idx="1751">
                  <c:v>13.0968</c:v>
                </c:pt>
                <c:pt idx="1752">
                  <c:v>8.20093</c:v>
                </c:pt>
                <c:pt idx="1753">
                  <c:v>7.686149999999999</c:v>
                </c:pt>
                <c:pt idx="1754">
                  <c:v>7.9684</c:v>
                </c:pt>
                <c:pt idx="1755">
                  <c:v>5.73217</c:v>
                </c:pt>
                <c:pt idx="1756">
                  <c:v>5.95996</c:v>
                </c:pt>
                <c:pt idx="1757">
                  <c:v>4.97066</c:v>
                </c:pt>
                <c:pt idx="1758">
                  <c:v>4.86174</c:v>
                </c:pt>
                <c:pt idx="1759">
                  <c:v>4.08886</c:v>
                </c:pt>
                <c:pt idx="1760">
                  <c:v>3.56509</c:v>
                </c:pt>
                <c:pt idx="1761">
                  <c:v>2.79363</c:v>
                </c:pt>
                <c:pt idx="1762">
                  <c:v>4.920939999999995</c:v>
                </c:pt>
                <c:pt idx="1763">
                  <c:v>4.70925</c:v>
                </c:pt>
                <c:pt idx="1764">
                  <c:v>3.28662</c:v>
                </c:pt>
                <c:pt idx="1765">
                  <c:v>5.544159999999994</c:v>
                </c:pt>
                <c:pt idx="1766">
                  <c:v>5.58158</c:v>
                </c:pt>
                <c:pt idx="1767">
                  <c:v>7.94757</c:v>
                </c:pt>
                <c:pt idx="1768">
                  <c:v>3.28378</c:v>
                </c:pt>
                <c:pt idx="1769">
                  <c:v>6.386179999999999</c:v>
                </c:pt>
                <c:pt idx="1770">
                  <c:v>4.34933</c:v>
                </c:pt>
                <c:pt idx="1771">
                  <c:v>7.63974</c:v>
                </c:pt>
                <c:pt idx="1772">
                  <c:v>3.097669999999999</c:v>
                </c:pt>
                <c:pt idx="1773">
                  <c:v>4.7495</c:v>
                </c:pt>
                <c:pt idx="1774">
                  <c:v>3.84971</c:v>
                </c:pt>
                <c:pt idx="1775">
                  <c:v>3.79477</c:v>
                </c:pt>
                <c:pt idx="1776">
                  <c:v>4.01025</c:v>
                </c:pt>
                <c:pt idx="1777">
                  <c:v>3.366179999999999</c:v>
                </c:pt>
                <c:pt idx="1778">
                  <c:v>3.994149999999998</c:v>
                </c:pt>
                <c:pt idx="1779">
                  <c:v>4.71635</c:v>
                </c:pt>
                <c:pt idx="1780">
                  <c:v>2.212079999999998</c:v>
                </c:pt>
                <c:pt idx="1781">
                  <c:v>5.10563</c:v>
                </c:pt>
                <c:pt idx="1782">
                  <c:v>3.70905</c:v>
                </c:pt>
                <c:pt idx="1783">
                  <c:v>5.0758</c:v>
                </c:pt>
                <c:pt idx="1784">
                  <c:v>5.67677</c:v>
                </c:pt>
                <c:pt idx="1785">
                  <c:v>1.94024</c:v>
                </c:pt>
                <c:pt idx="1786">
                  <c:v>2.900659999999998</c:v>
                </c:pt>
                <c:pt idx="1787">
                  <c:v>5.75964</c:v>
                </c:pt>
                <c:pt idx="1788">
                  <c:v>4.07986</c:v>
                </c:pt>
                <c:pt idx="1789">
                  <c:v>3.69248</c:v>
                </c:pt>
                <c:pt idx="1790">
                  <c:v>4.615009999999986</c:v>
                </c:pt>
                <c:pt idx="1791">
                  <c:v>4.314759999999985</c:v>
                </c:pt>
                <c:pt idx="1792">
                  <c:v>3.18907</c:v>
                </c:pt>
                <c:pt idx="1793">
                  <c:v>3.195219999999999</c:v>
                </c:pt>
                <c:pt idx="1794">
                  <c:v>9.89255</c:v>
                </c:pt>
                <c:pt idx="1795">
                  <c:v>5.94007</c:v>
                </c:pt>
                <c:pt idx="1796">
                  <c:v>4.74571</c:v>
                </c:pt>
                <c:pt idx="1797">
                  <c:v>7.3466</c:v>
                </c:pt>
                <c:pt idx="1798">
                  <c:v>4.78976</c:v>
                </c:pt>
                <c:pt idx="1799">
                  <c:v>8.91508</c:v>
                </c:pt>
                <c:pt idx="1800">
                  <c:v>3.20943</c:v>
                </c:pt>
                <c:pt idx="1801">
                  <c:v>4.51177</c:v>
                </c:pt>
                <c:pt idx="1802">
                  <c:v>8.028069999999997</c:v>
                </c:pt>
                <c:pt idx="1803">
                  <c:v>3.791459999999998</c:v>
                </c:pt>
                <c:pt idx="1804">
                  <c:v>3.15734</c:v>
                </c:pt>
                <c:pt idx="1805">
                  <c:v>6.613499999999997</c:v>
                </c:pt>
                <c:pt idx="1806">
                  <c:v>2.01081</c:v>
                </c:pt>
                <c:pt idx="1807">
                  <c:v>7.49056</c:v>
                </c:pt>
                <c:pt idx="1808">
                  <c:v>6.9289</c:v>
                </c:pt>
                <c:pt idx="1809">
                  <c:v>5.76769</c:v>
                </c:pt>
                <c:pt idx="1810">
                  <c:v>2.69323</c:v>
                </c:pt>
                <c:pt idx="1811">
                  <c:v>6.18965</c:v>
                </c:pt>
                <c:pt idx="1812">
                  <c:v>4.25651</c:v>
                </c:pt>
                <c:pt idx="1813">
                  <c:v>3.04084</c:v>
                </c:pt>
                <c:pt idx="1814">
                  <c:v>4.08505</c:v>
                </c:pt>
                <c:pt idx="1815">
                  <c:v>3.77772</c:v>
                </c:pt>
                <c:pt idx="1816">
                  <c:v>2.9537</c:v>
                </c:pt>
                <c:pt idx="1817">
                  <c:v>1.75792</c:v>
                </c:pt>
                <c:pt idx="1818">
                  <c:v>1.81475</c:v>
                </c:pt>
                <c:pt idx="1819">
                  <c:v>2.49196</c:v>
                </c:pt>
                <c:pt idx="1820">
                  <c:v>1.79201</c:v>
                </c:pt>
                <c:pt idx="1821">
                  <c:v>2.01981</c:v>
                </c:pt>
                <c:pt idx="1822">
                  <c:v>2.45881</c:v>
                </c:pt>
                <c:pt idx="1823">
                  <c:v>2.18366</c:v>
                </c:pt>
                <c:pt idx="1824">
                  <c:v>2.22628</c:v>
                </c:pt>
                <c:pt idx="1825">
                  <c:v>1.72382</c:v>
                </c:pt>
                <c:pt idx="1826">
                  <c:v>1.49082</c:v>
                </c:pt>
                <c:pt idx="1827">
                  <c:v>4.8338</c:v>
                </c:pt>
                <c:pt idx="1828">
                  <c:v>4.057609999999999</c:v>
                </c:pt>
                <c:pt idx="1829">
                  <c:v>1.33738</c:v>
                </c:pt>
                <c:pt idx="1830">
                  <c:v>2.28927</c:v>
                </c:pt>
                <c:pt idx="1831">
                  <c:v>2.829149999999998</c:v>
                </c:pt>
                <c:pt idx="1832">
                  <c:v>3.59303</c:v>
                </c:pt>
                <c:pt idx="1833">
                  <c:v>1.77544</c:v>
                </c:pt>
                <c:pt idx="1834">
                  <c:v>6.46906</c:v>
                </c:pt>
                <c:pt idx="1835">
                  <c:v>1.8067</c:v>
                </c:pt>
                <c:pt idx="1836">
                  <c:v>1.6722</c:v>
                </c:pt>
                <c:pt idx="1837">
                  <c:v>1.99991</c:v>
                </c:pt>
                <c:pt idx="1838">
                  <c:v>3.15355</c:v>
                </c:pt>
                <c:pt idx="1839">
                  <c:v>2.00891</c:v>
                </c:pt>
                <c:pt idx="1840">
                  <c:v>3.84118</c:v>
                </c:pt>
                <c:pt idx="1841">
                  <c:v>2.1562</c:v>
                </c:pt>
                <c:pt idx="1842">
                  <c:v>3.28899</c:v>
                </c:pt>
                <c:pt idx="1843">
                  <c:v>2.29022</c:v>
                </c:pt>
                <c:pt idx="1844">
                  <c:v>1.34733</c:v>
                </c:pt>
                <c:pt idx="1845">
                  <c:v>1.88957</c:v>
                </c:pt>
                <c:pt idx="1846">
                  <c:v>2.49575</c:v>
                </c:pt>
                <c:pt idx="1847">
                  <c:v>0.894113</c:v>
                </c:pt>
                <c:pt idx="1848">
                  <c:v>0.820235</c:v>
                </c:pt>
                <c:pt idx="1849">
                  <c:v>0.956625</c:v>
                </c:pt>
                <c:pt idx="1850">
                  <c:v>1.74039</c:v>
                </c:pt>
                <c:pt idx="1851">
                  <c:v>2.48533</c:v>
                </c:pt>
                <c:pt idx="1852">
                  <c:v>3.890909999999998</c:v>
                </c:pt>
                <c:pt idx="1853">
                  <c:v>1.85311</c:v>
                </c:pt>
                <c:pt idx="1854">
                  <c:v>1.21283</c:v>
                </c:pt>
                <c:pt idx="1855">
                  <c:v>3.97947</c:v>
                </c:pt>
                <c:pt idx="1856">
                  <c:v>2.16472</c:v>
                </c:pt>
                <c:pt idx="1857">
                  <c:v>1.03287</c:v>
                </c:pt>
                <c:pt idx="1858">
                  <c:v>3.171069999999998</c:v>
                </c:pt>
                <c:pt idx="1859">
                  <c:v>1.90615</c:v>
                </c:pt>
                <c:pt idx="1860">
                  <c:v>2.43513</c:v>
                </c:pt>
                <c:pt idx="1861">
                  <c:v>2.06148</c:v>
                </c:pt>
                <c:pt idx="1862">
                  <c:v>1.911829999999999</c:v>
                </c:pt>
                <c:pt idx="1863">
                  <c:v>2.25423</c:v>
                </c:pt>
                <c:pt idx="1864">
                  <c:v>4.659999999999996</c:v>
                </c:pt>
                <c:pt idx="1865">
                  <c:v>1.23935</c:v>
                </c:pt>
                <c:pt idx="1866">
                  <c:v>2.02028</c:v>
                </c:pt>
                <c:pt idx="1867">
                  <c:v>1.28623</c:v>
                </c:pt>
                <c:pt idx="1868">
                  <c:v>1.58885</c:v>
                </c:pt>
                <c:pt idx="1869">
                  <c:v>1.53155</c:v>
                </c:pt>
                <c:pt idx="1870">
                  <c:v>2.19361</c:v>
                </c:pt>
                <c:pt idx="1871">
                  <c:v>1.08496</c:v>
                </c:pt>
                <c:pt idx="1872">
                  <c:v>1.42168</c:v>
                </c:pt>
                <c:pt idx="1873">
                  <c:v>1.3407</c:v>
                </c:pt>
                <c:pt idx="1874">
                  <c:v>2.19029</c:v>
                </c:pt>
                <c:pt idx="1875">
                  <c:v>2.445549999999999</c:v>
                </c:pt>
                <c:pt idx="1876">
                  <c:v>2.43561</c:v>
                </c:pt>
                <c:pt idx="1877">
                  <c:v>2.67097</c:v>
                </c:pt>
                <c:pt idx="1878">
                  <c:v>2.24144</c:v>
                </c:pt>
                <c:pt idx="1879">
                  <c:v>2.546899999999999</c:v>
                </c:pt>
                <c:pt idx="1880">
                  <c:v>3.60013</c:v>
                </c:pt>
                <c:pt idx="1881">
                  <c:v>4.5326</c:v>
                </c:pt>
                <c:pt idx="1882">
                  <c:v>6.30615</c:v>
                </c:pt>
                <c:pt idx="1883">
                  <c:v>2.58952</c:v>
                </c:pt>
                <c:pt idx="1884">
                  <c:v>3.0863</c:v>
                </c:pt>
                <c:pt idx="1885">
                  <c:v>1.29002</c:v>
                </c:pt>
                <c:pt idx="1886">
                  <c:v>1.36153</c:v>
                </c:pt>
                <c:pt idx="1887">
                  <c:v>0.863331</c:v>
                </c:pt>
                <c:pt idx="1888">
                  <c:v>1.52823</c:v>
                </c:pt>
                <c:pt idx="1889">
                  <c:v>1.45435</c:v>
                </c:pt>
                <c:pt idx="1890">
                  <c:v>1.14842</c:v>
                </c:pt>
                <c:pt idx="1891">
                  <c:v>1.62153</c:v>
                </c:pt>
                <c:pt idx="1892">
                  <c:v>1.66036</c:v>
                </c:pt>
                <c:pt idx="1893">
                  <c:v>1.77686</c:v>
                </c:pt>
                <c:pt idx="1894">
                  <c:v>1.14558</c:v>
                </c:pt>
                <c:pt idx="1895">
                  <c:v>2.03354</c:v>
                </c:pt>
                <c:pt idx="1896">
                  <c:v>2.12683</c:v>
                </c:pt>
                <c:pt idx="1897">
                  <c:v>2.09321</c:v>
                </c:pt>
                <c:pt idx="1898">
                  <c:v>1.15979</c:v>
                </c:pt>
                <c:pt idx="1899">
                  <c:v>1.34401</c:v>
                </c:pt>
                <c:pt idx="1900">
                  <c:v>1.50787</c:v>
                </c:pt>
                <c:pt idx="1901">
                  <c:v>1.84079</c:v>
                </c:pt>
                <c:pt idx="1902">
                  <c:v>2.50996</c:v>
                </c:pt>
                <c:pt idx="1903">
                  <c:v>3.853969999999999</c:v>
                </c:pt>
                <c:pt idx="1904">
                  <c:v>1.39942</c:v>
                </c:pt>
                <c:pt idx="1905">
                  <c:v>2.79931</c:v>
                </c:pt>
                <c:pt idx="1906">
                  <c:v>3.45948</c:v>
                </c:pt>
                <c:pt idx="1907">
                  <c:v>2.20592</c:v>
                </c:pt>
                <c:pt idx="1908">
                  <c:v>1.59122</c:v>
                </c:pt>
                <c:pt idx="1909">
                  <c:v>2.88598</c:v>
                </c:pt>
                <c:pt idx="1910">
                  <c:v>5.78001</c:v>
                </c:pt>
                <c:pt idx="1911">
                  <c:v>3.42633</c:v>
                </c:pt>
                <c:pt idx="1912">
                  <c:v>5.51386</c:v>
                </c:pt>
                <c:pt idx="1913">
                  <c:v>5.092849999999999</c:v>
                </c:pt>
                <c:pt idx="1914">
                  <c:v>2.859459999999952</c:v>
                </c:pt>
                <c:pt idx="1915">
                  <c:v>2.78937</c:v>
                </c:pt>
                <c:pt idx="1916">
                  <c:v>3.3444</c:v>
                </c:pt>
                <c:pt idx="1917">
                  <c:v>5.195139999999975</c:v>
                </c:pt>
                <c:pt idx="1918">
                  <c:v>2.416659999999952</c:v>
                </c:pt>
                <c:pt idx="1919">
                  <c:v>5.120309999999995</c:v>
                </c:pt>
                <c:pt idx="1920">
                  <c:v>3.824609999999998</c:v>
                </c:pt>
                <c:pt idx="1921">
                  <c:v>5.697129999999975</c:v>
                </c:pt>
                <c:pt idx="1922">
                  <c:v>5.555529999999997</c:v>
                </c:pt>
                <c:pt idx="1923">
                  <c:v>4.25461</c:v>
                </c:pt>
                <c:pt idx="1924">
                  <c:v>3.74694</c:v>
                </c:pt>
                <c:pt idx="1925">
                  <c:v>2.33237</c:v>
                </c:pt>
                <c:pt idx="1926">
                  <c:v>4.09644</c:v>
                </c:pt>
                <c:pt idx="1927">
                  <c:v>2.70697</c:v>
                </c:pt>
                <c:pt idx="1928">
                  <c:v>2.57531</c:v>
                </c:pt>
                <c:pt idx="1929">
                  <c:v>3.74647</c:v>
                </c:pt>
                <c:pt idx="1930">
                  <c:v>5.05638</c:v>
                </c:pt>
                <c:pt idx="1931">
                  <c:v>3.52767</c:v>
                </c:pt>
                <c:pt idx="1932">
                  <c:v>2.59236</c:v>
                </c:pt>
                <c:pt idx="1933">
                  <c:v>4.606959999999995</c:v>
                </c:pt>
                <c:pt idx="1934">
                  <c:v>4.17884</c:v>
                </c:pt>
                <c:pt idx="1935">
                  <c:v>5.23302</c:v>
                </c:pt>
                <c:pt idx="1936">
                  <c:v>6.78825</c:v>
                </c:pt>
                <c:pt idx="1937">
                  <c:v>2.991579999999999</c:v>
                </c:pt>
                <c:pt idx="1938">
                  <c:v>1.35632</c:v>
                </c:pt>
                <c:pt idx="1939">
                  <c:v>4.425579999999996</c:v>
                </c:pt>
                <c:pt idx="1940">
                  <c:v>3.405489999999999</c:v>
                </c:pt>
                <c:pt idx="1941">
                  <c:v>3.00721</c:v>
                </c:pt>
                <c:pt idx="1942">
                  <c:v>2.826779999999998</c:v>
                </c:pt>
                <c:pt idx="1943">
                  <c:v>3.479839999999998</c:v>
                </c:pt>
                <c:pt idx="1944">
                  <c:v>3.87481</c:v>
                </c:pt>
                <c:pt idx="1945">
                  <c:v>4.01735</c:v>
                </c:pt>
                <c:pt idx="1946">
                  <c:v>4.847529999999995</c:v>
                </c:pt>
                <c:pt idx="1947">
                  <c:v>5.23255</c:v>
                </c:pt>
                <c:pt idx="1948">
                  <c:v>5.574</c:v>
                </c:pt>
                <c:pt idx="1949">
                  <c:v>2.23954</c:v>
                </c:pt>
                <c:pt idx="1950">
                  <c:v>3.12561</c:v>
                </c:pt>
                <c:pt idx="1951">
                  <c:v>4.33086</c:v>
                </c:pt>
                <c:pt idx="1952">
                  <c:v>3.67401</c:v>
                </c:pt>
                <c:pt idx="1953">
                  <c:v>3.94868</c:v>
                </c:pt>
                <c:pt idx="1954">
                  <c:v>6.880119999999994</c:v>
                </c:pt>
                <c:pt idx="1955">
                  <c:v>4.41232</c:v>
                </c:pt>
                <c:pt idx="1956">
                  <c:v>2.96317</c:v>
                </c:pt>
                <c:pt idx="1957">
                  <c:v>5.164359999999975</c:v>
                </c:pt>
                <c:pt idx="1958">
                  <c:v>6.315149999999996</c:v>
                </c:pt>
                <c:pt idx="1959">
                  <c:v>4.507029999999999</c:v>
                </c:pt>
                <c:pt idx="1960">
                  <c:v>3.20801</c:v>
                </c:pt>
                <c:pt idx="1961">
                  <c:v>6.90664</c:v>
                </c:pt>
                <c:pt idx="1962">
                  <c:v>5.322529999999984</c:v>
                </c:pt>
                <c:pt idx="1963">
                  <c:v>3.73463</c:v>
                </c:pt>
                <c:pt idx="1964">
                  <c:v>5.63604</c:v>
                </c:pt>
                <c:pt idx="1965">
                  <c:v>4.43268</c:v>
                </c:pt>
                <c:pt idx="1966">
                  <c:v>6.20812</c:v>
                </c:pt>
                <c:pt idx="1967">
                  <c:v>1.72571</c:v>
                </c:pt>
                <c:pt idx="1968">
                  <c:v>2.66908</c:v>
                </c:pt>
                <c:pt idx="1969">
                  <c:v>1.95919</c:v>
                </c:pt>
                <c:pt idx="1970">
                  <c:v>1.98665</c:v>
                </c:pt>
                <c:pt idx="1971">
                  <c:v>5.44519</c:v>
                </c:pt>
                <c:pt idx="1972">
                  <c:v>3.6437</c:v>
                </c:pt>
                <c:pt idx="1973">
                  <c:v>2.58431</c:v>
                </c:pt>
                <c:pt idx="1974">
                  <c:v>4.49661</c:v>
                </c:pt>
                <c:pt idx="1975">
                  <c:v>3.313619999999998</c:v>
                </c:pt>
                <c:pt idx="1976">
                  <c:v>4.514129999999994</c:v>
                </c:pt>
                <c:pt idx="1977">
                  <c:v>7.23057</c:v>
                </c:pt>
                <c:pt idx="1978">
                  <c:v>7.05061</c:v>
                </c:pt>
                <c:pt idx="1979">
                  <c:v>4.542549999999999</c:v>
                </c:pt>
                <c:pt idx="1980">
                  <c:v>3.79572</c:v>
                </c:pt>
                <c:pt idx="1981">
                  <c:v>4.54823</c:v>
                </c:pt>
                <c:pt idx="1982">
                  <c:v>3.991309999999999</c:v>
                </c:pt>
                <c:pt idx="1983">
                  <c:v>7.68142</c:v>
                </c:pt>
                <c:pt idx="1984">
                  <c:v>8.098640000000001</c:v>
                </c:pt>
                <c:pt idx="1985">
                  <c:v>4.355009999999996</c:v>
                </c:pt>
                <c:pt idx="1986">
                  <c:v>9.19355</c:v>
                </c:pt>
                <c:pt idx="1987">
                  <c:v>9.75284</c:v>
                </c:pt>
                <c:pt idx="1988">
                  <c:v>8.589260000000001</c:v>
                </c:pt>
                <c:pt idx="1989">
                  <c:v>6.20812</c:v>
                </c:pt>
                <c:pt idx="1990">
                  <c:v>3.578349999999999</c:v>
                </c:pt>
                <c:pt idx="1991">
                  <c:v>5.617089999999965</c:v>
                </c:pt>
                <c:pt idx="1992">
                  <c:v>5.190399999999999</c:v>
                </c:pt>
                <c:pt idx="1993">
                  <c:v>4.782179999999998</c:v>
                </c:pt>
                <c:pt idx="1994">
                  <c:v>5.857199999999985</c:v>
                </c:pt>
                <c:pt idx="1995">
                  <c:v>5.60336</c:v>
                </c:pt>
                <c:pt idx="1996">
                  <c:v>4.48335</c:v>
                </c:pt>
                <c:pt idx="1997">
                  <c:v>3.45427</c:v>
                </c:pt>
                <c:pt idx="1998">
                  <c:v>5.127889999999937</c:v>
                </c:pt>
                <c:pt idx="1999">
                  <c:v>4.818169999999998</c:v>
                </c:pt>
                <c:pt idx="2000">
                  <c:v>3.857279999999998</c:v>
                </c:pt>
                <c:pt idx="2001">
                  <c:v>3.43012</c:v>
                </c:pt>
                <c:pt idx="2002">
                  <c:v>4.29913</c:v>
                </c:pt>
                <c:pt idx="2003">
                  <c:v>4.69267</c:v>
                </c:pt>
                <c:pt idx="2004">
                  <c:v>4.78597</c:v>
                </c:pt>
                <c:pt idx="2005">
                  <c:v>4.222409999999996</c:v>
                </c:pt>
                <c:pt idx="2006">
                  <c:v>5.94055</c:v>
                </c:pt>
                <c:pt idx="2007">
                  <c:v>5.57353</c:v>
                </c:pt>
                <c:pt idx="2008">
                  <c:v>3.0863</c:v>
                </c:pt>
                <c:pt idx="2009">
                  <c:v>5.7478</c:v>
                </c:pt>
                <c:pt idx="2010">
                  <c:v>4.20678</c:v>
                </c:pt>
                <c:pt idx="2011">
                  <c:v>4.40379</c:v>
                </c:pt>
                <c:pt idx="2012">
                  <c:v>5.11131</c:v>
                </c:pt>
                <c:pt idx="2013">
                  <c:v>6.417909999999996</c:v>
                </c:pt>
                <c:pt idx="2014">
                  <c:v>8.187200000000001</c:v>
                </c:pt>
                <c:pt idx="2015">
                  <c:v>5.057799999999999</c:v>
                </c:pt>
                <c:pt idx="2016">
                  <c:v>4.227619999999995</c:v>
                </c:pt>
                <c:pt idx="2017">
                  <c:v>4.174579999999994</c:v>
                </c:pt>
                <c:pt idx="2018">
                  <c:v>5.025119999999966</c:v>
                </c:pt>
                <c:pt idx="2019">
                  <c:v>4.13669</c:v>
                </c:pt>
                <c:pt idx="2020">
                  <c:v>4.4843</c:v>
                </c:pt>
                <c:pt idx="2021">
                  <c:v>3.89659</c:v>
                </c:pt>
                <c:pt idx="2022">
                  <c:v>3.61008</c:v>
                </c:pt>
                <c:pt idx="2023">
                  <c:v>5.87556</c:v>
                </c:pt>
                <c:pt idx="2024">
                  <c:v>6.138979999999997</c:v>
                </c:pt>
                <c:pt idx="2025">
                  <c:v>4.0363</c:v>
                </c:pt>
                <c:pt idx="2026">
                  <c:v>5.07106</c:v>
                </c:pt>
                <c:pt idx="2027">
                  <c:v>1.75697</c:v>
                </c:pt>
                <c:pt idx="2028">
                  <c:v>4.73103</c:v>
                </c:pt>
                <c:pt idx="2029">
                  <c:v>6.550509999999996</c:v>
                </c:pt>
                <c:pt idx="2030">
                  <c:v>4.302919999999967</c:v>
                </c:pt>
                <c:pt idx="2031">
                  <c:v>4.828119999999966</c:v>
                </c:pt>
                <c:pt idx="2032">
                  <c:v>6.704429999999998</c:v>
                </c:pt>
                <c:pt idx="2033">
                  <c:v>3.02095</c:v>
                </c:pt>
                <c:pt idx="2034">
                  <c:v>5.54464</c:v>
                </c:pt>
                <c:pt idx="2035">
                  <c:v>3.84876</c:v>
                </c:pt>
                <c:pt idx="2036">
                  <c:v>2.682809999999998</c:v>
                </c:pt>
                <c:pt idx="2037">
                  <c:v>3.32688</c:v>
                </c:pt>
                <c:pt idx="2038">
                  <c:v>4.444519999999994</c:v>
                </c:pt>
                <c:pt idx="2039">
                  <c:v>5.78616</c:v>
                </c:pt>
                <c:pt idx="2040">
                  <c:v>6.58082</c:v>
                </c:pt>
                <c:pt idx="2041">
                  <c:v>6.353509999999995</c:v>
                </c:pt>
                <c:pt idx="2042">
                  <c:v>6.20386</c:v>
                </c:pt>
                <c:pt idx="2043">
                  <c:v>7.85569</c:v>
                </c:pt>
                <c:pt idx="2044">
                  <c:v>4.26977</c:v>
                </c:pt>
                <c:pt idx="2045">
                  <c:v>3.651749999999998</c:v>
                </c:pt>
                <c:pt idx="2046">
                  <c:v>4.38343</c:v>
                </c:pt>
                <c:pt idx="2047">
                  <c:v>6.89765</c:v>
                </c:pt>
                <c:pt idx="2048">
                  <c:v>1.99044</c:v>
                </c:pt>
                <c:pt idx="2049">
                  <c:v>4.677519999999966</c:v>
                </c:pt>
                <c:pt idx="2050">
                  <c:v>2.90871</c:v>
                </c:pt>
                <c:pt idx="2051">
                  <c:v>5.20698</c:v>
                </c:pt>
                <c:pt idx="2052">
                  <c:v>8.12753</c:v>
                </c:pt>
                <c:pt idx="2053">
                  <c:v>4.05382</c:v>
                </c:pt>
                <c:pt idx="2054">
                  <c:v>3.00579</c:v>
                </c:pt>
                <c:pt idx="2055">
                  <c:v>4.214829999999997</c:v>
                </c:pt>
                <c:pt idx="2056">
                  <c:v>3.66738</c:v>
                </c:pt>
                <c:pt idx="2057">
                  <c:v>4.24656</c:v>
                </c:pt>
                <c:pt idx="2058">
                  <c:v>3.08393</c:v>
                </c:pt>
                <c:pt idx="2059">
                  <c:v>4.13622</c:v>
                </c:pt>
                <c:pt idx="2060">
                  <c:v>5.43524</c:v>
                </c:pt>
                <c:pt idx="2061">
                  <c:v>4.47814</c:v>
                </c:pt>
                <c:pt idx="2062">
                  <c:v>5.805579999999995</c:v>
                </c:pt>
                <c:pt idx="2063">
                  <c:v>2.32526</c:v>
                </c:pt>
                <c:pt idx="2064">
                  <c:v>3.377549999999998</c:v>
                </c:pt>
                <c:pt idx="2065">
                  <c:v>4.658579999999985</c:v>
                </c:pt>
                <c:pt idx="2066">
                  <c:v>6.062729999999997</c:v>
                </c:pt>
                <c:pt idx="2067">
                  <c:v>4.74429</c:v>
                </c:pt>
                <c:pt idx="2068">
                  <c:v>4.33275</c:v>
                </c:pt>
                <c:pt idx="2069">
                  <c:v>3.78672</c:v>
                </c:pt>
                <c:pt idx="2070">
                  <c:v>4.87358</c:v>
                </c:pt>
                <c:pt idx="2071">
                  <c:v>7.162849999999985</c:v>
                </c:pt>
                <c:pt idx="2072">
                  <c:v>3.16397</c:v>
                </c:pt>
                <c:pt idx="2073">
                  <c:v>2.650609999999998</c:v>
                </c:pt>
                <c:pt idx="2074">
                  <c:v>2.06148</c:v>
                </c:pt>
                <c:pt idx="2075">
                  <c:v>3.78483</c:v>
                </c:pt>
                <c:pt idx="2076">
                  <c:v>2.479649999999952</c:v>
                </c:pt>
                <c:pt idx="2077">
                  <c:v>2.515639999999999</c:v>
                </c:pt>
                <c:pt idx="2078">
                  <c:v>5.97465</c:v>
                </c:pt>
                <c:pt idx="2079">
                  <c:v>3.50115</c:v>
                </c:pt>
                <c:pt idx="2080">
                  <c:v>3.32593</c:v>
                </c:pt>
                <c:pt idx="2081">
                  <c:v>3.70716</c:v>
                </c:pt>
                <c:pt idx="2082">
                  <c:v>2.823469999999999</c:v>
                </c:pt>
                <c:pt idx="2083">
                  <c:v>3.10761</c:v>
                </c:pt>
                <c:pt idx="2084">
                  <c:v>3.306509999999998</c:v>
                </c:pt>
                <c:pt idx="2085">
                  <c:v>3.435799999999999</c:v>
                </c:pt>
                <c:pt idx="2086">
                  <c:v>4.03677</c:v>
                </c:pt>
                <c:pt idx="2087">
                  <c:v>4.24041</c:v>
                </c:pt>
                <c:pt idx="2088">
                  <c:v>5.412509999999997</c:v>
                </c:pt>
                <c:pt idx="2089">
                  <c:v>2.42045</c:v>
                </c:pt>
                <c:pt idx="2090">
                  <c:v>2.895449999999952</c:v>
                </c:pt>
                <c:pt idx="2091">
                  <c:v>5.23681</c:v>
                </c:pt>
                <c:pt idx="2092">
                  <c:v>2.14009</c:v>
                </c:pt>
                <c:pt idx="2093">
                  <c:v>3.16776</c:v>
                </c:pt>
                <c:pt idx="2094">
                  <c:v>3.856809999999952</c:v>
                </c:pt>
                <c:pt idx="2095">
                  <c:v>2.32289</c:v>
                </c:pt>
                <c:pt idx="2096">
                  <c:v>1.4965</c:v>
                </c:pt>
                <c:pt idx="2097">
                  <c:v>3.166809999999999</c:v>
                </c:pt>
                <c:pt idx="2098">
                  <c:v>1.9142</c:v>
                </c:pt>
                <c:pt idx="2099">
                  <c:v>1.82659</c:v>
                </c:pt>
                <c:pt idx="2100">
                  <c:v>2.756689999999998</c:v>
                </c:pt>
                <c:pt idx="2101">
                  <c:v>4.08981</c:v>
                </c:pt>
                <c:pt idx="2102">
                  <c:v>2.32289</c:v>
                </c:pt>
                <c:pt idx="2103">
                  <c:v>3.20564</c:v>
                </c:pt>
                <c:pt idx="2104">
                  <c:v>2.05532</c:v>
                </c:pt>
                <c:pt idx="2105">
                  <c:v>4.8267</c:v>
                </c:pt>
                <c:pt idx="2106">
                  <c:v>4.643889999999994</c:v>
                </c:pt>
                <c:pt idx="2107">
                  <c:v>6.14371</c:v>
                </c:pt>
                <c:pt idx="2108">
                  <c:v>2.84099</c:v>
                </c:pt>
                <c:pt idx="2109">
                  <c:v>3.15734</c:v>
                </c:pt>
                <c:pt idx="2110">
                  <c:v>2.05106</c:v>
                </c:pt>
                <c:pt idx="2111">
                  <c:v>3.31314</c:v>
                </c:pt>
                <c:pt idx="2112">
                  <c:v>4.34365</c:v>
                </c:pt>
                <c:pt idx="2113">
                  <c:v>4.85369</c:v>
                </c:pt>
                <c:pt idx="2114">
                  <c:v>3.5433</c:v>
                </c:pt>
                <c:pt idx="2115">
                  <c:v>2.98495</c:v>
                </c:pt>
                <c:pt idx="2116">
                  <c:v>2.7458</c:v>
                </c:pt>
                <c:pt idx="2117">
                  <c:v>3.49642</c:v>
                </c:pt>
                <c:pt idx="2118">
                  <c:v>3.343449999999998</c:v>
                </c:pt>
                <c:pt idx="2119">
                  <c:v>3.476049999999952</c:v>
                </c:pt>
                <c:pt idx="2120">
                  <c:v>2.46781</c:v>
                </c:pt>
                <c:pt idx="2121">
                  <c:v>3.452379999999998</c:v>
                </c:pt>
                <c:pt idx="2122">
                  <c:v>3.410229999999999</c:v>
                </c:pt>
                <c:pt idx="2123">
                  <c:v>2.932389999999998</c:v>
                </c:pt>
                <c:pt idx="2124">
                  <c:v>1.99755</c:v>
                </c:pt>
                <c:pt idx="2125">
                  <c:v>3.1706</c:v>
                </c:pt>
                <c:pt idx="2126">
                  <c:v>1.27487</c:v>
                </c:pt>
                <c:pt idx="2127">
                  <c:v>2.92055</c:v>
                </c:pt>
                <c:pt idx="2128">
                  <c:v>1.64473</c:v>
                </c:pt>
                <c:pt idx="2129">
                  <c:v>4.328969999999995</c:v>
                </c:pt>
                <c:pt idx="2130">
                  <c:v>1.71387</c:v>
                </c:pt>
                <c:pt idx="2131">
                  <c:v>1.55854</c:v>
                </c:pt>
                <c:pt idx="2132">
                  <c:v>1.5808</c:v>
                </c:pt>
                <c:pt idx="2133">
                  <c:v>2.35983</c:v>
                </c:pt>
                <c:pt idx="2134">
                  <c:v>3.336349999999952</c:v>
                </c:pt>
                <c:pt idx="2135">
                  <c:v>2.36978</c:v>
                </c:pt>
                <c:pt idx="2136">
                  <c:v>1.79012</c:v>
                </c:pt>
                <c:pt idx="2137">
                  <c:v>3.1867</c:v>
                </c:pt>
                <c:pt idx="2138">
                  <c:v>2.06148</c:v>
                </c:pt>
                <c:pt idx="2139">
                  <c:v>2.992529999999999</c:v>
                </c:pt>
                <c:pt idx="2140">
                  <c:v>2.139149999999999</c:v>
                </c:pt>
                <c:pt idx="2141">
                  <c:v>1.87821</c:v>
                </c:pt>
                <c:pt idx="2142">
                  <c:v>3.22601</c:v>
                </c:pt>
                <c:pt idx="2143">
                  <c:v>3.63518</c:v>
                </c:pt>
                <c:pt idx="2144">
                  <c:v>4.257929999999996</c:v>
                </c:pt>
                <c:pt idx="2145">
                  <c:v>1.23556</c:v>
                </c:pt>
                <c:pt idx="2146">
                  <c:v>2.111679999999998</c:v>
                </c:pt>
                <c:pt idx="2147">
                  <c:v>2.271749999999999</c:v>
                </c:pt>
                <c:pt idx="2148">
                  <c:v>3.95153</c:v>
                </c:pt>
                <c:pt idx="2149">
                  <c:v>3.11045</c:v>
                </c:pt>
                <c:pt idx="2150">
                  <c:v>2.830569999999998</c:v>
                </c:pt>
                <c:pt idx="2151">
                  <c:v>1.26256</c:v>
                </c:pt>
                <c:pt idx="2152">
                  <c:v>2.67429</c:v>
                </c:pt>
                <c:pt idx="2153">
                  <c:v>4.36258999999994</c:v>
                </c:pt>
                <c:pt idx="2154">
                  <c:v>3.74694</c:v>
                </c:pt>
                <c:pt idx="2155">
                  <c:v>4.72061</c:v>
                </c:pt>
                <c:pt idx="2156">
                  <c:v>2.138669999999999</c:v>
                </c:pt>
                <c:pt idx="2157">
                  <c:v>2.314369999999998</c:v>
                </c:pt>
                <c:pt idx="2158">
                  <c:v>1.75697</c:v>
                </c:pt>
                <c:pt idx="2159">
                  <c:v>2.653449999999998</c:v>
                </c:pt>
                <c:pt idx="2160">
                  <c:v>2.72449</c:v>
                </c:pt>
                <c:pt idx="2161">
                  <c:v>1.96392</c:v>
                </c:pt>
                <c:pt idx="2162">
                  <c:v>4.27261</c:v>
                </c:pt>
                <c:pt idx="2163">
                  <c:v>3.671639999999999</c:v>
                </c:pt>
                <c:pt idx="2164">
                  <c:v>2.936179999999998</c:v>
                </c:pt>
                <c:pt idx="2165">
                  <c:v>2.71833</c:v>
                </c:pt>
                <c:pt idx="2166">
                  <c:v>4.39337</c:v>
                </c:pt>
                <c:pt idx="2167">
                  <c:v>2.4304</c:v>
                </c:pt>
                <c:pt idx="2168">
                  <c:v>1.34022</c:v>
                </c:pt>
                <c:pt idx="2169">
                  <c:v>2.386829999999998</c:v>
                </c:pt>
                <c:pt idx="2170">
                  <c:v>3.22553</c:v>
                </c:pt>
                <c:pt idx="2171">
                  <c:v>1.90662</c:v>
                </c:pt>
                <c:pt idx="2172">
                  <c:v>1.24503</c:v>
                </c:pt>
                <c:pt idx="2173">
                  <c:v>1.68735</c:v>
                </c:pt>
                <c:pt idx="2174">
                  <c:v>1.01819</c:v>
                </c:pt>
                <c:pt idx="2175">
                  <c:v>1.67267</c:v>
                </c:pt>
                <c:pt idx="2176">
                  <c:v>1.18962</c:v>
                </c:pt>
                <c:pt idx="2177">
                  <c:v>1.8228</c:v>
                </c:pt>
                <c:pt idx="2178">
                  <c:v>1.7816</c:v>
                </c:pt>
                <c:pt idx="2179">
                  <c:v>0.801292</c:v>
                </c:pt>
                <c:pt idx="2180">
                  <c:v>0.986461</c:v>
                </c:pt>
                <c:pt idx="2181">
                  <c:v>3.68111</c:v>
                </c:pt>
                <c:pt idx="2182">
                  <c:v>3.55372</c:v>
                </c:pt>
                <c:pt idx="2183">
                  <c:v>2.00749</c:v>
                </c:pt>
                <c:pt idx="2184">
                  <c:v>3.19712</c:v>
                </c:pt>
                <c:pt idx="2185">
                  <c:v>3.5954</c:v>
                </c:pt>
                <c:pt idx="2186">
                  <c:v>2.11736</c:v>
                </c:pt>
                <c:pt idx="2187">
                  <c:v>1.36627</c:v>
                </c:pt>
                <c:pt idx="2188">
                  <c:v>1.43115</c:v>
                </c:pt>
                <c:pt idx="2189">
                  <c:v>2.07758</c:v>
                </c:pt>
                <c:pt idx="2190">
                  <c:v>4.29866</c:v>
                </c:pt>
                <c:pt idx="2191">
                  <c:v>2.17987</c:v>
                </c:pt>
                <c:pt idx="2192">
                  <c:v>1.59217</c:v>
                </c:pt>
                <c:pt idx="2193">
                  <c:v>0.922054</c:v>
                </c:pt>
                <c:pt idx="2194">
                  <c:v>1.62058</c:v>
                </c:pt>
                <c:pt idx="2195">
                  <c:v>2.12304</c:v>
                </c:pt>
                <c:pt idx="2196">
                  <c:v>2.28027</c:v>
                </c:pt>
                <c:pt idx="2197">
                  <c:v>2.68707</c:v>
                </c:pt>
                <c:pt idx="2198">
                  <c:v>1.59548</c:v>
                </c:pt>
                <c:pt idx="2199">
                  <c:v>2.57152</c:v>
                </c:pt>
                <c:pt idx="2200">
                  <c:v>2.0468</c:v>
                </c:pt>
                <c:pt idx="2201">
                  <c:v>2.923859999999999</c:v>
                </c:pt>
                <c:pt idx="2202">
                  <c:v>1.69446</c:v>
                </c:pt>
                <c:pt idx="2203">
                  <c:v>3.42964</c:v>
                </c:pt>
                <c:pt idx="2204">
                  <c:v>1.8962</c:v>
                </c:pt>
                <c:pt idx="2205">
                  <c:v>4.00883</c:v>
                </c:pt>
                <c:pt idx="2206">
                  <c:v>3.28378</c:v>
                </c:pt>
                <c:pt idx="2207">
                  <c:v>1.84884</c:v>
                </c:pt>
                <c:pt idx="2208">
                  <c:v>1.2976</c:v>
                </c:pt>
                <c:pt idx="2209">
                  <c:v>2.91771</c:v>
                </c:pt>
                <c:pt idx="2210">
                  <c:v>1.7797</c:v>
                </c:pt>
                <c:pt idx="2211">
                  <c:v>2.350839999999998</c:v>
                </c:pt>
                <c:pt idx="2212">
                  <c:v>1.7816</c:v>
                </c:pt>
                <c:pt idx="2213">
                  <c:v>1.52066</c:v>
                </c:pt>
                <c:pt idx="2214">
                  <c:v>1.51592</c:v>
                </c:pt>
                <c:pt idx="2215">
                  <c:v>1.80385</c:v>
                </c:pt>
                <c:pt idx="2216">
                  <c:v>1.31607</c:v>
                </c:pt>
                <c:pt idx="2217">
                  <c:v>2.26512</c:v>
                </c:pt>
                <c:pt idx="2218">
                  <c:v>2.28311</c:v>
                </c:pt>
                <c:pt idx="2219">
                  <c:v>1.92367</c:v>
                </c:pt>
                <c:pt idx="2220">
                  <c:v>1.05655</c:v>
                </c:pt>
                <c:pt idx="2221">
                  <c:v>0.773351</c:v>
                </c:pt>
                <c:pt idx="2222">
                  <c:v>1.94924</c:v>
                </c:pt>
                <c:pt idx="2223">
                  <c:v>1.89052</c:v>
                </c:pt>
                <c:pt idx="2224">
                  <c:v>1.52965</c:v>
                </c:pt>
                <c:pt idx="2225">
                  <c:v>2.85141</c:v>
                </c:pt>
                <c:pt idx="2226">
                  <c:v>2.616509999999998</c:v>
                </c:pt>
                <c:pt idx="2227">
                  <c:v>2.332839999999996</c:v>
                </c:pt>
                <c:pt idx="2228">
                  <c:v>2.47349</c:v>
                </c:pt>
                <c:pt idx="2229">
                  <c:v>2.448869999999999</c:v>
                </c:pt>
                <c:pt idx="2230">
                  <c:v>2.47397</c:v>
                </c:pt>
                <c:pt idx="2231">
                  <c:v>1.68972</c:v>
                </c:pt>
                <c:pt idx="2232">
                  <c:v>2.898289999999998</c:v>
                </c:pt>
                <c:pt idx="2233">
                  <c:v>1.95019</c:v>
                </c:pt>
                <c:pt idx="2234">
                  <c:v>2.6956</c:v>
                </c:pt>
                <c:pt idx="2235">
                  <c:v>1.40747</c:v>
                </c:pt>
                <c:pt idx="2236">
                  <c:v>3.64844</c:v>
                </c:pt>
                <c:pt idx="2237">
                  <c:v>3.23974</c:v>
                </c:pt>
                <c:pt idx="2238">
                  <c:v>2.034009999999999</c:v>
                </c:pt>
                <c:pt idx="2239">
                  <c:v>3.26342</c:v>
                </c:pt>
                <c:pt idx="2240">
                  <c:v>1.86779</c:v>
                </c:pt>
                <c:pt idx="2241">
                  <c:v>2.36504</c:v>
                </c:pt>
                <c:pt idx="2242">
                  <c:v>2.32432</c:v>
                </c:pt>
                <c:pt idx="2243">
                  <c:v>2.1311</c:v>
                </c:pt>
                <c:pt idx="2244">
                  <c:v>4.96309</c:v>
                </c:pt>
                <c:pt idx="2245">
                  <c:v>5.52664</c:v>
                </c:pt>
                <c:pt idx="2246">
                  <c:v>3.2601</c:v>
                </c:pt>
                <c:pt idx="2247">
                  <c:v>3.17912</c:v>
                </c:pt>
                <c:pt idx="2248">
                  <c:v>4.43363</c:v>
                </c:pt>
                <c:pt idx="2249">
                  <c:v>1.62295</c:v>
                </c:pt>
                <c:pt idx="2250">
                  <c:v>1.27724</c:v>
                </c:pt>
                <c:pt idx="2251">
                  <c:v>3.02142</c:v>
                </c:pt>
                <c:pt idx="2252">
                  <c:v>3.10477</c:v>
                </c:pt>
                <c:pt idx="2253">
                  <c:v>2.43513</c:v>
                </c:pt>
                <c:pt idx="2254">
                  <c:v>3.39933</c:v>
                </c:pt>
                <c:pt idx="2255">
                  <c:v>5.7156</c:v>
                </c:pt>
                <c:pt idx="2256">
                  <c:v>3.74599</c:v>
                </c:pt>
                <c:pt idx="2257">
                  <c:v>4.364479999999975</c:v>
                </c:pt>
                <c:pt idx="2258">
                  <c:v>5.267599999999994</c:v>
                </c:pt>
                <c:pt idx="2259">
                  <c:v>3.972839999999997</c:v>
                </c:pt>
                <c:pt idx="2260">
                  <c:v>3.406909999999999</c:v>
                </c:pt>
                <c:pt idx="2261">
                  <c:v>3.309829999999998</c:v>
                </c:pt>
                <c:pt idx="2262">
                  <c:v>4.024459999999975</c:v>
                </c:pt>
                <c:pt idx="2263">
                  <c:v>2.135359999999999</c:v>
                </c:pt>
                <c:pt idx="2264">
                  <c:v>3.21227</c:v>
                </c:pt>
                <c:pt idx="2265">
                  <c:v>2.62456</c:v>
                </c:pt>
                <c:pt idx="2266">
                  <c:v>2.26417</c:v>
                </c:pt>
                <c:pt idx="2267">
                  <c:v>4.069919999999994</c:v>
                </c:pt>
                <c:pt idx="2268">
                  <c:v>1.68309</c:v>
                </c:pt>
                <c:pt idx="2269">
                  <c:v>2.97643</c:v>
                </c:pt>
                <c:pt idx="2270">
                  <c:v>3.86344</c:v>
                </c:pt>
                <c:pt idx="2271">
                  <c:v>4.25461</c:v>
                </c:pt>
                <c:pt idx="2272">
                  <c:v>4.71919</c:v>
                </c:pt>
                <c:pt idx="2273">
                  <c:v>2.370249999999956</c:v>
                </c:pt>
                <c:pt idx="2274">
                  <c:v>3.20564</c:v>
                </c:pt>
                <c:pt idx="2275">
                  <c:v>2.43371</c:v>
                </c:pt>
                <c:pt idx="2276">
                  <c:v>2.22771</c:v>
                </c:pt>
                <c:pt idx="2277">
                  <c:v>5.8984</c:v>
                </c:pt>
                <c:pt idx="2278">
                  <c:v>6.10535</c:v>
                </c:pt>
                <c:pt idx="2279">
                  <c:v>4.605529999999986</c:v>
                </c:pt>
                <c:pt idx="2280">
                  <c:v>3.50873</c:v>
                </c:pt>
                <c:pt idx="2281">
                  <c:v>2.5701</c:v>
                </c:pt>
                <c:pt idx="2282">
                  <c:v>2.11073</c:v>
                </c:pt>
                <c:pt idx="2283">
                  <c:v>4.597009999999996</c:v>
                </c:pt>
                <c:pt idx="2284">
                  <c:v>3.64133</c:v>
                </c:pt>
                <c:pt idx="2285">
                  <c:v>4.96687</c:v>
                </c:pt>
                <c:pt idx="2286">
                  <c:v>4.2082</c:v>
                </c:pt>
                <c:pt idx="2287">
                  <c:v>5.07059</c:v>
                </c:pt>
                <c:pt idx="2288">
                  <c:v>4.74666</c:v>
                </c:pt>
                <c:pt idx="2289">
                  <c:v>3.15497</c:v>
                </c:pt>
                <c:pt idx="2290">
                  <c:v>4.643889999999994</c:v>
                </c:pt>
                <c:pt idx="2291">
                  <c:v>4.227619999999995</c:v>
                </c:pt>
                <c:pt idx="2292">
                  <c:v>4.80112</c:v>
                </c:pt>
                <c:pt idx="2293">
                  <c:v>6.99615</c:v>
                </c:pt>
                <c:pt idx="2294">
                  <c:v>5.21787</c:v>
                </c:pt>
                <c:pt idx="2295">
                  <c:v>3.879539999999999</c:v>
                </c:pt>
                <c:pt idx="2296">
                  <c:v>3.301779999999999</c:v>
                </c:pt>
                <c:pt idx="2297">
                  <c:v>2.91344</c:v>
                </c:pt>
                <c:pt idx="2298">
                  <c:v>2.332839999999996</c:v>
                </c:pt>
                <c:pt idx="2299">
                  <c:v>1.75886</c:v>
                </c:pt>
                <c:pt idx="2300">
                  <c:v>1.80338</c:v>
                </c:pt>
                <c:pt idx="2301">
                  <c:v>2.97501</c:v>
                </c:pt>
                <c:pt idx="2302">
                  <c:v>4.60932</c:v>
                </c:pt>
                <c:pt idx="2303">
                  <c:v>2.79694</c:v>
                </c:pt>
                <c:pt idx="2304">
                  <c:v>2.56252</c:v>
                </c:pt>
                <c:pt idx="2305">
                  <c:v>4.874049999999999</c:v>
                </c:pt>
                <c:pt idx="2306">
                  <c:v>4.21862</c:v>
                </c:pt>
                <c:pt idx="2307">
                  <c:v>2.46355</c:v>
                </c:pt>
                <c:pt idx="2308">
                  <c:v>4.74619</c:v>
                </c:pt>
                <c:pt idx="2309">
                  <c:v>4.30529</c:v>
                </c:pt>
                <c:pt idx="2310">
                  <c:v>4.83806</c:v>
                </c:pt>
                <c:pt idx="2311">
                  <c:v>2.84193</c:v>
                </c:pt>
                <c:pt idx="2312">
                  <c:v>2.87651</c:v>
                </c:pt>
                <c:pt idx="2313">
                  <c:v>2.97596</c:v>
                </c:pt>
                <c:pt idx="2314">
                  <c:v>4.927569999999998</c:v>
                </c:pt>
                <c:pt idx="2315">
                  <c:v>4.04529</c:v>
                </c:pt>
                <c:pt idx="2316">
                  <c:v>5.582519999999985</c:v>
                </c:pt>
                <c:pt idx="2317">
                  <c:v>3.26673</c:v>
                </c:pt>
                <c:pt idx="2318">
                  <c:v>3.03657</c:v>
                </c:pt>
                <c:pt idx="2319">
                  <c:v>3.69437</c:v>
                </c:pt>
                <c:pt idx="2320">
                  <c:v>3.578349999999999</c:v>
                </c:pt>
                <c:pt idx="2321">
                  <c:v>3.50305</c:v>
                </c:pt>
                <c:pt idx="2322">
                  <c:v>3.896119999999998</c:v>
                </c:pt>
                <c:pt idx="2323">
                  <c:v>3.96763</c:v>
                </c:pt>
                <c:pt idx="2324">
                  <c:v>4.394319999999976</c:v>
                </c:pt>
                <c:pt idx="2325">
                  <c:v>2.2045</c:v>
                </c:pt>
                <c:pt idx="2326">
                  <c:v>7.24999</c:v>
                </c:pt>
                <c:pt idx="2327">
                  <c:v>3.682059999999998</c:v>
                </c:pt>
                <c:pt idx="2328">
                  <c:v>7.27888</c:v>
                </c:pt>
                <c:pt idx="2329">
                  <c:v>3.59587</c:v>
                </c:pt>
                <c:pt idx="2330">
                  <c:v>4.784549999999998</c:v>
                </c:pt>
                <c:pt idx="2331">
                  <c:v>4.700719999999999</c:v>
                </c:pt>
                <c:pt idx="2332">
                  <c:v>2.98874</c:v>
                </c:pt>
                <c:pt idx="2333">
                  <c:v>5.808419999999995</c:v>
                </c:pt>
                <c:pt idx="2334">
                  <c:v>7.31108</c:v>
                </c:pt>
                <c:pt idx="2335">
                  <c:v>5.45987</c:v>
                </c:pt>
                <c:pt idx="2336">
                  <c:v>5.628459999999975</c:v>
                </c:pt>
                <c:pt idx="2337">
                  <c:v>5.769109999999999</c:v>
                </c:pt>
                <c:pt idx="2338">
                  <c:v>5.2425</c:v>
                </c:pt>
                <c:pt idx="2339">
                  <c:v>4.79118</c:v>
                </c:pt>
                <c:pt idx="2340">
                  <c:v>5.58773</c:v>
                </c:pt>
                <c:pt idx="2341">
                  <c:v>5.11652</c:v>
                </c:pt>
                <c:pt idx="2342">
                  <c:v>5.43098</c:v>
                </c:pt>
                <c:pt idx="2343">
                  <c:v>2.992059999999952</c:v>
                </c:pt>
                <c:pt idx="2344">
                  <c:v>2.98117</c:v>
                </c:pt>
                <c:pt idx="2345">
                  <c:v>3.58403</c:v>
                </c:pt>
                <c:pt idx="2346">
                  <c:v>2.17372</c:v>
                </c:pt>
                <c:pt idx="2347">
                  <c:v>4.41326</c:v>
                </c:pt>
                <c:pt idx="2348">
                  <c:v>2.445079999999999</c:v>
                </c:pt>
                <c:pt idx="2349">
                  <c:v>4.68036</c:v>
                </c:pt>
                <c:pt idx="2350">
                  <c:v>3.72894</c:v>
                </c:pt>
                <c:pt idx="2351">
                  <c:v>5.17998</c:v>
                </c:pt>
                <c:pt idx="2352">
                  <c:v>4.87121</c:v>
                </c:pt>
                <c:pt idx="2353">
                  <c:v>5.55837</c:v>
                </c:pt>
                <c:pt idx="2354">
                  <c:v>4.527869999999997</c:v>
                </c:pt>
                <c:pt idx="2355">
                  <c:v>4.825749999999997</c:v>
                </c:pt>
                <c:pt idx="2356">
                  <c:v>3.58403</c:v>
                </c:pt>
                <c:pt idx="2357">
                  <c:v>7.169949999999996</c:v>
                </c:pt>
                <c:pt idx="2358">
                  <c:v>2.0378</c:v>
                </c:pt>
                <c:pt idx="2359">
                  <c:v>3.12845</c:v>
                </c:pt>
                <c:pt idx="2360">
                  <c:v>6.361079999999998</c:v>
                </c:pt>
                <c:pt idx="2361">
                  <c:v>7.09608</c:v>
                </c:pt>
                <c:pt idx="2362">
                  <c:v>3.956729999999998</c:v>
                </c:pt>
                <c:pt idx="2363">
                  <c:v>2.63309</c:v>
                </c:pt>
                <c:pt idx="2364">
                  <c:v>2.304419999999999</c:v>
                </c:pt>
                <c:pt idx="2365">
                  <c:v>6.765519999999975</c:v>
                </c:pt>
                <c:pt idx="2366">
                  <c:v>3.21085</c:v>
                </c:pt>
                <c:pt idx="2367">
                  <c:v>4.71635</c:v>
                </c:pt>
                <c:pt idx="2368">
                  <c:v>4.00172</c:v>
                </c:pt>
                <c:pt idx="2369">
                  <c:v>2.01033</c:v>
                </c:pt>
                <c:pt idx="2370">
                  <c:v>4.928989999999994</c:v>
                </c:pt>
                <c:pt idx="2371">
                  <c:v>4.684149999999985</c:v>
                </c:pt>
                <c:pt idx="2372">
                  <c:v>2.478699999999999</c:v>
                </c:pt>
                <c:pt idx="2373">
                  <c:v>4.21957</c:v>
                </c:pt>
                <c:pt idx="2374">
                  <c:v>3.02852</c:v>
                </c:pt>
                <c:pt idx="2375">
                  <c:v>3.96194</c:v>
                </c:pt>
                <c:pt idx="2376">
                  <c:v>2.313419999999998</c:v>
                </c:pt>
                <c:pt idx="2377">
                  <c:v>4.917149999999999</c:v>
                </c:pt>
                <c:pt idx="2378">
                  <c:v>2.18366</c:v>
                </c:pt>
                <c:pt idx="2379">
                  <c:v>3.38134</c:v>
                </c:pt>
                <c:pt idx="2380">
                  <c:v>6.629129999999995</c:v>
                </c:pt>
                <c:pt idx="2381">
                  <c:v>2.90539</c:v>
                </c:pt>
                <c:pt idx="2382">
                  <c:v>3.52957</c:v>
                </c:pt>
                <c:pt idx="2383">
                  <c:v>6.78541</c:v>
                </c:pt>
                <c:pt idx="2384">
                  <c:v>5.08385</c:v>
                </c:pt>
                <c:pt idx="2385">
                  <c:v>6.174489999999984</c:v>
                </c:pt>
                <c:pt idx="2386">
                  <c:v>3.854439999999998</c:v>
                </c:pt>
                <c:pt idx="2387">
                  <c:v>4.697409999999976</c:v>
                </c:pt>
                <c:pt idx="2388">
                  <c:v>7.616539999999984</c:v>
                </c:pt>
                <c:pt idx="2389">
                  <c:v>4.862689999999985</c:v>
                </c:pt>
                <c:pt idx="2390">
                  <c:v>2.67997</c:v>
                </c:pt>
                <c:pt idx="2391">
                  <c:v>2.138669999999999</c:v>
                </c:pt>
                <c:pt idx="2392">
                  <c:v>6.842709999999998</c:v>
                </c:pt>
                <c:pt idx="2393">
                  <c:v>4.29913</c:v>
                </c:pt>
                <c:pt idx="2394">
                  <c:v>5.38504</c:v>
                </c:pt>
                <c:pt idx="2395">
                  <c:v>5.43714</c:v>
                </c:pt>
                <c:pt idx="2396">
                  <c:v>6.093989999999994</c:v>
                </c:pt>
                <c:pt idx="2397">
                  <c:v>8.44908</c:v>
                </c:pt>
                <c:pt idx="2398">
                  <c:v>5.89603</c:v>
                </c:pt>
                <c:pt idx="2399">
                  <c:v>4.614059999999966</c:v>
                </c:pt>
                <c:pt idx="2400">
                  <c:v>5.80037</c:v>
                </c:pt>
                <c:pt idx="2401">
                  <c:v>3.78151</c:v>
                </c:pt>
                <c:pt idx="2402">
                  <c:v>6.064149999999985</c:v>
                </c:pt>
                <c:pt idx="2403">
                  <c:v>8.98375</c:v>
                </c:pt>
                <c:pt idx="2404">
                  <c:v>5.95049</c:v>
                </c:pt>
                <c:pt idx="2405">
                  <c:v>7.96272</c:v>
                </c:pt>
                <c:pt idx="2406">
                  <c:v>5.21077</c:v>
                </c:pt>
                <c:pt idx="2407">
                  <c:v>3.02474</c:v>
                </c:pt>
                <c:pt idx="2408">
                  <c:v>3.19712</c:v>
                </c:pt>
                <c:pt idx="2409">
                  <c:v>4.94083</c:v>
                </c:pt>
                <c:pt idx="2410">
                  <c:v>5.715129999999998</c:v>
                </c:pt>
                <c:pt idx="2411">
                  <c:v>4.3517</c:v>
                </c:pt>
                <c:pt idx="2412">
                  <c:v>3.969549999999999</c:v>
                </c:pt>
                <c:pt idx="2413">
                  <c:v>1.19436</c:v>
                </c:pt>
                <c:pt idx="2414">
                  <c:v>1.96771</c:v>
                </c:pt>
                <c:pt idx="2415">
                  <c:v>2.00891</c:v>
                </c:pt>
                <c:pt idx="2416">
                  <c:v>2.22297</c:v>
                </c:pt>
                <c:pt idx="2417">
                  <c:v>2.08374</c:v>
                </c:pt>
                <c:pt idx="2418">
                  <c:v>2.02312</c:v>
                </c:pt>
                <c:pt idx="2419">
                  <c:v>2.959379999999999</c:v>
                </c:pt>
                <c:pt idx="2420">
                  <c:v>1.50503</c:v>
                </c:pt>
                <c:pt idx="2421">
                  <c:v>1.79107</c:v>
                </c:pt>
                <c:pt idx="2422">
                  <c:v>3.8767</c:v>
                </c:pt>
                <c:pt idx="2423">
                  <c:v>3.74078</c:v>
                </c:pt>
                <c:pt idx="2424">
                  <c:v>3.452849999999952</c:v>
                </c:pt>
                <c:pt idx="2425">
                  <c:v>6.44017</c:v>
                </c:pt>
                <c:pt idx="2426">
                  <c:v>3.5594</c:v>
                </c:pt>
                <c:pt idx="2427">
                  <c:v>3.16349</c:v>
                </c:pt>
                <c:pt idx="2428">
                  <c:v>5.837779999999999</c:v>
                </c:pt>
                <c:pt idx="2429">
                  <c:v>2.01696</c:v>
                </c:pt>
                <c:pt idx="2430">
                  <c:v>1.73187</c:v>
                </c:pt>
                <c:pt idx="2431">
                  <c:v>3.35103</c:v>
                </c:pt>
                <c:pt idx="2432">
                  <c:v>4.3086</c:v>
                </c:pt>
                <c:pt idx="2433">
                  <c:v>3.87433</c:v>
                </c:pt>
                <c:pt idx="2434">
                  <c:v>3.90369</c:v>
                </c:pt>
                <c:pt idx="2435">
                  <c:v>4.55534</c:v>
                </c:pt>
                <c:pt idx="2436">
                  <c:v>6.88865</c:v>
                </c:pt>
                <c:pt idx="2437">
                  <c:v>3.35908</c:v>
                </c:pt>
                <c:pt idx="2438">
                  <c:v>4.04008</c:v>
                </c:pt>
                <c:pt idx="2439">
                  <c:v>4.49424</c:v>
                </c:pt>
                <c:pt idx="2440">
                  <c:v>5.75727</c:v>
                </c:pt>
                <c:pt idx="2441">
                  <c:v>5.23539</c:v>
                </c:pt>
                <c:pt idx="2442">
                  <c:v>3.994619999999998</c:v>
                </c:pt>
                <c:pt idx="2443">
                  <c:v>2.64161</c:v>
                </c:pt>
                <c:pt idx="2444">
                  <c:v>4.91099</c:v>
                </c:pt>
                <c:pt idx="2445">
                  <c:v>3.12229</c:v>
                </c:pt>
                <c:pt idx="2446">
                  <c:v>3.302249999999952</c:v>
                </c:pt>
                <c:pt idx="2447">
                  <c:v>2.91439</c:v>
                </c:pt>
                <c:pt idx="2448">
                  <c:v>1.37811</c:v>
                </c:pt>
                <c:pt idx="2449">
                  <c:v>0.793715</c:v>
                </c:pt>
                <c:pt idx="2450">
                  <c:v>1.0987</c:v>
                </c:pt>
                <c:pt idx="2451">
                  <c:v>1.47424</c:v>
                </c:pt>
                <c:pt idx="2452">
                  <c:v>1.20336</c:v>
                </c:pt>
                <c:pt idx="2453">
                  <c:v>2.75859</c:v>
                </c:pt>
                <c:pt idx="2454">
                  <c:v>0.964202</c:v>
                </c:pt>
                <c:pt idx="2455">
                  <c:v>0.905005</c:v>
                </c:pt>
                <c:pt idx="2456">
                  <c:v>2.25801</c:v>
                </c:pt>
                <c:pt idx="2457">
                  <c:v>1.93314</c:v>
                </c:pt>
                <c:pt idx="2458">
                  <c:v>5.159149999999999</c:v>
                </c:pt>
                <c:pt idx="2459">
                  <c:v>4.823849999999997</c:v>
                </c:pt>
                <c:pt idx="2460">
                  <c:v>3.1777</c:v>
                </c:pt>
                <c:pt idx="2461">
                  <c:v>1.44772</c:v>
                </c:pt>
                <c:pt idx="2462">
                  <c:v>0.761512</c:v>
                </c:pt>
                <c:pt idx="2463">
                  <c:v>2.12494</c:v>
                </c:pt>
                <c:pt idx="2464">
                  <c:v>1.45009</c:v>
                </c:pt>
                <c:pt idx="2465">
                  <c:v>1.0234</c:v>
                </c:pt>
                <c:pt idx="2466">
                  <c:v>1.46904</c:v>
                </c:pt>
                <c:pt idx="2467">
                  <c:v>5.260489999999995</c:v>
                </c:pt>
                <c:pt idx="2468">
                  <c:v>1.96913</c:v>
                </c:pt>
                <c:pt idx="2469">
                  <c:v>1.9052</c:v>
                </c:pt>
                <c:pt idx="2470">
                  <c:v>2.42708</c:v>
                </c:pt>
                <c:pt idx="2471">
                  <c:v>4.23993</c:v>
                </c:pt>
                <c:pt idx="2472">
                  <c:v>2.340889999999999</c:v>
                </c:pt>
                <c:pt idx="2473">
                  <c:v>3.66691</c:v>
                </c:pt>
                <c:pt idx="2474">
                  <c:v>2.828669999999998</c:v>
                </c:pt>
                <c:pt idx="2475">
                  <c:v>2.50285</c:v>
                </c:pt>
                <c:pt idx="2476">
                  <c:v>2.20261</c:v>
                </c:pt>
                <c:pt idx="2477">
                  <c:v>3.59445</c:v>
                </c:pt>
                <c:pt idx="2478">
                  <c:v>3.00816</c:v>
                </c:pt>
                <c:pt idx="2479">
                  <c:v>4.71683</c:v>
                </c:pt>
                <c:pt idx="2480">
                  <c:v>2.7207</c:v>
                </c:pt>
                <c:pt idx="2481">
                  <c:v>4.317129999999985</c:v>
                </c:pt>
                <c:pt idx="2482">
                  <c:v>2.83483</c:v>
                </c:pt>
                <c:pt idx="2483">
                  <c:v>1.5145</c:v>
                </c:pt>
                <c:pt idx="2484">
                  <c:v>2.49622</c:v>
                </c:pt>
                <c:pt idx="2485">
                  <c:v>3.20801</c:v>
                </c:pt>
                <c:pt idx="2486">
                  <c:v>4.03582</c:v>
                </c:pt>
                <c:pt idx="2487">
                  <c:v>5.514329999999998</c:v>
                </c:pt>
                <c:pt idx="2488">
                  <c:v>3.1114</c:v>
                </c:pt>
                <c:pt idx="2489">
                  <c:v>9.848500000000001</c:v>
                </c:pt>
                <c:pt idx="2490">
                  <c:v>5.0758</c:v>
                </c:pt>
                <c:pt idx="2491">
                  <c:v>8.12468</c:v>
                </c:pt>
                <c:pt idx="2492">
                  <c:v>2.819199999999999</c:v>
                </c:pt>
                <c:pt idx="2493">
                  <c:v>4.41658</c:v>
                </c:pt>
                <c:pt idx="2494">
                  <c:v>2.19929</c:v>
                </c:pt>
                <c:pt idx="2495">
                  <c:v>3.89848</c:v>
                </c:pt>
                <c:pt idx="2496">
                  <c:v>2.05864</c:v>
                </c:pt>
                <c:pt idx="2497">
                  <c:v>2.46781</c:v>
                </c:pt>
                <c:pt idx="2498">
                  <c:v>2.379719999999998</c:v>
                </c:pt>
                <c:pt idx="2499">
                  <c:v>6.504099999999998</c:v>
                </c:pt>
                <c:pt idx="2500">
                  <c:v>3.41733</c:v>
                </c:pt>
                <c:pt idx="2501">
                  <c:v>4.35028</c:v>
                </c:pt>
                <c:pt idx="2502">
                  <c:v>4.23283</c:v>
                </c:pt>
                <c:pt idx="2503">
                  <c:v>3.333029999999999</c:v>
                </c:pt>
                <c:pt idx="2504">
                  <c:v>4.10828</c:v>
                </c:pt>
                <c:pt idx="2505">
                  <c:v>3.52104</c:v>
                </c:pt>
                <c:pt idx="2506">
                  <c:v>4.65526</c:v>
                </c:pt>
                <c:pt idx="2507">
                  <c:v>2.93996</c:v>
                </c:pt>
                <c:pt idx="2508">
                  <c:v>7.29687</c:v>
                </c:pt>
                <c:pt idx="2509">
                  <c:v>7.20074</c:v>
                </c:pt>
                <c:pt idx="2510">
                  <c:v>4.11065</c:v>
                </c:pt>
                <c:pt idx="2511">
                  <c:v>5.352839999999984</c:v>
                </c:pt>
                <c:pt idx="2512">
                  <c:v>4.685569999999997</c:v>
                </c:pt>
                <c:pt idx="2513">
                  <c:v>2.73349</c:v>
                </c:pt>
                <c:pt idx="2514">
                  <c:v>3.475109999999999</c:v>
                </c:pt>
                <c:pt idx="2515">
                  <c:v>2.20403</c:v>
                </c:pt>
                <c:pt idx="2516">
                  <c:v>3.4609</c:v>
                </c:pt>
                <c:pt idx="2517">
                  <c:v>3.65459</c:v>
                </c:pt>
                <c:pt idx="2518">
                  <c:v>4.08697</c:v>
                </c:pt>
                <c:pt idx="2519">
                  <c:v>4.1831</c:v>
                </c:pt>
                <c:pt idx="2520">
                  <c:v>6.57703</c:v>
                </c:pt>
                <c:pt idx="2521">
                  <c:v>2.15762</c:v>
                </c:pt>
                <c:pt idx="2522">
                  <c:v>4.86979</c:v>
                </c:pt>
                <c:pt idx="2523">
                  <c:v>3.76067</c:v>
                </c:pt>
                <c:pt idx="2524">
                  <c:v>3.471789999999999</c:v>
                </c:pt>
                <c:pt idx="2525">
                  <c:v>3.474159999999999</c:v>
                </c:pt>
                <c:pt idx="2526">
                  <c:v>4.91999</c:v>
                </c:pt>
                <c:pt idx="2527">
                  <c:v>4.897729999999997</c:v>
                </c:pt>
                <c:pt idx="2528">
                  <c:v>2.23718</c:v>
                </c:pt>
                <c:pt idx="2529">
                  <c:v>5.59436</c:v>
                </c:pt>
                <c:pt idx="2530">
                  <c:v>3.136499999999998</c:v>
                </c:pt>
                <c:pt idx="2531">
                  <c:v>4.805379999999999</c:v>
                </c:pt>
                <c:pt idx="2532">
                  <c:v>3.997459999999998</c:v>
                </c:pt>
                <c:pt idx="2533">
                  <c:v>4.72866</c:v>
                </c:pt>
                <c:pt idx="2534">
                  <c:v>5.612829999999985</c:v>
                </c:pt>
                <c:pt idx="2535">
                  <c:v>3.68348</c:v>
                </c:pt>
                <c:pt idx="2536">
                  <c:v>8.01576</c:v>
                </c:pt>
                <c:pt idx="2537">
                  <c:v>4.34649</c:v>
                </c:pt>
                <c:pt idx="2538">
                  <c:v>3.08109</c:v>
                </c:pt>
                <c:pt idx="2539">
                  <c:v>4.98866</c:v>
                </c:pt>
                <c:pt idx="2540">
                  <c:v>2.49717</c:v>
                </c:pt>
                <c:pt idx="2541">
                  <c:v>5.80179</c:v>
                </c:pt>
                <c:pt idx="2542">
                  <c:v>3.52862</c:v>
                </c:pt>
                <c:pt idx="2543">
                  <c:v>5.05022</c:v>
                </c:pt>
                <c:pt idx="2544">
                  <c:v>3.13034</c:v>
                </c:pt>
                <c:pt idx="2545">
                  <c:v>4.35833</c:v>
                </c:pt>
                <c:pt idx="2546">
                  <c:v>3.475109999999999</c:v>
                </c:pt>
                <c:pt idx="2547">
                  <c:v>6.73568</c:v>
                </c:pt>
                <c:pt idx="2548">
                  <c:v>3.43438</c:v>
                </c:pt>
                <c:pt idx="2549">
                  <c:v>4.99955</c:v>
                </c:pt>
                <c:pt idx="2550">
                  <c:v>5.98601</c:v>
                </c:pt>
                <c:pt idx="2551">
                  <c:v>7.3376</c:v>
                </c:pt>
                <c:pt idx="2552">
                  <c:v>4.73624</c:v>
                </c:pt>
                <c:pt idx="2553">
                  <c:v>3.54804</c:v>
                </c:pt>
                <c:pt idx="2554">
                  <c:v>2.07711</c:v>
                </c:pt>
                <c:pt idx="2555">
                  <c:v>2.49859</c:v>
                </c:pt>
                <c:pt idx="2556">
                  <c:v>2.69844</c:v>
                </c:pt>
                <c:pt idx="2557">
                  <c:v>4.13622</c:v>
                </c:pt>
                <c:pt idx="2558">
                  <c:v>5.49207</c:v>
                </c:pt>
                <c:pt idx="2559">
                  <c:v>6.04805</c:v>
                </c:pt>
                <c:pt idx="2560">
                  <c:v>6.44301</c:v>
                </c:pt>
                <c:pt idx="2561">
                  <c:v>3.59019</c:v>
                </c:pt>
                <c:pt idx="2562">
                  <c:v>4.884469999999998</c:v>
                </c:pt>
                <c:pt idx="2563">
                  <c:v>5.22261</c:v>
                </c:pt>
                <c:pt idx="2564">
                  <c:v>4.12627</c:v>
                </c:pt>
                <c:pt idx="2565">
                  <c:v>4.31523</c:v>
                </c:pt>
                <c:pt idx="2566">
                  <c:v>3.10477</c:v>
                </c:pt>
                <c:pt idx="2567">
                  <c:v>2.998209999999998</c:v>
                </c:pt>
                <c:pt idx="2568">
                  <c:v>4.667569999999975</c:v>
                </c:pt>
                <c:pt idx="2569">
                  <c:v>4.70688</c:v>
                </c:pt>
                <c:pt idx="2570">
                  <c:v>6.81666</c:v>
                </c:pt>
                <c:pt idx="2571">
                  <c:v>6.17118</c:v>
                </c:pt>
                <c:pt idx="2572">
                  <c:v>4.96119</c:v>
                </c:pt>
                <c:pt idx="2573">
                  <c:v>4.595589999999984</c:v>
                </c:pt>
                <c:pt idx="2574">
                  <c:v>3.7602</c:v>
                </c:pt>
                <c:pt idx="2575">
                  <c:v>5.609989999999994</c:v>
                </c:pt>
                <c:pt idx="2576">
                  <c:v>3.36713</c:v>
                </c:pt>
                <c:pt idx="2577">
                  <c:v>1.6273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6FF-4DF7-BC8A-A1B5D35075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7615304"/>
        <c:axId val="2123843720"/>
      </c:scatterChart>
      <c:valAx>
        <c:axId val="20876153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plicate-1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3843720"/>
        <c:crosses val="autoZero"/>
        <c:crossBetween val="midCat"/>
      </c:valAx>
      <c:valAx>
        <c:axId val="212384372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plicate-2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8761530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rgbClr val="3366FF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3366FF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3366FF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1"/>
            <c:plus>
              <c:numRef>
                <c:f>まとめ!$Z$14:$AE$14</c:f>
                <c:numCache>
                  <c:formatCode>General</c:formatCode>
                  <c:ptCount val="6"/>
                  <c:pt idx="0">
                    <c:v>0.454953356970252</c:v>
                  </c:pt>
                  <c:pt idx="1">
                    <c:v>0.697330254570124</c:v>
                  </c:pt>
                  <c:pt idx="2">
                    <c:v>0.377472217573571</c:v>
                  </c:pt>
                  <c:pt idx="3">
                    <c:v>0.141678812035132</c:v>
                  </c:pt>
                  <c:pt idx="4">
                    <c:v>0.594513952619989</c:v>
                  </c:pt>
                  <c:pt idx="5">
                    <c:v>0.11755010605535</c:v>
                  </c:pt>
                </c:numCache>
              </c:numRef>
            </c:plus>
            <c:minus>
              <c:numRef>
                <c:f>まとめ!$Z$14:$AE$14</c:f>
                <c:numCache>
                  <c:formatCode>General</c:formatCode>
                  <c:ptCount val="6"/>
                  <c:pt idx="0">
                    <c:v>0.454953356970252</c:v>
                  </c:pt>
                  <c:pt idx="1">
                    <c:v>0.697330254570124</c:v>
                  </c:pt>
                  <c:pt idx="2">
                    <c:v>0.377472217573571</c:v>
                  </c:pt>
                  <c:pt idx="3">
                    <c:v>0.141678812035132</c:v>
                  </c:pt>
                  <c:pt idx="4">
                    <c:v>0.594513952619989</c:v>
                  </c:pt>
                  <c:pt idx="5">
                    <c:v>0.11755010605535</c:v>
                  </c:pt>
                </c:numCache>
              </c:numRef>
            </c:minus>
          </c:errBars>
          <c:cat>
            <c:multiLvlStrRef>
              <c:f>まとめ!$Z$11:$AE$12</c:f>
              <c:multiLvlStrCache>
                <c:ptCount val="6"/>
                <c:lvl>
                  <c:pt idx="0">
                    <c:v>AG</c:v>
                  </c:pt>
                  <c:pt idx="1">
                    <c:v>FUS3</c:v>
                  </c:pt>
                  <c:pt idx="2">
                    <c:v>AGL19</c:v>
                  </c:pt>
                  <c:pt idx="3">
                    <c:v>AG</c:v>
                  </c:pt>
                  <c:pt idx="4">
                    <c:v>FUS3</c:v>
                  </c:pt>
                  <c:pt idx="5">
                    <c:v>AGL19</c:v>
                  </c:pt>
                </c:lvl>
                <c:lvl>
                  <c:pt idx="0">
                    <c:v>RJKB-T23 / 14d-C</c:v>
                  </c:pt>
                  <c:pt idx="3">
                    <c:v>RJKB-T24 / 14d-C</c:v>
                  </c:pt>
                </c:lvl>
              </c:multiLvlStrCache>
            </c:multiLvlStrRef>
          </c:cat>
          <c:val>
            <c:numRef>
              <c:f>まとめ!$Z$13:$AE$13</c:f>
              <c:numCache>
                <c:formatCode>General</c:formatCode>
                <c:ptCount val="6"/>
                <c:pt idx="0">
                  <c:v>14.63330515604583</c:v>
                </c:pt>
                <c:pt idx="1">
                  <c:v>22.4292144531532</c:v>
                </c:pt>
                <c:pt idx="2">
                  <c:v>12.14117021680658</c:v>
                </c:pt>
                <c:pt idx="3">
                  <c:v>14.50897804315715</c:v>
                </c:pt>
                <c:pt idx="4">
                  <c:v>22.93245491972022</c:v>
                </c:pt>
                <c:pt idx="5">
                  <c:v>12.03801671702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5502584"/>
        <c:axId val="2085516392"/>
      </c:barChart>
      <c:catAx>
        <c:axId val="2085502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85516392"/>
        <c:crosses val="autoZero"/>
        <c:auto val="1"/>
        <c:lblAlgn val="ctr"/>
        <c:lblOffset val="100"/>
        <c:noMultiLvlLbl val="0"/>
      </c:catAx>
      <c:valAx>
        <c:axId val="208551639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dirty="0" err="1"/>
                  <a:t>Enrichment</a:t>
                </a:r>
                <a:endParaRPr lang="de-DE" dirty="0"/>
              </a:p>
              <a:p>
                <a:pPr>
                  <a:defRPr/>
                </a:pPr>
                <a:r>
                  <a:rPr lang="de-DE" dirty="0"/>
                  <a:t> (</a:t>
                </a:r>
                <a:r>
                  <a:rPr lang="de-DE" dirty="0" smtClean="0"/>
                  <a:t>vs. </a:t>
                </a:r>
                <a:r>
                  <a:rPr lang="de-DE" dirty="0"/>
                  <a:t>Bra013206 &amp; Bra028913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855025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C$4</c:f>
              <c:strCache>
                <c:ptCount val="1"/>
                <c:pt idx="0">
                  <c:v>Upstream (2kb)</c:v>
                </c:pt>
              </c:strCache>
            </c:strRef>
          </c:tx>
          <c:spPr>
            <a:solidFill>
              <a:schemeClr val="accent5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1!$A$5:$B$16</c:f>
              <c:multiLvlStrCache>
                <c:ptCount val="12"/>
                <c:lvl>
                  <c:pt idx="0">
                    <c:v>RJKB-T23 rep1</c:v>
                  </c:pt>
                  <c:pt idx="1">
                    <c:v>RJKB-T23 rep2</c:v>
                  </c:pt>
                  <c:pt idx="2">
                    <c:v>RJKB-T24 rep1</c:v>
                  </c:pt>
                  <c:pt idx="3">
                    <c:v>RJKB-T24 rep2</c:v>
                  </c:pt>
                  <c:pt idx="4">
                    <c:v>RJKB-T23-NV (2 DAS)</c:v>
                  </c:pt>
                  <c:pt idx="5">
                    <c:v>RJKB-T23-NV (14 DAS) rep1</c:v>
                  </c:pt>
                  <c:pt idx="6">
                    <c:v>RJKB-T23-NV (14 DAS) rep2</c:v>
                  </c:pt>
                  <c:pt idx="7">
                    <c:v>RJKB-T24-NV (2 DAS)</c:v>
                  </c:pt>
                  <c:pt idx="8">
                    <c:v>RJKB-T24-NV (14 DAS) rep1</c:v>
                  </c:pt>
                  <c:pt idx="9">
                    <c:v>RJKB-T24-NV (14 DAS) rep2</c:v>
                  </c:pt>
                  <c:pt idx="10">
                    <c:v>RJKB-T24 4wkV</c:v>
                  </c:pt>
                  <c:pt idx="11">
                    <c:v>RJKB-T24 4wkV+12d</c:v>
                  </c:pt>
                </c:lvl>
                <c:lvl>
                  <c:pt idx="0">
                    <c:v>Input</c:v>
                  </c:pt>
                  <c:pt idx="4">
                    <c:v>H3K27me3</c:v>
                  </c:pt>
                </c:lvl>
              </c:multiLvlStrCache>
            </c:multiLvlStrRef>
          </c:cat>
          <c:val>
            <c:numRef>
              <c:f>Sheet1!$C$5:$C$16</c:f>
              <c:numCache>
                <c:formatCode>#,##0_);[Red]\(#,##0\)</c:formatCode>
                <c:ptCount val="12"/>
                <c:pt idx="0">
                  <c:v>3.104668E6</c:v>
                </c:pt>
                <c:pt idx="1">
                  <c:v>4.185124E6</c:v>
                </c:pt>
                <c:pt idx="2">
                  <c:v>2.549482E6</c:v>
                </c:pt>
                <c:pt idx="3">
                  <c:v>4.192231E6</c:v>
                </c:pt>
                <c:pt idx="4">
                  <c:v>8.124571E6</c:v>
                </c:pt>
                <c:pt idx="5">
                  <c:v>7.068465E6</c:v>
                </c:pt>
                <c:pt idx="6">
                  <c:v>7.06166E6</c:v>
                </c:pt>
                <c:pt idx="7">
                  <c:v>4.108931E6</c:v>
                </c:pt>
                <c:pt idx="8">
                  <c:v>4.920545E6</c:v>
                </c:pt>
                <c:pt idx="9">
                  <c:v>6.927559E6</c:v>
                </c:pt>
                <c:pt idx="10">
                  <c:v>5.723551E6</c:v>
                </c:pt>
                <c:pt idx="11">
                  <c:v>5.612568E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96E-4754-B62C-35A3E2915CA0}"/>
            </c:ext>
          </c:extLst>
        </c:ser>
        <c:ser>
          <c:idx val="1"/>
          <c:order val="1"/>
          <c:tx>
            <c:strRef>
              <c:f>Sheet1!$D$4</c:f>
              <c:strCache>
                <c:ptCount val="1"/>
                <c:pt idx="0">
                  <c:v>Exon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1!$A$5:$B$16</c:f>
              <c:multiLvlStrCache>
                <c:ptCount val="12"/>
                <c:lvl>
                  <c:pt idx="0">
                    <c:v>RJKB-T23 rep1</c:v>
                  </c:pt>
                  <c:pt idx="1">
                    <c:v>RJKB-T23 rep2</c:v>
                  </c:pt>
                  <c:pt idx="2">
                    <c:v>RJKB-T24 rep1</c:v>
                  </c:pt>
                  <c:pt idx="3">
                    <c:v>RJKB-T24 rep2</c:v>
                  </c:pt>
                  <c:pt idx="4">
                    <c:v>RJKB-T23-NV (2 DAS)</c:v>
                  </c:pt>
                  <c:pt idx="5">
                    <c:v>RJKB-T23-NV (14 DAS) rep1</c:v>
                  </c:pt>
                  <c:pt idx="6">
                    <c:v>RJKB-T23-NV (14 DAS) rep2</c:v>
                  </c:pt>
                  <c:pt idx="7">
                    <c:v>RJKB-T24-NV (2 DAS)</c:v>
                  </c:pt>
                  <c:pt idx="8">
                    <c:v>RJKB-T24-NV (14 DAS) rep1</c:v>
                  </c:pt>
                  <c:pt idx="9">
                    <c:v>RJKB-T24-NV (14 DAS) rep2</c:v>
                  </c:pt>
                  <c:pt idx="10">
                    <c:v>RJKB-T24 4wkV</c:v>
                  </c:pt>
                  <c:pt idx="11">
                    <c:v>RJKB-T24 4wkV+12d</c:v>
                  </c:pt>
                </c:lvl>
                <c:lvl>
                  <c:pt idx="0">
                    <c:v>Input</c:v>
                  </c:pt>
                  <c:pt idx="4">
                    <c:v>H3K27me3</c:v>
                  </c:pt>
                </c:lvl>
              </c:multiLvlStrCache>
            </c:multiLvlStrRef>
          </c:cat>
          <c:val>
            <c:numRef>
              <c:f>Sheet1!$D$5:$D$16</c:f>
              <c:numCache>
                <c:formatCode>#,##0_);[Red]\(#,##0\)</c:formatCode>
                <c:ptCount val="12"/>
                <c:pt idx="0">
                  <c:v>3.617693E6</c:v>
                </c:pt>
                <c:pt idx="1">
                  <c:v>4.588848E6</c:v>
                </c:pt>
                <c:pt idx="2">
                  <c:v>2.971301E6</c:v>
                </c:pt>
                <c:pt idx="3">
                  <c:v>4.433169E6</c:v>
                </c:pt>
                <c:pt idx="4">
                  <c:v>8.519668E6</c:v>
                </c:pt>
                <c:pt idx="5">
                  <c:v>7.574954E6</c:v>
                </c:pt>
                <c:pt idx="6">
                  <c:v>7.374104E6</c:v>
                </c:pt>
                <c:pt idx="7">
                  <c:v>4.643563E6</c:v>
                </c:pt>
                <c:pt idx="8">
                  <c:v>5.066318E6</c:v>
                </c:pt>
                <c:pt idx="9">
                  <c:v>6.762614E6</c:v>
                </c:pt>
                <c:pt idx="10">
                  <c:v>5.850405E6</c:v>
                </c:pt>
                <c:pt idx="11">
                  <c:v>6.032169E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96E-4754-B62C-35A3E2915CA0}"/>
            </c:ext>
          </c:extLst>
        </c:ser>
        <c:ser>
          <c:idx val="2"/>
          <c:order val="2"/>
          <c:tx>
            <c:strRef>
              <c:f>Sheet1!$E$4</c:f>
              <c:strCache>
                <c:ptCount val="1"/>
                <c:pt idx="0">
                  <c:v>Intro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1!$A$5:$B$16</c:f>
              <c:multiLvlStrCache>
                <c:ptCount val="12"/>
                <c:lvl>
                  <c:pt idx="0">
                    <c:v>RJKB-T23 rep1</c:v>
                  </c:pt>
                  <c:pt idx="1">
                    <c:v>RJKB-T23 rep2</c:v>
                  </c:pt>
                  <c:pt idx="2">
                    <c:v>RJKB-T24 rep1</c:v>
                  </c:pt>
                  <c:pt idx="3">
                    <c:v>RJKB-T24 rep2</c:v>
                  </c:pt>
                  <c:pt idx="4">
                    <c:v>RJKB-T23-NV (2 DAS)</c:v>
                  </c:pt>
                  <c:pt idx="5">
                    <c:v>RJKB-T23-NV (14 DAS) rep1</c:v>
                  </c:pt>
                  <c:pt idx="6">
                    <c:v>RJKB-T23-NV (14 DAS) rep2</c:v>
                  </c:pt>
                  <c:pt idx="7">
                    <c:v>RJKB-T24-NV (2 DAS)</c:v>
                  </c:pt>
                  <c:pt idx="8">
                    <c:v>RJKB-T24-NV (14 DAS) rep1</c:v>
                  </c:pt>
                  <c:pt idx="9">
                    <c:v>RJKB-T24-NV (14 DAS) rep2</c:v>
                  </c:pt>
                  <c:pt idx="10">
                    <c:v>RJKB-T24 4wkV</c:v>
                  </c:pt>
                  <c:pt idx="11">
                    <c:v>RJKB-T24 4wkV+12d</c:v>
                  </c:pt>
                </c:lvl>
                <c:lvl>
                  <c:pt idx="0">
                    <c:v>Input</c:v>
                  </c:pt>
                  <c:pt idx="4">
                    <c:v>H3K27me3</c:v>
                  </c:pt>
                </c:lvl>
              </c:multiLvlStrCache>
            </c:multiLvlStrRef>
          </c:cat>
          <c:val>
            <c:numRef>
              <c:f>Sheet1!$E$5:$E$16</c:f>
              <c:numCache>
                <c:formatCode>#,##0_);[Red]\(#,##0\)</c:formatCode>
                <c:ptCount val="12"/>
                <c:pt idx="0">
                  <c:v>1.815451E6</c:v>
                </c:pt>
                <c:pt idx="1">
                  <c:v>2.498728E6</c:v>
                </c:pt>
                <c:pt idx="2">
                  <c:v>1.474871E6</c:v>
                </c:pt>
                <c:pt idx="3">
                  <c:v>2.573304E6</c:v>
                </c:pt>
                <c:pt idx="4">
                  <c:v>4.072384E6</c:v>
                </c:pt>
                <c:pt idx="5">
                  <c:v>3.513082E6</c:v>
                </c:pt>
                <c:pt idx="6">
                  <c:v>3.877172E6</c:v>
                </c:pt>
                <c:pt idx="7">
                  <c:v>2.114726E6</c:v>
                </c:pt>
                <c:pt idx="8">
                  <c:v>2.432701E6</c:v>
                </c:pt>
                <c:pt idx="9">
                  <c:v>3.783487E6</c:v>
                </c:pt>
                <c:pt idx="10">
                  <c:v>3.003627E6</c:v>
                </c:pt>
                <c:pt idx="11">
                  <c:v>2.897528E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96E-4754-B62C-35A3E2915CA0}"/>
            </c:ext>
          </c:extLst>
        </c:ser>
        <c:ser>
          <c:idx val="3"/>
          <c:order val="3"/>
          <c:tx>
            <c:strRef>
              <c:f>Sheet1!$F$4</c:f>
              <c:strCache>
                <c:ptCount val="1"/>
                <c:pt idx="0">
                  <c:v>Downstream (2kb)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1!$A$5:$B$16</c:f>
              <c:multiLvlStrCache>
                <c:ptCount val="12"/>
                <c:lvl>
                  <c:pt idx="0">
                    <c:v>RJKB-T23 rep1</c:v>
                  </c:pt>
                  <c:pt idx="1">
                    <c:v>RJKB-T23 rep2</c:v>
                  </c:pt>
                  <c:pt idx="2">
                    <c:v>RJKB-T24 rep1</c:v>
                  </c:pt>
                  <c:pt idx="3">
                    <c:v>RJKB-T24 rep2</c:v>
                  </c:pt>
                  <c:pt idx="4">
                    <c:v>RJKB-T23-NV (2 DAS)</c:v>
                  </c:pt>
                  <c:pt idx="5">
                    <c:v>RJKB-T23-NV (14 DAS) rep1</c:v>
                  </c:pt>
                  <c:pt idx="6">
                    <c:v>RJKB-T23-NV (14 DAS) rep2</c:v>
                  </c:pt>
                  <c:pt idx="7">
                    <c:v>RJKB-T24-NV (2 DAS)</c:v>
                  </c:pt>
                  <c:pt idx="8">
                    <c:v>RJKB-T24-NV (14 DAS) rep1</c:v>
                  </c:pt>
                  <c:pt idx="9">
                    <c:v>RJKB-T24-NV (14 DAS) rep2</c:v>
                  </c:pt>
                  <c:pt idx="10">
                    <c:v>RJKB-T24 4wkV</c:v>
                  </c:pt>
                  <c:pt idx="11">
                    <c:v>RJKB-T24 4wkV+12d</c:v>
                  </c:pt>
                </c:lvl>
                <c:lvl>
                  <c:pt idx="0">
                    <c:v>Input</c:v>
                  </c:pt>
                  <c:pt idx="4">
                    <c:v>H3K27me3</c:v>
                  </c:pt>
                </c:lvl>
              </c:multiLvlStrCache>
            </c:multiLvlStrRef>
          </c:cat>
          <c:val>
            <c:numRef>
              <c:f>Sheet1!$F$5:$F$16</c:f>
              <c:numCache>
                <c:formatCode>#,##0_);[Red]\(#,##0\)</c:formatCode>
                <c:ptCount val="12"/>
                <c:pt idx="0">
                  <c:v>3.410205E6</c:v>
                </c:pt>
                <c:pt idx="1">
                  <c:v>4.71218E6</c:v>
                </c:pt>
                <c:pt idx="2">
                  <c:v>2.787697E6</c:v>
                </c:pt>
                <c:pt idx="3">
                  <c:v>4.778009E6</c:v>
                </c:pt>
                <c:pt idx="4">
                  <c:v>7.458267E6</c:v>
                </c:pt>
                <c:pt idx="5">
                  <c:v>6.722707E6</c:v>
                </c:pt>
                <c:pt idx="6">
                  <c:v>6.715249E6</c:v>
                </c:pt>
                <c:pt idx="7">
                  <c:v>3.82852E6</c:v>
                </c:pt>
                <c:pt idx="8">
                  <c:v>4.625054E6</c:v>
                </c:pt>
                <c:pt idx="9">
                  <c:v>6.474412E6</c:v>
                </c:pt>
                <c:pt idx="10">
                  <c:v>5.487379E6</c:v>
                </c:pt>
                <c:pt idx="11">
                  <c:v>5.320993E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96E-4754-B62C-35A3E2915C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84442760"/>
        <c:axId val="2084471592"/>
      </c:barChart>
      <c:catAx>
        <c:axId val="2084442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84471592"/>
        <c:crosses val="autoZero"/>
        <c:auto val="1"/>
        <c:lblAlgn val="ctr"/>
        <c:lblOffset val="100"/>
        <c:noMultiLvlLbl val="0"/>
      </c:catAx>
      <c:valAx>
        <c:axId val="2084471592"/>
        <c:scaling>
          <c:orientation val="minMax"/>
        </c:scaling>
        <c:delete val="0"/>
        <c:axPos val="l"/>
        <c:majorGridlines/>
        <c:numFmt formatCode="0%" sourceLinked="1"/>
        <c:majorTickMark val="out"/>
        <c:minorTickMark val="none"/>
        <c:tickLblPos val="nextTo"/>
        <c:crossAx val="208444276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0022952435212"/>
          <c:y val="0.194212311309088"/>
          <c:w val="0.185623240182307"/>
          <c:h val="0.18776530484018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 charset="0"/>
          <a:ea typeface="Arial" charset="0"/>
          <a:cs typeface="Arial" charset="0"/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[Br転写とK27me3.xlsx]まとめ2!$A$4</c:f>
              <c:strCache>
                <c:ptCount val="1"/>
                <c:pt idx="0">
                  <c:v>G0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[Br転写とK27me3.xlsx]まとめ2!$B$1:$M$3</c:f>
              <c:multiLvlStrCache>
                <c:ptCount val="12"/>
                <c:lvl>
                  <c:pt idx="0">
                    <c:v>K27me3</c:v>
                  </c:pt>
                  <c:pt idx="1">
                    <c:v>K27me3*</c:v>
                  </c:pt>
                  <c:pt idx="2">
                    <c:v>Total</c:v>
                  </c:pt>
                  <c:pt idx="3">
                    <c:v>K27me3</c:v>
                  </c:pt>
                  <c:pt idx="4">
                    <c:v>K27me3*</c:v>
                  </c:pt>
                  <c:pt idx="5">
                    <c:v>Total</c:v>
                  </c:pt>
                  <c:pt idx="6">
                    <c:v>K27me3</c:v>
                  </c:pt>
                  <c:pt idx="7">
                    <c:v>K27me3*</c:v>
                  </c:pt>
                  <c:pt idx="8">
                    <c:v>Total</c:v>
                  </c:pt>
                  <c:pt idx="9">
                    <c:v>K27me3</c:v>
                  </c:pt>
                  <c:pt idx="10">
                    <c:v>K27me3*</c:v>
                  </c:pt>
                  <c:pt idx="11">
                    <c:v>Total</c:v>
                  </c:pt>
                </c:lvl>
                <c:lvl>
                  <c:pt idx="0">
                    <c:v>RJKB-T23</c:v>
                  </c:pt>
                  <c:pt idx="3">
                    <c:v>RJKB-T24</c:v>
                  </c:pt>
                  <c:pt idx="6">
                    <c:v>RJKB-T23</c:v>
                  </c:pt>
                  <c:pt idx="9">
                    <c:v>RJKB-T24</c:v>
                  </c:pt>
                </c:lvl>
                <c:lvl>
                  <c:pt idx="0">
                    <c:v>2d-C</c:v>
                  </c:pt>
                  <c:pt idx="6">
                    <c:v>14d-L</c:v>
                  </c:pt>
                </c:lvl>
              </c:multiLvlStrCache>
            </c:multiLvlStrRef>
          </c:cat>
          <c:val>
            <c:numRef>
              <c:f>[Br転写とK27me3.xlsx]まとめ2!$B$4:$M$4</c:f>
              <c:numCache>
                <c:formatCode>0.00%</c:formatCode>
                <c:ptCount val="12"/>
                <c:pt idx="0">
                  <c:v>0.261840803053867</c:v>
                </c:pt>
                <c:pt idx="1">
                  <c:v>0.572149981062997</c:v>
                </c:pt>
                <c:pt idx="2">
                  <c:v>0.307662302835271</c:v>
                </c:pt>
                <c:pt idx="3">
                  <c:v>0.288886475921603</c:v>
                </c:pt>
                <c:pt idx="4">
                  <c:v>0.596263098093675</c:v>
                </c:pt>
                <c:pt idx="5">
                  <c:v>0.318169628708647</c:v>
                </c:pt>
                <c:pt idx="6">
                  <c:v>0.518446914773643</c:v>
                </c:pt>
                <c:pt idx="7">
                  <c:v>0.592854437571014</c:v>
                </c:pt>
                <c:pt idx="8">
                  <c:v>0.323825544259977</c:v>
                </c:pt>
                <c:pt idx="9">
                  <c:v>0.545173479903813</c:v>
                </c:pt>
                <c:pt idx="10">
                  <c:v>0.572528721121071</c:v>
                </c:pt>
                <c:pt idx="11">
                  <c:v>0.3176332918891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7CB-42CD-B10B-4B4D42B372DC}"/>
            </c:ext>
          </c:extLst>
        </c:ser>
        <c:ser>
          <c:idx val="1"/>
          <c:order val="1"/>
          <c:tx>
            <c:strRef>
              <c:f>[Br転写とK27me3.xlsx]まとめ2!$A$5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[Br転写とK27me3.xlsx]まとめ2!$B$1:$M$3</c:f>
              <c:multiLvlStrCache>
                <c:ptCount val="12"/>
                <c:lvl>
                  <c:pt idx="0">
                    <c:v>K27me3</c:v>
                  </c:pt>
                  <c:pt idx="1">
                    <c:v>K27me3*</c:v>
                  </c:pt>
                  <c:pt idx="2">
                    <c:v>Total</c:v>
                  </c:pt>
                  <c:pt idx="3">
                    <c:v>K27me3</c:v>
                  </c:pt>
                  <c:pt idx="4">
                    <c:v>K27me3*</c:v>
                  </c:pt>
                  <c:pt idx="5">
                    <c:v>Total</c:v>
                  </c:pt>
                  <c:pt idx="6">
                    <c:v>K27me3</c:v>
                  </c:pt>
                  <c:pt idx="7">
                    <c:v>K27me3*</c:v>
                  </c:pt>
                  <c:pt idx="8">
                    <c:v>Total</c:v>
                  </c:pt>
                  <c:pt idx="9">
                    <c:v>K27me3</c:v>
                  </c:pt>
                  <c:pt idx="10">
                    <c:v>K27me3*</c:v>
                  </c:pt>
                  <c:pt idx="11">
                    <c:v>Total</c:v>
                  </c:pt>
                </c:lvl>
                <c:lvl>
                  <c:pt idx="0">
                    <c:v>RJKB-T23</c:v>
                  </c:pt>
                  <c:pt idx="3">
                    <c:v>RJKB-T24</c:v>
                  </c:pt>
                  <c:pt idx="6">
                    <c:v>RJKB-T23</c:v>
                  </c:pt>
                  <c:pt idx="9">
                    <c:v>RJKB-T24</c:v>
                  </c:pt>
                </c:lvl>
                <c:lvl>
                  <c:pt idx="0">
                    <c:v>2d-C</c:v>
                  </c:pt>
                  <c:pt idx="6">
                    <c:v>14d-L</c:v>
                  </c:pt>
                </c:lvl>
              </c:multiLvlStrCache>
            </c:multiLvlStrRef>
          </c:cat>
          <c:val>
            <c:numRef>
              <c:f>[Br転写とK27me3.xlsx]まとめ2!$B$5:$M$5</c:f>
              <c:numCache>
                <c:formatCode>0.00%</c:formatCode>
                <c:ptCount val="12"/>
                <c:pt idx="0">
                  <c:v>0.0131014656675621</c:v>
                </c:pt>
                <c:pt idx="1">
                  <c:v>0.0279005176114127</c:v>
                </c:pt>
                <c:pt idx="2">
                  <c:v>0.0139447573075892</c:v>
                </c:pt>
                <c:pt idx="3">
                  <c:v>0.0129757315815191</c:v>
                </c:pt>
                <c:pt idx="4">
                  <c:v>0.0258805706350208</c:v>
                </c:pt>
                <c:pt idx="5">
                  <c:v>0.0135790731124601</c:v>
                </c:pt>
                <c:pt idx="6">
                  <c:v>0.0204607700982761</c:v>
                </c:pt>
                <c:pt idx="7">
                  <c:v>0.0218406766822371</c:v>
                </c:pt>
                <c:pt idx="8">
                  <c:v>0.0122138521173115</c:v>
                </c:pt>
                <c:pt idx="9">
                  <c:v>0.0249914118859498</c:v>
                </c:pt>
                <c:pt idx="10">
                  <c:v>0.023103143542482</c:v>
                </c:pt>
                <c:pt idx="11">
                  <c:v>0.01326214681001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7CB-42CD-B10B-4B4D42B372DC}"/>
            </c:ext>
          </c:extLst>
        </c:ser>
        <c:ser>
          <c:idx val="2"/>
          <c:order val="2"/>
          <c:tx>
            <c:strRef>
              <c:f>[Br転写とK27me3.xlsx]まとめ2!$A$6</c:f>
              <c:strCache>
                <c:ptCount val="1"/>
                <c:pt idx="0">
                  <c:v>G2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[Br転写とK27me3.xlsx]まとめ2!$B$1:$M$3</c:f>
              <c:multiLvlStrCache>
                <c:ptCount val="12"/>
                <c:lvl>
                  <c:pt idx="0">
                    <c:v>K27me3</c:v>
                  </c:pt>
                  <c:pt idx="1">
                    <c:v>K27me3*</c:v>
                  </c:pt>
                  <c:pt idx="2">
                    <c:v>Total</c:v>
                  </c:pt>
                  <c:pt idx="3">
                    <c:v>K27me3</c:v>
                  </c:pt>
                  <c:pt idx="4">
                    <c:v>K27me3*</c:v>
                  </c:pt>
                  <c:pt idx="5">
                    <c:v>Total</c:v>
                  </c:pt>
                  <c:pt idx="6">
                    <c:v>K27me3</c:v>
                  </c:pt>
                  <c:pt idx="7">
                    <c:v>K27me3*</c:v>
                  </c:pt>
                  <c:pt idx="8">
                    <c:v>Total</c:v>
                  </c:pt>
                  <c:pt idx="9">
                    <c:v>K27me3</c:v>
                  </c:pt>
                  <c:pt idx="10">
                    <c:v>K27me3*</c:v>
                  </c:pt>
                  <c:pt idx="11">
                    <c:v>Total</c:v>
                  </c:pt>
                </c:lvl>
                <c:lvl>
                  <c:pt idx="0">
                    <c:v>RJKB-T23</c:v>
                  </c:pt>
                  <c:pt idx="3">
                    <c:v>RJKB-T24</c:v>
                  </c:pt>
                  <c:pt idx="6">
                    <c:v>RJKB-T23</c:v>
                  </c:pt>
                  <c:pt idx="9">
                    <c:v>RJKB-T24</c:v>
                  </c:pt>
                </c:lvl>
                <c:lvl>
                  <c:pt idx="0">
                    <c:v>2d-C</c:v>
                  </c:pt>
                  <c:pt idx="6">
                    <c:v>14d-L</c:v>
                  </c:pt>
                </c:lvl>
              </c:multiLvlStrCache>
            </c:multiLvlStrRef>
          </c:cat>
          <c:val>
            <c:numRef>
              <c:f>[Br転写とK27me3.xlsx]まとめ2!$B$6:$M$6</c:f>
              <c:numCache>
                <c:formatCode>0.00%</c:formatCode>
                <c:ptCount val="12"/>
                <c:pt idx="0">
                  <c:v>0.0707856166643103</c:v>
                </c:pt>
                <c:pt idx="1">
                  <c:v>0.140765054917308</c:v>
                </c:pt>
                <c:pt idx="2">
                  <c:v>0.0876910699919549</c:v>
                </c:pt>
                <c:pt idx="3">
                  <c:v>0.0710679189966882</c:v>
                </c:pt>
                <c:pt idx="4">
                  <c:v>0.139628834743088</c:v>
                </c:pt>
                <c:pt idx="5">
                  <c:v>0.0891294278261293</c:v>
                </c:pt>
                <c:pt idx="6">
                  <c:v>0.117045271467698</c:v>
                </c:pt>
                <c:pt idx="7">
                  <c:v>0.119303118293145</c:v>
                </c:pt>
                <c:pt idx="8">
                  <c:v>0.0908847119627489</c:v>
                </c:pt>
                <c:pt idx="9">
                  <c:v>0.139213328753006</c:v>
                </c:pt>
                <c:pt idx="10">
                  <c:v>0.129402853175104</c:v>
                </c:pt>
                <c:pt idx="11">
                  <c:v>0.08773982788463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7CB-42CD-B10B-4B4D42B372DC}"/>
            </c:ext>
          </c:extLst>
        </c:ser>
        <c:ser>
          <c:idx val="3"/>
          <c:order val="3"/>
          <c:tx>
            <c:strRef>
              <c:f>[Br転写とK27me3.xlsx]まとめ2!$A$7</c:f>
              <c:strCache>
                <c:ptCount val="1"/>
                <c:pt idx="0">
                  <c:v>G3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[Br転写とK27me3.xlsx]まとめ2!$B$1:$M$3</c:f>
              <c:multiLvlStrCache>
                <c:ptCount val="12"/>
                <c:lvl>
                  <c:pt idx="0">
                    <c:v>K27me3</c:v>
                  </c:pt>
                  <c:pt idx="1">
                    <c:v>K27me3*</c:v>
                  </c:pt>
                  <c:pt idx="2">
                    <c:v>Total</c:v>
                  </c:pt>
                  <c:pt idx="3">
                    <c:v>K27me3</c:v>
                  </c:pt>
                  <c:pt idx="4">
                    <c:v>K27me3*</c:v>
                  </c:pt>
                  <c:pt idx="5">
                    <c:v>Total</c:v>
                  </c:pt>
                  <c:pt idx="6">
                    <c:v>K27me3</c:v>
                  </c:pt>
                  <c:pt idx="7">
                    <c:v>K27me3*</c:v>
                  </c:pt>
                  <c:pt idx="8">
                    <c:v>Total</c:v>
                  </c:pt>
                  <c:pt idx="9">
                    <c:v>K27me3</c:v>
                  </c:pt>
                  <c:pt idx="10">
                    <c:v>K27me3*</c:v>
                  </c:pt>
                  <c:pt idx="11">
                    <c:v>Total</c:v>
                  </c:pt>
                </c:lvl>
                <c:lvl>
                  <c:pt idx="0">
                    <c:v>RJKB-T23</c:v>
                  </c:pt>
                  <c:pt idx="3">
                    <c:v>RJKB-T24</c:v>
                  </c:pt>
                  <c:pt idx="6">
                    <c:v>RJKB-T23</c:v>
                  </c:pt>
                  <c:pt idx="9">
                    <c:v>RJKB-T24</c:v>
                  </c:pt>
                </c:lvl>
                <c:lvl>
                  <c:pt idx="0">
                    <c:v>2d-C</c:v>
                  </c:pt>
                  <c:pt idx="6">
                    <c:v>14d-L</c:v>
                  </c:pt>
                </c:lvl>
              </c:multiLvlStrCache>
            </c:multiLvlStrRef>
          </c:cat>
          <c:val>
            <c:numRef>
              <c:f>[Br転写とK27me3.xlsx]まとめ2!$B$7:$M$7</c:f>
              <c:numCache>
                <c:formatCode>0.00%</c:formatCode>
                <c:ptCount val="12"/>
                <c:pt idx="0">
                  <c:v>0.167114378622932</c:v>
                </c:pt>
                <c:pt idx="1">
                  <c:v>0.151622269915415</c:v>
                </c:pt>
                <c:pt idx="2">
                  <c:v>0.206270264999147</c:v>
                </c:pt>
                <c:pt idx="3">
                  <c:v>0.142841630924589</c:v>
                </c:pt>
                <c:pt idx="4">
                  <c:v>0.141143794975382</c:v>
                </c:pt>
                <c:pt idx="5">
                  <c:v>0.198834686364855</c:v>
                </c:pt>
                <c:pt idx="6">
                  <c:v>0.159739004349927</c:v>
                </c:pt>
                <c:pt idx="7">
                  <c:v>0.152253503345537</c:v>
                </c:pt>
                <c:pt idx="8">
                  <c:v>0.217289548745703</c:v>
                </c:pt>
                <c:pt idx="9">
                  <c:v>0.171934043284095</c:v>
                </c:pt>
                <c:pt idx="10">
                  <c:v>0.15768211084459</c:v>
                </c:pt>
                <c:pt idx="11">
                  <c:v>0.2153148540920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7CB-42CD-B10B-4B4D42B372DC}"/>
            </c:ext>
          </c:extLst>
        </c:ser>
        <c:ser>
          <c:idx val="4"/>
          <c:order val="4"/>
          <c:tx>
            <c:strRef>
              <c:f>[Br転写とK27me3.xlsx]まとめ2!$A$8</c:f>
              <c:strCache>
                <c:ptCount val="1"/>
                <c:pt idx="0">
                  <c:v>G4</c:v>
                </c:pt>
              </c:strCache>
            </c:strRef>
          </c:tx>
          <c:spPr>
            <a:solidFill>
              <a:schemeClr val="accent5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[Br転写とK27me3.xlsx]まとめ2!$B$1:$M$3</c:f>
              <c:multiLvlStrCache>
                <c:ptCount val="12"/>
                <c:lvl>
                  <c:pt idx="0">
                    <c:v>K27me3</c:v>
                  </c:pt>
                  <c:pt idx="1">
                    <c:v>K27me3*</c:v>
                  </c:pt>
                  <c:pt idx="2">
                    <c:v>Total</c:v>
                  </c:pt>
                  <c:pt idx="3">
                    <c:v>K27me3</c:v>
                  </c:pt>
                  <c:pt idx="4">
                    <c:v>K27me3*</c:v>
                  </c:pt>
                  <c:pt idx="5">
                    <c:v>Total</c:v>
                  </c:pt>
                  <c:pt idx="6">
                    <c:v>K27me3</c:v>
                  </c:pt>
                  <c:pt idx="7">
                    <c:v>K27me3*</c:v>
                  </c:pt>
                  <c:pt idx="8">
                    <c:v>Total</c:v>
                  </c:pt>
                  <c:pt idx="9">
                    <c:v>K27me3</c:v>
                  </c:pt>
                  <c:pt idx="10">
                    <c:v>K27me3*</c:v>
                  </c:pt>
                  <c:pt idx="11">
                    <c:v>Total</c:v>
                  </c:pt>
                </c:lvl>
                <c:lvl>
                  <c:pt idx="0">
                    <c:v>RJKB-T23</c:v>
                  </c:pt>
                  <c:pt idx="3">
                    <c:v>RJKB-T24</c:v>
                  </c:pt>
                  <c:pt idx="6">
                    <c:v>RJKB-T23</c:v>
                  </c:pt>
                  <c:pt idx="9">
                    <c:v>RJKB-T24</c:v>
                  </c:pt>
                </c:lvl>
                <c:lvl>
                  <c:pt idx="0">
                    <c:v>2d-C</c:v>
                  </c:pt>
                  <c:pt idx="6">
                    <c:v>14d-L</c:v>
                  </c:pt>
                </c:lvl>
              </c:multiLvlStrCache>
            </c:multiLvlStrRef>
          </c:cat>
          <c:val>
            <c:numRef>
              <c:f>[Br転写とK27me3.xlsx]まとめ2!$B$8:$M$8</c:f>
              <c:numCache>
                <c:formatCode>0.00%</c:formatCode>
                <c:ptCount val="12"/>
                <c:pt idx="0">
                  <c:v>0.393750883642019</c:v>
                </c:pt>
                <c:pt idx="1">
                  <c:v>0.093170054286075</c:v>
                </c:pt>
                <c:pt idx="2">
                  <c:v>0.320412491772106</c:v>
                </c:pt>
                <c:pt idx="3">
                  <c:v>0.390792116835876</c:v>
                </c:pt>
                <c:pt idx="4">
                  <c:v>0.0835753061482136</c:v>
                </c:pt>
                <c:pt idx="5">
                  <c:v>0.320924449645286</c:v>
                </c:pt>
                <c:pt idx="6">
                  <c:v>0.157564040599323</c:v>
                </c:pt>
                <c:pt idx="7">
                  <c:v>0.100113622017422</c:v>
                </c:pt>
                <c:pt idx="8">
                  <c:v>0.309490723810917</c:v>
                </c:pt>
                <c:pt idx="9">
                  <c:v>0.104860872552387</c:v>
                </c:pt>
                <c:pt idx="10">
                  <c:v>0.103774775912132</c:v>
                </c:pt>
                <c:pt idx="11">
                  <c:v>0.318705965528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77CB-42CD-B10B-4B4D42B372DC}"/>
            </c:ext>
          </c:extLst>
        </c:ser>
        <c:ser>
          <c:idx val="5"/>
          <c:order val="5"/>
          <c:tx>
            <c:strRef>
              <c:f>[Br転写とK27me3.xlsx]まとめ2!$A$9</c:f>
              <c:strCache>
                <c:ptCount val="1"/>
                <c:pt idx="0">
                  <c:v>G5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7-77CB-42CD-B10B-4B4D42B372DC}"/>
              </c:ext>
            </c:extLst>
          </c:dPt>
          <c:cat>
            <c:multiLvlStrRef>
              <c:f>[Br転写とK27me3.xlsx]まとめ2!$B$1:$M$3</c:f>
              <c:multiLvlStrCache>
                <c:ptCount val="12"/>
                <c:lvl>
                  <c:pt idx="0">
                    <c:v>K27me3</c:v>
                  </c:pt>
                  <c:pt idx="1">
                    <c:v>K27me3*</c:v>
                  </c:pt>
                  <c:pt idx="2">
                    <c:v>Total</c:v>
                  </c:pt>
                  <c:pt idx="3">
                    <c:v>K27me3</c:v>
                  </c:pt>
                  <c:pt idx="4">
                    <c:v>K27me3*</c:v>
                  </c:pt>
                  <c:pt idx="5">
                    <c:v>Total</c:v>
                  </c:pt>
                  <c:pt idx="6">
                    <c:v>K27me3</c:v>
                  </c:pt>
                  <c:pt idx="7">
                    <c:v>K27me3*</c:v>
                  </c:pt>
                  <c:pt idx="8">
                    <c:v>Total</c:v>
                  </c:pt>
                  <c:pt idx="9">
                    <c:v>K27me3</c:v>
                  </c:pt>
                  <c:pt idx="10">
                    <c:v>K27me3*</c:v>
                  </c:pt>
                  <c:pt idx="11">
                    <c:v>Total</c:v>
                  </c:pt>
                </c:lvl>
                <c:lvl>
                  <c:pt idx="0">
                    <c:v>RJKB-T23</c:v>
                  </c:pt>
                  <c:pt idx="3">
                    <c:v>RJKB-T24</c:v>
                  </c:pt>
                  <c:pt idx="6">
                    <c:v>RJKB-T23</c:v>
                  </c:pt>
                  <c:pt idx="9">
                    <c:v>RJKB-T24</c:v>
                  </c:pt>
                </c:lvl>
                <c:lvl>
                  <c:pt idx="0">
                    <c:v>2d-C</c:v>
                  </c:pt>
                  <c:pt idx="6">
                    <c:v>14d-L</c:v>
                  </c:pt>
                </c:lvl>
              </c:multiLvlStrCache>
            </c:multiLvlStrRef>
          </c:cat>
          <c:val>
            <c:numRef>
              <c:f>[Br転写とK27me3.xlsx]まとめ2!$B$9:$M$9</c:f>
              <c:numCache>
                <c:formatCode>0.00%</c:formatCode>
                <c:ptCount val="12"/>
                <c:pt idx="0">
                  <c:v>0.0905791978886846</c:v>
                </c:pt>
                <c:pt idx="1">
                  <c:v>0.0137608887766696</c:v>
                </c:pt>
                <c:pt idx="2">
                  <c:v>0.062458860528048</c:v>
                </c:pt>
                <c:pt idx="3">
                  <c:v>0.0908301210706336</c:v>
                </c:pt>
                <c:pt idx="4">
                  <c:v>0.0126246686024492</c:v>
                </c:pt>
                <c:pt idx="5">
                  <c:v>0.0578024817767376</c:v>
                </c:pt>
                <c:pt idx="6">
                  <c:v>0.0253745770903818</c:v>
                </c:pt>
                <c:pt idx="7">
                  <c:v>0.0128771619744982</c:v>
                </c:pt>
                <c:pt idx="8">
                  <c:v>0.0442234086642775</c:v>
                </c:pt>
                <c:pt idx="9">
                  <c:v>0.0127962899347303</c:v>
                </c:pt>
                <c:pt idx="10">
                  <c:v>0.0124984219164247</c:v>
                </c:pt>
                <c:pt idx="11">
                  <c:v>0.0456130086057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77CB-42CD-B10B-4B4D42B372DC}"/>
            </c:ext>
          </c:extLst>
        </c:ser>
        <c:ser>
          <c:idx val="6"/>
          <c:order val="6"/>
          <c:tx>
            <c:strRef>
              <c:f>[Br転写とK27me3.xlsx]まとめ2!$A$10</c:f>
              <c:strCache>
                <c:ptCount val="1"/>
                <c:pt idx="0">
                  <c:v>G6</c:v>
                </c:pt>
              </c:strCache>
            </c:strRef>
          </c:tx>
          <c:spPr>
            <a:solidFill>
              <a:schemeClr val="tx2"/>
            </a:solidFill>
            <a:ln>
              <a:solidFill>
                <a:schemeClr val="tx1"/>
              </a:solidFill>
            </a:ln>
          </c:spPr>
          <c:invertIfNegative val="0"/>
          <c:cat>
            <c:multiLvlStrRef>
              <c:f>[Br転写とK27me3.xlsx]まとめ2!$B$1:$M$3</c:f>
              <c:multiLvlStrCache>
                <c:ptCount val="12"/>
                <c:lvl>
                  <c:pt idx="0">
                    <c:v>K27me3</c:v>
                  </c:pt>
                  <c:pt idx="1">
                    <c:v>K27me3*</c:v>
                  </c:pt>
                  <c:pt idx="2">
                    <c:v>Total</c:v>
                  </c:pt>
                  <c:pt idx="3">
                    <c:v>K27me3</c:v>
                  </c:pt>
                  <c:pt idx="4">
                    <c:v>K27me3*</c:v>
                  </c:pt>
                  <c:pt idx="5">
                    <c:v>Total</c:v>
                  </c:pt>
                  <c:pt idx="6">
                    <c:v>K27me3</c:v>
                  </c:pt>
                  <c:pt idx="7">
                    <c:v>K27me3*</c:v>
                  </c:pt>
                  <c:pt idx="8">
                    <c:v>Total</c:v>
                  </c:pt>
                  <c:pt idx="9">
                    <c:v>K27me3</c:v>
                  </c:pt>
                  <c:pt idx="10">
                    <c:v>K27me3*</c:v>
                  </c:pt>
                  <c:pt idx="11">
                    <c:v>Total</c:v>
                  </c:pt>
                </c:lvl>
                <c:lvl>
                  <c:pt idx="0">
                    <c:v>RJKB-T23</c:v>
                  </c:pt>
                  <c:pt idx="3">
                    <c:v>RJKB-T24</c:v>
                  </c:pt>
                  <c:pt idx="6">
                    <c:v>RJKB-T23</c:v>
                  </c:pt>
                  <c:pt idx="9">
                    <c:v>RJKB-T24</c:v>
                  </c:pt>
                </c:lvl>
                <c:lvl>
                  <c:pt idx="0">
                    <c:v>2d-C</c:v>
                  </c:pt>
                  <c:pt idx="6">
                    <c:v>14d-L</c:v>
                  </c:pt>
                </c:lvl>
              </c:multiLvlStrCache>
            </c:multiLvlStrRef>
          </c:cat>
          <c:val>
            <c:numRef>
              <c:f>[Br転写とK27me3.xlsx]まとめ2!$B$10:$M$10</c:f>
              <c:numCache>
                <c:formatCode>0.00%</c:formatCode>
                <c:ptCount val="12"/>
                <c:pt idx="0">
                  <c:v>0.00282765446062491</c:v>
                </c:pt>
                <c:pt idx="1">
                  <c:v>0.000631233430122459</c:v>
                </c:pt>
                <c:pt idx="2">
                  <c:v>0.00180404202930349</c:v>
                </c:pt>
                <c:pt idx="3">
                  <c:v>0.0026060046690917</c:v>
                </c:pt>
                <c:pt idx="4">
                  <c:v>0.000883726802171443</c:v>
                </c:pt>
                <c:pt idx="5">
                  <c:v>0.00180404202930349</c:v>
                </c:pt>
                <c:pt idx="6">
                  <c:v>0.00136942162075076</c:v>
                </c:pt>
                <c:pt idx="7">
                  <c:v>0.000757480116146951</c:v>
                </c:pt>
                <c:pt idx="8">
                  <c:v>0.00231599990248421</c:v>
                </c:pt>
                <c:pt idx="9">
                  <c:v>0.00103057368601855</c:v>
                </c:pt>
                <c:pt idx="10">
                  <c:v>0.00100997348819593</c:v>
                </c:pt>
                <c:pt idx="11">
                  <c:v>0.001974694653697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77CB-42CD-B10B-4B4D42B372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23687976"/>
        <c:axId val="2123690920"/>
      </c:barChart>
      <c:catAx>
        <c:axId val="2123687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3690920"/>
        <c:crosses val="autoZero"/>
        <c:auto val="1"/>
        <c:lblAlgn val="ctr"/>
        <c:lblOffset val="100"/>
        <c:noMultiLvlLbl val="0"/>
      </c:catAx>
      <c:valAx>
        <c:axId val="2123690920"/>
        <c:scaling>
          <c:orientation val="minMax"/>
        </c:scaling>
        <c:delete val="0"/>
        <c:axPos val="l"/>
        <c:majorGridlines/>
        <c:numFmt formatCode="0%" sourceLinked="1"/>
        <c:majorTickMark val="out"/>
        <c:minorTickMark val="none"/>
        <c:tickLblPos val="nextTo"/>
        <c:crossAx val="212368797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effectLst/>
  </c:spPr>
  <c:txPr>
    <a:bodyPr/>
    <a:lstStyle/>
    <a:p>
      <a:pPr>
        <a:defRPr sz="14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753-438F-9862-AFF737338EAA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753-438F-9862-AFF737338EAA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A753-438F-9862-AFF737338EAA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A753-438F-9862-AFF737338EAA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A753-438F-9862-AFF737338EAA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A753-438F-9862-AFF737338EAA}"/>
              </c:ext>
            </c:extLst>
          </c:dPt>
          <c:errBars>
            <c:errBarType val="both"/>
            <c:errValType val="cust"/>
            <c:noEndCap val="0"/>
            <c:plus>
              <c:numRef>
                <c:f>figure!$B$14:$S$14</c:f>
                <c:numCache>
                  <c:formatCode>General</c:formatCode>
                  <c:ptCount val="18"/>
                  <c:pt idx="0">
                    <c:v>2.574273155340586</c:v>
                  </c:pt>
                  <c:pt idx="1">
                    <c:v>1.945968072009967</c:v>
                  </c:pt>
                  <c:pt idx="2">
                    <c:v>4.070431824496485</c:v>
                  </c:pt>
                  <c:pt idx="3">
                    <c:v>1.197929502757296</c:v>
                  </c:pt>
                  <c:pt idx="4">
                    <c:v>2.093823960581705</c:v>
                  </c:pt>
                  <c:pt idx="5">
                    <c:v>0.715262528096668</c:v>
                  </c:pt>
                  <c:pt idx="6">
                    <c:v>3.280535320230814</c:v>
                  </c:pt>
                  <c:pt idx="7">
                    <c:v>1.109785865311142</c:v>
                  </c:pt>
                  <c:pt idx="8">
                    <c:v>2.805505702782097</c:v>
                  </c:pt>
                  <c:pt idx="9">
                    <c:v>3.162792257983432</c:v>
                  </c:pt>
                  <c:pt idx="10">
                    <c:v>2.748586965606337</c:v>
                  </c:pt>
                  <c:pt idx="11">
                    <c:v>5.057514215764384</c:v>
                  </c:pt>
                  <c:pt idx="12">
                    <c:v>0.939055000046217</c:v>
                  </c:pt>
                  <c:pt idx="13">
                    <c:v>2.255675467759537</c:v>
                  </c:pt>
                  <c:pt idx="14">
                    <c:v>0.838569001137924</c:v>
                  </c:pt>
                  <c:pt idx="15">
                    <c:v>3.532300315379388</c:v>
                  </c:pt>
                  <c:pt idx="16">
                    <c:v>1.206399293014216</c:v>
                  </c:pt>
                  <c:pt idx="17">
                    <c:v>3.11221829828666</c:v>
                  </c:pt>
                </c:numCache>
              </c:numRef>
            </c:plus>
            <c:minus>
              <c:numRef>
                <c:f>figure!$B$14:$S$14</c:f>
                <c:numCache>
                  <c:formatCode>General</c:formatCode>
                  <c:ptCount val="18"/>
                  <c:pt idx="0">
                    <c:v>2.574273155340586</c:v>
                  </c:pt>
                  <c:pt idx="1">
                    <c:v>1.945968072009967</c:v>
                  </c:pt>
                  <c:pt idx="2">
                    <c:v>4.070431824496485</c:v>
                  </c:pt>
                  <c:pt idx="3">
                    <c:v>1.197929502757296</c:v>
                  </c:pt>
                  <c:pt idx="4">
                    <c:v>2.093823960581705</c:v>
                  </c:pt>
                  <c:pt idx="5">
                    <c:v>0.715262528096668</c:v>
                  </c:pt>
                  <c:pt idx="6">
                    <c:v>3.280535320230814</c:v>
                  </c:pt>
                  <c:pt idx="7">
                    <c:v>1.109785865311142</c:v>
                  </c:pt>
                  <c:pt idx="8">
                    <c:v>2.805505702782097</c:v>
                  </c:pt>
                  <c:pt idx="9">
                    <c:v>3.162792257983432</c:v>
                  </c:pt>
                  <c:pt idx="10">
                    <c:v>2.748586965606337</c:v>
                  </c:pt>
                  <c:pt idx="11">
                    <c:v>5.057514215764384</c:v>
                  </c:pt>
                  <c:pt idx="12">
                    <c:v>0.939055000046217</c:v>
                  </c:pt>
                  <c:pt idx="13">
                    <c:v>2.255675467759537</c:v>
                  </c:pt>
                  <c:pt idx="14">
                    <c:v>0.838569001137924</c:v>
                  </c:pt>
                  <c:pt idx="15">
                    <c:v>3.532300315379388</c:v>
                  </c:pt>
                  <c:pt idx="16">
                    <c:v>1.206399293014216</c:v>
                  </c:pt>
                  <c:pt idx="17">
                    <c:v>3.112218298286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B$9:$S$12</c:f>
              <c:multiLvlStrCache>
                <c:ptCount val="18"/>
                <c:lvl>
                  <c:pt idx="0">
                    <c:v>+</c:v>
                  </c:pt>
                  <c:pt idx="1">
                    <c:v>+</c:v>
                  </c:pt>
                  <c:pt idx="2">
                    <c:v>-</c:v>
                  </c:pt>
                  <c:pt idx="3">
                    <c:v>+</c:v>
                  </c:pt>
                  <c:pt idx="4">
                    <c:v>-</c:v>
                  </c:pt>
                  <c:pt idx="5">
                    <c:v>+</c:v>
                  </c:pt>
                  <c:pt idx="6">
                    <c:v>-</c:v>
                  </c:pt>
                  <c:pt idx="7">
                    <c:v>+</c:v>
                  </c:pt>
                  <c:pt idx="8">
                    <c:v>+</c:v>
                  </c:pt>
                  <c:pt idx="9">
                    <c:v>+</c:v>
                  </c:pt>
                  <c:pt idx="10">
                    <c:v>+</c:v>
                  </c:pt>
                  <c:pt idx="11">
                    <c:v>-</c:v>
                  </c:pt>
                  <c:pt idx="12">
                    <c:v>+</c:v>
                  </c:pt>
                  <c:pt idx="13">
                    <c:v>-</c:v>
                  </c:pt>
                  <c:pt idx="14">
                    <c:v>+</c:v>
                  </c:pt>
                  <c:pt idx="15">
                    <c:v>-</c:v>
                  </c:pt>
                  <c:pt idx="16">
                    <c:v>+</c:v>
                  </c:pt>
                  <c:pt idx="17">
                    <c:v>+</c:v>
                  </c:pt>
                </c:lvl>
                <c:lvl>
                  <c:pt idx="0">
                    <c:v>LF</c:v>
                  </c:pt>
                  <c:pt idx="1">
                    <c:v>MF1</c:v>
                  </c:pt>
                  <c:pt idx="2">
                    <c:v>MF2</c:v>
                  </c:pt>
                  <c:pt idx="3">
                    <c:v>LF</c:v>
                  </c:pt>
                  <c:pt idx="4">
                    <c:v>MF1</c:v>
                  </c:pt>
                  <c:pt idx="5">
                    <c:v>MF2</c:v>
                  </c:pt>
                  <c:pt idx="6">
                    <c:v>LF</c:v>
                  </c:pt>
                  <c:pt idx="7">
                    <c:v>MF1</c:v>
                  </c:pt>
                  <c:pt idx="8">
                    <c:v>MF2</c:v>
                  </c:pt>
                  <c:pt idx="9">
                    <c:v>LF</c:v>
                  </c:pt>
                  <c:pt idx="10">
                    <c:v>MF1</c:v>
                  </c:pt>
                  <c:pt idx="11">
                    <c:v>MF2</c:v>
                  </c:pt>
                  <c:pt idx="12">
                    <c:v>LF</c:v>
                  </c:pt>
                  <c:pt idx="13">
                    <c:v>MF1</c:v>
                  </c:pt>
                  <c:pt idx="14">
                    <c:v>MF2</c:v>
                  </c:pt>
                  <c:pt idx="15">
                    <c:v>LF</c:v>
                  </c:pt>
                  <c:pt idx="16">
                    <c:v>MF1</c:v>
                  </c:pt>
                  <c:pt idx="17">
                    <c:v>MF2</c:v>
                  </c:pt>
                </c:lvl>
                <c:lvl>
                  <c:pt idx="0">
                    <c:v>RJKB-T23</c:v>
                  </c:pt>
                  <c:pt idx="9">
                    <c:v>RJKB-T24</c:v>
                  </c:pt>
                </c:lvl>
                <c:lvl>
                  <c:pt idx="0">
                    <c:v>2 of 3 genes</c:v>
                  </c:pt>
                </c:lvl>
              </c:multiLvlStrCache>
            </c:multiLvlStrRef>
          </c:cat>
          <c:val>
            <c:numRef>
              <c:f>figure!$B$13:$S$13</c:f>
              <c:numCache>
                <c:formatCode>General</c:formatCode>
                <c:ptCount val="18"/>
                <c:pt idx="0">
                  <c:v>5.455500189189187</c:v>
                </c:pt>
                <c:pt idx="1">
                  <c:v>5.168716094594592</c:v>
                </c:pt>
                <c:pt idx="2">
                  <c:v>12.93874547567568</c:v>
                </c:pt>
                <c:pt idx="3">
                  <c:v>3.816212120689635</c:v>
                </c:pt>
                <c:pt idx="4">
                  <c:v>8.11080295</c:v>
                </c:pt>
                <c:pt idx="5">
                  <c:v>2.231498896551724</c:v>
                </c:pt>
                <c:pt idx="6">
                  <c:v>11.43794627971014</c:v>
                </c:pt>
                <c:pt idx="7">
                  <c:v>4.770154539130424</c:v>
                </c:pt>
                <c:pt idx="8">
                  <c:v>6.91140247536232</c:v>
                </c:pt>
                <c:pt idx="9">
                  <c:v>6.27077627027027</c:v>
                </c:pt>
                <c:pt idx="10">
                  <c:v>6.54493795313792</c:v>
                </c:pt>
                <c:pt idx="11">
                  <c:v>15.37429873569241</c:v>
                </c:pt>
                <c:pt idx="12">
                  <c:v>3.28330770689655</c:v>
                </c:pt>
                <c:pt idx="13">
                  <c:v>8.328326764895843</c:v>
                </c:pt>
                <c:pt idx="14">
                  <c:v>2.736286968780749</c:v>
                </c:pt>
                <c:pt idx="15">
                  <c:v>13.49906234782608</c:v>
                </c:pt>
                <c:pt idx="16">
                  <c:v>5.015916869565173</c:v>
                </c:pt>
                <c:pt idx="17">
                  <c:v>7.989981702898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A753-438F-9862-AFF737338E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2853304"/>
        <c:axId val="2122856904"/>
      </c:barChart>
      <c:catAx>
        <c:axId val="2122853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2122856904"/>
        <c:crosses val="autoZero"/>
        <c:auto val="1"/>
        <c:lblAlgn val="ctr"/>
        <c:lblOffset val="100"/>
        <c:noMultiLvlLbl val="0"/>
      </c:catAx>
      <c:valAx>
        <c:axId val="2122856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FPKM</a:t>
                </a:r>
                <a:endParaRPr lang="ja-JP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2122853304"/>
        <c:crosses val="autoZero"/>
        <c:crossBetween val="between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charset="0"/>
          <a:ea typeface="Arial" charset="0"/>
          <a:cs typeface="Arial" charset="0"/>
        </a:defRPr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836-4CB0-9C84-F3212C57B6B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836-4CB0-9C84-F3212C57B6B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836-4CB0-9C84-F3212C57B6BE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2836-4CB0-9C84-F3212C57B6BE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2836-4CB0-9C84-F3212C57B6BE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2836-4CB0-9C84-F3212C57B6BE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2836-4CB0-9C84-F3212C57B6BE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2836-4CB0-9C84-F3212C57B6BE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2836-4CB0-9C84-F3212C57B6BE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2836-4CB0-9C84-F3212C57B6BE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2836-4CB0-9C84-F3212C57B6BE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2836-4CB0-9C84-F3212C57B6BE}"/>
              </c:ext>
            </c:extLst>
          </c:dPt>
          <c:errBars>
            <c:errBarType val="both"/>
            <c:errValType val="cust"/>
            <c:noEndCap val="0"/>
            <c:plus>
              <c:numRef>
                <c:f>figure!$Y$14:$AP$14</c:f>
                <c:numCache>
                  <c:formatCode>General</c:formatCode>
                  <c:ptCount val="18"/>
                  <c:pt idx="0">
                    <c:v>8.527900723729363</c:v>
                  </c:pt>
                  <c:pt idx="1">
                    <c:v>7.075057803833026</c:v>
                  </c:pt>
                  <c:pt idx="2">
                    <c:v>14.81929397043568</c:v>
                  </c:pt>
                  <c:pt idx="3">
                    <c:v>5.451982287652588</c:v>
                  </c:pt>
                  <c:pt idx="4">
                    <c:v>1.064793937447035</c:v>
                  </c:pt>
                  <c:pt idx="5">
                    <c:v>3.571947413508497</c:v>
                  </c:pt>
                  <c:pt idx="6">
                    <c:v>5.269169478013643</c:v>
                  </c:pt>
                  <c:pt idx="7">
                    <c:v>5.599883448607125</c:v>
                  </c:pt>
                  <c:pt idx="8">
                    <c:v>1.246317979907883</c:v>
                  </c:pt>
                  <c:pt idx="9">
                    <c:v>9.86054473212615</c:v>
                  </c:pt>
                  <c:pt idx="10">
                    <c:v>9.342357718063121</c:v>
                  </c:pt>
                  <c:pt idx="11">
                    <c:v>13.97857874191147</c:v>
                  </c:pt>
                  <c:pt idx="12">
                    <c:v>4.23684469517764</c:v>
                  </c:pt>
                  <c:pt idx="13">
                    <c:v>0.828701559641002</c:v>
                  </c:pt>
                  <c:pt idx="14">
                    <c:v>3.810967097523647</c:v>
                  </c:pt>
                  <c:pt idx="15">
                    <c:v>5.544759594106614</c:v>
                  </c:pt>
                  <c:pt idx="16">
                    <c:v>5.688240495425698</c:v>
                  </c:pt>
                  <c:pt idx="17">
                    <c:v>2.153142383812079</c:v>
                  </c:pt>
                </c:numCache>
              </c:numRef>
            </c:plus>
            <c:minus>
              <c:numRef>
                <c:f>figure!$Y$14:$AP$14</c:f>
                <c:numCache>
                  <c:formatCode>General</c:formatCode>
                  <c:ptCount val="18"/>
                  <c:pt idx="0">
                    <c:v>8.527900723729363</c:v>
                  </c:pt>
                  <c:pt idx="1">
                    <c:v>7.075057803833026</c:v>
                  </c:pt>
                  <c:pt idx="2">
                    <c:v>14.81929397043568</c:v>
                  </c:pt>
                  <c:pt idx="3">
                    <c:v>5.451982287652588</c:v>
                  </c:pt>
                  <c:pt idx="4">
                    <c:v>1.064793937447035</c:v>
                  </c:pt>
                  <c:pt idx="5">
                    <c:v>3.571947413508497</c:v>
                  </c:pt>
                  <c:pt idx="6">
                    <c:v>5.269169478013643</c:v>
                  </c:pt>
                  <c:pt idx="7">
                    <c:v>5.599883448607125</c:v>
                  </c:pt>
                  <c:pt idx="8">
                    <c:v>1.246317979907883</c:v>
                  </c:pt>
                  <c:pt idx="9">
                    <c:v>9.86054473212615</c:v>
                  </c:pt>
                  <c:pt idx="10">
                    <c:v>9.342357718063121</c:v>
                  </c:pt>
                  <c:pt idx="11">
                    <c:v>13.97857874191147</c:v>
                  </c:pt>
                  <c:pt idx="12">
                    <c:v>4.23684469517764</c:v>
                  </c:pt>
                  <c:pt idx="13">
                    <c:v>0.828701559641002</c:v>
                  </c:pt>
                  <c:pt idx="14">
                    <c:v>3.810967097523647</c:v>
                  </c:pt>
                  <c:pt idx="15">
                    <c:v>5.544759594106614</c:v>
                  </c:pt>
                  <c:pt idx="16">
                    <c:v>5.688240495425698</c:v>
                  </c:pt>
                  <c:pt idx="17">
                    <c:v>2.1531423838120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Y$9:$AP$12</c:f>
              <c:multiLvlStrCache>
                <c:ptCount val="18"/>
                <c:lvl>
                  <c:pt idx="0">
                    <c:v>+</c:v>
                  </c:pt>
                  <c:pt idx="1">
                    <c:v>-</c:v>
                  </c:pt>
                  <c:pt idx="2">
                    <c:v>-</c:v>
                  </c:pt>
                  <c:pt idx="3">
                    <c:v>-</c:v>
                  </c:pt>
                  <c:pt idx="4">
                    <c:v>+</c:v>
                  </c:pt>
                  <c:pt idx="5">
                    <c:v>-</c:v>
                  </c:pt>
                  <c:pt idx="6">
                    <c:v>-</c:v>
                  </c:pt>
                  <c:pt idx="7">
                    <c:v>-</c:v>
                  </c:pt>
                  <c:pt idx="8">
                    <c:v>+</c:v>
                  </c:pt>
                  <c:pt idx="9">
                    <c:v>+</c:v>
                  </c:pt>
                  <c:pt idx="10">
                    <c:v>-</c:v>
                  </c:pt>
                  <c:pt idx="11">
                    <c:v>-</c:v>
                  </c:pt>
                  <c:pt idx="12">
                    <c:v>-</c:v>
                  </c:pt>
                  <c:pt idx="13">
                    <c:v>+</c:v>
                  </c:pt>
                  <c:pt idx="14">
                    <c:v>-</c:v>
                  </c:pt>
                  <c:pt idx="15">
                    <c:v>-</c:v>
                  </c:pt>
                  <c:pt idx="16">
                    <c:v>-</c:v>
                  </c:pt>
                  <c:pt idx="17">
                    <c:v>+</c:v>
                  </c:pt>
                </c:lvl>
                <c:lvl>
                  <c:pt idx="0">
                    <c:v>LF</c:v>
                  </c:pt>
                  <c:pt idx="1">
                    <c:v>MF1</c:v>
                  </c:pt>
                  <c:pt idx="2">
                    <c:v>MF2</c:v>
                  </c:pt>
                  <c:pt idx="3">
                    <c:v>LF</c:v>
                  </c:pt>
                  <c:pt idx="4">
                    <c:v>MF1</c:v>
                  </c:pt>
                  <c:pt idx="5">
                    <c:v>MF2</c:v>
                  </c:pt>
                  <c:pt idx="6">
                    <c:v>LF</c:v>
                  </c:pt>
                  <c:pt idx="7">
                    <c:v>MF1</c:v>
                  </c:pt>
                  <c:pt idx="8">
                    <c:v>MF2</c:v>
                  </c:pt>
                  <c:pt idx="9">
                    <c:v>LF</c:v>
                  </c:pt>
                  <c:pt idx="10">
                    <c:v>MF1</c:v>
                  </c:pt>
                  <c:pt idx="11">
                    <c:v>MF2</c:v>
                  </c:pt>
                  <c:pt idx="12">
                    <c:v>LF</c:v>
                  </c:pt>
                  <c:pt idx="13">
                    <c:v>MF1</c:v>
                  </c:pt>
                  <c:pt idx="14">
                    <c:v>MF2</c:v>
                  </c:pt>
                  <c:pt idx="15">
                    <c:v>LF</c:v>
                  </c:pt>
                  <c:pt idx="16">
                    <c:v>MF1</c:v>
                  </c:pt>
                  <c:pt idx="17">
                    <c:v>MF2</c:v>
                  </c:pt>
                </c:lvl>
                <c:lvl>
                  <c:pt idx="0">
                    <c:v>RJKB-T23</c:v>
                  </c:pt>
                  <c:pt idx="9">
                    <c:v>RJKB-T24</c:v>
                  </c:pt>
                </c:lvl>
                <c:lvl>
                  <c:pt idx="0">
                    <c:v>1 of 3 genes</c:v>
                  </c:pt>
                </c:lvl>
              </c:multiLvlStrCache>
            </c:multiLvlStrRef>
          </c:cat>
          <c:val>
            <c:numRef>
              <c:f>figure!$Y$13:$AP$13</c:f>
              <c:numCache>
                <c:formatCode>General</c:formatCode>
                <c:ptCount val="18"/>
                <c:pt idx="0">
                  <c:v>16.08563670877172</c:v>
                </c:pt>
                <c:pt idx="1">
                  <c:v>24.40306305964912</c:v>
                </c:pt>
                <c:pt idx="2">
                  <c:v>38.52898012280702</c:v>
                </c:pt>
                <c:pt idx="3">
                  <c:v>25.43366417525775</c:v>
                </c:pt>
                <c:pt idx="4">
                  <c:v>4.876754525773194</c:v>
                </c:pt>
                <c:pt idx="5">
                  <c:v>20.72810245876288</c:v>
                </c:pt>
                <c:pt idx="6">
                  <c:v>26.13725603703704</c:v>
                </c:pt>
                <c:pt idx="7">
                  <c:v>26.17326632407407</c:v>
                </c:pt>
                <c:pt idx="8">
                  <c:v>5.521215401851852</c:v>
                </c:pt>
                <c:pt idx="9">
                  <c:v>17.24356186666667</c:v>
                </c:pt>
                <c:pt idx="10">
                  <c:v>27.92130785964912</c:v>
                </c:pt>
                <c:pt idx="11">
                  <c:v>36.6407404385965</c:v>
                </c:pt>
                <c:pt idx="12">
                  <c:v>23.31302307216495</c:v>
                </c:pt>
                <c:pt idx="13">
                  <c:v>3.967674344329898</c:v>
                </c:pt>
                <c:pt idx="14">
                  <c:v>22.21939348659794</c:v>
                </c:pt>
                <c:pt idx="15">
                  <c:v>28.40911946296292</c:v>
                </c:pt>
                <c:pt idx="16">
                  <c:v>28.17079750925926</c:v>
                </c:pt>
                <c:pt idx="17">
                  <c:v>7.3256932018518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8-2836-4CB0-9C84-F3212C57B6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4656600"/>
        <c:axId val="2124660184"/>
      </c:barChart>
      <c:catAx>
        <c:axId val="2124656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2124660184"/>
        <c:crosses val="autoZero"/>
        <c:auto val="1"/>
        <c:lblAlgn val="ctr"/>
        <c:lblOffset val="100"/>
        <c:noMultiLvlLbl val="0"/>
      </c:catAx>
      <c:valAx>
        <c:axId val="21246601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FPKM</a:t>
                </a:r>
                <a:endParaRPr lang="ja-JP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2124656600"/>
        <c:crosses val="autoZero"/>
        <c:crossBetween val="between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charset="0"/>
          <a:ea typeface="Arial" charset="0"/>
          <a:cs typeface="Arial" charset="0"/>
        </a:defRPr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E12D5C-87E7-5147-9FD7-C4C42D2AFA56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DF698D-C6BC-8940-AB21-7DDF13E4E6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115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DF698D-C6BC-8940-AB21-7DDF13E4E671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028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DF698D-C6BC-8940-AB21-7DDF13E4E671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6845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DF698D-C6BC-8940-AB21-7DDF13E4E671}" type="slidenum">
              <a:rPr kumimoji="1" lang="ja-JP" altLang="en-US" smtClean="0"/>
              <a:t>1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22078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DF698D-C6BC-8940-AB21-7DDF13E4E671}" type="slidenum">
              <a:rPr kumimoji="1" lang="ja-JP" altLang="en-US" smtClean="0"/>
              <a:t>1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6659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ED2877-7012-C248-B287-43005D0985C4}" type="slidenum">
              <a:rPr kumimoji="1" lang="ja-JP" altLang="en-US" smtClean="0"/>
              <a:t>1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034850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DF698D-C6BC-8940-AB21-7DDF13E4E671}" type="slidenum">
              <a:rPr kumimoji="1" lang="ja-JP" altLang="en-US" smtClean="0"/>
              <a:t>1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639733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DF698D-C6BC-8940-AB21-7DDF13E4E671}" type="slidenum">
              <a:rPr kumimoji="1" lang="ja-JP" altLang="en-US" smtClean="0"/>
              <a:t>1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48762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525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4205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7048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660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403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9511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692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448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7652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018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941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3DB75-23CA-F644-9AC2-E2E5B9A2CC58}" type="datetimeFigureOut">
              <a:rPr kumimoji="1" lang="ja-JP" altLang="en-US" smtClean="0"/>
              <a:t>19/0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E0AC3-2B92-2B4D-BA78-EFB305E156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866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4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4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4" Type="http://schemas.openxmlformats.org/officeDocument/2006/relationships/chart" Target="../charts/chart15.xml"/><Relationship Id="rId5" Type="http://schemas.openxmlformats.org/officeDocument/2006/relationships/chart" Target="../charts/chart16.xml"/><Relationship Id="rId6" Type="http://schemas.openxmlformats.org/officeDocument/2006/relationships/chart" Target="../charts/chart17.xml"/><Relationship Id="rId7" Type="http://schemas.openxmlformats.org/officeDocument/2006/relationships/chart" Target="../charts/chart18.xml"/><Relationship Id="rId8" Type="http://schemas.openxmlformats.org/officeDocument/2006/relationships/chart" Target="../charts/chart19.xml"/><Relationship Id="rId9" Type="http://schemas.openxmlformats.org/officeDocument/2006/relationships/chart" Target="../charts/chart20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Relationship Id="rId3" Type="http://schemas.openxmlformats.org/officeDocument/2006/relationships/image" Target="../media/image14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chart" Target="../charts/chart1.xml"/><Relationship Id="rId7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Relationship Id="rId3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4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752601" y="90720"/>
            <a:ext cx="5538971" cy="5949280"/>
            <a:chOff x="711201" y="0"/>
            <a:chExt cx="5538971" cy="5949280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1201" y="0"/>
              <a:ext cx="3529477" cy="5949280"/>
            </a:xfrm>
            <a:prstGeom prst="rect">
              <a:avLst/>
            </a:prstGeom>
          </p:spPr>
        </p:pic>
        <p:sp>
          <p:nvSpPr>
            <p:cNvPr id="6" name="右大かっこ 5"/>
            <p:cNvSpPr/>
            <p:nvPr/>
          </p:nvSpPr>
          <p:spPr>
            <a:xfrm>
              <a:off x="4770969" y="143933"/>
              <a:ext cx="186267" cy="4148667"/>
            </a:xfrm>
            <a:prstGeom prst="rightBracket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右大かっこ 6"/>
            <p:cNvSpPr/>
            <p:nvPr/>
          </p:nvSpPr>
          <p:spPr>
            <a:xfrm>
              <a:off x="4770969" y="4351867"/>
              <a:ext cx="186267" cy="431999"/>
            </a:xfrm>
            <a:prstGeom prst="rightBracket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右大かっこ 7"/>
            <p:cNvSpPr/>
            <p:nvPr/>
          </p:nvSpPr>
          <p:spPr>
            <a:xfrm>
              <a:off x="4770969" y="4851400"/>
              <a:ext cx="186267" cy="503999"/>
            </a:xfrm>
            <a:prstGeom prst="rightBracket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5012308" y="2079767"/>
              <a:ext cx="12378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var. </a:t>
              </a:r>
              <a:r>
                <a:rPr kumimoji="1" lang="en-US" altLang="ja-JP" sz="1200" i="1" dirty="0" smtClean="0">
                  <a:latin typeface="Arial"/>
                  <a:cs typeface="Arial"/>
                </a:rPr>
                <a:t>pekinensis</a:t>
              </a:r>
              <a:endParaRPr kumimoji="1" lang="ja-JP" altLang="en-US" sz="1200" i="1" dirty="0">
                <a:latin typeface="Arial"/>
                <a:cs typeface="Arial"/>
              </a:endParaRPr>
            </a:p>
          </p:txBody>
        </p:sp>
        <p:sp>
          <p:nvSpPr>
            <p:cNvPr id="10" name="右大かっこ 9"/>
            <p:cNvSpPr/>
            <p:nvPr/>
          </p:nvSpPr>
          <p:spPr>
            <a:xfrm>
              <a:off x="4770969" y="5372334"/>
              <a:ext cx="186267" cy="251996"/>
            </a:xfrm>
            <a:prstGeom prst="rightBracket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5012308" y="4429367"/>
              <a:ext cx="11264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var. </a:t>
              </a:r>
              <a:r>
                <a:rPr kumimoji="1" lang="en-US" altLang="ja-JP" sz="1200" i="1" dirty="0" err="1" smtClean="0">
                  <a:latin typeface="Arial"/>
                  <a:cs typeface="Arial"/>
                </a:rPr>
                <a:t>perviridis</a:t>
              </a:r>
              <a:endParaRPr kumimoji="1" lang="ja-JP" altLang="en-US" sz="1200" i="1" dirty="0">
                <a:latin typeface="Arial"/>
                <a:cs typeface="Arial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5012308" y="5359833"/>
              <a:ext cx="11264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var. </a:t>
              </a:r>
              <a:r>
                <a:rPr kumimoji="1" lang="en-US" altLang="ja-JP" sz="1200" i="1" dirty="0" err="1" smtClean="0">
                  <a:latin typeface="Arial"/>
                  <a:cs typeface="Arial"/>
                </a:rPr>
                <a:t>perviridis</a:t>
              </a:r>
              <a:endParaRPr kumimoji="1" lang="ja-JP" altLang="en-US" sz="1200" i="1" dirty="0">
                <a:latin typeface="Arial"/>
                <a:cs typeface="Arial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5012308" y="4964900"/>
              <a:ext cx="8187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var. </a:t>
              </a:r>
              <a:r>
                <a:rPr kumimoji="1" lang="en-US" altLang="ja-JP" sz="1200" i="1" dirty="0" smtClean="0">
                  <a:latin typeface="Arial"/>
                  <a:cs typeface="Arial"/>
                </a:rPr>
                <a:t>rapa</a:t>
              </a:r>
              <a:endParaRPr kumimoji="1" lang="ja-JP" altLang="en-US" sz="1200" i="1" dirty="0">
                <a:latin typeface="Arial"/>
                <a:cs typeface="Arial"/>
              </a:endParaRPr>
            </a:p>
          </p:txBody>
        </p:sp>
        <p:sp>
          <p:nvSpPr>
            <p:cNvPr id="14" name="左矢印 13"/>
            <p:cNvSpPr/>
            <p:nvPr/>
          </p:nvSpPr>
          <p:spPr>
            <a:xfrm>
              <a:off x="3760322" y="577850"/>
              <a:ext cx="316378" cy="190500"/>
            </a:xfrm>
            <a:prstGeom prst="leftArrow">
              <a:avLst/>
            </a:prstGeom>
            <a:solidFill>
              <a:srgbClr val="FFFF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左矢印 14"/>
            <p:cNvSpPr/>
            <p:nvPr/>
          </p:nvSpPr>
          <p:spPr>
            <a:xfrm>
              <a:off x="3760322" y="1933717"/>
              <a:ext cx="316378" cy="190500"/>
            </a:xfrm>
            <a:prstGeom prst="leftArrow">
              <a:avLst/>
            </a:prstGeom>
            <a:solidFill>
              <a:srgbClr val="FFFF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左矢印 15"/>
            <p:cNvSpPr/>
            <p:nvPr/>
          </p:nvSpPr>
          <p:spPr>
            <a:xfrm>
              <a:off x="3760322" y="3305317"/>
              <a:ext cx="316378" cy="190500"/>
            </a:xfrm>
            <a:prstGeom prst="leftArrow">
              <a:avLst/>
            </a:prstGeom>
            <a:solidFill>
              <a:schemeClr val="tx2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7" name="テキスト ボックス 16"/>
          <p:cNvSpPr txBox="1"/>
          <p:nvPr/>
        </p:nvSpPr>
        <p:spPr>
          <a:xfrm>
            <a:off x="174405" y="6050492"/>
            <a:ext cx="85885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Figure S1. </a:t>
            </a:r>
            <a:r>
              <a:rPr kumimoji="1" lang="en-US" altLang="ja-JP" sz="1200" dirty="0" smtClean="0">
                <a:latin typeface="Arial"/>
                <a:cs typeface="Arial"/>
              </a:rPr>
              <a:t>Genetic distance of lines/cultivars in </a:t>
            </a:r>
            <a:r>
              <a:rPr kumimoji="1" lang="en-US" altLang="ja-JP" sz="1200" i="1" dirty="0" smtClean="0">
                <a:latin typeface="Arial"/>
                <a:cs typeface="Arial"/>
              </a:rPr>
              <a:t>B. rapa</a:t>
            </a:r>
            <a:r>
              <a:rPr kumimoji="1" lang="en-US" altLang="ja-JP" sz="1200" dirty="0" smtClean="0">
                <a:latin typeface="Arial"/>
                <a:cs typeface="Arial"/>
              </a:rPr>
              <a:t>. The Chinese cabbage </a:t>
            </a:r>
            <a:r>
              <a:rPr lang="en-US" altLang="ja-JP" sz="1200" dirty="0" smtClean="0">
                <a:latin typeface="Arial"/>
                <a:cs typeface="Arial"/>
              </a:rPr>
              <a:t>line, </a:t>
            </a:r>
            <a:r>
              <a:rPr kumimoji="1" lang="en-US" altLang="ja-JP" sz="1200" dirty="0" err="1" smtClean="0">
                <a:latin typeface="Arial"/>
                <a:cs typeface="Arial"/>
              </a:rPr>
              <a:t>Chiifu</a:t>
            </a:r>
            <a:r>
              <a:rPr kumimoji="1" lang="en-US" altLang="ja-JP" sz="1200" dirty="0" smtClean="0">
                <a:latin typeface="Arial"/>
                <a:cs typeface="Arial"/>
              </a:rPr>
              <a:t> (blue arrow; reference genome), twenty-four Chinese cabbage (var. </a:t>
            </a:r>
            <a:r>
              <a:rPr kumimoji="1" lang="en-US" altLang="ja-JP" sz="1200" i="1" dirty="0" smtClean="0">
                <a:latin typeface="Arial"/>
                <a:cs typeface="Arial"/>
              </a:rPr>
              <a:t>pekinensis</a:t>
            </a:r>
            <a:r>
              <a:rPr kumimoji="1" lang="en-US" altLang="ja-JP" sz="1200" dirty="0" smtClean="0">
                <a:latin typeface="Arial"/>
                <a:cs typeface="Arial"/>
              </a:rPr>
              <a:t>) inbred lines, three turnip (var. </a:t>
            </a:r>
            <a:r>
              <a:rPr kumimoji="1" lang="en-US" altLang="ja-JP" sz="1200" i="1" dirty="0" smtClean="0">
                <a:latin typeface="Arial"/>
                <a:cs typeface="Arial"/>
              </a:rPr>
              <a:t>rapa</a:t>
            </a:r>
            <a:r>
              <a:rPr kumimoji="1" lang="en-US" altLang="ja-JP" sz="1200" dirty="0" smtClean="0">
                <a:latin typeface="Arial"/>
                <a:cs typeface="Arial"/>
              </a:rPr>
              <a:t>) lines and four komatsuna (var. </a:t>
            </a:r>
            <a:r>
              <a:rPr kumimoji="1" lang="en-US" altLang="ja-JP" sz="1200" i="1" dirty="0" err="1" smtClean="0">
                <a:latin typeface="Arial"/>
                <a:cs typeface="Arial"/>
              </a:rPr>
              <a:t>perviridis</a:t>
            </a:r>
            <a:r>
              <a:rPr kumimoji="1" lang="en-US" altLang="ja-JP" sz="1200" dirty="0" smtClean="0">
                <a:latin typeface="Arial"/>
                <a:cs typeface="Arial"/>
              </a:rPr>
              <a:t>) lines were used. Genetic distance was calculated using data described in Kawamura </a:t>
            </a:r>
            <a:r>
              <a:rPr kumimoji="1" lang="en-US" altLang="ja-JP" sz="1200" i="1" dirty="0" smtClean="0">
                <a:latin typeface="Arial"/>
                <a:cs typeface="Arial"/>
              </a:rPr>
              <a:t>et al</a:t>
            </a:r>
            <a:r>
              <a:rPr kumimoji="1" lang="en-US" altLang="ja-JP" sz="1200" dirty="0" smtClean="0">
                <a:latin typeface="Arial"/>
                <a:cs typeface="Arial"/>
              </a:rPr>
              <a:t>. 2016.</a:t>
            </a:r>
            <a:r>
              <a:rPr kumimoji="1" lang="en-US" altLang="ja-JP" sz="1200" baseline="30000" dirty="0" smtClean="0">
                <a:latin typeface="Arial"/>
                <a:cs typeface="Arial"/>
              </a:rPr>
              <a:t>34</a:t>
            </a:r>
            <a:endParaRPr kumimoji="1" lang="ja-JP" altLang="en-US" sz="1200" baseline="30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909654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正方形/長方形 85"/>
          <p:cNvSpPr/>
          <p:nvPr/>
        </p:nvSpPr>
        <p:spPr>
          <a:xfrm>
            <a:off x="48656" y="6229242"/>
            <a:ext cx="905016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S10.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Comparison of the tissue specificity between paralogous pairs with and without H3K27me3 using T-values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Values are means ± standard error (</a:t>
            </a:r>
            <a:r>
              <a:rPr lang="en-US" altLang="ja-JP" sz="1200" dirty="0" err="1">
                <a:solidFill>
                  <a:srgbClr val="000000"/>
                </a:solidFill>
                <a:latin typeface="Arial"/>
                <a:cs typeface="Arial"/>
              </a:rPr>
              <a:t>s.e.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)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of T-values.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+ and </a:t>
            </a:r>
            <a:r>
              <a:rPr lang="mr-IN" altLang="ja-JP" sz="1200" dirty="0">
                <a:solidFill>
                  <a:srgbClr val="000000"/>
                </a:solidFill>
                <a:latin typeface="Arial"/>
                <a:cs typeface="Arial"/>
              </a:rPr>
              <a:t>–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represent presence and absence of H3K27me3, respectively. *, </a:t>
            </a: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&lt;0.05; **, </a:t>
            </a: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&lt;0.01 (Student </a:t>
            </a: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t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-test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)</a:t>
            </a:r>
            <a:endParaRPr lang="ja-JP" altLang="ja-JP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pSp>
        <p:nvGrpSpPr>
          <p:cNvPr id="2" name="図形グループ 1"/>
          <p:cNvGrpSpPr/>
          <p:nvPr/>
        </p:nvGrpSpPr>
        <p:grpSpPr>
          <a:xfrm>
            <a:off x="92217" y="65832"/>
            <a:ext cx="8959567" cy="6176110"/>
            <a:chOff x="6632" y="116632"/>
            <a:chExt cx="8959567" cy="6176110"/>
          </a:xfrm>
        </p:grpSpPr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7260227"/>
                </p:ext>
              </p:extLst>
            </p:nvPr>
          </p:nvGraphicFramePr>
          <p:xfrm>
            <a:off x="321732" y="315384"/>
            <a:ext cx="8644467" cy="2857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53" name="図形グループ 52"/>
            <p:cNvGrpSpPr/>
            <p:nvPr/>
          </p:nvGrpSpPr>
          <p:grpSpPr>
            <a:xfrm>
              <a:off x="4188594" y="643928"/>
              <a:ext cx="660690" cy="461392"/>
              <a:chOff x="4048894" y="656628"/>
              <a:chExt cx="660690" cy="461392"/>
            </a:xfrm>
          </p:grpSpPr>
          <p:grpSp>
            <p:nvGrpSpPr>
              <p:cNvPr id="51" name="図形グループ 50"/>
              <p:cNvGrpSpPr/>
              <p:nvPr/>
            </p:nvGrpSpPr>
            <p:grpSpPr>
              <a:xfrm>
                <a:off x="4048894" y="656628"/>
                <a:ext cx="482889" cy="461392"/>
                <a:chOff x="4048894" y="656628"/>
                <a:chExt cx="482889" cy="461392"/>
              </a:xfrm>
            </p:grpSpPr>
            <p:cxnSp>
              <p:nvCxnSpPr>
                <p:cNvPr id="12" name="直線コネクタ 11"/>
                <p:cNvCxnSpPr/>
                <p:nvPr/>
              </p:nvCxnSpPr>
              <p:spPr>
                <a:xfrm flipV="1">
                  <a:off x="4048894" y="656628"/>
                  <a:ext cx="0" cy="461392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線コネクタ 14"/>
                <p:cNvCxnSpPr/>
                <p:nvPr/>
              </p:nvCxnSpPr>
              <p:spPr>
                <a:xfrm>
                  <a:off x="4048894" y="656628"/>
                  <a:ext cx="48288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図形グループ 51"/>
              <p:cNvGrpSpPr/>
              <p:nvPr/>
            </p:nvGrpSpPr>
            <p:grpSpPr>
              <a:xfrm>
                <a:off x="4339167" y="656628"/>
                <a:ext cx="370417" cy="143996"/>
                <a:chOff x="4339167" y="670917"/>
                <a:chExt cx="370417" cy="143996"/>
              </a:xfrm>
            </p:grpSpPr>
            <p:cxnSp>
              <p:nvCxnSpPr>
                <p:cNvPr id="11" name="直線コネクタ 10"/>
                <p:cNvCxnSpPr/>
                <p:nvPr/>
              </p:nvCxnSpPr>
              <p:spPr>
                <a:xfrm>
                  <a:off x="4339167" y="814913"/>
                  <a:ext cx="370417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線コネクタ 17"/>
                <p:cNvCxnSpPr/>
                <p:nvPr/>
              </p:nvCxnSpPr>
              <p:spPr>
                <a:xfrm flipV="1">
                  <a:off x="4524375" y="670917"/>
                  <a:ext cx="0" cy="143996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20" name="直線コネクタ 19"/>
            <p:cNvCxnSpPr/>
            <p:nvPr/>
          </p:nvCxnSpPr>
          <p:spPr>
            <a:xfrm flipV="1">
              <a:off x="2114550" y="482600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/>
            <p:cNvCxnSpPr/>
            <p:nvPr/>
          </p:nvCxnSpPr>
          <p:spPr>
            <a:xfrm flipV="1">
              <a:off x="3073400" y="482600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 flipV="1">
              <a:off x="4013200" y="482600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/>
            <p:cNvCxnSpPr/>
            <p:nvPr/>
          </p:nvCxnSpPr>
          <p:spPr>
            <a:xfrm flipV="1">
              <a:off x="4984750" y="482600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/>
            <p:cNvSpPr txBox="1"/>
            <p:nvPr/>
          </p:nvSpPr>
          <p:spPr>
            <a:xfrm>
              <a:off x="4312987" y="472013"/>
              <a:ext cx="2487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25" name="直線コネクタ 24"/>
            <p:cNvCxnSpPr/>
            <p:nvPr/>
          </p:nvCxnSpPr>
          <p:spPr>
            <a:xfrm flipV="1">
              <a:off x="5943600" y="482600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/>
            <p:cNvCxnSpPr/>
            <p:nvPr/>
          </p:nvCxnSpPr>
          <p:spPr>
            <a:xfrm flipV="1">
              <a:off x="6889750" y="482600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/>
            <p:cNvCxnSpPr/>
            <p:nvPr/>
          </p:nvCxnSpPr>
          <p:spPr>
            <a:xfrm flipV="1">
              <a:off x="7854950" y="472013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6" name="図形グループ 55"/>
            <p:cNvGrpSpPr/>
            <p:nvPr/>
          </p:nvGrpSpPr>
          <p:grpSpPr>
            <a:xfrm>
              <a:off x="5142153" y="912217"/>
              <a:ext cx="661458" cy="683999"/>
              <a:chOff x="4989753" y="924917"/>
              <a:chExt cx="661458" cy="683999"/>
            </a:xfrm>
          </p:grpSpPr>
          <p:grpSp>
            <p:nvGrpSpPr>
              <p:cNvPr id="55" name="図形グループ 54"/>
              <p:cNvGrpSpPr/>
              <p:nvPr/>
            </p:nvGrpSpPr>
            <p:grpSpPr>
              <a:xfrm>
                <a:off x="5280794" y="924917"/>
                <a:ext cx="370417" cy="683999"/>
                <a:chOff x="5299844" y="931014"/>
                <a:chExt cx="370417" cy="683999"/>
              </a:xfrm>
            </p:grpSpPr>
            <p:cxnSp>
              <p:nvCxnSpPr>
                <p:cNvPr id="28" name="直線コネクタ 27"/>
                <p:cNvCxnSpPr/>
                <p:nvPr/>
              </p:nvCxnSpPr>
              <p:spPr>
                <a:xfrm flipH="1">
                  <a:off x="5299844" y="1615013"/>
                  <a:ext cx="370417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28"/>
                <p:cNvCxnSpPr/>
                <p:nvPr/>
              </p:nvCxnSpPr>
              <p:spPr>
                <a:xfrm flipH="1" flipV="1">
                  <a:off x="5485052" y="931014"/>
                  <a:ext cx="0" cy="683999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4" name="図形グループ 53"/>
              <p:cNvGrpSpPr/>
              <p:nvPr/>
            </p:nvGrpSpPr>
            <p:grpSpPr>
              <a:xfrm>
                <a:off x="4989753" y="924917"/>
                <a:ext cx="482889" cy="143996"/>
                <a:chOff x="4989753" y="924917"/>
                <a:chExt cx="482889" cy="143996"/>
              </a:xfrm>
            </p:grpSpPr>
            <p:cxnSp>
              <p:nvCxnSpPr>
                <p:cNvPr id="30" name="直線コネクタ 29"/>
                <p:cNvCxnSpPr/>
                <p:nvPr/>
              </p:nvCxnSpPr>
              <p:spPr>
                <a:xfrm flipH="1">
                  <a:off x="4989753" y="924917"/>
                  <a:ext cx="48288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線コネクタ 30"/>
                <p:cNvCxnSpPr/>
                <p:nvPr/>
              </p:nvCxnSpPr>
              <p:spPr>
                <a:xfrm flipH="1" flipV="1">
                  <a:off x="4989753" y="924917"/>
                  <a:ext cx="0" cy="143996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3" name="テキスト ボックス 32"/>
            <p:cNvSpPr txBox="1"/>
            <p:nvPr/>
          </p:nvSpPr>
          <p:spPr>
            <a:xfrm>
              <a:off x="5270500" y="663713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34" name="直線コネクタ 33"/>
            <p:cNvCxnSpPr/>
            <p:nvPr/>
          </p:nvCxnSpPr>
          <p:spPr>
            <a:xfrm flipV="1">
              <a:off x="1826684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/>
            <p:cNvCxnSpPr/>
            <p:nvPr/>
          </p:nvCxnSpPr>
          <p:spPr>
            <a:xfrm flipV="1">
              <a:off x="2461684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 flipV="1">
              <a:off x="3098800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 flipV="1">
              <a:off x="3731684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/>
            <p:cNvCxnSpPr/>
            <p:nvPr/>
          </p:nvCxnSpPr>
          <p:spPr>
            <a:xfrm flipV="1">
              <a:off x="4375151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/>
            <p:cNvCxnSpPr/>
            <p:nvPr/>
          </p:nvCxnSpPr>
          <p:spPr>
            <a:xfrm flipV="1">
              <a:off x="5010150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/>
            <p:cNvCxnSpPr/>
            <p:nvPr/>
          </p:nvCxnSpPr>
          <p:spPr>
            <a:xfrm flipV="1">
              <a:off x="5644092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/>
            <p:cNvCxnSpPr/>
            <p:nvPr/>
          </p:nvCxnSpPr>
          <p:spPr>
            <a:xfrm flipV="1">
              <a:off x="6262158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/>
            <p:cNvCxnSpPr/>
            <p:nvPr/>
          </p:nvCxnSpPr>
          <p:spPr>
            <a:xfrm flipV="1">
              <a:off x="7540625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/>
            <p:cNvCxnSpPr/>
            <p:nvPr/>
          </p:nvCxnSpPr>
          <p:spPr>
            <a:xfrm flipV="1">
              <a:off x="8175625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/>
            <p:cNvCxnSpPr/>
            <p:nvPr/>
          </p:nvCxnSpPr>
          <p:spPr>
            <a:xfrm flipV="1">
              <a:off x="6915150" y="3615266"/>
              <a:ext cx="0" cy="175895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8" name="図形グループ 57"/>
            <p:cNvGrpSpPr/>
            <p:nvPr/>
          </p:nvGrpSpPr>
          <p:grpSpPr>
            <a:xfrm>
              <a:off x="6094709" y="1014636"/>
              <a:ext cx="648000" cy="503998"/>
              <a:chOff x="5955009" y="1027336"/>
              <a:chExt cx="648000" cy="503998"/>
            </a:xfrm>
          </p:grpSpPr>
          <p:grpSp>
            <p:nvGrpSpPr>
              <p:cNvPr id="50" name="図形グループ 49"/>
              <p:cNvGrpSpPr/>
              <p:nvPr/>
            </p:nvGrpSpPr>
            <p:grpSpPr>
              <a:xfrm>
                <a:off x="5955009" y="1027336"/>
                <a:ext cx="648000" cy="503998"/>
                <a:chOff x="5955009" y="1027336"/>
                <a:chExt cx="648000" cy="503998"/>
              </a:xfrm>
            </p:grpSpPr>
            <p:grpSp>
              <p:nvGrpSpPr>
                <p:cNvPr id="49" name="図形グループ 48"/>
                <p:cNvGrpSpPr/>
                <p:nvPr/>
              </p:nvGrpSpPr>
              <p:grpSpPr>
                <a:xfrm>
                  <a:off x="5955009" y="1027336"/>
                  <a:ext cx="648000" cy="503998"/>
                  <a:chOff x="5955009" y="1027336"/>
                  <a:chExt cx="648000" cy="503998"/>
                </a:xfrm>
              </p:grpSpPr>
              <p:cxnSp>
                <p:nvCxnSpPr>
                  <p:cNvPr id="46" name="直線コネクタ 45"/>
                  <p:cNvCxnSpPr/>
                  <p:nvPr/>
                </p:nvCxnSpPr>
                <p:spPr>
                  <a:xfrm flipH="1" flipV="1">
                    <a:off x="5955009" y="1027336"/>
                    <a:ext cx="0" cy="503998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直線コネクタ 46"/>
                  <p:cNvCxnSpPr/>
                  <p:nvPr/>
                </p:nvCxnSpPr>
                <p:spPr>
                  <a:xfrm flipH="1">
                    <a:off x="5955009" y="1027336"/>
                    <a:ext cx="6480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8" name="直線コネクタ 47"/>
                <p:cNvCxnSpPr/>
                <p:nvPr/>
              </p:nvCxnSpPr>
              <p:spPr>
                <a:xfrm flipH="1" flipV="1">
                  <a:off x="6603009" y="1027336"/>
                  <a:ext cx="0" cy="503998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7" name="直線コネクタ 56"/>
              <p:cNvCxnSpPr/>
              <p:nvPr/>
            </p:nvCxnSpPr>
            <p:spPr>
              <a:xfrm flipH="1" flipV="1">
                <a:off x="6279009" y="1027336"/>
                <a:ext cx="0" cy="143996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9" name="テキスト ボックス 58"/>
            <p:cNvSpPr txBox="1"/>
            <p:nvPr/>
          </p:nvSpPr>
          <p:spPr>
            <a:xfrm>
              <a:off x="6080305" y="805467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6422312" y="805467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61" name="図形グループ 60"/>
            <p:cNvGrpSpPr/>
            <p:nvPr/>
          </p:nvGrpSpPr>
          <p:grpSpPr>
            <a:xfrm flipH="1">
              <a:off x="7024928" y="860035"/>
              <a:ext cx="661458" cy="719999"/>
              <a:chOff x="4989753" y="924917"/>
              <a:chExt cx="661458" cy="719999"/>
            </a:xfrm>
          </p:grpSpPr>
          <p:grpSp>
            <p:nvGrpSpPr>
              <p:cNvPr id="62" name="図形グループ 61"/>
              <p:cNvGrpSpPr/>
              <p:nvPr/>
            </p:nvGrpSpPr>
            <p:grpSpPr>
              <a:xfrm>
                <a:off x="5280794" y="924917"/>
                <a:ext cx="370417" cy="719999"/>
                <a:chOff x="5299844" y="931014"/>
                <a:chExt cx="370417" cy="719999"/>
              </a:xfrm>
            </p:grpSpPr>
            <p:cxnSp>
              <p:nvCxnSpPr>
                <p:cNvPr id="66" name="直線コネクタ 65"/>
                <p:cNvCxnSpPr/>
                <p:nvPr/>
              </p:nvCxnSpPr>
              <p:spPr>
                <a:xfrm flipH="1">
                  <a:off x="5299844" y="1646763"/>
                  <a:ext cx="370417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直線コネクタ 66"/>
                <p:cNvCxnSpPr/>
                <p:nvPr/>
              </p:nvCxnSpPr>
              <p:spPr>
                <a:xfrm flipH="1" flipV="1">
                  <a:off x="5485052" y="931014"/>
                  <a:ext cx="0" cy="719999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" name="図形グループ 62"/>
              <p:cNvGrpSpPr/>
              <p:nvPr/>
            </p:nvGrpSpPr>
            <p:grpSpPr>
              <a:xfrm>
                <a:off x="4989753" y="924917"/>
                <a:ext cx="482889" cy="143996"/>
                <a:chOff x="4989753" y="924917"/>
                <a:chExt cx="482889" cy="143996"/>
              </a:xfrm>
            </p:grpSpPr>
            <p:cxnSp>
              <p:nvCxnSpPr>
                <p:cNvPr id="64" name="直線コネクタ 63"/>
                <p:cNvCxnSpPr/>
                <p:nvPr/>
              </p:nvCxnSpPr>
              <p:spPr>
                <a:xfrm flipH="1">
                  <a:off x="4989753" y="924917"/>
                  <a:ext cx="48288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線コネクタ 64"/>
                <p:cNvCxnSpPr/>
                <p:nvPr/>
              </p:nvCxnSpPr>
              <p:spPr>
                <a:xfrm flipH="1" flipV="1">
                  <a:off x="4989753" y="924917"/>
                  <a:ext cx="0" cy="143996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8" name="テキスト ボックス 67"/>
            <p:cNvSpPr txBox="1"/>
            <p:nvPr/>
          </p:nvSpPr>
          <p:spPr>
            <a:xfrm>
              <a:off x="7304962" y="635218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73" name="図形グループ 72"/>
            <p:cNvGrpSpPr/>
            <p:nvPr/>
          </p:nvGrpSpPr>
          <p:grpSpPr>
            <a:xfrm>
              <a:off x="6632" y="116632"/>
              <a:ext cx="626963" cy="2431762"/>
              <a:chOff x="6632" y="116632"/>
              <a:chExt cx="626963" cy="2431762"/>
            </a:xfrm>
          </p:grpSpPr>
          <p:sp>
            <p:nvSpPr>
              <p:cNvPr id="69" name="二等辺三角形 68"/>
              <p:cNvSpPr/>
              <p:nvPr/>
            </p:nvSpPr>
            <p:spPr>
              <a:xfrm flipV="1">
                <a:off x="303801" y="404664"/>
                <a:ext cx="158428" cy="1836886"/>
              </a:xfrm>
              <a:prstGeom prst="triangle">
                <a:avLst/>
              </a:prstGeom>
              <a:effectLst/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0" name="テキスト ボックス 69"/>
              <p:cNvSpPr txBox="1"/>
              <p:nvPr/>
            </p:nvSpPr>
            <p:spPr>
              <a:xfrm rot="16200000">
                <a:off x="-525860" y="1184608"/>
                <a:ext cx="13419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/>
                    <a:cs typeface="Arial"/>
                  </a:rPr>
                  <a:t>Tissue specificity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1" name="テキスト ボックス 70"/>
              <p:cNvSpPr txBox="1"/>
              <p:nvPr/>
            </p:nvSpPr>
            <p:spPr>
              <a:xfrm>
                <a:off x="132436" y="116632"/>
                <a:ext cx="501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/>
                    <a:cs typeface="Arial"/>
                  </a:rPr>
                  <a:t>High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2" name="テキスト ボックス 71"/>
              <p:cNvSpPr txBox="1"/>
              <p:nvPr/>
            </p:nvSpPr>
            <p:spPr>
              <a:xfrm>
                <a:off x="149530" y="2271395"/>
                <a:ext cx="466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/>
                    <a:cs typeface="Arial"/>
                  </a:rPr>
                  <a:t>Low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74" name="図形グループ 73"/>
            <p:cNvGrpSpPr/>
            <p:nvPr/>
          </p:nvGrpSpPr>
          <p:grpSpPr>
            <a:xfrm>
              <a:off x="8250" y="3239766"/>
              <a:ext cx="626963" cy="2431762"/>
              <a:chOff x="6632" y="116632"/>
              <a:chExt cx="626963" cy="2431762"/>
            </a:xfrm>
          </p:grpSpPr>
          <p:sp>
            <p:nvSpPr>
              <p:cNvPr id="75" name="二等辺三角形 74"/>
              <p:cNvSpPr/>
              <p:nvPr/>
            </p:nvSpPr>
            <p:spPr>
              <a:xfrm flipV="1">
                <a:off x="303801" y="404664"/>
                <a:ext cx="158428" cy="1836886"/>
              </a:xfrm>
              <a:prstGeom prst="triangle">
                <a:avLst/>
              </a:prstGeom>
              <a:effectLst/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6" name="テキスト ボックス 75"/>
              <p:cNvSpPr txBox="1"/>
              <p:nvPr/>
            </p:nvSpPr>
            <p:spPr>
              <a:xfrm rot="16200000">
                <a:off x="-525860" y="1184608"/>
                <a:ext cx="13419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/>
                    <a:cs typeface="Arial"/>
                  </a:rPr>
                  <a:t>Tissue specificity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>
                <a:off x="132436" y="116632"/>
                <a:ext cx="501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/>
                    <a:cs typeface="Arial"/>
                  </a:rPr>
                  <a:t>High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8" name="テキスト ボックス 77"/>
              <p:cNvSpPr txBox="1"/>
              <p:nvPr/>
            </p:nvSpPr>
            <p:spPr>
              <a:xfrm>
                <a:off x="149530" y="2271395"/>
                <a:ext cx="466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/>
                    <a:cs typeface="Arial"/>
                  </a:rPr>
                  <a:t>Low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</p:grpSp>
        <p:sp>
          <p:nvSpPr>
            <p:cNvPr id="79" name="テキスト ボックス 78"/>
            <p:cNvSpPr txBox="1"/>
            <p:nvPr/>
          </p:nvSpPr>
          <p:spPr>
            <a:xfrm rot="16200000">
              <a:off x="3449432" y="429397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 rot="16200000">
              <a:off x="3769048" y="445907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 rot="16200000">
              <a:off x="4718231" y="437017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 rot="16200000">
              <a:off x="5035731" y="437017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 rot="16200000">
              <a:off x="5988231" y="447177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 rot="16200000">
              <a:off x="6293031" y="438287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*</a:t>
              </a:r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graphicFrame>
          <p:nvGraphicFramePr>
            <p:cNvPr id="87" name="グラフ 8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3504511"/>
                </p:ext>
              </p:extLst>
            </p:nvPr>
          </p:nvGraphicFramePr>
          <p:xfrm>
            <a:off x="326436" y="3403600"/>
            <a:ext cx="8636000" cy="2889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85" name="テキスト ボックス 84"/>
          <p:cNvSpPr txBox="1"/>
          <p:nvPr/>
        </p:nvSpPr>
        <p:spPr>
          <a:xfrm>
            <a:off x="2677445" y="175274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3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3624689" y="175274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5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4584633" y="175274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69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1646180" y="175274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265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5481077" y="175274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10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6499642" y="175274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9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7459586" y="175274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5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8381430" y="175274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984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1367428" y="3272058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391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2005587" y="3272058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293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2643746" y="3272058"/>
            <a:ext cx="5353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112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3272387" y="3272058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202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3961346" y="3272058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83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4528184" y="3272058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25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5229843" y="3272058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56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5809381" y="3272058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193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6434840" y="3272058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14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6958699" y="3272058"/>
            <a:ext cx="6517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1,349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7614908" y="3272058"/>
            <a:ext cx="6517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1,77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8372718" y="3272058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n</a:t>
            </a:r>
            <a:r>
              <a:rPr kumimoji="1" lang="en-US" altLang="ja-JP" sz="1000" dirty="0" smtClean="0">
                <a:latin typeface="Arial"/>
                <a:cs typeface="Arial"/>
              </a:rPr>
              <a:t>=57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419964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図形グループ 12"/>
          <p:cNvGrpSpPr/>
          <p:nvPr/>
        </p:nvGrpSpPr>
        <p:grpSpPr>
          <a:xfrm>
            <a:off x="2674340" y="1046081"/>
            <a:ext cx="322610" cy="322610"/>
            <a:chOff x="2483768" y="1190402"/>
            <a:chExt cx="322610" cy="322610"/>
          </a:xfrm>
        </p:grpSpPr>
        <p:cxnSp>
          <p:nvCxnSpPr>
            <p:cNvPr id="9" name="直線コネクタ 8"/>
            <p:cNvCxnSpPr/>
            <p:nvPr/>
          </p:nvCxnSpPr>
          <p:spPr>
            <a:xfrm flipV="1">
              <a:off x="2806378" y="1190402"/>
              <a:ext cx="0" cy="14260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" name="図形グループ 11"/>
            <p:cNvGrpSpPr/>
            <p:nvPr/>
          </p:nvGrpSpPr>
          <p:grpSpPr>
            <a:xfrm>
              <a:off x="2483768" y="1190402"/>
              <a:ext cx="322610" cy="322610"/>
              <a:chOff x="2483768" y="1190402"/>
              <a:chExt cx="322610" cy="322610"/>
            </a:xfrm>
          </p:grpSpPr>
          <p:cxnSp>
            <p:nvCxnSpPr>
              <p:cNvPr id="7" name="直線コネクタ 6"/>
              <p:cNvCxnSpPr/>
              <p:nvPr/>
            </p:nvCxnSpPr>
            <p:spPr>
              <a:xfrm flipV="1">
                <a:off x="2483768" y="1190402"/>
                <a:ext cx="0" cy="322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/>
              <p:cNvCxnSpPr/>
              <p:nvPr/>
            </p:nvCxnSpPr>
            <p:spPr>
              <a:xfrm rot="5400000" flipV="1">
                <a:off x="2645073" y="1029097"/>
                <a:ext cx="0" cy="322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" name="テキスト ボックス 10"/>
          <p:cNvSpPr txBox="1"/>
          <p:nvPr/>
        </p:nvSpPr>
        <p:spPr>
          <a:xfrm>
            <a:off x="2713576" y="794482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grpSp>
        <p:nvGrpSpPr>
          <p:cNvPr id="14" name="図形グループ 13"/>
          <p:cNvGrpSpPr/>
          <p:nvPr/>
        </p:nvGrpSpPr>
        <p:grpSpPr>
          <a:xfrm>
            <a:off x="6927451" y="1472631"/>
            <a:ext cx="322610" cy="214609"/>
            <a:chOff x="2483768" y="1253903"/>
            <a:chExt cx="322610" cy="214609"/>
          </a:xfrm>
        </p:grpSpPr>
        <p:cxnSp>
          <p:nvCxnSpPr>
            <p:cNvPr id="15" name="直線コネクタ 14"/>
            <p:cNvCxnSpPr/>
            <p:nvPr/>
          </p:nvCxnSpPr>
          <p:spPr>
            <a:xfrm flipV="1">
              <a:off x="2806378" y="1253903"/>
              <a:ext cx="0" cy="14260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" name="図形グループ 15"/>
            <p:cNvGrpSpPr/>
            <p:nvPr/>
          </p:nvGrpSpPr>
          <p:grpSpPr>
            <a:xfrm>
              <a:off x="2483768" y="1253903"/>
              <a:ext cx="322610" cy="214609"/>
              <a:chOff x="2483768" y="1253903"/>
              <a:chExt cx="322610" cy="214609"/>
            </a:xfrm>
          </p:grpSpPr>
          <p:cxnSp>
            <p:nvCxnSpPr>
              <p:cNvPr id="17" name="直線コネクタ 16"/>
              <p:cNvCxnSpPr/>
              <p:nvPr/>
            </p:nvCxnSpPr>
            <p:spPr>
              <a:xfrm flipV="1">
                <a:off x="2483768" y="1253903"/>
                <a:ext cx="0" cy="21460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線コネクタ 17"/>
              <p:cNvCxnSpPr/>
              <p:nvPr/>
            </p:nvCxnSpPr>
            <p:spPr>
              <a:xfrm rot="5400000" flipV="1">
                <a:off x="2645073" y="1092598"/>
                <a:ext cx="0" cy="322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9" name="テキスト ボックス 18"/>
          <p:cNvSpPr txBox="1"/>
          <p:nvPr/>
        </p:nvSpPr>
        <p:spPr>
          <a:xfrm>
            <a:off x="6906025" y="1230333"/>
            <a:ext cx="39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Arial"/>
                <a:cs typeface="Arial"/>
              </a:rPr>
              <a:t>n.s</a:t>
            </a:r>
            <a:r>
              <a:rPr lang="en-US" altLang="ja-JP" sz="1000" dirty="0">
                <a:latin typeface="Arial"/>
                <a:cs typeface="Arial"/>
              </a:rPr>
              <a:t>.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grpSp>
        <p:nvGrpSpPr>
          <p:cNvPr id="20" name="図形グループ 19"/>
          <p:cNvGrpSpPr/>
          <p:nvPr/>
        </p:nvGrpSpPr>
        <p:grpSpPr>
          <a:xfrm>
            <a:off x="3277590" y="948276"/>
            <a:ext cx="273546" cy="394609"/>
            <a:chOff x="2483768" y="1190402"/>
            <a:chExt cx="322610" cy="394609"/>
          </a:xfrm>
        </p:grpSpPr>
        <p:cxnSp>
          <p:nvCxnSpPr>
            <p:cNvPr id="21" name="直線コネクタ 20"/>
            <p:cNvCxnSpPr/>
            <p:nvPr/>
          </p:nvCxnSpPr>
          <p:spPr>
            <a:xfrm flipV="1">
              <a:off x="2806378" y="1190402"/>
              <a:ext cx="0" cy="14260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" name="図形グループ 21"/>
            <p:cNvGrpSpPr/>
            <p:nvPr/>
          </p:nvGrpSpPr>
          <p:grpSpPr>
            <a:xfrm>
              <a:off x="2483768" y="1190402"/>
              <a:ext cx="322610" cy="394609"/>
              <a:chOff x="2483768" y="1190402"/>
              <a:chExt cx="322610" cy="394609"/>
            </a:xfrm>
          </p:grpSpPr>
          <p:cxnSp>
            <p:nvCxnSpPr>
              <p:cNvPr id="23" name="直線コネクタ 22"/>
              <p:cNvCxnSpPr/>
              <p:nvPr/>
            </p:nvCxnSpPr>
            <p:spPr>
              <a:xfrm flipV="1">
                <a:off x="2483768" y="1190402"/>
                <a:ext cx="0" cy="39460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線コネクタ 23"/>
              <p:cNvCxnSpPr/>
              <p:nvPr/>
            </p:nvCxnSpPr>
            <p:spPr>
              <a:xfrm rot="5400000" flipV="1">
                <a:off x="2645073" y="1029097"/>
                <a:ext cx="0" cy="322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" name="図形グループ 34"/>
          <p:cNvGrpSpPr/>
          <p:nvPr/>
        </p:nvGrpSpPr>
        <p:grpSpPr>
          <a:xfrm>
            <a:off x="3620490" y="744621"/>
            <a:ext cx="273546" cy="358609"/>
            <a:chOff x="2483768" y="1222152"/>
            <a:chExt cx="322610" cy="358609"/>
          </a:xfrm>
        </p:grpSpPr>
        <p:cxnSp>
          <p:nvCxnSpPr>
            <p:cNvPr id="36" name="直線コネクタ 35"/>
            <p:cNvCxnSpPr/>
            <p:nvPr/>
          </p:nvCxnSpPr>
          <p:spPr>
            <a:xfrm flipV="1">
              <a:off x="2806378" y="1234852"/>
              <a:ext cx="0" cy="14260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7" name="図形グループ 36"/>
            <p:cNvGrpSpPr/>
            <p:nvPr/>
          </p:nvGrpSpPr>
          <p:grpSpPr>
            <a:xfrm>
              <a:off x="2483768" y="1222152"/>
              <a:ext cx="322610" cy="358609"/>
              <a:chOff x="2483768" y="1222152"/>
              <a:chExt cx="322610" cy="358609"/>
            </a:xfrm>
          </p:grpSpPr>
          <p:cxnSp>
            <p:nvCxnSpPr>
              <p:cNvPr id="38" name="直線コネクタ 37"/>
              <p:cNvCxnSpPr/>
              <p:nvPr/>
            </p:nvCxnSpPr>
            <p:spPr>
              <a:xfrm flipV="1">
                <a:off x="2483768" y="1222152"/>
                <a:ext cx="0" cy="35860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線コネクタ 38"/>
              <p:cNvCxnSpPr/>
              <p:nvPr/>
            </p:nvCxnSpPr>
            <p:spPr>
              <a:xfrm rot="5400000" flipV="1">
                <a:off x="2645073" y="1073547"/>
                <a:ext cx="0" cy="322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0" name="テキスト ボックス 39"/>
          <p:cNvSpPr txBox="1"/>
          <p:nvPr/>
        </p:nvSpPr>
        <p:spPr>
          <a:xfrm>
            <a:off x="3229124" y="702055"/>
            <a:ext cx="39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Arial"/>
                <a:cs typeface="Arial"/>
              </a:rPr>
              <a:t>n.s</a:t>
            </a:r>
            <a:r>
              <a:rPr lang="en-US" altLang="ja-JP" sz="1000" dirty="0">
                <a:latin typeface="Arial"/>
                <a:cs typeface="Arial"/>
              </a:rPr>
              <a:t>.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570186" y="500226"/>
            <a:ext cx="39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Arial"/>
                <a:cs typeface="Arial"/>
              </a:rPr>
              <a:t>n.s</a:t>
            </a:r>
            <a:r>
              <a:rPr lang="en-US" altLang="ja-JP" sz="1000" dirty="0">
                <a:latin typeface="Arial"/>
                <a:cs typeface="Arial"/>
              </a:rPr>
              <a:t>.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grpSp>
        <p:nvGrpSpPr>
          <p:cNvPr id="42" name="図形グループ 41"/>
          <p:cNvGrpSpPr/>
          <p:nvPr/>
        </p:nvGrpSpPr>
        <p:grpSpPr>
          <a:xfrm>
            <a:off x="7545954" y="1478505"/>
            <a:ext cx="272724" cy="286609"/>
            <a:chOff x="2483768" y="1292002"/>
            <a:chExt cx="322610" cy="286609"/>
          </a:xfrm>
        </p:grpSpPr>
        <p:cxnSp>
          <p:nvCxnSpPr>
            <p:cNvPr id="43" name="直線コネクタ 42"/>
            <p:cNvCxnSpPr/>
            <p:nvPr/>
          </p:nvCxnSpPr>
          <p:spPr>
            <a:xfrm flipV="1">
              <a:off x="2806378" y="1304702"/>
              <a:ext cx="0" cy="14260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4" name="図形グループ 43"/>
            <p:cNvGrpSpPr/>
            <p:nvPr/>
          </p:nvGrpSpPr>
          <p:grpSpPr>
            <a:xfrm>
              <a:off x="2483768" y="1292002"/>
              <a:ext cx="322610" cy="286609"/>
              <a:chOff x="2483768" y="1292002"/>
              <a:chExt cx="322610" cy="286609"/>
            </a:xfrm>
          </p:grpSpPr>
          <p:cxnSp>
            <p:nvCxnSpPr>
              <p:cNvPr id="45" name="直線コネクタ 44"/>
              <p:cNvCxnSpPr/>
              <p:nvPr/>
            </p:nvCxnSpPr>
            <p:spPr>
              <a:xfrm flipV="1">
                <a:off x="2483768" y="1292002"/>
                <a:ext cx="0" cy="28660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線コネクタ 45"/>
              <p:cNvCxnSpPr/>
              <p:nvPr/>
            </p:nvCxnSpPr>
            <p:spPr>
              <a:xfrm rot="5400000" flipV="1">
                <a:off x="2645073" y="1143397"/>
                <a:ext cx="0" cy="322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7" name="テキスト ボックス 46"/>
          <p:cNvSpPr txBox="1"/>
          <p:nvPr/>
        </p:nvSpPr>
        <p:spPr>
          <a:xfrm>
            <a:off x="7486633" y="1245650"/>
            <a:ext cx="39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Arial"/>
                <a:cs typeface="Arial"/>
              </a:rPr>
              <a:t>n.s</a:t>
            </a:r>
            <a:r>
              <a:rPr lang="en-US" altLang="ja-JP" sz="1000" dirty="0">
                <a:latin typeface="Arial"/>
                <a:cs typeface="Arial"/>
              </a:rPr>
              <a:t>.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grpSp>
        <p:nvGrpSpPr>
          <p:cNvPr id="48" name="図形グループ 47"/>
          <p:cNvGrpSpPr/>
          <p:nvPr/>
        </p:nvGrpSpPr>
        <p:grpSpPr>
          <a:xfrm>
            <a:off x="7887739" y="1293967"/>
            <a:ext cx="269976" cy="345909"/>
            <a:chOff x="2483768" y="1222152"/>
            <a:chExt cx="322610" cy="358609"/>
          </a:xfrm>
        </p:grpSpPr>
        <p:cxnSp>
          <p:nvCxnSpPr>
            <p:cNvPr id="49" name="直線コネクタ 48"/>
            <p:cNvCxnSpPr/>
            <p:nvPr/>
          </p:nvCxnSpPr>
          <p:spPr>
            <a:xfrm flipV="1">
              <a:off x="2806378" y="1234852"/>
              <a:ext cx="0" cy="14260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0" name="図形グループ 49"/>
            <p:cNvGrpSpPr/>
            <p:nvPr/>
          </p:nvGrpSpPr>
          <p:grpSpPr>
            <a:xfrm>
              <a:off x="2483768" y="1222152"/>
              <a:ext cx="322610" cy="358609"/>
              <a:chOff x="2483768" y="1222152"/>
              <a:chExt cx="322610" cy="358609"/>
            </a:xfrm>
          </p:grpSpPr>
          <p:cxnSp>
            <p:nvCxnSpPr>
              <p:cNvPr id="51" name="直線コネクタ 50"/>
              <p:cNvCxnSpPr/>
              <p:nvPr/>
            </p:nvCxnSpPr>
            <p:spPr>
              <a:xfrm flipV="1">
                <a:off x="2483768" y="1222152"/>
                <a:ext cx="0" cy="35860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/>
              <p:cNvCxnSpPr/>
              <p:nvPr/>
            </p:nvCxnSpPr>
            <p:spPr>
              <a:xfrm rot="5400000" flipV="1">
                <a:off x="2645073" y="1073547"/>
                <a:ext cx="0" cy="3226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3" name="テキスト ボックス 52"/>
          <p:cNvSpPr txBox="1"/>
          <p:nvPr/>
        </p:nvSpPr>
        <p:spPr>
          <a:xfrm>
            <a:off x="7827044" y="1047746"/>
            <a:ext cx="39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Arial"/>
                <a:cs typeface="Arial"/>
              </a:rPr>
              <a:t>n.s</a:t>
            </a:r>
            <a:r>
              <a:rPr lang="en-US" altLang="ja-JP" sz="1000" dirty="0">
                <a:latin typeface="Arial"/>
                <a:cs typeface="Arial"/>
              </a:rPr>
              <a:t>.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2640324" y="228967"/>
            <a:ext cx="894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RJKB-T23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6960570" y="228967"/>
            <a:ext cx="894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RJKB-T24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4" name="正方形/長方形 53"/>
          <p:cNvSpPr/>
          <p:nvPr/>
        </p:nvSpPr>
        <p:spPr>
          <a:xfrm>
            <a:off x="176030" y="5612793"/>
            <a:ext cx="865123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S11.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Comparison of the average mutation rate (SNPs per length) in each gene having a H3K27me3 mark in RJKB-T23 and RJKB-T24.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‘n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. s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’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represents no significant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difference. Values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are means ± standard error (</a:t>
            </a:r>
            <a:r>
              <a:rPr lang="en-US" altLang="ja-JP" sz="1200" dirty="0" err="1">
                <a:solidFill>
                  <a:srgbClr val="000000"/>
                </a:solidFill>
                <a:latin typeface="Arial"/>
                <a:cs typeface="Arial"/>
              </a:rPr>
              <a:t>s.e.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)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of SNP numbers per length.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*, </a:t>
            </a: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&lt; 0.05 (Student </a:t>
            </a: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t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-test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). ‘K27+’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and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‘K27*’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represent the H3K27me3-marked genes and H3K27me3 stably marked genes, respectively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K27+ in both lines (n=10,456), K27* (n=7,930), Species-conserved (n=4,368), Br-specific (n=4,224), Paralogous-conserved (n=2,715), Copy-specific (n=1,200), Pair of copy-specific genes without H3K27me3 (n=1,462), Total (n=35,198)</a:t>
            </a:r>
            <a:endParaRPr lang="ja-JP" altLang="ja-JP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aphicFrame>
        <p:nvGraphicFramePr>
          <p:cNvPr id="58" name="グラフ 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7556316"/>
              </p:ext>
            </p:extLst>
          </p:nvPr>
        </p:nvGraphicFramePr>
        <p:xfrm>
          <a:off x="313049" y="580507"/>
          <a:ext cx="4188597" cy="49657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9" name="グラフ 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965230"/>
              </p:ext>
            </p:extLst>
          </p:nvPr>
        </p:nvGraphicFramePr>
        <p:xfrm>
          <a:off x="4558527" y="580507"/>
          <a:ext cx="4200768" cy="49712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403871537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0841623"/>
              </p:ext>
            </p:extLst>
          </p:nvPr>
        </p:nvGraphicFramePr>
        <p:xfrm>
          <a:off x="786961" y="0"/>
          <a:ext cx="2535814" cy="1833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1382487"/>
              </p:ext>
            </p:extLst>
          </p:nvPr>
        </p:nvGraphicFramePr>
        <p:xfrm>
          <a:off x="3623743" y="3777478"/>
          <a:ext cx="2535814" cy="1833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3505268"/>
              </p:ext>
            </p:extLst>
          </p:nvPr>
        </p:nvGraphicFramePr>
        <p:xfrm>
          <a:off x="786961" y="3777478"/>
          <a:ext cx="2535814" cy="1833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8032605"/>
              </p:ext>
            </p:extLst>
          </p:nvPr>
        </p:nvGraphicFramePr>
        <p:xfrm>
          <a:off x="3623743" y="0"/>
          <a:ext cx="2535814" cy="1833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0389886"/>
              </p:ext>
            </p:extLst>
          </p:nvPr>
        </p:nvGraphicFramePr>
        <p:xfrm>
          <a:off x="786961" y="1947721"/>
          <a:ext cx="2535814" cy="1833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8350408"/>
              </p:ext>
            </p:extLst>
          </p:nvPr>
        </p:nvGraphicFramePr>
        <p:xfrm>
          <a:off x="3623743" y="1947721"/>
          <a:ext cx="2535814" cy="1833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1750796"/>
              </p:ext>
            </p:extLst>
          </p:nvPr>
        </p:nvGraphicFramePr>
        <p:xfrm>
          <a:off x="6379636" y="3777478"/>
          <a:ext cx="2535814" cy="1815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9" name="正方形/長方形 18"/>
          <p:cNvSpPr/>
          <p:nvPr/>
        </p:nvSpPr>
        <p:spPr>
          <a:xfrm>
            <a:off x="123193" y="5694839"/>
            <a:ext cx="889761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S12.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Expression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analysis by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qPCR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with and without vernalization treatment. Bar graph represents the level of expression among four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FLC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paralogs,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MAF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VIN3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SOC1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and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FT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2d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-C, 2-day cotyledons; 14d-L,14-day leaves; BrV1, seeds were treated for four weeks at 4°C (vernalization); BrV2, seeds were treated for four weeks at 4°C and plants were transferred to the normal growth conditions for 12 days after vernalization. Expression level of each gene relative to </a:t>
            </a:r>
            <a:r>
              <a:rPr lang="en-US" altLang="ja-JP" sz="1200" i="1" dirty="0" err="1" smtClean="0">
                <a:solidFill>
                  <a:srgbClr val="000000"/>
                </a:solidFill>
                <a:latin typeface="Arial"/>
                <a:cs typeface="Arial"/>
              </a:rPr>
              <a:t>BrACTIN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is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calculated, and the y-axis shows the ratio against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2d-C.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Data presented are the average and standard error (</a:t>
            </a:r>
            <a:r>
              <a:rPr lang="en-US" altLang="ja-JP" sz="1200" dirty="0" err="1">
                <a:solidFill>
                  <a:srgbClr val="000000"/>
                </a:solidFill>
                <a:latin typeface="Arial"/>
                <a:cs typeface="Arial"/>
              </a:rPr>
              <a:t>s.e.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) from three biological and experimental replications. </a:t>
            </a:r>
            <a:endParaRPr lang="ja-JP" altLang="ja-JP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214106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1561048" y="251675"/>
            <a:ext cx="6021905" cy="5823085"/>
            <a:chOff x="1024307" y="251675"/>
            <a:chExt cx="6810758" cy="6585893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29153" y="251675"/>
              <a:ext cx="5868144" cy="2663829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19672" y="3240870"/>
              <a:ext cx="6033653" cy="3252132"/>
            </a:xfrm>
            <a:prstGeom prst="rect">
              <a:avLst/>
            </a:prstGeom>
          </p:spPr>
        </p:pic>
        <p:grpSp>
          <p:nvGrpSpPr>
            <p:cNvPr id="6" name="図形グループ 5"/>
            <p:cNvGrpSpPr/>
            <p:nvPr/>
          </p:nvGrpSpPr>
          <p:grpSpPr>
            <a:xfrm>
              <a:off x="7359529" y="2894477"/>
              <a:ext cx="475536" cy="276999"/>
              <a:chOff x="7783053" y="3792665"/>
              <a:chExt cx="475536" cy="276999"/>
            </a:xfrm>
          </p:grpSpPr>
          <p:cxnSp>
            <p:nvCxnSpPr>
              <p:cNvPr id="7" name="直線コネクタ 6"/>
              <p:cNvCxnSpPr/>
              <p:nvPr/>
            </p:nvCxnSpPr>
            <p:spPr>
              <a:xfrm>
                <a:off x="7822821" y="3794730"/>
                <a:ext cx="396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テキスト ボックス 7"/>
              <p:cNvSpPr txBox="1"/>
              <p:nvPr/>
            </p:nvSpPr>
            <p:spPr>
              <a:xfrm>
                <a:off x="7783053" y="3792665"/>
                <a:ext cx="4755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1 kb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</p:grpSp>
        <p:sp>
          <p:nvSpPr>
            <p:cNvPr id="9" name="テキスト ボックス 8"/>
            <p:cNvSpPr txBox="1"/>
            <p:nvPr/>
          </p:nvSpPr>
          <p:spPr>
            <a:xfrm>
              <a:off x="1024307" y="273540"/>
              <a:ext cx="573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2d-C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024307" y="855787"/>
              <a:ext cx="6463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14d-L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024307" y="1545495"/>
              <a:ext cx="5838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BrV1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024307" y="2157048"/>
              <a:ext cx="5838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BrV2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747807" y="2847121"/>
              <a:ext cx="1060482" cy="5221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06051</a:t>
              </a:r>
            </a:p>
            <a:p>
              <a:r>
                <a:rPr kumimoji="1" lang="en-US" altLang="ja-JP" sz="1200" dirty="0" smtClean="0">
                  <a:latin typeface="Arial"/>
                  <a:cs typeface="Arial"/>
                </a:rPr>
                <a:t>(</a:t>
              </a:r>
              <a:r>
                <a:rPr kumimoji="1" lang="en-US" altLang="ja-JP" sz="1200" i="1" dirty="0" smtClean="0">
                  <a:latin typeface="Arial"/>
                  <a:cs typeface="Arial"/>
                </a:rPr>
                <a:t>BrFLC3</a:t>
              </a:r>
              <a:r>
                <a:rPr kumimoji="1" lang="en-US" altLang="ja-JP" sz="1200" dirty="0" smtClean="0">
                  <a:latin typeface="Arial"/>
                  <a:cs typeface="Arial"/>
                </a:rPr>
                <a:t>)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691516" y="2847121"/>
              <a:ext cx="937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06050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15" name="直線矢印コネクタ 14"/>
            <p:cNvCxnSpPr/>
            <p:nvPr/>
          </p:nvCxnSpPr>
          <p:spPr>
            <a:xfrm>
              <a:off x="3746251" y="2601407"/>
              <a:ext cx="862613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/>
            <p:cNvSpPr txBox="1"/>
            <p:nvPr/>
          </p:nvSpPr>
          <p:spPr>
            <a:xfrm>
              <a:off x="1024307" y="3786557"/>
              <a:ext cx="573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2d-C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024307" y="4368804"/>
              <a:ext cx="6463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14d-L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024307" y="5058512"/>
              <a:ext cx="5838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BrV1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024307" y="5670065"/>
              <a:ext cx="5838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BrV2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grpSp>
          <p:nvGrpSpPr>
            <p:cNvPr id="20" name="図形グループ 19"/>
            <p:cNvGrpSpPr/>
            <p:nvPr/>
          </p:nvGrpSpPr>
          <p:grpSpPr>
            <a:xfrm>
              <a:off x="7313929" y="6333231"/>
              <a:ext cx="475536" cy="276999"/>
              <a:chOff x="7783053" y="3792665"/>
              <a:chExt cx="475536" cy="276999"/>
            </a:xfrm>
          </p:grpSpPr>
          <p:cxnSp>
            <p:nvCxnSpPr>
              <p:cNvPr id="21" name="直線コネクタ 20"/>
              <p:cNvCxnSpPr/>
              <p:nvPr/>
            </p:nvCxnSpPr>
            <p:spPr>
              <a:xfrm>
                <a:off x="7822821" y="3794730"/>
                <a:ext cx="3960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テキスト ボックス 21"/>
              <p:cNvSpPr txBox="1"/>
              <p:nvPr/>
            </p:nvSpPr>
            <p:spPr>
              <a:xfrm>
                <a:off x="7783053" y="3792665"/>
                <a:ext cx="4755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1 kb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</p:grpSp>
        <p:sp>
          <p:nvSpPr>
            <p:cNvPr id="23" name="テキスト ボックス 22"/>
            <p:cNvSpPr txBox="1"/>
            <p:nvPr/>
          </p:nvSpPr>
          <p:spPr>
            <a:xfrm>
              <a:off x="3927535" y="6315426"/>
              <a:ext cx="1060482" cy="5221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09055</a:t>
              </a:r>
            </a:p>
            <a:p>
              <a:r>
                <a:rPr kumimoji="1" lang="en-US" altLang="ja-JP" sz="1200" dirty="0" smtClean="0">
                  <a:latin typeface="Arial"/>
                  <a:cs typeface="Arial"/>
                </a:rPr>
                <a:t>(</a:t>
              </a:r>
              <a:r>
                <a:rPr kumimoji="1" lang="en-US" altLang="ja-JP" sz="1200" i="1" dirty="0" smtClean="0">
                  <a:latin typeface="Arial"/>
                  <a:cs typeface="Arial"/>
                </a:rPr>
                <a:t>BrFLC1</a:t>
              </a:r>
              <a:r>
                <a:rPr kumimoji="1" lang="en-US" altLang="ja-JP" sz="1200" dirty="0" smtClean="0">
                  <a:latin typeface="Arial"/>
                  <a:cs typeface="Arial"/>
                </a:rPr>
                <a:t>)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24" name="直線矢印コネクタ 23"/>
            <p:cNvCxnSpPr/>
            <p:nvPr/>
          </p:nvCxnSpPr>
          <p:spPr>
            <a:xfrm>
              <a:off x="3714594" y="6128326"/>
              <a:ext cx="1402610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テキスト ボックス 24"/>
            <p:cNvSpPr txBox="1"/>
            <p:nvPr/>
          </p:nvSpPr>
          <p:spPr>
            <a:xfrm>
              <a:off x="5609630" y="6315426"/>
              <a:ext cx="937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09056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26" name="直線矢印コネクタ 25"/>
            <p:cNvCxnSpPr/>
            <p:nvPr/>
          </p:nvCxnSpPr>
          <p:spPr>
            <a:xfrm>
              <a:off x="5936688" y="6128326"/>
              <a:ext cx="322612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矢印コネクタ 26"/>
            <p:cNvCxnSpPr/>
            <p:nvPr/>
          </p:nvCxnSpPr>
          <p:spPr>
            <a:xfrm flipH="1">
              <a:off x="4766574" y="2601407"/>
              <a:ext cx="430613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正方形/長方形 64"/>
          <p:cNvSpPr/>
          <p:nvPr/>
        </p:nvSpPr>
        <p:spPr>
          <a:xfrm>
            <a:off x="68239" y="6017975"/>
            <a:ext cx="900752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13.</a:t>
            </a:r>
            <a:r>
              <a:rPr lang="en-US" altLang="ja-JP" sz="1200" dirty="0" smtClean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Visualization of H3K27me3 peaks by Integrative Genomics Viewer (IGV). 2d-C and 14d-L are non-vernalized samples and BrV1 and BrV2 are vernalized samples. 2d-C, 2-day cotyledons; 14d-L,14-day leaves; BrV1, seeds were treated for four weeks at 4°C (vernalization); BrV2, seeds were treated for four weeks at 4°C and plants were transferred to the normal growth conditions for 12 days after vernalization.</a:t>
            </a:r>
            <a:endParaRPr lang="ja-JP" altLang="ja-JP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921785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図形グループ 2"/>
          <p:cNvGrpSpPr/>
          <p:nvPr/>
        </p:nvGrpSpPr>
        <p:grpSpPr>
          <a:xfrm>
            <a:off x="474687" y="27495"/>
            <a:ext cx="8194626" cy="5800446"/>
            <a:chOff x="90004" y="27495"/>
            <a:chExt cx="8925304" cy="6317646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3955" y="140840"/>
              <a:ext cx="3757108" cy="2904108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0004" y="3326971"/>
              <a:ext cx="3995935" cy="2791377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10119" y="140840"/>
              <a:ext cx="4583800" cy="2841165"/>
            </a:xfrm>
            <a:prstGeom prst="rect">
              <a:avLst/>
            </a:prstGeom>
          </p:spPr>
        </p:pic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80119" y="3416647"/>
              <a:ext cx="4482361" cy="2700931"/>
            </a:xfrm>
            <a:prstGeom prst="rect">
              <a:avLst/>
            </a:prstGeom>
          </p:spPr>
        </p:pic>
        <p:cxnSp>
          <p:nvCxnSpPr>
            <p:cNvPr id="8" name="直線コネクタ 7"/>
            <p:cNvCxnSpPr/>
            <p:nvPr/>
          </p:nvCxnSpPr>
          <p:spPr>
            <a:xfrm>
              <a:off x="3476196" y="3044948"/>
              <a:ext cx="393756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テキスト ボックス 8"/>
            <p:cNvSpPr txBox="1"/>
            <p:nvPr/>
          </p:nvSpPr>
          <p:spPr>
            <a:xfrm>
              <a:off x="1437951" y="2894923"/>
              <a:ext cx="1807393" cy="3016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28599 (</a:t>
              </a:r>
              <a:r>
                <a:rPr lang="en-US" altLang="ja-JP" sz="1200" i="1" dirty="0" smtClean="0">
                  <a:latin typeface="Arial"/>
                  <a:cs typeface="Arial"/>
                </a:rPr>
                <a:t>BrFLC2</a:t>
              </a:r>
              <a:r>
                <a:rPr lang="en-US" altLang="ja-JP" sz="1200" dirty="0" smtClean="0">
                  <a:latin typeface="Arial"/>
                  <a:cs typeface="Arial"/>
                </a:rPr>
                <a:t>)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10" name="直線矢印コネクタ 9"/>
            <p:cNvCxnSpPr/>
            <p:nvPr/>
          </p:nvCxnSpPr>
          <p:spPr>
            <a:xfrm>
              <a:off x="1663449" y="2630577"/>
              <a:ext cx="1150610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3825063" y="6253814"/>
              <a:ext cx="25200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/>
            <p:cNvSpPr txBox="1"/>
            <p:nvPr/>
          </p:nvSpPr>
          <p:spPr>
            <a:xfrm>
              <a:off x="1347376" y="6043443"/>
              <a:ext cx="1807393" cy="3016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22771 (</a:t>
              </a:r>
              <a:r>
                <a:rPr lang="en-US" altLang="ja-JP" sz="1200" i="1" dirty="0" smtClean="0">
                  <a:latin typeface="Arial"/>
                  <a:cs typeface="Arial"/>
                </a:rPr>
                <a:t>BrFLC5</a:t>
              </a:r>
              <a:r>
                <a:rPr lang="en-US" altLang="ja-JP" sz="1200" dirty="0" smtClean="0">
                  <a:latin typeface="Arial"/>
                  <a:cs typeface="Arial"/>
                </a:rPr>
                <a:t>)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13" name="直線矢印コネクタ 12"/>
            <p:cNvCxnSpPr/>
            <p:nvPr/>
          </p:nvCxnSpPr>
          <p:spPr>
            <a:xfrm>
              <a:off x="1563210" y="5770582"/>
              <a:ext cx="1114610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/>
            <p:cNvCxnSpPr/>
            <p:nvPr/>
          </p:nvCxnSpPr>
          <p:spPr>
            <a:xfrm>
              <a:off x="8752046" y="3044948"/>
              <a:ext cx="18000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/>
            <p:cNvSpPr txBox="1"/>
            <p:nvPr/>
          </p:nvSpPr>
          <p:spPr>
            <a:xfrm>
              <a:off x="6007463" y="2894923"/>
              <a:ext cx="937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31888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16" name="直線矢印コネクタ 15"/>
            <p:cNvCxnSpPr/>
            <p:nvPr/>
          </p:nvCxnSpPr>
          <p:spPr>
            <a:xfrm>
              <a:off x="6142284" y="2630577"/>
              <a:ext cx="574610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>
              <a:off x="8835308" y="6253814"/>
              <a:ext cx="18000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矢印コネクタ 17"/>
            <p:cNvCxnSpPr/>
            <p:nvPr/>
          </p:nvCxnSpPr>
          <p:spPr>
            <a:xfrm>
              <a:off x="5678010" y="5770582"/>
              <a:ext cx="862610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矢印コネクタ 18"/>
            <p:cNvCxnSpPr/>
            <p:nvPr/>
          </p:nvCxnSpPr>
          <p:spPr>
            <a:xfrm>
              <a:off x="7100410" y="5770582"/>
              <a:ext cx="682610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/>
            <p:cNvSpPr txBox="1"/>
            <p:nvPr/>
          </p:nvSpPr>
          <p:spPr>
            <a:xfrm>
              <a:off x="5648057" y="6043443"/>
              <a:ext cx="937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24350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6978983" y="6043443"/>
              <a:ext cx="9376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a02435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143354" y="27495"/>
              <a:ext cx="5182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2d-C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143354" y="609742"/>
              <a:ext cx="5822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14d-L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143354" y="1299450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43354" y="1911003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2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43354" y="3172947"/>
              <a:ext cx="5182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2d-C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43354" y="3755194"/>
              <a:ext cx="5822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14d-L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43354" y="4444902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43354" y="5056455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2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4410119" y="41395"/>
              <a:ext cx="5182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2d-C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4410119" y="623642"/>
              <a:ext cx="5822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14d-L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4410119" y="1313350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4410119" y="1924903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2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4410119" y="3186847"/>
              <a:ext cx="5182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2d-C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4410119" y="3769094"/>
              <a:ext cx="5822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14d-L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4410119" y="4458802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4410119" y="5070355"/>
              <a:ext cx="52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BrV2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</p:grpSp>
      <p:sp>
        <p:nvSpPr>
          <p:cNvPr id="2" name="正方形/長方形 1"/>
          <p:cNvSpPr/>
          <p:nvPr/>
        </p:nvSpPr>
        <p:spPr>
          <a:xfrm>
            <a:off x="68239" y="6017975"/>
            <a:ext cx="900752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14.</a:t>
            </a:r>
            <a:r>
              <a:rPr lang="en-US" altLang="ja-JP" sz="1200" dirty="0" smtClean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Visualization of H3K27me3 peaks by Integrative Genomics Viewer (IGV). 2d-C and 14d-L are non-vernalized samples and BrV1 and BrV2 are vernalized samples. 2d-C, 2-day cotyledons; 14d-L,14-day leaves; BrV1, seeds were treated for 4 weeks at 4°C (vernalization); BrV2, seeds were treated for 4 weeks at 4°C and plants were transferred to the normal growth conditions for 12 days after vernalization. Bar represents 1 kb in length.</a:t>
            </a:r>
            <a:endParaRPr lang="ja-JP" altLang="ja-JP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0077000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2145131" y="499496"/>
            <a:ext cx="127672" cy="6662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/>
          <p:cNvSpPr/>
          <p:nvPr/>
        </p:nvSpPr>
        <p:spPr>
          <a:xfrm>
            <a:off x="2145131" y="1175863"/>
            <a:ext cx="127672" cy="7021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/>
          <p:cNvSpPr/>
          <p:nvPr/>
        </p:nvSpPr>
        <p:spPr>
          <a:xfrm>
            <a:off x="2145131" y="2123366"/>
            <a:ext cx="127672" cy="444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/>
          <p:cNvSpPr/>
          <p:nvPr/>
        </p:nvSpPr>
        <p:spPr>
          <a:xfrm>
            <a:off x="2145131" y="2583428"/>
            <a:ext cx="127672" cy="2530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2145131" y="2916094"/>
            <a:ext cx="127672" cy="5722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右矢印 8"/>
          <p:cNvSpPr/>
          <p:nvPr/>
        </p:nvSpPr>
        <p:spPr>
          <a:xfrm>
            <a:off x="1921083" y="3359092"/>
            <a:ext cx="229242" cy="129220"/>
          </a:xfrm>
          <a:prstGeom prst="rightArrow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950930" y="3206184"/>
            <a:ext cx="10316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 smtClean="0">
                <a:latin typeface="Arial"/>
                <a:cs typeface="Arial"/>
              </a:rPr>
              <a:t>AtMAF1 </a:t>
            </a:r>
          </a:p>
          <a:p>
            <a:pPr algn="ctr"/>
            <a:r>
              <a:rPr kumimoji="1" lang="en-US" altLang="ja-JP" sz="1200" dirty="0" smtClean="0">
                <a:latin typeface="Arial"/>
                <a:cs typeface="Arial"/>
              </a:rPr>
              <a:t>(At1g77080)</a:t>
            </a:r>
          </a:p>
        </p:txBody>
      </p:sp>
      <p:sp>
        <p:nvSpPr>
          <p:cNvPr id="11" name="右矢印 10"/>
          <p:cNvSpPr/>
          <p:nvPr/>
        </p:nvSpPr>
        <p:spPr>
          <a:xfrm>
            <a:off x="5069079" y="630004"/>
            <a:ext cx="229242" cy="129220"/>
          </a:xfrm>
          <a:prstGeom prst="rightArrow">
            <a:avLst/>
          </a:prstGeom>
          <a:solidFill>
            <a:schemeClr val="accent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140994" y="525602"/>
            <a:ext cx="10316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 smtClean="0">
                <a:latin typeface="Arial"/>
                <a:cs typeface="Arial"/>
              </a:rPr>
              <a:t>AtFLC</a:t>
            </a:r>
            <a:r>
              <a:rPr kumimoji="1" lang="en-US" altLang="ja-JP" sz="1200" dirty="0" smtClean="0">
                <a:latin typeface="Arial"/>
                <a:cs typeface="Arial"/>
              </a:rPr>
              <a:t> </a:t>
            </a:r>
          </a:p>
          <a:p>
            <a:pPr algn="ctr"/>
            <a:r>
              <a:rPr kumimoji="1" lang="en-US" altLang="ja-JP" sz="1200" dirty="0" smtClean="0">
                <a:latin typeface="Arial"/>
                <a:cs typeface="Arial"/>
              </a:rPr>
              <a:t>(At5g10140)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140993" y="2760530"/>
            <a:ext cx="10316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i="1" dirty="0" smtClean="0">
                <a:latin typeface="Arial"/>
                <a:cs typeface="Arial"/>
              </a:rPr>
              <a:t>AtMAF2</a:t>
            </a:r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r>
              <a:rPr kumimoji="1" lang="en-US" altLang="ja-JP" sz="1200" i="1" dirty="0" smtClean="0">
                <a:latin typeface="Arial"/>
                <a:cs typeface="Arial"/>
              </a:rPr>
              <a:t>5</a:t>
            </a:r>
            <a:r>
              <a:rPr kumimoji="1" lang="en-US" altLang="ja-JP" sz="1200" dirty="0" smtClean="0">
                <a:latin typeface="Arial"/>
                <a:cs typeface="Arial"/>
              </a:rPr>
              <a:t> </a:t>
            </a:r>
          </a:p>
          <a:p>
            <a:pPr algn="ctr"/>
            <a:r>
              <a:rPr kumimoji="1" lang="en-US" altLang="ja-JP" sz="1200" dirty="0" smtClean="0">
                <a:latin typeface="Arial"/>
                <a:cs typeface="Arial"/>
              </a:rPr>
              <a:t>(At5g65050</a:t>
            </a:r>
          </a:p>
          <a:p>
            <a:pPr algn="ctr"/>
            <a:r>
              <a:rPr kumimoji="1" lang="en-US" altLang="ja-JP" sz="1200" dirty="0" smtClean="0">
                <a:latin typeface="Arial"/>
                <a:cs typeface="Arial"/>
              </a:rPr>
              <a:t>-At5g65080)</a:t>
            </a:r>
          </a:p>
        </p:txBody>
      </p:sp>
      <p:sp>
        <p:nvSpPr>
          <p:cNvPr id="14" name="円/楕円 13"/>
          <p:cNvSpPr/>
          <p:nvPr/>
        </p:nvSpPr>
        <p:spPr>
          <a:xfrm>
            <a:off x="2141910" y="1918636"/>
            <a:ext cx="134114" cy="146491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906881" y="709813"/>
            <a:ext cx="266100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A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906881" y="1404166"/>
            <a:ext cx="254730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B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906881" y="2222844"/>
            <a:ext cx="266100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C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906881" y="2587152"/>
            <a:ext cx="262259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D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906881" y="3079408"/>
            <a:ext cx="262259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E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964050" y="231003"/>
            <a:ext cx="489835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Chr.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1" name="右矢印 20"/>
          <p:cNvSpPr/>
          <p:nvPr/>
        </p:nvSpPr>
        <p:spPr>
          <a:xfrm>
            <a:off x="5069079" y="3050298"/>
            <a:ext cx="229242" cy="129220"/>
          </a:xfrm>
          <a:prstGeom prst="rightArrow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/>
          <p:cNvSpPr/>
          <p:nvPr/>
        </p:nvSpPr>
        <p:spPr>
          <a:xfrm>
            <a:off x="5314501" y="499496"/>
            <a:ext cx="127672" cy="7341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/>
          <p:cNvSpPr/>
          <p:nvPr/>
        </p:nvSpPr>
        <p:spPr>
          <a:xfrm>
            <a:off x="5314501" y="1246878"/>
            <a:ext cx="127672" cy="3191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/>
          <p:cNvSpPr/>
          <p:nvPr/>
        </p:nvSpPr>
        <p:spPr>
          <a:xfrm>
            <a:off x="5314501" y="1737872"/>
            <a:ext cx="127672" cy="444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/>
          <p:cNvSpPr/>
          <p:nvPr/>
        </p:nvSpPr>
        <p:spPr>
          <a:xfrm>
            <a:off x="5314501" y="2210015"/>
            <a:ext cx="127672" cy="2530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/>
          <p:cNvSpPr/>
          <p:nvPr/>
        </p:nvSpPr>
        <p:spPr>
          <a:xfrm>
            <a:off x="5314501" y="2899979"/>
            <a:ext cx="127672" cy="3168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円/楕円 26"/>
          <p:cNvSpPr/>
          <p:nvPr/>
        </p:nvSpPr>
        <p:spPr>
          <a:xfrm>
            <a:off x="5311280" y="1578756"/>
            <a:ext cx="134114" cy="146491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5314501" y="2481093"/>
            <a:ext cx="127672" cy="412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9" name="図形グループ 28"/>
          <p:cNvGrpSpPr/>
          <p:nvPr/>
        </p:nvGrpSpPr>
        <p:grpSpPr>
          <a:xfrm>
            <a:off x="2512791" y="2606391"/>
            <a:ext cx="1401656" cy="879812"/>
            <a:chOff x="2512791" y="2606391"/>
            <a:chExt cx="1401656" cy="879812"/>
          </a:xfrm>
        </p:grpSpPr>
        <p:grpSp>
          <p:nvGrpSpPr>
            <p:cNvPr id="30" name="図形グループ 29"/>
            <p:cNvGrpSpPr/>
            <p:nvPr/>
          </p:nvGrpSpPr>
          <p:grpSpPr>
            <a:xfrm>
              <a:off x="2512791" y="2606391"/>
              <a:ext cx="417862" cy="879812"/>
              <a:chOff x="1700272" y="4319811"/>
              <a:chExt cx="471303" cy="992332"/>
            </a:xfrm>
          </p:grpSpPr>
          <p:sp>
            <p:nvSpPr>
              <p:cNvPr id="39" name="正方形/長方形 38"/>
              <p:cNvSpPr/>
              <p:nvPr/>
            </p:nvSpPr>
            <p:spPr>
              <a:xfrm>
                <a:off x="1876710" y="4666743"/>
                <a:ext cx="118427" cy="6454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>
                <a:off x="1700272" y="4850944"/>
                <a:ext cx="471303" cy="276999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BFBFBF"/>
                </a:solidFill>
              </a:ln>
              <a:effectLst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A07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1" name="テキスト ボックス 40"/>
              <p:cNvSpPr txBox="1"/>
              <p:nvPr/>
            </p:nvSpPr>
            <p:spPr>
              <a:xfrm>
                <a:off x="1753797" y="4319811"/>
                <a:ext cx="3642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LF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31" name="図形グループ 30"/>
            <p:cNvGrpSpPr/>
            <p:nvPr/>
          </p:nvGrpSpPr>
          <p:grpSpPr>
            <a:xfrm>
              <a:off x="2985945" y="2606391"/>
              <a:ext cx="436605" cy="879812"/>
              <a:chOff x="2082305" y="4319811"/>
              <a:chExt cx="492443" cy="992332"/>
            </a:xfrm>
          </p:grpSpPr>
          <p:sp>
            <p:nvSpPr>
              <p:cNvPr id="36" name="正方形/長方形 35"/>
              <p:cNvSpPr/>
              <p:nvPr/>
            </p:nvSpPr>
            <p:spPr>
              <a:xfrm>
                <a:off x="2269313" y="4666743"/>
                <a:ext cx="118427" cy="6454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2092875" y="4850944"/>
                <a:ext cx="471303" cy="276999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BFBFBF"/>
                </a:solidFill>
              </a:ln>
              <a:effectLst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A02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8" name="テキスト ボックス 37"/>
              <p:cNvSpPr txBox="1"/>
              <p:nvPr/>
            </p:nvSpPr>
            <p:spPr>
              <a:xfrm>
                <a:off x="2082305" y="4319811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MF1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32" name="図形グループ 31"/>
            <p:cNvGrpSpPr/>
            <p:nvPr/>
          </p:nvGrpSpPr>
          <p:grpSpPr>
            <a:xfrm>
              <a:off x="3477842" y="2606391"/>
              <a:ext cx="436605" cy="879812"/>
              <a:chOff x="2491020" y="4319811"/>
              <a:chExt cx="492443" cy="992332"/>
            </a:xfrm>
          </p:grpSpPr>
          <p:sp>
            <p:nvSpPr>
              <p:cNvPr id="33" name="正方形/長方形 32"/>
              <p:cNvSpPr/>
              <p:nvPr/>
            </p:nvSpPr>
            <p:spPr>
              <a:xfrm>
                <a:off x="2678028" y="4666743"/>
                <a:ext cx="118427" cy="6454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2501590" y="4850944"/>
                <a:ext cx="471303" cy="276999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BFBFBF"/>
                </a:solidFill>
              </a:ln>
              <a:effectLst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A07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2491020" y="4319811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MF2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</p:grpSp>
      </p:grpSp>
      <p:sp>
        <p:nvSpPr>
          <p:cNvPr id="42" name="テキスト ボックス 41"/>
          <p:cNvSpPr txBox="1"/>
          <p:nvPr/>
        </p:nvSpPr>
        <p:spPr>
          <a:xfrm>
            <a:off x="5026559" y="743758"/>
            <a:ext cx="266100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R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024682" y="1283672"/>
            <a:ext cx="269853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Q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026559" y="2213739"/>
            <a:ext cx="266100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V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5013357" y="2564612"/>
            <a:ext cx="292504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W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028480" y="2854686"/>
            <a:ext cx="262259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X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032243" y="1837350"/>
            <a:ext cx="254730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S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114157" y="231003"/>
            <a:ext cx="489835" cy="24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Chr.5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grpSp>
        <p:nvGrpSpPr>
          <p:cNvPr id="49" name="図形グループ 48"/>
          <p:cNvGrpSpPr/>
          <p:nvPr/>
        </p:nvGrpSpPr>
        <p:grpSpPr>
          <a:xfrm>
            <a:off x="5560122" y="247696"/>
            <a:ext cx="831332" cy="2935488"/>
            <a:chOff x="5416456" y="2223673"/>
            <a:chExt cx="937652" cy="3310909"/>
          </a:xfrm>
        </p:grpSpPr>
        <p:sp>
          <p:nvSpPr>
            <p:cNvPr id="50" name="正方形/長方形 49"/>
            <p:cNvSpPr/>
            <p:nvPr/>
          </p:nvSpPr>
          <p:spPr>
            <a:xfrm>
              <a:off x="5826069" y="2563778"/>
              <a:ext cx="118427" cy="8613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5703156" y="2223673"/>
              <a:ext cx="3642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LF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5665826" y="3011799"/>
              <a:ext cx="471303" cy="276999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>
                  <a:lumMod val="75000"/>
                </a:schemeClr>
              </a:solidFill>
            </a:ln>
            <a:effectLst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A10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53" name="正方形/長方形 52"/>
            <p:cNvSpPr/>
            <p:nvPr/>
          </p:nvSpPr>
          <p:spPr>
            <a:xfrm>
              <a:off x="5813282" y="5357188"/>
              <a:ext cx="144000" cy="1773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" name="ひし形 53"/>
            <p:cNvSpPr>
              <a:spLocks noChangeAspect="1"/>
            </p:cNvSpPr>
            <p:nvPr/>
          </p:nvSpPr>
          <p:spPr>
            <a:xfrm>
              <a:off x="5795282" y="2670956"/>
              <a:ext cx="180000" cy="180000"/>
            </a:xfrm>
            <a:prstGeom prst="diamond">
              <a:avLst/>
            </a:prstGeom>
            <a:solidFill>
              <a:schemeClr val="tx2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5416456" y="3489857"/>
              <a:ext cx="93765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0" i="0" u="none" strike="noStrike" dirty="0" smtClean="0">
                  <a:solidFill>
                    <a:srgbClr val="000000"/>
                  </a:solidFill>
                  <a:effectLst/>
                  <a:latin typeface="Arial"/>
                  <a:cs typeface="Arial"/>
                </a:rPr>
                <a:t>Bra009055</a:t>
              </a:r>
            </a:p>
            <a:p>
              <a:pPr algn="ctr"/>
              <a:r>
                <a:rPr lang="en-US" altLang="ja-JP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(</a:t>
              </a:r>
              <a:r>
                <a:rPr lang="en-US" altLang="ja-JP" sz="1200" i="1" dirty="0" smtClean="0">
                  <a:solidFill>
                    <a:srgbClr val="000000"/>
                  </a:solidFill>
                  <a:latin typeface="Arial"/>
                  <a:cs typeface="Arial"/>
                </a:rPr>
                <a:t>BrFLC1</a:t>
              </a:r>
              <a:r>
                <a:rPr lang="en-US" altLang="ja-JP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)</a:t>
              </a:r>
              <a:endParaRPr lang="en-US" altLang="ja-JP" sz="1200" b="0" i="0" u="none" strike="noStrike" dirty="0" smtClean="0"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5653126" y="5058276"/>
              <a:ext cx="4713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A06</a:t>
              </a:r>
            </a:p>
          </p:txBody>
        </p:sp>
      </p:grpSp>
      <p:grpSp>
        <p:nvGrpSpPr>
          <p:cNvPr id="57" name="図形グループ 56"/>
          <p:cNvGrpSpPr/>
          <p:nvPr/>
        </p:nvGrpSpPr>
        <p:grpSpPr>
          <a:xfrm>
            <a:off x="6387235" y="247696"/>
            <a:ext cx="831332" cy="2999323"/>
            <a:chOff x="6356814" y="2223673"/>
            <a:chExt cx="937652" cy="3382909"/>
          </a:xfrm>
        </p:grpSpPr>
        <p:sp>
          <p:nvSpPr>
            <p:cNvPr id="58" name="正方形/長方形 57"/>
            <p:cNvSpPr/>
            <p:nvPr/>
          </p:nvSpPr>
          <p:spPr>
            <a:xfrm>
              <a:off x="6766427" y="2563778"/>
              <a:ext cx="118427" cy="8613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6579419" y="222367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MF1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6589989" y="3011799"/>
              <a:ext cx="471303" cy="276999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>
                  <a:lumMod val="75000"/>
                </a:schemeClr>
              </a:solidFill>
            </a:ln>
            <a:effectLst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A03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61" name="正方形/長方形 60"/>
            <p:cNvSpPr/>
            <p:nvPr/>
          </p:nvSpPr>
          <p:spPr>
            <a:xfrm>
              <a:off x="6766427" y="5357188"/>
              <a:ext cx="118427" cy="2493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ひし形 61"/>
            <p:cNvSpPr>
              <a:spLocks noChangeAspect="1"/>
            </p:cNvSpPr>
            <p:nvPr/>
          </p:nvSpPr>
          <p:spPr>
            <a:xfrm>
              <a:off x="6735640" y="2670956"/>
              <a:ext cx="180000" cy="180000"/>
            </a:xfrm>
            <a:prstGeom prst="diamond">
              <a:avLst/>
            </a:prstGeom>
            <a:solidFill>
              <a:srgbClr val="1F497D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6356814" y="3489857"/>
              <a:ext cx="93765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0" i="0" u="none" strike="noStrike" dirty="0" smtClean="0">
                  <a:solidFill>
                    <a:srgbClr val="000000"/>
                  </a:solidFill>
                  <a:effectLst/>
                  <a:latin typeface="Arial"/>
                  <a:cs typeface="Arial"/>
                </a:rPr>
                <a:t>Bra006051</a:t>
              </a:r>
            </a:p>
            <a:p>
              <a:pPr algn="ctr"/>
              <a:r>
                <a:rPr lang="en-US" altLang="ja-JP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(</a:t>
              </a:r>
              <a:r>
                <a:rPr lang="en-US" altLang="ja-JP" sz="1200" i="1" dirty="0" smtClean="0">
                  <a:solidFill>
                    <a:srgbClr val="000000"/>
                  </a:solidFill>
                  <a:latin typeface="Arial"/>
                  <a:cs typeface="Arial"/>
                </a:rPr>
                <a:t>BrFLC3</a:t>
              </a:r>
              <a:r>
                <a:rPr lang="en-US" altLang="ja-JP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)</a:t>
              </a:r>
              <a:endParaRPr lang="en-US" altLang="ja-JP" sz="1200" b="0" i="0" u="none" strike="noStrike" dirty="0" smtClean="0"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6589989" y="5063892"/>
              <a:ext cx="4713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A09</a:t>
              </a:r>
            </a:p>
          </p:txBody>
        </p:sp>
      </p:grpSp>
      <p:grpSp>
        <p:nvGrpSpPr>
          <p:cNvPr id="65" name="図形グループ 64"/>
          <p:cNvGrpSpPr/>
          <p:nvPr/>
        </p:nvGrpSpPr>
        <p:grpSpPr>
          <a:xfrm>
            <a:off x="7214349" y="247696"/>
            <a:ext cx="831332" cy="2999323"/>
            <a:chOff x="7282243" y="2223673"/>
            <a:chExt cx="937652" cy="3382909"/>
          </a:xfrm>
        </p:grpSpPr>
        <p:sp>
          <p:nvSpPr>
            <p:cNvPr id="66" name="正方形/長方形 65"/>
            <p:cNvSpPr/>
            <p:nvPr/>
          </p:nvSpPr>
          <p:spPr>
            <a:xfrm>
              <a:off x="7691856" y="2563778"/>
              <a:ext cx="118427" cy="8613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7504848" y="222367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MF2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7515418" y="3011799"/>
              <a:ext cx="471303" cy="276999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>
                  <a:lumMod val="75000"/>
                </a:schemeClr>
              </a:solidFill>
            </a:ln>
            <a:effectLst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A02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69" name="正方形/長方形 68"/>
            <p:cNvSpPr/>
            <p:nvPr/>
          </p:nvSpPr>
          <p:spPr>
            <a:xfrm>
              <a:off x="7691856" y="5357188"/>
              <a:ext cx="118427" cy="2493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0" name="ひし形 69"/>
            <p:cNvSpPr>
              <a:spLocks noChangeAspect="1"/>
            </p:cNvSpPr>
            <p:nvPr/>
          </p:nvSpPr>
          <p:spPr>
            <a:xfrm>
              <a:off x="7661069" y="2670956"/>
              <a:ext cx="180000" cy="180000"/>
            </a:xfrm>
            <a:prstGeom prst="diamond">
              <a:avLst/>
            </a:prstGeom>
            <a:solidFill>
              <a:srgbClr val="1F497D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7282243" y="3479805"/>
              <a:ext cx="93765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0" i="0" u="none" strike="noStrike" dirty="0" smtClean="0">
                  <a:solidFill>
                    <a:srgbClr val="000000"/>
                  </a:solidFill>
                  <a:effectLst/>
                  <a:latin typeface="Arial"/>
                  <a:cs typeface="Arial"/>
                </a:rPr>
                <a:t>Bra028599</a:t>
              </a:r>
            </a:p>
            <a:p>
              <a:pPr algn="ctr"/>
              <a:r>
                <a:rPr lang="en-US" altLang="ja-JP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(</a:t>
              </a:r>
              <a:r>
                <a:rPr lang="en-US" altLang="ja-JP" sz="1200" i="1" dirty="0" smtClean="0">
                  <a:solidFill>
                    <a:srgbClr val="000000"/>
                  </a:solidFill>
                  <a:latin typeface="Arial"/>
                  <a:cs typeface="Arial"/>
                </a:rPr>
                <a:t>BrFLC2</a:t>
              </a:r>
              <a:r>
                <a:rPr lang="en-US" altLang="ja-JP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)</a:t>
              </a:r>
              <a:endParaRPr lang="en-US" altLang="ja-JP" sz="1200" b="0" i="0" u="none" strike="noStrike" dirty="0" smtClean="0"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7515418" y="5049567"/>
              <a:ext cx="4713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A02</a:t>
              </a:r>
            </a:p>
          </p:txBody>
        </p:sp>
      </p:grpSp>
      <p:grpSp>
        <p:nvGrpSpPr>
          <p:cNvPr id="73" name="図形グループ 72"/>
          <p:cNvGrpSpPr/>
          <p:nvPr/>
        </p:nvGrpSpPr>
        <p:grpSpPr>
          <a:xfrm>
            <a:off x="5055519" y="3566519"/>
            <a:ext cx="2965836" cy="2161325"/>
            <a:chOff x="737256" y="-38520"/>
            <a:chExt cx="2965836" cy="2161325"/>
          </a:xfrm>
        </p:grpSpPr>
        <p:sp>
          <p:nvSpPr>
            <p:cNvPr id="74" name="テキスト ボックス 73"/>
            <p:cNvSpPr txBox="1"/>
            <p:nvPr/>
          </p:nvSpPr>
          <p:spPr>
            <a:xfrm>
              <a:off x="2890049" y="-38520"/>
              <a:ext cx="647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AtMAF2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2890049" y="138175"/>
              <a:ext cx="647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AtMAF3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2890049" y="314870"/>
              <a:ext cx="647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AtMAF1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2890049" y="1097845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AtMAF4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2890049" y="1304171"/>
              <a:ext cx="647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AtMAF5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2890049" y="1876584"/>
              <a:ext cx="5480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AtFLC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2890049" y="512730"/>
              <a:ext cx="8121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31888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2890049" y="702124"/>
              <a:ext cx="8121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24350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2890049" y="912684"/>
              <a:ext cx="8121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31886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2890049" y="1485099"/>
              <a:ext cx="813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31884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2890049" y="1682959"/>
              <a:ext cx="8121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24351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grpSp>
          <p:nvGrpSpPr>
            <p:cNvPr id="85" name="図形グループ 84"/>
            <p:cNvGrpSpPr/>
            <p:nvPr/>
          </p:nvGrpSpPr>
          <p:grpSpPr>
            <a:xfrm>
              <a:off x="737256" y="77979"/>
              <a:ext cx="2227686" cy="1935483"/>
              <a:chOff x="737256" y="77979"/>
              <a:chExt cx="2227686" cy="1935483"/>
            </a:xfrm>
          </p:grpSpPr>
          <p:cxnSp>
            <p:nvCxnSpPr>
              <p:cNvPr id="86" name="直線コネクタ 85"/>
              <p:cNvCxnSpPr/>
              <p:nvPr/>
            </p:nvCxnSpPr>
            <p:spPr>
              <a:xfrm>
                <a:off x="2581549" y="77979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直線コネクタ 86"/>
              <p:cNvCxnSpPr/>
              <p:nvPr/>
            </p:nvCxnSpPr>
            <p:spPr>
              <a:xfrm>
                <a:off x="2581549" y="272713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直線コネクタ 87"/>
              <p:cNvCxnSpPr/>
              <p:nvPr/>
            </p:nvCxnSpPr>
            <p:spPr>
              <a:xfrm>
                <a:off x="2214012" y="170938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直線コネクタ 88"/>
              <p:cNvCxnSpPr/>
              <p:nvPr/>
            </p:nvCxnSpPr>
            <p:spPr>
              <a:xfrm>
                <a:off x="1846328" y="323338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直線コネクタ 89"/>
              <p:cNvCxnSpPr/>
              <p:nvPr/>
            </p:nvCxnSpPr>
            <p:spPr>
              <a:xfrm>
                <a:off x="1471833" y="491795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1" name="直線コネクタ 90"/>
              <p:cNvCxnSpPr/>
              <p:nvPr/>
            </p:nvCxnSpPr>
            <p:spPr>
              <a:xfrm>
                <a:off x="1100748" y="673828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直線コネクタ 91"/>
              <p:cNvCxnSpPr/>
              <p:nvPr/>
            </p:nvCxnSpPr>
            <p:spPr>
              <a:xfrm>
                <a:off x="1471833" y="847393"/>
                <a:ext cx="1478614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3" name="直線コネクタ 92"/>
              <p:cNvCxnSpPr/>
              <p:nvPr/>
            </p:nvCxnSpPr>
            <p:spPr>
              <a:xfrm>
                <a:off x="1846328" y="649155"/>
                <a:ext cx="1118614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4" name="直線コネクタ 93"/>
              <p:cNvCxnSpPr/>
              <p:nvPr/>
            </p:nvCxnSpPr>
            <p:spPr>
              <a:xfrm>
                <a:off x="1846328" y="1050837"/>
                <a:ext cx="1118614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5" name="直線コネクタ 94"/>
              <p:cNvCxnSpPr/>
              <p:nvPr/>
            </p:nvCxnSpPr>
            <p:spPr>
              <a:xfrm>
                <a:off x="1096515" y="1281095"/>
                <a:ext cx="75861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6" name="直線コネクタ 95"/>
              <p:cNvCxnSpPr/>
              <p:nvPr/>
            </p:nvCxnSpPr>
            <p:spPr>
              <a:xfrm>
                <a:off x="1846328" y="1526197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7" name="直線コネクタ 96"/>
              <p:cNvCxnSpPr/>
              <p:nvPr/>
            </p:nvCxnSpPr>
            <p:spPr>
              <a:xfrm>
                <a:off x="2214012" y="1336294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8" name="直線コネクタ 97"/>
              <p:cNvCxnSpPr/>
              <p:nvPr/>
            </p:nvCxnSpPr>
            <p:spPr>
              <a:xfrm>
                <a:off x="2214012" y="1719616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直線コネクタ 98"/>
              <p:cNvCxnSpPr/>
              <p:nvPr/>
            </p:nvCxnSpPr>
            <p:spPr>
              <a:xfrm>
                <a:off x="2581549" y="1240274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直線コネクタ 99"/>
              <p:cNvCxnSpPr/>
              <p:nvPr/>
            </p:nvCxnSpPr>
            <p:spPr>
              <a:xfrm>
                <a:off x="2581549" y="1443473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直線コネクタ 100"/>
              <p:cNvCxnSpPr/>
              <p:nvPr/>
            </p:nvCxnSpPr>
            <p:spPr>
              <a:xfrm>
                <a:off x="2581549" y="1629740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直線コネクタ 101"/>
              <p:cNvCxnSpPr/>
              <p:nvPr/>
            </p:nvCxnSpPr>
            <p:spPr>
              <a:xfrm>
                <a:off x="2581549" y="1816007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3" name="直線コネクタ 102"/>
              <p:cNvCxnSpPr/>
              <p:nvPr/>
            </p:nvCxnSpPr>
            <p:spPr>
              <a:xfrm>
                <a:off x="737256" y="2013462"/>
                <a:ext cx="219860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直線コネクタ 103"/>
              <p:cNvCxnSpPr/>
              <p:nvPr/>
            </p:nvCxnSpPr>
            <p:spPr>
              <a:xfrm>
                <a:off x="737256" y="971946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5" name="直線コネクタ 104"/>
              <p:cNvCxnSpPr/>
              <p:nvPr/>
            </p:nvCxnSpPr>
            <p:spPr>
              <a:xfrm>
                <a:off x="2214012" y="456886"/>
                <a:ext cx="722614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6" name="直線コネクタ 105"/>
              <p:cNvCxnSpPr/>
              <p:nvPr/>
            </p:nvCxnSpPr>
            <p:spPr>
              <a:xfrm>
                <a:off x="1471833" y="487393"/>
                <a:ext cx="0" cy="36000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7" name="直線コネクタ 106"/>
              <p:cNvCxnSpPr/>
              <p:nvPr/>
            </p:nvCxnSpPr>
            <p:spPr>
              <a:xfrm>
                <a:off x="1846328" y="320261"/>
                <a:ext cx="0" cy="32400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直線コネクタ 107"/>
              <p:cNvCxnSpPr/>
              <p:nvPr/>
            </p:nvCxnSpPr>
            <p:spPr>
              <a:xfrm>
                <a:off x="2214012" y="170939"/>
                <a:ext cx="0" cy="287999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直線コネクタ 108"/>
              <p:cNvCxnSpPr/>
              <p:nvPr/>
            </p:nvCxnSpPr>
            <p:spPr>
              <a:xfrm>
                <a:off x="2581549" y="83646"/>
                <a:ext cx="0" cy="179997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直線コネクタ 109"/>
              <p:cNvCxnSpPr/>
              <p:nvPr/>
            </p:nvCxnSpPr>
            <p:spPr>
              <a:xfrm>
                <a:off x="2214012" y="1328728"/>
                <a:ext cx="0" cy="39600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直線コネクタ 110"/>
              <p:cNvCxnSpPr/>
              <p:nvPr/>
            </p:nvCxnSpPr>
            <p:spPr>
              <a:xfrm>
                <a:off x="2581549" y="1234574"/>
                <a:ext cx="0" cy="215997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直線コネクタ 111"/>
              <p:cNvCxnSpPr/>
              <p:nvPr/>
            </p:nvCxnSpPr>
            <p:spPr>
              <a:xfrm>
                <a:off x="2581549" y="1629740"/>
                <a:ext cx="0" cy="179997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12"/>
              <p:cNvCxnSpPr/>
              <p:nvPr/>
            </p:nvCxnSpPr>
            <p:spPr>
              <a:xfrm>
                <a:off x="1846328" y="1050837"/>
                <a:ext cx="0" cy="46800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直線コネクタ 113"/>
              <p:cNvCxnSpPr/>
              <p:nvPr/>
            </p:nvCxnSpPr>
            <p:spPr>
              <a:xfrm>
                <a:off x="1104981" y="673829"/>
                <a:ext cx="0" cy="611999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直線コネクタ 114"/>
              <p:cNvCxnSpPr/>
              <p:nvPr/>
            </p:nvCxnSpPr>
            <p:spPr>
              <a:xfrm>
                <a:off x="737256" y="968555"/>
                <a:ext cx="0" cy="1043995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6" name="図形グループ 115"/>
          <p:cNvGrpSpPr/>
          <p:nvPr/>
        </p:nvGrpSpPr>
        <p:grpSpPr>
          <a:xfrm>
            <a:off x="1537559" y="4153749"/>
            <a:ext cx="2477175" cy="986865"/>
            <a:chOff x="1785836" y="4305712"/>
            <a:chExt cx="2477175" cy="986865"/>
          </a:xfrm>
        </p:grpSpPr>
        <p:grpSp>
          <p:nvGrpSpPr>
            <p:cNvPr id="117" name="図形グループ 116"/>
            <p:cNvGrpSpPr/>
            <p:nvPr/>
          </p:nvGrpSpPr>
          <p:grpSpPr>
            <a:xfrm flipV="1">
              <a:off x="1785836" y="4435884"/>
              <a:ext cx="1118614" cy="765170"/>
              <a:chOff x="6443991" y="4922576"/>
              <a:chExt cx="1118614" cy="765170"/>
            </a:xfrm>
          </p:grpSpPr>
          <p:cxnSp>
            <p:nvCxnSpPr>
              <p:cNvPr id="123" name="直線コネクタ 122"/>
              <p:cNvCxnSpPr/>
              <p:nvPr/>
            </p:nvCxnSpPr>
            <p:spPr>
              <a:xfrm>
                <a:off x="6443991" y="4922576"/>
                <a:ext cx="1118614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4" name="直線コネクタ 123"/>
              <p:cNvCxnSpPr/>
              <p:nvPr/>
            </p:nvCxnSpPr>
            <p:spPr>
              <a:xfrm>
                <a:off x="6443991" y="5397936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5" name="直線コネクタ 124"/>
              <p:cNvCxnSpPr/>
              <p:nvPr/>
            </p:nvCxnSpPr>
            <p:spPr>
              <a:xfrm>
                <a:off x="6811675" y="5208033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6" name="直線コネクタ 125"/>
              <p:cNvCxnSpPr/>
              <p:nvPr/>
            </p:nvCxnSpPr>
            <p:spPr>
              <a:xfrm>
                <a:off x="6811675" y="5591355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直線コネクタ 126"/>
              <p:cNvCxnSpPr/>
              <p:nvPr/>
            </p:nvCxnSpPr>
            <p:spPr>
              <a:xfrm>
                <a:off x="7179212" y="5112013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8" name="直線コネクタ 127"/>
              <p:cNvCxnSpPr/>
              <p:nvPr/>
            </p:nvCxnSpPr>
            <p:spPr>
              <a:xfrm>
                <a:off x="7179212" y="5315212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9" name="直線コネクタ 128"/>
              <p:cNvCxnSpPr/>
              <p:nvPr/>
            </p:nvCxnSpPr>
            <p:spPr>
              <a:xfrm>
                <a:off x="7179212" y="5501479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0" name="直線コネクタ 129"/>
              <p:cNvCxnSpPr/>
              <p:nvPr/>
            </p:nvCxnSpPr>
            <p:spPr>
              <a:xfrm>
                <a:off x="7179212" y="5687746"/>
                <a:ext cx="362622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直線コネクタ 130"/>
              <p:cNvCxnSpPr/>
              <p:nvPr/>
            </p:nvCxnSpPr>
            <p:spPr>
              <a:xfrm>
                <a:off x="6811675" y="5200467"/>
                <a:ext cx="0" cy="39600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2" name="直線コネクタ 131"/>
              <p:cNvCxnSpPr/>
              <p:nvPr/>
            </p:nvCxnSpPr>
            <p:spPr>
              <a:xfrm>
                <a:off x="7179212" y="5106313"/>
                <a:ext cx="0" cy="215997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直線コネクタ 132"/>
              <p:cNvCxnSpPr/>
              <p:nvPr/>
            </p:nvCxnSpPr>
            <p:spPr>
              <a:xfrm>
                <a:off x="7179212" y="5501479"/>
                <a:ext cx="0" cy="179997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直線コネクタ 133"/>
              <p:cNvCxnSpPr/>
              <p:nvPr/>
            </p:nvCxnSpPr>
            <p:spPr>
              <a:xfrm>
                <a:off x="6443991" y="4922576"/>
                <a:ext cx="0" cy="46800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8" name="テキスト ボックス 117"/>
            <p:cNvSpPr txBox="1"/>
            <p:nvPr/>
          </p:nvSpPr>
          <p:spPr>
            <a:xfrm>
              <a:off x="2887990" y="4305712"/>
              <a:ext cx="13750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28599 (BrFLC2)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19" name="テキスト ボックス 118"/>
            <p:cNvSpPr txBox="1"/>
            <p:nvPr/>
          </p:nvSpPr>
          <p:spPr>
            <a:xfrm>
              <a:off x="2887990" y="4482407"/>
              <a:ext cx="13750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06051 (BrFLC3)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20" name="テキスト ボックス 119"/>
            <p:cNvSpPr txBox="1"/>
            <p:nvPr/>
          </p:nvSpPr>
          <p:spPr>
            <a:xfrm>
              <a:off x="2887990" y="4659102"/>
              <a:ext cx="13750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09055 (BrFLC1)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21" name="テキスト ボックス 120"/>
            <p:cNvSpPr txBox="1"/>
            <p:nvPr/>
          </p:nvSpPr>
          <p:spPr>
            <a:xfrm>
              <a:off x="2887990" y="4856962"/>
              <a:ext cx="5480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AtFLC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22" name="テキスト ボックス 121"/>
            <p:cNvSpPr txBox="1"/>
            <p:nvPr/>
          </p:nvSpPr>
          <p:spPr>
            <a:xfrm>
              <a:off x="2887990" y="5046356"/>
              <a:ext cx="13750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/>
                  <a:cs typeface="Arial"/>
                </a:rPr>
                <a:t>Bra022771 (BrFLC5)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</p:grpSp>
      <p:sp>
        <p:nvSpPr>
          <p:cNvPr id="135" name="テキスト ボックス 134"/>
          <p:cNvSpPr txBox="1"/>
          <p:nvPr/>
        </p:nvSpPr>
        <p:spPr>
          <a:xfrm>
            <a:off x="277702" y="5761864"/>
            <a:ext cx="85885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Figure S15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Representation of the syntenic segments covering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tFLC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and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tMAF1-5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and their corresponding three subgenome in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B. rapa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For analysis of chromosome segments in chromosome 1 and 5 in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. thaliana,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Cheng et al. 2012 was followed.</a:t>
            </a:r>
            <a:r>
              <a:rPr kumimoji="1" lang="en-US" altLang="ja-JP" sz="1200" baseline="30000" dirty="0" smtClean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tFLC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has high confidence syntenic gene set in three subgenome of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B. rapa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while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tMAF1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 3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and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do not have high confidence syntenic gene set in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B. rapa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Phylogenetic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relationship in 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FLC or MAF genes in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. thaliana 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and </a:t>
            </a:r>
            <a:r>
              <a:rPr kumimoji="1"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B. rapa 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is shown in bottom panel.</a:t>
            </a:r>
            <a:endParaRPr kumimoji="1" lang="ja-JP" altLang="en-US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7880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378562" y="6149734"/>
            <a:ext cx="57828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Figure S2. </a:t>
            </a:r>
            <a:r>
              <a:rPr lang="en-GB" altLang="ja-JP" sz="1200" dirty="0" smtClean="0">
                <a:latin typeface="Arial" charset="0"/>
                <a:cs typeface="Arial" charset="0"/>
              </a:rPr>
              <a:t>Plants at 2 days or 14 days after sowing in RJKB-T23 and RJKB-T24. Scale bar represents 1 cm in length.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grpSp>
        <p:nvGrpSpPr>
          <p:cNvPr id="18" name="図形グループ 17"/>
          <p:cNvGrpSpPr/>
          <p:nvPr/>
        </p:nvGrpSpPr>
        <p:grpSpPr>
          <a:xfrm>
            <a:off x="5307194" y="1074716"/>
            <a:ext cx="1879600" cy="1828800"/>
            <a:chOff x="1752600" y="546100"/>
            <a:chExt cx="1879600" cy="1828800"/>
          </a:xfrm>
        </p:grpSpPr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52600" y="546100"/>
              <a:ext cx="1879600" cy="1828800"/>
            </a:xfrm>
            <a:prstGeom prst="rect">
              <a:avLst/>
            </a:prstGeom>
          </p:spPr>
        </p:pic>
        <p:cxnSp>
          <p:nvCxnSpPr>
            <p:cNvPr id="12" name="直線コネクタ 11"/>
            <p:cNvCxnSpPr/>
            <p:nvPr/>
          </p:nvCxnSpPr>
          <p:spPr>
            <a:xfrm rot="16200000">
              <a:off x="3276600" y="1981200"/>
              <a:ext cx="0" cy="66040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" name="図形グループ 18"/>
          <p:cNvGrpSpPr/>
          <p:nvPr/>
        </p:nvGrpSpPr>
        <p:grpSpPr>
          <a:xfrm>
            <a:off x="2019045" y="852466"/>
            <a:ext cx="2730500" cy="2273300"/>
            <a:chOff x="3860800" y="368300"/>
            <a:chExt cx="2730500" cy="2273300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60800" y="368300"/>
              <a:ext cx="2730500" cy="2273300"/>
            </a:xfrm>
            <a:prstGeom prst="rect">
              <a:avLst/>
            </a:prstGeom>
          </p:spPr>
        </p:pic>
        <p:cxnSp>
          <p:nvCxnSpPr>
            <p:cNvPr id="15" name="直線コネクタ 14"/>
            <p:cNvCxnSpPr/>
            <p:nvPr/>
          </p:nvCxnSpPr>
          <p:spPr>
            <a:xfrm rot="16200000">
              <a:off x="6134100" y="2222500"/>
              <a:ext cx="0" cy="66040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" name="図形グループ 19"/>
          <p:cNvGrpSpPr/>
          <p:nvPr/>
        </p:nvGrpSpPr>
        <p:grpSpPr>
          <a:xfrm>
            <a:off x="5161675" y="3474273"/>
            <a:ext cx="2170638" cy="2370237"/>
            <a:chOff x="1517718" y="3022600"/>
            <a:chExt cx="2170638" cy="2370237"/>
          </a:xfrm>
        </p:grpSpPr>
        <p:pic>
          <p:nvPicPr>
            <p:cNvPr id="8" name="図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17718" y="3022600"/>
              <a:ext cx="2170638" cy="2370237"/>
            </a:xfrm>
            <a:prstGeom prst="rect">
              <a:avLst/>
            </a:prstGeom>
          </p:spPr>
        </p:pic>
        <p:cxnSp>
          <p:nvCxnSpPr>
            <p:cNvPr id="16" name="直線コネクタ 15"/>
            <p:cNvCxnSpPr/>
            <p:nvPr/>
          </p:nvCxnSpPr>
          <p:spPr>
            <a:xfrm rot="16200000">
              <a:off x="3302000" y="4973737"/>
              <a:ext cx="0" cy="66040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" name="図形グループ 20"/>
          <p:cNvGrpSpPr/>
          <p:nvPr/>
        </p:nvGrpSpPr>
        <p:grpSpPr>
          <a:xfrm>
            <a:off x="2043240" y="3474273"/>
            <a:ext cx="2682111" cy="2370237"/>
            <a:chOff x="4050129" y="3022600"/>
            <a:chExt cx="2682111" cy="2370237"/>
          </a:xfrm>
        </p:grpSpPr>
        <p:pic>
          <p:nvPicPr>
            <p:cNvPr id="9" name="図 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50129" y="3022600"/>
              <a:ext cx="2682111" cy="2370237"/>
            </a:xfrm>
            <a:prstGeom prst="rect">
              <a:avLst/>
            </a:prstGeom>
          </p:spPr>
        </p:pic>
        <p:cxnSp>
          <p:nvCxnSpPr>
            <p:cNvPr id="17" name="直線コネクタ 16"/>
            <p:cNvCxnSpPr/>
            <p:nvPr/>
          </p:nvCxnSpPr>
          <p:spPr>
            <a:xfrm rot="16200000">
              <a:off x="6402040" y="4994474"/>
              <a:ext cx="0" cy="66040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テキスト ボックス 22"/>
          <p:cNvSpPr txBox="1"/>
          <p:nvPr/>
        </p:nvSpPr>
        <p:spPr>
          <a:xfrm>
            <a:off x="1060806" y="1835228"/>
            <a:ext cx="703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/>
                <a:cs typeface="Arial"/>
              </a:rPr>
              <a:t>2 DAS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010881" y="4505503"/>
            <a:ext cx="8034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/>
                <a:cs typeface="Arial"/>
              </a:rPr>
              <a:t>14 DAS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877924" y="355600"/>
            <a:ext cx="10127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RJKB-T23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740623" y="355600"/>
            <a:ext cx="10127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RJKB-T24</a:t>
            </a:r>
            <a:endParaRPr kumimoji="1" lang="ja-JP" alt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914986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575769" y="15033"/>
            <a:ext cx="7992462" cy="5569831"/>
            <a:chOff x="107930" y="15033"/>
            <a:chExt cx="8709996" cy="6069870"/>
          </a:xfrm>
        </p:grpSpPr>
        <p:cxnSp>
          <p:nvCxnSpPr>
            <p:cNvPr id="21" name="直線コネクタ 20"/>
            <p:cNvCxnSpPr/>
            <p:nvPr/>
          </p:nvCxnSpPr>
          <p:spPr>
            <a:xfrm>
              <a:off x="8256253" y="5614775"/>
              <a:ext cx="46799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/>
            <p:cNvSpPr txBox="1"/>
            <p:nvPr/>
          </p:nvSpPr>
          <p:spPr>
            <a:xfrm>
              <a:off x="8162578" y="5658709"/>
              <a:ext cx="655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500 bp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93" name="図形グループ 92"/>
            <p:cNvGrpSpPr/>
            <p:nvPr/>
          </p:nvGrpSpPr>
          <p:grpSpPr>
            <a:xfrm>
              <a:off x="5535774" y="3890747"/>
              <a:ext cx="2459750" cy="2194156"/>
              <a:chOff x="2760322" y="4149081"/>
              <a:chExt cx="2459750" cy="2194156"/>
            </a:xfrm>
          </p:grpSpPr>
          <p:pic>
            <p:nvPicPr>
              <p:cNvPr id="13" name="図 1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flipH="1">
                <a:off x="3698662" y="4195821"/>
                <a:ext cx="1520635" cy="1944216"/>
              </a:xfrm>
              <a:prstGeom prst="rect">
                <a:avLst/>
              </a:prstGeom>
            </p:spPr>
          </p:pic>
          <p:grpSp>
            <p:nvGrpSpPr>
              <p:cNvPr id="56" name="図形グループ 55"/>
              <p:cNvGrpSpPr/>
              <p:nvPr/>
            </p:nvGrpSpPr>
            <p:grpSpPr>
              <a:xfrm>
                <a:off x="2760322" y="4409162"/>
                <a:ext cx="971993" cy="1590886"/>
                <a:chOff x="-50098" y="732382"/>
                <a:chExt cx="971993" cy="1590886"/>
              </a:xfrm>
            </p:grpSpPr>
            <p:sp>
              <p:nvSpPr>
                <p:cNvPr id="57" name="テキスト ボックス 56"/>
                <p:cNvSpPr txBox="1"/>
                <p:nvPr/>
              </p:nvSpPr>
              <p:spPr>
                <a:xfrm>
                  <a:off x="416725" y="759863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8" name="テキスト ボックス 57"/>
                <p:cNvSpPr txBox="1"/>
                <p:nvPr/>
              </p:nvSpPr>
              <p:spPr>
                <a:xfrm>
                  <a:off x="387347" y="940396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9" name="テキスト ボックス 58"/>
                <p:cNvSpPr txBox="1"/>
                <p:nvPr/>
              </p:nvSpPr>
              <p:spPr>
                <a:xfrm>
                  <a:off x="412793" y="1685205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1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0" name="テキスト ボックス 59"/>
                <p:cNvSpPr txBox="1"/>
                <p:nvPr/>
              </p:nvSpPr>
              <p:spPr>
                <a:xfrm>
                  <a:off x="412793" y="1865738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2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1" name="テキスト ボックス 60"/>
                <p:cNvSpPr txBox="1"/>
                <p:nvPr/>
              </p:nvSpPr>
              <p:spPr>
                <a:xfrm>
                  <a:off x="395438" y="112092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2" name="テキスト ボックス 61"/>
                <p:cNvSpPr txBox="1"/>
                <p:nvPr/>
              </p:nvSpPr>
              <p:spPr>
                <a:xfrm>
                  <a:off x="416725" y="1324139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3" name="テキスト ボックス 62"/>
                <p:cNvSpPr txBox="1"/>
                <p:nvPr/>
              </p:nvSpPr>
              <p:spPr>
                <a:xfrm>
                  <a:off x="387347" y="1504672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4" name="テキスト ボックス 63"/>
                <p:cNvSpPr txBox="1"/>
                <p:nvPr/>
              </p:nvSpPr>
              <p:spPr>
                <a:xfrm>
                  <a:off x="395438" y="204626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5" name="テキスト ボックス 64"/>
                <p:cNvSpPr txBox="1"/>
                <p:nvPr/>
              </p:nvSpPr>
              <p:spPr>
                <a:xfrm rot="16200000">
                  <a:off x="-108279" y="790563"/>
                  <a:ext cx="578028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</a:t>
                  </a:r>
                </a:p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-T23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6" name="テキスト ボックス 65"/>
                <p:cNvSpPr txBox="1"/>
                <p:nvPr/>
              </p:nvSpPr>
              <p:spPr>
                <a:xfrm rot="16200000">
                  <a:off x="-108279" y="1588530"/>
                  <a:ext cx="578028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</a:t>
                  </a:r>
                </a:p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-T24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67" name="直線コネクタ 66"/>
                <p:cNvCxnSpPr/>
                <p:nvPr/>
              </p:nvCxnSpPr>
              <p:spPr>
                <a:xfrm>
                  <a:off x="412747" y="751396"/>
                  <a:ext cx="0" cy="53999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直線コネクタ 67"/>
                <p:cNvCxnSpPr/>
                <p:nvPr/>
              </p:nvCxnSpPr>
              <p:spPr>
                <a:xfrm>
                  <a:off x="412747" y="1387365"/>
                  <a:ext cx="0" cy="8639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7" name="正方形/長方形 86"/>
              <p:cNvSpPr/>
              <p:nvPr/>
            </p:nvSpPr>
            <p:spPr>
              <a:xfrm>
                <a:off x="3687235" y="4149081"/>
                <a:ext cx="1532837" cy="30073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>
                <a:off x="3934104" y="6066238"/>
                <a:ext cx="93765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Bra028913</a:t>
                </a:r>
              </a:p>
            </p:txBody>
          </p:sp>
          <p:cxnSp>
            <p:nvCxnSpPr>
              <p:cNvPr id="90" name="直線矢印コネクタ 89"/>
              <p:cNvCxnSpPr/>
              <p:nvPr/>
            </p:nvCxnSpPr>
            <p:spPr>
              <a:xfrm>
                <a:off x="3790930" y="6096961"/>
                <a:ext cx="1224000" cy="0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図形グループ 93"/>
            <p:cNvGrpSpPr/>
            <p:nvPr/>
          </p:nvGrpSpPr>
          <p:grpSpPr>
            <a:xfrm>
              <a:off x="3433422" y="3890747"/>
              <a:ext cx="1712393" cy="2194156"/>
              <a:chOff x="5955952" y="4149081"/>
              <a:chExt cx="1712393" cy="2194156"/>
            </a:xfrm>
          </p:grpSpPr>
          <p:pic>
            <p:nvPicPr>
              <p:cNvPr id="12" name="図 1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927945" y="4195821"/>
                <a:ext cx="648072" cy="1944216"/>
              </a:xfrm>
              <a:prstGeom prst="rect">
                <a:avLst/>
              </a:prstGeom>
            </p:spPr>
          </p:pic>
          <p:grpSp>
            <p:nvGrpSpPr>
              <p:cNvPr id="69" name="図形グループ 68"/>
              <p:cNvGrpSpPr/>
              <p:nvPr/>
            </p:nvGrpSpPr>
            <p:grpSpPr>
              <a:xfrm>
                <a:off x="5955952" y="4409162"/>
                <a:ext cx="971993" cy="1590886"/>
                <a:chOff x="-50098" y="732382"/>
                <a:chExt cx="971993" cy="1590886"/>
              </a:xfrm>
            </p:grpSpPr>
            <p:sp>
              <p:nvSpPr>
                <p:cNvPr id="70" name="テキスト ボックス 69"/>
                <p:cNvSpPr txBox="1"/>
                <p:nvPr/>
              </p:nvSpPr>
              <p:spPr>
                <a:xfrm>
                  <a:off x="416725" y="759863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1" name="テキスト ボックス 70"/>
                <p:cNvSpPr txBox="1"/>
                <p:nvPr/>
              </p:nvSpPr>
              <p:spPr>
                <a:xfrm>
                  <a:off x="387347" y="940396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2" name="テキスト ボックス 71"/>
                <p:cNvSpPr txBox="1"/>
                <p:nvPr/>
              </p:nvSpPr>
              <p:spPr>
                <a:xfrm>
                  <a:off x="412793" y="1685205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1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3" name="テキスト ボックス 72"/>
                <p:cNvSpPr txBox="1"/>
                <p:nvPr/>
              </p:nvSpPr>
              <p:spPr>
                <a:xfrm>
                  <a:off x="412793" y="1865738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2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4" name="テキスト ボックス 73"/>
                <p:cNvSpPr txBox="1"/>
                <p:nvPr/>
              </p:nvSpPr>
              <p:spPr>
                <a:xfrm>
                  <a:off x="395438" y="112092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5" name="テキスト ボックス 74"/>
                <p:cNvSpPr txBox="1"/>
                <p:nvPr/>
              </p:nvSpPr>
              <p:spPr>
                <a:xfrm>
                  <a:off x="416725" y="1324139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6" name="テキスト ボックス 75"/>
                <p:cNvSpPr txBox="1"/>
                <p:nvPr/>
              </p:nvSpPr>
              <p:spPr>
                <a:xfrm>
                  <a:off x="387347" y="1504672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7" name="テキスト ボックス 76"/>
                <p:cNvSpPr txBox="1"/>
                <p:nvPr/>
              </p:nvSpPr>
              <p:spPr>
                <a:xfrm>
                  <a:off x="395438" y="204626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8" name="テキスト ボックス 77"/>
                <p:cNvSpPr txBox="1"/>
                <p:nvPr/>
              </p:nvSpPr>
              <p:spPr>
                <a:xfrm rot="16200000">
                  <a:off x="-108279" y="790563"/>
                  <a:ext cx="578028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</a:t>
                  </a:r>
                </a:p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-T23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9" name="テキスト ボックス 78"/>
                <p:cNvSpPr txBox="1"/>
                <p:nvPr/>
              </p:nvSpPr>
              <p:spPr>
                <a:xfrm rot="16200000">
                  <a:off x="-108279" y="1588530"/>
                  <a:ext cx="578028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</a:t>
                  </a:r>
                </a:p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-T24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80" name="直線コネクタ 79"/>
                <p:cNvCxnSpPr/>
                <p:nvPr/>
              </p:nvCxnSpPr>
              <p:spPr>
                <a:xfrm>
                  <a:off x="412747" y="751396"/>
                  <a:ext cx="0" cy="53999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直線コネクタ 80"/>
                <p:cNvCxnSpPr/>
                <p:nvPr/>
              </p:nvCxnSpPr>
              <p:spPr>
                <a:xfrm>
                  <a:off x="412747" y="1387365"/>
                  <a:ext cx="0" cy="8639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8" name="正方形/長方形 87"/>
              <p:cNvSpPr/>
              <p:nvPr/>
            </p:nvSpPr>
            <p:spPr>
              <a:xfrm>
                <a:off x="6852251" y="4149081"/>
                <a:ext cx="816094" cy="31343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2" name="テキスト ボックス 91"/>
              <p:cNvSpPr txBox="1"/>
              <p:nvPr/>
            </p:nvSpPr>
            <p:spPr>
              <a:xfrm>
                <a:off x="6695048" y="6066238"/>
                <a:ext cx="93765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Bra013206</a:t>
                </a:r>
              </a:p>
            </p:txBody>
          </p:sp>
          <p:cxnSp>
            <p:nvCxnSpPr>
              <p:cNvPr id="91" name="直線矢印コネクタ 90"/>
              <p:cNvCxnSpPr/>
              <p:nvPr/>
            </p:nvCxnSpPr>
            <p:spPr>
              <a:xfrm>
                <a:off x="7097319" y="6096961"/>
                <a:ext cx="395998" cy="0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図形グループ 85"/>
            <p:cNvGrpSpPr/>
            <p:nvPr/>
          </p:nvGrpSpPr>
          <p:grpSpPr>
            <a:xfrm>
              <a:off x="3433422" y="2016920"/>
              <a:ext cx="4187942" cy="2146006"/>
              <a:chOff x="2760322" y="2182020"/>
              <a:chExt cx="4187942" cy="2146006"/>
            </a:xfrm>
          </p:grpSpPr>
          <p:pic>
            <p:nvPicPr>
              <p:cNvPr id="11" name="図 10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724224" y="2204863"/>
                <a:ext cx="3203721" cy="1927457"/>
              </a:xfrm>
              <a:prstGeom prst="rect">
                <a:avLst/>
              </a:prstGeom>
            </p:spPr>
          </p:pic>
          <p:grpSp>
            <p:nvGrpSpPr>
              <p:cNvPr id="43" name="図形グループ 42"/>
              <p:cNvGrpSpPr/>
              <p:nvPr/>
            </p:nvGrpSpPr>
            <p:grpSpPr>
              <a:xfrm>
                <a:off x="2760322" y="2362247"/>
                <a:ext cx="971993" cy="1590886"/>
                <a:chOff x="-50098" y="732382"/>
                <a:chExt cx="971993" cy="1590886"/>
              </a:xfrm>
            </p:grpSpPr>
            <p:sp>
              <p:nvSpPr>
                <p:cNvPr id="44" name="テキスト ボックス 43"/>
                <p:cNvSpPr txBox="1"/>
                <p:nvPr/>
              </p:nvSpPr>
              <p:spPr>
                <a:xfrm>
                  <a:off x="416725" y="759863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5" name="テキスト ボックス 44"/>
                <p:cNvSpPr txBox="1"/>
                <p:nvPr/>
              </p:nvSpPr>
              <p:spPr>
                <a:xfrm>
                  <a:off x="387347" y="940396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6" name="テキスト ボックス 45"/>
                <p:cNvSpPr txBox="1"/>
                <p:nvPr/>
              </p:nvSpPr>
              <p:spPr>
                <a:xfrm>
                  <a:off x="412793" y="1685205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1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7" name="テキスト ボックス 46"/>
                <p:cNvSpPr txBox="1"/>
                <p:nvPr/>
              </p:nvSpPr>
              <p:spPr>
                <a:xfrm>
                  <a:off x="412793" y="1865738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2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8" name="テキスト ボックス 47"/>
                <p:cNvSpPr txBox="1"/>
                <p:nvPr/>
              </p:nvSpPr>
              <p:spPr>
                <a:xfrm>
                  <a:off x="395438" y="112092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9" name="テキスト ボックス 48"/>
                <p:cNvSpPr txBox="1"/>
                <p:nvPr/>
              </p:nvSpPr>
              <p:spPr>
                <a:xfrm>
                  <a:off x="416725" y="1324139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0" name="テキスト ボックス 49"/>
                <p:cNvSpPr txBox="1"/>
                <p:nvPr/>
              </p:nvSpPr>
              <p:spPr>
                <a:xfrm>
                  <a:off x="387347" y="1504672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1" name="テキスト ボックス 50"/>
                <p:cNvSpPr txBox="1"/>
                <p:nvPr/>
              </p:nvSpPr>
              <p:spPr>
                <a:xfrm>
                  <a:off x="395438" y="204626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2" name="テキスト ボックス 51"/>
                <p:cNvSpPr txBox="1"/>
                <p:nvPr/>
              </p:nvSpPr>
              <p:spPr>
                <a:xfrm rot="16200000">
                  <a:off x="-108279" y="790563"/>
                  <a:ext cx="578028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</a:t>
                  </a:r>
                </a:p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-T23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3" name="テキスト ボックス 52"/>
                <p:cNvSpPr txBox="1"/>
                <p:nvPr/>
              </p:nvSpPr>
              <p:spPr>
                <a:xfrm rot="16200000">
                  <a:off x="-108279" y="1588530"/>
                  <a:ext cx="578028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</a:t>
                  </a:r>
                </a:p>
                <a:p>
                  <a:pPr algn="ctr"/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-T24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54" name="直線コネクタ 53"/>
                <p:cNvCxnSpPr/>
                <p:nvPr/>
              </p:nvCxnSpPr>
              <p:spPr>
                <a:xfrm>
                  <a:off x="412747" y="751396"/>
                  <a:ext cx="0" cy="53999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線コネクタ 54"/>
                <p:cNvCxnSpPr/>
                <p:nvPr/>
              </p:nvCxnSpPr>
              <p:spPr>
                <a:xfrm>
                  <a:off x="412747" y="1387365"/>
                  <a:ext cx="0" cy="8639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" name="正方形/長方形 81"/>
              <p:cNvSpPr/>
              <p:nvPr/>
            </p:nvSpPr>
            <p:spPr>
              <a:xfrm>
                <a:off x="3648556" y="2182020"/>
                <a:ext cx="3299708" cy="269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>
                <a:off x="4621367" y="4051027"/>
                <a:ext cx="1398911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i="1" dirty="0" smtClean="0">
                    <a:latin typeface="Arial"/>
                    <a:cs typeface="Arial"/>
                  </a:rPr>
                  <a:t>STM</a:t>
                </a:r>
                <a:r>
                  <a:rPr lang="en-US" altLang="ja-JP" sz="1200" dirty="0" smtClean="0">
                    <a:latin typeface="Arial"/>
                    <a:cs typeface="Arial"/>
                  </a:rPr>
                  <a:t> / Bra027050</a:t>
                </a:r>
              </a:p>
            </p:txBody>
          </p:sp>
          <p:cxnSp>
            <p:nvCxnSpPr>
              <p:cNvPr id="84" name="直線矢印コネクタ 83"/>
              <p:cNvCxnSpPr/>
              <p:nvPr/>
            </p:nvCxnSpPr>
            <p:spPr>
              <a:xfrm>
                <a:off x="4006830" y="4085426"/>
                <a:ext cx="2627985" cy="0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0" name="図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69563" y="53533"/>
              <a:ext cx="3290480" cy="1915765"/>
            </a:xfrm>
            <a:prstGeom prst="rect">
              <a:avLst/>
            </a:prstGeom>
          </p:spPr>
        </p:pic>
        <p:grpSp>
          <p:nvGrpSpPr>
            <p:cNvPr id="27" name="図形グループ 26"/>
            <p:cNvGrpSpPr/>
            <p:nvPr/>
          </p:nvGrpSpPr>
          <p:grpSpPr>
            <a:xfrm>
              <a:off x="3433422" y="211967"/>
              <a:ext cx="971993" cy="1590886"/>
              <a:chOff x="-50098" y="732382"/>
              <a:chExt cx="971993" cy="1590886"/>
            </a:xfrm>
          </p:grpSpPr>
          <p:sp>
            <p:nvSpPr>
              <p:cNvPr id="28" name="テキスト ボックス 27"/>
              <p:cNvSpPr txBox="1"/>
              <p:nvPr/>
            </p:nvSpPr>
            <p:spPr>
              <a:xfrm>
                <a:off x="416725" y="759863"/>
                <a:ext cx="475792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2d-C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387347" y="940396"/>
                <a:ext cx="534548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14d-L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412793" y="1685205"/>
                <a:ext cx="483657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BrV1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412793" y="1865738"/>
                <a:ext cx="483657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BrV2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395438" y="1120929"/>
                <a:ext cx="5183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input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>
                <a:off x="416725" y="1324139"/>
                <a:ext cx="475792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2d-C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387347" y="1504672"/>
                <a:ext cx="534548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14d-L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395438" y="2046269"/>
                <a:ext cx="5183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input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6" name="テキスト ボックス 35"/>
              <p:cNvSpPr txBox="1"/>
              <p:nvPr/>
            </p:nvSpPr>
            <p:spPr>
              <a:xfrm rot="16200000">
                <a:off x="-108279" y="790563"/>
                <a:ext cx="57802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RJKB</a:t>
                </a:r>
              </a:p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-T23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 rot="16200000">
                <a:off x="-108279" y="1588530"/>
                <a:ext cx="57802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RJKB</a:t>
                </a:r>
              </a:p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-T24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38" name="直線コネクタ 37"/>
              <p:cNvCxnSpPr/>
              <p:nvPr/>
            </p:nvCxnSpPr>
            <p:spPr>
              <a:xfrm>
                <a:off x="412747" y="751396"/>
                <a:ext cx="0" cy="53999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線コネクタ 38"/>
              <p:cNvCxnSpPr/>
              <p:nvPr/>
            </p:nvCxnSpPr>
            <p:spPr>
              <a:xfrm>
                <a:off x="412747" y="1387365"/>
                <a:ext cx="0" cy="8639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" name="正方形/長方形 39"/>
            <p:cNvSpPr/>
            <p:nvPr/>
          </p:nvSpPr>
          <p:spPr>
            <a:xfrm>
              <a:off x="4353243" y="15033"/>
              <a:ext cx="3366148" cy="269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5410705" y="1886752"/>
              <a:ext cx="1413188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200" i="1" dirty="0" smtClean="0">
                  <a:latin typeface="Arial"/>
                  <a:cs typeface="Arial"/>
                </a:rPr>
                <a:t>FWA</a:t>
              </a:r>
              <a:r>
                <a:rPr lang="en-US" altLang="ja-JP" sz="1200" dirty="0" smtClean="0">
                  <a:latin typeface="Arial"/>
                  <a:cs typeface="Arial"/>
                </a:rPr>
                <a:t> / Bra013898</a:t>
              </a:r>
            </a:p>
          </p:txBody>
        </p:sp>
        <p:cxnSp>
          <p:nvCxnSpPr>
            <p:cNvPr id="42" name="直線矢印コネクタ 41"/>
            <p:cNvCxnSpPr/>
            <p:nvPr/>
          </p:nvCxnSpPr>
          <p:spPr>
            <a:xfrm>
              <a:off x="4929307" y="1921151"/>
              <a:ext cx="2375985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85" name="グラフ 8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98835580"/>
                </p:ext>
              </p:extLst>
            </p:nvPr>
          </p:nvGraphicFramePr>
          <p:xfrm>
            <a:off x="107930" y="53533"/>
            <a:ext cx="309591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95" name="グラフ 9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55031412"/>
                </p:ext>
              </p:extLst>
            </p:nvPr>
          </p:nvGraphicFramePr>
          <p:xfrm>
            <a:off x="107930" y="3027017"/>
            <a:ext cx="309591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sp>
        <p:nvSpPr>
          <p:cNvPr id="96" name="テキスト ボックス 95"/>
          <p:cNvSpPr txBox="1"/>
          <p:nvPr/>
        </p:nvSpPr>
        <p:spPr>
          <a:xfrm>
            <a:off x="148068" y="5778718"/>
            <a:ext cx="85885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Figure S3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Validation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of the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enrichment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of purified immunoprecipitated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(IP) DNAs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by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qPCR.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FWA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and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STM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are H3K27me3 marked genes (positive control), and Bra013206 and Bra028913 are low level H3K27me3 marked genes (negative control) (Kawanabe et al. 2016).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Arial"/>
                <a:cs typeface="Arial"/>
              </a:rPr>
              <a:t>31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Values are means ± standard error (</a:t>
            </a:r>
            <a:r>
              <a:rPr lang="en-US" altLang="ja-JP" sz="1200" dirty="0" err="1">
                <a:solidFill>
                  <a:srgbClr val="000000"/>
                </a:solidFill>
                <a:latin typeface="Arial"/>
                <a:cs typeface="Arial"/>
              </a:rPr>
              <a:t>s.e.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)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(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three biological and technical replicates) of relative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H3K27me3 levels. Visualization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of H3K27me3 peaks by Integrative Genomics Viewer (IGV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) by ChIP-seq are shown in the right panel. </a:t>
            </a:r>
            <a:endParaRPr kumimoji="1" lang="ja-JP" altLang="en-US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850405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図形グループ 2"/>
          <p:cNvGrpSpPr/>
          <p:nvPr/>
        </p:nvGrpSpPr>
        <p:grpSpPr>
          <a:xfrm>
            <a:off x="41156" y="2057400"/>
            <a:ext cx="9061689" cy="2743200"/>
            <a:chOff x="82311" y="2057400"/>
            <a:chExt cx="9061689" cy="2743200"/>
          </a:xfrm>
        </p:grpSpPr>
        <p:graphicFrame>
          <p:nvGraphicFramePr>
            <p:cNvPr id="7" name="グラフ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7385587"/>
                </p:ext>
              </p:extLst>
            </p:nvPr>
          </p:nvGraphicFramePr>
          <p:xfrm>
            <a:off x="4572000" y="2057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8" name="グラフ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66626652"/>
                </p:ext>
              </p:extLst>
            </p:nvPr>
          </p:nvGraphicFramePr>
          <p:xfrm>
            <a:off x="82311" y="2057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2" name="正方形/長方形 1"/>
          <p:cNvSpPr/>
          <p:nvPr/>
        </p:nvSpPr>
        <p:spPr>
          <a:xfrm>
            <a:off x="254340" y="5062926"/>
            <a:ext cx="86353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S4.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Comparison of the two replicates for ChIP-seq of 14dL in RJKB-T23 and RJKB-T24. The RPKM of each sliding window per 100 kb was compared between replicate 1 and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2 (n=2,578).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Correlation coefficient in each window of the two replicates was 0.99 and 0.98 in RJKB-T23 and RJKB-24, respectively. </a:t>
            </a:r>
            <a:endParaRPr lang="ja-JP" altLang="ja-JP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7065439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425132" y="57062"/>
            <a:ext cx="8337868" cy="5763073"/>
            <a:chOff x="238704" y="57062"/>
            <a:chExt cx="8779714" cy="6068474"/>
          </a:xfrm>
        </p:grpSpPr>
        <p:grpSp>
          <p:nvGrpSpPr>
            <p:cNvPr id="59" name="図形グループ 58"/>
            <p:cNvGrpSpPr/>
            <p:nvPr/>
          </p:nvGrpSpPr>
          <p:grpSpPr>
            <a:xfrm>
              <a:off x="5288529" y="57062"/>
              <a:ext cx="3387927" cy="3200082"/>
              <a:chOff x="5288529" y="285662"/>
              <a:chExt cx="3387927" cy="3200082"/>
            </a:xfrm>
          </p:grpSpPr>
          <p:pic>
            <p:nvPicPr>
              <p:cNvPr id="6" name="図 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153811" y="342813"/>
                <a:ext cx="2482189" cy="2999282"/>
              </a:xfrm>
              <a:prstGeom prst="rect">
                <a:avLst/>
              </a:prstGeom>
            </p:spPr>
          </p:pic>
          <p:grpSp>
            <p:nvGrpSpPr>
              <p:cNvPr id="42" name="図形グループ 41"/>
              <p:cNvGrpSpPr/>
              <p:nvPr/>
            </p:nvGrpSpPr>
            <p:grpSpPr>
              <a:xfrm>
                <a:off x="5288529" y="670401"/>
                <a:ext cx="803457" cy="2328370"/>
                <a:chOff x="118438" y="670401"/>
                <a:chExt cx="803457" cy="2328370"/>
              </a:xfrm>
            </p:grpSpPr>
            <p:sp>
              <p:nvSpPr>
                <p:cNvPr id="43" name="テキスト ボックス 42"/>
                <p:cNvSpPr txBox="1"/>
                <p:nvPr/>
              </p:nvSpPr>
              <p:spPr>
                <a:xfrm>
                  <a:off x="416725" y="725995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4" name="テキスト ボックス 43"/>
                <p:cNvSpPr txBox="1"/>
                <p:nvPr/>
              </p:nvSpPr>
              <p:spPr>
                <a:xfrm>
                  <a:off x="387347" y="1006922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5" name="テキスト ボックス 44"/>
                <p:cNvSpPr txBox="1"/>
                <p:nvPr/>
              </p:nvSpPr>
              <p:spPr>
                <a:xfrm>
                  <a:off x="412793" y="2153307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1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6" name="テキスト ボックス 45"/>
                <p:cNvSpPr txBox="1"/>
                <p:nvPr/>
              </p:nvSpPr>
              <p:spPr>
                <a:xfrm>
                  <a:off x="412793" y="2434234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2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7" name="テキスト ボックス 46"/>
                <p:cNvSpPr txBox="1"/>
                <p:nvPr/>
              </p:nvSpPr>
              <p:spPr>
                <a:xfrm>
                  <a:off x="395438" y="128784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8" name="テキスト ボックス 47"/>
                <p:cNvSpPr txBox="1"/>
                <p:nvPr/>
              </p:nvSpPr>
              <p:spPr>
                <a:xfrm>
                  <a:off x="416725" y="1591453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9" name="テキスト ボックス 48"/>
                <p:cNvSpPr txBox="1"/>
                <p:nvPr/>
              </p:nvSpPr>
              <p:spPr>
                <a:xfrm>
                  <a:off x="387347" y="1872380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0" name="テキスト ボックス 49"/>
                <p:cNvSpPr txBox="1"/>
                <p:nvPr/>
              </p:nvSpPr>
              <p:spPr>
                <a:xfrm>
                  <a:off x="395438" y="2715162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1" name="テキスト ボックス 50"/>
                <p:cNvSpPr txBox="1"/>
                <p:nvPr/>
              </p:nvSpPr>
              <p:spPr>
                <a:xfrm rot="16200000">
                  <a:off x="-190285" y="979125"/>
                  <a:ext cx="8944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-T23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2" name="テキスト ボックス 51"/>
                <p:cNvSpPr txBox="1"/>
                <p:nvPr/>
              </p:nvSpPr>
              <p:spPr>
                <a:xfrm rot="16200000">
                  <a:off x="-190285" y="2194274"/>
                  <a:ext cx="8944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-T24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53" name="直線コネクタ 52"/>
                <p:cNvCxnSpPr/>
                <p:nvPr/>
              </p:nvCxnSpPr>
              <p:spPr>
                <a:xfrm>
                  <a:off x="412747" y="670401"/>
                  <a:ext cx="0" cy="8944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直線コネクタ 53"/>
                <p:cNvCxnSpPr/>
                <p:nvPr/>
              </p:nvCxnSpPr>
              <p:spPr>
                <a:xfrm>
                  <a:off x="412747" y="1666775"/>
                  <a:ext cx="0" cy="13319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5" name="テキスト ボックス 54"/>
              <p:cNvSpPr txBox="1"/>
              <p:nvPr/>
            </p:nvSpPr>
            <p:spPr>
              <a:xfrm>
                <a:off x="6819891" y="3208745"/>
                <a:ext cx="1467439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i="1" dirty="0" smtClean="0">
                    <a:latin typeface="Arial"/>
                    <a:cs typeface="Arial"/>
                  </a:rPr>
                  <a:t>FUS3</a:t>
                </a:r>
                <a:r>
                  <a:rPr lang="en-US" altLang="ja-JP" sz="1200" dirty="0" smtClean="0">
                    <a:latin typeface="Arial"/>
                    <a:cs typeface="Arial"/>
                  </a:rPr>
                  <a:t> / Bra025229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56" name="直線矢印コネクタ 55"/>
              <p:cNvCxnSpPr/>
              <p:nvPr/>
            </p:nvCxnSpPr>
            <p:spPr>
              <a:xfrm>
                <a:off x="6725619" y="3219085"/>
                <a:ext cx="1655982" cy="0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正方形/長方形 56"/>
              <p:cNvSpPr/>
              <p:nvPr/>
            </p:nvSpPr>
            <p:spPr>
              <a:xfrm>
                <a:off x="6153811" y="285662"/>
                <a:ext cx="2522645" cy="42189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66" name="図形グループ 65"/>
            <p:cNvGrpSpPr/>
            <p:nvPr/>
          </p:nvGrpSpPr>
          <p:grpSpPr>
            <a:xfrm>
              <a:off x="238704" y="3009494"/>
              <a:ext cx="5303851" cy="3116042"/>
              <a:chOff x="239618" y="3140968"/>
              <a:chExt cx="5303851" cy="3116042"/>
            </a:xfrm>
          </p:grpSpPr>
          <p:pic>
            <p:nvPicPr>
              <p:cNvPr id="5" name="図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flipH="1">
                <a:off x="1025950" y="3155950"/>
                <a:ext cx="4517519" cy="2981611"/>
              </a:xfrm>
              <a:prstGeom prst="rect">
                <a:avLst/>
              </a:prstGeom>
            </p:spPr>
          </p:pic>
          <p:grpSp>
            <p:nvGrpSpPr>
              <p:cNvPr id="29" name="図形グループ 28"/>
              <p:cNvGrpSpPr/>
              <p:nvPr/>
            </p:nvGrpSpPr>
            <p:grpSpPr>
              <a:xfrm>
                <a:off x="239618" y="3460234"/>
                <a:ext cx="803457" cy="2328370"/>
                <a:chOff x="118438" y="670401"/>
                <a:chExt cx="803457" cy="2328370"/>
              </a:xfrm>
            </p:grpSpPr>
            <p:sp>
              <p:nvSpPr>
                <p:cNvPr id="30" name="テキスト ボックス 29"/>
                <p:cNvSpPr txBox="1"/>
                <p:nvPr/>
              </p:nvSpPr>
              <p:spPr>
                <a:xfrm>
                  <a:off x="416725" y="725995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1" name="テキスト ボックス 30"/>
                <p:cNvSpPr txBox="1"/>
                <p:nvPr/>
              </p:nvSpPr>
              <p:spPr>
                <a:xfrm>
                  <a:off x="387347" y="1006922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2" name="テキスト ボックス 31"/>
                <p:cNvSpPr txBox="1"/>
                <p:nvPr/>
              </p:nvSpPr>
              <p:spPr>
                <a:xfrm>
                  <a:off x="412793" y="2153307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1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3" name="テキスト ボックス 32"/>
                <p:cNvSpPr txBox="1"/>
                <p:nvPr/>
              </p:nvSpPr>
              <p:spPr>
                <a:xfrm>
                  <a:off x="412793" y="2434234"/>
                  <a:ext cx="483657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Arial"/>
                      <a:cs typeface="Arial"/>
                    </a:rPr>
                    <a:t>BrV2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4" name="テキスト ボックス 33"/>
                <p:cNvSpPr txBox="1"/>
                <p:nvPr/>
              </p:nvSpPr>
              <p:spPr>
                <a:xfrm>
                  <a:off x="395438" y="1287849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5" name="テキスト ボックス 34"/>
                <p:cNvSpPr txBox="1"/>
                <p:nvPr/>
              </p:nvSpPr>
              <p:spPr>
                <a:xfrm>
                  <a:off x="416725" y="1591453"/>
                  <a:ext cx="475792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2d-C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6" name="テキスト ボックス 35"/>
                <p:cNvSpPr txBox="1"/>
                <p:nvPr/>
              </p:nvSpPr>
              <p:spPr>
                <a:xfrm>
                  <a:off x="387347" y="1872380"/>
                  <a:ext cx="534548" cy="254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14d-L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7" name="テキスト ボックス 36"/>
                <p:cNvSpPr txBox="1"/>
                <p:nvPr/>
              </p:nvSpPr>
              <p:spPr>
                <a:xfrm>
                  <a:off x="395438" y="2715162"/>
                  <a:ext cx="5183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input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8" name="テキスト ボックス 37"/>
                <p:cNvSpPr txBox="1"/>
                <p:nvPr/>
              </p:nvSpPr>
              <p:spPr>
                <a:xfrm rot="16200000">
                  <a:off x="-190285" y="979125"/>
                  <a:ext cx="8944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-T23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9" name="テキスト ボックス 38"/>
                <p:cNvSpPr txBox="1"/>
                <p:nvPr/>
              </p:nvSpPr>
              <p:spPr>
                <a:xfrm rot="16200000">
                  <a:off x="-190285" y="2194274"/>
                  <a:ext cx="8944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RJKB-T24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40" name="直線コネクタ 39"/>
                <p:cNvCxnSpPr/>
                <p:nvPr/>
              </p:nvCxnSpPr>
              <p:spPr>
                <a:xfrm>
                  <a:off x="412747" y="670401"/>
                  <a:ext cx="0" cy="8944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/>
                <p:cNvCxnSpPr/>
                <p:nvPr/>
              </p:nvCxnSpPr>
              <p:spPr>
                <a:xfrm>
                  <a:off x="412747" y="1666775"/>
                  <a:ext cx="0" cy="13319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3" name="テキスト ボックス 62"/>
              <p:cNvSpPr txBox="1"/>
              <p:nvPr/>
            </p:nvSpPr>
            <p:spPr>
              <a:xfrm>
                <a:off x="2720831" y="5980011"/>
                <a:ext cx="1553175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i="1" dirty="0" smtClean="0">
                    <a:latin typeface="Arial"/>
                    <a:cs typeface="Arial"/>
                  </a:rPr>
                  <a:t>AGL19</a:t>
                </a:r>
                <a:r>
                  <a:rPr lang="en-US" altLang="ja-JP" sz="1200" dirty="0" smtClean="0">
                    <a:latin typeface="Arial"/>
                    <a:cs typeface="Arial"/>
                  </a:rPr>
                  <a:t> / Bra019343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64" name="直線矢印コネクタ 63"/>
              <p:cNvCxnSpPr/>
              <p:nvPr/>
            </p:nvCxnSpPr>
            <p:spPr>
              <a:xfrm>
                <a:off x="1563722" y="6017727"/>
                <a:ext cx="3815996" cy="0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正方形/長方形 64"/>
              <p:cNvSpPr/>
              <p:nvPr/>
            </p:nvSpPr>
            <p:spPr>
              <a:xfrm>
                <a:off x="919607" y="3140968"/>
                <a:ext cx="4623862" cy="35340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51350" y="228600"/>
              <a:ext cx="3895960" cy="2859495"/>
            </a:xfrm>
            <a:prstGeom prst="rect">
              <a:avLst/>
            </a:prstGeom>
          </p:spPr>
        </p:pic>
        <p:sp>
          <p:nvSpPr>
            <p:cNvPr id="11" name="テキスト ボックス 10"/>
            <p:cNvSpPr txBox="1"/>
            <p:nvPr/>
          </p:nvSpPr>
          <p:spPr>
            <a:xfrm>
              <a:off x="2380879" y="2980145"/>
              <a:ext cx="1301082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200" i="1" dirty="0" smtClean="0">
                  <a:latin typeface="Arial"/>
                  <a:cs typeface="Arial"/>
                </a:rPr>
                <a:t>AG</a:t>
              </a:r>
              <a:r>
                <a:rPr lang="en-US" altLang="ja-JP" sz="1200" dirty="0" smtClean="0">
                  <a:latin typeface="Arial"/>
                  <a:cs typeface="Arial"/>
                </a:rPr>
                <a:t> / Bra012564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1007470" y="176064"/>
              <a:ext cx="3992262" cy="28803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21" name="直線矢印コネクタ 20"/>
            <p:cNvCxnSpPr/>
            <p:nvPr/>
          </p:nvCxnSpPr>
          <p:spPr>
            <a:xfrm>
              <a:off x="1195422" y="2990485"/>
              <a:ext cx="3671997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" name="図形グループ 27"/>
            <p:cNvGrpSpPr/>
            <p:nvPr/>
          </p:nvGrpSpPr>
          <p:grpSpPr>
            <a:xfrm>
              <a:off x="239618" y="441801"/>
              <a:ext cx="803457" cy="2328370"/>
              <a:chOff x="118438" y="670401"/>
              <a:chExt cx="803457" cy="2328370"/>
            </a:xfrm>
          </p:grpSpPr>
          <p:sp>
            <p:nvSpPr>
              <p:cNvPr id="12" name="テキスト ボックス 11"/>
              <p:cNvSpPr txBox="1"/>
              <p:nvPr/>
            </p:nvSpPr>
            <p:spPr>
              <a:xfrm>
                <a:off x="416725" y="725995"/>
                <a:ext cx="475792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2d-C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3" name="テキスト ボックス 12"/>
              <p:cNvSpPr txBox="1"/>
              <p:nvPr/>
            </p:nvSpPr>
            <p:spPr>
              <a:xfrm>
                <a:off x="387347" y="1006922"/>
                <a:ext cx="534548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14d-L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4" name="テキスト ボックス 13"/>
              <p:cNvSpPr txBox="1"/>
              <p:nvPr/>
            </p:nvSpPr>
            <p:spPr>
              <a:xfrm>
                <a:off x="412793" y="2153307"/>
                <a:ext cx="483657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BrV1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5" name="テキスト ボックス 14"/>
              <p:cNvSpPr txBox="1"/>
              <p:nvPr/>
            </p:nvSpPr>
            <p:spPr>
              <a:xfrm>
                <a:off x="412793" y="2434234"/>
                <a:ext cx="483657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BrV2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395438" y="1287849"/>
                <a:ext cx="5183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input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7" name="テキスト ボックス 16"/>
              <p:cNvSpPr txBox="1"/>
              <p:nvPr/>
            </p:nvSpPr>
            <p:spPr>
              <a:xfrm>
                <a:off x="416725" y="1591453"/>
                <a:ext cx="475792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2d-C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387347" y="1872380"/>
                <a:ext cx="534548" cy="254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14d-L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395438" y="2715162"/>
                <a:ext cx="5183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input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 rot="16200000">
                <a:off x="-190285" y="979125"/>
                <a:ext cx="8944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RJKB-T23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 rot="16200000">
                <a:off x="-190285" y="2194274"/>
                <a:ext cx="8944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RJKB-T24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26" name="直線コネクタ 25"/>
              <p:cNvCxnSpPr/>
              <p:nvPr/>
            </p:nvCxnSpPr>
            <p:spPr>
              <a:xfrm>
                <a:off x="412747" y="670401"/>
                <a:ext cx="0" cy="8944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線コネクタ 26"/>
              <p:cNvCxnSpPr/>
              <p:nvPr/>
            </p:nvCxnSpPr>
            <p:spPr>
              <a:xfrm>
                <a:off x="412747" y="1666775"/>
                <a:ext cx="0" cy="133199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58" name="グラフ 5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87859982"/>
                </p:ext>
              </p:extLst>
            </p:nvPr>
          </p:nvGraphicFramePr>
          <p:xfrm>
            <a:off x="5803297" y="3332312"/>
            <a:ext cx="3215121" cy="26535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8" name="直線コネクタ 7"/>
            <p:cNvCxnSpPr/>
            <p:nvPr/>
          </p:nvCxnSpPr>
          <p:spPr>
            <a:xfrm>
              <a:off x="5145719" y="3037377"/>
              <a:ext cx="46799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/>
            <p:cNvSpPr txBox="1"/>
            <p:nvPr/>
          </p:nvSpPr>
          <p:spPr>
            <a:xfrm>
              <a:off x="5052044" y="3055313"/>
              <a:ext cx="655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500 bp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</p:grpSp>
      <p:sp>
        <p:nvSpPr>
          <p:cNvPr id="60" name="テキスト ボックス 59"/>
          <p:cNvSpPr txBox="1"/>
          <p:nvPr/>
        </p:nvSpPr>
        <p:spPr>
          <a:xfrm>
            <a:off x="174404" y="5919217"/>
            <a:ext cx="85885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Figure S5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 Validation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of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the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enrichment of purified immunoprecipitated DNAs by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qPCR.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G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 FUS3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, and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AGL14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are H3K27me3 marked genes reported in Kawanabe et al. 2016.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Arial"/>
                <a:cs typeface="Arial"/>
              </a:rPr>
              <a:t>31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Values are means ± standard error (</a:t>
            </a:r>
            <a:r>
              <a:rPr lang="en-US" altLang="ja-JP" sz="1200" dirty="0" err="1">
                <a:solidFill>
                  <a:srgbClr val="000000"/>
                </a:solidFill>
                <a:latin typeface="Arial"/>
                <a:cs typeface="Arial"/>
              </a:rPr>
              <a:t>s.e.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)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(three biological and technical replicates) of relative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H3K27me3 levels. Visualization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of H3K27me3 peaks by Integrative Genomics Viewer (IGV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) by ChIP-seq are shown. </a:t>
            </a:r>
            <a:endParaRPr kumimoji="1" lang="ja-JP" altLang="en-US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744057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230492"/>
              </p:ext>
            </p:extLst>
          </p:nvPr>
        </p:nvGraphicFramePr>
        <p:xfrm>
          <a:off x="532342" y="324390"/>
          <a:ext cx="8079317" cy="57535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624766" y="6281113"/>
            <a:ext cx="78944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6.</a:t>
            </a:r>
            <a:r>
              <a:rPr lang="en-US" altLang="ja-JP" sz="1200" dirty="0" smtClean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Mapped reads of input and </a:t>
            </a:r>
            <a:r>
              <a:rPr lang="en-US" altLang="ja-JP" sz="1200" dirty="0" err="1">
                <a:latin typeface="Arial"/>
                <a:cs typeface="Arial"/>
              </a:rPr>
              <a:t>immunoprecipitated</a:t>
            </a:r>
            <a:r>
              <a:rPr lang="en-US" altLang="ja-JP" sz="1200" dirty="0">
                <a:latin typeface="Arial"/>
                <a:cs typeface="Arial"/>
              </a:rPr>
              <a:t> DNA using anti-H3K27me3 antibodies in genic regions classified into 2kb-upstream, exon, intron, and 2kb downstream positions. </a:t>
            </a:r>
            <a:endParaRPr lang="ja-JP" altLang="ja-JP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895524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3685282"/>
              </p:ext>
            </p:extLst>
          </p:nvPr>
        </p:nvGraphicFramePr>
        <p:xfrm>
          <a:off x="1211946" y="138635"/>
          <a:ext cx="2236725" cy="2182170"/>
        </p:xfrm>
        <a:graphic>
          <a:graphicData uri="http://schemas.openxmlformats.org/drawingml/2006/table">
            <a:tbl>
              <a:tblPr/>
              <a:tblGrid>
                <a:gridCol w="447345"/>
                <a:gridCol w="447345"/>
                <a:gridCol w="447345"/>
                <a:gridCol w="447345"/>
                <a:gridCol w="447345"/>
              </a:tblGrid>
              <a:tr h="21821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821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7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8A7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7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8A7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5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B78"/>
                    </a:solidFill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5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AB7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8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A6F"/>
                    </a:solidFill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6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9A75"/>
                    </a:solidFill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5191656"/>
              </p:ext>
            </p:extLst>
          </p:nvPr>
        </p:nvGraphicFramePr>
        <p:xfrm>
          <a:off x="1211946" y="3024952"/>
          <a:ext cx="2236725" cy="2182170"/>
        </p:xfrm>
        <a:graphic>
          <a:graphicData uri="http://schemas.openxmlformats.org/drawingml/2006/table">
            <a:tbl>
              <a:tblPr/>
              <a:tblGrid>
                <a:gridCol w="447345"/>
                <a:gridCol w="447345"/>
                <a:gridCol w="447345"/>
                <a:gridCol w="447345"/>
                <a:gridCol w="447345"/>
              </a:tblGrid>
              <a:tr h="21821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821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1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B8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4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BB7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6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D980"/>
                    </a:solidFill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3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9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E48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5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6D67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6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9A75"/>
                    </a:solidFill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4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AD27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8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081"/>
                    </a:solidFill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9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FC17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9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6E48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4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AD27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3317557"/>
              </p:ext>
            </p:extLst>
          </p:nvPr>
        </p:nvGraphicFramePr>
        <p:xfrm>
          <a:off x="4904727" y="138635"/>
          <a:ext cx="2891380" cy="2705897"/>
        </p:xfrm>
        <a:graphic>
          <a:graphicData uri="http://schemas.openxmlformats.org/drawingml/2006/table">
            <a:tbl>
              <a:tblPr/>
              <a:tblGrid>
                <a:gridCol w="578276"/>
                <a:gridCol w="578276"/>
                <a:gridCol w="578276"/>
                <a:gridCol w="578276"/>
                <a:gridCol w="578276"/>
              </a:tblGrid>
              <a:tr h="196396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63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+12d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821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2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14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6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9A75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7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8A72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4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BB7B"/>
                    </a:solidFill>
                  </a:tcPr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4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BB7B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9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5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AB78"/>
                    </a:solidFill>
                  </a:tcPr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2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+12d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14DAS)</a:t>
                      </a:r>
                    </a:p>
                  </a:txBody>
                  <a:tcPr marL="10911" marR="10911" marT="1091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7" name="テキスト ボックス 6"/>
          <p:cNvSpPr txBox="1"/>
          <p:nvPr/>
        </p:nvSpPr>
        <p:spPr>
          <a:xfrm rot="5400000">
            <a:off x="3021951" y="3920481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charset="0"/>
                <a:ea typeface="Arial" charset="0"/>
                <a:cs typeface="Arial" charset="0"/>
              </a:rPr>
              <a:t>Genic regions</a:t>
            </a:r>
            <a:endParaRPr kumimoji="1"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061464" y="5200868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charset="0"/>
                <a:ea typeface="Arial" charset="0"/>
                <a:cs typeface="Arial" charset="0"/>
              </a:rPr>
              <a:t>IRRs</a:t>
            </a:r>
            <a:endParaRPr kumimoji="1"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5400000">
            <a:off x="7348132" y="4203986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charset="0"/>
                <a:ea typeface="Arial" charset="0"/>
                <a:cs typeface="Arial" charset="0"/>
              </a:rPr>
              <a:t>Genic regions</a:t>
            </a:r>
            <a:endParaRPr kumimoji="1"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191662" y="5682936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charset="0"/>
                <a:ea typeface="Arial" charset="0"/>
                <a:cs typeface="Arial" charset="0"/>
              </a:rPr>
              <a:t>IRRs</a:t>
            </a:r>
            <a:endParaRPr kumimoji="1"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11" name="表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4250968"/>
              </p:ext>
            </p:extLst>
          </p:nvPr>
        </p:nvGraphicFramePr>
        <p:xfrm>
          <a:off x="4904727" y="3024952"/>
          <a:ext cx="2870125" cy="2651343"/>
        </p:xfrm>
        <a:graphic>
          <a:graphicData uri="http://schemas.openxmlformats.org/drawingml/2006/table">
            <a:tbl>
              <a:tblPr/>
              <a:tblGrid>
                <a:gridCol w="574025"/>
                <a:gridCol w="574025"/>
                <a:gridCol w="574025"/>
                <a:gridCol w="574025"/>
                <a:gridCol w="574025"/>
              </a:tblGrid>
              <a:tr h="160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495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+12d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6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2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14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08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6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9A75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6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D980"/>
                    </a:solidFill>
                  </a:tcPr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 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NV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4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AD27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1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B84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9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4 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08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4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AD27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1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B84"/>
                    </a:solidFill>
                  </a:tcPr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2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24-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2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B7D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3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CB7E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7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EDD8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wkV+12d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329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≈14DAS)</a:t>
                      </a:r>
                    </a:p>
                  </a:txBody>
                  <a:tcPr marL="10831" marR="10831" marT="108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="" xmlns:a16="http://schemas.microsoft.com/office/drawing/2014/main" id="{4AA35258-F015-E946-9C24-0F1DE9DF44D1}"/>
              </a:ext>
            </a:extLst>
          </p:cNvPr>
          <p:cNvSpPr txBox="1"/>
          <p:nvPr/>
        </p:nvSpPr>
        <p:spPr>
          <a:xfrm>
            <a:off x="777050" y="40832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="" xmlns:a16="http://schemas.microsoft.com/office/drawing/2014/main" id="{852D3077-21E1-9949-898F-A014B3AFBD3A}"/>
              </a:ext>
            </a:extLst>
          </p:cNvPr>
          <p:cNvSpPr txBox="1"/>
          <p:nvPr/>
        </p:nvSpPr>
        <p:spPr>
          <a:xfrm>
            <a:off x="4404142" y="60960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133760" y="5842337"/>
            <a:ext cx="893233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7.</a:t>
            </a:r>
            <a:r>
              <a:rPr lang="en-US" altLang="ja-JP" sz="1200" dirty="0" smtClean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The comparison of H3K27me3 levels between different tissues or </a:t>
            </a:r>
            <a:r>
              <a:rPr lang="en-US" altLang="ja-JP" sz="1200" dirty="0" smtClean="0">
                <a:latin typeface="Arial"/>
                <a:cs typeface="Arial"/>
              </a:rPr>
              <a:t>lines (A, B) or between with and without four weeks of cold treatments (C, D). </a:t>
            </a:r>
            <a:r>
              <a:rPr lang="en-US" altLang="ja-JP" sz="1200" dirty="0">
                <a:latin typeface="Arial"/>
                <a:cs typeface="Arial"/>
              </a:rPr>
              <a:t>The correlation coefficient of H3K27me3 levels quantified by reads per </a:t>
            </a:r>
            <a:r>
              <a:rPr lang="en-US" altLang="ja-JP" sz="1200" dirty="0" err="1">
                <a:latin typeface="Arial"/>
                <a:cs typeface="Arial"/>
              </a:rPr>
              <a:t>kilobase</a:t>
            </a:r>
            <a:r>
              <a:rPr lang="en-US" altLang="ja-JP" sz="1200" dirty="0">
                <a:latin typeface="Arial"/>
                <a:cs typeface="Arial"/>
              </a:rPr>
              <a:t> million (RPKM) in each sliding window per 100 kb at the whole genome </a:t>
            </a:r>
            <a:r>
              <a:rPr lang="en-US" altLang="ja-JP" sz="1200" dirty="0" smtClean="0">
                <a:latin typeface="Arial"/>
                <a:cs typeface="Arial"/>
              </a:rPr>
              <a:t>level (n</a:t>
            </a:r>
            <a:r>
              <a:rPr lang="en-US" altLang="ja-JP" sz="1200" dirty="0" smtClean="0">
                <a:latin typeface="Arial"/>
                <a:cs typeface="Arial"/>
              </a:rPr>
              <a:t>=2,578) (A, C). The bottom panel (B, D) represents the correlation coefficient of RPKM scores in the genic regions (n=39,609) (upper right) or interspersed repeats </a:t>
            </a:r>
            <a:r>
              <a:rPr lang="en-US" altLang="ja-JP" sz="1200" dirty="0">
                <a:latin typeface="Arial"/>
                <a:cs typeface="Arial"/>
              </a:rPr>
              <a:t>regions (IRRs</a:t>
            </a:r>
            <a:r>
              <a:rPr lang="en-US" altLang="ja-JP" sz="1200" dirty="0" smtClean="0">
                <a:latin typeface="Arial"/>
                <a:cs typeface="Arial"/>
              </a:rPr>
              <a:t>)</a:t>
            </a:r>
            <a:r>
              <a:rPr lang="en-US" altLang="ja-JP" sz="1200" dirty="0">
                <a:latin typeface="Arial"/>
                <a:cs typeface="Arial"/>
              </a:rPr>
              <a:t> (n</a:t>
            </a:r>
            <a:r>
              <a:rPr lang="en-US" altLang="ja-JP" sz="1200" dirty="0" smtClean="0">
                <a:latin typeface="Arial"/>
                <a:cs typeface="Arial"/>
              </a:rPr>
              <a:t>=314,881) </a:t>
            </a:r>
            <a:r>
              <a:rPr lang="en-US" altLang="ja-JP" sz="1200" dirty="0" smtClean="0">
                <a:latin typeface="Arial"/>
                <a:cs typeface="Arial"/>
              </a:rPr>
              <a:t>(lower </a:t>
            </a:r>
            <a:r>
              <a:rPr lang="en-US" altLang="ja-JP" sz="1200" dirty="0">
                <a:latin typeface="Arial"/>
                <a:cs typeface="Arial"/>
              </a:rPr>
              <a:t>left</a:t>
            </a:r>
            <a:r>
              <a:rPr lang="en-US" altLang="ja-JP" sz="1200" dirty="0" smtClean="0">
                <a:latin typeface="Arial"/>
                <a:cs typeface="Arial"/>
              </a:rPr>
              <a:t>). </a:t>
            </a:r>
            <a:endParaRPr lang="ja-JP" altLang="ja-JP" sz="1200" dirty="0">
              <a:latin typeface="Arial"/>
              <a:cs typeface="Arial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852D3077-21E1-9949-898F-A014B3AFBD3A}"/>
              </a:ext>
            </a:extLst>
          </p:cNvPr>
          <p:cNvSpPr txBox="1"/>
          <p:nvPr/>
        </p:nvSpPr>
        <p:spPr>
          <a:xfrm>
            <a:off x="777050" y="2871063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852D3077-21E1-9949-898F-A014B3AFBD3A}"/>
              </a:ext>
            </a:extLst>
          </p:cNvPr>
          <p:cNvSpPr txBox="1"/>
          <p:nvPr/>
        </p:nvSpPr>
        <p:spPr>
          <a:xfrm>
            <a:off x="4404142" y="2871063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69164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384909" y="5447236"/>
            <a:ext cx="837418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8.</a:t>
            </a:r>
            <a:r>
              <a:rPr lang="en-US" altLang="ja-JP" sz="1200" dirty="0" smtClean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Classification of genes having H3K27me3 in genic regions into seven groups of expression levels.</a:t>
            </a:r>
          </a:p>
          <a:p>
            <a:r>
              <a:rPr lang="en-US" altLang="ja-JP" sz="1200" dirty="0">
                <a:latin typeface="Arial"/>
                <a:cs typeface="Arial"/>
              </a:rPr>
              <a:t> </a:t>
            </a:r>
            <a:r>
              <a:rPr lang="en-US" altLang="ja-JP" sz="1200" dirty="0" smtClean="0">
                <a:latin typeface="Arial"/>
                <a:cs typeface="Arial"/>
              </a:rPr>
              <a:t>‘K27+’ and ‘K27*’ represent H3K27me3-marked genes and H3K27me3 stably marked genes, respectively</a:t>
            </a:r>
            <a:r>
              <a:rPr lang="en-US" altLang="ja-JP" sz="1200" dirty="0">
                <a:latin typeface="Arial"/>
                <a:cs typeface="Arial"/>
              </a:rPr>
              <a:t>. ‘Total’ indicates </a:t>
            </a:r>
            <a:r>
              <a:rPr lang="en-US" altLang="ja-JP" sz="1200" dirty="0" smtClean="0">
                <a:latin typeface="Arial"/>
                <a:cs typeface="Arial"/>
              </a:rPr>
              <a:t>all genes. 2d</a:t>
            </a:r>
            <a:r>
              <a:rPr lang="en-US" altLang="ja-JP" sz="1200" dirty="0">
                <a:latin typeface="Arial"/>
                <a:cs typeface="Arial"/>
              </a:rPr>
              <a:t>-C; 2-day cotyledons, 14d-L; 14-day leaves. Group-0, No mapped read; Group-1, log</a:t>
            </a:r>
            <a:r>
              <a:rPr lang="en-US" altLang="ja-JP" sz="1200" baseline="-25000" dirty="0">
                <a:latin typeface="Arial"/>
                <a:cs typeface="Arial"/>
              </a:rPr>
              <a:t>2</a:t>
            </a:r>
            <a:r>
              <a:rPr lang="en-US" altLang="ja-JP" sz="1200" dirty="0">
                <a:latin typeface="Arial"/>
                <a:cs typeface="Arial"/>
              </a:rPr>
              <a:t> (FPKM)&lt;-3.0; Group-2, -3.0=&lt; log</a:t>
            </a:r>
            <a:r>
              <a:rPr lang="en-US" altLang="ja-JP" sz="1200" baseline="-25000" dirty="0">
                <a:latin typeface="Arial"/>
                <a:cs typeface="Arial"/>
              </a:rPr>
              <a:t>2</a:t>
            </a:r>
            <a:r>
              <a:rPr lang="en-US" altLang="ja-JP" sz="1200" dirty="0">
                <a:latin typeface="Arial"/>
                <a:cs typeface="Arial"/>
              </a:rPr>
              <a:t> (FPKM)&lt;0.0; Group-3, 0.0=&lt; log</a:t>
            </a:r>
            <a:r>
              <a:rPr lang="en-US" altLang="ja-JP" sz="1200" baseline="-25000" dirty="0">
                <a:latin typeface="Arial"/>
                <a:cs typeface="Arial"/>
              </a:rPr>
              <a:t>2</a:t>
            </a:r>
            <a:r>
              <a:rPr lang="en-US" altLang="ja-JP" sz="1200" dirty="0">
                <a:latin typeface="Arial"/>
                <a:cs typeface="Arial"/>
              </a:rPr>
              <a:t> (FPKM)&lt;3.0; Group-4, 3.0=&lt; log</a:t>
            </a:r>
            <a:r>
              <a:rPr lang="en-US" altLang="ja-JP" sz="1200" baseline="-25000" dirty="0">
                <a:latin typeface="Arial"/>
                <a:cs typeface="Arial"/>
              </a:rPr>
              <a:t>2</a:t>
            </a:r>
            <a:r>
              <a:rPr lang="en-US" altLang="ja-JP" sz="1200" dirty="0">
                <a:latin typeface="Arial"/>
                <a:cs typeface="Arial"/>
              </a:rPr>
              <a:t> (FPKM)&lt;6.0; Group-5, 6.0=&lt; log</a:t>
            </a:r>
            <a:r>
              <a:rPr lang="en-US" altLang="ja-JP" sz="1200" baseline="-25000" dirty="0">
                <a:latin typeface="Arial"/>
                <a:cs typeface="Arial"/>
              </a:rPr>
              <a:t>2</a:t>
            </a:r>
            <a:r>
              <a:rPr lang="en-US" altLang="ja-JP" sz="1200" dirty="0">
                <a:latin typeface="Arial"/>
                <a:cs typeface="Arial"/>
              </a:rPr>
              <a:t> (FPKM)&lt;9.0; Group-6, 9.0=&lt; log</a:t>
            </a:r>
            <a:r>
              <a:rPr lang="en-US" altLang="ja-JP" sz="1200" baseline="-25000" dirty="0">
                <a:latin typeface="Arial"/>
                <a:cs typeface="Arial"/>
              </a:rPr>
              <a:t>2</a:t>
            </a:r>
            <a:r>
              <a:rPr lang="en-US" altLang="ja-JP" sz="1200" dirty="0">
                <a:latin typeface="Arial"/>
                <a:cs typeface="Arial"/>
              </a:rPr>
              <a:t> (FPKM). FPKM, Fragments Per </a:t>
            </a:r>
            <a:r>
              <a:rPr lang="en-US" altLang="ja-JP" sz="1200" dirty="0" err="1">
                <a:latin typeface="Arial"/>
                <a:cs typeface="Arial"/>
              </a:rPr>
              <a:t>Kilobase</a:t>
            </a:r>
            <a:r>
              <a:rPr lang="en-US" altLang="ja-JP" sz="1200" dirty="0">
                <a:latin typeface="Arial"/>
                <a:cs typeface="Arial"/>
              </a:rPr>
              <a:t> of transcript per Million mapped reads.</a:t>
            </a:r>
            <a:endParaRPr lang="ja-JP" altLang="ja-JP" sz="1200" dirty="0">
              <a:latin typeface="Arial"/>
              <a:cs typeface="Arial"/>
            </a:endParaRPr>
          </a:p>
        </p:txBody>
      </p:sp>
      <p:grpSp>
        <p:nvGrpSpPr>
          <p:cNvPr id="8" name="図形グループ 7"/>
          <p:cNvGrpSpPr/>
          <p:nvPr/>
        </p:nvGrpSpPr>
        <p:grpSpPr>
          <a:xfrm>
            <a:off x="636983" y="788390"/>
            <a:ext cx="7870034" cy="4355101"/>
            <a:chOff x="296333" y="513232"/>
            <a:chExt cx="7870034" cy="4355101"/>
          </a:xfrm>
          <a:effectLst/>
        </p:grpSpPr>
        <p:graphicFrame>
          <p:nvGraphicFramePr>
            <p:cNvPr id="5" name="グラフ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62809741"/>
                </p:ext>
              </p:extLst>
            </p:nvPr>
          </p:nvGraphicFramePr>
          <p:xfrm>
            <a:off x="296333" y="513232"/>
            <a:ext cx="7258501" cy="43551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二等辺三角形 2"/>
            <p:cNvSpPr/>
            <p:nvPr/>
          </p:nvSpPr>
          <p:spPr>
            <a:xfrm flipV="1">
              <a:off x="7506067" y="1772816"/>
              <a:ext cx="254000" cy="1905000"/>
            </a:xfrm>
            <a:prstGeom prst="triangle">
              <a:avLst/>
            </a:prstGeom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7356113" y="1268760"/>
              <a:ext cx="5539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/>
                  <a:cs typeface="Arial"/>
                </a:rPr>
                <a:t>High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7376057" y="3789040"/>
              <a:ext cx="5140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/>
                  <a:cs typeface="Arial"/>
                </a:rPr>
                <a:t>Low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 rot="5400000">
              <a:off x="7266521" y="2571428"/>
              <a:ext cx="14919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/>
                  <a:cs typeface="Arial"/>
                </a:rPr>
                <a:t>Expression level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</p:grpSp>
      <p:sp>
        <p:nvSpPr>
          <p:cNvPr id="9" name="テキスト ボックス 8"/>
          <p:cNvSpPr txBox="1"/>
          <p:nvPr/>
        </p:nvSpPr>
        <p:spPr>
          <a:xfrm rot="16200000">
            <a:off x="1270039" y="3749604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+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1749549" y="3749604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16200000">
            <a:off x="2229059" y="3749604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Total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2708569" y="3749604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+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3188079" y="3749604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3667589" y="3749604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Total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4147099" y="3749605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+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4626609" y="3749605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5106119" y="3749605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Total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5585629" y="3749605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+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6065139" y="3749605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K27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6544648" y="3749605"/>
            <a:ext cx="6089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/>
                <a:cs typeface="Arial"/>
              </a:rPr>
              <a:t>Total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1420630" y="4207972"/>
            <a:ext cx="307777" cy="16400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/>
          <p:cNvSpPr/>
          <p:nvPr/>
        </p:nvSpPr>
        <p:spPr>
          <a:xfrm>
            <a:off x="1900140" y="4196369"/>
            <a:ext cx="307777" cy="24074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/>
          <p:cNvSpPr/>
          <p:nvPr/>
        </p:nvSpPr>
        <p:spPr>
          <a:xfrm>
            <a:off x="2859160" y="4199980"/>
            <a:ext cx="307777" cy="16400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/>
          <p:cNvSpPr/>
          <p:nvPr/>
        </p:nvSpPr>
        <p:spPr>
          <a:xfrm>
            <a:off x="3338670" y="4188377"/>
            <a:ext cx="307777" cy="24074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正方形/長方形 26"/>
          <p:cNvSpPr/>
          <p:nvPr/>
        </p:nvSpPr>
        <p:spPr>
          <a:xfrm>
            <a:off x="4309030" y="4196895"/>
            <a:ext cx="307777" cy="16400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4777200" y="4207972"/>
            <a:ext cx="307777" cy="24074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5763720" y="4199980"/>
            <a:ext cx="307777" cy="16400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6243230" y="4188377"/>
            <a:ext cx="307777" cy="240743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20892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6688096"/>
              </p:ext>
            </p:extLst>
          </p:nvPr>
        </p:nvGraphicFramePr>
        <p:xfrm>
          <a:off x="968991" y="161500"/>
          <a:ext cx="6851176" cy="2954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6170085"/>
              </p:ext>
            </p:extLst>
          </p:nvPr>
        </p:nvGraphicFramePr>
        <p:xfrm>
          <a:off x="968991" y="3205140"/>
          <a:ext cx="6851176" cy="2954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7" name="直線コネクタ 6"/>
          <p:cNvCxnSpPr/>
          <p:nvPr/>
        </p:nvCxnSpPr>
        <p:spPr>
          <a:xfrm flipV="1">
            <a:off x="2681313" y="3411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 flipV="1">
            <a:off x="3666226" y="3411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 flipV="1">
            <a:off x="4664787" y="3411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 flipV="1">
            <a:off x="5649701" y="3411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 flipV="1">
            <a:off x="6661910" y="3411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 flipV="1">
            <a:off x="2824031" y="868091"/>
            <a:ext cx="0" cy="666856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 flipV="1">
            <a:off x="3501832" y="868091"/>
            <a:ext cx="0" cy="783049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 flipH="1">
            <a:off x="2824031" y="868091"/>
            <a:ext cx="677801" cy="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 flipH="1" flipV="1">
            <a:off x="3167562" y="868091"/>
            <a:ext cx="843" cy="333428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/>
          <p:cNvSpPr txBox="1"/>
          <p:nvPr/>
        </p:nvSpPr>
        <p:spPr>
          <a:xfrm>
            <a:off x="2843280" y="70071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171324" y="700714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cxnSp>
        <p:nvCxnSpPr>
          <p:cNvPr id="28" name="直線コネクタ 27"/>
          <p:cNvCxnSpPr/>
          <p:nvPr/>
        </p:nvCxnSpPr>
        <p:spPr>
          <a:xfrm flipV="1">
            <a:off x="5809981" y="810337"/>
            <a:ext cx="0" cy="720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 flipV="1">
            <a:off x="6490041" y="817865"/>
            <a:ext cx="0" cy="783049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 flipH="1">
            <a:off x="5805977" y="817865"/>
            <a:ext cx="677801" cy="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 flipH="1" flipV="1">
            <a:off x="6155771" y="817865"/>
            <a:ext cx="843" cy="333428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5857176" y="65048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197920" y="65048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cxnSp>
        <p:nvCxnSpPr>
          <p:cNvPr id="37" name="直線コネクタ 36"/>
          <p:cNvCxnSpPr/>
          <p:nvPr/>
        </p:nvCxnSpPr>
        <p:spPr>
          <a:xfrm flipH="1" flipV="1">
            <a:off x="6820965" y="577179"/>
            <a:ext cx="843" cy="144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/>
          <p:cNvSpPr txBox="1"/>
          <p:nvPr/>
        </p:nvSpPr>
        <p:spPr>
          <a:xfrm>
            <a:off x="6875484" y="38503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cxnSp>
        <p:nvCxnSpPr>
          <p:cNvPr id="39" name="直線コネクタ 38"/>
          <p:cNvCxnSpPr/>
          <p:nvPr/>
        </p:nvCxnSpPr>
        <p:spPr>
          <a:xfrm flipV="1">
            <a:off x="7144670" y="577179"/>
            <a:ext cx="0" cy="890095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 flipH="1">
            <a:off x="6827228" y="577179"/>
            <a:ext cx="324000" cy="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 flipV="1">
            <a:off x="2681313" y="33764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 flipV="1">
            <a:off x="3666226" y="33764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 flipV="1">
            <a:off x="4664787" y="33764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 flipV="1">
            <a:off x="5649701" y="33764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 flipV="1">
            <a:off x="6661910" y="3376496"/>
            <a:ext cx="0" cy="158400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 flipV="1">
            <a:off x="2835928" y="3962696"/>
            <a:ext cx="0" cy="108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 flipV="1">
            <a:off x="3499440" y="3962696"/>
            <a:ext cx="0" cy="252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 flipH="1" flipV="1">
            <a:off x="3155644" y="3962696"/>
            <a:ext cx="843" cy="756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/>
          <p:nvPr/>
        </p:nvSpPr>
        <p:spPr>
          <a:xfrm>
            <a:off x="2831362" y="3790572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159406" y="379057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cxnSp>
        <p:nvCxnSpPr>
          <p:cNvPr id="59" name="直線コネクタ 58"/>
          <p:cNvCxnSpPr/>
          <p:nvPr/>
        </p:nvCxnSpPr>
        <p:spPr>
          <a:xfrm flipV="1">
            <a:off x="2835671" y="3967065"/>
            <a:ext cx="660456" cy="1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 flipH="1" flipV="1">
            <a:off x="4500283" y="3918783"/>
            <a:ext cx="0" cy="82800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 flipH="1">
            <a:off x="3994503" y="3915718"/>
            <a:ext cx="496942" cy="1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 flipH="1">
            <a:off x="3812611" y="4029435"/>
            <a:ext cx="370417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 flipH="1" flipV="1">
            <a:off x="3997820" y="3909254"/>
            <a:ext cx="0" cy="10800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/>
          <p:cNvSpPr txBox="1"/>
          <p:nvPr/>
        </p:nvSpPr>
        <p:spPr>
          <a:xfrm flipH="1">
            <a:off x="4102123" y="373863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cxnSp>
        <p:nvCxnSpPr>
          <p:cNvPr id="68" name="直線コネクタ 67"/>
          <p:cNvCxnSpPr/>
          <p:nvPr/>
        </p:nvCxnSpPr>
        <p:spPr>
          <a:xfrm flipV="1">
            <a:off x="5832026" y="4012169"/>
            <a:ext cx="0" cy="108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 flipV="1">
            <a:off x="6489894" y="4012169"/>
            <a:ext cx="0" cy="180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 flipH="1" flipV="1">
            <a:off x="6157386" y="4012169"/>
            <a:ext cx="843" cy="75600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/>
          <p:cNvSpPr txBox="1"/>
          <p:nvPr/>
        </p:nvSpPr>
        <p:spPr>
          <a:xfrm>
            <a:off x="5844476" y="3842512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6172520" y="384251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cxnSp>
        <p:nvCxnSpPr>
          <p:cNvPr id="73" name="直線コネクタ 72"/>
          <p:cNvCxnSpPr/>
          <p:nvPr/>
        </p:nvCxnSpPr>
        <p:spPr>
          <a:xfrm flipV="1">
            <a:off x="5831769" y="4016538"/>
            <a:ext cx="660456" cy="1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 flipH="1" flipV="1">
            <a:off x="7490821" y="3874774"/>
            <a:ext cx="0" cy="82800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/>
          <p:cNvCxnSpPr/>
          <p:nvPr/>
        </p:nvCxnSpPr>
        <p:spPr>
          <a:xfrm flipH="1">
            <a:off x="6985041" y="3871709"/>
            <a:ext cx="496942" cy="1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/>
          <p:cNvCxnSpPr/>
          <p:nvPr/>
        </p:nvCxnSpPr>
        <p:spPr>
          <a:xfrm flipH="1">
            <a:off x="6803149" y="3985426"/>
            <a:ext cx="370417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/>
          <p:cNvCxnSpPr/>
          <p:nvPr/>
        </p:nvCxnSpPr>
        <p:spPr>
          <a:xfrm flipH="1" flipV="1">
            <a:off x="6988358" y="3865245"/>
            <a:ext cx="0" cy="10800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テキスト ボックス 77"/>
          <p:cNvSpPr txBox="1"/>
          <p:nvPr/>
        </p:nvSpPr>
        <p:spPr>
          <a:xfrm flipH="1">
            <a:off x="7062612" y="36947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*</a:t>
            </a:r>
            <a:r>
              <a:rPr lang="en-US" altLang="ja-JP" sz="1200" dirty="0">
                <a:latin typeface="Arial"/>
                <a:cs typeface="Arial"/>
              </a:rPr>
              <a:t>*</a:t>
            </a:r>
            <a:endParaRPr lang="ja-JP" altLang="en-US" sz="1200" dirty="0">
              <a:latin typeface="Arial"/>
              <a:cs typeface="Arial"/>
            </a:endParaRPr>
          </a:p>
        </p:txBody>
      </p:sp>
      <p:sp>
        <p:nvSpPr>
          <p:cNvPr id="80" name="正方形/長方形 79"/>
          <p:cNvSpPr/>
          <p:nvPr/>
        </p:nvSpPr>
        <p:spPr>
          <a:xfrm>
            <a:off x="308776" y="6170734"/>
            <a:ext cx="83830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S9.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Comparison of the expression level (FPKM) between paralogous pairs with and without H3K27me3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.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Values are means ± standard error (</a:t>
            </a:r>
            <a:r>
              <a:rPr lang="en-US" altLang="ja-JP" sz="1200" dirty="0" err="1">
                <a:solidFill>
                  <a:srgbClr val="000000"/>
                </a:solidFill>
                <a:latin typeface="Arial"/>
                <a:cs typeface="Arial"/>
              </a:rPr>
              <a:t>s.e.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) 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of FPKM. +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and </a:t>
            </a:r>
            <a:r>
              <a:rPr lang="mr-IN" altLang="ja-JP" sz="1200" dirty="0">
                <a:solidFill>
                  <a:srgbClr val="000000"/>
                </a:solidFill>
                <a:latin typeface="Arial"/>
                <a:cs typeface="Arial"/>
              </a:rPr>
              <a:t>–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represent presence and absence of H3K27me3, respectively. *, </a:t>
            </a: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&lt;0.05; **, </a:t>
            </a: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&lt;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0.01 (Student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t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-test)</a:t>
            </a:r>
            <a:endParaRPr lang="ja-JP" altLang="ja-JP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207793" y="119221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3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171324" y="119221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5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4191267" y="119221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69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5190092" y="119221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3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6153623" y="119221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5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7173566" y="119221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69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2151734" y="3127749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10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3170299" y="3127749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9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4130243" y="3127749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5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5140953" y="3127749"/>
            <a:ext cx="544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10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6159518" y="3127749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9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7119462" y="3127749"/>
            <a:ext cx="4735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n=57</a:t>
            </a:r>
            <a:endParaRPr kumimoji="1" lang="ja-JP" alt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5224381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98</TotalTime>
  <Words>2377</Words>
  <Application>Microsoft Macintosh PowerPoint</Application>
  <PresentationFormat>画面に合わせる (4:3)</PresentationFormat>
  <Paragraphs>485</Paragraphs>
  <Slides>15</Slides>
  <Notes>7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5</vt:i4>
      </vt:variant>
    </vt:vector>
  </HeadingPairs>
  <TitlesOfParts>
    <vt:vector size="16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moto</dc:creator>
  <cp:lastModifiedBy>Fujimoto</cp:lastModifiedBy>
  <cp:revision>161</cp:revision>
  <dcterms:created xsi:type="dcterms:W3CDTF">2017-03-28T07:23:07Z</dcterms:created>
  <dcterms:modified xsi:type="dcterms:W3CDTF">2019-08-19T05:00:11Z</dcterms:modified>
</cp:coreProperties>
</file>